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xlsx" ContentType="application/vnd.openxmlformats-officedocument.spreadsheetml.sheet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>
        <p:scale>
          <a:sx n="100" d="100"/>
          <a:sy n="100" d="100"/>
        </p:scale>
        <p:origin x="-942" y="1194"/>
      </p:cViewPr>
      <p:guideLst>
        <p:guide orient="horz" pos="4575"/>
        <p:guide pos="1089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Office_Excel_Worksheet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Office_Excel_Worksheet2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GB"/>
  <c:chart>
    <c:plotArea>
      <c:layout>
        <c:manualLayout>
          <c:layoutTarget val="inner"/>
          <c:xMode val="edge"/>
          <c:yMode val="edge"/>
          <c:x val="6.5015463441722501E-2"/>
          <c:y val="7.7489503506429414E-2"/>
          <c:w val="0.87551867219917789"/>
          <c:h val="0.64754098360655765"/>
        </c:manualLayout>
      </c:layout>
      <c:barChart>
        <c:barDir val="col"/>
        <c:grouping val="clustered"/>
        <c:ser>
          <c:idx val="0"/>
          <c:order val="0"/>
          <c:tx>
            <c:strRef>
              <c:f>Sheet1!$H$27</c:f>
              <c:strCache>
                <c:ptCount val="1"/>
                <c:pt idx="0">
                  <c:v>Periphery</c:v>
                </c:pt>
              </c:strCache>
            </c:strRef>
          </c:tx>
          <c:spPr>
            <a:solidFill>
              <a:srgbClr val="9999FF"/>
            </a:solidFill>
            <a:ln w="9052">
              <a:solidFill>
                <a:srgbClr val="000000"/>
              </a:solidFill>
              <a:prstDash val="solid"/>
            </a:ln>
          </c:spPr>
          <c:cat>
            <c:numRef>
              <c:f>Sheet1!$G$28:$G$47</c:f>
              <c:numCache>
                <c:formatCode>General</c:formatCode>
                <c:ptCount val="2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</c:numCache>
            </c:numRef>
          </c:cat>
          <c:val>
            <c:numRef>
              <c:f>Sheet1!$H$28:$H$47</c:f>
              <c:numCache>
                <c:formatCode>0.00</c:formatCode>
                <c:ptCount val="20"/>
                <c:pt idx="0">
                  <c:v>22.644000000000005</c:v>
                </c:pt>
                <c:pt idx="1">
                  <c:v>34.242000000000012</c:v>
                </c:pt>
                <c:pt idx="2">
                  <c:v>35.680000000000007</c:v>
                </c:pt>
                <c:pt idx="3">
                  <c:v>31.217999999999993</c:v>
                </c:pt>
                <c:pt idx="4">
                  <c:v>31.32400000000003</c:v>
                </c:pt>
                <c:pt idx="5">
                  <c:v>55.928000000000011</c:v>
                </c:pt>
                <c:pt idx="6">
                  <c:v>60.464000000000006</c:v>
                </c:pt>
                <c:pt idx="7">
                  <c:v>54.322000000000003</c:v>
                </c:pt>
                <c:pt idx="8">
                  <c:v>45.461000000000006</c:v>
                </c:pt>
                <c:pt idx="9">
                  <c:v>41.593000000000011</c:v>
                </c:pt>
                <c:pt idx="10">
                  <c:v>38.409000000000006</c:v>
                </c:pt>
                <c:pt idx="11">
                  <c:v>39.291000000000011</c:v>
                </c:pt>
                <c:pt idx="12">
                  <c:v>40.216000000000008</c:v>
                </c:pt>
                <c:pt idx="13">
                  <c:v>38.452999999999996</c:v>
                </c:pt>
                <c:pt idx="14">
                  <c:v>51.492000000000012</c:v>
                </c:pt>
                <c:pt idx="15">
                  <c:v>49.017000000000003</c:v>
                </c:pt>
                <c:pt idx="16">
                  <c:v>66.336000000000013</c:v>
                </c:pt>
                <c:pt idx="17">
                  <c:v>52.516000000000005</c:v>
                </c:pt>
                <c:pt idx="18">
                  <c:v>48.238000000000063</c:v>
                </c:pt>
                <c:pt idx="19">
                  <c:v>46</c:v>
                </c:pt>
              </c:numCache>
            </c:numRef>
          </c:val>
        </c:ser>
        <c:ser>
          <c:idx val="1"/>
          <c:order val="1"/>
          <c:tx>
            <c:strRef>
              <c:f>Sheet1!$I$27</c:f>
              <c:strCache>
                <c:ptCount val="1"/>
                <c:pt idx="0">
                  <c:v>Centre</c:v>
                </c:pt>
              </c:strCache>
            </c:strRef>
          </c:tx>
          <c:spPr>
            <a:solidFill>
              <a:srgbClr val="FFFF99"/>
            </a:solidFill>
            <a:ln w="9052">
              <a:solidFill>
                <a:srgbClr val="000000"/>
              </a:solidFill>
              <a:prstDash val="solid"/>
            </a:ln>
          </c:spPr>
          <c:cat>
            <c:numRef>
              <c:f>Sheet1!$G$28:$G$47</c:f>
              <c:numCache>
                <c:formatCode>General</c:formatCode>
                <c:ptCount val="2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</c:numCache>
            </c:numRef>
          </c:cat>
          <c:val>
            <c:numRef>
              <c:f>Sheet1!$I$28:$I$47</c:f>
              <c:numCache>
                <c:formatCode>0.00</c:formatCode>
                <c:ptCount val="20"/>
                <c:pt idx="0">
                  <c:v>41.900000000000006</c:v>
                </c:pt>
                <c:pt idx="1">
                  <c:v>39.056999999999988</c:v>
                </c:pt>
                <c:pt idx="2">
                  <c:v>23.391999999999996</c:v>
                </c:pt>
                <c:pt idx="3">
                  <c:v>37.442000000000007</c:v>
                </c:pt>
                <c:pt idx="4">
                  <c:v>39.728000000000208</c:v>
                </c:pt>
                <c:pt idx="5">
                  <c:v>45.505000000000003</c:v>
                </c:pt>
                <c:pt idx="6">
                  <c:v>62.717000000000006</c:v>
                </c:pt>
                <c:pt idx="7">
                  <c:v>52.572000000000003</c:v>
                </c:pt>
                <c:pt idx="8">
                  <c:v>45.2250000000002</c:v>
                </c:pt>
                <c:pt idx="9">
                  <c:v>42.844999999999999</c:v>
                </c:pt>
                <c:pt idx="10">
                  <c:v>27.27000000000001</c:v>
                </c:pt>
                <c:pt idx="11">
                  <c:v>40.794000000000011</c:v>
                </c:pt>
                <c:pt idx="12">
                  <c:v>34.157999999999987</c:v>
                </c:pt>
                <c:pt idx="13">
                  <c:v>0</c:v>
                </c:pt>
                <c:pt idx="14">
                  <c:v>41.407999999999987</c:v>
                </c:pt>
                <c:pt idx="15">
                  <c:v>57.279000000000011</c:v>
                </c:pt>
                <c:pt idx="16">
                  <c:v>67.61699999999999</c:v>
                </c:pt>
                <c:pt idx="17">
                  <c:v>0</c:v>
                </c:pt>
                <c:pt idx="18">
                  <c:v>38.251000000000005</c:v>
                </c:pt>
                <c:pt idx="19">
                  <c:v>45.364000000000004</c:v>
                </c:pt>
              </c:numCache>
            </c:numRef>
          </c:val>
        </c:ser>
        <c:gapWidth val="100"/>
        <c:axId val="138489216"/>
        <c:axId val="138491008"/>
      </c:barChart>
      <c:catAx>
        <c:axId val="138489216"/>
        <c:scaling>
          <c:orientation val="minMax"/>
        </c:scaling>
        <c:axPos val="b"/>
        <c:numFmt formatCode="General" sourceLinked="1"/>
        <c:tickLblPos val="nextTo"/>
        <c:spPr>
          <a:ln w="2263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7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138491008"/>
        <c:crosses val="autoZero"/>
        <c:auto val="1"/>
        <c:lblAlgn val="ctr"/>
        <c:lblOffset val="100"/>
        <c:tickLblSkip val="1"/>
        <c:tickMarkSkip val="1"/>
      </c:catAx>
      <c:valAx>
        <c:axId val="138491008"/>
        <c:scaling>
          <c:orientation val="minMax"/>
        </c:scaling>
        <c:axPos val="l"/>
        <c:majorGridlines>
          <c:spPr>
            <a:ln w="2263">
              <a:solidFill>
                <a:srgbClr val="000000"/>
              </a:solidFill>
              <a:prstDash val="solid"/>
            </a:ln>
          </c:spPr>
        </c:majorGridlines>
        <c:numFmt formatCode="0" sourceLinked="0"/>
        <c:tickLblPos val="nextTo"/>
        <c:spPr>
          <a:ln w="2263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7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138489216"/>
        <c:crosses val="autoZero"/>
        <c:crossBetween val="between"/>
      </c:valAx>
      <c:spPr>
        <a:noFill/>
        <a:ln w="9052">
          <a:solidFill>
            <a:srgbClr val="808080"/>
          </a:solidFill>
          <a:prstDash val="solid"/>
        </a:ln>
      </c:spPr>
    </c:plotArea>
    <c:plotVisOnly val="1"/>
    <c:dispBlanksAs val="gap"/>
  </c:chart>
  <c:spPr>
    <a:noFill/>
    <a:ln>
      <a:noFill/>
    </a:ln>
  </c:spPr>
  <c:txPr>
    <a:bodyPr/>
    <a:lstStyle/>
    <a:p>
      <a:pPr>
        <a:defRPr sz="373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GB"/>
  <c:chart>
    <c:plotArea>
      <c:layout>
        <c:manualLayout>
          <c:layoutTarget val="inner"/>
          <c:xMode val="edge"/>
          <c:yMode val="edge"/>
          <c:x val="0.13240289698854327"/>
          <c:y val="4.7358831527109804E-2"/>
          <c:w val="0.84407145709769882"/>
          <c:h val="0.75947232566169987"/>
        </c:manualLayout>
      </c:layout>
      <c:barChart>
        <c:barDir val="col"/>
        <c:grouping val="clustered"/>
        <c:ser>
          <c:idx val="0"/>
          <c:order val="0"/>
          <c:tx>
            <c:strRef>
              <c:f>Sheet2!$B$1</c:f>
              <c:strCache>
                <c:ptCount val="1"/>
                <c:pt idx="0">
                  <c:v>Periphery</c:v>
                </c:pt>
              </c:strCache>
            </c:strRef>
          </c:tx>
          <c:spPr>
            <a:solidFill>
              <a:srgbClr val="9999FF"/>
            </a:solidFill>
            <a:ln w="9843">
              <a:solidFill>
                <a:srgbClr val="000000"/>
              </a:solidFill>
              <a:prstDash val="solid"/>
            </a:ln>
          </c:spPr>
          <c:errBars>
            <c:errBarType val="plus"/>
            <c:errValType val="cust"/>
            <c:plus>
              <c:numRef>
                <c:f>Sheet2!$E$2:$E$21</c:f>
                <c:numCache>
                  <c:formatCode>General</c:formatCode>
                  <c:ptCount val="20"/>
                  <c:pt idx="0">
                    <c:v>17.39</c:v>
                  </c:pt>
                  <c:pt idx="1">
                    <c:v>13.92</c:v>
                  </c:pt>
                  <c:pt idx="2">
                    <c:v>12.28</c:v>
                  </c:pt>
                  <c:pt idx="3">
                    <c:v>6.6499999999999995</c:v>
                  </c:pt>
                  <c:pt idx="4">
                    <c:v>12.93</c:v>
                  </c:pt>
                  <c:pt idx="5">
                    <c:v>115.04</c:v>
                  </c:pt>
                  <c:pt idx="6">
                    <c:v>28.58</c:v>
                  </c:pt>
                  <c:pt idx="7">
                    <c:v>3.01</c:v>
                  </c:pt>
                  <c:pt idx="8">
                    <c:v>8.8500000000000068</c:v>
                  </c:pt>
                  <c:pt idx="9">
                    <c:v>66.819999999999993</c:v>
                  </c:pt>
                  <c:pt idx="10">
                    <c:v>16.55</c:v>
                  </c:pt>
                  <c:pt idx="11">
                    <c:v>13.850000000000026</c:v>
                  </c:pt>
                  <c:pt idx="12">
                    <c:v>18.010000000000005</c:v>
                  </c:pt>
                  <c:pt idx="13">
                    <c:v>7.88</c:v>
                  </c:pt>
                  <c:pt idx="14">
                    <c:v>8.3500000000000068</c:v>
                  </c:pt>
                  <c:pt idx="15">
                    <c:v>17.100000000000001</c:v>
                  </c:pt>
                  <c:pt idx="16">
                    <c:v>20.479999999999986</c:v>
                  </c:pt>
                  <c:pt idx="17">
                    <c:v>17.95</c:v>
                  </c:pt>
                  <c:pt idx="18">
                    <c:v>23.68</c:v>
                  </c:pt>
                  <c:pt idx="19">
                    <c:v>17.850000000000001</c:v>
                  </c:pt>
                </c:numCache>
              </c:numRef>
            </c:plus>
            <c:spPr>
              <a:solidFill>
                <a:srgbClr val="9999FF"/>
              </a:solidFill>
              <a:ln w="9843">
                <a:solidFill>
                  <a:srgbClr val="000000"/>
                </a:solidFill>
                <a:prstDash val="solid"/>
              </a:ln>
            </c:spPr>
          </c:errBars>
          <c:val>
            <c:numRef>
              <c:f>Sheet2!$B$2:$B$21</c:f>
              <c:numCache>
                <c:formatCode>General</c:formatCode>
                <c:ptCount val="20"/>
                <c:pt idx="0">
                  <c:v>120.34</c:v>
                </c:pt>
                <c:pt idx="1">
                  <c:v>190</c:v>
                </c:pt>
                <c:pt idx="2">
                  <c:v>88.42</c:v>
                </c:pt>
                <c:pt idx="3">
                  <c:v>128.12</c:v>
                </c:pt>
                <c:pt idx="4">
                  <c:v>142.81</c:v>
                </c:pt>
                <c:pt idx="5">
                  <c:v>322.95999999999964</c:v>
                </c:pt>
                <c:pt idx="6">
                  <c:v>241.23</c:v>
                </c:pt>
                <c:pt idx="7">
                  <c:v>112.03</c:v>
                </c:pt>
                <c:pt idx="8">
                  <c:v>139.65</c:v>
                </c:pt>
                <c:pt idx="9">
                  <c:v>250.67</c:v>
                </c:pt>
                <c:pt idx="10">
                  <c:v>197.53</c:v>
                </c:pt>
                <c:pt idx="11">
                  <c:v>107.31</c:v>
                </c:pt>
                <c:pt idx="12">
                  <c:v>192.76</c:v>
                </c:pt>
                <c:pt idx="13">
                  <c:v>150</c:v>
                </c:pt>
                <c:pt idx="14">
                  <c:v>144</c:v>
                </c:pt>
                <c:pt idx="15">
                  <c:v>138.39000000000001</c:v>
                </c:pt>
                <c:pt idx="16">
                  <c:v>142.47999999999999</c:v>
                </c:pt>
                <c:pt idx="17">
                  <c:v>141.8200000000007</c:v>
                </c:pt>
                <c:pt idx="18">
                  <c:v>168.1</c:v>
                </c:pt>
                <c:pt idx="19">
                  <c:v>123.83</c:v>
                </c:pt>
              </c:numCache>
            </c:numRef>
          </c:val>
        </c:ser>
        <c:ser>
          <c:idx val="1"/>
          <c:order val="1"/>
          <c:tx>
            <c:strRef>
              <c:f>Sheet2!$C$1</c:f>
              <c:strCache>
                <c:ptCount val="1"/>
                <c:pt idx="0">
                  <c:v>Centre</c:v>
                </c:pt>
              </c:strCache>
            </c:strRef>
          </c:tx>
          <c:spPr>
            <a:solidFill>
              <a:srgbClr val="FFFF99"/>
            </a:solidFill>
            <a:ln w="9843">
              <a:solidFill>
                <a:srgbClr val="000000"/>
              </a:solidFill>
              <a:prstDash val="solid"/>
            </a:ln>
          </c:spPr>
          <c:errBars>
            <c:errBarType val="plus"/>
            <c:errValType val="cust"/>
            <c:plus>
              <c:numRef>
                <c:f>Sheet2!$F$2:$F$21</c:f>
                <c:numCache>
                  <c:formatCode>General</c:formatCode>
                  <c:ptCount val="20"/>
                  <c:pt idx="0">
                    <c:v>22.89</c:v>
                  </c:pt>
                  <c:pt idx="1">
                    <c:v>29.830000000000005</c:v>
                  </c:pt>
                  <c:pt idx="2">
                    <c:v>2.1</c:v>
                  </c:pt>
                  <c:pt idx="3">
                    <c:v>11.139999999999999</c:v>
                  </c:pt>
                  <c:pt idx="4">
                    <c:v>21.84</c:v>
                  </c:pt>
                  <c:pt idx="5">
                    <c:v>34.790000000000013</c:v>
                  </c:pt>
                  <c:pt idx="6">
                    <c:v>36.24</c:v>
                  </c:pt>
                  <c:pt idx="7">
                    <c:v>26.32</c:v>
                  </c:pt>
                  <c:pt idx="8">
                    <c:v>11.03</c:v>
                  </c:pt>
                  <c:pt idx="9">
                    <c:v>29.419999999999987</c:v>
                  </c:pt>
                  <c:pt idx="10">
                    <c:v>46.86</c:v>
                  </c:pt>
                  <c:pt idx="11">
                    <c:v>32.89</c:v>
                  </c:pt>
                  <c:pt idx="12">
                    <c:v>71.88</c:v>
                  </c:pt>
                  <c:pt idx="13">
                    <c:v>8.8600000000000048</c:v>
                  </c:pt>
                  <c:pt idx="14">
                    <c:v>11.239999999999998</c:v>
                  </c:pt>
                  <c:pt idx="15">
                    <c:v>17.489999999999888</c:v>
                  </c:pt>
                  <c:pt idx="16">
                    <c:v>10.4</c:v>
                  </c:pt>
                  <c:pt idx="17">
                    <c:v>16.479999999999986</c:v>
                  </c:pt>
                  <c:pt idx="18">
                    <c:v>11.870000000000006</c:v>
                  </c:pt>
                  <c:pt idx="19">
                    <c:v>42.51</c:v>
                  </c:pt>
                </c:numCache>
              </c:numRef>
            </c:plus>
            <c:spPr>
              <a:solidFill>
                <a:srgbClr val="FFFF99"/>
              </a:solidFill>
              <a:ln w="9843">
                <a:solidFill>
                  <a:srgbClr val="000000"/>
                </a:solidFill>
                <a:prstDash val="solid"/>
              </a:ln>
            </c:spPr>
          </c:errBars>
          <c:val>
            <c:numRef>
              <c:f>Sheet2!$C$2:$C$21</c:f>
              <c:numCache>
                <c:formatCode>General</c:formatCode>
                <c:ptCount val="20"/>
                <c:pt idx="0">
                  <c:v>97.95</c:v>
                </c:pt>
                <c:pt idx="1">
                  <c:v>233.83</c:v>
                </c:pt>
                <c:pt idx="2">
                  <c:v>102.95</c:v>
                </c:pt>
                <c:pt idx="3">
                  <c:v>130.53</c:v>
                </c:pt>
                <c:pt idx="4">
                  <c:v>155.53</c:v>
                </c:pt>
                <c:pt idx="5">
                  <c:v>407.38</c:v>
                </c:pt>
                <c:pt idx="6">
                  <c:v>254.58</c:v>
                </c:pt>
                <c:pt idx="7">
                  <c:v>195.53</c:v>
                </c:pt>
                <c:pt idx="8">
                  <c:v>139.44</c:v>
                </c:pt>
                <c:pt idx="9">
                  <c:v>325.82</c:v>
                </c:pt>
                <c:pt idx="10">
                  <c:v>205.2</c:v>
                </c:pt>
                <c:pt idx="11">
                  <c:v>128.96</c:v>
                </c:pt>
                <c:pt idx="12">
                  <c:v>287.3</c:v>
                </c:pt>
                <c:pt idx="13">
                  <c:v>169.15</c:v>
                </c:pt>
                <c:pt idx="14">
                  <c:v>114.4</c:v>
                </c:pt>
                <c:pt idx="15">
                  <c:v>115.06</c:v>
                </c:pt>
                <c:pt idx="16">
                  <c:v>107.91000000000012</c:v>
                </c:pt>
                <c:pt idx="17">
                  <c:v>163.96</c:v>
                </c:pt>
                <c:pt idx="18">
                  <c:v>298.17</c:v>
                </c:pt>
                <c:pt idx="19">
                  <c:v>140.53</c:v>
                </c:pt>
              </c:numCache>
            </c:numRef>
          </c:val>
        </c:ser>
        <c:gapWidth val="100"/>
        <c:axId val="138675712"/>
        <c:axId val="138677248"/>
      </c:barChart>
      <c:catAx>
        <c:axId val="138675712"/>
        <c:scaling>
          <c:orientation val="minMax"/>
        </c:scaling>
        <c:axPos val="b"/>
        <c:numFmt formatCode="General" sourceLinked="1"/>
        <c:tickLblPos val="nextTo"/>
        <c:spPr>
          <a:ln w="2461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697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138677248"/>
        <c:crosses val="autoZero"/>
        <c:auto val="1"/>
        <c:lblAlgn val="ctr"/>
        <c:lblOffset val="100"/>
        <c:tickLblSkip val="1"/>
        <c:tickMarkSkip val="1"/>
      </c:catAx>
      <c:valAx>
        <c:axId val="138677248"/>
        <c:scaling>
          <c:orientation val="minMax"/>
          <c:max val="500"/>
        </c:scaling>
        <c:axPos val="l"/>
        <c:majorGridlines>
          <c:spPr>
            <a:ln w="2461">
              <a:solidFill>
                <a:srgbClr val="000000"/>
              </a:solidFill>
              <a:prstDash val="solid"/>
            </a:ln>
          </c:spPr>
        </c:majorGridlines>
        <c:numFmt formatCode="General" sourceLinked="1"/>
        <c:tickLblPos val="nextTo"/>
        <c:spPr>
          <a:ln w="2461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697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138675712"/>
        <c:crosses val="autoZero"/>
        <c:crossBetween val="between"/>
      </c:valAx>
      <c:spPr>
        <a:noFill/>
        <a:ln w="9843">
          <a:solidFill>
            <a:srgbClr val="808080"/>
          </a:solidFill>
          <a:prstDash val="solid"/>
        </a:ln>
      </c:spPr>
    </c:plotArea>
    <c:plotVisOnly val="1"/>
    <c:dispBlanksAs val="gap"/>
  </c:chart>
  <c:spPr>
    <a:noFill/>
    <a:ln>
      <a:noFill/>
    </a:ln>
  </c:spPr>
  <c:txPr>
    <a:bodyPr/>
    <a:lstStyle/>
    <a:p>
      <a:pPr>
        <a:defRPr sz="386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D93B28-BBB1-408D-948F-2EEFBCE781E1}" type="datetimeFigureOut">
              <a:rPr lang="en-GB" smtClean="0"/>
              <a:pPr/>
              <a:t>20/07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EF3DA3-2A92-4E14-9173-E1B5C296DD6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D93B28-BBB1-408D-948F-2EEFBCE781E1}" type="datetimeFigureOut">
              <a:rPr lang="en-GB" smtClean="0"/>
              <a:pPr/>
              <a:t>20/07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EF3DA3-2A92-4E14-9173-E1B5C296DD6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D93B28-BBB1-408D-948F-2EEFBCE781E1}" type="datetimeFigureOut">
              <a:rPr lang="en-GB" smtClean="0"/>
              <a:pPr/>
              <a:t>20/07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EF3DA3-2A92-4E14-9173-E1B5C296DD6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D93B28-BBB1-408D-948F-2EEFBCE781E1}" type="datetimeFigureOut">
              <a:rPr lang="en-GB" smtClean="0"/>
              <a:pPr/>
              <a:t>20/07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EF3DA3-2A92-4E14-9173-E1B5C296DD6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D93B28-BBB1-408D-948F-2EEFBCE781E1}" type="datetimeFigureOut">
              <a:rPr lang="en-GB" smtClean="0"/>
              <a:pPr/>
              <a:t>20/07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EF3DA3-2A92-4E14-9173-E1B5C296DD6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D93B28-BBB1-408D-948F-2EEFBCE781E1}" type="datetimeFigureOut">
              <a:rPr lang="en-GB" smtClean="0"/>
              <a:pPr/>
              <a:t>20/07/201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EF3DA3-2A92-4E14-9173-E1B5C296DD6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D93B28-BBB1-408D-948F-2EEFBCE781E1}" type="datetimeFigureOut">
              <a:rPr lang="en-GB" smtClean="0"/>
              <a:pPr/>
              <a:t>20/07/201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EF3DA3-2A92-4E14-9173-E1B5C296DD6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D93B28-BBB1-408D-948F-2EEFBCE781E1}" type="datetimeFigureOut">
              <a:rPr lang="en-GB" smtClean="0"/>
              <a:pPr/>
              <a:t>20/07/201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EF3DA3-2A92-4E14-9173-E1B5C296DD6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D93B28-BBB1-408D-948F-2EEFBCE781E1}" type="datetimeFigureOut">
              <a:rPr lang="en-GB" smtClean="0"/>
              <a:pPr/>
              <a:t>20/07/201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EF3DA3-2A92-4E14-9173-E1B5C296DD6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D93B28-BBB1-408D-948F-2EEFBCE781E1}" type="datetimeFigureOut">
              <a:rPr lang="en-GB" smtClean="0"/>
              <a:pPr/>
              <a:t>20/07/201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EF3DA3-2A92-4E14-9173-E1B5C296DD6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D93B28-BBB1-408D-948F-2EEFBCE781E1}" type="datetimeFigureOut">
              <a:rPr lang="en-GB" smtClean="0"/>
              <a:pPr/>
              <a:t>20/07/201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EF3DA3-2A92-4E14-9173-E1B5C296DD6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D93B28-BBB1-408D-948F-2EEFBCE781E1}" type="datetimeFigureOut">
              <a:rPr lang="en-GB" smtClean="0"/>
              <a:pPr/>
              <a:t>20/07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EF3DA3-2A92-4E14-9173-E1B5C296DD6C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09" name="Group 1608"/>
          <p:cNvGrpSpPr/>
          <p:nvPr/>
        </p:nvGrpSpPr>
        <p:grpSpPr>
          <a:xfrm>
            <a:off x="847725" y="42860"/>
            <a:ext cx="4429062" cy="1225484"/>
            <a:chOff x="847725" y="166685"/>
            <a:chExt cx="4429062" cy="1225484"/>
          </a:xfrm>
        </p:grpSpPr>
        <p:grpSp>
          <p:nvGrpSpPr>
            <p:cNvPr id="768" name="Group 767"/>
            <p:cNvGrpSpPr/>
            <p:nvPr/>
          </p:nvGrpSpPr>
          <p:grpSpPr>
            <a:xfrm>
              <a:off x="1878012" y="180974"/>
              <a:ext cx="2760663" cy="1190626"/>
              <a:chOff x="325437" y="180974"/>
              <a:chExt cx="2760663" cy="1190626"/>
            </a:xfrm>
          </p:grpSpPr>
          <p:sp>
            <p:nvSpPr>
              <p:cNvPr id="1451" name="Freeform 427"/>
              <p:cNvSpPr>
                <a:spLocks noEditPoints="1"/>
              </p:cNvSpPr>
              <p:nvPr/>
            </p:nvSpPr>
            <p:spPr bwMode="auto">
              <a:xfrm>
                <a:off x="542598" y="222304"/>
                <a:ext cx="2541408" cy="882860"/>
              </a:xfrm>
              <a:custGeom>
                <a:avLst/>
                <a:gdLst/>
                <a:ahLst/>
                <a:cxnLst>
                  <a:cxn ang="0">
                    <a:pos x="0" y="947"/>
                  </a:cxn>
                  <a:cxn ang="0">
                    <a:pos x="2427" y="947"/>
                  </a:cxn>
                  <a:cxn ang="0">
                    <a:pos x="2427" y="951"/>
                  </a:cxn>
                  <a:cxn ang="0">
                    <a:pos x="0" y="951"/>
                  </a:cxn>
                  <a:cxn ang="0">
                    <a:pos x="0" y="947"/>
                  </a:cxn>
                  <a:cxn ang="0">
                    <a:pos x="0" y="788"/>
                  </a:cxn>
                  <a:cxn ang="0">
                    <a:pos x="2427" y="788"/>
                  </a:cxn>
                  <a:cxn ang="0">
                    <a:pos x="2427" y="792"/>
                  </a:cxn>
                  <a:cxn ang="0">
                    <a:pos x="0" y="792"/>
                  </a:cxn>
                  <a:cxn ang="0">
                    <a:pos x="0" y="788"/>
                  </a:cxn>
                  <a:cxn ang="0">
                    <a:pos x="0" y="633"/>
                  </a:cxn>
                  <a:cxn ang="0">
                    <a:pos x="2427" y="633"/>
                  </a:cxn>
                  <a:cxn ang="0">
                    <a:pos x="2427" y="637"/>
                  </a:cxn>
                  <a:cxn ang="0">
                    <a:pos x="0" y="637"/>
                  </a:cxn>
                  <a:cxn ang="0">
                    <a:pos x="0" y="633"/>
                  </a:cxn>
                  <a:cxn ang="0">
                    <a:pos x="0" y="474"/>
                  </a:cxn>
                  <a:cxn ang="0">
                    <a:pos x="2427" y="474"/>
                  </a:cxn>
                  <a:cxn ang="0">
                    <a:pos x="2427" y="478"/>
                  </a:cxn>
                  <a:cxn ang="0">
                    <a:pos x="0" y="478"/>
                  </a:cxn>
                  <a:cxn ang="0">
                    <a:pos x="0" y="474"/>
                  </a:cxn>
                  <a:cxn ang="0">
                    <a:pos x="0" y="314"/>
                  </a:cxn>
                  <a:cxn ang="0">
                    <a:pos x="2427" y="314"/>
                  </a:cxn>
                  <a:cxn ang="0">
                    <a:pos x="2427" y="318"/>
                  </a:cxn>
                  <a:cxn ang="0">
                    <a:pos x="0" y="318"/>
                  </a:cxn>
                  <a:cxn ang="0">
                    <a:pos x="0" y="314"/>
                  </a:cxn>
                  <a:cxn ang="0">
                    <a:pos x="0" y="159"/>
                  </a:cxn>
                  <a:cxn ang="0">
                    <a:pos x="2427" y="159"/>
                  </a:cxn>
                  <a:cxn ang="0">
                    <a:pos x="2427" y="163"/>
                  </a:cxn>
                  <a:cxn ang="0">
                    <a:pos x="0" y="163"/>
                  </a:cxn>
                  <a:cxn ang="0">
                    <a:pos x="0" y="159"/>
                  </a:cxn>
                  <a:cxn ang="0">
                    <a:pos x="0" y="0"/>
                  </a:cxn>
                  <a:cxn ang="0">
                    <a:pos x="2427" y="0"/>
                  </a:cxn>
                  <a:cxn ang="0">
                    <a:pos x="2427" y="4"/>
                  </a:cxn>
                  <a:cxn ang="0">
                    <a:pos x="0" y="4"/>
                  </a:cxn>
                  <a:cxn ang="0">
                    <a:pos x="0" y="0"/>
                  </a:cxn>
                </a:cxnLst>
                <a:rect l="0" t="0" r="r" b="b"/>
                <a:pathLst>
                  <a:path w="2427" h="951">
                    <a:moveTo>
                      <a:pt x="0" y="947"/>
                    </a:moveTo>
                    <a:lnTo>
                      <a:pt x="2427" y="947"/>
                    </a:lnTo>
                    <a:lnTo>
                      <a:pt x="2427" y="951"/>
                    </a:lnTo>
                    <a:lnTo>
                      <a:pt x="0" y="951"/>
                    </a:lnTo>
                    <a:lnTo>
                      <a:pt x="0" y="947"/>
                    </a:lnTo>
                    <a:close/>
                    <a:moveTo>
                      <a:pt x="0" y="788"/>
                    </a:moveTo>
                    <a:lnTo>
                      <a:pt x="2427" y="788"/>
                    </a:lnTo>
                    <a:lnTo>
                      <a:pt x="2427" y="792"/>
                    </a:lnTo>
                    <a:lnTo>
                      <a:pt x="0" y="792"/>
                    </a:lnTo>
                    <a:lnTo>
                      <a:pt x="0" y="788"/>
                    </a:lnTo>
                    <a:close/>
                    <a:moveTo>
                      <a:pt x="0" y="633"/>
                    </a:moveTo>
                    <a:lnTo>
                      <a:pt x="2427" y="633"/>
                    </a:lnTo>
                    <a:lnTo>
                      <a:pt x="2427" y="637"/>
                    </a:lnTo>
                    <a:lnTo>
                      <a:pt x="0" y="637"/>
                    </a:lnTo>
                    <a:lnTo>
                      <a:pt x="0" y="633"/>
                    </a:lnTo>
                    <a:close/>
                    <a:moveTo>
                      <a:pt x="0" y="474"/>
                    </a:moveTo>
                    <a:lnTo>
                      <a:pt x="2427" y="474"/>
                    </a:lnTo>
                    <a:lnTo>
                      <a:pt x="2427" y="478"/>
                    </a:lnTo>
                    <a:lnTo>
                      <a:pt x="0" y="478"/>
                    </a:lnTo>
                    <a:lnTo>
                      <a:pt x="0" y="474"/>
                    </a:lnTo>
                    <a:close/>
                    <a:moveTo>
                      <a:pt x="0" y="314"/>
                    </a:moveTo>
                    <a:lnTo>
                      <a:pt x="2427" y="314"/>
                    </a:lnTo>
                    <a:lnTo>
                      <a:pt x="2427" y="318"/>
                    </a:lnTo>
                    <a:lnTo>
                      <a:pt x="0" y="318"/>
                    </a:lnTo>
                    <a:lnTo>
                      <a:pt x="0" y="314"/>
                    </a:lnTo>
                    <a:close/>
                    <a:moveTo>
                      <a:pt x="0" y="159"/>
                    </a:moveTo>
                    <a:lnTo>
                      <a:pt x="2427" y="159"/>
                    </a:lnTo>
                    <a:lnTo>
                      <a:pt x="2427" y="163"/>
                    </a:lnTo>
                    <a:lnTo>
                      <a:pt x="0" y="163"/>
                    </a:lnTo>
                    <a:lnTo>
                      <a:pt x="0" y="159"/>
                    </a:lnTo>
                    <a:close/>
                    <a:moveTo>
                      <a:pt x="0" y="0"/>
                    </a:moveTo>
                    <a:lnTo>
                      <a:pt x="2427" y="0"/>
                    </a:lnTo>
                    <a:lnTo>
                      <a:pt x="2427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793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52" name="Freeform 428"/>
              <p:cNvSpPr>
                <a:spLocks noEditPoints="1"/>
              </p:cNvSpPr>
              <p:nvPr/>
            </p:nvSpPr>
            <p:spPr bwMode="auto">
              <a:xfrm>
                <a:off x="540503" y="222304"/>
                <a:ext cx="2545597" cy="1027682"/>
              </a:xfrm>
              <a:custGeom>
                <a:avLst/>
                <a:gdLst/>
                <a:ahLst/>
                <a:cxnLst>
                  <a:cxn ang="0">
                    <a:pos x="0" y="8"/>
                  </a:cxn>
                  <a:cxn ang="0">
                    <a:pos x="8" y="0"/>
                  </a:cxn>
                  <a:cxn ang="0">
                    <a:pos x="9352" y="0"/>
                  </a:cxn>
                  <a:cxn ang="0">
                    <a:pos x="9360" y="8"/>
                  </a:cxn>
                  <a:cxn ang="0">
                    <a:pos x="9360" y="4328"/>
                  </a:cxn>
                  <a:cxn ang="0">
                    <a:pos x="9352" y="4336"/>
                  </a:cxn>
                  <a:cxn ang="0">
                    <a:pos x="8" y="4336"/>
                  </a:cxn>
                  <a:cxn ang="0">
                    <a:pos x="0" y="4328"/>
                  </a:cxn>
                  <a:cxn ang="0">
                    <a:pos x="0" y="8"/>
                  </a:cxn>
                  <a:cxn ang="0">
                    <a:pos x="16" y="4328"/>
                  </a:cxn>
                  <a:cxn ang="0">
                    <a:pos x="8" y="4320"/>
                  </a:cxn>
                  <a:cxn ang="0">
                    <a:pos x="9352" y="4320"/>
                  </a:cxn>
                  <a:cxn ang="0">
                    <a:pos x="9344" y="4328"/>
                  </a:cxn>
                  <a:cxn ang="0">
                    <a:pos x="9344" y="8"/>
                  </a:cxn>
                  <a:cxn ang="0">
                    <a:pos x="9352" y="16"/>
                  </a:cxn>
                  <a:cxn ang="0">
                    <a:pos x="8" y="16"/>
                  </a:cxn>
                  <a:cxn ang="0">
                    <a:pos x="16" y="8"/>
                  </a:cxn>
                  <a:cxn ang="0">
                    <a:pos x="16" y="4328"/>
                  </a:cxn>
                </a:cxnLst>
                <a:rect l="0" t="0" r="r" b="b"/>
                <a:pathLst>
                  <a:path w="9360" h="4336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9352" y="0"/>
                    </a:lnTo>
                    <a:cubicBezTo>
                      <a:pt x="9357" y="0"/>
                      <a:pt x="9360" y="4"/>
                      <a:pt x="9360" y="8"/>
                    </a:cubicBezTo>
                    <a:lnTo>
                      <a:pt x="9360" y="4328"/>
                    </a:lnTo>
                    <a:cubicBezTo>
                      <a:pt x="9360" y="4333"/>
                      <a:pt x="9357" y="4336"/>
                      <a:pt x="9352" y="4336"/>
                    </a:cubicBezTo>
                    <a:lnTo>
                      <a:pt x="8" y="4336"/>
                    </a:lnTo>
                    <a:cubicBezTo>
                      <a:pt x="4" y="4336"/>
                      <a:pt x="0" y="4333"/>
                      <a:pt x="0" y="4328"/>
                    </a:cubicBezTo>
                    <a:lnTo>
                      <a:pt x="0" y="8"/>
                    </a:lnTo>
                    <a:close/>
                    <a:moveTo>
                      <a:pt x="16" y="4328"/>
                    </a:moveTo>
                    <a:lnTo>
                      <a:pt x="8" y="4320"/>
                    </a:lnTo>
                    <a:lnTo>
                      <a:pt x="9352" y="4320"/>
                    </a:lnTo>
                    <a:lnTo>
                      <a:pt x="9344" y="4328"/>
                    </a:lnTo>
                    <a:lnTo>
                      <a:pt x="9344" y="8"/>
                    </a:lnTo>
                    <a:lnTo>
                      <a:pt x="9352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4328"/>
                    </a:lnTo>
                    <a:close/>
                  </a:path>
                </a:pathLst>
              </a:custGeom>
              <a:solidFill>
                <a:srgbClr val="808080"/>
              </a:solidFill>
              <a:ln w="7938" cap="flat">
                <a:solidFill>
                  <a:srgbClr val="80808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53" name="Rectangle 429"/>
              <p:cNvSpPr>
                <a:spLocks noChangeArrowheads="1"/>
              </p:cNvSpPr>
              <p:nvPr/>
            </p:nvSpPr>
            <p:spPr bwMode="auto">
              <a:xfrm>
                <a:off x="560399" y="925064"/>
                <a:ext cx="42933" cy="323065"/>
              </a:xfrm>
              <a:prstGeom prst="rect">
                <a:avLst/>
              </a:prstGeom>
              <a:solidFill>
                <a:srgbClr val="9999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54" name="Freeform 430"/>
              <p:cNvSpPr>
                <a:spLocks noEditPoints="1"/>
              </p:cNvSpPr>
              <p:nvPr/>
            </p:nvSpPr>
            <p:spPr bwMode="auto">
              <a:xfrm>
                <a:off x="558305" y="923207"/>
                <a:ext cx="47122" cy="326779"/>
              </a:xfrm>
              <a:custGeom>
                <a:avLst/>
                <a:gdLst/>
                <a:ahLst/>
                <a:cxnLst>
                  <a:cxn ang="0">
                    <a:pos x="0" y="8"/>
                  </a:cxn>
                  <a:cxn ang="0">
                    <a:pos x="8" y="0"/>
                  </a:cxn>
                  <a:cxn ang="0">
                    <a:pos x="168" y="0"/>
                  </a:cxn>
                  <a:cxn ang="0">
                    <a:pos x="176" y="8"/>
                  </a:cxn>
                  <a:cxn ang="0">
                    <a:pos x="176" y="1368"/>
                  </a:cxn>
                  <a:cxn ang="0">
                    <a:pos x="168" y="1376"/>
                  </a:cxn>
                  <a:cxn ang="0">
                    <a:pos x="8" y="1376"/>
                  </a:cxn>
                  <a:cxn ang="0">
                    <a:pos x="0" y="1368"/>
                  </a:cxn>
                  <a:cxn ang="0">
                    <a:pos x="0" y="8"/>
                  </a:cxn>
                  <a:cxn ang="0">
                    <a:pos x="16" y="1368"/>
                  </a:cxn>
                  <a:cxn ang="0">
                    <a:pos x="8" y="1360"/>
                  </a:cxn>
                  <a:cxn ang="0">
                    <a:pos x="168" y="1360"/>
                  </a:cxn>
                  <a:cxn ang="0">
                    <a:pos x="160" y="1368"/>
                  </a:cxn>
                  <a:cxn ang="0">
                    <a:pos x="160" y="8"/>
                  </a:cxn>
                  <a:cxn ang="0">
                    <a:pos x="168" y="16"/>
                  </a:cxn>
                  <a:cxn ang="0">
                    <a:pos x="8" y="16"/>
                  </a:cxn>
                  <a:cxn ang="0">
                    <a:pos x="16" y="8"/>
                  </a:cxn>
                  <a:cxn ang="0">
                    <a:pos x="16" y="1368"/>
                  </a:cxn>
                </a:cxnLst>
                <a:rect l="0" t="0" r="r" b="b"/>
                <a:pathLst>
                  <a:path w="176" h="1376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168" y="0"/>
                    </a:lnTo>
                    <a:cubicBezTo>
                      <a:pt x="173" y="0"/>
                      <a:pt x="176" y="4"/>
                      <a:pt x="176" y="8"/>
                    </a:cubicBezTo>
                    <a:lnTo>
                      <a:pt x="176" y="1368"/>
                    </a:lnTo>
                    <a:cubicBezTo>
                      <a:pt x="176" y="1373"/>
                      <a:pt x="173" y="1376"/>
                      <a:pt x="168" y="1376"/>
                    </a:cubicBezTo>
                    <a:lnTo>
                      <a:pt x="8" y="1376"/>
                    </a:lnTo>
                    <a:cubicBezTo>
                      <a:pt x="4" y="1376"/>
                      <a:pt x="0" y="1373"/>
                      <a:pt x="0" y="1368"/>
                    </a:cubicBezTo>
                    <a:lnTo>
                      <a:pt x="0" y="8"/>
                    </a:lnTo>
                    <a:close/>
                    <a:moveTo>
                      <a:pt x="16" y="1368"/>
                    </a:moveTo>
                    <a:lnTo>
                      <a:pt x="8" y="1360"/>
                    </a:lnTo>
                    <a:lnTo>
                      <a:pt x="168" y="1360"/>
                    </a:lnTo>
                    <a:lnTo>
                      <a:pt x="160" y="1368"/>
                    </a:lnTo>
                    <a:lnTo>
                      <a:pt x="160" y="8"/>
                    </a:lnTo>
                    <a:lnTo>
                      <a:pt x="168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1368"/>
                    </a:lnTo>
                    <a:close/>
                  </a:path>
                </a:pathLst>
              </a:custGeom>
              <a:solidFill>
                <a:srgbClr val="000000"/>
              </a:solidFill>
              <a:ln w="793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55" name="Rectangle 431"/>
              <p:cNvSpPr>
                <a:spLocks noChangeArrowheads="1"/>
              </p:cNvSpPr>
              <p:nvPr/>
            </p:nvSpPr>
            <p:spPr bwMode="auto">
              <a:xfrm>
                <a:off x="691291" y="853581"/>
                <a:ext cx="38744" cy="394548"/>
              </a:xfrm>
              <a:prstGeom prst="rect">
                <a:avLst/>
              </a:prstGeom>
              <a:solidFill>
                <a:srgbClr val="9999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56" name="Freeform 432"/>
              <p:cNvSpPr>
                <a:spLocks noEditPoints="1"/>
              </p:cNvSpPr>
              <p:nvPr/>
            </p:nvSpPr>
            <p:spPr bwMode="auto">
              <a:xfrm>
                <a:off x="688150" y="851725"/>
                <a:ext cx="43980" cy="398262"/>
              </a:xfrm>
              <a:custGeom>
                <a:avLst/>
                <a:gdLst/>
                <a:ahLst/>
                <a:cxnLst>
                  <a:cxn ang="0">
                    <a:pos x="0" y="8"/>
                  </a:cxn>
                  <a:cxn ang="0">
                    <a:pos x="8" y="0"/>
                  </a:cxn>
                  <a:cxn ang="0">
                    <a:pos x="152" y="0"/>
                  </a:cxn>
                  <a:cxn ang="0">
                    <a:pos x="160" y="8"/>
                  </a:cxn>
                  <a:cxn ang="0">
                    <a:pos x="160" y="1672"/>
                  </a:cxn>
                  <a:cxn ang="0">
                    <a:pos x="152" y="1680"/>
                  </a:cxn>
                  <a:cxn ang="0">
                    <a:pos x="8" y="1680"/>
                  </a:cxn>
                  <a:cxn ang="0">
                    <a:pos x="0" y="1672"/>
                  </a:cxn>
                  <a:cxn ang="0">
                    <a:pos x="0" y="8"/>
                  </a:cxn>
                  <a:cxn ang="0">
                    <a:pos x="16" y="1672"/>
                  </a:cxn>
                  <a:cxn ang="0">
                    <a:pos x="8" y="1664"/>
                  </a:cxn>
                  <a:cxn ang="0">
                    <a:pos x="152" y="1664"/>
                  </a:cxn>
                  <a:cxn ang="0">
                    <a:pos x="144" y="1672"/>
                  </a:cxn>
                  <a:cxn ang="0">
                    <a:pos x="144" y="8"/>
                  </a:cxn>
                  <a:cxn ang="0">
                    <a:pos x="152" y="16"/>
                  </a:cxn>
                  <a:cxn ang="0">
                    <a:pos x="8" y="16"/>
                  </a:cxn>
                  <a:cxn ang="0">
                    <a:pos x="16" y="8"/>
                  </a:cxn>
                  <a:cxn ang="0">
                    <a:pos x="16" y="1672"/>
                  </a:cxn>
                </a:cxnLst>
                <a:rect l="0" t="0" r="r" b="b"/>
                <a:pathLst>
                  <a:path w="160" h="1680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152" y="0"/>
                    </a:lnTo>
                    <a:cubicBezTo>
                      <a:pt x="157" y="0"/>
                      <a:pt x="160" y="4"/>
                      <a:pt x="160" y="8"/>
                    </a:cubicBezTo>
                    <a:lnTo>
                      <a:pt x="160" y="1672"/>
                    </a:lnTo>
                    <a:cubicBezTo>
                      <a:pt x="160" y="1677"/>
                      <a:pt x="157" y="1680"/>
                      <a:pt x="152" y="1680"/>
                    </a:cubicBezTo>
                    <a:lnTo>
                      <a:pt x="8" y="1680"/>
                    </a:lnTo>
                    <a:cubicBezTo>
                      <a:pt x="4" y="1680"/>
                      <a:pt x="0" y="1677"/>
                      <a:pt x="0" y="1672"/>
                    </a:cubicBezTo>
                    <a:lnTo>
                      <a:pt x="0" y="8"/>
                    </a:lnTo>
                    <a:close/>
                    <a:moveTo>
                      <a:pt x="16" y="1672"/>
                    </a:moveTo>
                    <a:lnTo>
                      <a:pt x="8" y="1664"/>
                    </a:lnTo>
                    <a:lnTo>
                      <a:pt x="152" y="1664"/>
                    </a:lnTo>
                    <a:lnTo>
                      <a:pt x="144" y="1672"/>
                    </a:lnTo>
                    <a:lnTo>
                      <a:pt x="144" y="8"/>
                    </a:lnTo>
                    <a:lnTo>
                      <a:pt x="152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1672"/>
                    </a:lnTo>
                    <a:close/>
                  </a:path>
                </a:pathLst>
              </a:custGeom>
              <a:solidFill>
                <a:srgbClr val="000000"/>
              </a:solidFill>
              <a:ln w="793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57" name="Rectangle 433"/>
              <p:cNvSpPr>
                <a:spLocks noChangeArrowheads="1"/>
              </p:cNvSpPr>
              <p:nvPr/>
            </p:nvSpPr>
            <p:spPr bwMode="auto">
              <a:xfrm>
                <a:off x="816948" y="633563"/>
                <a:ext cx="43980" cy="614567"/>
              </a:xfrm>
              <a:prstGeom prst="rect">
                <a:avLst/>
              </a:prstGeom>
              <a:solidFill>
                <a:srgbClr val="9999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58" name="Freeform 434"/>
              <p:cNvSpPr>
                <a:spLocks noEditPoints="1"/>
              </p:cNvSpPr>
              <p:nvPr/>
            </p:nvSpPr>
            <p:spPr bwMode="auto">
              <a:xfrm>
                <a:off x="814854" y="631706"/>
                <a:ext cx="48168" cy="618280"/>
              </a:xfrm>
              <a:custGeom>
                <a:avLst/>
                <a:gdLst/>
                <a:ahLst/>
                <a:cxnLst>
                  <a:cxn ang="0">
                    <a:pos x="0" y="8"/>
                  </a:cxn>
                  <a:cxn ang="0">
                    <a:pos x="8" y="0"/>
                  </a:cxn>
                  <a:cxn ang="0">
                    <a:pos x="168" y="0"/>
                  </a:cxn>
                  <a:cxn ang="0">
                    <a:pos x="176" y="8"/>
                  </a:cxn>
                  <a:cxn ang="0">
                    <a:pos x="176" y="2600"/>
                  </a:cxn>
                  <a:cxn ang="0">
                    <a:pos x="168" y="2608"/>
                  </a:cxn>
                  <a:cxn ang="0">
                    <a:pos x="8" y="2608"/>
                  </a:cxn>
                  <a:cxn ang="0">
                    <a:pos x="0" y="2600"/>
                  </a:cxn>
                  <a:cxn ang="0">
                    <a:pos x="0" y="8"/>
                  </a:cxn>
                  <a:cxn ang="0">
                    <a:pos x="16" y="2600"/>
                  </a:cxn>
                  <a:cxn ang="0">
                    <a:pos x="8" y="2592"/>
                  </a:cxn>
                  <a:cxn ang="0">
                    <a:pos x="168" y="2592"/>
                  </a:cxn>
                  <a:cxn ang="0">
                    <a:pos x="160" y="2600"/>
                  </a:cxn>
                  <a:cxn ang="0">
                    <a:pos x="160" y="8"/>
                  </a:cxn>
                  <a:cxn ang="0">
                    <a:pos x="168" y="16"/>
                  </a:cxn>
                  <a:cxn ang="0">
                    <a:pos x="8" y="16"/>
                  </a:cxn>
                  <a:cxn ang="0">
                    <a:pos x="16" y="8"/>
                  </a:cxn>
                  <a:cxn ang="0">
                    <a:pos x="16" y="2600"/>
                  </a:cxn>
                </a:cxnLst>
                <a:rect l="0" t="0" r="r" b="b"/>
                <a:pathLst>
                  <a:path w="176" h="2608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168" y="0"/>
                    </a:lnTo>
                    <a:cubicBezTo>
                      <a:pt x="173" y="0"/>
                      <a:pt x="176" y="4"/>
                      <a:pt x="176" y="8"/>
                    </a:cubicBezTo>
                    <a:lnTo>
                      <a:pt x="176" y="2600"/>
                    </a:lnTo>
                    <a:cubicBezTo>
                      <a:pt x="176" y="2605"/>
                      <a:pt x="173" y="2608"/>
                      <a:pt x="168" y="2608"/>
                    </a:cubicBezTo>
                    <a:lnTo>
                      <a:pt x="8" y="2608"/>
                    </a:lnTo>
                    <a:cubicBezTo>
                      <a:pt x="4" y="2608"/>
                      <a:pt x="0" y="2605"/>
                      <a:pt x="0" y="2600"/>
                    </a:cubicBezTo>
                    <a:lnTo>
                      <a:pt x="0" y="8"/>
                    </a:lnTo>
                    <a:close/>
                    <a:moveTo>
                      <a:pt x="16" y="2600"/>
                    </a:moveTo>
                    <a:lnTo>
                      <a:pt x="8" y="2592"/>
                    </a:lnTo>
                    <a:lnTo>
                      <a:pt x="168" y="2592"/>
                    </a:lnTo>
                    <a:lnTo>
                      <a:pt x="160" y="2600"/>
                    </a:lnTo>
                    <a:lnTo>
                      <a:pt x="160" y="8"/>
                    </a:lnTo>
                    <a:lnTo>
                      <a:pt x="168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2600"/>
                    </a:lnTo>
                    <a:close/>
                  </a:path>
                </a:pathLst>
              </a:custGeom>
              <a:solidFill>
                <a:srgbClr val="000000"/>
              </a:solidFill>
              <a:ln w="793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59" name="Rectangle 435"/>
              <p:cNvSpPr>
                <a:spLocks noChangeArrowheads="1"/>
              </p:cNvSpPr>
              <p:nvPr/>
            </p:nvSpPr>
            <p:spPr bwMode="auto">
              <a:xfrm>
                <a:off x="942605" y="1054105"/>
                <a:ext cx="43980" cy="194025"/>
              </a:xfrm>
              <a:prstGeom prst="rect">
                <a:avLst/>
              </a:prstGeom>
              <a:solidFill>
                <a:srgbClr val="9999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60" name="Freeform 436"/>
              <p:cNvSpPr>
                <a:spLocks noEditPoints="1"/>
              </p:cNvSpPr>
              <p:nvPr/>
            </p:nvSpPr>
            <p:spPr bwMode="auto">
              <a:xfrm>
                <a:off x="940511" y="1052248"/>
                <a:ext cx="48168" cy="197739"/>
              </a:xfrm>
              <a:custGeom>
                <a:avLst/>
                <a:gdLst/>
                <a:ahLst/>
                <a:cxnLst>
                  <a:cxn ang="0">
                    <a:pos x="0" y="8"/>
                  </a:cxn>
                  <a:cxn ang="0">
                    <a:pos x="8" y="0"/>
                  </a:cxn>
                  <a:cxn ang="0">
                    <a:pos x="168" y="0"/>
                  </a:cxn>
                  <a:cxn ang="0">
                    <a:pos x="176" y="8"/>
                  </a:cxn>
                  <a:cxn ang="0">
                    <a:pos x="176" y="824"/>
                  </a:cxn>
                  <a:cxn ang="0">
                    <a:pos x="168" y="832"/>
                  </a:cxn>
                  <a:cxn ang="0">
                    <a:pos x="8" y="832"/>
                  </a:cxn>
                  <a:cxn ang="0">
                    <a:pos x="0" y="824"/>
                  </a:cxn>
                  <a:cxn ang="0">
                    <a:pos x="0" y="8"/>
                  </a:cxn>
                  <a:cxn ang="0">
                    <a:pos x="16" y="824"/>
                  </a:cxn>
                  <a:cxn ang="0">
                    <a:pos x="8" y="816"/>
                  </a:cxn>
                  <a:cxn ang="0">
                    <a:pos x="168" y="816"/>
                  </a:cxn>
                  <a:cxn ang="0">
                    <a:pos x="160" y="824"/>
                  </a:cxn>
                  <a:cxn ang="0">
                    <a:pos x="160" y="8"/>
                  </a:cxn>
                  <a:cxn ang="0">
                    <a:pos x="168" y="16"/>
                  </a:cxn>
                  <a:cxn ang="0">
                    <a:pos x="8" y="16"/>
                  </a:cxn>
                  <a:cxn ang="0">
                    <a:pos x="16" y="8"/>
                  </a:cxn>
                  <a:cxn ang="0">
                    <a:pos x="16" y="824"/>
                  </a:cxn>
                </a:cxnLst>
                <a:rect l="0" t="0" r="r" b="b"/>
                <a:pathLst>
                  <a:path w="176" h="832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168" y="0"/>
                    </a:lnTo>
                    <a:cubicBezTo>
                      <a:pt x="173" y="0"/>
                      <a:pt x="176" y="4"/>
                      <a:pt x="176" y="8"/>
                    </a:cubicBezTo>
                    <a:lnTo>
                      <a:pt x="176" y="824"/>
                    </a:lnTo>
                    <a:cubicBezTo>
                      <a:pt x="176" y="829"/>
                      <a:pt x="173" y="832"/>
                      <a:pt x="168" y="832"/>
                    </a:cubicBezTo>
                    <a:lnTo>
                      <a:pt x="8" y="832"/>
                    </a:lnTo>
                    <a:cubicBezTo>
                      <a:pt x="4" y="832"/>
                      <a:pt x="0" y="829"/>
                      <a:pt x="0" y="824"/>
                    </a:cubicBezTo>
                    <a:lnTo>
                      <a:pt x="0" y="8"/>
                    </a:lnTo>
                    <a:close/>
                    <a:moveTo>
                      <a:pt x="16" y="824"/>
                    </a:moveTo>
                    <a:lnTo>
                      <a:pt x="8" y="816"/>
                    </a:lnTo>
                    <a:lnTo>
                      <a:pt x="168" y="816"/>
                    </a:lnTo>
                    <a:lnTo>
                      <a:pt x="160" y="824"/>
                    </a:lnTo>
                    <a:lnTo>
                      <a:pt x="160" y="8"/>
                    </a:lnTo>
                    <a:lnTo>
                      <a:pt x="168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824"/>
                    </a:lnTo>
                    <a:close/>
                  </a:path>
                </a:pathLst>
              </a:custGeom>
              <a:solidFill>
                <a:srgbClr val="000000"/>
              </a:solidFill>
              <a:ln w="793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61" name="Rectangle 437"/>
              <p:cNvSpPr>
                <a:spLocks noChangeArrowheads="1"/>
              </p:cNvSpPr>
              <p:nvPr/>
            </p:nvSpPr>
            <p:spPr bwMode="auto">
              <a:xfrm>
                <a:off x="1069309" y="701332"/>
                <a:ext cx="43980" cy="546798"/>
              </a:xfrm>
              <a:prstGeom prst="rect">
                <a:avLst/>
              </a:prstGeom>
              <a:solidFill>
                <a:srgbClr val="9999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62" name="Freeform 438"/>
              <p:cNvSpPr>
                <a:spLocks noEditPoints="1"/>
              </p:cNvSpPr>
              <p:nvPr/>
            </p:nvSpPr>
            <p:spPr bwMode="auto">
              <a:xfrm>
                <a:off x="1067215" y="699476"/>
                <a:ext cx="48168" cy="550511"/>
              </a:xfrm>
              <a:custGeom>
                <a:avLst/>
                <a:gdLst/>
                <a:ahLst/>
                <a:cxnLst>
                  <a:cxn ang="0">
                    <a:pos x="0" y="8"/>
                  </a:cxn>
                  <a:cxn ang="0">
                    <a:pos x="8" y="0"/>
                  </a:cxn>
                  <a:cxn ang="0">
                    <a:pos x="168" y="0"/>
                  </a:cxn>
                  <a:cxn ang="0">
                    <a:pos x="176" y="8"/>
                  </a:cxn>
                  <a:cxn ang="0">
                    <a:pos x="176" y="2312"/>
                  </a:cxn>
                  <a:cxn ang="0">
                    <a:pos x="168" y="2320"/>
                  </a:cxn>
                  <a:cxn ang="0">
                    <a:pos x="8" y="2320"/>
                  </a:cxn>
                  <a:cxn ang="0">
                    <a:pos x="0" y="2312"/>
                  </a:cxn>
                  <a:cxn ang="0">
                    <a:pos x="0" y="8"/>
                  </a:cxn>
                  <a:cxn ang="0">
                    <a:pos x="16" y="2312"/>
                  </a:cxn>
                  <a:cxn ang="0">
                    <a:pos x="8" y="2304"/>
                  </a:cxn>
                  <a:cxn ang="0">
                    <a:pos x="168" y="2304"/>
                  </a:cxn>
                  <a:cxn ang="0">
                    <a:pos x="160" y="2312"/>
                  </a:cxn>
                  <a:cxn ang="0">
                    <a:pos x="160" y="8"/>
                  </a:cxn>
                  <a:cxn ang="0">
                    <a:pos x="168" y="16"/>
                  </a:cxn>
                  <a:cxn ang="0">
                    <a:pos x="8" y="16"/>
                  </a:cxn>
                  <a:cxn ang="0">
                    <a:pos x="16" y="8"/>
                  </a:cxn>
                  <a:cxn ang="0">
                    <a:pos x="16" y="2312"/>
                  </a:cxn>
                </a:cxnLst>
                <a:rect l="0" t="0" r="r" b="b"/>
                <a:pathLst>
                  <a:path w="176" h="2320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168" y="0"/>
                    </a:lnTo>
                    <a:cubicBezTo>
                      <a:pt x="173" y="0"/>
                      <a:pt x="176" y="4"/>
                      <a:pt x="176" y="8"/>
                    </a:cubicBezTo>
                    <a:lnTo>
                      <a:pt x="176" y="2312"/>
                    </a:lnTo>
                    <a:cubicBezTo>
                      <a:pt x="176" y="2317"/>
                      <a:pt x="173" y="2320"/>
                      <a:pt x="168" y="2320"/>
                    </a:cubicBezTo>
                    <a:lnTo>
                      <a:pt x="8" y="2320"/>
                    </a:lnTo>
                    <a:cubicBezTo>
                      <a:pt x="4" y="2320"/>
                      <a:pt x="0" y="2317"/>
                      <a:pt x="0" y="2312"/>
                    </a:cubicBezTo>
                    <a:lnTo>
                      <a:pt x="0" y="8"/>
                    </a:lnTo>
                    <a:close/>
                    <a:moveTo>
                      <a:pt x="16" y="2312"/>
                    </a:moveTo>
                    <a:lnTo>
                      <a:pt x="8" y="2304"/>
                    </a:lnTo>
                    <a:lnTo>
                      <a:pt x="168" y="2304"/>
                    </a:lnTo>
                    <a:lnTo>
                      <a:pt x="160" y="2312"/>
                    </a:lnTo>
                    <a:lnTo>
                      <a:pt x="160" y="8"/>
                    </a:lnTo>
                    <a:lnTo>
                      <a:pt x="168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2312"/>
                    </a:lnTo>
                    <a:close/>
                  </a:path>
                </a:pathLst>
              </a:custGeom>
              <a:solidFill>
                <a:srgbClr val="000000"/>
              </a:solidFill>
              <a:ln w="793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63" name="Rectangle 439"/>
              <p:cNvSpPr>
                <a:spLocks noChangeArrowheads="1"/>
              </p:cNvSpPr>
              <p:nvPr/>
            </p:nvSpPr>
            <p:spPr bwMode="auto">
              <a:xfrm>
                <a:off x="1200201" y="557438"/>
                <a:ext cx="38744" cy="690691"/>
              </a:xfrm>
              <a:prstGeom prst="rect">
                <a:avLst/>
              </a:prstGeom>
              <a:solidFill>
                <a:srgbClr val="9999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64" name="Freeform 440"/>
              <p:cNvSpPr>
                <a:spLocks noEditPoints="1"/>
              </p:cNvSpPr>
              <p:nvPr/>
            </p:nvSpPr>
            <p:spPr bwMode="auto">
              <a:xfrm>
                <a:off x="1198107" y="555581"/>
                <a:ext cx="42933" cy="694405"/>
              </a:xfrm>
              <a:custGeom>
                <a:avLst/>
                <a:gdLst/>
                <a:ahLst/>
                <a:cxnLst>
                  <a:cxn ang="0">
                    <a:pos x="0" y="8"/>
                  </a:cxn>
                  <a:cxn ang="0">
                    <a:pos x="8" y="0"/>
                  </a:cxn>
                  <a:cxn ang="0">
                    <a:pos x="152" y="0"/>
                  </a:cxn>
                  <a:cxn ang="0">
                    <a:pos x="160" y="8"/>
                  </a:cxn>
                  <a:cxn ang="0">
                    <a:pos x="160" y="2920"/>
                  </a:cxn>
                  <a:cxn ang="0">
                    <a:pos x="152" y="2928"/>
                  </a:cxn>
                  <a:cxn ang="0">
                    <a:pos x="8" y="2928"/>
                  </a:cxn>
                  <a:cxn ang="0">
                    <a:pos x="0" y="2920"/>
                  </a:cxn>
                  <a:cxn ang="0">
                    <a:pos x="0" y="8"/>
                  </a:cxn>
                  <a:cxn ang="0">
                    <a:pos x="16" y="2920"/>
                  </a:cxn>
                  <a:cxn ang="0">
                    <a:pos x="8" y="2912"/>
                  </a:cxn>
                  <a:cxn ang="0">
                    <a:pos x="152" y="2912"/>
                  </a:cxn>
                  <a:cxn ang="0">
                    <a:pos x="144" y="2920"/>
                  </a:cxn>
                  <a:cxn ang="0">
                    <a:pos x="144" y="8"/>
                  </a:cxn>
                  <a:cxn ang="0">
                    <a:pos x="152" y="16"/>
                  </a:cxn>
                  <a:cxn ang="0">
                    <a:pos x="8" y="16"/>
                  </a:cxn>
                  <a:cxn ang="0">
                    <a:pos x="16" y="8"/>
                  </a:cxn>
                  <a:cxn ang="0">
                    <a:pos x="16" y="2920"/>
                  </a:cxn>
                </a:cxnLst>
                <a:rect l="0" t="0" r="r" b="b"/>
                <a:pathLst>
                  <a:path w="160" h="2928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152" y="0"/>
                    </a:lnTo>
                    <a:cubicBezTo>
                      <a:pt x="157" y="0"/>
                      <a:pt x="160" y="4"/>
                      <a:pt x="160" y="8"/>
                    </a:cubicBezTo>
                    <a:lnTo>
                      <a:pt x="160" y="2920"/>
                    </a:lnTo>
                    <a:cubicBezTo>
                      <a:pt x="160" y="2925"/>
                      <a:pt x="157" y="2928"/>
                      <a:pt x="152" y="2928"/>
                    </a:cubicBezTo>
                    <a:lnTo>
                      <a:pt x="8" y="2928"/>
                    </a:lnTo>
                    <a:cubicBezTo>
                      <a:pt x="4" y="2928"/>
                      <a:pt x="0" y="2925"/>
                      <a:pt x="0" y="2920"/>
                    </a:cubicBezTo>
                    <a:lnTo>
                      <a:pt x="0" y="8"/>
                    </a:lnTo>
                    <a:close/>
                    <a:moveTo>
                      <a:pt x="16" y="2920"/>
                    </a:moveTo>
                    <a:lnTo>
                      <a:pt x="8" y="2912"/>
                    </a:lnTo>
                    <a:lnTo>
                      <a:pt x="152" y="2912"/>
                    </a:lnTo>
                    <a:lnTo>
                      <a:pt x="144" y="2920"/>
                    </a:lnTo>
                    <a:lnTo>
                      <a:pt x="144" y="8"/>
                    </a:lnTo>
                    <a:lnTo>
                      <a:pt x="152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2920"/>
                    </a:lnTo>
                    <a:close/>
                  </a:path>
                </a:pathLst>
              </a:custGeom>
              <a:solidFill>
                <a:srgbClr val="000000"/>
              </a:solidFill>
              <a:ln w="793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65" name="Rectangle 441"/>
              <p:cNvSpPr>
                <a:spLocks noChangeArrowheads="1"/>
              </p:cNvSpPr>
              <p:nvPr/>
            </p:nvSpPr>
            <p:spPr bwMode="auto">
              <a:xfrm>
                <a:off x="1325858" y="424684"/>
                <a:ext cx="43980" cy="823446"/>
              </a:xfrm>
              <a:prstGeom prst="rect">
                <a:avLst/>
              </a:prstGeom>
              <a:solidFill>
                <a:srgbClr val="9999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66" name="Freeform 442"/>
              <p:cNvSpPr>
                <a:spLocks noEditPoints="1"/>
              </p:cNvSpPr>
              <p:nvPr/>
            </p:nvSpPr>
            <p:spPr bwMode="auto">
              <a:xfrm>
                <a:off x="1323764" y="422828"/>
                <a:ext cx="48168" cy="827159"/>
              </a:xfrm>
              <a:custGeom>
                <a:avLst/>
                <a:gdLst/>
                <a:ahLst/>
                <a:cxnLst>
                  <a:cxn ang="0">
                    <a:pos x="0" y="8"/>
                  </a:cxn>
                  <a:cxn ang="0">
                    <a:pos x="8" y="0"/>
                  </a:cxn>
                  <a:cxn ang="0">
                    <a:pos x="168" y="0"/>
                  </a:cxn>
                  <a:cxn ang="0">
                    <a:pos x="176" y="8"/>
                  </a:cxn>
                  <a:cxn ang="0">
                    <a:pos x="176" y="3480"/>
                  </a:cxn>
                  <a:cxn ang="0">
                    <a:pos x="168" y="3488"/>
                  </a:cxn>
                  <a:cxn ang="0">
                    <a:pos x="8" y="3488"/>
                  </a:cxn>
                  <a:cxn ang="0">
                    <a:pos x="0" y="3480"/>
                  </a:cxn>
                  <a:cxn ang="0">
                    <a:pos x="0" y="8"/>
                  </a:cxn>
                  <a:cxn ang="0">
                    <a:pos x="16" y="3480"/>
                  </a:cxn>
                  <a:cxn ang="0">
                    <a:pos x="8" y="3472"/>
                  </a:cxn>
                  <a:cxn ang="0">
                    <a:pos x="168" y="3472"/>
                  </a:cxn>
                  <a:cxn ang="0">
                    <a:pos x="160" y="3480"/>
                  </a:cxn>
                  <a:cxn ang="0">
                    <a:pos x="160" y="8"/>
                  </a:cxn>
                  <a:cxn ang="0">
                    <a:pos x="168" y="16"/>
                  </a:cxn>
                  <a:cxn ang="0">
                    <a:pos x="8" y="16"/>
                  </a:cxn>
                  <a:cxn ang="0">
                    <a:pos x="16" y="8"/>
                  </a:cxn>
                  <a:cxn ang="0">
                    <a:pos x="16" y="3480"/>
                  </a:cxn>
                </a:cxnLst>
                <a:rect l="0" t="0" r="r" b="b"/>
                <a:pathLst>
                  <a:path w="176" h="3488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168" y="0"/>
                    </a:lnTo>
                    <a:cubicBezTo>
                      <a:pt x="173" y="0"/>
                      <a:pt x="176" y="4"/>
                      <a:pt x="176" y="8"/>
                    </a:cubicBezTo>
                    <a:lnTo>
                      <a:pt x="176" y="3480"/>
                    </a:lnTo>
                    <a:cubicBezTo>
                      <a:pt x="176" y="3485"/>
                      <a:pt x="173" y="3488"/>
                      <a:pt x="168" y="3488"/>
                    </a:cubicBezTo>
                    <a:lnTo>
                      <a:pt x="8" y="3488"/>
                    </a:lnTo>
                    <a:cubicBezTo>
                      <a:pt x="4" y="3488"/>
                      <a:pt x="0" y="3485"/>
                      <a:pt x="0" y="3480"/>
                    </a:cubicBezTo>
                    <a:lnTo>
                      <a:pt x="0" y="8"/>
                    </a:lnTo>
                    <a:close/>
                    <a:moveTo>
                      <a:pt x="16" y="3480"/>
                    </a:moveTo>
                    <a:lnTo>
                      <a:pt x="8" y="3472"/>
                    </a:lnTo>
                    <a:lnTo>
                      <a:pt x="168" y="3472"/>
                    </a:lnTo>
                    <a:lnTo>
                      <a:pt x="160" y="3480"/>
                    </a:lnTo>
                    <a:lnTo>
                      <a:pt x="160" y="8"/>
                    </a:lnTo>
                    <a:lnTo>
                      <a:pt x="168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3480"/>
                    </a:lnTo>
                    <a:close/>
                  </a:path>
                </a:pathLst>
              </a:custGeom>
              <a:solidFill>
                <a:srgbClr val="000000"/>
              </a:solidFill>
              <a:ln w="793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67" name="Rectangle 443"/>
              <p:cNvSpPr>
                <a:spLocks noChangeArrowheads="1"/>
              </p:cNvSpPr>
              <p:nvPr/>
            </p:nvSpPr>
            <p:spPr bwMode="auto">
              <a:xfrm>
                <a:off x="1452562" y="1042965"/>
                <a:ext cx="42933" cy="205165"/>
              </a:xfrm>
              <a:prstGeom prst="rect">
                <a:avLst/>
              </a:prstGeom>
              <a:solidFill>
                <a:srgbClr val="9999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68" name="Freeform 444"/>
              <p:cNvSpPr>
                <a:spLocks noEditPoints="1"/>
              </p:cNvSpPr>
              <p:nvPr/>
            </p:nvSpPr>
            <p:spPr bwMode="auto">
              <a:xfrm>
                <a:off x="1450468" y="1041108"/>
                <a:ext cx="47122" cy="208879"/>
              </a:xfrm>
              <a:custGeom>
                <a:avLst/>
                <a:gdLst/>
                <a:ahLst/>
                <a:cxnLst>
                  <a:cxn ang="0">
                    <a:pos x="0" y="8"/>
                  </a:cxn>
                  <a:cxn ang="0">
                    <a:pos x="8" y="0"/>
                  </a:cxn>
                  <a:cxn ang="0">
                    <a:pos x="168" y="0"/>
                  </a:cxn>
                  <a:cxn ang="0">
                    <a:pos x="176" y="8"/>
                  </a:cxn>
                  <a:cxn ang="0">
                    <a:pos x="176" y="872"/>
                  </a:cxn>
                  <a:cxn ang="0">
                    <a:pos x="168" y="880"/>
                  </a:cxn>
                  <a:cxn ang="0">
                    <a:pos x="8" y="880"/>
                  </a:cxn>
                  <a:cxn ang="0">
                    <a:pos x="0" y="872"/>
                  </a:cxn>
                  <a:cxn ang="0">
                    <a:pos x="0" y="8"/>
                  </a:cxn>
                  <a:cxn ang="0">
                    <a:pos x="16" y="872"/>
                  </a:cxn>
                  <a:cxn ang="0">
                    <a:pos x="8" y="864"/>
                  </a:cxn>
                  <a:cxn ang="0">
                    <a:pos x="168" y="864"/>
                  </a:cxn>
                  <a:cxn ang="0">
                    <a:pos x="160" y="872"/>
                  </a:cxn>
                  <a:cxn ang="0">
                    <a:pos x="160" y="8"/>
                  </a:cxn>
                  <a:cxn ang="0">
                    <a:pos x="168" y="16"/>
                  </a:cxn>
                  <a:cxn ang="0">
                    <a:pos x="8" y="16"/>
                  </a:cxn>
                  <a:cxn ang="0">
                    <a:pos x="16" y="8"/>
                  </a:cxn>
                  <a:cxn ang="0">
                    <a:pos x="16" y="872"/>
                  </a:cxn>
                </a:cxnLst>
                <a:rect l="0" t="0" r="r" b="b"/>
                <a:pathLst>
                  <a:path w="176" h="880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168" y="0"/>
                    </a:lnTo>
                    <a:cubicBezTo>
                      <a:pt x="173" y="0"/>
                      <a:pt x="176" y="4"/>
                      <a:pt x="176" y="8"/>
                    </a:cubicBezTo>
                    <a:lnTo>
                      <a:pt x="176" y="872"/>
                    </a:lnTo>
                    <a:cubicBezTo>
                      <a:pt x="176" y="877"/>
                      <a:pt x="173" y="880"/>
                      <a:pt x="168" y="880"/>
                    </a:cubicBezTo>
                    <a:lnTo>
                      <a:pt x="8" y="880"/>
                    </a:lnTo>
                    <a:cubicBezTo>
                      <a:pt x="4" y="880"/>
                      <a:pt x="0" y="877"/>
                      <a:pt x="0" y="872"/>
                    </a:cubicBezTo>
                    <a:lnTo>
                      <a:pt x="0" y="8"/>
                    </a:lnTo>
                    <a:close/>
                    <a:moveTo>
                      <a:pt x="16" y="872"/>
                    </a:moveTo>
                    <a:lnTo>
                      <a:pt x="8" y="864"/>
                    </a:lnTo>
                    <a:lnTo>
                      <a:pt x="168" y="864"/>
                    </a:lnTo>
                    <a:lnTo>
                      <a:pt x="160" y="872"/>
                    </a:lnTo>
                    <a:lnTo>
                      <a:pt x="160" y="8"/>
                    </a:lnTo>
                    <a:lnTo>
                      <a:pt x="168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872"/>
                    </a:lnTo>
                    <a:close/>
                  </a:path>
                </a:pathLst>
              </a:custGeom>
              <a:solidFill>
                <a:srgbClr val="000000"/>
              </a:solidFill>
              <a:ln w="793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69" name="Rectangle 445"/>
              <p:cNvSpPr>
                <a:spLocks noChangeArrowheads="1"/>
              </p:cNvSpPr>
              <p:nvPr/>
            </p:nvSpPr>
            <p:spPr bwMode="auto">
              <a:xfrm>
                <a:off x="1578219" y="830372"/>
                <a:ext cx="43980" cy="417757"/>
              </a:xfrm>
              <a:prstGeom prst="rect">
                <a:avLst/>
              </a:prstGeom>
              <a:solidFill>
                <a:srgbClr val="9999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70" name="Freeform 446"/>
              <p:cNvSpPr>
                <a:spLocks noEditPoints="1"/>
              </p:cNvSpPr>
              <p:nvPr/>
            </p:nvSpPr>
            <p:spPr bwMode="auto">
              <a:xfrm>
                <a:off x="1576125" y="828516"/>
                <a:ext cx="48168" cy="421470"/>
              </a:xfrm>
              <a:custGeom>
                <a:avLst/>
                <a:gdLst/>
                <a:ahLst/>
                <a:cxnLst>
                  <a:cxn ang="0">
                    <a:pos x="0" y="8"/>
                  </a:cxn>
                  <a:cxn ang="0">
                    <a:pos x="8" y="0"/>
                  </a:cxn>
                  <a:cxn ang="0">
                    <a:pos x="168" y="0"/>
                  </a:cxn>
                  <a:cxn ang="0">
                    <a:pos x="176" y="8"/>
                  </a:cxn>
                  <a:cxn ang="0">
                    <a:pos x="176" y="1768"/>
                  </a:cxn>
                  <a:cxn ang="0">
                    <a:pos x="168" y="1776"/>
                  </a:cxn>
                  <a:cxn ang="0">
                    <a:pos x="8" y="1776"/>
                  </a:cxn>
                  <a:cxn ang="0">
                    <a:pos x="0" y="1768"/>
                  </a:cxn>
                  <a:cxn ang="0">
                    <a:pos x="0" y="8"/>
                  </a:cxn>
                  <a:cxn ang="0">
                    <a:pos x="16" y="1768"/>
                  </a:cxn>
                  <a:cxn ang="0">
                    <a:pos x="8" y="1760"/>
                  </a:cxn>
                  <a:cxn ang="0">
                    <a:pos x="168" y="1760"/>
                  </a:cxn>
                  <a:cxn ang="0">
                    <a:pos x="160" y="1768"/>
                  </a:cxn>
                  <a:cxn ang="0">
                    <a:pos x="160" y="8"/>
                  </a:cxn>
                  <a:cxn ang="0">
                    <a:pos x="168" y="16"/>
                  </a:cxn>
                  <a:cxn ang="0">
                    <a:pos x="8" y="16"/>
                  </a:cxn>
                  <a:cxn ang="0">
                    <a:pos x="16" y="8"/>
                  </a:cxn>
                  <a:cxn ang="0">
                    <a:pos x="16" y="1768"/>
                  </a:cxn>
                </a:cxnLst>
                <a:rect l="0" t="0" r="r" b="b"/>
                <a:pathLst>
                  <a:path w="176" h="1776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168" y="0"/>
                    </a:lnTo>
                    <a:cubicBezTo>
                      <a:pt x="173" y="0"/>
                      <a:pt x="176" y="4"/>
                      <a:pt x="176" y="8"/>
                    </a:cubicBezTo>
                    <a:lnTo>
                      <a:pt x="176" y="1768"/>
                    </a:lnTo>
                    <a:cubicBezTo>
                      <a:pt x="176" y="1773"/>
                      <a:pt x="173" y="1776"/>
                      <a:pt x="168" y="1776"/>
                    </a:cubicBezTo>
                    <a:lnTo>
                      <a:pt x="8" y="1776"/>
                    </a:lnTo>
                    <a:cubicBezTo>
                      <a:pt x="4" y="1776"/>
                      <a:pt x="0" y="1773"/>
                      <a:pt x="0" y="1768"/>
                    </a:cubicBezTo>
                    <a:lnTo>
                      <a:pt x="0" y="8"/>
                    </a:lnTo>
                    <a:close/>
                    <a:moveTo>
                      <a:pt x="16" y="1768"/>
                    </a:moveTo>
                    <a:lnTo>
                      <a:pt x="8" y="1760"/>
                    </a:lnTo>
                    <a:lnTo>
                      <a:pt x="168" y="1760"/>
                    </a:lnTo>
                    <a:lnTo>
                      <a:pt x="160" y="1768"/>
                    </a:lnTo>
                    <a:lnTo>
                      <a:pt x="160" y="8"/>
                    </a:lnTo>
                    <a:lnTo>
                      <a:pt x="168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1768"/>
                    </a:lnTo>
                    <a:close/>
                  </a:path>
                </a:pathLst>
              </a:custGeom>
              <a:solidFill>
                <a:srgbClr val="000000"/>
              </a:solidFill>
              <a:ln w="793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71" name="Rectangle 447"/>
              <p:cNvSpPr>
                <a:spLocks noChangeArrowheads="1"/>
              </p:cNvSpPr>
              <p:nvPr/>
            </p:nvSpPr>
            <p:spPr bwMode="auto">
              <a:xfrm>
                <a:off x="1709111" y="735681"/>
                <a:ext cx="38744" cy="512448"/>
              </a:xfrm>
              <a:prstGeom prst="rect">
                <a:avLst/>
              </a:prstGeom>
              <a:solidFill>
                <a:srgbClr val="9999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72" name="Freeform 448"/>
              <p:cNvSpPr>
                <a:spLocks noEditPoints="1"/>
              </p:cNvSpPr>
              <p:nvPr/>
            </p:nvSpPr>
            <p:spPr bwMode="auto">
              <a:xfrm>
                <a:off x="1707017" y="733824"/>
                <a:ext cx="42933" cy="516162"/>
              </a:xfrm>
              <a:custGeom>
                <a:avLst/>
                <a:gdLst/>
                <a:ahLst/>
                <a:cxnLst>
                  <a:cxn ang="0">
                    <a:pos x="0" y="8"/>
                  </a:cxn>
                  <a:cxn ang="0">
                    <a:pos x="8" y="0"/>
                  </a:cxn>
                  <a:cxn ang="0">
                    <a:pos x="152" y="0"/>
                  </a:cxn>
                  <a:cxn ang="0">
                    <a:pos x="160" y="8"/>
                  </a:cxn>
                  <a:cxn ang="0">
                    <a:pos x="160" y="2168"/>
                  </a:cxn>
                  <a:cxn ang="0">
                    <a:pos x="152" y="2176"/>
                  </a:cxn>
                  <a:cxn ang="0">
                    <a:pos x="8" y="2176"/>
                  </a:cxn>
                  <a:cxn ang="0">
                    <a:pos x="0" y="2168"/>
                  </a:cxn>
                  <a:cxn ang="0">
                    <a:pos x="0" y="8"/>
                  </a:cxn>
                  <a:cxn ang="0">
                    <a:pos x="16" y="2168"/>
                  </a:cxn>
                  <a:cxn ang="0">
                    <a:pos x="8" y="2160"/>
                  </a:cxn>
                  <a:cxn ang="0">
                    <a:pos x="152" y="2160"/>
                  </a:cxn>
                  <a:cxn ang="0">
                    <a:pos x="144" y="2168"/>
                  </a:cxn>
                  <a:cxn ang="0">
                    <a:pos x="144" y="8"/>
                  </a:cxn>
                  <a:cxn ang="0">
                    <a:pos x="152" y="16"/>
                  </a:cxn>
                  <a:cxn ang="0">
                    <a:pos x="8" y="16"/>
                  </a:cxn>
                  <a:cxn ang="0">
                    <a:pos x="16" y="8"/>
                  </a:cxn>
                  <a:cxn ang="0">
                    <a:pos x="16" y="2168"/>
                  </a:cxn>
                </a:cxnLst>
                <a:rect l="0" t="0" r="r" b="b"/>
                <a:pathLst>
                  <a:path w="160" h="2176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152" y="0"/>
                    </a:lnTo>
                    <a:cubicBezTo>
                      <a:pt x="157" y="0"/>
                      <a:pt x="160" y="4"/>
                      <a:pt x="160" y="8"/>
                    </a:cubicBezTo>
                    <a:lnTo>
                      <a:pt x="160" y="2168"/>
                    </a:lnTo>
                    <a:cubicBezTo>
                      <a:pt x="160" y="2173"/>
                      <a:pt x="157" y="2176"/>
                      <a:pt x="152" y="2176"/>
                    </a:cubicBezTo>
                    <a:lnTo>
                      <a:pt x="8" y="2176"/>
                    </a:lnTo>
                    <a:cubicBezTo>
                      <a:pt x="4" y="2176"/>
                      <a:pt x="0" y="2173"/>
                      <a:pt x="0" y="2168"/>
                    </a:cubicBezTo>
                    <a:lnTo>
                      <a:pt x="0" y="8"/>
                    </a:lnTo>
                    <a:close/>
                    <a:moveTo>
                      <a:pt x="16" y="2168"/>
                    </a:moveTo>
                    <a:lnTo>
                      <a:pt x="8" y="2160"/>
                    </a:lnTo>
                    <a:lnTo>
                      <a:pt x="152" y="2160"/>
                    </a:lnTo>
                    <a:lnTo>
                      <a:pt x="144" y="2168"/>
                    </a:lnTo>
                    <a:lnTo>
                      <a:pt x="144" y="8"/>
                    </a:lnTo>
                    <a:lnTo>
                      <a:pt x="152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2168"/>
                    </a:lnTo>
                    <a:close/>
                  </a:path>
                </a:pathLst>
              </a:custGeom>
              <a:solidFill>
                <a:srgbClr val="000000"/>
              </a:solidFill>
              <a:ln w="793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73" name="Rectangle 449"/>
              <p:cNvSpPr>
                <a:spLocks noChangeArrowheads="1"/>
              </p:cNvSpPr>
              <p:nvPr/>
            </p:nvSpPr>
            <p:spPr bwMode="auto">
              <a:xfrm>
                <a:off x="1834768" y="1073600"/>
                <a:ext cx="43980" cy="174530"/>
              </a:xfrm>
              <a:prstGeom prst="rect">
                <a:avLst/>
              </a:prstGeom>
              <a:solidFill>
                <a:srgbClr val="9999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74" name="Freeform 450"/>
              <p:cNvSpPr>
                <a:spLocks noEditPoints="1"/>
              </p:cNvSpPr>
              <p:nvPr/>
            </p:nvSpPr>
            <p:spPr bwMode="auto">
              <a:xfrm>
                <a:off x="1832674" y="1071743"/>
                <a:ext cx="48168" cy="178243"/>
              </a:xfrm>
              <a:custGeom>
                <a:avLst/>
                <a:gdLst/>
                <a:ahLst/>
                <a:cxnLst>
                  <a:cxn ang="0">
                    <a:pos x="0" y="8"/>
                  </a:cxn>
                  <a:cxn ang="0">
                    <a:pos x="8" y="0"/>
                  </a:cxn>
                  <a:cxn ang="0">
                    <a:pos x="168" y="0"/>
                  </a:cxn>
                  <a:cxn ang="0">
                    <a:pos x="176" y="8"/>
                  </a:cxn>
                  <a:cxn ang="0">
                    <a:pos x="176" y="744"/>
                  </a:cxn>
                  <a:cxn ang="0">
                    <a:pos x="168" y="752"/>
                  </a:cxn>
                  <a:cxn ang="0">
                    <a:pos x="8" y="752"/>
                  </a:cxn>
                  <a:cxn ang="0">
                    <a:pos x="0" y="744"/>
                  </a:cxn>
                  <a:cxn ang="0">
                    <a:pos x="0" y="8"/>
                  </a:cxn>
                  <a:cxn ang="0">
                    <a:pos x="16" y="744"/>
                  </a:cxn>
                  <a:cxn ang="0">
                    <a:pos x="8" y="736"/>
                  </a:cxn>
                  <a:cxn ang="0">
                    <a:pos x="168" y="736"/>
                  </a:cxn>
                  <a:cxn ang="0">
                    <a:pos x="160" y="744"/>
                  </a:cxn>
                  <a:cxn ang="0">
                    <a:pos x="160" y="8"/>
                  </a:cxn>
                  <a:cxn ang="0">
                    <a:pos x="168" y="16"/>
                  </a:cxn>
                  <a:cxn ang="0">
                    <a:pos x="8" y="16"/>
                  </a:cxn>
                  <a:cxn ang="0">
                    <a:pos x="16" y="8"/>
                  </a:cxn>
                  <a:cxn ang="0">
                    <a:pos x="16" y="744"/>
                  </a:cxn>
                </a:cxnLst>
                <a:rect l="0" t="0" r="r" b="b"/>
                <a:pathLst>
                  <a:path w="176" h="752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168" y="0"/>
                    </a:lnTo>
                    <a:cubicBezTo>
                      <a:pt x="173" y="0"/>
                      <a:pt x="176" y="4"/>
                      <a:pt x="176" y="8"/>
                    </a:cubicBezTo>
                    <a:lnTo>
                      <a:pt x="176" y="744"/>
                    </a:lnTo>
                    <a:cubicBezTo>
                      <a:pt x="176" y="749"/>
                      <a:pt x="173" y="752"/>
                      <a:pt x="168" y="752"/>
                    </a:cubicBezTo>
                    <a:lnTo>
                      <a:pt x="8" y="752"/>
                    </a:lnTo>
                    <a:cubicBezTo>
                      <a:pt x="4" y="752"/>
                      <a:pt x="0" y="749"/>
                      <a:pt x="0" y="744"/>
                    </a:cubicBezTo>
                    <a:lnTo>
                      <a:pt x="0" y="8"/>
                    </a:lnTo>
                    <a:close/>
                    <a:moveTo>
                      <a:pt x="16" y="744"/>
                    </a:moveTo>
                    <a:lnTo>
                      <a:pt x="8" y="736"/>
                    </a:lnTo>
                    <a:lnTo>
                      <a:pt x="168" y="736"/>
                    </a:lnTo>
                    <a:lnTo>
                      <a:pt x="160" y="744"/>
                    </a:lnTo>
                    <a:lnTo>
                      <a:pt x="160" y="8"/>
                    </a:lnTo>
                    <a:lnTo>
                      <a:pt x="168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744"/>
                    </a:lnTo>
                    <a:close/>
                  </a:path>
                </a:pathLst>
              </a:custGeom>
              <a:solidFill>
                <a:srgbClr val="000000"/>
              </a:solidFill>
              <a:ln w="793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75" name="Rectangle 451"/>
              <p:cNvSpPr>
                <a:spLocks noChangeArrowheads="1"/>
              </p:cNvSpPr>
              <p:nvPr/>
            </p:nvSpPr>
            <p:spPr bwMode="auto">
              <a:xfrm>
                <a:off x="1961472" y="735681"/>
                <a:ext cx="42933" cy="512448"/>
              </a:xfrm>
              <a:prstGeom prst="rect">
                <a:avLst/>
              </a:prstGeom>
              <a:solidFill>
                <a:srgbClr val="9999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76" name="Freeform 452"/>
              <p:cNvSpPr>
                <a:spLocks noEditPoints="1"/>
              </p:cNvSpPr>
              <p:nvPr/>
            </p:nvSpPr>
            <p:spPr bwMode="auto">
              <a:xfrm>
                <a:off x="1959378" y="733824"/>
                <a:ext cx="47122" cy="516162"/>
              </a:xfrm>
              <a:custGeom>
                <a:avLst/>
                <a:gdLst/>
                <a:ahLst/>
                <a:cxnLst>
                  <a:cxn ang="0">
                    <a:pos x="0" y="8"/>
                  </a:cxn>
                  <a:cxn ang="0">
                    <a:pos x="8" y="0"/>
                  </a:cxn>
                  <a:cxn ang="0">
                    <a:pos x="168" y="0"/>
                  </a:cxn>
                  <a:cxn ang="0">
                    <a:pos x="176" y="8"/>
                  </a:cxn>
                  <a:cxn ang="0">
                    <a:pos x="176" y="2168"/>
                  </a:cxn>
                  <a:cxn ang="0">
                    <a:pos x="168" y="2176"/>
                  </a:cxn>
                  <a:cxn ang="0">
                    <a:pos x="8" y="2176"/>
                  </a:cxn>
                  <a:cxn ang="0">
                    <a:pos x="0" y="2168"/>
                  </a:cxn>
                  <a:cxn ang="0">
                    <a:pos x="0" y="8"/>
                  </a:cxn>
                  <a:cxn ang="0">
                    <a:pos x="16" y="2168"/>
                  </a:cxn>
                  <a:cxn ang="0">
                    <a:pos x="8" y="2160"/>
                  </a:cxn>
                  <a:cxn ang="0">
                    <a:pos x="168" y="2160"/>
                  </a:cxn>
                  <a:cxn ang="0">
                    <a:pos x="160" y="2168"/>
                  </a:cxn>
                  <a:cxn ang="0">
                    <a:pos x="160" y="8"/>
                  </a:cxn>
                  <a:cxn ang="0">
                    <a:pos x="168" y="16"/>
                  </a:cxn>
                  <a:cxn ang="0">
                    <a:pos x="8" y="16"/>
                  </a:cxn>
                  <a:cxn ang="0">
                    <a:pos x="16" y="8"/>
                  </a:cxn>
                  <a:cxn ang="0">
                    <a:pos x="16" y="2168"/>
                  </a:cxn>
                </a:cxnLst>
                <a:rect l="0" t="0" r="r" b="b"/>
                <a:pathLst>
                  <a:path w="176" h="2176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168" y="0"/>
                    </a:lnTo>
                    <a:cubicBezTo>
                      <a:pt x="173" y="0"/>
                      <a:pt x="176" y="4"/>
                      <a:pt x="176" y="8"/>
                    </a:cubicBezTo>
                    <a:lnTo>
                      <a:pt x="176" y="2168"/>
                    </a:lnTo>
                    <a:cubicBezTo>
                      <a:pt x="176" y="2173"/>
                      <a:pt x="173" y="2176"/>
                      <a:pt x="168" y="2176"/>
                    </a:cubicBezTo>
                    <a:lnTo>
                      <a:pt x="8" y="2176"/>
                    </a:lnTo>
                    <a:cubicBezTo>
                      <a:pt x="4" y="2176"/>
                      <a:pt x="0" y="2173"/>
                      <a:pt x="0" y="2168"/>
                    </a:cubicBezTo>
                    <a:lnTo>
                      <a:pt x="0" y="8"/>
                    </a:lnTo>
                    <a:close/>
                    <a:moveTo>
                      <a:pt x="16" y="2168"/>
                    </a:moveTo>
                    <a:lnTo>
                      <a:pt x="8" y="2160"/>
                    </a:lnTo>
                    <a:lnTo>
                      <a:pt x="168" y="2160"/>
                    </a:lnTo>
                    <a:lnTo>
                      <a:pt x="160" y="2168"/>
                    </a:lnTo>
                    <a:lnTo>
                      <a:pt x="160" y="8"/>
                    </a:lnTo>
                    <a:lnTo>
                      <a:pt x="168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2168"/>
                    </a:lnTo>
                    <a:close/>
                  </a:path>
                </a:pathLst>
              </a:custGeom>
              <a:solidFill>
                <a:srgbClr val="000000"/>
              </a:solidFill>
              <a:ln w="793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77" name="Rectangle 453"/>
              <p:cNvSpPr>
                <a:spLocks noChangeArrowheads="1"/>
              </p:cNvSpPr>
              <p:nvPr/>
            </p:nvSpPr>
            <p:spPr bwMode="auto">
              <a:xfrm>
                <a:off x="2087129" y="800665"/>
                <a:ext cx="43980" cy="447464"/>
              </a:xfrm>
              <a:prstGeom prst="rect">
                <a:avLst/>
              </a:prstGeom>
              <a:solidFill>
                <a:srgbClr val="9999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78" name="Freeform 454"/>
              <p:cNvSpPr>
                <a:spLocks noEditPoints="1"/>
              </p:cNvSpPr>
              <p:nvPr/>
            </p:nvSpPr>
            <p:spPr bwMode="auto">
              <a:xfrm>
                <a:off x="2085035" y="798809"/>
                <a:ext cx="48168" cy="451177"/>
              </a:xfrm>
              <a:custGeom>
                <a:avLst/>
                <a:gdLst/>
                <a:ahLst/>
                <a:cxnLst>
                  <a:cxn ang="0">
                    <a:pos x="0" y="8"/>
                  </a:cxn>
                  <a:cxn ang="0">
                    <a:pos x="8" y="0"/>
                  </a:cxn>
                  <a:cxn ang="0">
                    <a:pos x="168" y="0"/>
                  </a:cxn>
                  <a:cxn ang="0">
                    <a:pos x="176" y="8"/>
                  </a:cxn>
                  <a:cxn ang="0">
                    <a:pos x="176" y="1896"/>
                  </a:cxn>
                  <a:cxn ang="0">
                    <a:pos x="168" y="1904"/>
                  </a:cxn>
                  <a:cxn ang="0">
                    <a:pos x="8" y="1904"/>
                  </a:cxn>
                  <a:cxn ang="0">
                    <a:pos x="0" y="1896"/>
                  </a:cxn>
                  <a:cxn ang="0">
                    <a:pos x="0" y="8"/>
                  </a:cxn>
                  <a:cxn ang="0">
                    <a:pos x="16" y="1896"/>
                  </a:cxn>
                  <a:cxn ang="0">
                    <a:pos x="8" y="1888"/>
                  </a:cxn>
                  <a:cxn ang="0">
                    <a:pos x="168" y="1888"/>
                  </a:cxn>
                  <a:cxn ang="0">
                    <a:pos x="160" y="1896"/>
                  </a:cxn>
                  <a:cxn ang="0">
                    <a:pos x="160" y="8"/>
                  </a:cxn>
                  <a:cxn ang="0">
                    <a:pos x="168" y="16"/>
                  </a:cxn>
                  <a:cxn ang="0">
                    <a:pos x="8" y="16"/>
                  </a:cxn>
                  <a:cxn ang="0">
                    <a:pos x="16" y="8"/>
                  </a:cxn>
                  <a:cxn ang="0">
                    <a:pos x="16" y="1896"/>
                  </a:cxn>
                </a:cxnLst>
                <a:rect l="0" t="0" r="r" b="b"/>
                <a:pathLst>
                  <a:path w="176" h="1904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168" y="0"/>
                    </a:lnTo>
                    <a:cubicBezTo>
                      <a:pt x="173" y="0"/>
                      <a:pt x="176" y="4"/>
                      <a:pt x="176" y="8"/>
                    </a:cubicBezTo>
                    <a:lnTo>
                      <a:pt x="176" y="1896"/>
                    </a:lnTo>
                    <a:cubicBezTo>
                      <a:pt x="176" y="1901"/>
                      <a:pt x="173" y="1904"/>
                      <a:pt x="168" y="1904"/>
                    </a:cubicBezTo>
                    <a:lnTo>
                      <a:pt x="8" y="1904"/>
                    </a:lnTo>
                    <a:cubicBezTo>
                      <a:pt x="4" y="1904"/>
                      <a:pt x="0" y="1901"/>
                      <a:pt x="0" y="1896"/>
                    </a:cubicBezTo>
                    <a:lnTo>
                      <a:pt x="0" y="8"/>
                    </a:lnTo>
                    <a:close/>
                    <a:moveTo>
                      <a:pt x="16" y="1896"/>
                    </a:moveTo>
                    <a:lnTo>
                      <a:pt x="8" y="1888"/>
                    </a:lnTo>
                    <a:lnTo>
                      <a:pt x="168" y="1888"/>
                    </a:lnTo>
                    <a:lnTo>
                      <a:pt x="160" y="1896"/>
                    </a:lnTo>
                    <a:lnTo>
                      <a:pt x="160" y="8"/>
                    </a:lnTo>
                    <a:lnTo>
                      <a:pt x="168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1896"/>
                    </a:lnTo>
                    <a:close/>
                  </a:path>
                </a:pathLst>
              </a:custGeom>
              <a:solidFill>
                <a:srgbClr val="000000"/>
              </a:solidFill>
              <a:ln w="793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79" name="Rectangle 455"/>
              <p:cNvSpPr>
                <a:spLocks noChangeArrowheads="1"/>
              </p:cNvSpPr>
              <p:nvPr/>
            </p:nvSpPr>
            <p:spPr bwMode="auto">
              <a:xfrm>
                <a:off x="2218021" y="982622"/>
                <a:ext cx="38744" cy="265508"/>
              </a:xfrm>
              <a:prstGeom prst="rect">
                <a:avLst/>
              </a:prstGeom>
              <a:solidFill>
                <a:srgbClr val="9999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80" name="Freeform 456"/>
              <p:cNvSpPr>
                <a:spLocks noEditPoints="1"/>
              </p:cNvSpPr>
              <p:nvPr/>
            </p:nvSpPr>
            <p:spPr bwMode="auto">
              <a:xfrm>
                <a:off x="2215927" y="980765"/>
                <a:ext cx="42933" cy="269221"/>
              </a:xfrm>
              <a:custGeom>
                <a:avLst/>
                <a:gdLst/>
                <a:ahLst/>
                <a:cxnLst>
                  <a:cxn ang="0">
                    <a:pos x="0" y="8"/>
                  </a:cxn>
                  <a:cxn ang="0">
                    <a:pos x="8" y="0"/>
                  </a:cxn>
                  <a:cxn ang="0">
                    <a:pos x="152" y="0"/>
                  </a:cxn>
                  <a:cxn ang="0">
                    <a:pos x="160" y="8"/>
                  </a:cxn>
                  <a:cxn ang="0">
                    <a:pos x="160" y="1128"/>
                  </a:cxn>
                  <a:cxn ang="0">
                    <a:pos x="152" y="1136"/>
                  </a:cxn>
                  <a:cxn ang="0">
                    <a:pos x="8" y="1136"/>
                  </a:cxn>
                  <a:cxn ang="0">
                    <a:pos x="0" y="1128"/>
                  </a:cxn>
                  <a:cxn ang="0">
                    <a:pos x="0" y="8"/>
                  </a:cxn>
                  <a:cxn ang="0">
                    <a:pos x="16" y="1128"/>
                  </a:cxn>
                  <a:cxn ang="0">
                    <a:pos x="8" y="1120"/>
                  </a:cxn>
                  <a:cxn ang="0">
                    <a:pos x="152" y="1120"/>
                  </a:cxn>
                  <a:cxn ang="0">
                    <a:pos x="144" y="1128"/>
                  </a:cxn>
                  <a:cxn ang="0">
                    <a:pos x="144" y="8"/>
                  </a:cxn>
                  <a:cxn ang="0">
                    <a:pos x="152" y="16"/>
                  </a:cxn>
                  <a:cxn ang="0">
                    <a:pos x="8" y="16"/>
                  </a:cxn>
                  <a:cxn ang="0">
                    <a:pos x="16" y="8"/>
                  </a:cxn>
                  <a:cxn ang="0">
                    <a:pos x="16" y="1128"/>
                  </a:cxn>
                </a:cxnLst>
                <a:rect l="0" t="0" r="r" b="b"/>
                <a:pathLst>
                  <a:path w="160" h="1136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152" y="0"/>
                    </a:lnTo>
                    <a:cubicBezTo>
                      <a:pt x="157" y="0"/>
                      <a:pt x="160" y="4"/>
                      <a:pt x="160" y="8"/>
                    </a:cubicBezTo>
                    <a:lnTo>
                      <a:pt x="160" y="1128"/>
                    </a:lnTo>
                    <a:cubicBezTo>
                      <a:pt x="160" y="1133"/>
                      <a:pt x="157" y="1136"/>
                      <a:pt x="152" y="1136"/>
                    </a:cubicBezTo>
                    <a:lnTo>
                      <a:pt x="8" y="1136"/>
                    </a:lnTo>
                    <a:cubicBezTo>
                      <a:pt x="4" y="1136"/>
                      <a:pt x="0" y="1133"/>
                      <a:pt x="0" y="1128"/>
                    </a:cubicBezTo>
                    <a:lnTo>
                      <a:pt x="0" y="8"/>
                    </a:lnTo>
                    <a:close/>
                    <a:moveTo>
                      <a:pt x="16" y="1128"/>
                    </a:moveTo>
                    <a:lnTo>
                      <a:pt x="8" y="1120"/>
                    </a:lnTo>
                    <a:lnTo>
                      <a:pt x="152" y="1120"/>
                    </a:lnTo>
                    <a:lnTo>
                      <a:pt x="144" y="1128"/>
                    </a:lnTo>
                    <a:lnTo>
                      <a:pt x="144" y="8"/>
                    </a:lnTo>
                    <a:lnTo>
                      <a:pt x="152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1128"/>
                    </a:lnTo>
                    <a:close/>
                  </a:path>
                </a:pathLst>
              </a:custGeom>
              <a:solidFill>
                <a:srgbClr val="000000"/>
              </a:solidFill>
              <a:ln w="793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81" name="Rectangle 457"/>
              <p:cNvSpPr>
                <a:spLocks noChangeArrowheads="1"/>
              </p:cNvSpPr>
              <p:nvPr/>
            </p:nvSpPr>
            <p:spPr bwMode="auto">
              <a:xfrm>
                <a:off x="2343678" y="542584"/>
                <a:ext cx="43980" cy="705545"/>
              </a:xfrm>
              <a:prstGeom prst="rect">
                <a:avLst/>
              </a:prstGeom>
              <a:solidFill>
                <a:srgbClr val="9999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82" name="Freeform 458"/>
              <p:cNvSpPr>
                <a:spLocks noEditPoints="1"/>
              </p:cNvSpPr>
              <p:nvPr/>
            </p:nvSpPr>
            <p:spPr bwMode="auto">
              <a:xfrm>
                <a:off x="2341583" y="540728"/>
                <a:ext cx="48168" cy="709258"/>
              </a:xfrm>
              <a:custGeom>
                <a:avLst/>
                <a:gdLst/>
                <a:ahLst/>
                <a:cxnLst>
                  <a:cxn ang="0">
                    <a:pos x="0" y="8"/>
                  </a:cxn>
                  <a:cxn ang="0">
                    <a:pos x="8" y="0"/>
                  </a:cxn>
                  <a:cxn ang="0">
                    <a:pos x="168" y="0"/>
                  </a:cxn>
                  <a:cxn ang="0">
                    <a:pos x="176" y="8"/>
                  </a:cxn>
                  <a:cxn ang="0">
                    <a:pos x="176" y="2984"/>
                  </a:cxn>
                  <a:cxn ang="0">
                    <a:pos x="168" y="2992"/>
                  </a:cxn>
                  <a:cxn ang="0">
                    <a:pos x="8" y="2992"/>
                  </a:cxn>
                  <a:cxn ang="0">
                    <a:pos x="0" y="2984"/>
                  </a:cxn>
                  <a:cxn ang="0">
                    <a:pos x="0" y="8"/>
                  </a:cxn>
                  <a:cxn ang="0">
                    <a:pos x="16" y="2984"/>
                  </a:cxn>
                  <a:cxn ang="0">
                    <a:pos x="8" y="2976"/>
                  </a:cxn>
                  <a:cxn ang="0">
                    <a:pos x="168" y="2976"/>
                  </a:cxn>
                  <a:cxn ang="0">
                    <a:pos x="160" y="2984"/>
                  </a:cxn>
                  <a:cxn ang="0">
                    <a:pos x="160" y="8"/>
                  </a:cxn>
                  <a:cxn ang="0">
                    <a:pos x="168" y="16"/>
                  </a:cxn>
                  <a:cxn ang="0">
                    <a:pos x="8" y="16"/>
                  </a:cxn>
                  <a:cxn ang="0">
                    <a:pos x="16" y="8"/>
                  </a:cxn>
                  <a:cxn ang="0">
                    <a:pos x="16" y="2984"/>
                  </a:cxn>
                </a:cxnLst>
                <a:rect l="0" t="0" r="r" b="b"/>
                <a:pathLst>
                  <a:path w="176" h="2992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168" y="0"/>
                    </a:lnTo>
                    <a:cubicBezTo>
                      <a:pt x="173" y="0"/>
                      <a:pt x="176" y="4"/>
                      <a:pt x="176" y="8"/>
                    </a:cubicBezTo>
                    <a:lnTo>
                      <a:pt x="176" y="2984"/>
                    </a:lnTo>
                    <a:cubicBezTo>
                      <a:pt x="176" y="2989"/>
                      <a:pt x="173" y="2992"/>
                      <a:pt x="168" y="2992"/>
                    </a:cubicBezTo>
                    <a:lnTo>
                      <a:pt x="8" y="2992"/>
                    </a:lnTo>
                    <a:cubicBezTo>
                      <a:pt x="4" y="2992"/>
                      <a:pt x="0" y="2989"/>
                      <a:pt x="0" y="2984"/>
                    </a:cubicBezTo>
                    <a:lnTo>
                      <a:pt x="0" y="8"/>
                    </a:lnTo>
                    <a:close/>
                    <a:moveTo>
                      <a:pt x="16" y="2984"/>
                    </a:moveTo>
                    <a:lnTo>
                      <a:pt x="8" y="2976"/>
                    </a:lnTo>
                    <a:lnTo>
                      <a:pt x="168" y="2976"/>
                    </a:lnTo>
                    <a:lnTo>
                      <a:pt x="160" y="2984"/>
                    </a:lnTo>
                    <a:lnTo>
                      <a:pt x="160" y="8"/>
                    </a:lnTo>
                    <a:lnTo>
                      <a:pt x="168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2984"/>
                    </a:lnTo>
                    <a:close/>
                  </a:path>
                </a:pathLst>
              </a:custGeom>
              <a:solidFill>
                <a:srgbClr val="000000"/>
              </a:solidFill>
              <a:ln w="793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83" name="Rectangle 459"/>
              <p:cNvSpPr>
                <a:spLocks noChangeArrowheads="1"/>
              </p:cNvSpPr>
              <p:nvPr/>
            </p:nvSpPr>
            <p:spPr bwMode="auto">
              <a:xfrm>
                <a:off x="2470382" y="784884"/>
                <a:ext cx="42933" cy="463246"/>
              </a:xfrm>
              <a:prstGeom prst="rect">
                <a:avLst/>
              </a:prstGeom>
              <a:solidFill>
                <a:srgbClr val="9999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84" name="Freeform 460"/>
              <p:cNvSpPr>
                <a:spLocks noEditPoints="1"/>
              </p:cNvSpPr>
              <p:nvPr/>
            </p:nvSpPr>
            <p:spPr bwMode="auto">
              <a:xfrm>
                <a:off x="2468288" y="783027"/>
                <a:ext cx="47122" cy="466960"/>
              </a:xfrm>
              <a:custGeom>
                <a:avLst/>
                <a:gdLst/>
                <a:ahLst/>
                <a:cxnLst>
                  <a:cxn ang="0">
                    <a:pos x="0" y="8"/>
                  </a:cxn>
                  <a:cxn ang="0">
                    <a:pos x="8" y="0"/>
                  </a:cxn>
                  <a:cxn ang="0">
                    <a:pos x="168" y="0"/>
                  </a:cxn>
                  <a:cxn ang="0">
                    <a:pos x="176" y="8"/>
                  </a:cxn>
                  <a:cxn ang="0">
                    <a:pos x="176" y="1960"/>
                  </a:cxn>
                  <a:cxn ang="0">
                    <a:pos x="168" y="1968"/>
                  </a:cxn>
                  <a:cxn ang="0">
                    <a:pos x="8" y="1968"/>
                  </a:cxn>
                  <a:cxn ang="0">
                    <a:pos x="0" y="1960"/>
                  </a:cxn>
                  <a:cxn ang="0">
                    <a:pos x="0" y="8"/>
                  </a:cxn>
                  <a:cxn ang="0">
                    <a:pos x="16" y="1960"/>
                  </a:cxn>
                  <a:cxn ang="0">
                    <a:pos x="8" y="1952"/>
                  </a:cxn>
                  <a:cxn ang="0">
                    <a:pos x="168" y="1952"/>
                  </a:cxn>
                  <a:cxn ang="0">
                    <a:pos x="160" y="1960"/>
                  </a:cxn>
                  <a:cxn ang="0">
                    <a:pos x="160" y="8"/>
                  </a:cxn>
                  <a:cxn ang="0">
                    <a:pos x="168" y="16"/>
                  </a:cxn>
                  <a:cxn ang="0">
                    <a:pos x="8" y="16"/>
                  </a:cxn>
                  <a:cxn ang="0">
                    <a:pos x="16" y="8"/>
                  </a:cxn>
                  <a:cxn ang="0">
                    <a:pos x="16" y="1960"/>
                  </a:cxn>
                </a:cxnLst>
                <a:rect l="0" t="0" r="r" b="b"/>
                <a:pathLst>
                  <a:path w="176" h="1968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168" y="0"/>
                    </a:lnTo>
                    <a:cubicBezTo>
                      <a:pt x="173" y="0"/>
                      <a:pt x="176" y="4"/>
                      <a:pt x="176" y="8"/>
                    </a:cubicBezTo>
                    <a:lnTo>
                      <a:pt x="176" y="1960"/>
                    </a:lnTo>
                    <a:cubicBezTo>
                      <a:pt x="176" y="1965"/>
                      <a:pt x="173" y="1968"/>
                      <a:pt x="168" y="1968"/>
                    </a:cubicBezTo>
                    <a:lnTo>
                      <a:pt x="8" y="1968"/>
                    </a:lnTo>
                    <a:cubicBezTo>
                      <a:pt x="4" y="1968"/>
                      <a:pt x="0" y="1965"/>
                      <a:pt x="0" y="1960"/>
                    </a:cubicBezTo>
                    <a:lnTo>
                      <a:pt x="0" y="8"/>
                    </a:lnTo>
                    <a:close/>
                    <a:moveTo>
                      <a:pt x="16" y="1960"/>
                    </a:moveTo>
                    <a:lnTo>
                      <a:pt x="8" y="1952"/>
                    </a:lnTo>
                    <a:lnTo>
                      <a:pt x="168" y="1952"/>
                    </a:lnTo>
                    <a:lnTo>
                      <a:pt x="160" y="1960"/>
                    </a:lnTo>
                    <a:lnTo>
                      <a:pt x="160" y="8"/>
                    </a:lnTo>
                    <a:lnTo>
                      <a:pt x="168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1960"/>
                    </a:lnTo>
                    <a:close/>
                  </a:path>
                </a:pathLst>
              </a:custGeom>
              <a:solidFill>
                <a:srgbClr val="000000"/>
              </a:solidFill>
              <a:ln w="793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85" name="Rectangle 461"/>
              <p:cNvSpPr>
                <a:spLocks noChangeArrowheads="1"/>
              </p:cNvSpPr>
              <p:nvPr/>
            </p:nvSpPr>
            <p:spPr bwMode="auto">
              <a:xfrm>
                <a:off x="2596039" y="808092"/>
                <a:ext cx="43980" cy="440037"/>
              </a:xfrm>
              <a:prstGeom prst="rect">
                <a:avLst/>
              </a:prstGeom>
              <a:solidFill>
                <a:srgbClr val="9999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86" name="Freeform 462"/>
              <p:cNvSpPr>
                <a:spLocks noEditPoints="1"/>
              </p:cNvSpPr>
              <p:nvPr/>
            </p:nvSpPr>
            <p:spPr bwMode="auto">
              <a:xfrm>
                <a:off x="2593944" y="806235"/>
                <a:ext cx="48168" cy="443751"/>
              </a:xfrm>
              <a:custGeom>
                <a:avLst/>
                <a:gdLst/>
                <a:ahLst/>
                <a:cxnLst>
                  <a:cxn ang="0">
                    <a:pos x="0" y="8"/>
                  </a:cxn>
                  <a:cxn ang="0">
                    <a:pos x="8" y="0"/>
                  </a:cxn>
                  <a:cxn ang="0">
                    <a:pos x="168" y="0"/>
                  </a:cxn>
                  <a:cxn ang="0">
                    <a:pos x="176" y="8"/>
                  </a:cxn>
                  <a:cxn ang="0">
                    <a:pos x="176" y="1864"/>
                  </a:cxn>
                  <a:cxn ang="0">
                    <a:pos x="168" y="1872"/>
                  </a:cxn>
                  <a:cxn ang="0">
                    <a:pos x="8" y="1872"/>
                  </a:cxn>
                  <a:cxn ang="0">
                    <a:pos x="0" y="1864"/>
                  </a:cxn>
                  <a:cxn ang="0">
                    <a:pos x="0" y="8"/>
                  </a:cxn>
                  <a:cxn ang="0">
                    <a:pos x="16" y="1864"/>
                  </a:cxn>
                  <a:cxn ang="0">
                    <a:pos x="8" y="1856"/>
                  </a:cxn>
                  <a:cxn ang="0">
                    <a:pos x="168" y="1856"/>
                  </a:cxn>
                  <a:cxn ang="0">
                    <a:pos x="160" y="1864"/>
                  </a:cxn>
                  <a:cxn ang="0">
                    <a:pos x="160" y="8"/>
                  </a:cxn>
                  <a:cxn ang="0">
                    <a:pos x="168" y="16"/>
                  </a:cxn>
                  <a:cxn ang="0">
                    <a:pos x="8" y="16"/>
                  </a:cxn>
                  <a:cxn ang="0">
                    <a:pos x="16" y="8"/>
                  </a:cxn>
                  <a:cxn ang="0">
                    <a:pos x="16" y="1864"/>
                  </a:cxn>
                </a:cxnLst>
                <a:rect l="0" t="0" r="r" b="b"/>
                <a:pathLst>
                  <a:path w="176" h="1872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168" y="0"/>
                    </a:lnTo>
                    <a:cubicBezTo>
                      <a:pt x="173" y="0"/>
                      <a:pt x="176" y="4"/>
                      <a:pt x="176" y="8"/>
                    </a:cubicBezTo>
                    <a:lnTo>
                      <a:pt x="176" y="1864"/>
                    </a:lnTo>
                    <a:cubicBezTo>
                      <a:pt x="176" y="1869"/>
                      <a:pt x="173" y="1872"/>
                      <a:pt x="168" y="1872"/>
                    </a:cubicBezTo>
                    <a:lnTo>
                      <a:pt x="8" y="1872"/>
                    </a:lnTo>
                    <a:cubicBezTo>
                      <a:pt x="4" y="1872"/>
                      <a:pt x="0" y="1869"/>
                      <a:pt x="0" y="1864"/>
                    </a:cubicBezTo>
                    <a:lnTo>
                      <a:pt x="0" y="8"/>
                    </a:lnTo>
                    <a:close/>
                    <a:moveTo>
                      <a:pt x="16" y="1864"/>
                    </a:moveTo>
                    <a:lnTo>
                      <a:pt x="8" y="1856"/>
                    </a:lnTo>
                    <a:lnTo>
                      <a:pt x="168" y="1856"/>
                    </a:lnTo>
                    <a:lnTo>
                      <a:pt x="160" y="1864"/>
                    </a:lnTo>
                    <a:lnTo>
                      <a:pt x="160" y="8"/>
                    </a:lnTo>
                    <a:lnTo>
                      <a:pt x="168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1864"/>
                    </a:lnTo>
                    <a:close/>
                  </a:path>
                </a:pathLst>
              </a:custGeom>
              <a:solidFill>
                <a:srgbClr val="000000"/>
              </a:solidFill>
              <a:ln w="793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87" name="Rectangle 463"/>
              <p:cNvSpPr>
                <a:spLocks noChangeArrowheads="1"/>
              </p:cNvSpPr>
              <p:nvPr/>
            </p:nvSpPr>
            <p:spPr bwMode="auto">
              <a:xfrm>
                <a:off x="2722742" y="1042965"/>
                <a:ext cx="42933" cy="205165"/>
              </a:xfrm>
              <a:prstGeom prst="rect">
                <a:avLst/>
              </a:prstGeom>
              <a:solidFill>
                <a:srgbClr val="9999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88" name="Freeform 464"/>
              <p:cNvSpPr>
                <a:spLocks noEditPoints="1"/>
              </p:cNvSpPr>
              <p:nvPr/>
            </p:nvSpPr>
            <p:spPr bwMode="auto">
              <a:xfrm>
                <a:off x="2720648" y="1041108"/>
                <a:ext cx="47122" cy="208879"/>
              </a:xfrm>
              <a:custGeom>
                <a:avLst/>
                <a:gdLst/>
                <a:ahLst/>
                <a:cxnLst>
                  <a:cxn ang="0">
                    <a:pos x="0" y="8"/>
                  </a:cxn>
                  <a:cxn ang="0">
                    <a:pos x="8" y="0"/>
                  </a:cxn>
                  <a:cxn ang="0">
                    <a:pos x="168" y="0"/>
                  </a:cxn>
                  <a:cxn ang="0">
                    <a:pos x="176" y="8"/>
                  </a:cxn>
                  <a:cxn ang="0">
                    <a:pos x="176" y="872"/>
                  </a:cxn>
                  <a:cxn ang="0">
                    <a:pos x="168" y="880"/>
                  </a:cxn>
                  <a:cxn ang="0">
                    <a:pos x="8" y="880"/>
                  </a:cxn>
                  <a:cxn ang="0">
                    <a:pos x="0" y="872"/>
                  </a:cxn>
                  <a:cxn ang="0">
                    <a:pos x="0" y="8"/>
                  </a:cxn>
                  <a:cxn ang="0">
                    <a:pos x="16" y="872"/>
                  </a:cxn>
                  <a:cxn ang="0">
                    <a:pos x="8" y="864"/>
                  </a:cxn>
                  <a:cxn ang="0">
                    <a:pos x="168" y="864"/>
                  </a:cxn>
                  <a:cxn ang="0">
                    <a:pos x="160" y="872"/>
                  </a:cxn>
                  <a:cxn ang="0">
                    <a:pos x="160" y="8"/>
                  </a:cxn>
                  <a:cxn ang="0">
                    <a:pos x="168" y="16"/>
                  </a:cxn>
                  <a:cxn ang="0">
                    <a:pos x="8" y="16"/>
                  </a:cxn>
                  <a:cxn ang="0">
                    <a:pos x="16" y="8"/>
                  </a:cxn>
                  <a:cxn ang="0">
                    <a:pos x="16" y="872"/>
                  </a:cxn>
                </a:cxnLst>
                <a:rect l="0" t="0" r="r" b="b"/>
                <a:pathLst>
                  <a:path w="176" h="880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168" y="0"/>
                    </a:lnTo>
                    <a:cubicBezTo>
                      <a:pt x="173" y="0"/>
                      <a:pt x="176" y="4"/>
                      <a:pt x="176" y="8"/>
                    </a:cubicBezTo>
                    <a:lnTo>
                      <a:pt x="176" y="872"/>
                    </a:lnTo>
                    <a:cubicBezTo>
                      <a:pt x="176" y="877"/>
                      <a:pt x="173" y="880"/>
                      <a:pt x="168" y="880"/>
                    </a:cubicBezTo>
                    <a:lnTo>
                      <a:pt x="8" y="880"/>
                    </a:lnTo>
                    <a:cubicBezTo>
                      <a:pt x="4" y="880"/>
                      <a:pt x="0" y="877"/>
                      <a:pt x="0" y="872"/>
                    </a:cubicBezTo>
                    <a:lnTo>
                      <a:pt x="0" y="8"/>
                    </a:lnTo>
                    <a:close/>
                    <a:moveTo>
                      <a:pt x="16" y="872"/>
                    </a:moveTo>
                    <a:lnTo>
                      <a:pt x="8" y="864"/>
                    </a:lnTo>
                    <a:lnTo>
                      <a:pt x="168" y="864"/>
                    </a:lnTo>
                    <a:lnTo>
                      <a:pt x="160" y="872"/>
                    </a:lnTo>
                    <a:lnTo>
                      <a:pt x="160" y="8"/>
                    </a:lnTo>
                    <a:lnTo>
                      <a:pt x="168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872"/>
                    </a:lnTo>
                    <a:close/>
                  </a:path>
                </a:pathLst>
              </a:custGeom>
              <a:solidFill>
                <a:srgbClr val="000000"/>
              </a:solidFill>
              <a:ln w="793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89" name="Rectangle 465"/>
              <p:cNvSpPr>
                <a:spLocks noChangeArrowheads="1"/>
              </p:cNvSpPr>
              <p:nvPr/>
            </p:nvSpPr>
            <p:spPr bwMode="auto">
              <a:xfrm>
                <a:off x="2853635" y="800665"/>
                <a:ext cx="38744" cy="447464"/>
              </a:xfrm>
              <a:prstGeom prst="rect">
                <a:avLst/>
              </a:prstGeom>
              <a:solidFill>
                <a:srgbClr val="9999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90" name="Freeform 466"/>
              <p:cNvSpPr>
                <a:spLocks noEditPoints="1"/>
              </p:cNvSpPr>
              <p:nvPr/>
            </p:nvSpPr>
            <p:spPr bwMode="auto">
              <a:xfrm>
                <a:off x="2850493" y="798809"/>
                <a:ext cx="43980" cy="451177"/>
              </a:xfrm>
              <a:custGeom>
                <a:avLst/>
                <a:gdLst/>
                <a:ahLst/>
                <a:cxnLst>
                  <a:cxn ang="0">
                    <a:pos x="0" y="8"/>
                  </a:cxn>
                  <a:cxn ang="0">
                    <a:pos x="8" y="0"/>
                  </a:cxn>
                  <a:cxn ang="0">
                    <a:pos x="152" y="0"/>
                  </a:cxn>
                  <a:cxn ang="0">
                    <a:pos x="160" y="8"/>
                  </a:cxn>
                  <a:cxn ang="0">
                    <a:pos x="160" y="1896"/>
                  </a:cxn>
                  <a:cxn ang="0">
                    <a:pos x="152" y="1904"/>
                  </a:cxn>
                  <a:cxn ang="0">
                    <a:pos x="8" y="1904"/>
                  </a:cxn>
                  <a:cxn ang="0">
                    <a:pos x="0" y="1896"/>
                  </a:cxn>
                  <a:cxn ang="0">
                    <a:pos x="0" y="8"/>
                  </a:cxn>
                  <a:cxn ang="0">
                    <a:pos x="16" y="1896"/>
                  </a:cxn>
                  <a:cxn ang="0">
                    <a:pos x="8" y="1888"/>
                  </a:cxn>
                  <a:cxn ang="0">
                    <a:pos x="152" y="1888"/>
                  </a:cxn>
                  <a:cxn ang="0">
                    <a:pos x="144" y="1896"/>
                  </a:cxn>
                  <a:cxn ang="0">
                    <a:pos x="144" y="8"/>
                  </a:cxn>
                  <a:cxn ang="0">
                    <a:pos x="152" y="16"/>
                  </a:cxn>
                  <a:cxn ang="0">
                    <a:pos x="8" y="16"/>
                  </a:cxn>
                  <a:cxn ang="0">
                    <a:pos x="16" y="8"/>
                  </a:cxn>
                  <a:cxn ang="0">
                    <a:pos x="16" y="1896"/>
                  </a:cxn>
                </a:cxnLst>
                <a:rect l="0" t="0" r="r" b="b"/>
                <a:pathLst>
                  <a:path w="160" h="1904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152" y="0"/>
                    </a:lnTo>
                    <a:cubicBezTo>
                      <a:pt x="157" y="0"/>
                      <a:pt x="160" y="4"/>
                      <a:pt x="160" y="8"/>
                    </a:cubicBezTo>
                    <a:lnTo>
                      <a:pt x="160" y="1896"/>
                    </a:lnTo>
                    <a:cubicBezTo>
                      <a:pt x="160" y="1901"/>
                      <a:pt x="157" y="1904"/>
                      <a:pt x="152" y="1904"/>
                    </a:cubicBezTo>
                    <a:lnTo>
                      <a:pt x="8" y="1904"/>
                    </a:lnTo>
                    <a:cubicBezTo>
                      <a:pt x="4" y="1904"/>
                      <a:pt x="0" y="1901"/>
                      <a:pt x="0" y="1896"/>
                    </a:cubicBezTo>
                    <a:lnTo>
                      <a:pt x="0" y="8"/>
                    </a:lnTo>
                    <a:close/>
                    <a:moveTo>
                      <a:pt x="16" y="1896"/>
                    </a:moveTo>
                    <a:lnTo>
                      <a:pt x="8" y="1888"/>
                    </a:lnTo>
                    <a:lnTo>
                      <a:pt x="152" y="1888"/>
                    </a:lnTo>
                    <a:lnTo>
                      <a:pt x="144" y="1896"/>
                    </a:lnTo>
                    <a:lnTo>
                      <a:pt x="144" y="8"/>
                    </a:lnTo>
                    <a:lnTo>
                      <a:pt x="152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1896"/>
                    </a:lnTo>
                    <a:close/>
                  </a:path>
                </a:pathLst>
              </a:custGeom>
              <a:solidFill>
                <a:srgbClr val="000000"/>
              </a:solidFill>
              <a:ln w="793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91" name="Rectangle 467"/>
              <p:cNvSpPr>
                <a:spLocks noChangeArrowheads="1"/>
              </p:cNvSpPr>
              <p:nvPr/>
            </p:nvSpPr>
            <p:spPr bwMode="auto">
              <a:xfrm>
                <a:off x="2979292" y="815519"/>
                <a:ext cx="43980" cy="432610"/>
              </a:xfrm>
              <a:prstGeom prst="rect">
                <a:avLst/>
              </a:prstGeom>
              <a:solidFill>
                <a:srgbClr val="9999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92" name="Freeform 468"/>
              <p:cNvSpPr>
                <a:spLocks noEditPoints="1"/>
              </p:cNvSpPr>
              <p:nvPr/>
            </p:nvSpPr>
            <p:spPr bwMode="auto">
              <a:xfrm>
                <a:off x="2977197" y="813662"/>
                <a:ext cx="48168" cy="436324"/>
              </a:xfrm>
              <a:custGeom>
                <a:avLst/>
                <a:gdLst/>
                <a:ahLst/>
                <a:cxnLst>
                  <a:cxn ang="0">
                    <a:pos x="0" y="8"/>
                  </a:cxn>
                  <a:cxn ang="0">
                    <a:pos x="8" y="0"/>
                  </a:cxn>
                  <a:cxn ang="0">
                    <a:pos x="168" y="0"/>
                  </a:cxn>
                  <a:cxn ang="0">
                    <a:pos x="176" y="8"/>
                  </a:cxn>
                  <a:cxn ang="0">
                    <a:pos x="176" y="1832"/>
                  </a:cxn>
                  <a:cxn ang="0">
                    <a:pos x="168" y="1840"/>
                  </a:cxn>
                  <a:cxn ang="0">
                    <a:pos x="8" y="1840"/>
                  </a:cxn>
                  <a:cxn ang="0">
                    <a:pos x="0" y="1832"/>
                  </a:cxn>
                  <a:cxn ang="0">
                    <a:pos x="0" y="8"/>
                  </a:cxn>
                  <a:cxn ang="0">
                    <a:pos x="16" y="1832"/>
                  </a:cxn>
                  <a:cxn ang="0">
                    <a:pos x="8" y="1824"/>
                  </a:cxn>
                  <a:cxn ang="0">
                    <a:pos x="168" y="1824"/>
                  </a:cxn>
                  <a:cxn ang="0">
                    <a:pos x="160" y="1832"/>
                  </a:cxn>
                  <a:cxn ang="0">
                    <a:pos x="160" y="8"/>
                  </a:cxn>
                  <a:cxn ang="0">
                    <a:pos x="168" y="16"/>
                  </a:cxn>
                  <a:cxn ang="0">
                    <a:pos x="8" y="16"/>
                  </a:cxn>
                  <a:cxn ang="0">
                    <a:pos x="16" y="8"/>
                  </a:cxn>
                  <a:cxn ang="0">
                    <a:pos x="16" y="1832"/>
                  </a:cxn>
                </a:cxnLst>
                <a:rect l="0" t="0" r="r" b="b"/>
                <a:pathLst>
                  <a:path w="176" h="1840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168" y="0"/>
                    </a:lnTo>
                    <a:cubicBezTo>
                      <a:pt x="173" y="0"/>
                      <a:pt x="176" y="4"/>
                      <a:pt x="176" y="8"/>
                    </a:cubicBezTo>
                    <a:lnTo>
                      <a:pt x="176" y="1832"/>
                    </a:lnTo>
                    <a:cubicBezTo>
                      <a:pt x="176" y="1837"/>
                      <a:pt x="173" y="1840"/>
                      <a:pt x="168" y="1840"/>
                    </a:cubicBezTo>
                    <a:lnTo>
                      <a:pt x="8" y="1840"/>
                    </a:lnTo>
                    <a:cubicBezTo>
                      <a:pt x="4" y="1840"/>
                      <a:pt x="0" y="1837"/>
                      <a:pt x="0" y="1832"/>
                    </a:cubicBezTo>
                    <a:lnTo>
                      <a:pt x="0" y="8"/>
                    </a:lnTo>
                    <a:close/>
                    <a:moveTo>
                      <a:pt x="16" y="1832"/>
                    </a:moveTo>
                    <a:lnTo>
                      <a:pt x="8" y="1824"/>
                    </a:lnTo>
                    <a:lnTo>
                      <a:pt x="168" y="1824"/>
                    </a:lnTo>
                    <a:lnTo>
                      <a:pt x="160" y="1832"/>
                    </a:lnTo>
                    <a:lnTo>
                      <a:pt x="160" y="8"/>
                    </a:lnTo>
                    <a:lnTo>
                      <a:pt x="168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1832"/>
                    </a:lnTo>
                    <a:close/>
                  </a:path>
                </a:pathLst>
              </a:custGeom>
              <a:solidFill>
                <a:srgbClr val="000000"/>
              </a:solidFill>
              <a:ln w="793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93" name="Rectangle 469"/>
              <p:cNvSpPr>
                <a:spLocks noChangeArrowheads="1"/>
              </p:cNvSpPr>
              <p:nvPr/>
            </p:nvSpPr>
            <p:spPr bwMode="auto">
              <a:xfrm>
                <a:off x="603332" y="822946"/>
                <a:ext cx="43980" cy="425184"/>
              </a:xfrm>
              <a:prstGeom prst="rect">
                <a:avLst/>
              </a:prstGeom>
              <a:solidFill>
                <a:srgbClr val="FFFF99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94" name="Freeform 470"/>
              <p:cNvSpPr>
                <a:spLocks noEditPoints="1"/>
              </p:cNvSpPr>
              <p:nvPr/>
            </p:nvSpPr>
            <p:spPr bwMode="auto">
              <a:xfrm>
                <a:off x="601237" y="821089"/>
                <a:ext cx="48168" cy="428897"/>
              </a:xfrm>
              <a:custGeom>
                <a:avLst/>
                <a:gdLst/>
                <a:ahLst/>
                <a:cxnLst>
                  <a:cxn ang="0">
                    <a:pos x="0" y="8"/>
                  </a:cxn>
                  <a:cxn ang="0">
                    <a:pos x="8" y="0"/>
                  </a:cxn>
                  <a:cxn ang="0">
                    <a:pos x="168" y="0"/>
                  </a:cxn>
                  <a:cxn ang="0">
                    <a:pos x="176" y="8"/>
                  </a:cxn>
                  <a:cxn ang="0">
                    <a:pos x="176" y="1800"/>
                  </a:cxn>
                  <a:cxn ang="0">
                    <a:pos x="168" y="1808"/>
                  </a:cxn>
                  <a:cxn ang="0">
                    <a:pos x="8" y="1808"/>
                  </a:cxn>
                  <a:cxn ang="0">
                    <a:pos x="0" y="1800"/>
                  </a:cxn>
                  <a:cxn ang="0">
                    <a:pos x="0" y="8"/>
                  </a:cxn>
                  <a:cxn ang="0">
                    <a:pos x="16" y="1800"/>
                  </a:cxn>
                  <a:cxn ang="0">
                    <a:pos x="8" y="1792"/>
                  </a:cxn>
                  <a:cxn ang="0">
                    <a:pos x="168" y="1792"/>
                  </a:cxn>
                  <a:cxn ang="0">
                    <a:pos x="160" y="1800"/>
                  </a:cxn>
                  <a:cxn ang="0">
                    <a:pos x="160" y="8"/>
                  </a:cxn>
                  <a:cxn ang="0">
                    <a:pos x="168" y="16"/>
                  </a:cxn>
                  <a:cxn ang="0">
                    <a:pos x="8" y="16"/>
                  </a:cxn>
                  <a:cxn ang="0">
                    <a:pos x="16" y="8"/>
                  </a:cxn>
                  <a:cxn ang="0">
                    <a:pos x="16" y="1800"/>
                  </a:cxn>
                </a:cxnLst>
                <a:rect l="0" t="0" r="r" b="b"/>
                <a:pathLst>
                  <a:path w="176" h="1808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168" y="0"/>
                    </a:lnTo>
                    <a:cubicBezTo>
                      <a:pt x="173" y="0"/>
                      <a:pt x="176" y="4"/>
                      <a:pt x="176" y="8"/>
                    </a:cubicBezTo>
                    <a:lnTo>
                      <a:pt x="176" y="1800"/>
                    </a:lnTo>
                    <a:cubicBezTo>
                      <a:pt x="176" y="1805"/>
                      <a:pt x="173" y="1808"/>
                      <a:pt x="168" y="1808"/>
                    </a:cubicBezTo>
                    <a:lnTo>
                      <a:pt x="8" y="1808"/>
                    </a:lnTo>
                    <a:cubicBezTo>
                      <a:pt x="4" y="1808"/>
                      <a:pt x="0" y="1805"/>
                      <a:pt x="0" y="1800"/>
                    </a:cubicBezTo>
                    <a:lnTo>
                      <a:pt x="0" y="8"/>
                    </a:lnTo>
                    <a:close/>
                    <a:moveTo>
                      <a:pt x="16" y="1800"/>
                    </a:moveTo>
                    <a:lnTo>
                      <a:pt x="8" y="1792"/>
                    </a:lnTo>
                    <a:lnTo>
                      <a:pt x="168" y="1792"/>
                    </a:lnTo>
                    <a:lnTo>
                      <a:pt x="160" y="1800"/>
                    </a:lnTo>
                    <a:lnTo>
                      <a:pt x="160" y="8"/>
                    </a:lnTo>
                    <a:lnTo>
                      <a:pt x="168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1800"/>
                    </a:lnTo>
                    <a:close/>
                  </a:path>
                </a:pathLst>
              </a:custGeom>
              <a:solidFill>
                <a:srgbClr val="000000"/>
              </a:solidFill>
              <a:ln w="793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95" name="Rectangle 471"/>
              <p:cNvSpPr>
                <a:spLocks noChangeArrowheads="1"/>
              </p:cNvSpPr>
              <p:nvPr/>
            </p:nvSpPr>
            <p:spPr bwMode="auto">
              <a:xfrm>
                <a:off x="730036" y="777457"/>
                <a:ext cx="42933" cy="470673"/>
              </a:xfrm>
              <a:prstGeom prst="rect">
                <a:avLst/>
              </a:prstGeom>
              <a:solidFill>
                <a:srgbClr val="FFFF99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96" name="Freeform 472"/>
              <p:cNvSpPr>
                <a:spLocks noEditPoints="1"/>
              </p:cNvSpPr>
              <p:nvPr/>
            </p:nvSpPr>
            <p:spPr bwMode="auto">
              <a:xfrm>
                <a:off x="727942" y="775600"/>
                <a:ext cx="48168" cy="474386"/>
              </a:xfrm>
              <a:custGeom>
                <a:avLst/>
                <a:gdLst/>
                <a:ahLst/>
                <a:cxnLst>
                  <a:cxn ang="0">
                    <a:pos x="0" y="8"/>
                  </a:cxn>
                  <a:cxn ang="0">
                    <a:pos x="8" y="0"/>
                  </a:cxn>
                  <a:cxn ang="0">
                    <a:pos x="168" y="0"/>
                  </a:cxn>
                  <a:cxn ang="0">
                    <a:pos x="176" y="8"/>
                  </a:cxn>
                  <a:cxn ang="0">
                    <a:pos x="176" y="1992"/>
                  </a:cxn>
                  <a:cxn ang="0">
                    <a:pos x="168" y="2000"/>
                  </a:cxn>
                  <a:cxn ang="0">
                    <a:pos x="8" y="2000"/>
                  </a:cxn>
                  <a:cxn ang="0">
                    <a:pos x="0" y="1992"/>
                  </a:cxn>
                  <a:cxn ang="0">
                    <a:pos x="0" y="8"/>
                  </a:cxn>
                  <a:cxn ang="0">
                    <a:pos x="16" y="1992"/>
                  </a:cxn>
                  <a:cxn ang="0">
                    <a:pos x="8" y="1984"/>
                  </a:cxn>
                  <a:cxn ang="0">
                    <a:pos x="168" y="1984"/>
                  </a:cxn>
                  <a:cxn ang="0">
                    <a:pos x="160" y="1992"/>
                  </a:cxn>
                  <a:cxn ang="0">
                    <a:pos x="160" y="8"/>
                  </a:cxn>
                  <a:cxn ang="0">
                    <a:pos x="168" y="16"/>
                  </a:cxn>
                  <a:cxn ang="0">
                    <a:pos x="8" y="16"/>
                  </a:cxn>
                  <a:cxn ang="0">
                    <a:pos x="16" y="8"/>
                  </a:cxn>
                  <a:cxn ang="0">
                    <a:pos x="16" y="1992"/>
                  </a:cxn>
                </a:cxnLst>
                <a:rect l="0" t="0" r="r" b="b"/>
                <a:pathLst>
                  <a:path w="176" h="2000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168" y="0"/>
                    </a:lnTo>
                    <a:cubicBezTo>
                      <a:pt x="173" y="0"/>
                      <a:pt x="176" y="4"/>
                      <a:pt x="176" y="8"/>
                    </a:cubicBezTo>
                    <a:lnTo>
                      <a:pt x="176" y="1992"/>
                    </a:lnTo>
                    <a:cubicBezTo>
                      <a:pt x="176" y="1997"/>
                      <a:pt x="173" y="2000"/>
                      <a:pt x="168" y="2000"/>
                    </a:cubicBezTo>
                    <a:lnTo>
                      <a:pt x="8" y="2000"/>
                    </a:lnTo>
                    <a:cubicBezTo>
                      <a:pt x="4" y="2000"/>
                      <a:pt x="0" y="1997"/>
                      <a:pt x="0" y="1992"/>
                    </a:cubicBezTo>
                    <a:lnTo>
                      <a:pt x="0" y="8"/>
                    </a:lnTo>
                    <a:close/>
                    <a:moveTo>
                      <a:pt x="16" y="1992"/>
                    </a:moveTo>
                    <a:lnTo>
                      <a:pt x="8" y="1984"/>
                    </a:lnTo>
                    <a:lnTo>
                      <a:pt x="168" y="1984"/>
                    </a:lnTo>
                    <a:lnTo>
                      <a:pt x="160" y="1992"/>
                    </a:lnTo>
                    <a:lnTo>
                      <a:pt x="160" y="8"/>
                    </a:lnTo>
                    <a:lnTo>
                      <a:pt x="168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1992"/>
                    </a:lnTo>
                    <a:close/>
                  </a:path>
                </a:pathLst>
              </a:custGeom>
              <a:solidFill>
                <a:srgbClr val="000000"/>
              </a:solidFill>
              <a:ln w="793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97" name="Rectangle 473"/>
              <p:cNvSpPr>
                <a:spLocks noChangeArrowheads="1"/>
              </p:cNvSpPr>
              <p:nvPr/>
            </p:nvSpPr>
            <p:spPr bwMode="auto">
              <a:xfrm>
                <a:off x="860928" y="864722"/>
                <a:ext cx="38744" cy="383408"/>
              </a:xfrm>
              <a:prstGeom prst="rect">
                <a:avLst/>
              </a:prstGeom>
              <a:solidFill>
                <a:srgbClr val="FFFF99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98" name="Freeform 474"/>
              <p:cNvSpPr>
                <a:spLocks noEditPoints="1"/>
              </p:cNvSpPr>
              <p:nvPr/>
            </p:nvSpPr>
            <p:spPr bwMode="auto">
              <a:xfrm>
                <a:off x="857787" y="862865"/>
                <a:ext cx="43980" cy="387122"/>
              </a:xfrm>
              <a:custGeom>
                <a:avLst/>
                <a:gdLst/>
                <a:ahLst/>
                <a:cxnLst>
                  <a:cxn ang="0">
                    <a:pos x="0" y="8"/>
                  </a:cxn>
                  <a:cxn ang="0">
                    <a:pos x="8" y="0"/>
                  </a:cxn>
                  <a:cxn ang="0">
                    <a:pos x="152" y="0"/>
                  </a:cxn>
                  <a:cxn ang="0">
                    <a:pos x="160" y="8"/>
                  </a:cxn>
                  <a:cxn ang="0">
                    <a:pos x="160" y="1624"/>
                  </a:cxn>
                  <a:cxn ang="0">
                    <a:pos x="152" y="1632"/>
                  </a:cxn>
                  <a:cxn ang="0">
                    <a:pos x="8" y="1632"/>
                  </a:cxn>
                  <a:cxn ang="0">
                    <a:pos x="0" y="1624"/>
                  </a:cxn>
                  <a:cxn ang="0">
                    <a:pos x="0" y="8"/>
                  </a:cxn>
                  <a:cxn ang="0">
                    <a:pos x="16" y="1624"/>
                  </a:cxn>
                  <a:cxn ang="0">
                    <a:pos x="8" y="1616"/>
                  </a:cxn>
                  <a:cxn ang="0">
                    <a:pos x="152" y="1616"/>
                  </a:cxn>
                  <a:cxn ang="0">
                    <a:pos x="144" y="1624"/>
                  </a:cxn>
                  <a:cxn ang="0">
                    <a:pos x="144" y="8"/>
                  </a:cxn>
                  <a:cxn ang="0">
                    <a:pos x="152" y="16"/>
                  </a:cxn>
                  <a:cxn ang="0">
                    <a:pos x="8" y="16"/>
                  </a:cxn>
                  <a:cxn ang="0">
                    <a:pos x="16" y="8"/>
                  </a:cxn>
                  <a:cxn ang="0">
                    <a:pos x="16" y="1624"/>
                  </a:cxn>
                </a:cxnLst>
                <a:rect l="0" t="0" r="r" b="b"/>
                <a:pathLst>
                  <a:path w="160" h="1632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152" y="0"/>
                    </a:lnTo>
                    <a:cubicBezTo>
                      <a:pt x="157" y="0"/>
                      <a:pt x="160" y="4"/>
                      <a:pt x="160" y="8"/>
                    </a:cubicBezTo>
                    <a:lnTo>
                      <a:pt x="160" y="1624"/>
                    </a:lnTo>
                    <a:cubicBezTo>
                      <a:pt x="160" y="1629"/>
                      <a:pt x="157" y="1632"/>
                      <a:pt x="152" y="1632"/>
                    </a:cubicBezTo>
                    <a:lnTo>
                      <a:pt x="8" y="1632"/>
                    </a:lnTo>
                    <a:cubicBezTo>
                      <a:pt x="4" y="1632"/>
                      <a:pt x="0" y="1629"/>
                      <a:pt x="0" y="1624"/>
                    </a:cubicBezTo>
                    <a:lnTo>
                      <a:pt x="0" y="8"/>
                    </a:lnTo>
                    <a:close/>
                    <a:moveTo>
                      <a:pt x="16" y="1624"/>
                    </a:moveTo>
                    <a:lnTo>
                      <a:pt x="8" y="1616"/>
                    </a:lnTo>
                    <a:lnTo>
                      <a:pt x="152" y="1616"/>
                    </a:lnTo>
                    <a:lnTo>
                      <a:pt x="144" y="1624"/>
                    </a:lnTo>
                    <a:lnTo>
                      <a:pt x="144" y="8"/>
                    </a:lnTo>
                    <a:lnTo>
                      <a:pt x="152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1624"/>
                    </a:lnTo>
                    <a:close/>
                  </a:path>
                </a:pathLst>
              </a:custGeom>
              <a:solidFill>
                <a:srgbClr val="000000"/>
              </a:solidFill>
              <a:ln w="793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99" name="Rectangle 475"/>
              <p:cNvSpPr>
                <a:spLocks noChangeArrowheads="1"/>
              </p:cNvSpPr>
              <p:nvPr/>
            </p:nvSpPr>
            <p:spPr bwMode="auto">
              <a:xfrm>
                <a:off x="986585" y="990048"/>
                <a:ext cx="43980" cy="258081"/>
              </a:xfrm>
              <a:prstGeom prst="rect">
                <a:avLst/>
              </a:prstGeom>
              <a:solidFill>
                <a:srgbClr val="FFFF99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500" name="Freeform 476"/>
              <p:cNvSpPr>
                <a:spLocks noEditPoints="1"/>
              </p:cNvSpPr>
              <p:nvPr/>
            </p:nvSpPr>
            <p:spPr bwMode="auto">
              <a:xfrm>
                <a:off x="984490" y="988192"/>
                <a:ext cx="48168" cy="261794"/>
              </a:xfrm>
              <a:custGeom>
                <a:avLst/>
                <a:gdLst/>
                <a:ahLst/>
                <a:cxnLst>
                  <a:cxn ang="0">
                    <a:pos x="0" y="8"/>
                  </a:cxn>
                  <a:cxn ang="0">
                    <a:pos x="8" y="0"/>
                  </a:cxn>
                  <a:cxn ang="0">
                    <a:pos x="168" y="0"/>
                  </a:cxn>
                  <a:cxn ang="0">
                    <a:pos x="176" y="8"/>
                  </a:cxn>
                  <a:cxn ang="0">
                    <a:pos x="176" y="1096"/>
                  </a:cxn>
                  <a:cxn ang="0">
                    <a:pos x="168" y="1104"/>
                  </a:cxn>
                  <a:cxn ang="0">
                    <a:pos x="8" y="1104"/>
                  </a:cxn>
                  <a:cxn ang="0">
                    <a:pos x="0" y="1096"/>
                  </a:cxn>
                  <a:cxn ang="0">
                    <a:pos x="0" y="8"/>
                  </a:cxn>
                  <a:cxn ang="0">
                    <a:pos x="16" y="1096"/>
                  </a:cxn>
                  <a:cxn ang="0">
                    <a:pos x="8" y="1088"/>
                  </a:cxn>
                  <a:cxn ang="0">
                    <a:pos x="168" y="1088"/>
                  </a:cxn>
                  <a:cxn ang="0">
                    <a:pos x="160" y="1096"/>
                  </a:cxn>
                  <a:cxn ang="0">
                    <a:pos x="160" y="8"/>
                  </a:cxn>
                  <a:cxn ang="0">
                    <a:pos x="168" y="16"/>
                  </a:cxn>
                  <a:cxn ang="0">
                    <a:pos x="8" y="16"/>
                  </a:cxn>
                  <a:cxn ang="0">
                    <a:pos x="16" y="8"/>
                  </a:cxn>
                  <a:cxn ang="0">
                    <a:pos x="16" y="1096"/>
                  </a:cxn>
                </a:cxnLst>
                <a:rect l="0" t="0" r="r" b="b"/>
                <a:pathLst>
                  <a:path w="176" h="1104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168" y="0"/>
                    </a:lnTo>
                    <a:cubicBezTo>
                      <a:pt x="173" y="0"/>
                      <a:pt x="176" y="4"/>
                      <a:pt x="176" y="8"/>
                    </a:cubicBezTo>
                    <a:lnTo>
                      <a:pt x="176" y="1096"/>
                    </a:lnTo>
                    <a:cubicBezTo>
                      <a:pt x="176" y="1101"/>
                      <a:pt x="173" y="1104"/>
                      <a:pt x="168" y="1104"/>
                    </a:cubicBezTo>
                    <a:lnTo>
                      <a:pt x="8" y="1104"/>
                    </a:lnTo>
                    <a:cubicBezTo>
                      <a:pt x="4" y="1104"/>
                      <a:pt x="0" y="1101"/>
                      <a:pt x="0" y="1096"/>
                    </a:cubicBezTo>
                    <a:lnTo>
                      <a:pt x="0" y="8"/>
                    </a:lnTo>
                    <a:close/>
                    <a:moveTo>
                      <a:pt x="16" y="1096"/>
                    </a:moveTo>
                    <a:lnTo>
                      <a:pt x="8" y="1088"/>
                    </a:lnTo>
                    <a:lnTo>
                      <a:pt x="168" y="1088"/>
                    </a:lnTo>
                    <a:lnTo>
                      <a:pt x="160" y="1096"/>
                    </a:lnTo>
                    <a:lnTo>
                      <a:pt x="160" y="8"/>
                    </a:lnTo>
                    <a:lnTo>
                      <a:pt x="168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1096"/>
                    </a:lnTo>
                    <a:close/>
                  </a:path>
                </a:pathLst>
              </a:custGeom>
              <a:solidFill>
                <a:srgbClr val="000000"/>
              </a:solidFill>
              <a:ln w="793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501" name="Rectangle 477"/>
              <p:cNvSpPr>
                <a:spLocks noChangeArrowheads="1"/>
              </p:cNvSpPr>
              <p:nvPr/>
            </p:nvSpPr>
            <p:spPr bwMode="auto">
              <a:xfrm>
                <a:off x="1113289" y="526803"/>
                <a:ext cx="42933" cy="721327"/>
              </a:xfrm>
              <a:prstGeom prst="rect">
                <a:avLst/>
              </a:prstGeom>
              <a:solidFill>
                <a:srgbClr val="FFFF99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502" name="Freeform 478"/>
              <p:cNvSpPr>
                <a:spLocks noEditPoints="1"/>
              </p:cNvSpPr>
              <p:nvPr/>
            </p:nvSpPr>
            <p:spPr bwMode="auto">
              <a:xfrm>
                <a:off x="1110147" y="524946"/>
                <a:ext cx="48168" cy="725041"/>
              </a:xfrm>
              <a:custGeom>
                <a:avLst/>
                <a:gdLst/>
                <a:ahLst/>
                <a:cxnLst>
                  <a:cxn ang="0">
                    <a:pos x="0" y="8"/>
                  </a:cxn>
                  <a:cxn ang="0">
                    <a:pos x="8" y="0"/>
                  </a:cxn>
                  <a:cxn ang="0">
                    <a:pos x="168" y="0"/>
                  </a:cxn>
                  <a:cxn ang="0">
                    <a:pos x="176" y="8"/>
                  </a:cxn>
                  <a:cxn ang="0">
                    <a:pos x="176" y="3048"/>
                  </a:cxn>
                  <a:cxn ang="0">
                    <a:pos x="168" y="3056"/>
                  </a:cxn>
                  <a:cxn ang="0">
                    <a:pos x="8" y="3056"/>
                  </a:cxn>
                  <a:cxn ang="0">
                    <a:pos x="0" y="3048"/>
                  </a:cxn>
                  <a:cxn ang="0">
                    <a:pos x="0" y="8"/>
                  </a:cxn>
                  <a:cxn ang="0">
                    <a:pos x="16" y="3048"/>
                  </a:cxn>
                  <a:cxn ang="0">
                    <a:pos x="8" y="3040"/>
                  </a:cxn>
                  <a:cxn ang="0">
                    <a:pos x="168" y="3040"/>
                  </a:cxn>
                  <a:cxn ang="0">
                    <a:pos x="160" y="3048"/>
                  </a:cxn>
                  <a:cxn ang="0">
                    <a:pos x="160" y="8"/>
                  </a:cxn>
                  <a:cxn ang="0">
                    <a:pos x="168" y="16"/>
                  </a:cxn>
                  <a:cxn ang="0">
                    <a:pos x="8" y="16"/>
                  </a:cxn>
                  <a:cxn ang="0">
                    <a:pos x="16" y="8"/>
                  </a:cxn>
                  <a:cxn ang="0">
                    <a:pos x="16" y="3048"/>
                  </a:cxn>
                </a:cxnLst>
                <a:rect l="0" t="0" r="r" b="b"/>
                <a:pathLst>
                  <a:path w="176" h="3056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168" y="0"/>
                    </a:lnTo>
                    <a:cubicBezTo>
                      <a:pt x="173" y="0"/>
                      <a:pt x="176" y="4"/>
                      <a:pt x="176" y="8"/>
                    </a:cubicBezTo>
                    <a:lnTo>
                      <a:pt x="176" y="3048"/>
                    </a:lnTo>
                    <a:cubicBezTo>
                      <a:pt x="176" y="3053"/>
                      <a:pt x="173" y="3056"/>
                      <a:pt x="168" y="3056"/>
                    </a:cubicBezTo>
                    <a:lnTo>
                      <a:pt x="8" y="3056"/>
                    </a:lnTo>
                    <a:cubicBezTo>
                      <a:pt x="4" y="3056"/>
                      <a:pt x="0" y="3053"/>
                      <a:pt x="0" y="3048"/>
                    </a:cubicBezTo>
                    <a:lnTo>
                      <a:pt x="0" y="8"/>
                    </a:lnTo>
                    <a:close/>
                    <a:moveTo>
                      <a:pt x="16" y="3048"/>
                    </a:moveTo>
                    <a:lnTo>
                      <a:pt x="8" y="3040"/>
                    </a:lnTo>
                    <a:lnTo>
                      <a:pt x="168" y="3040"/>
                    </a:lnTo>
                    <a:lnTo>
                      <a:pt x="160" y="3048"/>
                    </a:lnTo>
                    <a:lnTo>
                      <a:pt x="160" y="8"/>
                    </a:lnTo>
                    <a:lnTo>
                      <a:pt x="168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3048"/>
                    </a:lnTo>
                    <a:close/>
                  </a:path>
                </a:pathLst>
              </a:custGeom>
              <a:solidFill>
                <a:srgbClr val="000000"/>
              </a:solidFill>
              <a:ln w="793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503" name="Rectangle 479"/>
              <p:cNvSpPr>
                <a:spLocks noChangeArrowheads="1"/>
              </p:cNvSpPr>
              <p:nvPr/>
            </p:nvSpPr>
            <p:spPr bwMode="auto">
              <a:xfrm>
                <a:off x="1238946" y="538871"/>
                <a:ext cx="43980" cy="709258"/>
              </a:xfrm>
              <a:prstGeom prst="rect">
                <a:avLst/>
              </a:prstGeom>
              <a:solidFill>
                <a:srgbClr val="FFFF99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504" name="Freeform 480"/>
              <p:cNvSpPr>
                <a:spLocks noEditPoints="1"/>
              </p:cNvSpPr>
              <p:nvPr/>
            </p:nvSpPr>
            <p:spPr bwMode="auto">
              <a:xfrm>
                <a:off x="1236851" y="537014"/>
                <a:ext cx="48168" cy="712972"/>
              </a:xfrm>
              <a:custGeom>
                <a:avLst/>
                <a:gdLst/>
                <a:ahLst/>
                <a:cxnLst>
                  <a:cxn ang="0">
                    <a:pos x="0" y="8"/>
                  </a:cxn>
                  <a:cxn ang="0">
                    <a:pos x="8" y="0"/>
                  </a:cxn>
                  <a:cxn ang="0">
                    <a:pos x="168" y="0"/>
                  </a:cxn>
                  <a:cxn ang="0">
                    <a:pos x="176" y="8"/>
                  </a:cxn>
                  <a:cxn ang="0">
                    <a:pos x="176" y="3000"/>
                  </a:cxn>
                  <a:cxn ang="0">
                    <a:pos x="168" y="3008"/>
                  </a:cxn>
                  <a:cxn ang="0">
                    <a:pos x="8" y="3008"/>
                  </a:cxn>
                  <a:cxn ang="0">
                    <a:pos x="0" y="3000"/>
                  </a:cxn>
                  <a:cxn ang="0">
                    <a:pos x="0" y="8"/>
                  </a:cxn>
                  <a:cxn ang="0">
                    <a:pos x="16" y="3000"/>
                  </a:cxn>
                  <a:cxn ang="0">
                    <a:pos x="8" y="2992"/>
                  </a:cxn>
                  <a:cxn ang="0">
                    <a:pos x="168" y="2992"/>
                  </a:cxn>
                  <a:cxn ang="0">
                    <a:pos x="160" y="3000"/>
                  </a:cxn>
                  <a:cxn ang="0">
                    <a:pos x="160" y="8"/>
                  </a:cxn>
                  <a:cxn ang="0">
                    <a:pos x="168" y="16"/>
                  </a:cxn>
                  <a:cxn ang="0">
                    <a:pos x="8" y="16"/>
                  </a:cxn>
                  <a:cxn ang="0">
                    <a:pos x="16" y="8"/>
                  </a:cxn>
                  <a:cxn ang="0">
                    <a:pos x="16" y="3000"/>
                  </a:cxn>
                </a:cxnLst>
                <a:rect l="0" t="0" r="r" b="b"/>
                <a:pathLst>
                  <a:path w="176" h="3008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168" y="0"/>
                    </a:lnTo>
                    <a:cubicBezTo>
                      <a:pt x="173" y="0"/>
                      <a:pt x="176" y="4"/>
                      <a:pt x="176" y="8"/>
                    </a:cubicBezTo>
                    <a:lnTo>
                      <a:pt x="176" y="3000"/>
                    </a:lnTo>
                    <a:cubicBezTo>
                      <a:pt x="176" y="3005"/>
                      <a:pt x="173" y="3008"/>
                      <a:pt x="168" y="3008"/>
                    </a:cubicBezTo>
                    <a:lnTo>
                      <a:pt x="8" y="3008"/>
                    </a:lnTo>
                    <a:cubicBezTo>
                      <a:pt x="4" y="3008"/>
                      <a:pt x="0" y="3005"/>
                      <a:pt x="0" y="3000"/>
                    </a:cubicBezTo>
                    <a:lnTo>
                      <a:pt x="0" y="8"/>
                    </a:lnTo>
                    <a:close/>
                    <a:moveTo>
                      <a:pt x="16" y="3000"/>
                    </a:moveTo>
                    <a:lnTo>
                      <a:pt x="8" y="2992"/>
                    </a:lnTo>
                    <a:lnTo>
                      <a:pt x="168" y="2992"/>
                    </a:lnTo>
                    <a:lnTo>
                      <a:pt x="160" y="3000"/>
                    </a:lnTo>
                    <a:lnTo>
                      <a:pt x="160" y="8"/>
                    </a:lnTo>
                    <a:lnTo>
                      <a:pt x="168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3000"/>
                    </a:lnTo>
                    <a:close/>
                  </a:path>
                </a:pathLst>
              </a:custGeom>
              <a:solidFill>
                <a:srgbClr val="000000"/>
              </a:solidFill>
              <a:ln w="793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505" name="Rectangle 481"/>
              <p:cNvSpPr>
                <a:spLocks noChangeArrowheads="1"/>
              </p:cNvSpPr>
              <p:nvPr/>
            </p:nvSpPr>
            <p:spPr bwMode="auto">
              <a:xfrm>
                <a:off x="1369838" y="614067"/>
                <a:ext cx="38744" cy="634062"/>
              </a:xfrm>
              <a:prstGeom prst="rect">
                <a:avLst/>
              </a:prstGeom>
              <a:solidFill>
                <a:srgbClr val="FFFF99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506" name="Freeform 482"/>
              <p:cNvSpPr>
                <a:spLocks noEditPoints="1"/>
              </p:cNvSpPr>
              <p:nvPr/>
            </p:nvSpPr>
            <p:spPr bwMode="auto">
              <a:xfrm>
                <a:off x="1367744" y="612211"/>
                <a:ext cx="42933" cy="637776"/>
              </a:xfrm>
              <a:custGeom>
                <a:avLst/>
                <a:gdLst/>
                <a:ahLst/>
                <a:cxnLst>
                  <a:cxn ang="0">
                    <a:pos x="0" y="8"/>
                  </a:cxn>
                  <a:cxn ang="0">
                    <a:pos x="8" y="0"/>
                  </a:cxn>
                  <a:cxn ang="0">
                    <a:pos x="152" y="0"/>
                  </a:cxn>
                  <a:cxn ang="0">
                    <a:pos x="160" y="8"/>
                  </a:cxn>
                  <a:cxn ang="0">
                    <a:pos x="160" y="2680"/>
                  </a:cxn>
                  <a:cxn ang="0">
                    <a:pos x="152" y="2688"/>
                  </a:cxn>
                  <a:cxn ang="0">
                    <a:pos x="8" y="2688"/>
                  </a:cxn>
                  <a:cxn ang="0">
                    <a:pos x="0" y="2680"/>
                  </a:cxn>
                  <a:cxn ang="0">
                    <a:pos x="0" y="8"/>
                  </a:cxn>
                  <a:cxn ang="0">
                    <a:pos x="16" y="2680"/>
                  </a:cxn>
                  <a:cxn ang="0">
                    <a:pos x="8" y="2672"/>
                  </a:cxn>
                  <a:cxn ang="0">
                    <a:pos x="152" y="2672"/>
                  </a:cxn>
                  <a:cxn ang="0">
                    <a:pos x="144" y="2680"/>
                  </a:cxn>
                  <a:cxn ang="0">
                    <a:pos x="144" y="8"/>
                  </a:cxn>
                  <a:cxn ang="0">
                    <a:pos x="152" y="16"/>
                  </a:cxn>
                  <a:cxn ang="0">
                    <a:pos x="8" y="16"/>
                  </a:cxn>
                  <a:cxn ang="0">
                    <a:pos x="16" y="8"/>
                  </a:cxn>
                  <a:cxn ang="0">
                    <a:pos x="16" y="2680"/>
                  </a:cxn>
                </a:cxnLst>
                <a:rect l="0" t="0" r="r" b="b"/>
                <a:pathLst>
                  <a:path w="160" h="2688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152" y="0"/>
                    </a:lnTo>
                    <a:cubicBezTo>
                      <a:pt x="157" y="0"/>
                      <a:pt x="160" y="4"/>
                      <a:pt x="160" y="8"/>
                    </a:cubicBezTo>
                    <a:lnTo>
                      <a:pt x="160" y="2680"/>
                    </a:lnTo>
                    <a:cubicBezTo>
                      <a:pt x="160" y="2685"/>
                      <a:pt x="157" y="2688"/>
                      <a:pt x="152" y="2688"/>
                    </a:cubicBezTo>
                    <a:lnTo>
                      <a:pt x="8" y="2688"/>
                    </a:lnTo>
                    <a:cubicBezTo>
                      <a:pt x="4" y="2688"/>
                      <a:pt x="0" y="2685"/>
                      <a:pt x="0" y="2680"/>
                    </a:cubicBezTo>
                    <a:lnTo>
                      <a:pt x="0" y="8"/>
                    </a:lnTo>
                    <a:close/>
                    <a:moveTo>
                      <a:pt x="16" y="2680"/>
                    </a:moveTo>
                    <a:lnTo>
                      <a:pt x="8" y="2672"/>
                    </a:lnTo>
                    <a:lnTo>
                      <a:pt x="152" y="2672"/>
                    </a:lnTo>
                    <a:lnTo>
                      <a:pt x="144" y="2680"/>
                    </a:lnTo>
                    <a:lnTo>
                      <a:pt x="144" y="8"/>
                    </a:lnTo>
                    <a:lnTo>
                      <a:pt x="152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2680"/>
                    </a:lnTo>
                    <a:close/>
                  </a:path>
                </a:pathLst>
              </a:custGeom>
              <a:solidFill>
                <a:srgbClr val="000000"/>
              </a:solidFill>
              <a:ln w="793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507" name="Rectangle 483"/>
              <p:cNvSpPr>
                <a:spLocks noChangeArrowheads="1"/>
              </p:cNvSpPr>
              <p:nvPr/>
            </p:nvSpPr>
            <p:spPr bwMode="auto">
              <a:xfrm>
                <a:off x="1495495" y="333706"/>
                <a:ext cx="43980" cy="914424"/>
              </a:xfrm>
              <a:prstGeom prst="rect">
                <a:avLst/>
              </a:prstGeom>
              <a:solidFill>
                <a:srgbClr val="FFFF99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508" name="Freeform 484"/>
              <p:cNvSpPr>
                <a:spLocks noEditPoints="1"/>
              </p:cNvSpPr>
              <p:nvPr/>
            </p:nvSpPr>
            <p:spPr bwMode="auto">
              <a:xfrm>
                <a:off x="1493400" y="331850"/>
                <a:ext cx="48168" cy="918137"/>
              </a:xfrm>
              <a:custGeom>
                <a:avLst/>
                <a:gdLst/>
                <a:ahLst/>
                <a:cxnLst>
                  <a:cxn ang="0">
                    <a:pos x="0" y="8"/>
                  </a:cxn>
                  <a:cxn ang="0">
                    <a:pos x="8" y="0"/>
                  </a:cxn>
                  <a:cxn ang="0">
                    <a:pos x="168" y="0"/>
                  </a:cxn>
                  <a:cxn ang="0">
                    <a:pos x="176" y="8"/>
                  </a:cxn>
                  <a:cxn ang="0">
                    <a:pos x="176" y="3864"/>
                  </a:cxn>
                  <a:cxn ang="0">
                    <a:pos x="168" y="3872"/>
                  </a:cxn>
                  <a:cxn ang="0">
                    <a:pos x="8" y="3872"/>
                  </a:cxn>
                  <a:cxn ang="0">
                    <a:pos x="0" y="3864"/>
                  </a:cxn>
                  <a:cxn ang="0">
                    <a:pos x="0" y="8"/>
                  </a:cxn>
                  <a:cxn ang="0">
                    <a:pos x="16" y="3864"/>
                  </a:cxn>
                  <a:cxn ang="0">
                    <a:pos x="8" y="3856"/>
                  </a:cxn>
                  <a:cxn ang="0">
                    <a:pos x="168" y="3856"/>
                  </a:cxn>
                  <a:cxn ang="0">
                    <a:pos x="160" y="3864"/>
                  </a:cxn>
                  <a:cxn ang="0">
                    <a:pos x="160" y="8"/>
                  </a:cxn>
                  <a:cxn ang="0">
                    <a:pos x="168" y="16"/>
                  </a:cxn>
                  <a:cxn ang="0">
                    <a:pos x="8" y="16"/>
                  </a:cxn>
                  <a:cxn ang="0">
                    <a:pos x="16" y="8"/>
                  </a:cxn>
                  <a:cxn ang="0">
                    <a:pos x="16" y="3864"/>
                  </a:cxn>
                </a:cxnLst>
                <a:rect l="0" t="0" r="r" b="b"/>
                <a:pathLst>
                  <a:path w="176" h="3872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168" y="0"/>
                    </a:lnTo>
                    <a:cubicBezTo>
                      <a:pt x="173" y="0"/>
                      <a:pt x="176" y="4"/>
                      <a:pt x="176" y="8"/>
                    </a:cubicBezTo>
                    <a:lnTo>
                      <a:pt x="176" y="3864"/>
                    </a:lnTo>
                    <a:cubicBezTo>
                      <a:pt x="176" y="3869"/>
                      <a:pt x="173" y="3872"/>
                      <a:pt x="168" y="3872"/>
                    </a:cubicBezTo>
                    <a:lnTo>
                      <a:pt x="8" y="3872"/>
                    </a:lnTo>
                    <a:cubicBezTo>
                      <a:pt x="4" y="3872"/>
                      <a:pt x="0" y="3869"/>
                      <a:pt x="0" y="3864"/>
                    </a:cubicBezTo>
                    <a:lnTo>
                      <a:pt x="0" y="8"/>
                    </a:lnTo>
                    <a:close/>
                    <a:moveTo>
                      <a:pt x="16" y="3864"/>
                    </a:moveTo>
                    <a:lnTo>
                      <a:pt x="8" y="3856"/>
                    </a:lnTo>
                    <a:lnTo>
                      <a:pt x="168" y="3856"/>
                    </a:lnTo>
                    <a:lnTo>
                      <a:pt x="160" y="3864"/>
                    </a:lnTo>
                    <a:lnTo>
                      <a:pt x="160" y="8"/>
                    </a:lnTo>
                    <a:lnTo>
                      <a:pt x="168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3864"/>
                    </a:lnTo>
                    <a:close/>
                  </a:path>
                </a:pathLst>
              </a:custGeom>
              <a:solidFill>
                <a:srgbClr val="000000"/>
              </a:solidFill>
              <a:ln w="793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509" name="Rectangle 485"/>
              <p:cNvSpPr>
                <a:spLocks noChangeArrowheads="1"/>
              </p:cNvSpPr>
              <p:nvPr/>
            </p:nvSpPr>
            <p:spPr bwMode="auto">
              <a:xfrm>
                <a:off x="1622199" y="580647"/>
                <a:ext cx="42933" cy="667483"/>
              </a:xfrm>
              <a:prstGeom prst="rect">
                <a:avLst/>
              </a:prstGeom>
              <a:solidFill>
                <a:srgbClr val="FFFF99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510" name="Freeform 486"/>
              <p:cNvSpPr>
                <a:spLocks noEditPoints="1"/>
              </p:cNvSpPr>
              <p:nvPr/>
            </p:nvSpPr>
            <p:spPr bwMode="auto">
              <a:xfrm>
                <a:off x="1620105" y="578790"/>
                <a:ext cx="47122" cy="671196"/>
              </a:xfrm>
              <a:custGeom>
                <a:avLst/>
                <a:gdLst/>
                <a:ahLst/>
                <a:cxnLst>
                  <a:cxn ang="0">
                    <a:pos x="0" y="8"/>
                  </a:cxn>
                  <a:cxn ang="0">
                    <a:pos x="8" y="0"/>
                  </a:cxn>
                  <a:cxn ang="0">
                    <a:pos x="168" y="0"/>
                  </a:cxn>
                  <a:cxn ang="0">
                    <a:pos x="176" y="8"/>
                  </a:cxn>
                  <a:cxn ang="0">
                    <a:pos x="176" y="2824"/>
                  </a:cxn>
                  <a:cxn ang="0">
                    <a:pos x="168" y="2832"/>
                  </a:cxn>
                  <a:cxn ang="0">
                    <a:pos x="8" y="2832"/>
                  </a:cxn>
                  <a:cxn ang="0">
                    <a:pos x="0" y="2824"/>
                  </a:cxn>
                  <a:cxn ang="0">
                    <a:pos x="0" y="8"/>
                  </a:cxn>
                  <a:cxn ang="0">
                    <a:pos x="16" y="2824"/>
                  </a:cxn>
                  <a:cxn ang="0">
                    <a:pos x="8" y="2816"/>
                  </a:cxn>
                  <a:cxn ang="0">
                    <a:pos x="168" y="2816"/>
                  </a:cxn>
                  <a:cxn ang="0">
                    <a:pos x="160" y="2824"/>
                  </a:cxn>
                  <a:cxn ang="0">
                    <a:pos x="160" y="8"/>
                  </a:cxn>
                  <a:cxn ang="0">
                    <a:pos x="168" y="16"/>
                  </a:cxn>
                  <a:cxn ang="0">
                    <a:pos x="8" y="16"/>
                  </a:cxn>
                  <a:cxn ang="0">
                    <a:pos x="16" y="8"/>
                  </a:cxn>
                  <a:cxn ang="0">
                    <a:pos x="16" y="2824"/>
                  </a:cxn>
                </a:cxnLst>
                <a:rect l="0" t="0" r="r" b="b"/>
                <a:pathLst>
                  <a:path w="176" h="2832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168" y="0"/>
                    </a:lnTo>
                    <a:cubicBezTo>
                      <a:pt x="173" y="0"/>
                      <a:pt x="176" y="4"/>
                      <a:pt x="176" y="8"/>
                    </a:cubicBezTo>
                    <a:lnTo>
                      <a:pt x="176" y="2824"/>
                    </a:lnTo>
                    <a:cubicBezTo>
                      <a:pt x="176" y="2829"/>
                      <a:pt x="173" y="2832"/>
                      <a:pt x="168" y="2832"/>
                    </a:cubicBezTo>
                    <a:lnTo>
                      <a:pt x="8" y="2832"/>
                    </a:lnTo>
                    <a:cubicBezTo>
                      <a:pt x="4" y="2832"/>
                      <a:pt x="0" y="2829"/>
                      <a:pt x="0" y="2824"/>
                    </a:cubicBezTo>
                    <a:lnTo>
                      <a:pt x="0" y="8"/>
                    </a:lnTo>
                    <a:close/>
                    <a:moveTo>
                      <a:pt x="16" y="2824"/>
                    </a:moveTo>
                    <a:lnTo>
                      <a:pt x="8" y="2816"/>
                    </a:lnTo>
                    <a:lnTo>
                      <a:pt x="168" y="2816"/>
                    </a:lnTo>
                    <a:lnTo>
                      <a:pt x="160" y="2824"/>
                    </a:lnTo>
                    <a:lnTo>
                      <a:pt x="160" y="8"/>
                    </a:lnTo>
                    <a:lnTo>
                      <a:pt x="168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2824"/>
                    </a:lnTo>
                    <a:close/>
                  </a:path>
                </a:pathLst>
              </a:custGeom>
              <a:solidFill>
                <a:srgbClr val="000000"/>
              </a:solidFill>
              <a:ln w="793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511" name="Rectangle 487"/>
              <p:cNvSpPr>
                <a:spLocks noChangeArrowheads="1"/>
              </p:cNvSpPr>
              <p:nvPr/>
            </p:nvSpPr>
            <p:spPr bwMode="auto">
              <a:xfrm>
                <a:off x="1747856" y="455320"/>
                <a:ext cx="43980" cy="792810"/>
              </a:xfrm>
              <a:prstGeom prst="rect">
                <a:avLst/>
              </a:prstGeom>
              <a:solidFill>
                <a:srgbClr val="FFFF99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512" name="Freeform 488"/>
              <p:cNvSpPr>
                <a:spLocks noEditPoints="1"/>
              </p:cNvSpPr>
              <p:nvPr/>
            </p:nvSpPr>
            <p:spPr bwMode="auto">
              <a:xfrm>
                <a:off x="1745761" y="453463"/>
                <a:ext cx="48168" cy="796523"/>
              </a:xfrm>
              <a:custGeom>
                <a:avLst/>
                <a:gdLst/>
                <a:ahLst/>
                <a:cxnLst>
                  <a:cxn ang="0">
                    <a:pos x="0" y="8"/>
                  </a:cxn>
                  <a:cxn ang="0">
                    <a:pos x="8" y="0"/>
                  </a:cxn>
                  <a:cxn ang="0">
                    <a:pos x="168" y="0"/>
                  </a:cxn>
                  <a:cxn ang="0">
                    <a:pos x="176" y="8"/>
                  </a:cxn>
                  <a:cxn ang="0">
                    <a:pos x="176" y="3352"/>
                  </a:cxn>
                  <a:cxn ang="0">
                    <a:pos x="168" y="3360"/>
                  </a:cxn>
                  <a:cxn ang="0">
                    <a:pos x="8" y="3360"/>
                  </a:cxn>
                  <a:cxn ang="0">
                    <a:pos x="0" y="3352"/>
                  </a:cxn>
                  <a:cxn ang="0">
                    <a:pos x="0" y="8"/>
                  </a:cxn>
                  <a:cxn ang="0">
                    <a:pos x="16" y="3352"/>
                  </a:cxn>
                  <a:cxn ang="0">
                    <a:pos x="8" y="3344"/>
                  </a:cxn>
                  <a:cxn ang="0">
                    <a:pos x="168" y="3344"/>
                  </a:cxn>
                  <a:cxn ang="0">
                    <a:pos x="160" y="3352"/>
                  </a:cxn>
                  <a:cxn ang="0">
                    <a:pos x="160" y="8"/>
                  </a:cxn>
                  <a:cxn ang="0">
                    <a:pos x="168" y="16"/>
                  </a:cxn>
                  <a:cxn ang="0">
                    <a:pos x="8" y="16"/>
                  </a:cxn>
                  <a:cxn ang="0">
                    <a:pos x="16" y="8"/>
                  </a:cxn>
                  <a:cxn ang="0">
                    <a:pos x="16" y="3352"/>
                  </a:cxn>
                </a:cxnLst>
                <a:rect l="0" t="0" r="r" b="b"/>
                <a:pathLst>
                  <a:path w="176" h="3360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168" y="0"/>
                    </a:lnTo>
                    <a:cubicBezTo>
                      <a:pt x="173" y="0"/>
                      <a:pt x="176" y="4"/>
                      <a:pt x="176" y="8"/>
                    </a:cubicBezTo>
                    <a:lnTo>
                      <a:pt x="176" y="3352"/>
                    </a:lnTo>
                    <a:cubicBezTo>
                      <a:pt x="176" y="3357"/>
                      <a:pt x="173" y="3360"/>
                      <a:pt x="168" y="3360"/>
                    </a:cubicBezTo>
                    <a:lnTo>
                      <a:pt x="8" y="3360"/>
                    </a:lnTo>
                    <a:cubicBezTo>
                      <a:pt x="4" y="3360"/>
                      <a:pt x="0" y="3357"/>
                      <a:pt x="0" y="3352"/>
                    </a:cubicBezTo>
                    <a:lnTo>
                      <a:pt x="0" y="8"/>
                    </a:lnTo>
                    <a:close/>
                    <a:moveTo>
                      <a:pt x="16" y="3352"/>
                    </a:moveTo>
                    <a:lnTo>
                      <a:pt x="8" y="3344"/>
                    </a:lnTo>
                    <a:lnTo>
                      <a:pt x="168" y="3344"/>
                    </a:lnTo>
                    <a:lnTo>
                      <a:pt x="160" y="3352"/>
                    </a:lnTo>
                    <a:lnTo>
                      <a:pt x="160" y="8"/>
                    </a:lnTo>
                    <a:lnTo>
                      <a:pt x="168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3352"/>
                    </a:lnTo>
                    <a:close/>
                  </a:path>
                </a:pathLst>
              </a:custGeom>
              <a:solidFill>
                <a:srgbClr val="000000"/>
              </a:solidFill>
              <a:ln w="793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513" name="Rectangle 489"/>
              <p:cNvSpPr>
                <a:spLocks noChangeArrowheads="1"/>
              </p:cNvSpPr>
              <p:nvPr/>
            </p:nvSpPr>
            <p:spPr bwMode="auto">
              <a:xfrm>
                <a:off x="1878748" y="808092"/>
                <a:ext cx="38744" cy="440037"/>
              </a:xfrm>
              <a:prstGeom prst="rect">
                <a:avLst/>
              </a:prstGeom>
              <a:solidFill>
                <a:srgbClr val="FFFF99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514" name="Freeform 490"/>
              <p:cNvSpPr>
                <a:spLocks noEditPoints="1"/>
              </p:cNvSpPr>
              <p:nvPr/>
            </p:nvSpPr>
            <p:spPr bwMode="auto">
              <a:xfrm>
                <a:off x="1876653" y="806235"/>
                <a:ext cx="42933" cy="443751"/>
              </a:xfrm>
              <a:custGeom>
                <a:avLst/>
                <a:gdLst/>
                <a:ahLst/>
                <a:cxnLst>
                  <a:cxn ang="0">
                    <a:pos x="0" y="8"/>
                  </a:cxn>
                  <a:cxn ang="0">
                    <a:pos x="8" y="0"/>
                  </a:cxn>
                  <a:cxn ang="0">
                    <a:pos x="152" y="0"/>
                  </a:cxn>
                  <a:cxn ang="0">
                    <a:pos x="160" y="8"/>
                  </a:cxn>
                  <a:cxn ang="0">
                    <a:pos x="160" y="1864"/>
                  </a:cxn>
                  <a:cxn ang="0">
                    <a:pos x="152" y="1872"/>
                  </a:cxn>
                  <a:cxn ang="0">
                    <a:pos x="8" y="1872"/>
                  </a:cxn>
                  <a:cxn ang="0">
                    <a:pos x="0" y="1864"/>
                  </a:cxn>
                  <a:cxn ang="0">
                    <a:pos x="0" y="8"/>
                  </a:cxn>
                  <a:cxn ang="0">
                    <a:pos x="16" y="1864"/>
                  </a:cxn>
                  <a:cxn ang="0">
                    <a:pos x="8" y="1856"/>
                  </a:cxn>
                  <a:cxn ang="0">
                    <a:pos x="152" y="1856"/>
                  </a:cxn>
                  <a:cxn ang="0">
                    <a:pos x="144" y="1864"/>
                  </a:cxn>
                  <a:cxn ang="0">
                    <a:pos x="144" y="8"/>
                  </a:cxn>
                  <a:cxn ang="0">
                    <a:pos x="152" y="16"/>
                  </a:cxn>
                  <a:cxn ang="0">
                    <a:pos x="8" y="16"/>
                  </a:cxn>
                  <a:cxn ang="0">
                    <a:pos x="16" y="8"/>
                  </a:cxn>
                  <a:cxn ang="0">
                    <a:pos x="16" y="1864"/>
                  </a:cxn>
                </a:cxnLst>
                <a:rect l="0" t="0" r="r" b="b"/>
                <a:pathLst>
                  <a:path w="160" h="1872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152" y="0"/>
                    </a:lnTo>
                    <a:cubicBezTo>
                      <a:pt x="157" y="0"/>
                      <a:pt x="160" y="4"/>
                      <a:pt x="160" y="8"/>
                    </a:cubicBezTo>
                    <a:lnTo>
                      <a:pt x="160" y="1864"/>
                    </a:lnTo>
                    <a:cubicBezTo>
                      <a:pt x="160" y="1869"/>
                      <a:pt x="157" y="1872"/>
                      <a:pt x="152" y="1872"/>
                    </a:cubicBezTo>
                    <a:lnTo>
                      <a:pt x="8" y="1872"/>
                    </a:lnTo>
                    <a:cubicBezTo>
                      <a:pt x="4" y="1872"/>
                      <a:pt x="0" y="1869"/>
                      <a:pt x="0" y="1864"/>
                    </a:cubicBezTo>
                    <a:lnTo>
                      <a:pt x="0" y="8"/>
                    </a:lnTo>
                    <a:close/>
                    <a:moveTo>
                      <a:pt x="16" y="1864"/>
                    </a:moveTo>
                    <a:lnTo>
                      <a:pt x="8" y="1856"/>
                    </a:lnTo>
                    <a:lnTo>
                      <a:pt x="152" y="1856"/>
                    </a:lnTo>
                    <a:lnTo>
                      <a:pt x="144" y="1864"/>
                    </a:lnTo>
                    <a:lnTo>
                      <a:pt x="144" y="8"/>
                    </a:lnTo>
                    <a:lnTo>
                      <a:pt x="152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1864"/>
                    </a:lnTo>
                    <a:close/>
                  </a:path>
                </a:pathLst>
              </a:custGeom>
              <a:solidFill>
                <a:srgbClr val="000000"/>
              </a:solidFill>
              <a:ln w="793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515" name="Rectangle 491"/>
              <p:cNvSpPr>
                <a:spLocks noChangeArrowheads="1"/>
              </p:cNvSpPr>
              <p:nvPr/>
            </p:nvSpPr>
            <p:spPr bwMode="auto">
              <a:xfrm>
                <a:off x="2004404" y="417258"/>
                <a:ext cx="43980" cy="830872"/>
              </a:xfrm>
              <a:prstGeom prst="rect">
                <a:avLst/>
              </a:prstGeom>
              <a:solidFill>
                <a:srgbClr val="FFFF99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516" name="Freeform 492"/>
              <p:cNvSpPr>
                <a:spLocks noEditPoints="1"/>
              </p:cNvSpPr>
              <p:nvPr/>
            </p:nvSpPr>
            <p:spPr bwMode="auto">
              <a:xfrm>
                <a:off x="2002310" y="415401"/>
                <a:ext cx="48168" cy="834586"/>
              </a:xfrm>
              <a:custGeom>
                <a:avLst/>
                <a:gdLst/>
                <a:ahLst/>
                <a:cxnLst>
                  <a:cxn ang="0">
                    <a:pos x="0" y="8"/>
                  </a:cxn>
                  <a:cxn ang="0">
                    <a:pos x="8" y="0"/>
                  </a:cxn>
                  <a:cxn ang="0">
                    <a:pos x="168" y="0"/>
                  </a:cxn>
                  <a:cxn ang="0">
                    <a:pos x="176" y="8"/>
                  </a:cxn>
                  <a:cxn ang="0">
                    <a:pos x="176" y="3512"/>
                  </a:cxn>
                  <a:cxn ang="0">
                    <a:pos x="168" y="3520"/>
                  </a:cxn>
                  <a:cxn ang="0">
                    <a:pos x="8" y="3520"/>
                  </a:cxn>
                  <a:cxn ang="0">
                    <a:pos x="0" y="3512"/>
                  </a:cxn>
                  <a:cxn ang="0">
                    <a:pos x="0" y="8"/>
                  </a:cxn>
                  <a:cxn ang="0">
                    <a:pos x="16" y="3512"/>
                  </a:cxn>
                  <a:cxn ang="0">
                    <a:pos x="8" y="3504"/>
                  </a:cxn>
                  <a:cxn ang="0">
                    <a:pos x="168" y="3504"/>
                  </a:cxn>
                  <a:cxn ang="0">
                    <a:pos x="160" y="3512"/>
                  </a:cxn>
                  <a:cxn ang="0">
                    <a:pos x="160" y="8"/>
                  </a:cxn>
                  <a:cxn ang="0">
                    <a:pos x="168" y="16"/>
                  </a:cxn>
                  <a:cxn ang="0">
                    <a:pos x="8" y="16"/>
                  </a:cxn>
                  <a:cxn ang="0">
                    <a:pos x="16" y="8"/>
                  </a:cxn>
                  <a:cxn ang="0">
                    <a:pos x="16" y="3512"/>
                  </a:cxn>
                </a:cxnLst>
                <a:rect l="0" t="0" r="r" b="b"/>
                <a:pathLst>
                  <a:path w="176" h="3520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168" y="0"/>
                    </a:lnTo>
                    <a:cubicBezTo>
                      <a:pt x="173" y="0"/>
                      <a:pt x="176" y="4"/>
                      <a:pt x="176" y="8"/>
                    </a:cubicBezTo>
                    <a:lnTo>
                      <a:pt x="176" y="3512"/>
                    </a:lnTo>
                    <a:cubicBezTo>
                      <a:pt x="176" y="3517"/>
                      <a:pt x="173" y="3520"/>
                      <a:pt x="168" y="3520"/>
                    </a:cubicBezTo>
                    <a:lnTo>
                      <a:pt x="8" y="3520"/>
                    </a:lnTo>
                    <a:cubicBezTo>
                      <a:pt x="4" y="3520"/>
                      <a:pt x="0" y="3517"/>
                      <a:pt x="0" y="3512"/>
                    </a:cubicBezTo>
                    <a:lnTo>
                      <a:pt x="0" y="8"/>
                    </a:lnTo>
                    <a:close/>
                    <a:moveTo>
                      <a:pt x="16" y="3512"/>
                    </a:moveTo>
                    <a:lnTo>
                      <a:pt x="8" y="3504"/>
                    </a:lnTo>
                    <a:lnTo>
                      <a:pt x="168" y="3504"/>
                    </a:lnTo>
                    <a:lnTo>
                      <a:pt x="160" y="3512"/>
                    </a:lnTo>
                    <a:lnTo>
                      <a:pt x="160" y="8"/>
                    </a:lnTo>
                    <a:lnTo>
                      <a:pt x="168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3512"/>
                    </a:lnTo>
                    <a:close/>
                  </a:path>
                </a:pathLst>
              </a:custGeom>
              <a:solidFill>
                <a:srgbClr val="000000"/>
              </a:solidFill>
              <a:ln w="793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517" name="Rectangle 493"/>
              <p:cNvSpPr>
                <a:spLocks noChangeArrowheads="1"/>
              </p:cNvSpPr>
              <p:nvPr/>
            </p:nvSpPr>
            <p:spPr bwMode="auto">
              <a:xfrm>
                <a:off x="2131109" y="978908"/>
                <a:ext cx="42933" cy="269221"/>
              </a:xfrm>
              <a:prstGeom prst="rect">
                <a:avLst/>
              </a:prstGeom>
              <a:solidFill>
                <a:srgbClr val="FFFF99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518" name="Freeform 494"/>
              <p:cNvSpPr>
                <a:spLocks noEditPoints="1"/>
              </p:cNvSpPr>
              <p:nvPr/>
            </p:nvSpPr>
            <p:spPr bwMode="auto">
              <a:xfrm>
                <a:off x="2129014" y="977052"/>
                <a:ext cx="47122" cy="272935"/>
              </a:xfrm>
              <a:custGeom>
                <a:avLst/>
                <a:gdLst/>
                <a:ahLst/>
                <a:cxnLst>
                  <a:cxn ang="0">
                    <a:pos x="0" y="8"/>
                  </a:cxn>
                  <a:cxn ang="0">
                    <a:pos x="8" y="0"/>
                  </a:cxn>
                  <a:cxn ang="0">
                    <a:pos x="168" y="0"/>
                  </a:cxn>
                  <a:cxn ang="0">
                    <a:pos x="176" y="8"/>
                  </a:cxn>
                  <a:cxn ang="0">
                    <a:pos x="176" y="1144"/>
                  </a:cxn>
                  <a:cxn ang="0">
                    <a:pos x="168" y="1152"/>
                  </a:cxn>
                  <a:cxn ang="0">
                    <a:pos x="8" y="1152"/>
                  </a:cxn>
                  <a:cxn ang="0">
                    <a:pos x="0" y="1144"/>
                  </a:cxn>
                  <a:cxn ang="0">
                    <a:pos x="0" y="8"/>
                  </a:cxn>
                  <a:cxn ang="0">
                    <a:pos x="16" y="1144"/>
                  </a:cxn>
                  <a:cxn ang="0">
                    <a:pos x="8" y="1136"/>
                  </a:cxn>
                  <a:cxn ang="0">
                    <a:pos x="168" y="1136"/>
                  </a:cxn>
                  <a:cxn ang="0">
                    <a:pos x="160" y="1144"/>
                  </a:cxn>
                  <a:cxn ang="0">
                    <a:pos x="160" y="8"/>
                  </a:cxn>
                  <a:cxn ang="0">
                    <a:pos x="168" y="16"/>
                  </a:cxn>
                  <a:cxn ang="0">
                    <a:pos x="8" y="16"/>
                  </a:cxn>
                  <a:cxn ang="0">
                    <a:pos x="16" y="8"/>
                  </a:cxn>
                  <a:cxn ang="0">
                    <a:pos x="16" y="1144"/>
                  </a:cxn>
                </a:cxnLst>
                <a:rect l="0" t="0" r="r" b="b"/>
                <a:pathLst>
                  <a:path w="176" h="1152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168" y="0"/>
                    </a:lnTo>
                    <a:cubicBezTo>
                      <a:pt x="173" y="0"/>
                      <a:pt x="176" y="4"/>
                      <a:pt x="176" y="8"/>
                    </a:cubicBezTo>
                    <a:lnTo>
                      <a:pt x="176" y="1144"/>
                    </a:lnTo>
                    <a:cubicBezTo>
                      <a:pt x="176" y="1149"/>
                      <a:pt x="173" y="1152"/>
                      <a:pt x="168" y="1152"/>
                    </a:cubicBezTo>
                    <a:lnTo>
                      <a:pt x="8" y="1152"/>
                    </a:lnTo>
                    <a:cubicBezTo>
                      <a:pt x="4" y="1152"/>
                      <a:pt x="0" y="1149"/>
                      <a:pt x="0" y="1144"/>
                    </a:cubicBezTo>
                    <a:lnTo>
                      <a:pt x="0" y="8"/>
                    </a:lnTo>
                    <a:close/>
                    <a:moveTo>
                      <a:pt x="16" y="1144"/>
                    </a:moveTo>
                    <a:lnTo>
                      <a:pt x="8" y="1136"/>
                    </a:lnTo>
                    <a:lnTo>
                      <a:pt x="168" y="1136"/>
                    </a:lnTo>
                    <a:lnTo>
                      <a:pt x="160" y="1144"/>
                    </a:lnTo>
                    <a:lnTo>
                      <a:pt x="160" y="8"/>
                    </a:lnTo>
                    <a:lnTo>
                      <a:pt x="168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1144"/>
                    </a:lnTo>
                    <a:close/>
                  </a:path>
                </a:pathLst>
              </a:custGeom>
              <a:solidFill>
                <a:srgbClr val="000000"/>
              </a:solidFill>
              <a:ln w="793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519" name="Rectangle 495"/>
              <p:cNvSpPr>
                <a:spLocks noChangeArrowheads="1"/>
              </p:cNvSpPr>
              <p:nvPr/>
            </p:nvSpPr>
            <p:spPr bwMode="auto">
              <a:xfrm>
                <a:off x="2256765" y="731967"/>
                <a:ext cx="43980" cy="516162"/>
              </a:xfrm>
              <a:prstGeom prst="rect">
                <a:avLst/>
              </a:prstGeom>
              <a:solidFill>
                <a:srgbClr val="FFFF99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520" name="Freeform 496"/>
              <p:cNvSpPr>
                <a:spLocks noEditPoints="1"/>
              </p:cNvSpPr>
              <p:nvPr/>
            </p:nvSpPr>
            <p:spPr bwMode="auto">
              <a:xfrm>
                <a:off x="2254671" y="730111"/>
                <a:ext cx="48168" cy="519875"/>
              </a:xfrm>
              <a:custGeom>
                <a:avLst/>
                <a:gdLst/>
                <a:ahLst/>
                <a:cxnLst>
                  <a:cxn ang="0">
                    <a:pos x="0" y="8"/>
                  </a:cxn>
                  <a:cxn ang="0">
                    <a:pos x="8" y="0"/>
                  </a:cxn>
                  <a:cxn ang="0">
                    <a:pos x="168" y="0"/>
                  </a:cxn>
                  <a:cxn ang="0">
                    <a:pos x="176" y="8"/>
                  </a:cxn>
                  <a:cxn ang="0">
                    <a:pos x="176" y="2184"/>
                  </a:cxn>
                  <a:cxn ang="0">
                    <a:pos x="168" y="2192"/>
                  </a:cxn>
                  <a:cxn ang="0">
                    <a:pos x="8" y="2192"/>
                  </a:cxn>
                  <a:cxn ang="0">
                    <a:pos x="0" y="2184"/>
                  </a:cxn>
                  <a:cxn ang="0">
                    <a:pos x="0" y="8"/>
                  </a:cxn>
                  <a:cxn ang="0">
                    <a:pos x="16" y="2184"/>
                  </a:cxn>
                  <a:cxn ang="0">
                    <a:pos x="8" y="2176"/>
                  </a:cxn>
                  <a:cxn ang="0">
                    <a:pos x="168" y="2176"/>
                  </a:cxn>
                  <a:cxn ang="0">
                    <a:pos x="160" y="2184"/>
                  </a:cxn>
                  <a:cxn ang="0">
                    <a:pos x="160" y="8"/>
                  </a:cxn>
                  <a:cxn ang="0">
                    <a:pos x="168" y="16"/>
                  </a:cxn>
                  <a:cxn ang="0">
                    <a:pos x="8" y="16"/>
                  </a:cxn>
                  <a:cxn ang="0">
                    <a:pos x="16" y="8"/>
                  </a:cxn>
                  <a:cxn ang="0">
                    <a:pos x="16" y="2184"/>
                  </a:cxn>
                </a:cxnLst>
                <a:rect l="0" t="0" r="r" b="b"/>
                <a:pathLst>
                  <a:path w="176" h="2192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168" y="0"/>
                    </a:lnTo>
                    <a:cubicBezTo>
                      <a:pt x="173" y="0"/>
                      <a:pt x="176" y="4"/>
                      <a:pt x="176" y="8"/>
                    </a:cubicBezTo>
                    <a:lnTo>
                      <a:pt x="176" y="2184"/>
                    </a:lnTo>
                    <a:cubicBezTo>
                      <a:pt x="176" y="2189"/>
                      <a:pt x="173" y="2192"/>
                      <a:pt x="168" y="2192"/>
                    </a:cubicBezTo>
                    <a:lnTo>
                      <a:pt x="8" y="2192"/>
                    </a:lnTo>
                    <a:cubicBezTo>
                      <a:pt x="4" y="2192"/>
                      <a:pt x="0" y="2189"/>
                      <a:pt x="0" y="2184"/>
                    </a:cubicBezTo>
                    <a:lnTo>
                      <a:pt x="0" y="8"/>
                    </a:lnTo>
                    <a:close/>
                    <a:moveTo>
                      <a:pt x="16" y="2184"/>
                    </a:moveTo>
                    <a:lnTo>
                      <a:pt x="8" y="2176"/>
                    </a:lnTo>
                    <a:lnTo>
                      <a:pt x="168" y="2176"/>
                    </a:lnTo>
                    <a:lnTo>
                      <a:pt x="160" y="2184"/>
                    </a:lnTo>
                    <a:lnTo>
                      <a:pt x="160" y="8"/>
                    </a:lnTo>
                    <a:lnTo>
                      <a:pt x="168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2184"/>
                    </a:lnTo>
                    <a:close/>
                  </a:path>
                </a:pathLst>
              </a:custGeom>
              <a:solidFill>
                <a:srgbClr val="000000"/>
              </a:solidFill>
              <a:ln w="793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521" name="Rectangle 497"/>
              <p:cNvSpPr>
                <a:spLocks noChangeArrowheads="1"/>
              </p:cNvSpPr>
              <p:nvPr/>
            </p:nvSpPr>
            <p:spPr bwMode="auto">
              <a:xfrm>
                <a:off x="2387658" y="659556"/>
                <a:ext cx="38744" cy="588573"/>
              </a:xfrm>
              <a:prstGeom prst="rect">
                <a:avLst/>
              </a:prstGeom>
              <a:solidFill>
                <a:srgbClr val="FFFF99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522" name="Freeform 498"/>
              <p:cNvSpPr>
                <a:spLocks noEditPoints="1"/>
              </p:cNvSpPr>
              <p:nvPr/>
            </p:nvSpPr>
            <p:spPr bwMode="auto">
              <a:xfrm>
                <a:off x="2385563" y="657700"/>
                <a:ext cx="42933" cy="592286"/>
              </a:xfrm>
              <a:custGeom>
                <a:avLst/>
                <a:gdLst/>
                <a:ahLst/>
                <a:cxnLst>
                  <a:cxn ang="0">
                    <a:pos x="0" y="8"/>
                  </a:cxn>
                  <a:cxn ang="0">
                    <a:pos x="8" y="0"/>
                  </a:cxn>
                  <a:cxn ang="0">
                    <a:pos x="152" y="0"/>
                  </a:cxn>
                  <a:cxn ang="0">
                    <a:pos x="160" y="8"/>
                  </a:cxn>
                  <a:cxn ang="0">
                    <a:pos x="160" y="2488"/>
                  </a:cxn>
                  <a:cxn ang="0">
                    <a:pos x="152" y="2496"/>
                  </a:cxn>
                  <a:cxn ang="0">
                    <a:pos x="8" y="2496"/>
                  </a:cxn>
                  <a:cxn ang="0">
                    <a:pos x="0" y="2488"/>
                  </a:cxn>
                  <a:cxn ang="0">
                    <a:pos x="0" y="8"/>
                  </a:cxn>
                  <a:cxn ang="0">
                    <a:pos x="16" y="2488"/>
                  </a:cxn>
                  <a:cxn ang="0">
                    <a:pos x="8" y="2480"/>
                  </a:cxn>
                  <a:cxn ang="0">
                    <a:pos x="152" y="2480"/>
                  </a:cxn>
                  <a:cxn ang="0">
                    <a:pos x="144" y="2488"/>
                  </a:cxn>
                  <a:cxn ang="0">
                    <a:pos x="144" y="8"/>
                  </a:cxn>
                  <a:cxn ang="0">
                    <a:pos x="152" y="16"/>
                  </a:cxn>
                  <a:cxn ang="0">
                    <a:pos x="8" y="16"/>
                  </a:cxn>
                  <a:cxn ang="0">
                    <a:pos x="16" y="8"/>
                  </a:cxn>
                  <a:cxn ang="0">
                    <a:pos x="16" y="2488"/>
                  </a:cxn>
                </a:cxnLst>
                <a:rect l="0" t="0" r="r" b="b"/>
                <a:pathLst>
                  <a:path w="160" h="2496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152" y="0"/>
                    </a:lnTo>
                    <a:cubicBezTo>
                      <a:pt x="157" y="0"/>
                      <a:pt x="160" y="4"/>
                      <a:pt x="160" y="8"/>
                    </a:cubicBezTo>
                    <a:lnTo>
                      <a:pt x="160" y="2488"/>
                    </a:lnTo>
                    <a:cubicBezTo>
                      <a:pt x="160" y="2493"/>
                      <a:pt x="157" y="2496"/>
                      <a:pt x="152" y="2496"/>
                    </a:cubicBezTo>
                    <a:lnTo>
                      <a:pt x="8" y="2496"/>
                    </a:lnTo>
                    <a:cubicBezTo>
                      <a:pt x="4" y="2496"/>
                      <a:pt x="0" y="2493"/>
                      <a:pt x="0" y="2488"/>
                    </a:cubicBezTo>
                    <a:lnTo>
                      <a:pt x="0" y="8"/>
                    </a:lnTo>
                    <a:close/>
                    <a:moveTo>
                      <a:pt x="16" y="2488"/>
                    </a:moveTo>
                    <a:lnTo>
                      <a:pt x="8" y="2480"/>
                    </a:lnTo>
                    <a:lnTo>
                      <a:pt x="152" y="2480"/>
                    </a:lnTo>
                    <a:lnTo>
                      <a:pt x="144" y="2488"/>
                    </a:lnTo>
                    <a:lnTo>
                      <a:pt x="144" y="8"/>
                    </a:lnTo>
                    <a:lnTo>
                      <a:pt x="152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2488"/>
                    </a:lnTo>
                    <a:close/>
                  </a:path>
                </a:pathLst>
              </a:custGeom>
              <a:solidFill>
                <a:srgbClr val="000000"/>
              </a:solidFill>
              <a:ln w="793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523" name="Rectangle 499"/>
              <p:cNvSpPr>
                <a:spLocks noChangeArrowheads="1"/>
              </p:cNvSpPr>
              <p:nvPr/>
            </p:nvSpPr>
            <p:spPr bwMode="auto">
              <a:xfrm>
                <a:off x="2513314" y="834086"/>
                <a:ext cx="43980" cy="414043"/>
              </a:xfrm>
              <a:prstGeom prst="rect">
                <a:avLst/>
              </a:prstGeom>
              <a:solidFill>
                <a:srgbClr val="FFFF99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524" name="Freeform 500"/>
              <p:cNvSpPr>
                <a:spLocks noEditPoints="1"/>
              </p:cNvSpPr>
              <p:nvPr/>
            </p:nvSpPr>
            <p:spPr bwMode="auto">
              <a:xfrm>
                <a:off x="2511220" y="832229"/>
                <a:ext cx="48168" cy="417757"/>
              </a:xfrm>
              <a:custGeom>
                <a:avLst/>
                <a:gdLst/>
                <a:ahLst/>
                <a:cxnLst>
                  <a:cxn ang="0">
                    <a:pos x="0" y="8"/>
                  </a:cxn>
                  <a:cxn ang="0">
                    <a:pos x="8" y="0"/>
                  </a:cxn>
                  <a:cxn ang="0">
                    <a:pos x="168" y="0"/>
                  </a:cxn>
                  <a:cxn ang="0">
                    <a:pos x="176" y="8"/>
                  </a:cxn>
                  <a:cxn ang="0">
                    <a:pos x="176" y="1752"/>
                  </a:cxn>
                  <a:cxn ang="0">
                    <a:pos x="168" y="1760"/>
                  </a:cxn>
                  <a:cxn ang="0">
                    <a:pos x="8" y="1760"/>
                  </a:cxn>
                  <a:cxn ang="0">
                    <a:pos x="0" y="1752"/>
                  </a:cxn>
                  <a:cxn ang="0">
                    <a:pos x="0" y="8"/>
                  </a:cxn>
                  <a:cxn ang="0">
                    <a:pos x="16" y="1752"/>
                  </a:cxn>
                  <a:cxn ang="0">
                    <a:pos x="8" y="1744"/>
                  </a:cxn>
                  <a:cxn ang="0">
                    <a:pos x="168" y="1744"/>
                  </a:cxn>
                  <a:cxn ang="0">
                    <a:pos x="160" y="1752"/>
                  </a:cxn>
                  <a:cxn ang="0">
                    <a:pos x="160" y="8"/>
                  </a:cxn>
                  <a:cxn ang="0">
                    <a:pos x="168" y="16"/>
                  </a:cxn>
                  <a:cxn ang="0">
                    <a:pos x="8" y="16"/>
                  </a:cxn>
                  <a:cxn ang="0">
                    <a:pos x="16" y="8"/>
                  </a:cxn>
                  <a:cxn ang="0">
                    <a:pos x="16" y="1752"/>
                  </a:cxn>
                </a:cxnLst>
                <a:rect l="0" t="0" r="r" b="b"/>
                <a:pathLst>
                  <a:path w="176" h="1760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168" y="0"/>
                    </a:lnTo>
                    <a:cubicBezTo>
                      <a:pt x="173" y="0"/>
                      <a:pt x="176" y="4"/>
                      <a:pt x="176" y="8"/>
                    </a:cubicBezTo>
                    <a:lnTo>
                      <a:pt x="176" y="1752"/>
                    </a:lnTo>
                    <a:cubicBezTo>
                      <a:pt x="176" y="1757"/>
                      <a:pt x="173" y="1760"/>
                      <a:pt x="168" y="1760"/>
                    </a:cubicBezTo>
                    <a:lnTo>
                      <a:pt x="8" y="1760"/>
                    </a:lnTo>
                    <a:cubicBezTo>
                      <a:pt x="4" y="1760"/>
                      <a:pt x="0" y="1757"/>
                      <a:pt x="0" y="1752"/>
                    </a:cubicBezTo>
                    <a:lnTo>
                      <a:pt x="0" y="8"/>
                    </a:lnTo>
                    <a:close/>
                    <a:moveTo>
                      <a:pt x="16" y="1752"/>
                    </a:moveTo>
                    <a:lnTo>
                      <a:pt x="8" y="1744"/>
                    </a:lnTo>
                    <a:lnTo>
                      <a:pt x="168" y="1744"/>
                    </a:lnTo>
                    <a:lnTo>
                      <a:pt x="160" y="1752"/>
                    </a:lnTo>
                    <a:lnTo>
                      <a:pt x="160" y="8"/>
                    </a:lnTo>
                    <a:lnTo>
                      <a:pt x="168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1752"/>
                    </a:lnTo>
                    <a:close/>
                  </a:path>
                </a:pathLst>
              </a:custGeom>
              <a:solidFill>
                <a:srgbClr val="000000"/>
              </a:solidFill>
              <a:ln w="793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525" name="Rectangle 501"/>
              <p:cNvSpPr>
                <a:spLocks noChangeArrowheads="1"/>
              </p:cNvSpPr>
              <p:nvPr/>
            </p:nvSpPr>
            <p:spPr bwMode="auto">
              <a:xfrm>
                <a:off x="2640019" y="1069886"/>
                <a:ext cx="42933" cy="178243"/>
              </a:xfrm>
              <a:prstGeom prst="rect">
                <a:avLst/>
              </a:prstGeom>
              <a:solidFill>
                <a:srgbClr val="FFFF99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526" name="Freeform 502"/>
              <p:cNvSpPr>
                <a:spLocks noEditPoints="1"/>
              </p:cNvSpPr>
              <p:nvPr/>
            </p:nvSpPr>
            <p:spPr bwMode="auto">
              <a:xfrm>
                <a:off x="2637924" y="1068030"/>
                <a:ext cx="48168" cy="181956"/>
              </a:xfrm>
              <a:custGeom>
                <a:avLst/>
                <a:gdLst/>
                <a:ahLst/>
                <a:cxnLst>
                  <a:cxn ang="0">
                    <a:pos x="0" y="8"/>
                  </a:cxn>
                  <a:cxn ang="0">
                    <a:pos x="8" y="0"/>
                  </a:cxn>
                  <a:cxn ang="0">
                    <a:pos x="168" y="0"/>
                  </a:cxn>
                  <a:cxn ang="0">
                    <a:pos x="176" y="8"/>
                  </a:cxn>
                  <a:cxn ang="0">
                    <a:pos x="176" y="760"/>
                  </a:cxn>
                  <a:cxn ang="0">
                    <a:pos x="168" y="768"/>
                  </a:cxn>
                  <a:cxn ang="0">
                    <a:pos x="8" y="768"/>
                  </a:cxn>
                  <a:cxn ang="0">
                    <a:pos x="0" y="760"/>
                  </a:cxn>
                  <a:cxn ang="0">
                    <a:pos x="0" y="8"/>
                  </a:cxn>
                  <a:cxn ang="0">
                    <a:pos x="16" y="760"/>
                  </a:cxn>
                  <a:cxn ang="0">
                    <a:pos x="8" y="752"/>
                  </a:cxn>
                  <a:cxn ang="0">
                    <a:pos x="168" y="752"/>
                  </a:cxn>
                  <a:cxn ang="0">
                    <a:pos x="160" y="760"/>
                  </a:cxn>
                  <a:cxn ang="0">
                    <a:pos x="160" y="8"/>
                  </a:cxn>
                  <a:cxn ang="0">
                    <a:pos x="168" y="16"/>
                  </a:cxn>
                  <a:cxn ang="0">
                    <a:pos x="8" y="16"/>
                  </a:cxn>
                  <a:cxn ang="0">
                    <a:pos x="16" y="8"/>
                  </a:cxn>
                  <a:cxn ang="0">
                    <a:pos x="16" y="760"/>
                  </a:cxn>
                </a:cxnLst>
                <a:rect l="0" t="0" r="r" b="b"/>
                <a:pathLst>
                  <a:path w="176" h="768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168" y="0"/>
                    </a:lnTo>
                    <a:cubicBezTo>
                      <a:pt x="173" y="0"/>
                      <a:pt x="176" y="4"/>
                      <a:pt x="176" y="8"/>
                    </a:cubicBezTo>
                    <a:lnTo>
                      <a:pt x="176" y="760"/>
                    </a:lnTo>
                    <a:cubicBezTo>
                      <a:pt x="176" y="765"/>
                      <a:pt x="173" y="768"/>
                      <a:pt x="168" y="768"/>
                    </a:cubicBezTo>
                    <a:lnTo>
                      <a:pt x="8" y="768"/>
                    </a:lnTo>
                    <a:cubicBezTo>
                      <a:pt x="4" y="768"/>
                      <a:pt x="0" y="765"/>
                      <a:pt x="0" y="760"/>
                    </a:cubicBezTo>
                    <a:lnTo>
                      <a:pt x="0" y="8"/>
                    </a:lnTo>
                    <a:close/>
                    <a:moveTo>
                      <a:pt x="16" y="760"/>
                    </a:moveTo>
                    <a:lnTo>
                      <a:pt x="8" y="752"/>
                    </a:lnTo>
                    <a:lnTo>
                      <a:pt x="168" y="752"/>
                    </a:lnTo>
                    <a:lnTo>
                      <a:pt x="160" y="760"/>
                    </a:lnTo>
                    <a:lnTo>
                      <a:pt x="160" y="8"/>
                    </a:lnTo>
                    <a:lnTo>
                      <a:pt x="168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760"/>
                    </a:lnTo>
                    <a:close/>
                  </a:path>
                </a:pathLst>
              </a:custGeom>
              <a:solidFill>
                <a:srgbClr val="000000"/>
              </a:solidFill>
              <a:ln w="793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527" name="Rectangle 503"/>
              <p:cNvSpPr>
                <a:spLocks noChangeArrowheads="1"/>
              </p:cNvSpPr>
              <p:nvPr/>
            </p:nvSpPr>
            <p:spPr bwMode="auto">
              <a:xfrm>
                <a:off x="2765675" y="830372"/>
                <a:ext cx="43980" cy="417757"/>
              </a:xfrm>
              <a:prstGeom prst="rect">
                <a:avLst/>
              </a:prstGeom>
              <a:solidFill>
                <a:srgbClr val="FFFF99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528" name="Freeform 504"/>
              <p:cNvSpPr>
                <a:spLocks noEditPoints="1"/>
              </p:cNvSpPr>
              <p:nvPr/>
            </p:nvSpPr>
            <p:spPr bwMode="auto">
              <a:xfrm>
                <a:off x="2763581" y="828516"/>
                <a:ext cx="48168" cy="421470"/>
              </a:xfrm>
              <a:custGeom>
                <a:avLst/>
                <a:gdLst/>
                <a:ahLst/>
                <a:cxnLst>
                  <a:cxn ang="0">
                    <a:pos x="0" y="8"/>
                  </a:cxn>
                  <a:cxn ang="0">
                    <a:pos x="8" y="0"/>
                  </a:cxn>
                  <a:cxn ang="0">
                    <a:pos x="168" y="0"/>
                  </a:cxn>
                  <a:cxn ang="0">
                    <a:pos x="176" y="8"/>
                  </a:cxn>
                  <a:cxn ang="0">
                    <a:pos x="176" y="1768"/>
                  </a:cxn>
                  <a:cxn ang="0">
                    <a:pos x="168" y="1776"/>
                  </a:cxn>
                  <a:cxn ang="0">
                    <a:pos x="8" y="1776"/>
                  </a:cxn>
                  <a:cxn ang="0">
                    <a:pos x="0" y="1768"/>
                  </a:cxn>
                  <a:cxn ang="0">
                    <a:pos x="0" y="8"/>
                  </a:cxn>
                  <a:cxn ang="0">
                    <a:pos x="16" y="1768"/>
                  </a:cxn>
                  <a:cxn ang="0">
                    <a:pos x="8" y="1760"/>
                  </a:cxn>
                  <a:cxn ang="0">
                    <a:pos x="168" y="1760"/>
                  </a:cxn>
                  <a:cxn ang="0">
                    <a:pos x="160" y="1768"/>
                  </a:cxn>
                  <a:cxn ang="0">
                    <a:pos x="160" y="8"/>
                  </a:cxn>
                  <a:cxn ang="0">
                    <a:pos x="168" y="16"/>
                  </a:cxn>
                  <a:cxn ang="0">
                    <a:pos x="8" y="16"/>
                  </a:cxn>
                  <a:cxn ang="0">
                    <a:pos x="16" y="8"/>
                  </a:cxn>
                  <a:cxn ang="0">
                    <a:pos x="16" y="1768"/>
                  </a:cxn>
                </a:cxnLst>
                <a:rect l="0" t="0" r="r" b="b"/>
                <a:pathLst>
                  <a:path w="176" h="1776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168" y="0"/>
                    </a:lnTo>
                    <a:cubicBezTo>
                      <a:pt x="173" y="0"/>
                      <a:pt x="176" y="4"/>
                      <a:pt x="176" y="8"/>
                    </a:cubicBezTo>
                    <a:lnTo>
                      <a:pt x="176" y="1768"/>
                    </a:lnTo>
                    <a:cubicBezTo>
                      <a:pt x="176" y="1773"/>
                      <a:pt x="173" y="1776"/>
                      <a:pt x="168" y="1776"/>
                    </a:cubicBezTo>
                    <a:lnTo>
                      <a:pt x="8" y="1776"/>
                    </a:lnTo>
                    <a:cubicBezTo>
                      <a:pt x="4" y="1776"/>
                      <a:pt x="0" y="1773"/>
                      <a:pt x="0" y="1768"/>
                    </a:cubicBezTo>
                    <a:lnTo>
                      <a:pt x="0" y="8"/>
                    </a:lnTo>
                    <a:close/>
                    <a:moveTo>
                      <a:pt x="16" y="1768"/>
                    </a:moveTo>
                    <a:lnTo>
                      <a:pt x="8" y="1760"/>
                    </a:lnTo>
                    <a:lnTo>
                      <a:pt x="168" y="1760"/>
                    </a:lnTo>
                    <a:lnTo>
                      <a:pt x="160" y="1768"/>
                    </a:lnTo>
                    <a:lnTo>
                      <a:pt x="160" y="8"/>
                    </a:lnTo>
                    <a:lnTo>
                      <a:pt x="168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1768"/>
                    </a:lnTo>
                    <a:close/>
                  </a:path>
                </a:pathLst>
              </a:custGeom>
              <a:solidFill>
                <a:srgbClr val="000000"/>
              </a:solidFill>
              <a:ln w="793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529" name="Rectangle 505"/>
              <p:cNvSpPr>
                <a:spLocks noChangeArrowheads="1"/>
              </p:cNvSpPr>
              <p:nvPr/>
            </p:nvSpPr>
            <p:spPr bwMode="auto">
              <a:xfrm>
                <a:off x="2892379" y="451606"/>
                <a:ext cx="42933" cy="796523"/>
              </a:xfrm>
              <a:prstGeom prst="rect">
                <a:avLst/>
              </a:prstGeom>
              <a:solidFill>
                <a:srgbClr val="FFFF99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530" name="Freeform 506"/>
              <p:cNvSpPr>
                <a:spLocks noEditPoints="1"/>
              </p:cNvSpPr>
              <p:nvPr/>
            </p:nvSpPr>
            <p:spPr bwMode="auto">
              <a:xfrm>
                <a:off x="2890285" y="449749"/>
                <a:ext cx="48168" cy="800237"/>
              </a:xfrm>
              <a:custGeom>
                <a:avLst/>
                <a:gdLst/>
                <a:ahLst/>
                <a:cxnLst>
                  <a:cxn ang="0">
                    <a:pos x="0" y="8"/>
                  </a:cxn>
                  <a:cxn ang="0">
                    <a:pos x="8" y="0"/>
                  </a:cxn>
                  <a:cxn ang="0">
                    <a:pos x="168" y="0"/>
                  </a:cxn>
                  <a:cxn ang="0">
                    <a:pos x="176" y="8"/>
                  </a:cxn>
                  <a:cxn ang="0">
                    <a:pos x="176" y="3368"/>
                  </a:cxn>
                  <a:cxn ang="0">
                    <a:pos x="168" y="3376"/>
                  </a:cxn>
                  <a:cxn ang="0">
                    <a:pos x="8" y="3376"/>
                  </a:cxn>
                  <a:cxn ang="0">
                    <a:pos x="0" y="3368"/>
                  </a:cxn>
                  <a:cxn ang="0">
                    <a:pos x="0" y="8"/>
                  </a:cxn>
                  <a:cxn ang="0">
                    <a:pos x="16" y="3368"/>
                  </a:cxn>
                  <a:cxn ang="0">
                    <a:pos x="8" y="3360"/>
                  </a:cxn>
                  <a:cxn ang="0">
                    <a:pos x="168" y="3360"/>
                  </a:cxn>
                  <a:cxn ang="0">
                    <a:pos x="160" y="3368"/>
                  </a:cxn>
                  <a:cxn ang="0">
                    <a:pos x="160" y="8"/>
                  </a:cxn>
                  <a:cxn ang="0">
                    <a:pos x="168" y="16"/>
                  </a:cxn>
                  <a:cxn ang="0">
                    <a:pos x="8" y="16"/>
                  </a:cxn>
                  <a:cxn ang="0">
                    <a:pos x="16" y="8"/>
                  </a:cxn>
                  <a:cxn ang="0">
                    <a:pos x="16" y="3368"/>
                  </a:cxn>
                </a:cxnLst>
                <a:rect l="0" t="0" r="r" b="b"/>
                <a:pathLst>
                  <a:path w="176" h="3376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168" y="0"/>
                    </a:lnTo>
                    <a:cubicBezTo>
                      <a:pt x="173" y="0"/>
                      <a:pt x="176" y="4"/>
                      <a:pt x="176" y="8"/>
                    </a:cubicBezTo>
                    <a:lnTo>
                      <a:pt x="176" y="3368"/>
                    </a:lnTo>
                    <a:cubicBezTo>
                      <a:pt x="176" y="3373"/>
                      <a:pt x="173" y="3376"/>
                      <a:pt x="168" y="3376"/>
                    </a:cubicBezTo>
                    <a:lnTo>
                      <a:pt x="8" y="3376"/>
                    </a:lnTo>
                    <a:cubicBezTo>
                      <a:pt x="4" y="3376"/>
                      <a:pt x="0" y="3373"/>
                      <a:pt x="0" y="3368"/>
                    </a:cubicBezTo>
                    <a:lnTo>
                      <a:pt x="0" y="8"/>
                    </a:lnTo>
                    <a:close/>
                    <a:moveTo>
                      <a:pt x="16" y="3368"/>
                    </a:moveTo>
                    <a:lnTo>
                      <a:pt x="8" y="3360"/>
                    </a:lnTo>
                    <a:lnTo>
                      <a:pt x="168" y="3360"/>
                    </a:lnTo>
                    <a:lnTo>
                      <a:pt x="160" y="3368"/>
                    </a:lnTo>
                    <a:lnTo>
                      <a:pt x="160" y="8"/>
                    </a:lnTo>
                    <a:lnTo>
                      <a:pt x="168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3368"/>
                    </a:lnTo>
                    <a:close/>
                  </a:path>
                </a:pathLst>
              </a:custGeom>
              <a:solidFill>
                <a:srgbClr val="000000"/>
              </a:solidFill>
              <a:ln w="793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531" name="Rectangle 507"/>
              <p:cNvSpPr>
                <a:spLocks noChangeArrowheads="1"/>
              </p:cNvSpPr>
              <p:nvPr/>
            </p:nvSpPr>
            <p:spPr bwMode="auto">
              <a:xfrm>
                <a:off x="3023272" y="550011"/>
                <a:ext cx="38744" cy="698118"/>
              </a:xfrm>
              <a:prstGeom prst="rect">
                <a:avLst/>
              </a:prstGeom>
              <a:solidFill>
                <a:srgbClr val="FFFF99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532" name="Freeform 508"/>
              <p:cNvSpPr>
                <a:spLocks noEditPoints="1"/>
              </p:cNvSpPr>
              <p:nvPr/>
            </p:nvSpPr>
            <p:spPr bwMode="auto">
              <a:xfrm>
                <a:off x="3020130" y="548154"/>
                <a:ext cx="43980" cy="701832"/>
              </a:xfrm>
              <a:custGeom>
                <a:avLst/>
                <a:gdLst/>
                <a:ahLst/>
                <a:cxnLst>
                  <a:cxn ang="0">
                    <a:pos x="0" y="8"/>
                  </a:cxn>
                  <a:cxn ang="0">
                    <a:pos x="8" y="0"/>
                  </a:cxn>
                  <a:cxn ang="0">
                    <a:pos x="152" y="0"/>
                  </a:cxn>
                  <a:cxn ang="0">
                    <a:pos x="160" y="8"/>
                  </a:cxn>
                  <a:cxn ang="0">
                    <a:pos x="160" y="2952"/>
                  </a:cxn>
                  <a:cxn ang="0">
                    <a:pos x="152" y="2960"/>
                  </a:cxn>
                  <a:cxn ang="0">
                    <a:pos x="8" y="2960"/>
                  </a:cxn>
                  <a:cxn ang="0">
                    <a:pos x="0" y="2952"/>
                  </a:cxn>
                  <a:cxn ang="0">
                    <a:pos x="0" y="8"/>
                  </a:cxn>
                  <a:cxn ang="0">
                    <a:pos x="16" y="2952"/>
                  </a:cxn>
                  <a:cxn ang="0">
                    <a:pos x="8" y="2944"/>
                  </a:cxn>
                  <a:cxn ang="0">
                    <a:pos x="152" y="2944"/>
                  </a:cxn>
                  <a:cxn ang="0">
                    <a:pos x="144" y="2952"/>
                  </a:cxn>
                  <a:cxn ang="0">
                    <a:pos x="144" y="8"/>
                  </a:cxn>
                  <a:cxn ang="0">
                    <a:pos x="152" y="16"/>
                  </a:cxn>
                  <a:cxn ang="0">
                    <a:pos x="8" y="16"/>
                  </a:cxn>
                  <a:cxn ang="0">
                    <a:pos x="16" y="8"/>
                  </a:cxn>
                  <a:cxn ang="0">
                    <a:pos x="16" y="2952"/>
                  </a:cxn>
                </a:cxnLst>
                <a:rect l="0" t="0" r="r" b="b"/>
                <a:pathLst>
                  <a:path w="160" h="2960">
                    <a:moveTo>
                      <a:pt x="0" y="8"/>
                    </a:moveTo>
                    <a:cubicBezTo>
                      <a:pt x="0" y="4"/>
                      <a:pt x="4" y="0"/>
                      <a:pt x="8" y="0"/>
                    </a:cubicBezTo>
                    <a:lnTo>
                      <a:pt x="152" y="0"/>
                    </a:lnTo>
                    <a:cubicBezTo>
                      <a:pt x="157" y="0"/>
                      <a:pt x="160" y="4"/>
                      <a:pt x="160" y="8"/>
                    </a:cubicBezTo>
                    <a:lnTo>
                      <a:pt x="160" y="2952"/>
                    </a:lnTo>
                    <a:cubicBezTo>
                      <a:pt x="160" y="2957"/>
                      <a:pt x="157" y="2960"/>
                      <a:pt x="152" y="2960"/>
                    </a:cubicBezTo>
                    <a:lnTo>
                      <a:pt x="8" y="2960"/>
                    </a:lnTo>
                    <a:cubicBezTo>
                      <a:pt x="4" y="2960"/>
                      <a:pt x="0" y="2957"/>
                      <a:pt x="0" y="2952"/>
                    </a:cubicBezTo>
                    <a:lnTo>
                      <a:pt x="0" y="8"/>
                    </a:lnTo>
                    <a:close/>
                    <a:moveTo>
                      <a:pt x="16" y="2952"/>
                    </a:moveTo>
                    <a:lnTo>
                      <a:pt x="8" y="2944"/>
                    </a:lnTo>
                    <a:lnTo>
                      <a:pt x="152" y="2944"/>
                    </a:lnTo>
                    <a:lnTo>
                      <a:pt x="144" y="2952"/>
                    </a:lnTo>
                    <a:lnTo>
                      <a:pt x="144" y="8"/>
                    </a:lnTo>
                    <a:lnTo>
                      <a:pt x="152" y="16"/>
                    </a:lnTo>
                    <a:lnTo>
                      <a:pt x="8" y="16"/>
                    </a:lnTo>
                    <a:lnTo>
                      <a:pt x="16" y="8"/>
                    </a:lnTo>
                    <a:lnTo>
                      <a:pt x="16" y="2952"/>
                    </a:lnTo>
                    <a:close/>
                  </a:path>
                </a:pathLst>
              </a:custGeom>
              <a:solidFill>
                <a:srgbClr val="000000"/>
              </a:solidFill>
              <a:ln w="793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533" name="Rectangle 509"/>
              <p:cNvSpPr>
                <a:spLocks noChangeArrowheads="1"/>
              </p:cNvSpPr>
              <p:nvPr/>
            </p:nvSpPr>
            <p:spPr bwMode="auto">
              <a:xfrm>
                <a:off x="540503" y="224161"/>
                <a:ext cx="4189" cy="1023969"/>
              </a:xfrm>
              <a:prstGeom prst="rect">
                <a:avLst/>
              </a:prstGeom>
              <a:solidFill>
                <a:srgbClr val="000000"/>
              </a:solidFill>
              <a:ln w="793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534" name="Freeform 510"/>
              <p:cNvSpPr>
                <a:spLocks noEditPoints="1"/>
              </p:cNvSpPr>
              <p:nvPr/>
            </p:nvSpPr>
            <p:spPr bwMode="auto">
              <a:xfrm>
                <a:off x="525843" y="222304"/>
                <a:ext cx="16754" cy="1027682"/>
              </a:xfrm>
              <a:custGeom>
                <a:avLst/>
                <a:gdLst/>
                <a:ahLst/>
                <a:cxnLst>
                  <a:cxn ang="0">
                    <a:pos x="0" y="1103"/>
                  </a:cxn>
                  <a:cxn ang="0">
                    <a:pos x="16" y="1103"/>
                  </a:cxn>
                  <a:cxn ang="0">
                    <a:pos x="16" y="1107"/>
                  </a:cxn>
                  <a:cxn ang="0">
                    <a:pos x="0" y="1107"/>
                  </a:cxn>
                  <a:cxn ang="0">
                    <a:pos x="0" y="1103"/>
                  </a:cxn>
                  <a:cxn ang="0">
                    <a:pos x="0" y="947"/>
                  </a:cxn>
                  <a:cxn ang="0">
                    <a:pos x="16" y="947"/>
                  </a:cxn>
                  <a:cxn ang="0">
                    <a:pos x="16" y="951"/>
                  </a:cxn>
                  <a:cxn ang="0">
                    <a:pos x="0" y="951"/>
                  </a:cxn>
                  <a:cxn ang="0">
                    <a:pos x="0" y="947"/>
                  </a:cxn>
                  <a:cxn ang="0">
                    <a:pos x="0" y="788"/>
                  </a:cxn>
                  <a:cxn ang="0">
                    <a:pos x="16" y="788"/>
                  </a:cxn>
                  <a:cxn ang="0">
                    <a:pos x="16" y="792"/>
                  </a:cxn>
                  <a:cxn ang="0">
                    <a:pos x="0" y="792"/>
                  </a:cxn>
                  <a:cxn ang="0">
                    <a:pos x="0" y="788"/>
                  </a:cxn>
                  <a:cxn ang="0">
                    <a:pos x="0" y="633"/>
                  </a:cxn>
                  <a:cxn ang="0">
                    <a:pos x="16" y="633"/>
                  </a:cxn>
                  <a:cxn ang="0">
                    <a:pos x="16" y="637"/>
                  </a:cxn>
                  <a:cxn ang="0">
                    <a:pos x="0" y="637"/>
                  </a:cxn>
                  <a:cxn ang="0">
                    <a:pos x="0" y="633"/>
                  </a:cxn>
                  <a:cxn ang="0">
                    <a:pos x="0" y="474"/>
                  </a:cxn>
                  <a:cxn ang="0">
                    <a:pos x="16" y="474"/>
                  </a:cxn>
                  <a:cxn ang="0">
                    <a:pos x="16" y="478"/>
                  </a:cxn>
                  <a:cxn ang="0">
                    <a:pos x="0" y="478"/>
                  </a:cxn>
                  <a:cxn ang="0">
                    <a:pos x="0" y="474"/>
                  </a:cxn>
                  <a:cxn ang="0">
                    <a:pos x="0" y="314"/>
                  </a:cxn>
                  <a:cxn ang="0">
                    <a:pos x="16" y="314"/>
                  </a:cxn>
                  <a:cxn ang="0">
                    <a:pos x="16" y="318"/>
                  </a:cxn>
                  <a:cxn ang="0">
                    <a:pos x="0" y="318"/>
                  </a:cxn>
                  <a:cxn ang="0">
                    <a:pos x="0" y="314"/>
                  </a:cxn>
                  <a:cxn ang="0">
                    <a:pos x="0" y="159"/>
                  </a:cxn>
                  <a:cxn ang="0">
                    <a:pos x="16" y="159"/>
                  </a:cxn>
                  <a:cxn ang="0">
                    <a:pos x="16" y="163"/>
                  </a:cxn>
                  <a:cxn ang="0">
                    <a:pos x="0" y="163"/>
                  </a:cxn>
                  <a:cxn ang="0">
                    <a:pos x="0" y="159"/>
                  </a:cxn>
                  <a:cxn ang="0">
                    <a:pos x="0" y="0"/>
                  </a:cxn>
                  <a:cxn ang="0">
                    <a:pos x="16" y="0"/>
                  </a:cxn>
                  <a:cxn ang="0">
                    <a:pos x="16" y="4"/>
                  </a:cxn>
                  <a:cxn ang="0">
                    <a:pos x="0" y="4"/>
                  </a:cxn>
                  <a:cxn ang="0">
                    <a:pos x="0" y="0"/>
                  </a:cxn>
                </a:cxnLst>
                <a:rect l="0" t="0" r="r" b="b"/>
                <a:pathLst>
                  <a:path w="16" h="1107">
                    <a:moveTo>
                      <a:pt x="0" y="1103"/>
                    </a:moveTo>
                    <a:lnTo>
                      <a:pt x="16" y="1103"/>
                    </a:lnTo>
                    <a:lnTo>
                      <a:pt x="16" y="1107"/>
                    </a:lnTo>
                    <a:lnTo>
                      <a:pt x="0" y="1107"/>
                    </a:lnTo>
                    <a:lnTo>
                      <a:pt x="0" y="1103"/>
                    </a:lnTo>
                    <a:close/>
                    <a:moveTo>
                      <a:pt x="0" y="947"/>
                    </a:moveTo>
                    <a:lnTo>
                      <a:pt x="16" y="947"/>
                    </a:lnTo>
                    <a:lnTo>
                      <a:pt x="16" y="951"/>
                    </a:lnTo>
                    <a:lnTo>
                      <a:pt x="0" y="951"/>
                    </a:lnTo>
                    <a:lnTo>
                      <a:pt x="0" y="947"/>
                    </a:lnTo>
                    <a:close/>
                    <a:moveTo>
                      <a:pt x="0" y="788"/>
                    </a:moveTo>
                    <a:lnTo>
                      <a:pt x="16" y="788"/>
                    </a:lnTo>
                    <a:lnTo>
                      <a:pt x="16" y="792"/>
                    </a:lnTo>
                    <a:lnTo>
                      <a:pt x="0" y="792"/>
                    </a:lnTo>
                    <a:lnTo>
                      <a:pt x="0" y="788"/>
                    </a:lnTo>
                    <a:close/>
                    <a:moveTo>
                      <a:pt x="0" y="633"/>
                    </a:moveTo>
                    <a:lnTo>
                      <a:pt x="16" y="633"/>
                    </a:lnTo>
                    <a:lnTo>
                      <a:pt x="16" y="637"/>
                    </a:lnTo>
                    <a:lnTo>
                      <a:pt x="0" y="637"/>
                    </a:lnTo>
                    <a:lnTo>
                      <a:pt x="0" y="633"/>
                    </a:lnTo>
                    <a:close/>
                    <a:moveTo>
                      <a:pt x="0" y="474"/>
                    </a:moveTo>
                    <a:lnTo>
                      <a:pt x="16" y="474"/>
                    </a:lnTo>
                    <a:lnTo>
                      <a:pt x="16" y="478"/>
                    </a:lnTo>
                    <a:lnTo>
                      <a:pt x="0" y="478"/>
                    </a:lnTo>
                    <a:lnTo>
                      <a:pt x="0" y="474"/>
                    </a:lnTo>
                    <a:close/>
                    <a:moveTo>
                      <a:pt x="0" y="314"/>
                    </a:moveTo>
                    <a:lnTo>
                      <a:pt x="16" y="314"/>
                    </a:lnTo>
                    <a:lnTo>
                      <a:pt x="16" y="318"/>
                    </a:lnTo>
                    <a:lnTo>
                      <a:pt x="0" y="318"/>
                    </a:lnTo>
                    <a:lnTo>
                      <a:pt x="0" y="314"/>
                    </a:lnTo>
                    <a:close/>
                    <a:moveTo>
                      <a:pt x="0" y="159"/>
                    </a:moveTo>
                    <a:lnTo>
                      <a:pt x="16" y="159"/>
                    </a:lnTo>
                    <a:lnTo>
                      <a:pt x="16" y="163"/>
                    </a:lnTo>
                    <a:lnTo>
                      <a:pt x="0" y="163"/>
                    </a:lnTo>
                    <a:lnTo>
                      <a:pt x="0" y="159"/>
                    </a:lnTo>
                    <a:close/>
                    <a:moveTo>
                      <a:pt x="0" y="0"/>
                    </a:moveTo>
                    <a:lnTo>
                      <a:pt x="16" y="0"/>
                    </a:lnTo>
                    <a:lnTo>
                      <a:pt x="16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793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535" name="Rectangle 511"/>
              <p:cNvSpPr>
                <a:spLocks noChangeArrowheads="1"/>
              </p:cNvSpPr>
              <p:nvPr/>
            </p:nvSpPr>
            <p:spPr bwMode="auto">
              <a:xfrm>
                <a:off x="542598" y="1246273"/>
                <a:ext cx="2541408" cy="3713"/>
              </a:xfrm>
              <a:prstGeom prst="rect">
                <a:avLst/>
              </a:prstGeom>
              <a:solidFill>
                <a:srgbClr val="000000"/>
              </a:solidFill>
              <a:ln w="793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536" name="Freeform 512"/>
              <p:cNvSpPr>
                <a:spLocks noEditPoints="1"/>
              </p:cNvSpPr>
              <p:nvPr/>
            </p:nvSpPr>
            <p:spPr bwMode="auto">
              <a:xfrm>
                <a:off x="540503" y="1248129"/>
                <a:ext cx="2545597" cy="14854"/>
              </a:xfrm>
              <a:custGeom>
                <a:avLst/>
                <a:gdLst/>
                <a:ahLst/>
                <a:cxnLst>
                  <a:cxn ang="0">
                    <a:pos x="4" y="16"/>
                  </a:cxn>
                  <a:cxn ang="0">
                    <a:pos x="0" y="0"/>
                  </a:cxn>
                  <a:cxn ang="0">
                    <a:pos x="125" y="0"/>
                  </a:cxn>
                  <a:cxn ang="0">
                    <a:pos x="121" y="16"/>
                  </a:cxn>
                  <a:cxn ang="0">
                    <a:pos x="125" y="0"/>
                  </a:cxn>
                  <a:cxn ang="0">
                    <a:pos x="245" y="16"/>
                  </a:cxn>
                  <a:cxn ang="0">
                    <a:pos x="241" y="0"/>
                  </a:cxn>
                  <a:cxn ang="0">
                    <a:pos x="366" y="0"/>
                  </a:cxn>
                  <a:cxn ang="0">
                    <a:pos x="362" y="16"/>
                  </a:cxn>
                  <a:cxn ang="0">
                    <a:pos x="366" y="0"/>
                  </a:cxn>
                  <a:cxn ang="0">
                    <a:pos x="490" y="16"/>
                  </a:cxn>
                  <a:cxn ang="0">
                    <a:pos x="486" y="0"/>
                  </a:cxn>
                  <a:cxn ang="0">
                    <a:pos x="611" y="0"/>
                  </a:cxn>
                  <a:cxn ang="0">
                    <a:pos x="607" y="16"/>
                  </a:cxn>
                  <a:cxn ang="0">
                    <a:pos x="611" y="0"/>
                  </a:cxn>
                  <a:cxn ang="0">
                    <a:pos x="731" y="16"/>
                  </a:cxn>
                  <a:cxn ang="0">
                    <a:pos x="727" y="0"/>
                  </a:cxn>
                  <a:cxn ang="0">
                    <a:pos x="852" y="0"/>
                  </a:cxn>
                  <a:cxn ang="0">
                    <a:pos x="848" y="16"/>
                  </a:cxn>
                  <a:cxn ang="0">
                    <a:pos x="852" y="0"/>
                  </a:cxn>
                  <a:cxn ang="0">
                    <a:pos x="972" y="16"/>
                  </a:cxn>
                  <a:cxn ang="0">
                    <a:pos x="968" y="0"/>
                  </a:cxn>
                  <a:cxn ang="0">
                    <a:pos x="1097" y="0"/>
                  </a:cxn>
                  <a:cxn ang="0">
                    <a:pos x="1093" y="16"/>
                  </a:cxn>
                  <a:cxn ang="0">
                    <a:pos x="1097" y="0"/>
                  </a:cxn>
                  <a:cxn ang="0">
                    <a:pos x="1218" y="16"/>
                  </a:cxn>
                  <a:cxn ang="0">
                    <a:pos x="1213" y="0"/>
                  </a:cxn>
                  <a:cxn ang="0">
                    <a:pos x="1338" y="0"/>
                  </a:cxn>
                  <a:cxn ang="0">
                    <a:pos x="1334" y="16"/>
                  </a:cxn>
                  <a:cxn ang="0">
                    <a:pos x="1338" y="0"/>
                  </a:cxn>
                  <a:cxn ang="0">
                    <a:pos x="1459" y="16"/>
                  </a:cxn>
                  <a:cxn ang="0">
                    <a:pos x="1454" y="0"/>
                  </a:cxn>
                  <a:cxn ang="0">
                    <a:pos x="1583" y="0"/>
                  </a:cxn>
                  <a:cxn ang="0">
                    <a:pos x="1579" y="16"/>
                  </a:cxn>
                  <a:cxn ang="0">
                    <a:pos x="1583" y="0"/>
                  </a:cxn>
                  <a:cxn ang="0">
                    <a:pos x="1704" y="16"/>
                  </a:cxn>
                  <a:cxn ang="0">
                    <a:pos x="1700" y="0"/>
                  </a:cxn>
                  <a:cxn ang="0">
                    <a:pos x="1824" y="0"/>
                  </a:cxn>
                  <a:cxn ang="0">
                    <a:pos x="1820" y="16"/>
                  </a:cxn>
                  <a:cxn ang="0">
                    <a:pos x="1824" y="0"/>
                  </a:cxn>
                  <a:cxn ang="0">
                    <a:pos x="1945" y="16"/>
                  </a:cxn>
                  <a:cxn ang="0">
                    <a:pos x="1941" y="0"/>
                  </a:cxn>
                  <a:cxn ang="0">
                    <a:pos x="2069" y="0"/>
                  </a:cxn>
                  <a:cxn ang="0">
                    <a:pos x="2065" y="16"/>
                  </a:cxn>
                  <a:cxn ang="0">
                    <a:pos x="2069" y="0"/>
                  </a:cxn>
                  <a:cxn ang="0">
                    <a:pos x="2190" y="16"/>
                  </a:cxn>
                  <a:cxn ang="0">
                    <a:pos x="2186" y="0"/>
                  </a:cxn>
                  <a:cxn ang="0">
                    <a:pos x="2310" y="0"/>
                  </a:cxn>
                  <a:cxn ang="0">
                    <a:pos x="2306" y="16"/>
                  </a:cxn>
                  <a:cxn ang="0">
                    <a:pos x="2310" y="0"/>
                  </a:cxn>
                  <a:cxn ang="0">
                    <a:pos x="2431" y="16"/>
                  </a:cxn>
                  <a:cxn ang="0">
                    <a:pos x="2427" y="0"/>
                  </a:cxn>
                </a:cxnLst>
                <a:rect l="0" t="0" r="r" b="b"/>
                <a:pathLst>
                  <a:path w="2431" h="16">
                    <a:moveTo>
                      <a:pt x="4" y="0"/>
                    </a:moveTo>
                    <a:lnTo>
                      <a:pt x="4" y="16"/>
                    </a:lnTo>
                    <a:lnTo>
                      <a:pt x="0" y="16"/>
                    </a:lnTo>
                    <a:lnTo>
                      <a:pt x="0" y="0"/>
                    </a:lnTo>
                    <a:lnTo>
                      <a:pt x="4" y="0"/>
                    </a:lnTo>
                    <a:close/>
                    <a:moveTo>
                      <a:pt x="125" y="0"/>
                    </a:moveTo>
                    <a:lnTo>
                      <a:pt x="125" y="16"/>
                    </a:lnTo>
                    <a:lnTo>
                      <a:pt x="121" y="16"/>
                    </a:lnTo>
                    <a:lnTo>
                      <a:pt x="121" y="0"/>
                    </a:lnTo>
                    <a:lnTo>
                      <a:pt x="125" y="0"/>
                    </a:lnTo>
                    <a:close/>
                    <a:moveTo>
                      <a:pt x="245" y="0"/>
                    </a:moveTo>
                    <a:lnTo>
                      <a:pt x="245" y="16"/>
                    </a:lnTo>
                    <a:lnTo>
                      <a:pt x="241" y="16"/>
                    </a:lnTo>
                    <a:lnTo>
                      <a:pt x="241" y="0"/>
                    </a:lnTo>
                    <a:lnTo>
                      <a:pt x="245" y="0"/>
                    </a:lnTo>
                    <a:close/>
                    <a:moveTo>
                      <a:pt x="366" y="0"/>
                    </a:moveTo>
                    <a:lnTo>
                      <a:pt x="366" y="16"/>
                    </a:lnTo>
                    <a:lnTo>
                      <a:pt x="362" y="16"/>
                    </a:lnTo>
                    <a:lnTo>
                      <a:pt x="362" y="0"/>
                    </a:lnTo>
                    <a:lnTo>
                      <a:pt x="366" y="0"/>
                    </a:lnTo>
                    <a:close/>
                    <a:moveTo>
                      <a:pt x="490" y="0"/>
                    </a:moveTo>
                    <a:lnTo>
                      <a:pt x="490" y="16"/>
                    </a:lnTo>
                    <a:lnTo>
                      <a:pt x="486" y="16"/>
                    </a:lnTo>
                    <a:lnTo>
                      <a:pt x="486" y="0"/>
                    </a:lnTo>
                    <a:lnTo>
                      <a:pt x="490" y="0"/>
                    </a:lnTo>
                    <a:close/>
                    <a:moveTo>
                      <a:pt x="611" y="0"/>
                    </a:moveTo>
                    <a:lnTo>
                      <a:pt x="611" y="16"/>
                    </a:lnTo>
                    <a:lnTo>
                      <a:pt x="607" y="16"/>
                    </a:lnTo>
                    <a:lnTo>
                      <a:pt x="607" y="0"/>
                    </a:lnTo>
                    <a:lnTo>
                      <a:pt x="611" y="0"/>
                    </a:lnTo>
                    <a:close/>
                    <a:moveTo>
                      <a:pt x="731" y="0"/>
                    </a:moveTo>
                    <a:lnTo>
                      <a:pt x="731" y="16"/>
                    </a:lnTo>
                    <a:lnTo>
                      <a:pt x="727" y="16"/>
                    </a:lnTo>
                    <a:lnTo>
                      <a:pt x="727" y="0"/>
                    </a:lnTo>
                    <a:lnTo>
                      <a:pt x="731" y="0"/>
                    </a:lnTo>
                    <a:close/>
                    <a:moveTo>
                      <a:pt x="852" y="0"/>
                    </a:moveTo>
                    <a:lnTo>
                      <a:pt x="852" y="16"/>
                    </a:lnTo>
                    <a:lnTo>
                      <a:pt x="848" y="16"/>
                    </a:lnTo>
                    <a:lnTo>
                      <a:pt x="848" y="0"/>
                    </a:lnTo>
                    <a:lnTo>
                      <a:pt x="852" y="0"/>
                    </a:lnTo>
                    <a:close/>
                    <a:moveTo>
                      <a:pt x="972" y="0"/>
                    </a:moveTo>
                    <a:lnTo>
                      <a:pt x="972" y="16"/>
                    </a:lnTo>
                    <a:lnTo>
                      <a:pt x="968" y="16"/>
                    </a:lnTo>
                    <a:lnTo>
                      <a:pt x="968" y="0"/>
                    </a:lnTo>
                    <a:lnTo>
                      <a:pt x="972" y="0"/>
                    </a:lnTo>
                    <a:close/>
                    <a:moveTo>
                      <a:pt x="1097" y="0"/>
                    </a:moveTo>
                    <a:lnTo>
                      <a:pt x="1097" y="16"/>
                    </a:lnTo>
                    <a:lnTo>
                      <a:pt x="1093" y="16"/>
                    </a:lnTo>
                    <a:lnTo>
                      <a:pt x="1093" y="0"/>
                    </a:lnTo>
                    <a:lnTo>
                      <a:pt x="1097" y="0"/>
                    </a:lnTo>
                    <a:close/>
                    <a:moveTo>
                      <a:pt x="1218" y="0"/>
                    </a:moveTo>
                    <a:lnTo>
                      <a:pt x="1218" y="16"/>
                    </a:lnTo>
                    <a:lnTo>
                      <a:pt x="1213" y="16"/>
                    </a:lnTo>
                    <a:lnTo>
                      <a:pt x="1213" y="0"/>
                    </a:lnTo>
                    <a:lnTo>
                      <a:pt x="1218" y="0"/>
                    </a:lnTo>
                    <a:close/>
                    <a:moveTo>
                      <a:pt x="1338" y="0"/>
                    </a:moveTo>
                    <a:lnTo>
                      <a:pt x="1338" y="16"/>
                    </a:lnTo>
                    <a:lnTo>
                      <a:pt x="1334" y="16"/>
                    </a:lnTo>
                    <a:lnTo>
                      <a:pt x="1334" y="0"/>
                    </a:lnTo>
                    <a:lnTo>
                      <a:pt x="1338" y="0"/>
                    </a:lnTo>
                    <a:close/>
                    <a:moveTo>
                      <a:pt x="1459" y="0"/>
                    </a:moveTo>
                    <a:lnTo>
                      <a:pt x="1459" y="16"/>
                    </a:lnTo>
                    <a:lnTo>
                      <a:pt x="1454" y="16"/>
                    </a:lnTo>
                    <a:lnTo>
                      <a:pt x="1454" y="0"/>
                    </a:lnTo>
                    <a:lnTo>
                      <a:pt x="1459" y="0"/>
                    </a:lnTo>
                    <a:close/>
                    <a:moveTo>
                      <a:pt x="1583" y="0"/>
                    </a:moveTo>
                    <a:lnTo>
                      <a:pt x="1583" y="16"/>
                    </a:lnTo>
                    <a:lnTo>
                      <a:pt x="1579" y="16"/>
                    </a:lnTo>
                    <a:lnTo>
                      <a:pt x="1579" y="0"/>
                    </a:lnTo>
                    <a:lnTo>
                      <a:pt x="1583" y="0"/>
                    </a:lnTo>
                    <a:close/>
                    <a:moveTo>
                      <a:pt x="1704" y="0"/>
                    </a:moveTo>
                    <a:lnTo>
                      <a:pt x="1704" y="16"/>
                    </a:lnTo>
                    <a:lnTo>
                      <a:pt x="1700" y="16"/>
                    </a:lnTo>
                    <a:lnTo>
                      <a:pt x="1700" y="0"/>
                    </a:lnTo>
                    <a:lnTo>
                      <a:pt x="1704" y="0"/>
                    </a:lnTo>
                    <a:close/>
                    <a:moveTo>
                      <a:pt x="1824" y="0"/>
                    </a:moveTo>
                    <a:lnTo>
                      <a:pt x="1824" y="16"/>
                    </a:lnTo>
                    <a:lnTo>
                      <a:pt x="1820" y="16"/>
                    </a:lnTo>
                    <a:lnTo>
                      <a:pt x="1820" y="0"/>
                    </a:lnTo>
                    <a:lnTo>
                      <a:pt x="1824" y="0"/>
                    </a:lnTo>
                    <a:close/>
                    <a:moveTo>
                      <a:pt x="1945" y="0"/>
                    </a:moveTo>
                    <a:lnTo>
                      <a:pt x="1945" y="16"/>
                    </a:lnTo>
                    <a:lnTo>
                      <a:pt x="1941" y="16"/>
                    </a:lnTo>
                    <a:lnTo>
                      <a:pt x="1941" y="0"/>
                    </a:lnTo>
                    <a:lnTo>
                      <a:pt x="1945" y="0"/>
                    </a:lnTo>
                    <a:close/>
                    <a:moveTo>
                      <a:pt x="2069" y="0"/>
                    </a:moveTo>
                    <a:lnTo>
                      <a:pt x="2069" y="16"/>
                    </a:lnTo>
                    <a:lnTo>
                      <a:pt x="2065" y="16"/>
                    </a:lnTo>
                    <a:lnTo>
                      <a:pt x="2065" y="0"/>
                    </a:lnTo>
                    <a:lnTo>
                      <a:pt x="2069" y="0"/>
                    </a:lnTo>
                    <a:close/>
                    <a:moveTo>
                      <a:pt x="2190" y="0"/>
                    </a:moveTo>
                    <a:lnTo>
                      <a:pt x="2190" y="16"/>
                    </a:lnTo>
                    <a:lnTo>
                      <a:pt x="2186" y="16"/>
                    </a:lnTo>
                    <a:lnTo>
                      <a:pt x="2186" y="0"/>
                    </a:lnTo>
                    <a:lnTo>
                      <a:pt x="2190" y="0"/>
                    </a:lnTo>
                    <a:close/>
                    <a:moveTo>
                      <a:pt x="2310" y="0"/>
                    </a:moveTo>
                    <a:lnTo>
                      <a:pt x="2310" y="16"/>
                    </a:lnTo>
                    <a:lnTo>
                      <a:pt x="2306" y="16"/>
                    </a:lnTo>
                    <a:lnTo>
                      <a:pt x="2306" y="0"/>
                    </a:lnTo>
                    <a:lnTo>
                      <a:pt x="2310" y="0"/>
                    </a:lnTo>
                    <a:close/>
                    <a:moveTo>
                      <a:pt x="2431" y="0"/>
                    </a:moveTo>
                    <a:lnTo>
                      <a:pt x="2431" y="16"/>
                    </a:lnTo>
                    <a:lnTo>
                      <a:pt x="2427" y="16"/>
                    </a:lnTo>
                    <a:lnTo>
                      <a:pt x="2427" y="0"/>
                    </a:lnTo>
                    <a:lnTo>
                      <a:pt x="2431" y="0"/>
                    </a:lnTo>
                    <a:close/>
                  </a:path>
                </a:pathLst>
              </a:custGeom>
              <a:solidFill>
                <a:srgbClr val="000000"/>
              </a:solidFill>
              <a:ln w="793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537" name="Rectangle 513"/>
              <p:cNvSpPr>
                <a:spLocks noChangeArrowheads="1"/>
              </p:cNvSpPr>
              <p:nvPr/>
            </p:nvSpPr>
            <p:spPr bwMode="auto">
              <a:xfrm>
                <a:off x="424916" y="1204942"/>
                <a:ext cx="60734" cy="7148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538" name="Rectangle 514"/>
              <p:cNvSpPr>
                <a:spLocks noChangeArrowheads="1"/>
              </p:cNvSpPr>
              <p:nvPr/>
            </p:nvSpPr>
            <p:spPr bwMode="auto">
              <a:xfrm>
                <a:off x="358946" y="1058263"/>
                <a:ext cx="126704" cy="724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2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539" name="Rectangle 515"/>
              <p:cNvSpPr>
                <a:spLocks noChangeArrowheads="1"/>
              </p:cNvSpPr>
              <p:nvPr/>
            </p:nvSpPr>
            <p:spPr bwMode="auto">
              <a:xfrm>
                <a:off x="358946" y="912513"/>
                <a:ext cx="126704" cy="7148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400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540" name="Rectangle 516"/>
              <p:cNvSpPr>
                <a:spLocks noChangeArrowheads="1"/>
              </p:cNvSpPr>
              <p:nvPr/>
            </p:nvSpPr>
            <p:spPr bwMode="auto">
              <a:xfrm>
                <a:off x="358946" y="765834"/>
                <a:ext cx="126704" cy="724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6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541" name="Rectangle 517"/>
              <p:cNvSpPr>
                <a:spLocks noChangeArrowheads="1"/>
              </p:cNvSpPr>
              <p:nvPr/>
            </p:nvSpPr>
            <p:spPr bwMode="auto">
              <a:xfrm>
                <a:off x="358946" y="620083"/>
                <a:ext cx="126704" cy="7148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8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542" name="Rectangle 518"/>
              <p:cNvSpPr>
                <a:spLocks noChangeArrowheads="1"/>
              </p:cNvSpPr>
              <p:nvPr/>
            </p:nvSpPr>
            <p:spPr bwMode="auto">
              <a:xfrm>
                <a:off x="325437" y="473404"/>
                <a:ext cx="160213" cy="724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10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543" name="Rectangle 519"/>
              <p:cNvSpPr>
                <a:spLocks noChangeArrowheads="1"/>
              </p:cNvSpPr>
              <p:nvPr/>
            </p:nvSpPr>
            <p:spPr bwMode="auto">
              <a:xfrm>
                <a:off x="325437" y="327653"/>
                <a:ext cx="160213" cy="724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12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544" name="Rectangle 520"/>
              <p:cNvSpPr>
                <a:spLocks noChangeArrowheads="1"/>
              </p:cNvSpPr>
              <p:nvPr/>
            </p:nvSpPr>
            <p:spPr bwMode="auto">
              <a:xfrm>
                <a:off x="325437" y="180974"/>
                <a:ext cx="160213" cy="7148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14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545" name="Rectangle 521"/>
              <p:cNvSpPr>
                <a:spLocks noChangeArrowheads="1"/>
              </p:cNvSpPr>
              <p:nvPr/>
            </p:nvSpPr>
            <p:spPr bwMode="auto">
              <a:xfrm>
                <a:off x="590766" y="1300117"/>
                <a:ext cx="60734" cy="7148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1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546" name="Rectangle 522"/>
              <p:cNvSpPr>
                <a:spLocks noChangeArrowheads="1"/>
              </p:cNvSpPr>
              <p:nvPr/>
            </p:nvSpPr>
            <p:spPr bwMode="auto">
              <a:xfrm>
                <a:off x="718517" y="1300117"/>
                <a:ext cx="60734" cy="7148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2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547" name="Rectangle 523"/>
              <p:cNvSpPr>
                <a:spLocks noChangeArrowheads="1"/>
              </p:cNvSpPr>
              <p:nvPr/>
            </p:nvSpPr>
            <p:spPr bwMode="auto">
              <a:xfrm>
                <a:off x="845221" y="1300117"/>
                <a:ext cx="60734" cy="7148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3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548" name="Rectangle 524"/>
              <p:cNvSpPr>
                <a:spLocks noChangeArrowheads="1"/>
              </p:cNvSpPr>
              <p:nvPr/>
            </p:nvSpPr>
            <p:spPr bwMode="auto">
              <a:xfrm>
                <a:off x="972972" y="1300117"/>
                <a:ext cx="60734" cy="7148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4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549" name="Rectangle 525"/>
              <p:cNvSpPr>
                <a:spLocks noChangeArrowheads="1"/>
              </p:cNvSpPr>
              <p:nvPr/>
            </p:nvSpPr>
            <p:spPr bwMode="auto">
              <a:xfrm>
                <a:off x="1099676" y="1300117"/>
                <a:ext cx="60734" cy="7148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5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550" name="Rectangle 526"/>
              <p:cNvSpPr>
                <a:spLocks noChangeArrowheads="1"/>
              </p:cNvSpPr>
              <p:nvPr/>
            </p:nvSpPr>
            <p:spPr bwMode="auto">
              <a:xfrm>
                <a:off x="1227427" y="1300117"/>
                <a:ext cx="60734" cy="7148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6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551" name="Rectangle 527"/>
              <p:cNvSpPr>
                <a:spLocks noChangeArrowheads="1"/>
              </p:cNvSpPr>
              <p:nvPr/>
            </p:nvSpPr>
            <p:spPr bwMode="auto">
              <a:xfrm>
                <a:off x="1354131" y="1300117"/>
                <a:ext cx="60734" cy="7148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7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552" name="Rectangle 528"/>
              <p:cNvSpPr>
                <a:spLocks noChangeArrowheads="1"/>
              </p:cNvSpPr>
              <p:nvPr/>
            </p:nvSpPr>
            <p:spPr bwMode="auto">
              <a:xfrm>
                <a:off x="1481882" y="1300117"/>
                <a:ext cx="60734" cy="7148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8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553" name="Rectangle 529"/>
              <p:cNvSpPr>
                <a:spLocks noChangeArrowheads="1"/>
              </p:cNvSpPr>
              <p:nvPr/>
            </p:nvSpPr>
            <p:spPr bwMode="auto">
              <a:xfrm>
                <a:off x="1608586" y="1300117"/>
                <a:ext cx="60734" cy="7148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9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554" name="Rectangle 530"/>
              <p:cNvSpPr>
                <a:spLocks noChangeArrowheads="1"/>
              </p:cNvSpPr>
              <p:nvPr/>
            </p:nvSpPr>
            <p:spPr bwMode="auto">
              <a:xfrm>
                <a:off x="1718536" y="1300117"/>
                <a:ext cx="91101" cy="7148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1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555" name="Rectangle 531"/>
              <p:cNvSpPr>
                <a:spLocks noChangeArrowheads="1"/>
              </p:cNvSpPr>
              <p:nvPr/>
            </p:nvSpPr>
            <p:spPr bwMode="auto">
              <a:xfrm>
                <a:off x="1846287" y="1300117"/>
                <a:ext cx="92148" cy="7148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11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556" name="Rectangle 532"/>
              <p:cNvSpPr>
                <a:spLocks noChangeArrowheads="1"/>
              </p:cNvSpPr>
              <p:nvPr/>
            </p:nvSpPr>
            <p:spPr bwMode="auto">
              <a:xfrm>
                <a:off x="1972990" y="1300117"/>
                <a:ext cx="91101" cy="7148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12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557" name="Rectangle 533"/>
              <p:cNvSpPr>
                <a:spLocks noChangeArrowheads="1"/>
              </p:cNvSpPr>
              <p:nvPr/>
            </p:nvSpPr>
            <p:spPr bwMode="auto">
              <a:xfrm>
                <a:off x="2100741" y="1300117"/>
                <a:ext cx="92148" cy="7148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13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558" name="Rectangle 534"/>
              <p:cNvSpPr>
                <a:spLocks noChangeArrowheads="1"/>
              </p:cNvSpPr>
              <p:nvPr/>
            </p:nvSpPr>
            <p:spPr bwMode="auto">
              <a:xfrm>
                <a:off x="2227446" y="1300117"/>
                <a:ext cx="91101" cy="7148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14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559" name="Rectangle 535"/>
              <p:cNvSpPr>
                <a:spLocks noChangeArrowheads="1"/>
              </p:cNvSpPr>
              <p:nvPr/>
            </p:nvSpPr>
            <p:spPr bwMode="auto">
              <a:xfrm>
                <a:off x="2354149" y="1300117"/>
                <a:ext cx="92148" cy="7148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15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560" name="Rectangle 536"/>
              <p:cNvSpPr>
                <a:spLocks noChangeArrowheads="1"/>
              </p:cNvSpPr>
              <p:nvPr/>
            </p:nvSpPr>
            <p:spPr bwMode="auto">
              <a:xfrm>
                <a:off x="2481900" y="1300117"/>
                <a:ext cx="91101" cy="7148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16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561" name="Rectangle 537"/>
              <p:cNvSpPr>
                <a:spLocks noChangeArrowheads="1"/>
              </p:cNvSpPr>
              <p:nvPr/>
            </p:nvSpPr>
            <p:spPr bwMode="auto">
              <a:xfrm>
                <a:off x="2608604" y="1300117"/>
                <a:ext cx="92148" cy="7148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17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562" name="Rectangle 538"/>
              <p:cNvSpPr>
                <a:spLocks noChangeArrowheads="1"/>
              </p:cNvSpPr>
              <p:nvPr/>
            </p:nvSpPr>
            <p:spPr bwMode="auto">
              <a:xfrm>
                <a:off x="2736355" y="1300117"/>
                <a:ext cx="91101" cy="7148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18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563" name="Rectangle 539"/>
              <p:cNvSpPr>
                <a:spLocks noChangeArrowheads="1"/>
              </p:cNvSpPr>
              <p:nvPr/>
            </p:nvSpPr>
            <p:spPr bwMode="auto">
              <a:xfrm>
                <a:off x="2863059" y="1300117"/>
                <a:ext cx="92148" cy="7148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19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564" name="Rectangle 540"/>
              <p:cNvSpPr>
                <a:spLocks noChangeArrowheads="1"/>
              </p:cNvSpPr>
              <p:nvPr/>
            </p:nvSpPr>
            <p:spPr bwMode="auto">
              <a:xfrm>
                <a:off x="2990810" y="1300117"/>
                <a:ext cx="91101" cy="7148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2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</p:grpSp>
        <p:grpSp>
          <p:nvGrpSpPr>
            <p:cNvPr id="764" name="Group 763"/>
            <p:cNvGrpSpPr/>
            <p:nvPr/>
          </p:nvGrpSpPr>
          <p:grpSpPr>
            <a:xfrm>
              <a:off x="4919652" y="166685"/>
              <a:ext cx="357135" cy="1225484"/>
              <a:chOff x="3757602" y="38098"/>
              <a:chExt cx="357135" cy="1225484"/>
            </a:xfrm>
          </p:grpSpPr>
          <p:sp>
            <p:nvSpPr>
              <p:cNvPr id="1589" name="Rectangle 565"/>
              <p:cNvSpPr>
                <a:spLocks noChangeArrowheads="1"/>
              </p:cNvSpPr>
              <p:nvPr/>
            </p:nvSpPr>
            <p:spPr bwMode="auto">
              <a:xfrm>
                <a:off x="3768474" y="38098"/>
                <a:ext cx="85416" cy="4010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5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1000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590" name="Rectangle 566"/>
              <p:cNvSpPr>
                <a:spLocks noChangeArrowheads="1"/>
              </p:cNvSpPr>
              <p:nvPr/>
            </p:nvSpPr>
            <p:spPr bwMode="auto">
              <a:xfrm>
                <a:off x="3786333" y="334442"/>
                <a:ext cx="67557" cy="4010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5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591" name="Rectangle 567"/>
              <p:cNvSpPr>
                <a:spLocks noChangeArrowheads="1"/>
              </p:cNvSpPr>
              <p:nvPr/>
            </p:nvSpPr>
            <p:spPr bwMode="auto">
              <a:xfrm>
                <a:off x="3822052" y="630787"/>
                <a:ext cx="31838" cy="4010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592" name="Rectangle 568"/>
              <p:cNvSpPr>
                <a:spLocks noChangeArrowheads="1"/>
              </p:cNvSpPr>
              <p:nvPr/>
            </p:nvSpPr>
            <p:spPr bwMode="auto">
              <a:xfrm>
                <a:off x="3775462" y="927131"/>
                <a:ext cx="78428" cy="4010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5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-500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593" name="Rectangle 569"/>
              <p:cNvSpPr>
                <a:spLocks noChangeArrowheads="1"/>
              </p:cNvSpPr>
              <p:nvPr/>
            </p:nvSpPr>
            <p:spPr bwMode="auto">
              <a:xfrm>
                <a:off x="3757602" y="1223475"/>
                <a:ext cx="96288" cy="4010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5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-1000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grpSp>
            <p:nvGrpSpPr>
              <p:cNvPr id="763" name="Group 762"/>
              <p:cNvGrpSpPr/>
              <p:nvPr/>
            </p:nvGrpSpPr>
            <p:grpSpPr>
              <a:xfrm>
                <a:off x="3912843" y="75331"/>
                <a:ext cx="201894" cy="1186120"/>
                <a:chOff x="3912843" y="75331"/>
                <a:chExt cx="201894" cy="1186120"/>
              </a:xfrm>
            </p:grpSpPr>
            <p:grpSp>
              <p:nvGrpSpPr>
                <p:cNvPr id="577" name="Group 576"/>
                <p:cNvGrpSpPr/>
                <p:nvPr/>
              </p:nvGrpSpPr>
              <p:grpSpPr>
                <a:xfrm>
                  <a:off x="3912843" y="75331"/>
                  <a:ext cx="20189" cy="1186120"/>
                  <a:chOff x="3984560" y="324752"/>
                  <a:chExt cx="32550" cy="1770057"/>
                </a:xfrm>
              </p:grpSpPr>
              <p:sp>
                <p:nvSpPr>
                  <p:cNvPr id="1584" name="Line 56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4015858" y="324752"/>
                    <a:ext cx="1252" cy="1768948"/>
                  </a:xfrm>
                  <a:prstGeom prst="line">
                    <a:avLst/>
                  </a:prstGeom>
                  <a:noFill/>
                  <a:ln w="793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GB"/>
                  </a:p>
                </p:txBody>
              </p:sp>
              <p:sp>
                <p:nvSpPr>
                  <p:cNvPr id="1585" name="Line 561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984560" y="2093700"/>
                    <a:ext cx="31299" cy="1109"/>
                  </a:xfrm>
                  <a:prstGeom prst="line">
                    <a:avLst/>
                  </a:prstGeom>
                  <a:noFill/>
                  <a:ln w="793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GB"/>
                  </a:p>
                </p:txBody>
              </p:sp>
              <p:sp>
                <p:nvSpPr>
                  <p:cNvPr id="1586" name="Line 562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984560" y="1651463"/>
                    <a:ext cx="31299" cy="1109"/>
                  </a:xfrm>
                  <a:prstGeom prst="line">
                    <a:avLst/>
                  </a:prstGeom>
                  <a:noFill/>
                  <a:ln w="793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GB"/>
                  </a:p>
                </p:txBody>
              </p:sp>
              <p:sp>
                <p:nvSpPr>
                  <p:cNvPr id="1587" name="Line 563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984560" y="1209226"/>
                    <a:ext cx="31299" cy="1109"/>
                  </a:xfrm>
                  <a:prstGeom prst="line">
                    <a:avLst/>
                  </a:prstGeom>
                  <a:noFill/>
                  <a:ln w="793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GB"/>
                  </a:p>
                </p:txBody>
              </p:sp>
              <p:sp>
                <p:nvSpPr>
                  <p:cNvPr id="1588" name="Line 564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984560" y="766989"/>
                    <a:ext cx="31299" cy="1109"/>
                  </a:xfrm>
                  <a:prstGeom prst="line">
                    <a:avLst/>
                  </a:prstGeom>
                  <a:noFill/>
                  <a:ln w="793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GB"/>
                  </a:p>
                </p:txBody>
              </p:sp>
              <p:sp>
                <p:nvSpPr>
                  <p:cNvPr id="1594" name="Line 570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984560" y="324752"/>
                    <a:ext cx="31299" cy="1109"/>
                  </a:xfrm>
                  <a:prstGeom prst="line">
                    <a:avLst/>
                  </a:prstGeom>
                  <a:noFill/>
                  <a:ln w="793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GB"/>
                  </a:p>
                </p:txBody>
              </p:sp>
            </p:grpSp>
            <p:sp>
              <p:nvSpPr>
                <p:cNvPr id="1595" name="Freeform 571"/>
                <p:cNvSpPr>
                  <a:spLocks/>
                </p:cNvSpPr>
                <p:nvPr/>
              </p:nvSpPr>
              <p:spPr bwMode="auto">
                <a:xfrm>
                  <a:off x="4049510" y="93156"/>
                  <a:ext cx="26402" cy="785795"/>
                </a:xfrm>
                <a:custGeom>
                  <a:avLst/>
                  <a:gdLst/>
                  <a:ahLst/>
                  <a:cxnLst>
                    <a:cxn ang="0">
                      <a:pos x="0" y="6178"/>
                    </a:cxn>
                    <a:cxn ang="0">
                      <a:pos x="95" y="6178"/>
                    </a:cxn>
                    <a:cxn ang="0">
                      <a:pos x="95" y="0"/>
                    </a:cxn>
                    <a:cxn ang="0">
                      <a:pos x="0" y="0"/>
                    </a:cxn>
                    <a:cxn ang="0">
                      <a:pos x="189" y="0"/>
                    </a:cxn>
                    <a:cxn ang="0">
                      <a:pos x="95" y="0"/>
                    </a:cxn>
                    <a:cxn ang="0">
                      <a:pos x="95" y="6178"/>
                    </a:cxn>
                    <a:cxn ang="0">
                      <a:pos x="189" y="6178"/>
                    </a:cxn>
                    <a:cxn ang="0">
                      <a:pos x="0" y="6178"/>
                    </a:cxn>
                  </a:cxnLst>
                  <a:rect l="0" t="0" r="r" b="b"/>
                  <a:pathLst>
                    <a:path w="189" h="6178">
                      <a:moveTo>
                        <a:pt x="0" y="6178"/>
                      </a:moveTo>
                      <a:lnTo>
                        <a:pt x="95" y="6178"/>
                      </a:lnTo>
                      <a:lnTo>
                        <a:pt x="95" y="0"/>
                      </a:lnTo>
                      <a:lnTo>
                        <a:pt x="0" y="0"/>
                      </a:lnTo>
                      <a:lnTo>
                        <a:pt x="189" y="0"/>
                      </a:lnTo>
                      <a:lnTo>
                        <a:pt x="95" y="0"/>
                      </a:lnTo>
                      <a:lnTo>
                        <a:pt x="95" y="6178"/>
                      </a:lnTo>
                      <a:lnTo>
                        <a:pt x="189" y="6178"/>
                      </a:lnTo>
                      <a:lnTo>
                        <a:pt x="0" y="6178"/>
                      </a:lnTo>
                      <a:close/>
                    </a:path>
                  </a:pathLst>
                </a:custGeom>
                <a:solidFill>
                  <a:srgbClr val="DBD8AC"/>
                </a:solidFill>
                <a:ln w="793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596" name="Rectangle 572"/>
                <p:cNvSpPr>
                  <a:spLocks noChangeArrowheads="1"/>
                </p:cNvSpPr>
                <p:nvPr/>
              </p:nvSpPr>
              <p:spPr bwMode="auto">
                <a:xfrm>
                  <a:off x="4010684" y="453375"/>
                  <a:ext cx="104053" cy="281490"/>
                </a:xfrm>
                <a:prstGeom prst="rect">
                  <a:avLst/>
                </a:prstGeom>
                <a:solidFill>
                  <a:srgbClr val="2EB848"/>
                </a:solidFill>
                <a:ln w="793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597" name="Freeform 573"/>
                <p:cNvSpPr>
                  <a:spLocks/>
                </p:cNvSpPr>
                <p:nvPr/>
              </p:nvSpPr>
              <p:spPr bwMode="auto">
                <a:xfrm>
                  <a:off x="4010684" y="555869"/>
                  <a:ext cx="104053" cy="74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756" y="0"/>
                    </a:cxn>
                    <a:cxn ang="0">
                      <a:pos x="0" y="0"/>
                    </a:cxn>
                  </a:cxnLst>
                  <a:rect l="0" t="0" r="r" b="b"/>
                  <a:pathLst>
                    <a:path w="756">
                      <a:moveTo>
                        <a:pt x="0" y="0"/>
                      </a:moveTo>
                      <a:lnTo>
                        <a:pt x="756" y="0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noFill/>
                <a:ln w="2857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</p:grpSp>
        </p:grpSp>
        <p:sp>
          <p:nvSpPr>
            <p:cNvPr id="770" name="TextBox 769"/>
            <p:cNvSpPr txBox="1"/>
            <p:nvPr/>
          </p:nvSpPr>
          <p:spPr>
            <a:xfrm>
              <a:off x="847725" y="552450"/>
              <a:ext cx="6858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dirty="0" smtClean="0"/>
                <a:t>PGE</a:t>
              </a:r>
              <a:r>
                <a:rPr lang="en-GB" baseline="-25000" dirty="0" smtClean="0"/>
                <a:t>2</a:t>
              </a:r>
              <a:endParaRPr lang="en-GB" baseline="-25000" dirty="0"/>
            </a:p>
          </p:txBody>
        </p:sp>
        <p:sp>
          <p:nvSpPr>
            <p:cNvPr id="773" name="TextBox 772"/>
            <p:cNvSpPr txBox="1"/>
            <p:nvPr/>
          </p:nvSpPr>
          <p:spPr>
            <a:xfrm rot="16200000">
              <a:off x="1419226" y="561975"/>
              <a:ext cx="70485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b="1" dirty="0" smtClean="0">
                  <a:latin typeface="Arial" pitchFamily="34" charset="0"/>
                  <a:cs typeface="Arial" pitchFamily="34" charset="0"/>
                </a:rPr>
                <a:t>pg/mg</a:t>
              </a:r>
              <a:endParaRPr lang="en-GB" sz="1000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610" name="Group 1609"/>
          <p:cNvGrpSpPr/>
          <p:nvPr/>
        </p:nvGrpSpPr>
        <p:grpSpPr>
          <a:xfrm>
            <a:off x="-9524" y="2614611"/>
            <a:ext cx="5337173" cy="1414464"/>
            <a:chOff x="-19049" y="2833686"/>
            <a:chExt cx="5337173" cy="1414464"/>
          </a:xfrm>
        </p:grpSpPr>
        <p:grpSp>
          <p:nvGrpSpPr>
            <p:cNvPr id="769" name="Group 768"/>
            <p:cNvGrpSpPr/>
            <p:nvPr/>
          </p:nvGrpSpPr>
          <p:grpSpPr>
            <a:xfrm>
              <a:off x="1900240" y="2928939"/>
              <a:ext cx="2833685" cy="1319211"/>
              <a:chOff x="347665" y="2928939"/>
              <a:chExt cx="2833685" cy="1319211"/>
            </a:xfrm>
          </p:grpSpPr>
          <p:sp>
            <p:nvSpPr>
              <p:cNvPr id="1636" name="Rectangle 612"/>
              <p:cNvSpPr>
                <a:spLocks noChangeArrowheads="1"/>
              </p:cNvSpPr>
              <p:nvPr/>
            </p:nvSpPr>
            <p:spPr bwMode="auto">
              <a:xfrm>
                <a:off x="3129572" y="4159518"/>
                <a:ext cx="51778" cy="886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</a:rPr>
                  <a:t> 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637" name="Freeform 613"/>
              <p:cNvSpPr>
                <a:spLocks noEditPoints="1"/>
              </p:cNvSpPr>
              <p:nvPr/>
            </p:nvSpPr>
            <p:spPr bwMode="auto">
              <a:xfrm>
                <a:off x="544650" y="2956928"/>
                <a:ext cx="2514225" cy="907774"/>
              </a:xfrm>
              <a:custGeom>
                <a:avLst/>
                <a:gdLst/>
                <a:ahLst/>
                <a:cxnLst>
                  <a:cxn ang="0">
                    <a:pos x="0" y="972"/>
                  </a:cxn>
                  <a:cxn ang="0">
                    <a:pos x="2525" y="972"/>
                  </a:cxn>
                  <a:cxn ang="0">
                    <a:pos x="2525" y="973"/>
                  </a:cxn>
                  <a:cxn ang="0">
                    <a:pos x="0" y="973"/>
                  </a:cxn>
                  <a:cxn ang="0">
                    <a:pos x="0" y="972"/>
                  </a:cxn>
                  <a:cxn ang="0">
                    <a:pos x="0" y="810"/>
                  </a:cxn>
                  <a:cxn ang="0">
                    <a:pos x="2525" y="810"/>
                  </a:cxn>
                  <a:cxn ang="0">
                    <a:pos x="2525" y="811"/>
                  </a:cxn>
                  <a:cxn ang="0">
                    <a:pos x="0" y="811"/>
                  </a:cxn>
                  <a:cxn ang="0">
                    <a:pos x="0" y="810"/>
                  </a:cxn>
                  <a:cxn ang="0">
                    <a:pos x="0" y="648"/>
                  </a:cxn>
                  <a:cxn ang="0">
                    <a:pos x="2525" y="648"/>
                  </a:cxn>
                  <a:cxn ang="0">
                    <a:pos x="2525" y="649"/>
                  </a:cxn>
                  <a:cxn ang="0">
                    <a:pos x="0" y="649"/>
                  </a:cxn>
                  <a:cxn ang="0">
                    <a:pos x="0" y="648"/>
                  </a:cxn>
                  <a:cxn ang="0">
                    <a:pos x="0" y="486"/>
                  </a:cxn>
                  <a:cxn ang="0">
                    <a:pos x="2525" y="486"/>
                  </a:cxn>
                  <a:cxn ang="0">
                    <a:pos x="2525" y="487"/>
                  </a:cxn>
                  <a:cxn ang="0">
                    <a:pos x="0" y="487"/>
                  </a:cxn>
                  <a:cxn ang="0">
                    <a:pos x="0" y="486"/>
                  </a:cxn>
                  <a:cxn ang="0">
                    <a:pos x="0" y="324"/>
                  </a:cxn>
                  <a:cxn ang="0">
                    <a:pos x="2525" y="324"/>
                  </a:cxn>
                  <a:cxn ang="0">
                    <a:pos x="2525" y="325"/>
                  </a:cxn>
                  <a:cxn ang="0">
                    <a:pos x="0" y="325"/>
                  </a:cxn>
                  <a:cxn ang="0">
                    <a:pos x="0" y="324"/>
                  </a:cxn>
                  <a:cxn ang="0">
                    <a:pos x="0" y="162"/>
                  </a:cxn>
                  <a:cxn ang="0">
                    <a:pos x="2525" y="162"/>
                  </a:cxn>
                  <a:cxn ang="0">
                    <a:pos x="2525" y="163"/>
                  </a:cxn>
                  <a:cxn ang="0">
                    <a:pos x="0" y="163"/>
                  </a:cxn>
                  <a:cxn ang="0">
                    <a:pos x="0" y="162"/>
                  </a:cxn>
                  <a:cxn ang="0">
                    <a:pos x="0" y="0"/>
                  </a:cxn>
                  <a:cxn ang="0">
                    <a:pos x="2525" y="0"/>
                  </a:cxn>
                  <a:cxn ang="0">
                    <a:pos x="2525" y="1"/>
                  </a:cxn>
                  <a:cxn ang="0">
                    <a:pos x="0" y="1"/>
                  </a:cxn>
                  <a:cxn ang="0">
                    <a:pos x="0" y="0"/>
                  </a:cxn>
                </a:cxnLst>
                <a:rect l="0" t="0" r="r" b="b"/>
                <a:pathLst>
                  <a:path w="2525" h="973">
                    <a:moveTo>
                      <a:pt x="0" y="972"/>
                    </a:moveTo>
                    <a:lnTo>
                      <a:pt x="2525" y="972"/>
                    </a:lnTo>
                    <a:lnTo>
                      <a:pt x="2525" y="973"/>
                    </a:lnTo>
                    <a:lnTo>
                      <a:pt x="0" y="973"/>
                    </a:lnTo>
                    <a:lnTo>
                      <a:pt x="0" y="972"/>
                    </a:lnTo>
                    <a:close/>
                    <a:moveTo>
                      <a:pt x="0" y="810"/>
                    </a:moveTo>
                    <a:lnTo>
                      <a:pt x="2525" y="810"/>
                    </a:lnTo>
                    <a:lnTo>
                      <a:pt x="2525" y="811"/>
                    </a:lnTo>
                    <a:lnTo>
                      <a:pt x="0" y="811"/>
                    </a:lnTo>
                    <a:lnTo>
                      <a:pt x="0" y="810"/>
                    </a:lnTo>
                    <a:close/>
                    <a:moveTo>
                      <a:pt x="0" y="648"/>
                    </a:moveTo>
                    <a:lnTo>
                      <a:pt x="2525" y="648"/>
                    </a:lnTo>
                    <a:lnTo>
                      <a:pt x="2525" y="649"/>
                    </a:lnTo>
                    <a:lnTo>
                      <a:pt x="0" y="649"/>
                    </a:lnTo>
                    <a:lnTo>
                      <a:pt x="0" y="648"/>
                    </a:lnTo>
                    <a:close/>
                    <a:moveTo>
                      <a:pt x="0" y="486"/>
                    </a:moveTo>
                    <a:lnTo>
                      <a:pt x="2525" y="486"/>
                    </a:lnTo>
                    <a:lnTo>
                      <a:pt x="2525" y="487"/>
                    </a:lnTo>
                    <a:lnTo>
                      <a:pt x="0" y="487"/>
                    </a:lnTo>
                    <a:lnTo>
                      <a:pt x="0" y="486"/>
                    </a:lnTo>
                    <a:close/>
                    <a:moveTo>
                      <a:pt x="0" y="324"/>
                    </a:moveTo>
                    <a:lnTo>
                      <a:pt x="2525" y="324"/>
                    </a:lnTo>
                    <a:lnTo>
                      <a:pt x="2525" y="325"/>
                    </a:lnTo>
                    <a:lnTo>
                      <a:pt x="0" y="325"/>
                    </a:lnTo>
                    <a:lnTo>
                      <a:pt x="0" y="324"/>
                    </a:lnTo>
                    <a:close/>
                    <a:moveTo>
                      <a:pt x="0" y="162"/>
                    </a:moveTo>
                    <a:lnTo>
                      <a:pt x="2525" y="162"/>
                    </a:lnTo>
                    <a:lnTo>
                      <a:pt x="2525" y="163"/>
                    </a:lnTo>
                    <a:lnTo>
                      <a:pt x="0" y="163"/>
                    </a:lnTo>
                    <a:lnTo>
                      <a:pt x="0" y="162"/>
                    </a:lnTo>
                    <a:close/>
                    <a:moveTo>
                      <a:pt x="0" y="0"/>
                    </a:moveTo>
                    <a:lnTo>
                      <a:pt x="2525" y="0"/>
                    </a:lnTo>
                    <a:lnTo>
                      <a:pt x="2525" y="1"/>
                    </a:lnTo>
                    <a:lnTo>
                      <a:pt x="0" y="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38" name="Freeform 614"/>
              <p:cNvSpPr>
                <a:spLocks noEditPoints="1"/>
              </p:cNvSpPr>
              <p:nvPr/>
            </p:nvSpPr>
            <p:spPr bwMode="auto">
              <a:xfrm>
                <a:off x="541662" y="2955062"/>
                <a:ext cx="2520200" cy="1062646"/>
              </a:xfrm>
              <a:custGeom>
                <a:avLst/>
                <a:gdLst/>
                <a:ahLst/>
                <a:cxnLst>
                  <a:cxn ang="0">
                    <a:pos x="0" y="28"/>
                  </a:cxn>
                  <a:cxn ang="0">
                    <a:pos x="28" y="0"/>
                  </a:cxn>
                  <a:cxn ang="0">
                    <a:pos x="26232" y="0"/>
                  </a:cxn>
                  <a:cxn ang="0">
                    <a:pos x="26260" y="28"/>
                  </a:cxn>
                  <a:cxn ang="0">
                    <a:pos x="26260" y="12944"/>
                  </a:cxn>
                  <a:cxn ang="0">
                    <a:pos x="26232" y="12972"/>
                  </a:cxn>
                  <a:cxn ang="0">
                    <a:pos x="28" y="12972"/>
                  </a:cxn>
                  <a:cxn ang="0">
                    <a:pos x="0" y="12944"/>
                  </a:cxn>
                  <a:cxn ang="0">
                    <a:pos x="0" y="28"/>
                  </a:cxn>
                  <a:cxn ang="0">
                    <a:pos x="56" y="12944"/>
                  </a:cxn>
                  <a:cxn ang="0">
                    <a:pos x="28" y="12916"/>
                  </a:cxn>
                  <a:cxn ang="0">
                    <a:pos x="26232" y="12916"/>
                  </a:cxn>
                  <a:cxn ang="0">
                    <a:pos x="26204" y="12944"/>
                  </a:cxn>
                  <a:cxn ang="0">
                    <a:pos x="26204" y="28"/>
                  </a:cxn>
                  <a:cxn ang="0">
                    <a:pos x="26232" y="56"/>
                  </a:cxn>
                  <a:cxn ang="0">
                    <a:pos x="28" y="56"/>
                  </a:cxn>
                  <a:cxn ang="0">
                    <a:pos x="56" y="28"/>
                  </a:cxn>
                  <a:cxn ang="0">
                    <a:pos x="56" y="12944"/>
                  </a:cxn>
                </a:cxnLst>
                <a:rect l="0" t="0" r="r" b="b"/>
                <a:pathLst>
                  <a:path w="26260" h="12972">
                    <a:moveTo>
                      <a:pt x="0" y="28"/>
                    </a:moveTo>
                    <a:cubicBezTo>
                      <a:pt x="0" y="13"/>
                      <a:pt x="13" y="0"/>
                      <a:pt x="28" y="0"/>
                    </a:cubicBezTo>
                    <a:lnTo>
                      <a:pt x="26232" y="0"/>
                    </a:lnTo>
                    <a:cubicBezTo>
                      <a:pt x="26248" y="0"/>
                      <a:pt x="26260" y="13"/>
                      <a:pt x="26260" y="28"/>
                    </a:cubicBezTo>
                    <a:lnTo>
                      <a:pt x="26260" y="12944"/>
                    </a:lnTo>
                    <a:cubicBezTo>
                      <a:pt x="26260" y="12960"/>
                      <a:pt x="26248" y="12972"/>
                      <a:pt x="26232" y="12972"/>
                    </a:cubicBezTo>
                    <a:lnTo>
                      <a:pt x="28" y="12972"/>
                    </a:lnTo>
                    <a:cubicBezTo>
                      <a:pt x="13" y="12972"/>
                      <a:pt x="0" y="12960"/>
                      <a:pt x="0" y="12944"/>
                    </a:cubicBezTo>
                    <a:lnTo>
                      <a:pt x="0" y="28"/>
                    </a:lnTo>
                    <a:close/>
                    <a:moveTo>
                      <a:pt x="56" y="12944"/>
                    </a:moveTo>
                    <a:lnTo>
                      <a:pt x="28" y="12916"/>
                    </a:lnTo>
                    <a:lnTo>
                      <a:pt x="26232" y="12916"/>
                    </a:lnTo>
                    <a:lnTo>
                      <a:pt x="26204" y="12944"/>
                    </a:lnTo>
                    <a:lnTo>
                      <a:pt x="26204" y="28"/>
                    </a:lnTo>
                    <a:lnTo>
                      <a:pt x="26232" y="56"/>
                    </a:lnTo>
                    <a:lnTo>
                      <a:pt x="28" y="56"/>
                    </a:lnTo>
                    <a:lnTo>
                      <a:pt x="56" y="28"/>
                    </a:lnTo>
                    <a:lnTo>
                      <a:pt x="56" y="12944"/>
                    </a:lnTo>
                    <a:close/>
                  </a:path>
                </a:pathLst>
              </a:custGeom>
              <a:solidFill>
                <a:srgbClr val="808080"/>
              </a:solidFill>
              <a:ln w="0" cap="flat">
                <a:solidFill>
                  <a:srgbClr val="80808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39" name="Rectangle 615"/>
              <p:cNvSpPr>
                <a:spLocks noChangeArrowheads="1"/>
              </p:cNvSpPr>
              <p:nvPr/>
            </p:nvSpPr>
            <p:spPr bwMode="auto">
              <a:xfrm>
                <a:off x="565560" y="3307722"/>
                <a:ext cx="41821" cy="708120"/>
              </a:xfrm>
              <a:prstGeom prst="rect">
                <a:avLst/>
              </a:prstGeom>
              <a:solidFill>
                <a:srgbClr val="9999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40" name="Freeform 616"/>
              <p:cNvSpPr>
                <a:spLocks noEditPoints="1"/>
              </p:cNvSpPr>
              <p:nvPr/>
            </p:nvSpPr>
            <p:spPr bwMode="auto">
              <a:xfrm>
                <a:off x="563569" y="3305856"/>
                <a:ext cx="46800" cy="711852"/>
              </a:xfrm>
              <a:custGeom>
                <a:avLst/>
                <a:gdLst/>
                <a:ahLst/>
                <a:cxnLst>
                  <a:cxn ang="0">
                    <a:pos x="0" y="56"/>
                  </a:cxn>
                  <a:cxn ang="0">
                    <a:pos x="56" y="0"/>
                  </a:cxn>
                  <a:cxn ang="0">
                    <a:pos x="928" y="0"/>
                  </a:cxn>
                  <a:cxn ang="0">
                    <a:pos x="984" y="56"/>
                  </a:cxn>
                  <a:cxn ang="0">
                    <a:pos x="984" y="17336"/>
                  </a:cxn>
                  <a:cxn ang="0">
                    <a:pos x="928" y="17392"/>
                  </a:cxn>
                  <a:cxn ang="0">
                    <a:pos x="56" y="17392"/>
                  </a:cxn>
                  <a:cxn ang="0">
                    <a:pos x="0" y="17336"/>
                  </a:cxn>
                  <a:cxn ang="0">
                    <a:pos x="0" y="56"/>
                  </a:cxn>
                  <a:cxn ang="0">
                    <a:pos x="112" y="17336"/>
                  </a:cxn>
                  <a:cxn ang="0">
                    <a:pos x="56" y="17280"/>
                  </a:cxn>
                  <a:cxn ang="0">
                    <a:pos x="928" y="17280"/>
                  </a:cxn>
                  <a:cxn ang="0">
                    <a:pos x="872" y="17336"/>
                  </a:cxn>
                  <a:cxn ang="0">
                    <a:pos x="872" y="56"/>
                  </a:cxn>
                  <a:cxn ang="0">
                    <a:pos x="928" y="112"/>
                  </a:cxn>
                  <a:cxn ang="0">
                    <a:pos x="56" y="112"/>
                  </a:cxn>
                  <a:cxn ang="0">
                    <a:pos x="112" y="56"/>
                  </a:cxn>
                  <a:cxn ang="0">
                    <a:pos x="112" y="17336"/>
                  </a:cxn>
                </a:cxnLst>
                <a:rect l="0" t="0" r="r" b="b"/>
                <a:pathLst>
                  <a:path w="984" h="17392">
                    <a:moveTo>
                      <a:pt x="0" y="56"/>
                    </a:moveTo>
                    <a:cubicBezTo>
                      <a:pt x="0" y="26"/>
                      <a:pt x="26" y="0"/>
                      <a:pt x="56" y="0"/>
                    </a:cubicBezTo>
                    <a:lnTo>
                      <a:pt x="928" y="0"/>
                    </a:lnTo>
                    <a:cubicBezTo>
                      <a:pt x="959" y="0"/>
                      <a:pt x="984" y="26"/>
                      <a:pt x="984" y="56"/>
                    </a:cubicBezTo>
                    <a:lnTo>
                      <a:pt x="984" y="17336"/>
                    </a:lnTo>
                    <a:cubicBezTo>
                      <a:pt x="984" y="17367"/>
                      <a:pt x="959" y="17392"/>
                      <a:pt x="928" y="17392"/>
                    </a:cubicBezTo>
                    <a:lnTo>
                      <a:pt x="56" y="17392"/>
                    </a:lnTo>
                    <a:cubicBezTo>
                      <a:pt x="26" y="17392"/>
                      <a:pt x="0" y="17367"/>
                      <a:pt x="0" y="17336"/>
                    </a:cubicBezTo>
                    <a:lnTo>
                      <a:pt x="0" y="56"/>
                    </a:lnTo>
                    <a:close/>
                    <a:moveTo>
                      <a:pt x="112" y="17336"/>
                    </a:moveTo>
                    <a:lnTo>
                      <a:pt x="56" y="17280"/>
                    </a:lnTo>
                    <a:lnTo>
                      <a:pt x="928" y="17280"/>
                    </a:lnTo>
                    <a:lnTo>
                      <a:pt x="872" y="17336"/>
                    </a:lnTo>
                    <a:lnTo>
                      <a:pt x="872" y="56"/>
                    </a:lnTo>
                    <a:lnTo>
                      <a:pt x="928" y="112"/>
                    </a:lnTo>
                    <a:lnTo>
                      <a:pt x="56" y="112"/>
                    </a:lnTo>
                    <a:lnTo>
                      <a:pt x="112" y="56"/>
                    </a:lnTo>
                    <a:lnTo>
                      <a:pt x="112" y="17336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41" name="Rectangle 617"/>
              <p:cNvSpPr>
                <a:spLocks noChangeArrowheads="1"/>
              </p:cNvSpPr>
              <p:nvPr/>
            </p:nvSpPr>
            <p:spPr bwMode="auto">
              <a:xfrm>
                <a:off x="691022" y="3384225"/>
                <a:ext cx="41821" cy="631617"/>
              </a:xfrm>
              <a:prstGeom prst="rect">
                <a:avLst/>
              </a:prstGeom>
              <a:solidFill>
                <a:srgbClr val="9999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42" name="Freeform 618"/>
              <p:cNvSpPr>
                <a:spLocks noEditPoints="1"/>
              </p:cNvSpPr>
              <p:nvPr/>
            </p:nvSpPr>
            <p:spPr bwMode="auto">
              <a:xfrm>
                <a:off x="689031" y="3382359"/>
                <a:ext cx="46800" cy="635349"/>
              </a:xfrm>
              <a:custGeom>
                <a:avLst/>
                <a:gdLst/>
                <a:ahLst/>
                <a:cxnLst>
                  <a:cxn ang="0">
                    <a:pos x="0" y="56"/>
                  </a:cxn>
                  <a:cxn ang="0">
                    <a:pos x="56" y="0"/>
                  </a:cxn>
                  <a:cxn ang="0">
                    <a:pos x="928" y="0"/>
                  </a:cxn>
                  <a:cxn ang="0">
                    <a:pos x="984" y="56"/>
                  </a:cxn>
                  <a:cxn ang="0">
                    <a:pos x="984" y="15472"/>
                  </a:cxn>
                  <a:cxn ang="0">
                    <a:pos x="928" y="15528"/>
                  </a:cxn>
                  <a:cxn ang="0">
                    <a:pos x="56" y="15528"/>
                  </a:cxn>
                  <a:cxn ang="0">
                    <a:pos x="0" y="15472"/>
                  </a:cxn>
                  <a:cxn ang="0">
                    <a:pos x="0" y="56"/>
                  </a:cxn>
                  <a:cxn ang="0">
                    <a:pos x="112" y="15472"/>
                  </a:cxn>
                  <a:cxn ang="0">
                    <a:pos x="56" y="15416"/>
                  </a:cxn>
                  <a:cxn ang="0">
                    <a:pos x="928" y="15416"/>
                  </a:cxn>
                  <a:cxn ang="0">
                    <a:pos x="872" y="15472"/>
                  </a:cxn>
                  <a:cxn ang="0">
                    <a:pos x="872" y="56"/>
                  </a:cxn>
                  <a:cxn ang="0">
                    <a:pos x="928" y="112"/>
                  </a:cxn>
                  <a:cxn ang="0">
                    <a:pos x="56" y="112"/>
                  </a:cxn>
                  <a:cxn ang="0">
                    <a:pos x="112" y="56"/>
                  </a:cxn>
                  <a:cxn ang="0">
                    <a:pos x="112" y="15472"/>
                  </a:cxn>
                </a:cxnLst>
                <a:rect l="0" t="0" r="r" b="b"/>
                <a:pathLst>
                  <a:path w="984" h="15528">
                    <a:moveTo>
                      <a:pt x="0" y="56"/>
                    </a:moveTo>
                    <a:cubicBezTo>
                      <a:pt x="0" y="26"/>
                      <a:pt x="26" y="0"/>
                      <a:pt x="56" y="0"/>
                    </a:cubicBezTo>
                    <a:lnTo>
                      <a:pt x="928" y="0"/>
                    </a:lnTo>
                    <a:cubicBezTo>
                      <a:pt x="959" y="0"/>
                      <a:pt x="984" y="26"/>
                      <a:pt x="984" y="56"/>
                    </a:cubicBezTo>
                    <a:lnTo>
                      <a:pt x="984" y="15472"/>
                    </a:lnTo>
                    <a:cubicBezTo>
                      <a:pt x="984" y="15503"/>
                      <a:pt x="959" y="15528"/>
                      <a:pt x="928" y="15528"/>
                    </a:cubicBezTo>
                    <a:lnTo>
                      <a:pt x="56" y="15528"/>
                    </a:lnTo>
                    <a:cubicBezTo>
                      <a:pt x="26" y="15528"/>
                      <a:pt x="0" y="15503"/>
                      <a:pt x="0" y="15472"/>
                    </a:cubicBezTo>
                    <a:lnTo>
                      <a:pt x="0" y="56"/>
                    </a:lnTo>
                    <a:close/>
                    <a:moveTo>
                      <a:pt x="112" y="15472"/>
                    </a:moveTo>
                    <a:lnTo>
                      <a:pt x="56" y="15416"/>
                    </a:lnTo>
                    <a:lnTo>
                      <a:pt x="928" y="15416"/>
                    </a:lnTo>
                    <a:lnTo>
                      <a:pt x="872" y="15472"/>
                    </a:lnTo>
                    <a:lnTo>
                      <a:pt x="872" y="56"/>
                    </a:lnTo>
                    <a:lnTo>
                      <a:pt x="928" y="112"/>
                    </a:lnTo>
                    <a:lnTo>
                      <a:pt x="56" y="112"/>
                    </a:lnTo>
                    <a:lnTo>
                      <a:pt x="112" y="56"/>
                    </a:lnTo>
                    <a:lnTo>
                      <a:pt x="112" y="15472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43" name="Rectangle 619"/>
              <p:cNvSpPr>
                <a:spLocks noChangeArrowheads="1"/>
              </p:cNvSpPr>
              <p:nvPr/>
            </p:nvSpPr>
            <p:spPr bwMode="auto">
              <a:xfrm>
                <a:off x="817481" y="3403817"/>
                <a:ext cx="41821" cy="612024"/>
              </a:xfrm>
              <a:prstGeom prst="rect">
                <a:avLst/>
              </a:prstGeom>
              <a:solidFill>
                <a:srgbClr val="9999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44" name="Freeform 620"/>
              <p:cNvSpPr>
                <a:spLocks noEditPoints="1"/>
              </p:cNvSpPr>
              <p:nvPr/>
            </p:nvSpPr>
            <p:spPr bwMode="auto">
              <a:xfrm>
                <a:off x="814493" y="3401951"/>
                <a:ext cx="47795" cy="615756"/>
              </a:xfrm>
              <a:custGeom>
                <a:avLst/>
                <a:gdLst/>
                <a:ahLst/>
                <a:cxnLst>
                  <a:cxn ang="0">
                    <a:pos x="0" y="56"/>
                  </a:cxn>
                  <a:cxn ang="0">
                    <a:pos x="56" y="0"/>
                  </a:cxn>
                  <a:cxn ang="0">
                    <a:pos x="928" y="0"/>
                  </a:cxn>
                  <a:cxn ang="0">
                    <a:pos x="984" y="56"/>
                  </a:cxn>
                  <a:cxn ang="0">
                    <a:pos x="984" y="14984"/>
                  </a:cxn>
                  <a:cxn ang="0">
                    <a:pos x="928" y="15040"/>
                  </a:cxn>
                  <a:cxn ang="0">
                    <a:pos x="56" y="15040"/>
                  </a:cxn>
                  <a:cxn ang="0">
                    <a:pos x="0" y="14984"/>
                  </a:cxn>
                  <a:cxn ang="0">
                    <a:pos x="0" y="56"/>
                  </a:cxn>
                  <a:cxn ang="0">
                    <a:pos x="112" y="14984"/>
                  </a:cxn>
                  <a:cxn ang="0">
                    <a:pos x="56" y="14928"/>
                  </a:cxn>
                  <a:cxn ang="0">
                    <a:pos x="928" y="14928"/>
                  </a:cxn>
                  <a:cxn ang="0">
                    <a:pos x="872" y="14984"/>
                  </a:cxn>
                  <a:cxn ang="0">
                    <a:pos x="872" y="56"/>
                  </a:cxn>
                  <a:cxn ang="0">
                    <a:pos x="928" y="112"/>
                  </a:cxn>
                  <a:cxn ang="0">
                    <a:pos x="56" y="112"/>
                  </a:cxn>
                  <a:cxn ang="0">
                    <a:pos x="112" y="56"/>
                  </a:cxn>
                  <a:cxn ang="0">
                    <a:pos x="112" y="14984"/>
                  </a:cxn>
                </a:cxnLst>
                <a:rect l="0" t="0" r="r" b="b"/>
                <a:pathLst>
                  <a:path w="984" h="15040">
                    <a:moveTo>
                      <a:pt x="0" y="56"/>
                    </a:moveTo>
                    <a:cubicBezTo>
                      <a:pt x="0" y="26"/>
                      <a:pt x="26" y="0"/>
                      <a:pt x="56" y="0"/>
                    </a:cubicBezTo>
                    <a:lnTo>
                      <a:pt x="928" y="0"/>
                    </a:lnTo>
                    <a:cubicBezTo>
                      <a:pt x="959" y="0"/>
                      <a:pt x="984" y="26"/>
                      <a:pt x="984" y="56"/>
                    </a:cubicBezTo>
                    <a:lnTo>
                      <a:pt x="984" y="14984"/>
                    </a:lnTo>
                    <a:cubicBezTo>
                      <a:pt x="984" y="15015"/>
                      <a:pt x="959" y="15040"/>
                      <a:pt x="928" y="15040"/>
                    </a:cubicBezTo>
                    <a:lnTo>
                      <a:pt x="56" y="15040"/>
                    </a:lnTo>
                    <a:cubicBezTo>
                      <a:pt x="26" y="15040"/>
                      <a:pt x="0" y="15015"/>
                      <a:pt x="0" y="14984"/>
                    </a:cubicBezTo>
                    <a:lnTo>
                      <a:pt x="0" y="56"/>
                    </a:lnTo>
                    <a:close/>
                    <a:moveTo>
                      <a:pt x="112" y="14984"/>
                    </a:moveTo>
                    <a:lnTo>
                      <a:pt x="56" y="14928"/>
                    </a:lnTo>
                    <a:lnTo>
                      <a:pt x="928" y="14928"/>
                    </a:lnTo>
                    <a:lnTo>
                      <a:pt x="872" y="14984"/>
                    </a:lnTo>
                    <a:lnTo>
                      <a:pt x="872" y="56"/>
                    </a:lnTo>
                    <a:lnTo>
                      <a:pt x="928" y="112"/>
                    </a:lnTo>
                    <a:lnTo>
                      <a:pt x="56" y="112"/>
                    </a:lnTo>
                    <a:lnTo>
                      <a:pt x="112" y="56"/>
                    </a:lnTo>
                    <a:lnTo>
                      <a:pt x="112" y="14984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45" name="Rectangle 621"/>
              <p:cNvSpPr>
                <a:spLocks noChangeArrowheads="1"/>
              </p:cNvSpPr>
              <p:nvPr/>
            </p:nvSpPr>
            <p:spPr bwMode="auto">
              <a:xfrm>
                <a:off x="942943" y="3582946"/>
                <a:ext cx="41821" cy="432895"/>
              </a:xfrm>
              <a:prstGeom prst="rect">
                <a:avLst/>
              </a:prstGeom>
              <a:solidFill>
                <a:srgbClr val="9999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46" name="Freeform 622"/>
              <p:cNvSpPr>
                <a:spLocks noEditPoints="1"/>
              </p:cNvSpPr>
              <p:nvPr/>
            </p:nvSpPr>
            <p:spPr bwMode="auto">
              <a:xfrm>
                <a:off x="939955" y="3580148"/>
                <a:ext cx="47795" cy="437560"/>
              </a:xfrm>
              <a:custGeom>
                <a:avLst/>
                <a:gdLst/>
                <a:ahLst/>
                <a:cxnLst>
                  <a:cxn ang="0">
                    <a:pos x="0" y="56"/>
                  </a:cxn>
                  <a:cxn ang="0">
                    <a:pos x="56" y="0"/>
                  </a:cxn>
                  <a:cxn ang="0">
                    <a:pos x="928" y="0"/>
                  </a:cxn>
                  <a:cxn ang="0">
                    <a:pos x="984" y="56"/>
                  </a:cxn>
                  <a:cxn ang="0">
                    <a:pos x="984" y="10624"/>
                  </a:cxn>
                  <a:cxn ang="0">
                    <a:pos x="928" y="10680"/>
                  </a:cxn>
                  <a:cxn ang="0">
                    <a:pos x="56" y="10680"/>
                  </a:cxn>
                  <a:cxn ang="0">
                    <a:pos x="0" y="10624"/>
                  </a:cxn>
                  <a:cxn ang="0">
                    <a:pos x="0" y="56"/>
                  </a:cxn>
                  <a:cxn ang="0">
                    <a:pos x="112" y="10624"/>
                  </a:cxn>
                  <a:cxn ang="0">
                    <a:pos x="56" y="10568"/>
                  </a:cxn>
                  <a:cxn ang="0">
                    <a:pos x="928" y="10568"/>
                  </a:cxn>
                  <a:cxn ang="0">
                    <a:pos x="872" y="10624"/>
                  </a:cxn>
                  <a:cxn ang="0">
                    <a:pos x="872" y="56"/>
                  </a:cxn>
                  <a:cxn ang="0">
                    <a:pos x="928" y="112"/>
                  </a:cxn>
                  <a:cxn ang="0">
                    <a:pos x="56" y="112"/>
                  </a:cxn>
                  <a:cxn ang="0">
                    <a:pos x="112" y="56"/>
                  </a:cxn>
                  <a:cxn ang="0">
                    <a:pos x="112" y="10624"/>
                  </a:cxn>
                </a:cxnLst>
                <a:rect l="0" t="0" r="r" b="b"/>
                <a:pathLst>
                  <a:path w="984" h="10680">
                    <a:moveTo>
                      <a:pt x="0" y="56"/>
                    </a:moveTo>
                    <a:cubicBezTo>
                      <a:pt x="0" y="26"/>
                      <a:pt x="26" y="0"/>
                      <a:pt x="56" y="0"/>
                    </a:cubicBezTo>
                    <a:lnTo>
                      <a:pt x="928" y="0"/>
                    </a:lnTo>
                    <a:cubicBezTo>
                      <a:pt x="959" y="0"/>
                      <a:pt x="984" y="26"/>
                      <a:pt x="984" y="56"/>
                    </a:cubicBezTo>
                    <a:lnTo>
                      <a:pt x="984" y="10624"/>
                    </a:lnTo>
                    <a:cubicBezTo>
                      <a:pt x="984" y="10655"/>
                      <a:pt x="959" y="10680"/>
                      <a:pt x="928" y="10680"/>
                    </a:cubicBezTo>
                    <a:lnTo>
                      <a:pt x="56" y="10680"/>
                    </a:lnTo>
                    <a:cubicBezTo>
                      <a:pt x="26" y="10680"/>
                      <a:pt x="0" y="10655"/>
                      <a:pt x="0" y="10624"/>
                    </a:cubicBezTo>
                    <a:lnTo>
                      <a:pt x="0" y="56"/>
                    </a:lnTo>
                    <a:close/>
                    <a:moveTo>
                      <a:pt x="112" y="10624"/>
                    </a:moveTo>
                    <a:lnTo>
                      <a:pt x="56" y="10568"/>
                    </a:lnTo>
                    <a:lnTo>
                      <a:pt x="928" y="10568"/>
                    </a:lnTo>
                    <a:lnTo>
                      <a:pt x="872" y="10624"/>
                    </a:lnTo>
                    <a:lnTo>
                      <a:pt x="872" y="56"/>
                    </a:lnTo>
                    <a:lnTo>
                      <a:pt x="928" y="112"/>
                    </a:lnTo>
                    <a:lnTo>
                      <a:pt x="56" y="112"/>
                    </a:lnTo>
                    <a:lnTo>
                      <a:pt x="112" y="56"/>
                    </a:lnTo>
                    <a:lnTo>
                      <a:pt x="112" y="10624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47" name="Rectangle 623"/>
              <p:cNvSpPr>
                <a:spLocks noChangeArrowheads="1"/>
              </p:cNvSpPr>
              <p:nvPr/>
            </p:nvSpPr>
            <p:spPr bwMode="auto">
              <a:xfrm>
                <a:off x="1068405" y="3368365"/>
                <a:ext cx="41821" cy="647477"/>
              </a:xfrm>
              <a:prstGeom prst="rect">
                <a:avLst/>
              </a:prstGeom>
              <a:solidFill>
                <a:srgbClr val="9999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48" name="Freeform 624"/>
              <p:cNvSpPr>
                <a:spLocks noEditPoints="1"/>
              </p:cNvSpPr>
              <p:nvPr/>
            </p:nvSpPr>
            <p:spPr bwMode="auto">
              <a:xfrm>
                <a:off x="1066414" y="3365566"/>
                <a:ext cx="46800" cy="652142"/>
              </a:xfrm>
              <a:custGeom>
                <a:avLst/>
                <a:gdLst/>
                <a:ahLst/>
                <a:cxnLst>
                  <a:cxn ang="0">
                    <a:pos x="0" y="56"/>
                  </a:cxn>
                  <a:cxn ang="0">
                    <a:pos x="56" y="0"/>
                  </a:cxn>
                  <a:cxn ang="0">
                    <a:pos x="928" y="0"/>
                  </a:cxn>
                  <a:cxn ang="0">
                    <a:pos x="984" y="56"/>
                  </a:cxn>
                  <a:cxn ang="0">
                    <a:pos x="984" y="15872"/>
                  </a:cxn>
                  <a:cxn ang="0">
                    <a:pos x="928" y="15928"/>
                  </a:cxn>
                  <a:cxn ang="0">
                    <a:pos x="56" y="15928"/>
                  </a:cxn>
                  <a:cxn ang="0">
                    <a:pos x="0" y="15872"/>
                  </a:cxn>
                  <a:cxn ang="0">
                    <a:pos x="0" y="56"/>
                  </a:cxn>
                  <a:cxn ang="0">
                    <a:pos x="112" y="15872"/>
                  </a:cxn>
                  <a:cxn ang="0">
                    <a:pos x="56" y="15816"/>
                  </a:cxn>
                  <a:cxn ang="0">
                    <a:pos x="928" y="15816"/>
                  </a:cxn>
                  <a:cxn ang="0">
                    <a:pos x="872" y="15872"/>
                  </a:cxn>
                  <a:cxn ang="0">
                    <a:pos x="872" y="56"/>
                  </a:cxn>
                  <a:cxn ang="0">
                    <a:pos x="928" y="112"/>
                  </a:cxn>
                  <a:cxn ang="0">
                    <a:pos x="56" y="112"/>
                  </a:cxn>
                  <a:cxn ang="0">
                    <a:pos x="112" y="56"/>
                  </a:cxn>
                  <a:cxn ang="0">
                    <a:pos x="112" y="15872"/>
                  </a:cxn>
                </a:cxnLst>
                <a:rect l="0" t="0" r="r" b="b"/>
                <a:pathLst>
                  <a:path w="984" h="15928">
                    <a:moveTo>
                      <a:pt x="0" y="56"/>
                    </a:moveTo>
                    <a:cubicBezTo>
                      <a:pt x="0" y="26"/>
                      <a:pt x="26" y="0"/>
                      <a:pt x="56" y="0"/>
                    </a:cubicBezTo>
                    <a:lnTo>
                      <a:pt x="928" y="0"/>
                    </a:lnTo>
                    <a:cubicBezTo>
                      <a:pt x="959" y="0"/>
                      <a:pt x="984" y="26"/>
                      <a:pt x="984" y="56"/>
                    </a:cubicBezTo>
                    <a:lnTo>
                      <a:pt x="984" y="15872"/>
                    </a:lnTo>
                    <a:cubicBezTo>
                      <a:pt x="984" y="15903"/>
                      <a:pt x="959" y="15928"/>
                      <a:pt x="928" y="15928"/>
                    </a:cubicBezTo>
                    <a:lnTo>
                      <a:pt x="56" y="15928"/>
                    </a:lnTo>
                    <a:cubicBezTo>
                      <a:pt x="26" y="15928"/>
                      <a:pt x="0" y="15903"/>
                      <a:pt x="0" y="15872"/>
                    </a:cubicBezTo>
                    <a:lnTo>
                      <a:pt x="0" y="56"/>
                    </a:lnTo>
                    <a:close/>
                    <a:moveTo>
                      <a:pt x="112" y="15872"/>
                    </a:moveTo>
                    <a:lnTo>
                      <a:pt x="56" y="15816"/>
                    </a:lnTo>
                    <a:lnTo>
                      <a:pt x="928" y="15816"/>
                    </a:lnTo>
                    <a:lnTo>
                      <a:pt x="872" y="15872"/>
                    </a:lnTo>
                    <a:lnTo>
                      <a:pt x="872" y="56"/>
                    </a:lnTo>
                    <a:lnTo>
                      <a:pt x="928" y="112"/>
                    </a:lnTo>
                    <a:lnTo>
                      <a:pt x="56" y="112"/>
                    </a:lnTo>
                    <a:lnTo>
                      <a:pt x="112" y="56"/>
                    </a:lnTo>
                    <a:lnTo>
                      <a:pt x="112" y="15872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49" name="Rectangle 625"/>
              <p:cNvSpPr>
                <a:spLocks noChangeArrowheads="1"/>
              </p:cNvSpPr>
              <p:nvPr/>
            </p:nvSpPr>
            <p:spPr bwMode="auto">
              <a:xfrm>
                <a:off x="1193868" y="3157515"/>
                <a:ext cx="41821" cy="858327"/>
              </a:xfrm>
              <a:prstGeom prst="rect">
                <a:avLst/>
              </a:prstGeom>
              <a:solidFill>
                <a:srgbClr val="9999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50" name="Freeform 626"/>
              <p:cNvSpPr>
                <a:spLocks noEditPoints="1"/>
              </p:cNvSpPr>
              <p:nvPr/>
            </p:nvSpPr>
            <p:spPr bwMode="auto">
              <a:xfrm>
                <a:off x="1191876" y="3155649"/>
                <a:ext cx="46800" cy="862059"/>
              </a:xfrm>
              <a:custGeom>
                <a:avLst/>
                <a:gdLst/>
                <a:ahLst/>
                <a:cxnLst>
                  <a:cxn ang="0">
                    <a:pos x="0" y="56"/>
                  </a:cxn>
                  <a:cxn ang="0">
                    <a:pos x="56" y="0"/>
                  </a:cxn>
                  <a:cxn ang="0">
                    <a:pos x="928" y="0"/>
                  </a:cxn>
                  <a:cxn ang="0">
                    <a:pos x="984" y="56"/>
                  </a:cxn>
                  <a:cxn ang="0">
                    <a:pos x="984" y="21008"/>
                  </a:cxn>
                  <a:cxn ang="0">
                    <a:pos x="928" y="21064"/>
                  </a:cxn>
                  <a:cxn ang="0">
                    <a:pos x="56" y="21064"/>
                  </a:cxn>
                  <a:cxn ang="0">
                    <a:pos x="0" y="21008"/>
                  </a:cxn>
                  <a:cxn ang="0">
                    <a:pos x="0" y="56"/>
                  </a:cxn>
                  <a:cxn ang="0">
                    <a:pos x="112" y="21008"/>
                  </a:cxn>
                  <a:cxn ang="0">
                    <a:pos x="56" y="20952"/>
                  </a:cxn>
                  <a:cxn ang="0">
                    <a:pos x="928" y="20952"/>
                  </a:cxn>
                  <a:cxn ang="0">
                    <a:pos x="872" y="21008"/>
                  </a:cxn>
                  <a:cxn ang="0">
                    <a:pos x="872" y="56"/>
                  </a:cxn>
                  <a:cxn ang="0">
                    <a:pos x="928" y="112"/>
                  </a:cxn>
                  <a:cxn ang="0">
                    <a:pos x="56" y="112"/>
                  </a:cxn>
                  <a:cxn ang="0">
                    <a:pos x="112" y="56"/>
                  </a:cxn>
                  <a:cxn ang="0">
                    <a:pos x="112" y="21008"/>
                  </a:cxn>
                </a:cxnLst>
                <a:rect l="0" t="0" r="r" b="b"/>
                <a:pathLst>
                  <a:path w="984" h="21064">
                    <a:moveTo>
                      <a:pt x="0" y="56"/>
                    </a:moveTo>
                    <a:cubicBezTo>
                      <a:pt x="0" y="26"/>
                      <a:pt x="26" y="0"/>
                      <a:pt x="56" y="0"/>
                    </a:cubicBezTo>
                    <a:lnTo>
                      <a:pt x="928" y="0"/>
                    </a:lnTo>
                    <a:cubicBezTo>
                      <a:pt x="959" y="0"/>
                      <a:pt x="984" y="26"/>
                      <a:pt x="984" y="56"/>
                    </a:cubicBezTo>
                    <a:lnTo>
                      <a:pt x="984" y="21008"/>
                    </a:lnTo>
                    <a:cubicBezTo>
                      <a:pt x="984" y="21039"/>
                      <a:pt x="959" y="21064"/>
                      <a:pt x="928" y="21064"/>
                    </a:cubicBezTo>
                    <a:lnTo>
                      <a:pt x="56" y="21064"/>
                    </a:lnTo>
                    <a:cubicBezTo>
                      <a:pt x="26" y="21064"/>
                      <a:pt x="0" y="21039"/>
                      <a:pt x="0" y="21008"/>
                    </a:cubicBezTo>
                    <a:lnTo>
                      <a:pt x="0" y="56"/>
                    </a:lnTo>
                    <a:close/>
                    <a:moveTo>
                      <a:pt x="112" y="21008"/>
                    </a:moveTo>
                    <a:lnTo>
                      <a:pt x="56" y="20952"/>
                    </a:lnTo>
                    <a:lnTo>
                      <a:pt x="928" y="20952"/>
                    </a:lnTo>
                    <a:lnTo>
                      <a:pt x="872" y="21008"/>
                    </a:lnTo>
                    <a:lnTo>
                      <a:pt x="872" y="56"/>
                    </a:lnTo>
                    <a:lnTo>
                      <a:pt x="928" y="112"/>
                    </a:lnTo>
                    <a:lnTo>
                      <a:pt x="56" y="112"/>
                    </a:lnTo>
                    <a:lnTo>
                      <a:pt x="112" y="56"/>
                    </a:lnTo>
                    <a:lnTo>
                      <a:pt x="112" y="21008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51" name="Rectangle 627"/>
              <p:cNvSpPr>
                <a:spLocks noChangeArrowheads="1"/>
              </p:cNvSpPr>
              <p:nvPr/>
            </p:nvSpPr>
            <p:spPr bwMode="auto">
              <a:xfrm>
                <a:off x="1320325" y="3385158"/>
                <a:ext cx="41821" cy="630684"/>
              </a:xfrm>
              <a:prstGeom prst="rect">
                <a:avLst/>
              </a:prstGeom>
              <a:solidFill>
                <a:srgbClr val="9999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52" name="Freeform 628"/>
              <p:cNvSpPr>
                <a:spLocks noEditPoints="1"/>
              </p:cNvSpPr>
              <p:nvPr/>
            </p:nvSpPr>
            <p:spPr bwMode="auto">
              <a:xfrm>
                <a:off x="1317338" y="3382359"/>
                <a:ext cx="46800" cy="635349"/>
              </a:xfrm>
              <a:custGeom>
                <a:avLst/>
                <a:gdLst/>
                <a:ahLst/>
                <a:cxnLst>
                  <a:cxn ang="0">
                    <a:pos x="0" y="56"/>
                  </a:cxn>
                  <a:cxn ang="0">
                    <a:pos x="56" y="0"/>
                  </a:cxn>
                  <a:cxn ang="0">
                    <a:pos x="928" y="0"/>
                  </a:cxn>
                  <a:cxn ang="0">
                    <a:pos x="984" y="56"/>
                  </a:cxn>
                  <a:cxn ang="0">
                    <a:pos x="984" y="15456"/>
                  </a:cxn>
                  <a:cxn ang="0">
                    <a:pos x="928" y="15512"/>
                  </a:cxn>
                  <a:cxn ang="0">
                    <a:pos x="56" y="15512"/>
                  </a:cxn>
                  <a:cxn ang="0">
                    <a:pos x="0" y="15456"/>
                  </a:cxn>
                  <a:cxn ang="0">
                    <a:pos x="0" y="56"/>
                  </a:cxn>
                  <a:cxn ang="0">
                    <a:pos x="112" y="15456"/>
                  </a:cxn>
                  <a:cxn ang="0">
                    <a:pos x="56" y="15400"/>
                  </a:cxn>
                  <a:cxn ang="0">
                    <a:pos x="928" y="15400"/>
                  </a:cxn>
                  <a:cxn ang="0">
                    <a:pos x="872" y="15456"/>
                  </a:cxn>
                  <a:cxn ang="0">
                    <a:pos x="872" y="56"/>
                  </a:cxn>
                  <a:cxn ang="0">
                    <a:pos x="928" y="112"/>
                  </a:cxn>
                  <a:cxn ang="0">
                    <a:pos x="56" y="112"/>
                  </a:cxn>
                  <a:cxn ang="0">
                    <a:pos x="112" y="56"/>
                  </a:cxn>
                  <a:cxn ang="0">
                    <a:pos x="112" y="15456"/>
                  </a:cxn>
                </a:cxnLst>
                <a:rect l="0" t="0" r="r" b="b"/>
                <a:pathLst>
                  <a:path w="984" h="15512">
                    <a:moveTo>
                      <a:pt x="0" y="56"/>
                    </a:moveTo>
                    <a:cubicBezTo>
                      <a:pt x="0" y="26"/>
                      <a:pt x="26" y="0"/>
                      <a:pt x="56" y="0"/>
                    </a:cubicBezTo>
                    <a:lnTo>
                      <a:pt x="928" y="0"/>
                    </a:lnTo>
                    <a:cubicBezTo>
                      <a:pt x="959" y="0"/>
                      <a:pt x="984" y="26"/>
                      <a:pt x="984" y="56"/>
                    </a:cubicBezTo>
                    <a:lnTo>
                      <a:pt x="984" y="15456"/>
                    </a:lnTo>
                    <a:cubicBezTo>
                      <a:pt x="984" y="15487"/>
                      <a:pt x="959" y="15512"/>
                      <a:pt x="928" y="15512"/>
                    </a:cubicBezTo>
                    <a:lnTo>
                      <a:pt x="56" y="15512"/>
                    </a:lnTo>
                    <a:cubicBezTo>
                      <a:pt x="26" y="15512"/>
                      <a:pt x="0" y="15487"/>
                      <a:pt x="0" y="15456"/>
                    </a:cubicBezTo>
                    <a:lnTo>
                      <a:pt x="0" y="56"/>
                    </a:lnTo>
                    <a:close/>
                    <a:moveTo>
                      <a:pt x="112" y="15456"/>
                    </a:moveTo>
                    <a:lnTo>
                      <a:pt x="56" y="15400"/>
                    </a:lnTo>
                    <a:lnTo>
                      <a:pt x="928" y="15400"/>
                    </a:lnTo>
                    <a:lnTo>
                      <a:pt x="872" y="15456"/>
                    </a:lnTo>
                    <a:lnTo>
                      <a:pt x="872" y="56"/>
                    </a:lnTo>
                    <a:lnTo>
                      <a:pt x="928" y="112"/>
                    </a:lnTo>
                    <a:lnTo>
                      <a:pt x="56" y="112"/>
                    </a:lnTo>
                    <a:lnTo>
                      <a:pt x="112" y="56"/>
                    </a:lnTo>
                    <a:lnTo>
                      <a:pt x="112" y="15456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53" name="Rectangle 629"/>
              <p:cNvSpPr>
                <a:spLocks noChangeArrowheads="1"/>
              </p:cNvSpPr>
              <p:nvPr/>
            </p:nvSpPr>
            <p:spPr bwMode="auto">
              <a:xfrm>
                <a:off x="1445788" y="3666913"/>
                <a:ext cx="41821" cy="348929"/>
              </a:xfrm>
              <a:prstGeom prst="rect">
                <a:avLst/>
              </a:prstGeom>
              <a:solidFill>
                <a:srgbClr val="9999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54" name="Freeform 630"/>
              <p:cNvSpPr>
                <a:spLocks noEditPoints="1"/>
              </p:cNvSpPr>
              <p:nvPr/>
            </p:nvSpPr>
            <p:spPr bwMode="auto">
              <a:xfrm>
                <a:off x="1442801" y="3664115"/>
                <a:ext cx="47795" cy="353594"/>
              </a:xfrm>
              <a:custGeom>
                <a:avLst/>
                <a:gdLst/>
                <a:ahLst/>
                <a:cxnLst>
                  <a:cxn ang="0">
                    <a:pos x="0" y="56"/>
                  </a:cxn>
                  <a:cxn ang="0">
                    <a:pos x="56" y="0"/>
                  </a:cxn>
                  <a:cxn ang="0">
                    <a:pos x="928" y="0"/>
                  </a:cxn>
                  <a:cxn ang="0">
                    <a:pos x="984" y="56"/>
                  </a:cxn>
                  <a:cxn ang="0">
                    <a:pos x="984" y="8576"/>
                  </a:cxn>
                  <a:cxn ang="0">
                    <a:pos x="928" y="8632"/>
                  </a:cxn>
                  <a:cxn ang="0">
                    <a:pos x="56" y="8632"/>
                  </a:cxn>
                  <a:cxn ang="0">
                    <a:pos x="0" y="8576"/>
                  </a:cxn>
                  <a:cxn ang="0">
                    <a:pos x="0" y="56"/>
                  </a:cxn>
                  <a:cxn ang="0">
                    <a:pos x="112" y="8576"/>
                  </a:cxn>
                  <a:cxn ang="0">
                    <a:pos x="56" y="8520"/>
                  </a:cxn>
                  <a:cxn ang="0">
                    <a:pos x="928" y="8520"/>
                  </a:cxn>
                  <a:cxn ang="0">
                    <a:pos x="872" y="8576"/>
                  </a:cxn>
                  <a:cxn ang="0">
                    <a:pos x="872" y="56"/>
                  </a:cxn>
                  <a:cxn ang="0">
                    <a:pos x="928" y="112"/>
                  </a:cxn>
                  <a:cxn ang="0">
                    <a:pos x="56" y="112"/>
                  </a:cxn>
                  <a:cxn ang="0">
                    <a:pos x="112" y="56"/>
                  </a:cxn>
                  <a:cxn ang="0">
                    <a:pos x="112" y="8576"/>
                  </a:cxn>
                </a:cxnLst>
                <a:rect l="0" t="0" r="r" b="b"/>
                <a:pathLst>
                  <a:path w="984" h="8632">
                    <a:moveTo>
                      <a:pt x="0" y="56"/>
                    </a:moveTo>
                    <a:cubicBezTo>
                      <a:pt x="0" y="26"/>
                      <a:pt x="26" y="0"/>
                      <a:pt x="56" y="0"/>
                    </a:cubicBezTo>
                    <a:lnTo>
                      <a:pt x="928" y="0"/>
                    </a:lnTo>
                    <a:cubicBezTo>
                      <a:pt x="959" y="0"/>
                      <a:pt x="984" y="26"/>
                      <a:pt x="984" y="56"/>
                    </a:cubicBezTo>
                    <a:lnTo>
                      <a:pt x="984" y="8576"/>
                    </a:lnTo>
                    <a:cubicBezTo>
                      <a:pt x="984" y="8607"/>
                      <a:pt x="959" y="8632"/>
                      <a:pt x="928" y="8632"/>
                    </a:cubicBezTo>
                    <a:lnTo>
                      <a:pt x="56" y="8632"/>
                    </a:lnTo>
                    <a:cubicBezTo>
                      <a:pt x="26" y="8632"/>
                      <a:pt x="0" y="8607"/>
                      <a:pt x="0" y="8576"/>
                    </a:cubicBezTo>
                    <a:lnTo>
                      <a:pt x="0" y="56"/>
                    </a:lnTo>
                    <a:close/>
                    <a:moveTo>
                      <a:pt x="112" y="8576"/>
                    </a:moveTo>
                    <a:lnTo>
                      <a:pt x="56" y="8520"/>
                    </a:lnTo>
                    <a:lnTo>
                      <a:pt x="928" y="8520"/>
                    </a:lnTo>
                    <a:lnTo>
                      <a:pt x="872" y="8576"/>
                    </a:lnTo>
                    <a:lnTo>
                      <a:pt x="872" y="56"/>
                    </a:lnTo>
                    <a:lnTo>
                      <a:pt x="928" y="112"/>
                    </a:lnTo>
                    <a:lnTo>
                      <a:pt x="56" y="112"/>
                    </a:lnTo>
                    <a:lnTo>
                      <a:pt x="112" y="56"/>
                    </a:lnTo>
                    <a:lnTo>
                      <a:pt x="112" y="8576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55" name="Rectangle 631"/>
              <p:cNvSpPr>
                <a:spLocks noChangeArrowheads="1"/>
              </p:cNvSpPr>
              <p:nvPr/>
            </p:nvSpPr>
            <p:spPr bwMode="auto">
              <a:xfrm>
                <a:off x="1571250" y="3224688"/>
                <a:ext cx="41821" cy="791153"/>
              </a:xfrm>
              <a:prstGeom prst="rect">
                <a:avLst/>
              </a:prstGeom>
              <a:solidFill>
                <a:srgbClr val="9999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56" name="Freeform 632"/>
              <p:cNvSpPr>
                <a:spLocks noEditPoints="1"/>
              </p:cNvSpPr>
              <p:nvPr/>
            </p:nvSpPr>
            <p:spPr bwMode="auto">
              <a:xfrm>
                <a:off x="1569258" y="3222822"/>
                <a:ext cx="46800" cy="794885"/>
              </a:xfrm>
              <a:custGeom>
                <a:avLst/>
                <a:gdLst/>
                <a:ahLst/>
                <a:cxnLst>
                  <a:cxn ang="0">
                    <a:pos x="0" y="56"/>
                  </a:cxn>
                  <a:cxn ang="0">
                    <a:pos x="56" y="0"/>
                  </a:cxn>
                  <a:cxn ang="0">
                    <a:pos x="928" y="0"/>
                  </a:cxn>
                  <a:cxn ang="0">
                    <a:pos x="984" y="56"/>
                  </a:cxn>
                  <a:cxn ang="0">
                    <a:pos x="984" y="19360"/>
                  </a:cxn>
                  <a:cxn ang="0">
                    <a:pos x="928" y="19416"/>
                  </a:cxn>
                  <a:cxn ang="0">
                    <a:pos x="56" y="19416"/>
                  </a:cxn>
                  <a:cxn ang="0">
                    <a:pos x="0" y="19360"/>
                  </a:cxn>
                  <a:cxn ang="0">
                    <a:pos x="0" y="56"/>
                  </a:cxn>
                  <a:cxn ang="0">
                    <a:pos x="112" y="19360"/>
                  </a:cxn>
                  <a:cxn ang="0">
                    <a:pos x="56" y="19304"/>
                  </a:cxn>
                  <a:cxn ang="0">
                    <a:pos x="928" y="19304"/>
                  </a:cxn>
                  <a:cxn ang="0">
                    <a:pos x="872" y="19360"/>
                  </a:cxn>
                  <a:cxn ang="0">
                    <a:pos x="872" y="56"/>
                  </a:cxn>
                  <a:cxn ang="0">
                    <a:pos x="928" y="112"/>
                  </a:cxn>
                  <a:cxn ang="0">
                    <a:pos x="56" y="112"/>
                  </a:cxn>
                  <a:cxn ang="0">
                    <a:pos x="112" y="56"/>
                  </a:cxn>
                  <a:cxn ang="0">
                    <a:pos x="112" y="19360"/>
                  </a:cxn>
                </a:cxnLst>
                <a:rect l="0" t="0" r="r" b="b"/>
                <a:pathLst>
                  <a:path w="984" h="19416">
                    <a:moveTo>
                      <a:pt x="0" y="56"/>
                    </a:moveTo>
                    <a:cubicBezTo>
                      <a:pt x="0" y="26"/>
                      <a:pt x="26" y="0"/>
                      <a:pt x="56" y="0"/>
                    </a:cubicBezTo>
                    <a:lnTo>
                      <a:pt x="928" y="0"/>
                    </a:lnTo>
                    <a:cubicBezTo>
                      <a:pt x="959" y="0"/>
                      <a:pt x="984" y="26"/>
                      <a:pt x="984" y="56"/>
                    </a:cubicBezTo>
                    <a:lnTo>
                      <a:pt x="984" y="19360"/>
                    </a:lnTo>
                    <a:cubicBezTo>
                      <a:pt x="984" y="19391"/>
                      <a:pt x="959" y="19416"/>
                      <a:pt x="928" y="19416"/>
                    </a:cubicBezTo>
                    <a:lnTo>
                      <a:pt x="56" y="19416"/>
                    </a:lnTo>
                    <a:cubicBezTo>
                      <a:pt x="26" y="19416"/>
                      <a:pt x="0" y="19391"/>
                      <a:pt x="0" y="19360"/>
                    </a:cubicBezTo>
                    <a:lnTo>
                      <a:pt x="0" y="56"/>
                    </a:lnTo>
                    <a:close/>
                    <a:moveTo>
                      <a:pt x="112" y="19360"/>
                    </a:moveTo>
                    <a:lnTo>
                      <a:pt x="56" y="19304"/>
                    </a:lnTo>
                    <a:lnTo>
                      <a:pt x="928" y="19304"/>
                    </a:lnTo>
                    <a:lnTo>
                      <a:pt x="872" y="19360"/>
                    </a:lnTo>
                    <a:lnTo>
                      <a:pt x="872" y="56"/>
                    </a:lnTo>
                    <a:lnTo>
                      <a:pt x="928" y="112"/>
                    </a:lnTo>
                    <a:lnTo>
                      <a:pt x="56" y="112"/>
                    </a:lnTo>
                    <a:lnTo>
                      <a:pt x="112" y="56"/>
                    </a:lnTo>
                    <a:lnTo>
                      <a:pt x="112" y="19360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57" name="Rectangle 633"/>
              <p:cNvSpPr>
                <a:spLocks noChangeArrowheads="1"/>
              </p:cNvSpPr>
              <p:nvPr/>
            </p:nvSpPr>
            <p:spPr bwMode="auto">
              <a:xfrm>
                <a:off x="1696712" y="3611869"/>
                <a:ext cx="42817" cy="403974"/>
              </a:xfrm>
              <a:prstGeom prst="rect">
                <a:avLst/>
              </a:prstGeom>
              <a:solidFill>
                <a:srgbClr val="9999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58" name="Freeform 634"/>
              <p:cNvSpPr>
                <a:spLocks noEditPoints="1"/>
              </p:cNvSpPr>
              <p:nvPr/>
            </p:nvSpPr>
            <p:spPr bwMode="auto">
              <a:xfrm>
                <a:off x="1694721" y="3610003"/>
                <a:ext cx="46800" cy="407706"/>
              </a:xfrm>
              <a:custGeom>
                <a:avLst/>
                <a:gdLst/>
                <a:ahLst/>
                <a:cxnLst>
                  <a:cxn ang="0">
                    <a:pos x="0" y="56"/>
                  </a:cxn>
                  <a:cxn ang="0">
                    <a:pos x="56" y="0"/>
                  </a:cxn>
                  <a:cxn ang="0">
                    <a:pos x="936" y="0"/>
                  </a:cxn>
                  <a:cxn ang="0">
                    <a:pos x="992" y="56"/>
                  </a:cxn>
                  <a:cxn ang="0">
                    <a:pos x="992" y="9912"/>
                  </a:cxn>
                  <a:cxn ang="0">
                    <a:pos x="936" y="9968"/>
                  </a:cxn>
                  <a:cxn ang="0">
                    <a:pos x="56" y="9968"/>
                  </a:cxn>
                  <a:cxn ang="0">
                    <a:pos x="0" y="9912"/>
                  </a:cxn>
                  <a:cxn ang="0">
                    <a:pos x="0" y="56"/>
                  </a:cxn>
                  <a:cxn ang="0">
                    <a:pos x="112" y="9912"/>
                  </a:cxn>
                  <a:cxn ang="0">
                    <a:pos x="56" y="9856"/>
                  </a:cxn>
                  <a:cxn ang="0">
                    <a:pos x="936" y="9856"/>
                  </a:cxn>
                  <a:cxn ang="0">
                    <a:pos x="880" y="9912"/>
                  </a:cxn>
                  <a:cxn ang="0">
                    <a:pos x="880" y="56"/>
                  </a:cxn>
                  <a:cxn ang="0">
                    <a:pos x="936" y="112"/>
                  </a:cxn>
                  <a:cxn ang="0">
                    <a:pos x="56" y="112"/>
                  </a:cxn>
                  <a:cxn ang="0">
                    <a:pos x="112" y="56"/>
                  </a:cxn>
                  <a:cxn ang="0">
                    <a:pos x="112" y="9912"/>
                  </a:cxn>
                </a:cxnLst>
                <a:rect l="0" t="0" r="r" b="b"/>
                <a:pathLst>
                  <a:path w="992" h="9968">
                    <a:moveTo>
                      <a:pt x="0" y="56"/>
                    </a:moveTo>
                    <a:cubicBezTo>
                      <a:pt x="0" y="26"/>
                      <a:pt x="26" y="0"/>
                      <a:pt x="56" y="0"/>
                    </a:cubicBezTo>
                    <a:lnTo>
                      <a:pt x="936" y="0"/>
                    </a:lnTo>
                    <a:cubicBezTo>
                      <a:pt x="967" y="0"/>
                      <a:pt x="992" y="26"/>
                      <a:pt x="992" y="56"/>
                    </a:cubicBezTo>
                    <a:lnTo>
                      <a:pt x="992" y="9912"/>
                    </a:lnTo>
                    <a:cubicBezTo>
                      <a:pt x="992" y="9943"/>
                      <a:pt x="967" y="9968"/>
                      <a:pt x="936" y="9968"/>
                    </a:cubicBezTo>
                    <a:lnTo>
                      <a:pt x="56" y="9968"/>
                    </a:lnTo>
                    <a:cubicBezTo>
                      <a:pt x="26" y="9968"/>
                      <a:pt x="0" y="9943"/>
                      <a:pt x="0" y="9912"/>
                    </a:cubicBezTo>
                    <a:lnTo>
                      <a:pt x="0" y="56"/>
                    </a:lnTo>
                    <a:close/>
                    <a:moveTo>
                      <a:pt x="112" y="9912"/>
                    </a:moveTo>
                    <a:lnTo>
                      <a:pt x="56" y="9856"/>
                    </a:lnTo>
                    <a:lnTo>
                      <a:pt x="936" y="9856"/>
                    </a:lnTo>
                    <a:lnTo>
                      <a:pt x="880" y="9912"/>
                    </a:lnTo>
                    <a:lnTo>
                      <a:pt x="880" y="56"/>
                    </a:lnTo>
                    <a:lnTo>
                      <a:pt x="936" y="112"/>
                    </a:lnTo>
                    <a:lnTo>
                      <a:pt x="56" y="112"/>
                    </a:lnTo>
                    <a:lnTo>
                      <a:pt x="112" y="56"/>
                    </a:lnTo>
                    <a:lnTo>
                      <a:pt x="112" y="9912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59" name="Rectangle 635"/>
              <p:cNvSpPr>
                <a:spLocks noChangeArrowheads="1"/>
              </p:cNvSpPr>
              <p:nvPr/>
            </p:nvSpPr>
            <p:spPr bwMode="auto">
              <a:xfrm>
                <a:off x="1823171" y="3568952"/>
                <a:ext cx="41821" cy="446890"/>
              </a:xfrm>
              <a:prstGeom prst="rect">
                <a:avLst/>
              </a:prstGeom>
              <a:solidFill>
                <a:srgbClr val="9999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60" name="Freeform 636"/>
              <p:cNvSpPr>
                <a:spLocks noEditPoints="1"/>
              </p:cNvSpPr>
              <p:nvPr/>
            </p:nvSpPr>
            <p:spPr bwMode="auto">
              <a:xfrm>
                <a:off x="1820183" y="3566153"/>
                <a:ext cx="46800" cy="451555"/>
              </a:xfrm>
              <a:custGeom>
                <a:avLst/>
                <a:gdLst/>
                <a:ahLst/>
                <a:cxnLst>
                  <a:cxn ang="0">
                    <a:pos x="0" y="28"/>
                  </a:cxn>
                  <a:cxn ang="0">
                    <a:pos x="28" y="0"/>
                  </a:cxn>
                  <a:cxn ang="0">
                    <a:pos x="464" y="0"/>
                  </a:cxn>
                  <a:cxn ang="0">
                    <a:pos x="492" y="28"/>
                  </a:cxn>
                  <a:cxn ang="0">
                    <a:pos x="492" y="5484"/>
                  </a:cxn>
                  <a:cxn ang="0">
                    <a:pos x="464" y="5512"/>
                  </a:cxn>
                  <a:cxn ang="0">
                    <a:pos x="28" y="5512"/>
                  </a:cxn>
                  <a:cxn ang="0">
                    <a:pos x="0" y="5484"/>
                  </a:cxn>
                  <a:cxn ang="0">
                    <a:pos x="0" y="28"/>
                  </a:cxn>
                  <a:cxn ang="0">
                    <a:pos x="56" y="5484"/>
                  </a:cxn>
                  <a:cxn ang="0">
                    <a:pos x="28" y="5456"/>
                  </a:cxn>
                  <a:cxn ang="0">
                    <a:pos x="464" y="5456"/>
                  </a:cxn>
                  <a:cxn ang="0">
                    <a:pos x="436" y="5484"/>
                  </a:cxn>
                  <a:cxn ang="0">
                    <a:pos x="436" y="28"/>
                  </a:cxn>
                  <a:cxn ang="0">
                    <a:pos x="464" y="56"/>
                  </a:cxn>
                  <a:cxn ang="0">
                    <a:pos x="28" y="56"/>
                  </a:cxn>
                  <a:cxn ang="0">
                    <a:pos x="56" y="28"/>
                  </a:cxn>
                  <a:cxn ang="0">
                    <a:pos x="56" y="5484"/>
                  </a:cxn>
                </a:cxnLst>
                <a:rect l="0" t="0" r="r" b="b"/>
                <a:pathLst>
                  <a:path w="492" h="5512">
                    <a:moveTo>
                      <a:pt x="0" y="28"/>
                    </a:moveTo>
                    <a:cubicBezTo>
                      <a:pt x="0" y="13"/>
                      <a:pt x="13" y="0"/>
                      <a:pt x="28" y="0"/>
                    </a:cubicBezTo>
                    <a:lnTo>
                      <a:pt x="464" y="0"/>
                    </a:lnTo>
                    <a:cubicBezTo>
                      <a:pt x="480" y="0"/>
                      <a:pt x="492" y="13"/>
                      <a:pt x="492" y="28"/>
                    </a:cubicBezTo>
                    <a:lnTo>
                      <a:pt x="492" y="5484"/>
                    </a:lnTo>
                    <a:cubicBezTo>
                      <a:pt x="492" y="5500"/>
                      <a:pt x="480" y="5512"/>
                      <a:pt x="464" y="5512"/>
                    </a:cubicBezTo>
                    <a:lnTo>
                      <a:pt x="28" y="5512"/>
                    </a:lnTo>
                    <a:cubicBezTo>
                      <a:pt x="13" y="5512"/>
                      <a:pt x="0" y="5500"/>
                      <a:pt x="0" y="5484"/>
                    </a:cubicBezTo>
                    <a:lnTo>
                      <a:pt x="0" y="28"/>
                    </a:lnTo>
                    <a:close/>
                    <a:moveTo>
                      <a:pt x="56" y="5484"/>
                    </a:moveTo>
                    <a:lnTo>
                      <a:pt x="28" y="5456"/>
                    </a:lnTo>
                    <a:lnTo>
                      <a:pt x="464" y="5456"/>
                    </a:lnTo>
                    <a:lnTo>
                      <a:pt x="436" y="5484"/>
                    </a:lnTo>
                    <a:lnTo>
                      <a:pt x="436" y="28"/>
                    </a:lnTo>
                    <a:lnTo>
                      <a:pt x="464" y="56"/>
                    </a:lnTo>
                    <a:lnTo>
                      <a:pt x="28" y="56"/>
                    </a:lnTo>
                    <a:lnTo>
                      <a:pt x="56" y="28"/>
                    </a:lnTo>
                    <a:lnTo>
                      <a:pt x="56" y="5484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61" name="Rectangle 637"/>
              <p:cNvSpPr>
                <a:spLocks noChangeArrowheads="1"/>
              </p:cNvSpPr>
              <p:nvPr/>
            </p:nvSpPr>
            <p:spPr bwMode="auto">
              <a:xfrm>
                <a:off x="1948633" y="3506443"/>
                <a:ext cx="41821" cy="509398"/>
              </a:xfrm>
              <a:prstGeom prst="rect">
                <a:avLst/>
              </a:prstGeom>
              <a:solidFill>
                <a:srgbClr val="9999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62" name="Freeform 638"/>
              <p:cNvSpPr>
                <a:spLocks noEditPoints="1"/>
              </p:cNvSpPr>
              <p:nvPr/>
            </p:nvSpPr>
            <p:spPr bwMode="auto">
              <a:xfrm>
                <a:off x="1945645" y="3504577"/>
                <a:ext cx="47795" cy="513130"/>
              </a:xfrm>
              <a:custGeom>
                <a:avLst/>
                <a:gdLst/>
                <a:ahLst/>
                <a:cxnLst>
                  <a:cxn ang="0">
                    <a:pos x="0" y="28"/>
                  </a:cxn>
                  <a:cxn ang="0">
                    <a:pos x="28" y="0"/>
                  </a:cxn>
                  <a:cxn ang="0">
                    <a:pos x="468" y="0"/>
                  </a:cxn>
                  <a:cxn ang="0">
                    <a:pos x="496" y="28"/>
                  </a:cxn>
                  <a:cxn ang="0">
                    <a:pos x="496" y="6244"/>
                  </a:cxn>
                  <a:cxn ang="0">
                    <a:pos x="468" y="6272"/>
                  </a:cxn>
                  <a:cxn ang="0">
                    <a:pos x="28" y="6272"/>
                  </a:cxn>
                  <a:cxn ang="0">
                    <a:pos x="0" y="6244"/>
                  </a:cxn>
                  <a:cxn ang="0">
                    <a:pos x="0" y="28"/>
                  </a:cxn>
                  <a:cxn ang="0">
                    <a:pos x="56" y="6244"/>
                  </a:cxn>
                  <a:cxn ang="0">
                    <a:pos x="28" y="6216"/>
                  </a:cxn>
                  <a:cxn ang="0">
                    <a:pos x="468" y="6216"/>
                  </a:cxn>
                  <a:cxn ang="0">
                    <a:pos x="440" y="6244"/>
                  </a:cxn>
                  <a:cxn ang="0">
                    <a:pos x="440" y="28"/>
                  </a:cxn>
                  <a:cxn ang="0">
                    <a:pos x="468" y="56"/>
                  </a:cxn>
                  <a:cxn ang="0">
                    <a:pos x="28" y="56"/>
                  </a:cxn>
                  <a:cxn ang="0">
                    <a:pos x="56" y="28"/>
                  </a:cxn>
                  <a:cxn ang="0">
                    <a:pos x="56" y="6244"/>
                  </a:cxn>
                </a:cxnLst>
                <a:rect l="0" t="0" r="r" b="b"/>
                <a:pathLst>
                  <a:path w="496" h="6272">
                    <a:moveTo>
                      <a:pt x="0" y="28"/>
                    </a:moveTo>
                    <a:cubicBezTo>
                      <a:pt x="0" y="13"/>
                      <a:pt x="13" y="0"/>
                      <a:pt x="28" y="0"/>
                    </a:cubicBezTo>
                    <a:lnTo>
                      <a:pt x="468" y="0"/>
                    </a:lnTo>
                    <a:cubicBezTo>
                      <a:pt x="484" y="0"/>
                      <a:pt x="496" y="13"/>
                      <a:pt x="496" y="28"/>
                    </a:cubicBezTo>
                    <a:lnTo>
                      <a:pt x="496" y="6244"/>
                    </a:lnTo>
                    <a:cubicBezTo>
                      <a:pt x="496" y="6260"/>
                      <a:pt x="484" y="6272"/>
                      <a:pt x="468" y="6272"/>
                    </a:cubicBezTo>
                    <a:lnTo>
                      <a:pt x="28" y="6272"/>
                    </a:lnTo>
                    <a:cubicBezTo>
                      <a:pt x="13" y="6272"/>
                      <a:pt x="0" y="6260"/>
                      <a:pt x="0" y="6244"/>
                    </a:cubicBezTo>
                    <a:lnTo>
                      <a:pt x="0" y="28"/>
                    </a:lnTo>
                    <a:close/>
                    <a:moveTo>
                      <a:pt x="56" y="6244"/>
                    </a:moveTo>
                    <a:lnTo>
                      <a:pt x="28" y="6216"/>
                    </a:lnTo>
                    <a:lnTo>
                      <a:pt x="468" y="6216"/>
                    </a:lnTo>
                    <a:lnTo>
                      <a:pt x="440" y="6244"/>
                    </a:lnTo>
                    <a:lnTo>
                      <a:pt x="440" y="28"/>
                    </a:lnTo>
                    <a:lnTo>
                      <a:pt x="468" y="56"/>
                    </a:lnTo>
                    <a:lnTo>
                      <a:pt x="28" y="56"/>
                    </a:lnTo>
                    <a:lnTo>
                      <a:pt x="56" y="28"/>
                    </a:lnTo>
                    <a:lnTo>
                      <a:pt x="56" y="6244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63" name="Rectangle 639"/>
              <p:cNvSpPr>
                <a:spLocks noChangeArrowheads="1"/>
              </p:cNvSpPr>
              <p:nvPr/>
            </p:nvSpPr>
            <p:spPr bwMode="auto">
              <a:xfrm>
                <a:off x="2074095" y="3479388"/>
                <a:ext cx="41821" cy="536455"/>
              </a:xfrm>
              <a:prstGeom prst="rect">
                <a:avLst/>
              </a:prstGeom>
              <a:solidFill>
                <a:srgbClr val="9999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64" name="Freeform 640"/>
              <p:cNvSpPr>
                <a:spLocks noEditPoints="1"/>
              </p:cNvSpPr>
              <p:nvPr/>
            </p:nvSpPr>
            <p:spPr bwMode="auto">
              <a:xfrm>
                <a:off x="2071108" y="3476589"/>
                <a:ext cx="47795" cy="541119"/>
              </a:xfrm>
              <a:custGeom>
                <a:avLst/>
                <a:gdLst/>
                <a:ahLst/>
                <a:cxnLst>
                  <a:cxn ang="0">
                    <a:pos x="0" y="28"/>
                  </a:cxn>
                  <a:cxn ang="0">
                    <a:pos x="28" y="0"/>
                  </a:cxn>
                  <a:cxn ang="0">
                    <a:pos x="464" y="0"/>
                  </a:cxn>
                  <a:cxn ang="0">
                    <a:pos x="492" y="28"/>
                  </a:cxn>
                  <a:cxn ang="0">
                    <a:pos x="492" y="6580"/>
                  </a:cxn>
                  <a:cxn ang="0">
                    <a:pos x="464" y="6608"/>
                  </a:cxn>
                  <a:cxn ang="0">
                    <a:pos x="28" y="6608"/>
                  </a:cxn>
                  <a:cxn ang="0">
                    <a:pos x="0" y="6580"/>
                  </a:cxn>
                  <a:cxn ang="0">
                    <a:pos x="0" y="28"/>
                  </a:cxn>
                  <a:cxn ang="0">
                    <a:pos x="56" y="6580"/>
                  </a:cxn>
                  <a:cxn ang="0">
                    <a:pos x="28" y="6552"/>
                  </a:cxn>
                  <a:cxn ang="0">
                    <a:pos x="464" y="6552"/>
                  </a:cxn>
                  <a:cxn ang="0">
                    <a:pos x="436" y="6580"/>
                  </a:cxn>
                  <a:cxn ang="0">
                    <a:pos x="436" y="28"/>
                  </a:cxn>
                  <a:cxn ang="0">
                    <a:pos x="464" y="56"/>
                  </a:cxn>
                  <a:cxn ang="0">
                    <a:pos x="28" y="56"/>
                  </a:cxn>
                  <a:cxn ang="0">
                    <a:pos x="56" y="28"/>
                  </a:cxn>
                  <a:cxn ang="0">
                    <a:pos x="56" y="6580"/>
                  </a:cxn>
                </a:cxnLst>
                <a:rect l="0" t="0" r="r" b="b"/>
                <a:pathLst>
                  <a:path w="492" h="6608">
                    <a:moveTo>
                      <a:pt x="0" y="28"/>
                    </a:moveTo>
                    <a:cubicBezTo>
                      <a:pt x="0" y="13"/>
                      <a:pt x="13" y="0"/>
                      <a:pt x="28" y="0"/>
                    </a:cubicBezTo>
                    <a:lnTo>
                      <a:pt x="464" y="0"/>
                    </a:lnTo>
                    <a:cubicBezTo>
                      <a:pt x="480" y="0"/>
                      <a:pt x="492" y="13"/>
                      <a:pt x="492" y="28"/>
                    </a:cubicBezTo>
                    <a:lnTo>
                      <a:pt x="492" y="6580"/>
                    </a:lnTo>
                    <a:cubicBezTo>
                      <a:pt x="492" y="6596"/>
                      <a:pt x="480" y="6608"/>
                      <a:pt x="464" y="6608"/>
                    </a:cubicBezTo>
                    <a:lnTo>
                      <a:pt x="28" y="6608"/>
                    </a:lnTo>
                    <a:cubicBezTo>
                      <a:pt x="13" y="6608"/>
                      <a:pt x="0" y="6596"/>
                      <a:pt x="0" y="6580"/>
                    </a:cubicBezTo>
                    <a:lnTo>
                      <a:pt x="0" y="28"/>
                    </a:lnTo>
                    <a:close/>
                    <a:moveTo>
                      <a:pt x="56" y="6580"/>
                    </a:moveTo>
                    <a:lnTo>
                      <a:pt x="28" y="6552"/>
                    </a:lnTo>
                    <a:lnTo>
                      <a:pt x="464" y="6552"/>
                    </a:lnTo>
                    <a:lnTo>
                      <a:pt x="436" y="6580"/>
                    </a:lnTo>
                    <a:lnTo>
                      <a:pt x="436" y="28"/>
                    </a:lnTo>
                    <a:lnTo>
                      <a:pt x="464" y="56"/>
                    </a:lnTo>
                    <a:lnTo>
                      <a:pt x="28" y="56"/>
                    </a:lnTo>
                    <a:lnTo>
                      <a:pt x="56" y="28"/>
                    </a:lnTo>
                    <a:lnTo>
                      <a:pt x="56" y="6580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65" name="Rectangle 641"/>
              <p:cNvSpPr>
                <a:spLocks noChangeArrowheads="1"/>
              </p:cNvSpPr>
              <p:nvPr/>
            </p:nvSpPr>
            <p:spPr bwMode="auto">
              <a:xfrm>
                <a:off x="2200553" y="3627729"/>
                <a:ext cx="41821" cy="388113"/>
              </a:xfrm>
              <a:prstGeom prst="rect">
                <a:avLst/>
              </a:prstGeom>
              <a:solidFill>
                <a:srgbClr val="9999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66" name="Freeform 642"/>
              <p:cNvSpPr>
                <a:spLocks noEditPoints="1"/>
              </p:cNvSpPr>
              <p:nvPr/>
            </p:nvSpPr>
            <p:spPr bwMode="auto">
              <a:xfrm>
                <a:off x="2197566" y="3624930"/>
                <a:ext cx="46800" cy="392778"/>
              </a:xfrm>
              <a:custGeom>
                <a:avLst/>
                <a:gdLst/>
                <a:ahLst/>
                <a:cxnLst>
                  <a:cxn ang="0">
                    <a:pos x="0" y="28"/>
                  </a:cxn>
                  <a:cxn ang="0">
                    <a:pos x="28" y="0"/>
                  </a:cxn>
                  <a:cxn ang="0">
                    <a:pos x="464" y="0"/>
                  </a:cxn>
                  <a:cxn ang="0">
                    <a:pos x="492" y="28"/>
                  </a:cxn>
                  <a:cxn ang="0">
                    <a:pos x="492" y="4768"/>
                  </a:cxn>
                  <a:cxn ang="0">
                    <a:pos x="464" y="4796"/>
                  </a:cxn>
                  <a:cxn ang="0">
                    <a:pos x="28" y="4796"/>
                  </a:cxn>
                  <a:cxn ang="0">
                    <a:pos x="0" y="4768"/>
                  </a:cxn>
                  <a:cxn ang="0">
                    <a:pos x="0" y="28"/>
                  </a:cxn>
                  <a:cxn ang="0">
                    <a:pos x="56" y="4768"/>
                  </a:cxn>
                  <a:cxn ang="0">
                    <a:pos x="28" y="4740"/>
                  </a:cxn>
                  <a:cxn ang="0">
                    <a:pos x="464" y="4740"/>
                  </a:cxn>
                  <a:cxn ang="0">
                    <a:pos x="436" y="4768"/>
                  </a:cxn>
                  <a:cxn ang="0">
                    <a:pos x="436" y="28"/>
                  </a:cxn>
                  <a:cxn ang="0">
                    <a:pos x="464" y="56"/>
                  </a:cxn>
                  <a:cxn ang="0">
                    <a:pos x="28" y="56"/>
                  </a:cxn>
                  <a:cxn ang="0">
                    <a:pos x="56" y="28"/>
                  </a:cxn>
                  <a:cxn ang="0">
                    <a:pos x="56" y="4768"/>
                  </a:cxn>
                </a:cxnLst>
                <a:rect l="0" t="0" r="r" b="b"/>
                <a:pathLst>
                  <a:path w="492" h="4796">
                    <a:moveTo>
                      <a:pt x="0" y="28"/>
                    </a:moveTo>
                    <a:cubicBezTo>
                      <a:pt x="0" y="13"/>
                      <a:pt x="13" y="0"/>
                      <a:pt x="28" y="0"/>
                    </a:cubicBezTo>
                    <a:lnTo>
                      <a:pt x="464" y="0"/>
                    </a:lnTo>
                    <a:cubicBezTo>
                      <a:pt x="480" y="0"/>
                      <a:pt x="492" y="13"/>
                      <a:pt x="492" y="28"/>
                    </a:cubicBezTo>
                    <a:lnTo>
                      <a:pt x="492" y="4768"/>
                    </a:lnTo>
                    <a:cubicBezTo>
                      <a:pt x="492" y="4784"/>
                      <a:pt x="480" y="4796"/>
                      <a:pt x="464" y="4796"/>
                    </a:cubicBezTo>
                    <a:lnTo>
                      <a:pt x="28" y="4796"/>
                    </a:lnTo>
                    <a:cubicBezTo>
                      <a:pt x="13" y="4796"/>
                      <a:pt x="0" y="4784"/>
                      <a:pt x="0" y="4768"/>
                    </a:cubicBezTo>
                    <a:lnTo>
                      <a:pt x="0" y="28"/>
                    </a:lnTo>
                    <a:close/>
                    <a:moveTo>
                      <a:pt x="56" y="4768"/>
                    </a:moveTo>
                    <a:lnTo>
                      <a:pt x="28" y="4740"/>
                    </a:lnTo>
                    <a:lnTo>
                      <a:pt x="464" y="4740"/>
                    </a:lnTo>
                    <a:lnTo>
                      <a:pt x="436" y="4768"/>
                    </a:lnTo>
                    <a:lnTo>
                      <a:pt x="436" y="28"/>
                    </a:lnTo>
                    <a:lnTo>
                      <a:pt x="464" y="56"/>
                    </a:lnTo>
                    <a:lnTo>
                      <a:pt x="28" y="56"/>
                    </a:lnTo>
                    <a:lnTo>
                      <a:pt x="56" y="28"/>
                    </a:lnTo>
                    <a:lnTo>
                      <a:pt x="56" y="4768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67" name="Rectangle 643"/>
              <p:cNvSpPr>
                <a:spLocks noChangeArrowheads="1"/>
              </p:cNvSpPr>
              <p:nvPr/>
            </p:nvSpPr>
            <p:spPr bwMode="auto">
              <a:xfrm>
                <a:off x="2326015" y="3437404"/>
                <a:ext cx="41821" cy="578438"/>
              </a:xfrm>
              <a:prstGeom prst="rect">
                <a:avLst/>
              </a:prstGeom>
              <a:solidFill>
                <a:srgbClr val="9999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68" name="Freeform 644"/>
              <p:cNvSpPr>
                <a:spLocks noEditPoints="1"/>
              </p:cNvSpPr>
              <p:nvPr/>
            </p:nvSpPr>
            <p:spPr bwMode="auto">
              <a:xfrm>
                <a:off x="2323028" y="3434605"/>
                <a:ext cx="46800" cy="583103"/>
              </a:xfrm>
              <a:custGeom>
                <a:avLst/>
                <a:gdLst/>
                <a:ahLst/>
                <a:cxnLst>
                  <a:cxn ang="0">
                    <a:pos x="0" y="28"/>
                  </a:cxn>
                  <a:cxn ang="0">
                    <a:pos x="28" y="0"/>
                  </a:cxn>
                  <a:cxn ang="0">
                    <a:pos x="464" y="0"/>
                  </a:cxn>
                  <a:cxn ang="0">
                    <a:pos x="492" y="28"/>
                  </a:cxn>
                  <a:cxn ang="0">
                    <a:pos x="492" y="7088"/>
                  </a:cxn>
                  <a:cxn ang="0">
                    <a:pos x="464" y="7116"/>
                  </a:cxn>
                  <a:cxn ang="0">
                    <a:pos x="28" y="7116"/>
                  </a:cxn>
                  <a:cxn ang="0">
                    <a:pos x="0" y="7088"/>
                  </a:cxn>
                  <a:cxn ang="0">
                    <a:pos x="0" y="28"/>
                  </a:cxn>
                  <a:cxn ang="0">
                    <a:pos x="56" y="7088"/>
                  </a:cxn>
                  <a:cxn ang="0">
                    <a:pos x="28" y="7060"/>
                  </a:cxn>
                  <a:cxn ang="0">
                    <a:pos x="464" y="7060"/>
                  </a:cxn>
                  <a:cxn ang="0">
                    <a:pos x="436" y="7088"/>
                  </a:cxn>
                  <a:cxn ang="0">
                    <a:pos x="436" y="28"/>
                  </a:cxn>
                  <a:cxn ang="0">
                    <a:pos x="464" y="56"/>
                  </a:cxn>
                  <a:cxn ang="0">
                    <a:pos x="28" y="56"/>
                  </a:cxn>
                  <a:cxn ang="0">
                    <a:pos x="56" y="28"/>
                  </a:cxn>
                  <a:cxn ang="0">
                    <a:pos x="56" y="7088"/>
                  </a:cxn>
                </a:cxnLst>
                <a:rect l="0" t="0" r="r" b="b"/>
                <a:pathLst>
                  <a:path w="492" h="7116">
                    <a:moveTo>
                      <a:pt x="0" y="28"/>
                    </a:moveTo>
                    <a:cubicBezTo>
                      <a:pt x="0" y="13"/>
                      <a:pt x="13" y="0"/>
                      <a:pt x="28" y="0"/>
                    </a:cubicBezTo>
                    <a:lnTo>
                      <a:pt x="464" y="0"/>
                    </a:lnTo>
                    <a:cubicBezTo>
                      <a:pt x="480" y="0"/>
                      <a:pt x="492" y="13"/>
                      <a:pt x="492" y="28"/>
                    </a:cubicBezTo>
                    <a:lnTo>
                      <a:pt x="492" y="7088"/>
                    </a:lnTo>
                    <a:cubicBezTo>
                      <a:pt x="492" y="7104"/>
                      <a:pt x="480" y="7116"/>
                      <a:pt x="464" y="7116"/>
                    </a:cubicBezTo>
                    <a:lnTo>
                      <a:pt x="28" y="7116"/>
                    </a:lnTo>
                    <a:cubicBezTo>
                      <a:pt x="13" y="7116"/>
                      <a:pt x="0" y="7104"/>
                      <a:pt x="0" y="7088"/>
                    </a:cubicBezTo>
                    <a:lnTo>
                      <a:pt x="0" y="28"/>
                    </a:lnTo>
                    <a:close/>
                    <a:moveTo>
                      <a:pt x="56" y="7088"/>
                    </a:moveTo>
                    <a:lnTo>
                      <a:pt x="28" y="7060"/>
                    </a:lnTo>
                    <a:lnTo>
                      <a:pt x="464" y="7060"/>
                    </a:lnTo>
                    <a:lnTo>
                      <a:pt x="436" y="7088"/>
                    </a:lnTo>
                    <a:lnTo>
                      <a:pt x="436" y="28"/>
                    </a:lnTo>
                    <a:lnTo>
                      <a:pt x="464" y="56"/>
                    </a:lnTo>
                    <a:lnTo>
                      <a:pt x="28" y="56"/>
                    </a:lnTo>
                    <a:lnTo>
                      <a:pt x="56" y="28"/>
                    </a:lnTo>
                    <a:lnTo>
                      <a:pt x="56" y="7088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69" name="Rectangle 645"/>
              <p:cNvSpPr>
                <a:spLocks noChangeArrowheads="1"/>
              </p:cNvSpPr>
              <p:nvPr/>
            </p:nvSpPr>
            <p:spPr bwMode="auto">
              <a:xfrm>
                <a:off x="2451478" y="3681841"/>
                <a:ext cx="41821" cy="334001"/>
              </a:xfrm>
              <a:prstGeom prst="rect">
                <a:avLst/>
              </a:prstGeom>
              <a:solidFill>
                <a:srgbClr val="9999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70" name="Freeform 646"/>
              <p:cNvSpPr>
                <a:spLocks noEditPoints="1"/>
              </p:cNvSpPr>
              <p:nvPr/>
            </p:nvSpPr>
            <p:spPr bwMode="auto">
              <a:xfrm>
                <a:off x="2448491" y="3679042"/>
                <a:ext cx="47795" cy="338666"/>
              </a:xfrm>
              <a:custGeom>
                <a:avLst/>
                <a:gdLst/>
                <a:ahLst/>
                <a:cxnLst>
                  <a:cxn ang="0">
                    <a:pos x="0" y="28"/>
                  </a:cxn>
                  <a:cxn ang="0">
                    <a:pos x="28" y="0"/>
                  </a:cxn>
                  <a:cxn ang="0">
                    <a:pos x="464" y="0"/>
                  </a:cxn>
                  <a:cxn ang="0">
                    <a:pos x="492" y="28"/>
                  </a:cxn>
                  <a:cxn ang="0">
                    <a:pos x="492" y="4108"/>
                  </a:cxn>
                  <a:cxn ang="0">
                    <a:pos x="464" y="4136"/>
                  </a:cxn>
                  <a:cxn ang="0">
                    <a:pos x="28" y="4136"/>
                  </a:cxn>
                  <a:cxn ang="0">
                    <a:pos x="0" y="4108"/>
                  </a:cxn>
                  <a:cxn ang="0">
                    <a:pos x="0" y="28"/>
                  </a:cxn>
                  <a:cxn ang="0">
                    <a:pos x="56" y="4108"/>
                  </a:cxn>
                  <a:cxn ang="0">
                    <a:pos x="28" y="4080"/>
                  </a:cxn>
                  <a:cxn ang="0">
                    <a:pos x="464" y="4080"/>
                  </a:cxn>
                  <a:cxn ang="0">
                    <a:pos x="436" y="4108"/>
                  </a:cxn>
                  <a:cxn ang="0">
                    <a:pos x="436" y="28"/>
                  </a:cxn>
                  <a:cxn ang="0">
                    <a:pos x="464" y="56"/>
                  </a:cxn>
                  <a:cxn ang="0">
                    <a:pos x="28" y="56"/>
                  </a:cxn>
                  <a:cxn ang="0">
                    <a:pos x="56" y="28"/>
                  </a:cxn>
                  <a:cxn ang="0">
                    <a:pos x="56" y="4108"/>
                  </a:cxn>
                </a:cxnLst>
                <a:rect l="0" t="0" r="r" b="b"/>
                <a:pathLst>
                  <a:path w="492" h="4136">
                    <a:moveTo>
                      <a:pt x="0" y="28"/>
                    </a:moveTo>
                    <a:cubicBezTo>
                      <a:pt x="0" y="13"/>
                      <a:pt x="13" y="0"/>
                      <a:pt x="28" y="0"/>
                    </a:cubicBezTo>
                    <a:lnTo>
                      <a:pt x="464" y="0"/>
                    </a:lnTo>
                    <a:cubicBezTo>
                      <a:pt x="480" y="0"/>
                      <a:pt x="492" y="13"/>
                      <a:pt x="492" y="28"/>
                    </a:cubicBezTo>
                    <a:lnTo>
                      <a:pt x="492" y="4108"/>
                    </a:lnTo>
                    <a:cubicBezTo>
                      <a:pt x="492" y="4124"/>
                      <a:pt x="480" y="4136"/>
                      <a:pt x="464" y="4136"/>
                    </a:cubicBezTo>
                    <a:lnTo>
                      <a:pt x="28" y="4136"/>
                    </a:lnTo>
                    <a:cubicBezTo>
                      <a:pt x="13" y="4136"/>
                      <a:pt x="0" y="4124"/>
                      <a:pt x="0" y="4108"/>
                    </a:cubicBezTo>
                    <a:lnTo>
                      <a:pt x="0" y="28"/>
                    </a:lnTo>
                    <a:close/>
                    <a:moveTo>
                      <a:pt x="56" y="4108"/>
                    </a:moveTo>
                    <a:lnTo>
                      <a:pt x="28" y="4080"/>
                    </a:lnTo>
                    <a:lnTo>
                      <a:pt x="464" y="4080"/>
                    </a:lnTo>
                    <a:lnTo>
                      <a:pt x="436" y="4108"/>
                    </a:lnTo>
                    <a:lnTo>
                      <a:pt x="436" y="28"/>
                    </a:lnTo>
                    <a:lnTo>
                      <a:pt x="464" y="56"/>
                    </a:lnTo>
                    <a:lnTo>
                      <a:pt x="28" y="56"/>
                    </a:lnTo>
                    <a:lnTo>
                      <a:pt x="56" y="28"/>
                    </a:lnTo>
                    <a:lnTo>
                      <a:pt x="56" y="4108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71" name="Rectangle 647"/>
              <p:cNvSpPr>
                <a:spLocks noChangeArrowheads="1"/>
              </p:cNvSpPr>
              <p:nvPr/>
            </p:nvSpPr>
            <p:spPr bwMode="auto">
              <a:xfrm>
                <a:off x="2576940" y="3503645"/>
                <a:ext cx="41821" cy="512197"/>
              </a:xfrm>
              <a:prstGeom prst="rect">
                <a:avLst/>
              </a:prstGeom>
              <a:solidFill>
                <a:srgbClr val="9999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72" name="Freeform 648"/>
              <p:cNvSpPr>
                <a:spLocks noEditPoints="1"/>
              </p:cNvSpPr>
              <p:nvPr/>
            </p:nvSpPr>
            <p:spPr bwMode="auto">
              <a:xfrm>
                <a:off x="2573953" y="3500846"/>
                <a:ext cx="47795" cy="516862"/>
              </a:xfrm>
              <a:custGeom>
                <a:avLst/>
                <a:gdLst/>
                <a:ahLst/>
                <a:cxnLst>
                  <a:cxn ang="0">
                    <a:pos x="0" y="28"/>
                  </a:cxn>
                  <a:cxn ang="0">
                    <a:pos x="28" y="0"/>
                  </a:cxn>
                  <a:cxn ang="0">
                    <a:pos x="464" y="0"/>
                  </a:cxn>
                  <a:cxn ang="0">
                    <a:pos x="492" y="28"/>
                  </a:cxn>
                  <a:cxn ang="0">
                    <a:pos x="492" y="6280"/>
                  </a:cxn>
                  <a:cxn ang="0">
                    <a:pos x="464" y="6308"/>
                  </a:cxn>
                  <a:cxn ang="0">
                    <a:pos x="28" y="6308"/>
                  </a:cxn>
                  <a:cxn ang="0">
                    <a:pos x="0" y="6280"/>
                  </a:cxn>
                  <a:cxn ang="0">
                    <a:pos x="0" y="28"/>
                  </a:cxn>
                  <a:cxn ang="0">
                    <a:pos x="56" y="6280"/>
                  </a:cxn>
                  <a:cxn ang="0">
                    <a:pos x="28" y="6252"/>
                  </a:cxn>
                  <a:cxn ang="0">
                    <a:pos x="464" y="6252"/>
                  </a:cxn>
                  <a:cxn ang="0">
                    <a:pos x="436" y="6280"/>
                  </a:cxn>
                  <a:cxn ang="0">
                    <a:pos x="436" y="28"/>
                  </a:cxn>
                  <a:cxn ang="0">
                    <a:pos x="464" y="56"/>
                  </a:cxn>
                  <a:cxn ang="0">
                    <a:pos x="28" y="56"/>
                  </a:cxn>
                  <a:cxn ang="0">
                    <a:pos x="56" y="28"/>
                  </a:cxn>
                  <a:cxn ang="0">
                    <a:pos x="56" y="6280"/>
                  </a:cxn>
                </a:cxnLst>
                <a:rect l="0" t="0" r="r" b="b"/>
                <a:pathLst>
                  <a:path w="492" h="6308">
                    <a:moveTo>
                      <a:pt x="0" y="28"/>
                    </a:moveTo>
                    <a:cubicBezTo>
                      <a:pt x="0" y="13"/>
                      <a:pt x="13" y="0"/>
                      <a:pt x="28" y="0"/>
                    </a:cubicBezTo>
                    <a:lnTo>
                      <a:pt x="464" y="0"/>
                    </a:lnTo>
                    <a:cubicBezTo>
                      <a:pt x="480" y="0"/>
                      <a:pt x="492" y="13"/>
                      <a:pt x="492" y="28"/>
                    </a:cubicBezTo>
                    <a:lnTo>
                      <a:pt x="492" y="6280"/>
                    </a:lnTo>
                    <a:cubicBezTo>
                      <a:pt x="492" y="6296"/>
                      <a:pt x="480" y="6308"/>
                      <a:pt x="464" y="6308"/>
                    </a:cubicBezTo>
                    <a:lnTo>
                      <a:pt x="28" y="6308"/>
                    </a:lnTo>
                    <a:cubicBezTo>
                      <a:pt x="13" y="6308"/>
                      <a:pt x="0" y="6296"/>
                      <a:pt x="0" y="6280"/>
                    </a:cubicBezTo>
                    <a:lnTo>
                      <a:pt x="0" y="28"/>
                    </a:lnTo>
                    <a:close/>
                    <a:moveTo>
                      <a:pt x="56" y="6280"/>
                    </a:moveTo>
                    <a:lnTo>
                      <a:pt x="28" y="6252"/>
                    </a:lnTo>
                    <a:lnTo>
                      <a:pt x="464" y="6252"/>
                    </a:lnTo>
                    <a:lnTo>
                      <a:pt x="436" y="6280"/>
                    </a:lnTo>
                    <a:lnTo>
                      <a:pt x="436" y="28"/>
                    </a:lnTo>
                    <a:lnTo>
                      <a:pt x="464" y="56"/>
                    </a:lnTo>
                    <a:lnTo>
                      <a:pt x="28" y="56"/>
                    </a:lnTo>
                    <a:lnTo>
                      <a:pt x="56" y="28"/>
                    </a:lnTo>
                    <a:lnTo>
                      <a:pt x="56" y="6280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73" name="Rectangle 649"/>
              <p:cNvSpPr>
                <a:spLocks noChangeArrowheads="1"/>
              </p:cNvSpPr>
              <p:nvPr/>
            </p:nvSpPr>
            <p:spPr bwMode="auto">
              <a:xfrm>
                <a:off x="2703398" y="3458863"/>
                <a:ext cx="41821" cy="556980"/>
              </a:xfrm>
              <a:prstGeom prst="rect">
                <a:avLst/>
              </a:prstGeom>
              <a:solidFill>
                <a:srgbClr val="9999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74" name="Freeform 650"/>
              <p:cNvSpPr>
                <a:spLocks noEditPoints="1"/>
              </p:cNvSpPr>
              <p:nvPr/>
            </p:nvSpPr>
            <p:spPr bwMode="auto">
              <a:xfrm>
                <a:off x="2700411" y="3456997"/>
                <a:ext cx="46800" cy="560712"/>
              </a:xfrm>
              <a:custGeom>
                <a:avLst/>
                <a:gdLst/>
                <a:ahLst/>
                <a:cxnLst>
                  <a:cxn ang="0">
                    <a:pos x="0" y="28"/>
                  </a:cxn>
                  <a:cxn ang="0">
                    <a:pos x="28" y="0"/>
                  </a:cxn>
                  <a:cxn ang="0">
                    <a:pos x="464" y="0"/>
                  </a:cxn>
                  <a:cxn ang="0">
                    <a:pos x="492" y="28"/>
                  </a:cxn>
                  <a:cxn ang="0">
                    <a:pos x="492" y="6820"/>
                  </a:cxn>
                  <a:cxn ang="0">
                    <a:pos x="464" y="6848"/>
                  </a:cxn>
                  <a:cxn ang="0">
                    <a:pos x="28" y="6848"/>
                  </a:cxn>
                  <a:cxn ang="0">
                    <a:pos x="0" y="6820"/>
                  </a:cxn>
                  <a:cxn ang="0">
                    <a:pos x="0" y="28"/>
                  </a:cxn>
                  <a:cxn ang="0">
                    <a:pos x="56" y="6820"/>
                  </a:cxn>
                  <a:cxn ang="0">
                    <a:pos x="28" y="6792"/>
                  </a:cxn>
                  <a:cxn ang="0">
                    <a:pos x="464" y="6792"/>
                  </a:cxn>
                  <a:cxn ang="0">
                    <a:pos x="436" y="6820"/>
                  </a:cxn>
                  <a:cxn ang="0">
                    <a:pos x="436" y="28"/>
                  </a:cxn>
                  <a:cxn ang="0">
                    <a:pos x="464" y="56"/>
                  </a:cxn>
                  <a:cxn ang="0">
                    <a:pos x="28" y="56"/>
                  </a:cxn>
                  <a:cxn ang="0">
                    <a:pos x="56" y="28"/>
                  </a:cxn>
                  <a:cxn ang="0">
                    <a:pos x="56" y="6820"/>
                  </a:cxn>
                </a:cxnLst>
                <a:rect l="0" t="0" r="r" b="b"/>
                <a:pathLst>
                  <a:path w="492" h="6848">
                    <a:moveTo>
                      <a:pt x="0" y="28"/>
                    </a:moveTo>
                    <a:cubicBezTo>
                      <a:pt x="0" y="13"/>
                      <a:pt x="13" y="0"/>
                      <a:pt x="28" y="0"/>
                    </a:cubicBezTo>
                    <a:lnTo>
                      <a:pt x="464" y="0"/>
                    </a:lnTo>
                    <a:cubicBezTo>
                      <a:pt x="480" y="0"/>
                      <a:pt x="492" y="13"/>
                      <a:pt x="492" y="28"/>
                    </a:cubicBezTo>
                    <a:lnTo>
                      <a:pt x="492" y="6820"/>
                    </a:lnTo>
                    <a:cubicBezTo>
                      <a:pt x="492" y="6836"/>
                      <a:pt x="480" y="6848"/>
                      <a:pt x="464" y="6848"/>
                    </a:cubicBezTo>
                    <a:lnTo>
                      <a:pt x="28" y="6848"/>
                    </a:lnTo>
                    <a:cubicBezTo>
                      <a:pt x="13" y="6848"/>
                      <a:pt x="0" y="6836"/>
                      <a:pt x="0" y="6820"/>
                    </a:cubicBezTo>
                    <a:lnTo>
                      <a:pt x="0" y="28"/>
                    </a:lnTo>
                    <a:close/>
                    <a:moveTo>
                      <a:pt x="56" y="6820"/>
                    </a:moveTo>
                    <a:lnTo>
                      <a:pt x="28" y="6792"/>
                    </a:lnTo>
                    <a:lnTo>
                      <a:pt x="464" y="6792"/>
                    </a:lnTo>
                    <a:lnTo>
                      <a:pt x="436" y="6820"/>
                    </a:lnTo>
                    <a:lnTo>
                      <a:pt x="436" y="28"/>
                    </a:lnTo>
                    <a:lnTo>
                      <a:pt x="464" y="56"/>
                    </a:lnTo>
                    <a:lnTo>
                      <a:pt x="28" y="56"/>
                    </a:lnTo>
                    <a:lnTo>
                      <a:pt x="56" y="28"/>
                    </a:lnTo>
                    <a:lnTo>
                      <a:pt x="56" y="6820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75" name="Rectangle 651"/>
              <p:cNvSpPr>
                <a:spLocks noChangeArrowheads="1"/>
              </p:cNvSpPr>
              <p:nvPr/>
            </p:nvSpPr>
            <p:spPr bwMode="auto">
              <a:xfrm>
                <a:off x="2828861" y="3747148"/>
                <a:ext cx="41821" cy="268694"/>
              </a:xfrm>
              <a:prstGeom prst="rect">
                <a:avLst/>
              </a:prstGeom>
              <a:solidFill>
                <a:srgbClr val="9999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76" name="Freeform 652"/>
              <p:cNvSpPr>
                <a:spLocks noEditPoints="1"/>
              </p:cNvSpPr>
              <p:nvPr/>
            </p:nvSpPr>
            <p:spPr bwMode="auto">
              <a:xfrm>
                <a:off x="2825873" y="3744349"/>
                <a:ext cx="46800" cy="273359"/>
              </a:xfrm>
              <a:custGeom>
                <a:avLst/>
                <a:gdLst/>
                <a:ahLst/>
                <a:cxnLst>
                  <a:cxn ang="0">
                    <a:pos x="0" y="28"/>
                  </a:cxn>
                  <a:cxn ang="0">
                    <a:pos x="28" y="0"/>
                  </a:cxn>
                  <a:cxn ang="0">
                    <a:pos x="464" y="0"/>
                  </a:cxn>
                  <a:cxn ang="0">
                    <a:pos x="492" y="28"/>
                  </a:cxn>
                  <a:cxn ang="0">
                    <a:pos x="492" y="3308"/>
                  </a:cxn>
                  <a:cxn ang="0">
                    <a:pos x="464" y="3336"/>
                  </a:cxn>
                  <a:cxn ang="0">
                    <a:pos x="28" y="3336"/>
                  </a:cxn>
                  <a:cxn ang="0">
                    <a:pos x="0" y="3308"/>
                  </a:cxn>
                  <a:cxn ang="0">
                    <a:pos x="0" y="28"/>
                  </a:cxn>
                  <a:cxn ang="0">
                    <a:pos x="56" y="3308"/>
                  </a:cxn>
                  <a:cxn ang="0">
                    <a:pos x="28" y="3280"/>
                  </a:cxn>
                  <a:cxn ang="0">
                    <a:pos x="464" y="3280"/>
                  </a:cxn>
                  <a:cxn ang="0">
                    <a:pos x="436" y="3308"/>
                  </a:cxn>
                  <a:cxn ang="0">
                    <a:pos x="436" y="28"/>
                  </a:cxn>
                  <a:cxn ang="0">
                    <a:pos x="464" y="56"/>
                  </a:cxn>
                  <a:cxn ang="0">
                    <a:pos x="28" y="56"/>
                  </a:cxn>
                  <a:cxn ang="0">
                    <a:pos x="56" y="28"/>
                  </a:cxn>
                  <a:cxn ang="0">
                    <a:pos x="56" y="3308"/>
                  </a:cxn>
                </a:cxnLst>
                <a:rect l="0" t="0" r="r" b="b"/>
                <a:pathLst>
                  <a:path w="492" h="3336">
                    <a:moveTo>
                      <a:pt x="0" y="28"/>
                    </a:moveTo>
                    <a:cubicBezTo>
                      <a:pt x="0" y="13"/>
                      <a:pt x="13" y="0"/>
                      <a:pt x="28" y="0"/>
                    </a:cubicBezTo>
                    <a:lnTo>
                      <a:pt x="464" y="0"/>
                    </a:lnTo>
                    <a:cubicBezTo>
                      <a:pt x="480" y="0"/>
                      <a:pt x="492" y="13"/>
                      <a:pt x="492" y="28"/>
                    </a:cubicBezTo>
                    <a:lnTo>
                      <a:pt x="492" y="3308"/>
                    </a:lnTo>
                    <a:cubicBezTo>
                      <a:pt x="492" y="3324"/>
                      <a:pt x="480" y="3336"/>
                      <a:pt x="464" y="3336"/>
                    </a:cubicBezTo>
                    <a:lnTo>
                      <a:pt x="28" y="3336"/>
                    </a:lnTo>
                    <a:cubicBezTo>
                      <a:pt x="13" y="3336"/>
                      <a:pt x="0" y="3324"/>
                      <a:pt x="0" y="3308"/>
                    </a:cubicBezTo>
                    <a:lnTo>
                      <a:pt x="0" y="28"/>
                    </a:lnTo>
                    <a:close/>
                    <a:moveTo>
                      <a:pt x="56" y="3308"/>
                    </a:moveTo>
                    <a:lnTo>
                      <a:pt x="28" y="3280"/>
                    </a:lnTo>
                    <a:lnTo>
                      <a:pt x="464" y="3280"/>
                    </a:lnTo>
                    <a:lnTo>
                      <a:pt x="436" y="3308"/>
                    </a:lnTo>
                    <a:lnTo>
                      <a:pt x="436" y="28"/>
                    </a:lnTo>
                    <a:lnTo>
                      <a:pt x="464" y="56"/>
                    </a:lnTo>
                    <a:lnTo>
                      <a:pt x="28" y="56"/>
                    </a:lnTo>
                    <a:lnTo>
                      <a:pt x="56" y="28"/>
                    </a:lnTo>
                    <a:lnTo>
                      <a:pt x="56" y="3308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77" name="Rectangle 653"/>
              <p:cNvSpPr>
                <a:spLocks noChangeArrowheads="1"/>
              </p:cNvSpPr>
              <p:nvPr/>
            </p:nvSpPr>
            <p:spPr bwMode="auto">
              <a:xfrm>
                <a:off x="2954323" y="3591343"/>
                <a:ext cx="41821" cy="424499"/>
              </a:xfrm>
              <a:prstGeom prst="rect">
                <a:avLst/>
              </a:prstGeom>
              <a:solidFill>
                <a:srgbClr val="9999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78" name="Freeform 654"/>
              <p:cNvSpPr>
                <a:spLocks noEditPoints="1"/>
              </p:cNvSpPr>
              <p:nvPr/>
            </p:nvSpPr>
            <p:spPr bwMode="auto">
              <a:xfrm>
                <a:off x="2951335" y="3588544"/>
                <a:ext cx="47795" cy="429163"/>
              </a:xfrm>
              <a:custGeom>
                <a:avLst/>
                <a:gdLst/>
                <a:ahLst/>
                <a:cxnLst>
                  <a:cxn ang="0">
                    <a:pos x="0" y="28"/>
                  </a:cxn>
                  <a:cxn ang="0">
                    <a:pos x="28" y="0"/>
                  </a:cxn>
                  <a:cxn ang="0">
                    <a:pos x="464" y="0"/>
                  </a:cxn>
                  <a:cxn ang="0">
                    <a:pos x="492" y="28"/>
                  </a:cxn>
                  <a:cxn ang="0">
                    <a:pos x="492" y="5212"/>
                  </a:cxn>
                  <a:cxn ang="0">
                    <a:pos x="464" y="5240"/>
                  </a:cxn>
                  <a:cxn ang="0">
                    <a:pos x="28" y="5240"/>
                  </a:cxn>
                  <a:cxn ang="0">
                    <a:pos x="0" y="5212"/>
                  </a:cxn>
                  <a:cxn ang="0">
                    <a:pos x="0" y="28"/>
                  </a:cxn>
                  <a:cxn ang="0">
                    <a:pos x="56" y="5212"/>
                  </a:cxn>
                  <a:cxn ang="0">
                    <a:pos x="28" y="5184"/>
                  </a:cxn>
                  <a:cxn ang="0">
                    <a:pos x="464" y="5184"/>
                  </a:cxn>
                  <a:cxn ang="0">
                    <a:pos x="436" y="5212"/>
                  </a:cxn>
                  <a:cxn ang="0">
                    <a:pos x="436" y="28"/>
                  </a:cxn>
                  <a:cxn ang="0">
                    <a:pos x="464" y="56"/>
                  </a:cxn>
                  <a:cxn ang="0">
                    <a:pos x="28" y="56"/>
                  </a:cxn>
                  <a:cxn ang="0">
                    <a:pos x="56" y="28"/>
                  </a:cxn>
                  <a:cxn ang="0">
                    <a:pos x="56" y="5212"/>
                  </a:cxn>
                </a:cxnLst>
                <a:rect l="0" t="0" r="r" b="b"/>
                <a:pathLst>
                  <a:path w="492" h="5240">
                    <a:moveTo>
                      <a:pt x="0" y="28"/>
                    </a:moveTo>
                    <a:cubicBezTo>
                      <a:pt x="0" y="13"/>
                      <a:pt x="13" y="0"/>
                      <a:pt x="28" y="0"/>
                    </a:cubicBezTo>
                    <a:lnTo>
                      <a:pt x="464" y="0"/>
                    </a:lnTo>
                    <a:cubicBezTo>
                      <a:pt x="480" y="0"/>
                      <a:pt x="492" y="13"/>
                      <a:pt x="492" y="28"/>
                    </a:cubicBezTo>
                    <a:lnTo>
                      <a:pt x="492" y="5212"/>
                    </a:lnTo>
                    <a:cubicBezTo>
                      <a:pt x="492" y="5228"/>
                      <a:pt x="480" y="5240"/>
                      <a:pt x="464" y="5240"/>
                    </a:cubicBezTo>
                    <a:lnTo>
                      <a:pt x="28" y="5240"/>
                    </a:lnTo>
                    <a:cubicBezTo>
                      <a:pt x="13" y="5240"/>
                      <a:pt x="0" y="5228"/>
                      <a:pt x="0" y="5212"/>
                    </a:cubicBezTo>
                    <a:lnTo>
                      <a:pt x="0" y="28"/>
                    </a:lnTo>
                    <a:close/>
                    <a:moveTo>
                      <a:pt x="56" y="5212"/>
                    </a:moveTo>
                    <a:lnTo>
                      <a:pt x="28" y="5184"/>
                    </a:lnTo>
                    <a:lnTo>
                      <a:pt x="464" y="5184"/>
                    </a:lnTo>
                    <a:lnTo>
                      <a:pt x="436" y="5212"/>
                    </a:lnTo>
                    <a:lnTo>
                      <a:pt x="436" y="28"/>
                    </a:lnTo>
                    <a:lnTo>
                      <a:pt x="464" y="56"/>
                    </a:lnTo>
                    <a:lnTo>
                      <a:pt x="28" y="56"/>
                    </a:lnTo>
                    <a:lnTo>
                      <a:pt x="56" y="28"/>
                    </a:lnTo>
                    <a:lnTo>
                      <a:pt x="56" y="5212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79" name="Rectangle 655"/>
              <p:cNvSpPr>
                <a:spLocks noChangeArrowheads="1"/>
              </p:cNvSpPr>
              <p:nvPr/>
            </p:nvSpPr>
            <p:spPr bwMode="auto">
              <a:xfrm>
                <a:off x="607381" y="3188303"/>
                <a:ext cx="41821" cy="827539"/>
              </a:xfrm>
              <a:prstGeom prst="rect">
                <a:avLst/>
              </a:prstGeom>
              <a:solidFill>
                <a:srgbClr val="FFFF99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80" name="Freeform 656"/>
              <p:cNvSpPr>
                <a:spLocks noEditPoints="1"/>
              </p:cNvSpPr>
              <p:nvPr/>
            </p:nvSpPr>
            <p:spPr bwMode="auto">
              <a:xfrm>
                <a:off x="605389" y="3186437"/>
                <a:ext cx="46800" cy="831271"/>
              </a:xfrm>
              <a:custGeom>
                <a:avLst/>
                <a:gdLst/>
                <a:ahLst/>
                <a:cxnLst>
                  <a:cxn ang="0">
                    <a:pos x="0" y="56"/>
                  </a:cxn>
                  <a:cxn ang="0">
                    <a:pos x="56" y="0"/>
                  </a:cxn>
                  <a:cxn ang="0">
                    <a:pos x="928" y="0"/>
                  </a:cxn>
                  <a:cxn ang="0">
                    <a:pos x="984" y="56"/>
                  </a:cxn>
                  <a:cxn ang="0">
                    <a:pos x="984" y="20248"/>
                  </a:cxn>
                  <a:cxn ang="0">
                    <a:pos x="928" y="20304"/>
                  </a:cxn>
                  <a:cxn ang="0">
                    <a:pos x="56" y="20304"/>
                  </a:cxn>
                  <a:cxn ang="0">
                    <a:pos x="0" y="20248"/>
                  </a:cxn>
                  <a:cxn ang="0">
                    <a:pos x="0" y="56"/>
                  </a:cxn>
                  <a:cxn ang="0">
                    <a:pos x="112" y="20248"/>
                  </a:cxn>
                  <a:cxn ang="0">
                    <a:pos x="56" y="20192"/>
                  </a:cxn>
                  <a:cxn ang="0">
                    <a:pos x="928" y="20192"/>
                  </a:cxn>
                  <a:cxn ang="0">
                    <a:pos x="872" y="20248"/>
                  </a:cxn>
                  <a:cxn ang="0">
                    <a:pos x="872" y="56"/>
                  </a:cxn>
                  <a:cxn ang="0">
                    <a:pos x="928" y="112"/>
                  </a:cxn>
                  <a:cxn ang="0">
                    <a:pos x="56" y="112"/>
                  </a:cxn>
                  <a:cxn ang="0">
                    <a:pos x="112" y="56"/>
                  </a:cxn>
                  <a:cxn ang="0">
                    <a:pos x="112" y="20248"/>
                  </a:cxn>
                </a:cxnLst>
                <a:rect l="0" t="0" r="r" b="b"/>
                <a:pathLst>
                  <a:path w="984" h="20304">
                    <a:moveTo>
                      <a:pt x="0" y="56"/>
                    </a:moveTo>
                    <a:cubicBezTo>
                      <a:pt x="0" y="26"/>
                      <a:pt x="26" y="0"/>
                      <a:pt x="56" y="0"/>
                    </a:cubicBezTo>
                    <a:lnTo>
                      <a:pt x="928" y="0"/>
                    </a:lnTo>
                    <a:cubicBezTo>
                      <a:pt x="959" y="0"/>
                      <a:pt x="984" y="26"/>
                      <a:pt x="984" y="56"/>
                    </a:cubicBezTo>
                    <a:lnTo>
                      <a:pt x="984" y="20248"/>
                    </a:lnTo>
                    <a:cubicBezTo>
                      <a:pt x="984" y="20279"/>
                      <a:pt x="959" y="20304"/>
                      <a:pt x="928" y="20304"/>
                    </a:cubicBezTo>
                    <a:lnTo>
                      <a:pt x="56" y="20304"/>
                    </a:lnTo>
                    <a:cubicBezTo>
                      <a:pt x="26" y="20304"/>
                      <a:pt x="0" y="20279"/>
                      <a:pt x="0" y="20248"/>
                    </a:cubicBezTo>
                    <a:lnTo>
                      <a:pt x="0" y="56"/>
                    </a:lnTo>
                    <a:close/>
                    <a:moveTo>
                      <a:pt x="112" y="20248"/>
                    </a:moveTo>
                    <a:lnTo>
                      <a:pt x="56" y="20192"/>
                    </a:lnTo>
                    <a:lnTo>
                      <a:pt x="928" y="20192"/>
                    </a:lnTo>
                    <a:lnTo>
                      <a:pt x="872" y="20248"/>
                    </a:lnTo>
                    <a:lnTo>
                      <a:pt x="872" y="56"/>
                    </a:lnTo>
                    <a:lnTo>
                      <a:pt x="928" y="112"/>
                    </a:lnTo>
                    <a:lnTo>
                      <a:pt x="56" y="112"/>
                    </a:lnTo>
                    <a:lnTo>
                      <a:pt x="112" y="56"/>
                    </a:lnTo>
                    <a:lnTo>
                      <a:pt x="112" y="20248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81" name="Rectangle 657"/>
              <p:cNvSpPr>
                <a:spLocks noChangeArrowheads="1"/>
              </p:cNvSpPr>
              <p:nvPr/>
            </p:nvSpPr>
            <p:spPr bwMode="auto">
              <a:xfrm>
                <a:off x="732843" y="3337577"/>
                <a:ext cx="41821" cy="678265"/>
              </a:xfrm>
              <a:prstGeom prst="rect">
                <a:avLst/>
              </a:prstGeom>
              <a:solidFill>
                <a:srgbClr val="FFFF99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82" name="Freeform 658"/>
              <p:cNvSpPr>
                <a:spLocks noEditPoints="1"/>
              </p:cNvSpPr>
              <p:nvPr/>
            </p:nvSpPr>
            <p:spPr bwMode="auto">
              <a:xfrm>
                <a:off x="730852" y="3334778"/>
                <a:ext cx="46800" cy="682930"/>
              </a:xfrm>
              <a:custGeom>
                <a:avLst/>
                <a:gdLst/>
                <a:ahLst/>
                <a:cxnLst>
                  <a:cxn ang="0">
                    <a:pos x="0" y="56"/>
                  </a:cxn>
                  <a:cxn ang="0">
                    <a:pos x="56" y="0"/>
                  </a:cxn>
                  <a:cxn ang="0">
                    <a:pos x="928" y="0"/>
                  </a:cxn>
                  <a:cxn ang="0">
                    <a:pos x="984" y="56"/>
                  </a:cxn>
                  <a:cxn ang="0">
                    <a:pos x="984" y="16624"/>
                  </a:cxn>
                  <a:cxn ang="0">
                    <a:pos x="928" y="16680"/>
                  </a:cxn>
                  <a:cxn ang="0">
                    <a:pos x="56" y="16680"/>
                  </a:cxn>
                  <a:cxn ang="0">
                    <a:pos x="0" y="16624"/>
                  </a:cxn>
                  <a:cxn ang="0">
                    <a:pos x="0" y="56"/>
                  </a:cxn>
                  <a:cxn ang="0">
                    <a:pos x="112" y="16624"/>
                  </a:cxn>
                  <a:cxn ang="0">
                    <a:pos x="56" y="16568"/>
                  </a:cxn>
                  <a:cxn ang="0">
                    <a:pos x="928" y="16568"/>
                  </a:cxn>
                  <a:cxn ang="0">
                    <a:pos x="872" y="16624"/>
                  </a:cxn>
                  <a:cxn ang="0">
                    <a:pos x="872" y="56"/>
                  </a:cxn>
                  <a:cxn ang="0">
                    <a:pos x="928" y="112"/>
                  </a:cxn>
                  <a:cxn ang="0">
                    <a:pos x="56" y="112"/>
                  </a:cxn>
                  <a:cxn ang="0">
                    <a:pos x="112" y="56"/>
                  </a:cxn>
                  <a:cxn ang="0">
                    <a:pos x="112" y="16624"/>
                  </a:cxn>
                </a:cxnLst>
                <a:rect l="0" t="0" r="r" b="b"/>
                <a:pathLst>
                  <a:path w="984" h="16680">
                    <a:moveTo>
                      <a:pt x="0" y="56"/>
                    </a:moveTo>
                    <a:cubicBezTo>
                      <a:pt x="0" y="26"/>
                      <a:pt x="26" y="0"/>
                      <a:pt x="56" y="0"/>
                    </a:cubicBezTo>
                    <a:lnTo>
                      <a:pt x="928" y="0"/>
                    </a:lnTo>
                    <a:cubicBezTo>
                      <a:pt x="959" y="0"/>
                      <a:pt x="984" y="26"/>
                      <a:pt x="984" y="56"/>
                    </a:cubicBezTo>
                    <a:lnTo>
                      <a:pt x="984" y="16624"/>
                    </a:lnTo>
                    <a:cubicBezTo>
                      <a:pt x="984" y="16655"/>
                      <a:pt x="959" y="16680"/>
                      <a:pt x="928" y="16680"/>
                    </a:cubicBezTo>
                    <a:lnTo>
                      <a:pt x="56" y="16680"/>
                    </a:lnTo>
                    <a:cubicBezTo>
                      <a:pt x="26" y="16680"/>
                      <a:pt x="0" y="16655"/>
                      <a:pt x="0" y="16624"/>
                    </a:cubicBezTo>
                    <a:lnTo>
                      <a:pt x="0" y="56"/>
                    </a:lnTo>
                    <a:close/>
                    <a:moveTo>
                      <a:pt x="112" y="16624"/>
                    </a:moveTo>
                    <a:lnTo>
                      <a:pt x="56" y="16568"/>
                    </a:lnTo>
                    <a:lnTo>
                      <a:pt x="928" y="16568"/>
                    </a:lnTo>
                    <a:lnTo>
                      <a:pt x="872" y="16624"/>
                    </a:lnTo>
                    <a:lnTo>
                      <a:pt x="872" y="56"/>
                    </a:lnTo>
                    <a:lnTo>
                      <a:pt x="928" y="112"/>
                    </a:lnTo>
                    <a:lnTo>
                      <a:pt x="56" y="112"/>
                    </a:lnTo>
                    <a:lnTo>
                      <a:pt x="112" y="56"/>
                    </a:lnTo>
                    <a:lnTo>
                      <a:pt x="112" y="16624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83" name="Rectangle 659"/>
              <p:cNvSpPr>
                <a:spLocks noChangeArrowheads="1"/>
              </p:cNvSpPr>
              <p:nvPr/>
            </p:nvSpPr>
            <p:spPr bwMode="auto">
              <a:xfrm>
                <a:off x="859301" y="3382359"/>
                <a:ext cx="41821" cy="633483"/>
              </a:xfrm>
              <a:prstGeom prst="rect">
                <a:avLst/>
              </a:prstGeom>
              <a:solidFill>
                <a:srgbClr val="FFFF99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84" name="Freeform 660"/>
              <p:cNvSpPr>
                <a:spLocks noEditPoints="1"/>
              </p:cNvSpPr>
              <p:nvPr/>
            </p:nvSpPr>
            <p:spPr bwMode="auto">
              <a:xfrm>
                <a:off x="856314" y="3379560"/>
                <a:ext cx="47795" cy="638147"/>
              </a:xfrm>
              <a:custGeom>
                <a:avLst/>
                <a:gdLst/>
                <a:ahLst/>
                <a:cxnLst>
                  <a:cxn ang="0">
                    <a:pos x="0" y="56"/>
                  </a:cxn>
                  <a:cxn ang="0">
                    <a:pos x="56" y="0"/>
                  </a:cxn>
                  <a:cxn ang="0">
                    <a:pos x="928" y="0"/>
                  </a:cxn>
                  <a:cxn ang="0">
                    <a:pos x="984" y="56"/>
                  </a:cxn>
                  <a:cxn ang="0">
                    <a:pos x="984" y="15528"/>
                  </a:cxn>
                  <a:cxn ang="0">
                    <a:pos x="928" y="15584"/>
                  </a:cxn>
                  <a:cxn ang="0">
                    <a:pos x="56" y="15584"/>
                  </a:cxn>
                  <a:cxn ang="0">
                    <a:pos x="0" y="15528"/>
                  </a:cxn>
                  <a:cxn ang="0">
                    <a:pos x="0" y="56"/>
                  </a:cxn>
                  <a:cxn ang="0">
                    <a:pos x="112" y="15528"/>
                  </a:cxn>
                  <a:cxn ang="0">
                    <a:pos x="56" y="15472"/>
                  </a:cxn>
                  <a:cxn ang="0">
                    <a:pos x="928" y="15472"/>
                  </a:cxn>
                  <a:cxn ang="0">
                    <a:pos x="872" y="15528"/>
                  </a:cxn>
                  <a:cxn ang="0">
                    <a:pos x="872" y="56"/>
                  </a:cxn>
                  <a:cxn ang="0">
                    <a:pos x="928" y="112"/>
                  </a:cxn>
                  <a:cxn ang="0">
                    <a:pos x="56" y="112"/>
                  </a:cxn>
                  <a:cxn ang="0">
                    <a:pos x="112" y="56"/>
                  </a:cxn>
                  <a:cxn ang="0">
                    <a:pos x="112" y="15528"/>
                  </a:cxn>
                </a:cxnLst>
                <a:rect l="0" t="0" r="r" b="b"/>
                <a:pathLst>
                  <a:path w="984" h="15584">
                    <a:moveTo>
                      <a:pt x="0" y="56"/>
                    </a:moveTo>
                    <a:cubicBezTo>
                      <a:pt x="0" y="26"/>
                      <a:pt x="26" y="0"/>
                      <a:pt x="56" y="0"/>
                    </a:cubicBezTo>
                    <a:lnTo>
                      <a:pt x="928" y="0"/>
                    </a:lnTo>
                    <a:cubicBezTo>
                      <a:pt x="959" y="0"/>
                      <a:pt x="984" y="26"/>
                      <a:pt x="984" y="56"/>
                    </a:cubicBezTo>
                    <a:lnTo>
                      <a:pt x="984" y="15528"/>
                    </a:lnTo>
                    <a:cubicBezTo>
                      <a:pt x="984" y="15559"/>
                      <a:pt x="959" y="15584"/>
                      <a:pt x="928" y="15584"/>
                    </a:cubicBezTo>
                    <a:lnTo>
                      <a:pt x="56" y="15584"/>
                    </a:lnTo>
                    <a:cubicBezTo>
                      <a:pt x="26" y="15584"/>
                      <a:pt x="0" y="15559"/>
                      <a:pt x="0" y="15528"/>
                    </a:cubicBezTo>
                    <a:lnTo>
                      <a:pt x="0" y="56"/>
                    </a:lnTo>
                    <a:close/>
                    <a:moveTo>
                      <a:pt x="112" y="15528"/>
                    </a:moveTo>
                    <a:lnTo>
                      <a:pt x="56" y="15472"/>
                    </a:lnTo>
                    <a:lnTo>
                      <a:pt x="928" y="15472"/>
                    </a:lnTo>
                    <a:lnTo>
                      <a:pt x="872" y="15528"/>
                    </a:lnTo>
                    <a:lnTo>
                      <a:pt x="872" y="56"/>
                    </a:lnTo>
                    <a:lnTo>
                      <a:pt x="928" y="112"/>
                    </a:lnTo>
                    <a:lnTo>
                      <a:pt x="56" y="112"/>
                    </a:lnTo>
                    <a:lnTo>
                      <a:pt x="112" y="56"/>
                    </a:lnTo>
                    <a:lnTo>
                      <a:pt x="112" y="15528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85" name="Rectangle 661"/>
              <p:cNvSpPr>
                <a:spLocks noChangeArrowheads="1"/>
              </p:cNvSpPr>
              <p:nvPr/>
            </p:nvSpPr>
            <p:spPr bwMode="auto">
              <a:xfrm>
                <a:off x="984764" y="3363700"/>
                <a:ext cx="41821" cy="652142"/>
              </a:xfrm>
              <a:prstGeom prst="rect">
                <a:avLst/>
              </a:prstGeom>
              <a:solidFill>
                <a:srgbClr val="FFFF99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86" name="Freeform 662"/>
              <p:cNvSpPr>
                <a:spLocks noEditPoints="1"/>
              </p:cNvSpPr>
              <p:nvPr/>
            </p:nvSpPr>
            <p:spPr bwMode="auto">
              <a:xfrm>
                <a:off x="981776" y="3361834"/>
                <a:ext cx="47795" cy="655874"/>
              </a:xfrm>
              <a:custGeom>
                <a:avLst/>
                <a:gdLst/>
                <a:ahLst/>
                <a:cxnLst>
                  <a:cxn ang="0">
                    <a:pos x="0" y="56"/>
                  </a:cxn>
                  <a:cxn ang="0">
                    <a:pos x="56" y="0"/>
                  </a:cxn>
                  <a:cxn ang="0">
                    <a:pos x="928" y="0"/>
                  </a:cxn>
                  <a:cxn ang="0">
                    <a:pos x="984" y="56"/>
                  </a:cxn>
                  <a:cxn ang="0">
                    <a:pos x="984" y="15968"/>
                  </a:cxn>
                  <a:cxn ang="0">
                    <a:pos x="928" y="16024"/>
                  </a:cxn>
                  <a:cxn ang="0">
                    <a:pos x="56" y="16024"/>
                  </a:cxn>
                  <a:cxn ang="0">
                    <a:pos x="0" y="15968"/>
                  </a:cxn>
                  <a:cxn ang="0">
                    <a:pos x="0" y="56"/>
                  </a:cxn>
                  <a:cxn ang="0">
                    <a:pos x="112" y="15968"/>
                  </a:cxn>
                  <a:cxn ang="0">
                    <a:pos x="56" y="15912"/>
                  </a:cxn>
                  <a:cxn ang="0">
                    <a:pos x="928" y="15912"/>
                  </a:cxn>
                  <a:cxn ang="0">
                    <a:pos x="872" y="15968"/>
                  </a:cxn>
                  <a:cxn ang="0">
                    <a:pos x="872" y="56"/>
                  </a:cxn>
                  <a:cxn ang="0">
                    <a:pos x="928" y="112"/>
                  </a:cxn>
                  <a:cxn ang="0">
                    <a:pos x="56" y="112"/>
                  </a:cxn>
                  <a:cxn ang="0">
                    <a:pos x="112" y="56"/>
                  </a:cxn>
                  <a:cxn ang="0">
                    <a:pos x="112" y="15968"/>
                  </a:cxn>
                </a:cxnLst>
                <a:rect l="0" t="0" r="r" b="b"/>
                <a:pathLst>
                  <a:path w="984" h="16024">
                    <a:moveTo>
                      <a:pt x="0" y="56"/>
                    </a:moveTo>
                    <a:cubicBezTo>
                      <a:pt x="0" y="26"/>
                      <a:pt x="26" y="0"/>
                      <a:pt x="56" y="0"/>
                    </a:cubicBezTo>
                    <a:lnTo>
                      <a:pt x="928" y="0"/>
                    </a:lnTo>
                    <a:cubicBezTo>
                      <a:pt x="959" y="0"/>
                      <a:pt x="984" y="26"/>
                      <a:pt x="984" y="56"/>
                    </a:cubicBezTo>
                    <a:lnTo>
                      <a:pt x="984" y="15968"/>
                    </a:lnTo>
                    <a:cubicBezTo>
                      <a:pt x="984" y="15999"/>
                      <a:pt x="959" y="16024"/>
                      <a:pt x="928" y="16024"/>
                    </a:cubicBezTo>
                    <a:lnTo>
                      <a:pt x="56" y="16024"/>
                    </a:lnTo>
                    <a:cubicBezTo>
                      <a:pt x="26" y="16024"/>
                      <a:pt x="0" y="15999"/>
                      <a:pt x="0" y="15968"/>
                    </a:cubicBezTo>
                    <a:lnTo>
                      <a:pt x="0" y="56"/>
                    </a:lnTo>
                    <a:close/>
                    <a:moveTo>
                      <a:pt x="112" y="15968"/>
                    </a:moveTo>
                    <a:lnTo>
                      <a:pt x="56" y="15912"/>
                    </a:lnTo>
                    <a:lnTo>
                      <a:pt x="928" y="15912"/>
                    </a:lnTo>
                    <a:lnTo>
                      <a:pt x="872" y="15968"/>
                    </a:lnTo>
                    <a:lnTo>
                      <a:pt x="872" y="56"/>
                    </a:lnTo>
                    <a:lnTo>
                      <a:pt x="928" y="112"/>
                    </a:lnTo>
                    <a:lnTo>
                      <a:pt x="56" y="112"/>
                    </a:lnTo>
                    <a:lnTo>
                      <a:pt x="112" y="56"/>
                    </a:lnTo>
                    <a:lnTo>
                      <a:pt x="112" y="15968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87" name="Rectangle 663"/>
              <p:cNvSpPr>
                <a:spLocks noChangeArrowheads="1"/>
              </p:cNvSpPr>
              <p:nvPr/>
            </p:nvSpPr>
            <p:spPr bwMode="auto">
              <a:xfrm>
                <a:off x="1110226" y="3130459"/>
                <a:ext cx="41821" cy="885383"/>
              </a:xfrm>
              <a:prstGeom prst="rect">
                <a:avLst/>
              </a:prstGeom>
              <a:solidFill>
                <a:srgbClr val="FFFF99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88" name="Freeform 664"/>
              <p:cNvSpPr>
                <a:spLocks noEditPoints="1"/>
              </p:cNvSpPr>
              <p:nvPr/>
            </p:nvSpPr>
            <p:spPr bwMode="auto">
              <a:xfrm>
                <a:off x="1108235" y="3127660"/>
                <a:ext cx="46800" cy="890048"/>
              </a:xfrm>
              <a:custGeom>
                <a:avLst/>
                <a:gdLst/>
                <a:ahLst/>
                <a:cxnLst>
                  <a:cxn ang="0">
                    <a:pos x="0" y="56"/>
                  </a:cxn>
                  <a:cxn ang="0">
                    <a:pos x="56" y="0"/>
                  </a:cxn>
                  <a:cxn ang="0">
                    <a:pos x="928" y="0"/>
                  </a:cxn>
                  <a:cxn ang="0">
                    <a:pos x="984" y="56"/>
                  </a:cxn>
                  <a:cxn ang="0">
                    <a:pos x="984" y="21680"/>
                  </a:cxn>
                  <a:cxn ang="0">
                    <a:pos x="928" y="21736"/>
                  </a:cxn>
                  <a:cxn ang="0">
                    <a:pos x="56" y="21736"/>
                  </a:cxn>
                  <a:cxn ang="0">
                    <a:pos x="0" y="21680"/>
                  </a:cxn>
                  <a:cxn ang="0">
                    <a:pos x="0" y="56"/>
                  </a:cxn>
                  <a:cxn ang="0">
                    <a:pos x="112" y="21680"/>
                  </a:cxn>
                  <a:cxn ang="0">
                    <a:pos x="56" y="21624"/>
                  </a:cxn>
                  <a:cxn ang="0">
                    <a:pos x="928" y="21624"/>
                  </a:cxn>
                  <a:cxn ang="0">
                    <a:pos x="872" y="21680"/>
                  </a:cxn>
                  <a:cxn ang="0">
                    <a:pos x="872" y="56"/>
                  </a:cxn>
                  <a:cxn ang="0">
                    <a:pos x="928" y="112"/>
                  </a:cxn>
                  <a:cxn ang="0">
                    <a:pos x="56" y="112"/>
                  </a:cxn>
                  <a:cxn ang="0">
                    <a:pos x="112" y="56"/>
                  </a:cxn>
                  <a:cxn ang="0">
                    <a:pos x="112" y="21680"/>
                  </a:cxn>
                </a:cxnLst>
                <a:rect l="0" t="0" r="r" b="b"/>
                <a:pathLst>
                  <a:path w="984" h="21736">
                    <a:moveTo>
                      <a:pt x="0" y="56"/>
                    </a:moveTo>
                    <a:cubicBezTo>
                      <a:pt x="0" y="26"/>
                      <a:pt x="26" y="0"/>
                      <a:pt x="56" y="0"/>
                    </a:cubicBezTo>
                    <a:lnTo>
                      <a:pt x="928" y="0"/>
                    </a:lnTo>
                    <a:cubicBezTo>
                      <a:pt x="959" y="0"/>
                      <a:pt x="984" y="26"/>
                      <a:pt x="984" y="56"/>
                    </a:cubicBezTo>
                    <a:lnTo>
                      <a:pt x="984" y="21680"/>
                    </a:lnTo>
                    <a:cubicBezTo>
                      <a:pt x="984" y="21711"/>
                      <a:pt x="959" y="21736"/>
                      <a:pt x="928" y="21736"/>
                    </a:cubicBezTo>
                    <a:lnTo>
                      <a:pt x="56" y="21736"/>
                    </a:lnTo>
                    <a:cubicBezTo>
                      <a:pt x="26" y="21736"/>
                      <a:pt x="0" y="21711"/>
                      <a:pt x="0" y="21680"/>
                    </a:cubicBezTo>
                    <a:lnTo>
                      <a:pt x="0" y="56"/>
                    </a:lnTo>
                    <a:close/>
                    <a:moveTo>
                      <a:pt x="112" y="21680"/>
                    </a:moveTo>
                    <a:lnTo>
                      <a:pt x="56" y="21624"/>
                    </a:lnTo>
                    <a:lnTo>
                      <a:pt x="928" y="21624"/>
                    </a:lnTo>
                    <a:lnTo>
                      <a:pt x="872" y="21680"/>
                    </a:lnTo>
                    <a:lnTo>
                      <a:pt x="872" y="56"/>
                    </a:lnTo>
                    <a:lnTo>
                      <a:pt x="928" y="112"/>
                    </a:lnTo>
                    <a:lnTo>
                      <a:pt x="56" y="112"/>
                    </a:lnTo>
                    <a:lnTo>
                      <a:pt x="112" y="56"/>
                    </a:lnTo>
                    <a:lnTo>
                      <a:pt x="112" y="21680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89" name="Rectangle 665"/>
              <p:cNvSpPr>
                <a:spLocks noChangeArrowheads="1"/>
              </p:cNvSpPr>
              <p:nvPr/>
            </p:nvSpPr>
            <p:spPr bwMode="auto">
              <a:xfrm>
                <a:off x="1235688" y="3378628"/>
                <a:ext cx="42817" cy="637215"/>
              </a:xfrm>
              <a:prstGeom prst="rect">
                <a:avLst/>
              </a:prstGeom>
              <a:solidFill>
                <a:srgbClr val="FFFF99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90" name="Freeform 666"/>
              <p:cNvSpPr>
                <a:spLocks noEditPoints="1"/>
              </p:cNvSpPr>
              <p:nvPr/>
            </p:nvSpPr>
            <p:spPr bwMode="auto">
              <a:xfrm>
                <a:off x="1233697" y="3376762"/>
                <a:ext cx="46800" cy="640947"/>
              </a:xfrm>
              <a:custGeom>
                <a:avLst/>
                <a:gdLst/>
                <a:ahLst/>
                <a:cxnLst>
                  <a:cxn ang="0">
                    <a:pos x="0" y="56"/>
                  </a:cxn>
                  <a:cxn ang="0">
                    <a:pos x="56" y="0"/>
                  </a:cxn>
                  <a:cxn ang="0">
                    <a:pos x="936" y="0"/>
                  </a:cxn>
                  <a:cxn ang="0">
                    <a:pos x="992" y="56"/>
                  </a:cxn>
                  <a:cxn ang="0">
                    <a:pos x="992" y="15608"/>
                  </a:cxn>
                  <a:cxn ang="0">
                    <a:pos x="936" y="15664"/>
                  </a:cxn>
                  <a:cxn ang="0">
                    <a:pos x="56" y="15664"/>
                  </a:cxn>
                  <a:cxn ang="0">
                    <a:pos x="0" y="15608"/>
                  </a:cxn>
                  <a:cxn ang="0">
                    <a:pos x="0" y="56"/>
                  </a:cxn>
                  <a:cxn ang="0">
                    <a:pos x="112" y="15608"/>
                  </a:cxn>
                  <a:cxn ang="0">
                    <a:pos x="56" y="15552"/>
                  </a:cxn>
                  <a:cxn ang="0">
                    <a:pos x="936" y="15552"/>
                  </a:cxn>
                  <a:cxn ang="0">
                    <a:pos x="880" y="15608"/>
                  </a:cxn>
                  <a:cxn ang="0">
                    <a:pos x="880" y="56"/>
                  </a:cxn>
                  <a:cxn ang="0">
                    <a:pos x="936" y="112"/>
                  </a:cxn>
                  <a:cxn ang="0">
                    <a:pos x="56" y="112"/>
                  </a:cxn>
                  <a:cxn ang="0">
                    <a:pos x="112" y="56"/>
                  </a:cxn>
                  <a:cxn ang="0">
                    <a:pos x="112" y="15608"/>
                  </a:cxn>
                </a:cxnLst>
                <a:rect l="0" t="0" r="r" b="b"/>
                <a:pathLst>
                  <a:path w="992" h="15664">
                    <a:moveTo>
                      <a:pt x="0" y="56"/>
                    </a:moveTo>
                    <a:cubicBezTo>
                      <a:pt x="0" y="26"/>
                      <a:pt x="26" y="0"/>
                      <a:pt x="56" y="0"/>
                    </a:cubicBezTo>
                    <a:lnTo>
                      <a:pt x="936" y="0"/>
                    </a:lnTo>
                    <a:cubicBezTo>
                      <a:pt x="967" y="0"/>
                      <a:pt x="992" y="26"/>
                      <a:pt x="992" y="56"/>
                    </a:cubicBezTo>
                    <a:lnTo>
                      <a:pt x="992" y="15608"/>
                    </a:lnTo>
                    <a:cubicBezTo>
                      <a:pt x="992" y="15639"/>
                      <a:pt x="967" y="15664"/>
                      <a:pt x="936" y="15664"/>
                    </a:cubicBezTo>
                    <a:lnTo>
                      <a:pt x="56" y="15664"/>
                    </a:lnTo>
                    <a:cubicBezTo>
                      <a:pt x="26" y="15664"/>
                      <a:pt x="0" y="15639"/>
                      <a:pt x="0" y="15608"/>
                    </a:cubicBezTo>
                    <a:lnTo>
                      <a:pt x="0" y="56"/>
                    </a:lnTo>
                    <a:close/>
                    <a:moveTo>
                      <a:pt x="112" y="15608"/>
                    </a:moveTo>
                    <a:lnTo>
                      <a:pt x="56" y="15552"/>
                    </a:lnTo>
                    <a:lnTo>
                      <a:pt x="936" y="15552"/>
                    </a:lnTo>
                    <a:lnTo>
                      <a:pt x="880" y="15608"/>
                    </a:lnTo>
                    <a:lnTo>
                      <a:pt x="880" y="56"/>
                    </a:lnTo>
                    <a:lnTo>
                      <a:pt x="936" y="112"/>
                    </a:lnTo>
                    <a:lnTo>
                      <a:pt x="56" y="112"/>
                    </a:lnTo>
                    <a:lnTo>
                      <a:pt x="112" y="56"/>
                    </a:lnTo>
                    <a:lnTo>
                      <a:pt x="112" y="15608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91" name="Rectangle 667"/>
              <p:cNvSpPr>
                <a:spLocks noChangeArrowheads="1"/>
              </p:cNvSpPr>
              <p:nvPr/>
            </p:nvSpPr>
            <p:spPr bwMode="auto">
              <a:xfrm>
                <a:off x="1362146" y="3355303"/>
                <a:ext cx="41821" cy="660538"/>
              </a:xfrm>
              <a:prstGeom prst="rect">
                <a:avLst/>
              </a:prstGeom>
              <a:solidFill>
                <a:srgbClr val="FFFF99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92" name="Freeform 668"/>
              <p:cNvSpPr>
                <a:spLocks noEditPoints="1"/>
              </p:cNvSpPr>
              <p:nvPr/>
            </p:nvSpPr>
            <p:spPr bwMode="auto">
              <a:xfrm>
                <a:off x="1359159" y="3352505"/>
                <a:ext cx="46800" cy="665204"/>
              </a:xfrm>
              <a:custGeom>
                <a:avLst/>
                <a:gdLst/>
                <a:ahLst/>
                <a:cxnLst>
                  <a:cxn ang="0">
                    <a:pos x="0" y="56"/>
                  </a:cxn>
                  <a:cxn ang="0">
                    <a:pos x="56" y="0"/>
                  </a:cxn>
                  <a:cxn ang="0">
                    <a:pos x="928" y="0"/>
                  </a:cxn>
                  <a:cxn ang="0">
                    <a:pos x="984" y="56"/>
                  </a:cxn>
                  <a:cxn ang="0">
                    <a:pos x="984" y="16184"/>
                  </a:cxn>
                  <a:cxn ang="0">
                    <a:pos x="928" y="16240"/>
                  </a:cxn>
                  <a:cxn ang="0">
                    <a:pos x="56" y="16240"/>
                  </a:cxn>
                  <a:cxn ang="0">
                    <a:pos x="0" y="16184"/>
                  </a:cxn>
                  <a:cxn ang="0">
                    <a:pos x="0" y="56"/>
                  </a:cxn>
                  <a:cxn ang="0">
                    <a:pos x="112" y="16184"/>
                  </a:cxn>
                  <a:cxn ang="0">
                    <a:pos x="56" y="16128"/>
                  </a:cxn>
                  <a:cxn ang="0">
                    <a:pos x="928" y="16128"/>
                  </a:cxn>
                  <a:cxn ang="0">
                    <a:pos x="872" y="16184"/>
                  </a:cxn>
                  <a:cxn ang="0">
                    <a:pos x="872" y="56"/>
                  </a:cxn>
                  <a:cxn ang="0">
                    <a:pos x="928" y="112"/>
                  </a:cxn>
                  <a:cxn ang="0">
                    <a:pos x="56" y="112"/>
                  </a:cxn>
                  <a:cxn ang="0">
                    <a:pos x="112" y="56"/>
                  </a:cxn>
                  <a:cxn ang="0">
                    <a:pos x="112" y="16184"/>
                  </a:cxn>
                </a:cxnLst>
                <a:rect l="0" t="0" r="r" b="b"/>
                <a:pathLst>
                  <a:path w="984" h="16240">
                    <a:moveTo>
                      <a:pt x="0" y="56"/>
                    </a:moveTo>
                    <a:cubicBezTo>
                      <a:pt x="0" y="26"/>
                      <a:pt x="26" y="0"/>
                      <a:pt x="56" y="0"/>
                    </a:cubicBezTo>
                    <a:lnTo>
                      <a:pt x="928" y="0"/>
                    </a:lnTo>
                    <a:cubicBezTo>
                      <a:pt x="959" y="0"/>
                      <a:pt x="984" y="26"/>
                      <a:pt x="984" y="56"/>
                    </a:cubicBezTo>
                    <a:lnTo>
                      <a:pt x="984" y="16184"/>
                    </a:lnTo>
                    <a:cubicBezTo>
                      <a:pt x="984" y="16215"/>
                      <a:pt x="959" y="16240"/>
                      <a:pt x="928" y="16240"/>
                    </a:cubicBezTo>
                    <a:lnTo>
                      <a:pt x="56" y="16240"/>
                    </a:lnTo>
                    <a:cubicBezTo>
                      <a:pt x="26" y="16240"/>
                      <a:pt x="0" y="16215"/>
                      <a:pt x="0" y="16184"/>
                    </a:cubicBezTo>
                    <a:lnTo>
                      <a:pt x="0" y="56"/>
                    </a:lnTo>
                    <a:close/>
                    <a:moveTo>
                      <a:pt x="112" y="16184"/>
                    </a:moveTo>
                    <a:lnTo>
                      <a:pt x="56" y="16128"/>
                    </a:lnTo>
                    <a:lnTo>
                      <a:pt x="928" y="16128"/>
                    </a:lnTo>
                    <a:lnTo>
                      <a:pt x="872" y="16184"/>
                    </a:lnTo>
                    <a:lnTo>
                      <a:pt x="872" y="56"/>
                    </a:lnTo>
                    <a:lnTo>
                      <a:pt x="928" y="112"/>
                    </a:lnTo>
                    <a:lnTo>
                      <a:pt x="56" y="112"/>
                    </a:lnTo>
                    <a:lnTo>
                      <a:pt x="112" y="56"/>
                    </a:lnTo>
                    <a:lnTo>
                      <a:pt x="112" y="16184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93" name="Rectangle 669"/>
              <p:cNvSpPr>
                <a:spLocks noChangeArrowheads="1"/>
              </p:cNvSpPr>
              <p:nvPr/>
            </p:nvSpPr>
            <p:spPr bwMode="auto">
              <a:xfrm>
                <a:off x="1487608" y="3391689"/>
                <a:ext cx="41821" cy="624153"/>
              </a:xfrm>
              <a:prstGeom prst="rect">
                <a:avLst/>
              </a:prstGeom>
              <a:solidFill>
                <a:srgbClr val="FFFF99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94" name="Freeform 670"/>
              <p:cNvSpPr>
                <a:spLocks noEditPoints="1"/>
              </p:cNvSpPr>
              <p:nvPr/>
            </p:nvSpPr>
            <p:spPr bwMode="auto">
              <a:xfrm>
                <a:off x="1484622" y="3389823"/>
                <a:ext cx="47795" cy="627885"/>
              </a:xfrm>
              <a:custGeom>
                <a:avLst/>
                <a:gdLst/>
                <a:ahLst/>
                <a:cxnLst>
                  <a:cxn ang="0">
                    <a:pos x="0" y="56"/>
                  </a:cxn>
                  <a:cxn ang="0">
                    <a:pos x="56" y="0"/>
                  </a:cxn>
                  <a:cxn ang="0">
                    <a:pos x="936" y="0"/>
                  </a:cxn>
                  <a:cxn ang="0">
                    <a:pos x="992" y="56"/>
                  </a:cxn>
                  <a:cxn ang="0">
                    <a:pos x="992" y="15280"/>
                  </a:cxn>
                  <a:cxn ang="0">
                    <a:pos x="936" y="15336"/>
                  </a:cxn>
                  <a:cxn ang="0">
                    <a:pos x="56" y="15336"/>
                  </a:cxn>
                  <a:cxn ang="0">
                    <a:pos x="0" y="15280"/>
                  </a:cxn>
                  <a:cxn ang="0">
                    <a:pos x="0" y="56"/>
                  </a:cxn>
                  <a:cxn ang="0">
                    <a:pos x="112" y="15280"/>
                  </a:cxn>
                  <a:cxn ang="0">
                    <a:pos x="56" y="15224"/>
                  </a:cxn>
                  <a:cxn ang="0">
                    <a:pos x="936" y="15224"/>
                  </a:cxn>
                  <a:cxn ang="0">
                    <a:pos x="880" y="15280"/>
                  </a:cxn>
                  <a:cxn ang="0">
                    <a:pos x="880" y="56"/>
                  </a:cxn>
                  <a:cxn ang="0">
                    <a:pos x="936" y="112"/>
                  </a:cxn>
                  <a:cxn ang="0">
                    <a:pos x="56" y="112"/>
                  </a:cxn>
                  <a:cxn ang="0">
                    <a:pos x="112" y="56"/>
                  </a:cxn>
                  <a:cxn ang="0">
                    <a:pos x="112" y="15280"/>
                  </a:cxn>
                </a:cxnLst>
                <a:rect l="0" t="0" r="r" b="b"/>
                <a:pathLst>
                  <a:path w="992" h="15336">
                    <a:moveTo>
                      <a:pt x="0" y="56"/>
                    </a:moveTo>
                    <a:cubicBezTo>
                      <a:pt x="0" y="26"/>
                      <a:pt x="26" y="0"/>
                      <a:pt x="56" y="0"/>
                    </a:cubicBezTo>
                    <a:lnTo>
                      <a:pt x="936" y="0"/>
                    </a:lnTo>
                    <a:cubicBezTo>
                      <a:pt x="967" y="0"/>
                      <a:pt x="992" y="26"/>
                      <a:pt x="992" y="56"/>
                    </a:cubicBezTo>
                    <a:lnTo>
                      <a:pt x="992" y="15280"/>
                    </a:lnTo>
                    <a:cubicBezTo>
                      <a:pt x="992" y="15311"/>
                      <a:pt x="967" y="15336"/>
                      <a:pt x="936" y="15336"/>
                    </a:cubicBezTo>
                    <a:lnTo>
                      <a:pt x="56" y="15336"/>
                    </a:lnTo>
                    <a:cubicBezTo>
                      <a:pt x="26" y="15336"/>
                      <a:pt x="0" y="15311"/>
                      <a:pt x="0" y="15280"/>
                    </a:cubicBezTo>
                    <a:lnTo>
                      <a:pt x="0" y="56"/>
                    </a:lnTo>
                    <a:close/>
                    <a:moveTo>
                      <a:pt x="112" y="15280"/>
                    </a:moveTo>
                    <a:lnTo>
                      <a:pt x="56" y="15224"/>
                    </a:lnTo>
                    <a:lnTo>
                      <a:pt x="936" y="15224"/>
                    </a:lnTo>
                    <a:lnTo>
                      <a:pt x="880" y="15280"/>
                    </a:lnTo>
                    <a:lnTo>
                      <a:pt x="880" y="56"/>
                    </a:lnTo>
                    <a:lnTo>
                      <a:pt x="936" y="112"/>
                    </a:lnTo>
                    <a:lnTo>
                      <a:pt x="56" y="112"/>
                    </a:lnTo>
                    <a:lnTo>
                      <a:pt x="112" y="56"/>
                    </a:lnTo>
                    <a:lnTo>
                      <a:pt x="112" y="15280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95" name="Rectangle 671"/>
              <p:cNvSpPr>
                <a:spLocks noChangeArrowheads="1"/>
              </p:cNvSpPr>
              <p:nvPr/>
            </p:nvSpPr>
            <p:spPr bwMode="auto">
              <a:xfrm>
                <a:off x="1613071" y="3331046"/>
                <a:ext cx="41821" cy="684796"/>
              </a:xfrm>
              <a:prstGeom prst="rect">
                <a:avLst/>
              </a:prstGeom>
              <a:solidFill>
                <a:srgbClr val="FFFF99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96" name="Freeform 672"/>
              <p:cNvSpPr>
                <a:spLocks noEditPoints="1"/>
              </p:cNvSpPr>
              <p:nvPr/>
            </p:nvSpPr>
            <p:spPr bwMode="auto">
              <a:xfrm>
                <a:off x="1611079" y="3329180"/>
                <a:ext cx="46800" cy="688527"/>
              </a:xfrm>
              <a:custGeom>
                <a:avLst/>
                <a:gdLst/>
                <a:ahLst/>
                <a:cxnLst>
                  <a:cxn ang="0">
                    <a:pos x="0" y="56"/>
                  </a:cxn>
                  <a:cxn ang="0">
                    <a:pos x="56" y="0"/>
                  </a:cxn>
                  <a:cxn ang="0">
                    <a:pos x="928" y="0"/>
                  </a:cxn>
                  <a:cxn ang="0">
                    <a:pos x="984" y="56"/>
                  </a:cxn>
                  <a:cxn ang="0">
                    <a:pos x="984" y="16768"/>
                  </a:cxn>
                  <a:cxn ang="0">
                    <a:pos x="928" y="16824"/>
                  </a:cxn>
                  <a:cxn ang="0">
                    <a:pos x="56" y="16824"/>
                  </a:cxn>
                  <a:cxn ang="0">
                    <a:pos x="0" y="16768"/>
                  </a:cxn>
                  <a:cxn ang="0">
                    <a:pos x="0" y="56"/>
                  </a:cxn>
                  <a:cxn ang="0">
                    <a:pos x="112" y="16768"/>
                  </a:cxn>
                  <a:cxn ang="0">
                    <a:pos x="56" y="16712"/>
                  </a:cxn>
                  <a:cxn ang="0">
                    <a:pos x="928" y="16712"/>
                  </a:cxn>
                  <a:cxn ang="0">
                    <a:pos x="872" y="16768"/>
                  </a:cxn>
                  <a:cxn ang="0">
                    <a:pos x="872" y="56"/>
                  </a:cxn>
                  <a:cxn ang="0">
                    <a:pos x="928" y="112"/>
                  </a:cxn>
                  <a:cxn ang="0">
                    <a:pos x="56" y="112"/>
                  </a:cxn>
                  <a:cxn ang="0">
                    <a:pos x="112" y="56"/>
                  </a:cxn>
                  <a:cxn ang="0">
                    <a:pos x="112" y="16768"/>
                  </a:cxn>
                </a:cxnLst>
                <a:rect l="0" t="0" r="r" b="b"/>
                <a:pathLst>
                  <a:path w="984" h="16824">
                    <a:moveTo>
                      <a:pt x="0" y="56"/>
                    </a:moveTo>
                    <a:cubicBezTo>
                      <a:pt x="0" y="26"/>
                      <a:pt x="26" y="0"/>
                      <a:pt x="56" y="0"/>
                    </a:cubicBezTo>
                    <a:lnTo>
                      <a:pt x="928" y="0"/>
                    </a:lnTo>
                    <a:cubicBezTo>
                      <a:pt x="959" y="0"/>
                      <a:pt x="984" y="26"/>
                      <a:pt x="984" y="56"/>
                    </a:cubicBezTo>
                    <a:lnTo>
                      <a:pt x="984" y="16768"/>
                    </a:lnTo>
                    <a:cubicBezTo>
                      <a:pt x="984" y="16799"/>
                      <a:pt x="959" y="16824"/>
                      <a:pt x="928" y="16824"/>
                    </a:cubicBezTo>
                    <a:lnTo>
                      <a:pt x="56" y="16824"/>
                    </a:lnTo>
                    <a:cubicBezTo>
                      <a:pt x="26" y="16824"/>
                      <a:pt x="0" y="16799"/>
                      <a:pt x="0" y="16768"/>
                    </a:cubicBezTo>
                    <a:lnTo>
                      <a:pt x="0" y="56"/>
                    </a:lnTo>
                    <a:close/>
                    <a:moveTo>
                      <a:pt x="112" y="16768"/>
                    </a:moveTo>
                    <a:lnTo>
                      <a:pt x="56" y="16712"/>
                    </a:lnTo>
                    <a:lnTo>
                      <a:pt x="928" y="16712"/>
                    </a:lnTo>
                    <a:lnTo>
                      <a:pt x="872" y="16768"/>
                    </a:lnTo>
                    <a:lnTo>
                      <a:pt x="872" y="56"/>
                    </a:lnTo>
                    <a:lnTo>
                      <a:pt x="928" y="112"/>
                    </a:lnTo>
                    <a:lnTo>
                      <a:pt x="56" y="112"/>
                    </a:lnTo>
                    <a:lnTo>
                      <a:pt x="112" y="56"/>
                    </a:lnTo>
                    <a:lnTo>
                      <a:pt x="112" y="16768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97" name="Rectangle 673"/>
              <p:cNvSpPr>
                <a:spLocks noChangeArrowheads="1"/>
              </p:cNvSpPr>
              <p:nvPr/>
            </p:nvSpPr>
            <p:spPr bwMode="auto">
              <a:xfrm>
                <a:off x="1739529" y="3694902"/>
                <a:ext cx="41821" cy="320940"/>
              </a:xfrm>
              <a:prstGeom prst="rect">
                <a:avLst/>
              </a:prstGeom>
              <a:solidFill>
                <a:srgbClr val="FFFF99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98" name="Freeform 674"/>
              <p:cNvSpPr>
                <a:spLocks noEditPoints="1"/>
              </p:cNvSpPr>
              <p:nvPr/>
            </p:nvSpPr>
            <p:spPr bwMode="auto">
              <a:xfrm>
                <a:off x="1736542" y="3692103"/>
                <a:ext cx="46800" cy="325605"/>
              </a:xfrm>
              <a:custGeom>
                <a:avLst/>
                <a:gdLst/>
                <a:ahLst/>
                <a:cxnLst>
                  <a:cxn ang="0">
                    <a:pos x="0" y="56"/>
                  </a:cxn>
                  <a:cxn ang="0">
                    <a:pos x="56" y="0"/>
                  </a:cxn>
                  <a:cxn ang="0">
                    <a:pos x="928" y="0"/>
                  </a:cxn>
                  <a:cxn ang="0">
                    <a:pos x="984" y="56"/>
                  </a:cxn>
                  <a:cxn ang="0">
                    <a:pos x="984" y="7896"/>
                  </a:cxn>
                  <a:cxn ang="0">
                    <a:pos x="928" y="7952"/>
                  </a:cxn>
                  <a:cxn ang="0">
                    <a:pos x="56" y="7952"/>
                  </a:cxn>
                  <a:cxn ang="0">
                    <a:pos x="0" y="7896"/>
                  </a:cxn>
                  <a:cxn ang="0">
                    <a:pos x="0" y="56"/>
                  </a:cxn>
                  <a:cxn ang="0">
                    <a:pos x="112" y="7896"/>
                  </a:cxn>
                  <a:cxn ang="0">
                    <a:pos x="56" y="7840"/>
                  </a:cxn>
                  <a:cxn ang="0">
                    <a:pos x="928" y="7840"/>
                  </a:cxn>
                  <a:cxn ang="0">
                    <a:pos x="872" y="7896"/>
                  </a:cxn>
                  <a:cxn ang="0">
                    <a:pos x="872" y="56"/>
                  </a:cxn>
                  <a:cxn ang="0">
                    <a:pos x="928" y="112"/>
                  </a:cxn>
                  <a:cxn ang="0">
                    <a:pos x="56" y="112"/>
                  </a:cxn>
                  <a:cxn ang="0">
                    <a:pos x="112" y="56"/>
                  </a:cxn>
                  <a:cxn ang="0">
                    <a:pos x="112" y="7896"/>
                  </a:cxn>
                </a:cxnLst>
                <a:rect l="0" t="0" r="r" b="b"/>
                <a:pathLst>
                  <a:path w="984" h="7952">
                    <a:moveTo>
                      <a:pt x="0" y="56"/>
                    </a:moveTo>
                    <a:cubicBezTo>
                      <a:pt x="0" y="26"/>
                      <a:pt x="26" y="0"/>
                      <a:pt x="56" y="0"/>
                    </a:cubicBezTo>
                    <a:lnTo>
                      <a:pt x="928" y="0"/>
                    </a:lnTo>
                    <a:cubicBezTo>
                      <a:pt x="959" y="0"/>
                      <a:pt x="984" y="26"/>
                      <a:pt x="984" y="56"/>
                    </a:cubicBezTo>
                    <a:lnTo>
                      <a:pt x="984" y="7896"/>
                    </a:lnTo>
                    <a:cubicBezTo>
                      <a:pt x="984" y="7927"/>
                      <a:pt x="959" y="7952"/>
                      <a:pt x="928" y="7952"/>
                    </a:cubicBezTo>
                    <a:lnTo>
                      <a:pt x="56" y="7952"/>
                    </a:lnTo>
                    <a:cubicBezTo>
                      <a:pt x="26" y="7952"/>
                      <a:pt x="0" y="7927"/>
                      <a:pt x="0" y="7896"/>
                    </a:cubicBezTo>
                    <a:lnTo>
                      <a:pt x="0" y="56"/>
                    </a:lnTo>
                    <a:close/>
                    <a:moveTo>
                      <a:pt x="112" y="7896"/>
                    </a:moveTo>
                    <a:lnTo>
                      <a:pt x="56" y="7840"/>
                    </a:lnTo>
                    <a:lnTo>
                      <a:pt x="928" y="7840"/>
                    </a:lnTo>
                    <a:lnTo>
                      <a:pt x="872" y="7896"/>
                    </a:lnTo>
                    <a:lnTo>
                      <a:pt x="872" y="56"/>
                    </a:lnTo>
                    <a:lnTo>
                      <a:pt x="928" y="112"/>
                    </a:lnTo>
                    <a:lnTo>
                      <a:pt x="56" y="112"/>
                    </a:lnTo>
                    <a:lnTo>
                      <a:pt x="112" y="56"/>
                    </a:lnTo>
                    <a:lnTo>
                      <a:pt x="112" y="7896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99" name="Rectangle 675"/>
              <p:cNvSpPr>
                <a:spLocks noChangeArrowheads="1"/>
              </p:cNvSpPr>
              <p:nvPr/>
            </p:nvSpPr>
            <p:spPr bwMode="auto">
              <a:xfrm>
                <a:off x="1864991" y="3456063"/>
                <a:ext cx="41821" cy="559778"/>
              </a:xfrm>
              <a:prstGeom prst="rect">
                <a:avLst/>
              </a:prstGeom>
              <a:solidFill>
                <a:srgbClr val="FFFF99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00" name="Freeform 676"/>
              <p:cNvSpPr>
                <a:spLocks noEditPoints="1"/>
              </p:cNvSpPr>
              <p:nvPr/>
            </p:nvSpPr>
            <p:spPr bwMode="auto">
              <a:xfrm>
                <a:off x="1862004" y="3453265"/>
                <a:ext cx="46800" cy="564443"/>
              </a:xfrm>
              <a:custGeom>
                <a:avLst/>
                <a:gdLst/>
                <a:ahLst/>
                <a:cxnLst>
                  <a:cxn ang="0">
                    <a:pos x="0" y="28"/>
                  </a:cxn>
                  <a:cxn ang="0">
                    <a:pos x="28" y="0"/>
                  </a:cxn>
                  <a:cxn ang="0">
                    <a:pos x="464" y="0"/>
                  </a:cxn>
                  <a:cxn ang="0">
                    <a:pos x="492" y="28"/>
                  </a:cxn>
                  <a:cxn ang="0">
                    <a:pos x="492" y="6864"/>
                  </a:cxn>
                  <a:cxn ang="0">
                    <a:pos x="464" y="6892"/>
                  </a:cxn>
                  <a:cxn ang="0">
                    <a:pos x="28" y="6892"/>
                  </a:cxn>
                  <a:cxn ang="0">
                    <a:pos x="0" y="6864"/>
                  </a:cxn>
                  <a:cxn ang="0">
                    <a:pos x="0" y="28"/>
                  </a:cxn>
                  <a:cxn ang="0">
                    <a:pos x="56" y="6864"/>
                  </a:cxn>
                  <a:cxn ang="0">
                    <a:pos x="28" y="6836"/>
                  </a:cxn>
                  <a:cxn ang="0">
                    <a:pos x="464" y="6836"/>
                  </a:cxn>
                  <a:cxn ang="0">
                    <a:pos x="436" y="6864"/>
                  </a:cxn>
                  <a:cxn ang="0">
                    <a:pos x="436" y="28"/>
                  </a:cxn>
                  <a:cxn ang="0">
                    <a:pos x="464" y="56"/>
                  </a:cxn>
                  <a:cxn ang="0">
                    <a:pos x="28" y="56"/>
                  </a:cxn>
                  <a:cxn ang="0">
                    <a:pos x="56" y="28"/>
                  </a:cxn>
                  <a:cxn ang="0">
                    <a:pos x="56" y="6864"/>
                  </a:cxn>
                </a:cxnLst>
                <a:rect l="0" t="0" r="r" b="b"/>
                <a:pathLst>
                  <a:path w="492" h="6892">
                    <a:moveTo>
                      <a:pt x="0" y="28"/>
                    </a:moveTo>
                    <a:cubicBezTo>
                      <a:pt x="0" y="13"/>
                      <a:pt x="13" y="0"/>
                      <a:pt x="28" y="0"/>
                    </a:cubicBezTo>
                    <a:lnTo>
                      <a:pt x="464" y="0"/>
                    </a:lnTo>
                    <a:cubicBezTo>
                      <a:pt x="480" y="0"/>
                      <a:pt x="492" y="13"/>
                      <a:pt x="492" y="28"/>
                    </a:cubicBezTo>
                    <a:lnTo>
                      <a:pt x="492" y="6864"/>
                    </a:lnTo>
                    <a:cubicBezTo>
                      <a:pt x="492" y="6880"/>
                      <a:pt x="480" y="6892"/>
                      <a:pt x="464" y="6892"/>
                    </a:cubicBezTo>
                    <a:lnTo>
                      <a:pt x="28" y="6892"/>
                    </a:lnTo>
                    <a:cubicBezTo>
                      <a:pt x="13" y="6892"/>
                      <a:pt x="0" y="6880"/>
                      <a:pt x="0" y="6864"/>
                    </a:cubicBezTo>
                    <a:lnTo>
                      <a:pt x="0" y="28"/>
                    </a:lnTo>
                    <a:close/>
                    <a:moveTo>
                      <a:pt x="56" y="6864"/>
                    </a:moveTo>
                    <a:lnTo>
                      <a:pt x="28" y="6836"/>
                    </a:lnTo>
                    <a:lnTo>
                      <a:pt x="464" y="6836"/>
                    </a:lnTo>
                    <a:lnTo>
                      <a:pt x="436" y="6864"/>
                    </a:lnTo>
                    <a:lnTo>
                      <a:pt x="436" y="28"/>
                    </a:lnTo>
                    <a:lnTo>
                      <a:pt x="464" y="56"/>
                    </a:lnTo>
                    <a:lnTo>
                      <a:pt x="28" y="56"/>
                    </a:lnTo>
                    <a:lnTo>
                      <a:pt x="56" y="28"/>
                    </a:lnTo>
                    <a:lnTo>
                      <a:pt x="56" y="6864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01" name="Rectangle 677"/>
              <p:cNvSpPr>
                <a:spLocks noChangeArrowheads="1"/>
              </p:cNvSpPr>
              <p:nvPr/>
            </p:nvSpPr>
            <p:spPr bwMode="auto">
              <a:xfrm>
                <a:off x="1990454" y="3296527"/>
                <a:ext cx="41821" cy="719315"/>
              </a:xfrm>
              <a:prstGeom prst="rect">
                <a:avLst/>
              </a:prstGeom>
              <a:solidFill>
                <a:srgbClr val="FFFF99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02" name="Freeform 678"/>
              <p:cNvSpPr>
                <a:spLocks noEditPoints="1"/>
              </p:cNvSpPr>
              <p:nvPr/>
            </p:nvSpPr>
            <p:spPr bwMode="auto">
              <a:xfrm>
                <a:off x="1987466" y="3294661"/>
                <a:ext cx="47795" cy="723047"/>
              </a:xfrm>
              <a:custGeom>
                <a:avLst/>
                <a:gdLst/>
                <a:ahLst/>
                <a:cxnLst>
                  <a:cxn ang="0">
                    <a:pos x="0" y="28"/>
                  </a:cxn>
                  <a:cxn ang="0">
                    <a:pos x="28" y="0"/>
                  </a:cxn>
                  <a:cxn ang="0">
                    <a:pos x="464" y="0"/>
                  </a:cxn>
                  <a:cxn ang="0">
                    <a:pos x="492" y="28"/>
                  </a:cxn>
                  <a:cxn ang="0">
                    <a:pos x="492" y="8804"/>
                  </a:cxn>
                  <a:cxn ang="0">
                    <a:pos x="464" y="8832"/>
                  </a:cxn>
                  <a:cxn ang="0">
                    <a:pos x="28" y="8832"/>
                  </a:cxn>
                  <a:cxn ang="0">
                    <a:pos x="0" y="8804"/>
                  </a:cxn>
                  <a:cxn ang="0">
                    <a:pos x="0" y="28"/>
                  </a:cxn>
                  <a:cxn ang="0">
                    <a:pos x="56" y="8804"/>
                  </a:cxn>
                  <a:cxn ang="0">
                    <a:pos x="28" y="8776"/>
                  </a:cxn>
                  <a:cxn ang="0">
                    <a:pos x="464" y="8776"/>
                  </a:cxn>
                  <a:cxn ang="0">
                    <a:pos x="436" y="8804"/>
                  </a:cxn>
                  <a:cxn ang="0">
                    <a:pos x="436" y="28"/>
                  </a:cxn>
                  <a:cxn ang="0">
                    <a:pos x="464" y="56"/>
                  </a:cxn>
                  <a:cxn ang="0">
                    <a:pos x="28" y="56"/>
                  </a:cxn>
                  <a:cxn ang="0">
                    <a:pos x="56" y="28"/>
                  </a:cxn>
                  <a:cxn ang="0">
                    <a:pos x="56" y="8804"/>
                  </a:cxn>
                </a:cxnLst>
                <a:rect l="0" t="0" r="r" b="b"/>
                <a:pathLst>
                  <a:path w="492" h="8832">
                    <a:moveTo>
                      <a:pt x="0" y="28"/>
                    </a:moveTo>
                    <a:cubicBezTo>
                      <a:pt x="0" y="13"/>
                      <a:pt x="13" y="0"/>
                      <a:pt x="28" y="0"/>
                    </a:cubicBezTo>
                    <a:lnTo>
                      <a:pt x="464" y="0"/>
                    </a:lnTo>
                    <a:cubicBezTo>
                      <a:pt x="480" y="0"/>
                      <a:pt x="492" y="13"/>
                      <a:pt x="492" y="28"/>
                    </a:cubicBezTo>
                    <a:lnTo>
                      <a:pt x="492" y="8804"/>
                    </a:lnTo>
                    <a:cubicBezTo>
                      <a:pt x="492" y="8820"/>
                      <a:pt x="480" y="8832"/>
                      <a:pt x="464" y="8832"/>
                    </a:cubicBezTo>
                    <a:lnTo>
                      <a:pt x="28" y="8832"/>
                    </a:lnTo>
                    <a:cubicBezTo>
                      <a:pt x="13" y="8832"/>
                      <a:pt x="0" y="8820"/>
                      <a:pt x="0" y="8804"/>
                    </a:cubicBezTo>
                    <a:lnTo>
                      <a:pt x="0" y="28"/>
                    </a:lnTo>
                    <a:close/>
                    <a:moveTo>
                      <a:pt x="56" y="8804"/>
                    </a:moveTo>
                    <a:lnTo>
                      <a:pt x="28" y="8776"/>
                    </a:lnTo>
                    <a:lnTo>
                      <a:pt x="464" y="8776"/>
                    </a:lnTo>
                    <a:lnTo>
                      <a:pt x="436" y="8804"/>
                    </a:lnTo>
                    <a:lnTo>
                      <a:pt x="436" y="28"/>
                    </a:lnTo>
                    <a:lnTo>
                      <a:pt x="464" y="56"/>
                    </a:lnTo>
                    <a:lnTo>
                      <a:pt x="28" y="56"/>
                    </a:lnTo>
                    <a:lnTo>
                      <a:pt x="56" y="28"/>
                    </a:lnTo>
                    <a:lnTo>
                      <a:pt x="56" y="8804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03" name="Rectangle 679"/>
              <p:cNvSpPr>
                <a:spLocks noChangeArrowheads="1"/>
              </p:cNvSpPr>
              <p:nvPr/>
            </p:nvSpPr>
            <p:spPr bwMode="auto">
              <a:xfrm>
                <a:off x="2115916" y="3333845"/>
                <a:ext cx="41821" cy="681997"/>
              </a:xfrm>
              <a:prstGeom prst="rect">
                <a:avLst/>
              </a:prstGeom>
              <a:solidFill>
                <a:srgbClr val="FFFF99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04" name="Freeform 680"/>
              <p:cNvSpPr>
                <a:spLocks noEditPoints="1"/>
              </p:cNvSpPr>
              <p:nvPr/>
            </p:nvSpPr>
            <p:spPr bwMode="auto">
              <a:xfrm>
                <a:off x="2112929" y="3331979"/>
                <a:ext cx="47795" cy="685729"/>
              </a:xfrm>
              <a:custGeom>
                <a:avLst/>
                <a:gdLst/>
                <a:ahLst/>
                <a:cxnLst>
                  <a:cxn ang="0">
                    <a:pos x="0" y="28"/>
                  </a:cxn>
                  <a:cxn ang="0">
                    <a:pos x="28" y="0"/>
                  </a:cxn>
                  <a:cxn ang="0">
                    <a:pos x="464" y="0"/>
                  </a:cxn>
                  <a:cxn ang="0">
                    <a:pos x="492" y="28"/>
                  </a:cxn>
                  <a:cxn ang="0">
                    <a:pos x="492" y="8348"/>
                  </a:cxn>
                  <a:cxn ang="0">
                    <a:pos x="464" y="8376"/>
                  </a:cxn>
                  <a:cxn ang="0">
                    <a:pos x="28" y="8376"/>
                  </a:cxn>
                  <a:cxn ang="0">
                    <a:pos x="0" y="8348"/>
                  </a:cxn>
                  <a:cxn ang="0">
                    <a:pos x="0" y="28"/>
                  </a:cxn>
                  <a:cxn ang="0">
                    <a:pos x="56" y="8348"/>
                  </a:cxn>
                  <a:cxn ang="0">
                    <a:pos x="28" y="8320"/>
                  </a:cxn>
                  <a:cxn ang="0">
                    <a:pos x="464" y="8320"/>
                  </a:cxn>
                  <a:cxn ang="0">
                    <a:pos x="436" y="8348"/>
                  </a:cxn>
                  <a:cxn ang="0">
                    <a:pos x="436" y="28"/>
                  </a:cxn>
                  <a:cxn ang="0">
                    <a:pos x="464" y="56"/>
                  </a:cxn>
                  <a:cxn ang="0">
                    <a:pos x="28" y="56"/>
                  </a:cxn>
                  <a:cxn ang="0">
                    <a:pos x="56" y="28"/>
                  </a:cxn>
                  <a:cxn ang="0">
                    <a:pos x="56" y="8348"/>
                  </a:cxn>
                </a:cxnLst>
                <a:rect l="0" t="0" r="r" b="b"/>
                <a:pathLst>
                  <a:path w="492" h="8376">
                    <a:moveTo>
                      <a:pt x="0" y="28"/>
                    </a:moveTo>
                    <a:cubicBezTo>
                      <a:pt x="0" y="13"/>
                      <a:pt x="13" y="0"/>
                      <a:pt x="28" y="0"/>
                    </a:cubicBezTo>
                    <a:lnTo>
                      <a:pt x="464" y="0"/>
                    </a:lnTo>
                    <a:cubicBezTo>
                      <a:pt x="480" y="0"/>
                      <a:pt x="492" y="13"/>
                      <a:pt x="492" y="28"/>
                    </a:cubicBezTo>
                    <a:lnTo>
                      <a:pt x="492" y="8348"/>
                    </a:lnTo>
                    <a:cubicBezTo>
                      <a:pt x="492" y="8364"/>
                      <a:pt x="480" y="8376"/>
                      <a:pt x="464" y="8376"/>
                    </a:cubicBezTo>
                    <a:lnTo>
                      <a:pt x="28" y="8376"/>
                    </a:lnTo>
                    <a:cubicBezTo>
                      <a:pt x="13" y="8376"/>
                      <a:pt x="0" y="8364"/>
                      <a:pt x="0" y="8348"/>
                    </a:cubicBezTo>
                    <a:lnTo>
                      <a:pt x="0" y="28"/>
                    </a:lnTo>
                    <a:close/>
                    <a:moveTo>
                      <a:pt x="56" y="8348"/>
                    </a:moveTo>
                    <a:lnTo>
                      <a:pt x="28" y="8320"/>
                    </a:lnTo>
                    <a:lnTo>
                      <a:pt x="464" y="8320"/>
                    </a:lnTo>
                    <a:lnTo>
                      <a:pt x="436" y="8348"/>
                    </a:lnTo>
                    <a:lnTo>
                      <a:pt x="436" y="28"/>
                    </a:lnTo>
                    <a:lnTo>
                      <a:pt x="464" y="56"/>
                    </a:lnTo>
                    <a:lnTo>
                      <a:pt x="28" y="56"/>
                    </a:lnTo>
                    <a:lnTo>
                      <a:pt x="56" y="28"/>
                    </a:lnTo>
                    <a:lnTo>
                      <a:pt x="56" y="8348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05" name="Rectangle 681"/>
              <p:cNvSpPr>
                <a:spLocks noChangeArrowheads="1"/>
              </p:cNvSpPr>
              <p:nvPr/>
            </p:nvSpPr>
            <p:spPr bwMode="auto">
              <a:xfrm>
                <a:off x="2367836" y="3463527"/>
                <a:ext cx="41821" cy="552315"/>
              </a:xfrm>
              <a:prstGeom prst="rect">
                <a:avLst/>
              </a:prstGeom>
              <a:solidFill>
                <a:srgbClr val="FFFF99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06" name="Freeform 682"/>
              <p:cNvSpPr>
                <a:spLocks noEditPoints="1"/>
              </p:cNvSpPr>
              <p:nvPr/>
            </p:nvSpPr>
            <p:spPr bwMode="auto">
              <a:xfrm>
                <a:off x="2364849" y="3461661"/>
                <a:ext cx="46800" cy="556047"/>
              </a:xfrm>
              <a:custGeom>
                <a:avLst/>
                <a:gdLst/>
                <a:ahLst/>
                <a:cxnLst>
                  <a:cxn ang="0">
                    <a:pos x="0" y="28"/>
                  </a:cxn>
                  <a:cxn ang="0">
                    <a:pos x="28" y="0"/>
                  </a:cxn>
                  <a:cxn ang="0">
                    <a:pos x="464" y="0"/>
                  </a:cxn>
                  <a:cxn ang="0">
                    <a:pos x="492" y="28"/>
                  </a:cxn>
                  <a:cxn ang="0">
                    <a:pos x="492" y="6768"/>
                  </a:cxn>
                  <a:cxn ang="0">
                    <a:pos x="464" y="6796"/>
                  </a:cxn>
                  <a:cxn ang="0">
                    <a:pos x="28" y="6796"/>
                  </a:cxn>
                  <a:cxn ang="0">
                    <a:pos x="0" y="6768"/>
                  </a:cxn>
                  <a:cxn ang="0">
                    <a:pos x="0" y="28"/>
                  </a:cxn>
                  <a:cxn ang="0">
                    <a:pos x="56" y="6768"/>
                  </a:cxn>
                  <a:cxn ang="0">
                    <a:pos x="28" y="6740"/>
                  </a:cxn>
                  <a:cxn ang="0">
                    <a:pos x="464" y="6740"/>
                  </a:cxn>
                  <a:cxn ang="0">
                    <a:pos x="436" y="6768"/>
                  </a:cxn>
                  <a:cxn ang="0">
                    <a:pos x="436" y="28"/>
                  </a:cxn>
                  <a:cxn ang="0">
                    <a:pos x="464" y="56"/>
                  </a:cxn>
                  <a:cxn ang="0">
                    <a:pos x="28" y="56"/>
                  </a:cxn>
                  <a:cxn ang="0">
                    <a:pos x="56" y="28"/>
                  </a:cxn>
                  <a:cxn ang="0">
                    <a:pos x="56" y="6768"/>
                  </a:cxn>
                </a:cxnLst>
                <a:rect l="0" t="0" r="r" b="b"/>
                <a:pathLst>
                  <a:path w="492" h="6796">
                    <a:moveTo>
                      <a:pt x="0" y="28"/>
                    </a:moveTo>
                    <a:cubicBezTo>
                      <a:pt x="0" y="13"/>
                      <a:pt x="13" y="0"/>
                      <a:pt x="28" y="0"/>
                    </a:cubicBezTo>
                    <a:lnTo>
                      <a:pt x="464" y="0"/>
                    </a:lnTo>
                    <a:cubicBezTo>
                      <a:pt x="480" y="0"/>
                      <a:pt x="492" y="13"/>
                      <a:pt x="492" y="28"/>
                    </a:cubicBezTo>
                    <a:lnTo>
                      <a:pt x="492" y="6768"/>
                    </a:lnTo>
                    <a:cubicBezTo>
                      <a:pt x="492" y="6784"/>
                      <a:pt x="480" y="6796"/>
                      <a:pt x="464" y="6796"/>
                    </a:cubicBezTo>
                    <a:lnTo>
                      <a:pt x="28" y="6796"/>
                    </a:lnTo>
                    <a:cubicBezTo>
                      <a:pt x="13" y="6796"/>
                      <a:pt x="0" y="6784"/>
                      <a:pt x="0" y="6768"/>
                    </a:cubicBezTo>
                    <a:lnTo>
                      <a:pt x="0" y="28"/>
                    </a:lnTo>
                    <a:close/>
                    <a:moveTo>
                      <a:pt x="56" y="6768"/>
                    </a:moveTo>
                    <a:lnTo>
                      <a:pt x="28" y="6740"/>
                    </a:lnTo>
                    <a:lnTo>
                      <a:pt x="464" y="6740"/>
                    </a:lnTo>
                    <a:lnTo>
                      <a:pt x="436" y="6768"/>
                    </a:lnTo>
                    <a:lnTo>
                      <a:pt x="436" y="28"/>
                    </a:lnTo>
                    <a:lnTo>
                      <a:pt x="464" y="56"/>
                    </a:lnTo>
                    <a:lnTo>
                      <a:pt x="28" y="56"/>
                    </a:lnTo>
                    <a:lnTo>
                      <a:pt x="56" y="28"/>
                    </a:lnTo>
                    <a:lnTo>
                      <a:pt x="56" y="6768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07" name="Rectangle 683"/>
              <p:cNvSpPr>
                <a:spLocks noChangeArrowheads="1"/>
              </p:cNvSpPr>
              <p:nvPr/>
            </p:nvSpPr>
            <p:spPr bwMode="auto">
              <a:xfrm>
                <a:off x="2493298" y="3636126"/>
                <a:ext cx="41821" cy="379717"/>
              </a:xfrm>
              <a:prstGeom prst="rect">
                <a:avLst/>
              </a:prstGeom>
              <a:solidFill>
                <a:srgbClr val="FFFF99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08" name="Freeform 684"/>
              <p:cNvSpPr>
                <a:spLocks noEditPoints="1"/>
              </p:cNvSpPr>
              <p:nvPr/>
            </p:nvSpPr>
            <p:spPr bwMode="auto">
              <a:xfrm>
                <a:off x="2490312" y="3634260"/>
                <a:ext cx="47795" cy="383448"/>
              </a:xfrm>
              <a:custGeom>
                <a:avLst/>
                <a:gdLst/>
                <a:ahLst/>
                <a:cxnLst>
                  <a:cxn ang="0">
                    <a:pos x="0" y="28"/>
                  </a:cxn>
                  <a:cxn ang="0">
                    <a:pos x="28" y="0"/>
                  </a:cxn>
                  <a:cxn ang="0">
                    <a:pos x="464" y="0"/>
                  </a:cxn>
                  <a:cxn ang="0">
                    <a:pos x="492" y="28"/>
                  </a:cxn>
                  <a:cxn ang="0">
                    <a:pos x="492" y="4660"/>
                  </a:cxn>
                  <a:cxn ang="0">
                    <a:pos x="464" y="4688"/>
                  </a:cxn>
                  <a:cxn ang="0">
                    <a:pos x="28" y="4688"/>
                  </a:cxn>
                  <a:cxn ang="0">
                    <a:pos x="0" y="4660"/>
                  </a:cxn>
                  <a:cxn ang="0">
                    <a:pos x="0" y="28"/>
                  </a:cxn>
                  <a:cxn ang="0">
                    <a:pos x="56" y="4660"/>
                  </a:cxn>
                  <a:cxn ang="0">
                    <a:pos x="28" y="4632"/>
                  </a:cxn>
                  <a:cxn ang="0">
                    <a:pos x="464" y="4632"/>
                  </a:cxn>
                  <a:cxn ang="0">
                    <a:pos x="436" y="4660"/>
                  </a:cxn>
                  <a:cxn ang="0">
                    <a:pos x="436" y="28"/>
                  </a:cxn>
                  <a:cxn ang="0">
                    <a:pos x="464" y="56"/>
                  </a:cxn>
                  <a:cxn ang="0">
                    <a:pos x="28" y="56"/>
                  </a:cxn>
                  <a:cxn ang="0">
                    <a:pos x="56" y="28"/>
                  </a:cxn>
                  <a:cxn ang="0">
                    <a:pos x="56" y="4660"/>
                  </a:cxn>
                </a:cxnLst>
                <a:rect l="0" t="0" r="r" b="b"/>
                <a:pathLst>
                  <a:path w="492" h="4688">
                    <a:moveTo>
                      <a:pt x="0" y="28"/>
                    </a:moveTo>
                    <a:cubicBezTo>
                      <a:pt x="0" y="13"/>
                      <a:pt x="13" y="0"/>
                      <a:pt x="28" y="0"/>
                    </a:cubicBezTo>
                    <a:lnTo>
                      <a:pt x="464" y="0"/>
                    </a:lnTo>
                    <a:cubicBezTo>
                      <a:pt x="480" y="0"/>
                      <a:pt x="492" y="13"/>
                      <a:pt x="492" y="28"/>
                    </a:cubicBezTo>
                    <a:lnTo>
                      <a:pt x="492" y="4660"/>
                    </a:lnTo>
                    <a:cubicBezTo>
                      <a:pt x="492" y="4676"/>
                      <a:pt x="480" y="4688"/>
                      <a:pt x="464" y="4688"/>
                    </a:cubicBezTo>
                    <a:lnTo>
                      <a:pt x="28" y="4688"/>
                    </a:lnTo>
                    <a:cubicBezTo>
                      <a:pt x="13" y="4688"/>
                      <a:pt x="0" y="4676"/>
                      <a:pt x="0" y="4660"/>
                    </a:cubicBezTo>
                    <a:lnTo>
                      <a:pt x="0" y="28"/>
                    </a:lnTo>
                    <a:close/>
                    <a:moveTo>
                      <a:pt x="56" y="4660"/>
                    </a:moveTo>
                    <a:lnTo>
                      <a:pt x="28" y="4632"/>
                    </a:lnTo>
                    <a:lnTo>
                      <a:pt x="464" y="4632"/>
                    </a:lnTo>
                    <a:lnTo>
                      <a:pt x="436" y="4660"/>
                    </a:lnTo>
                    <a:lnTo>
                      <a:pt x="436" y="28"/>
                    </a:lnTo>
                    <a:lnTo>
                      <a:pt x="464" y="56"/>
                    </a:lnTo>
                    <a:lnTo>
                      <a:pt x="28" y="56"/>
                    </a:lnTo>
                    <a:lnTo>
                      <a:pt x="56" y="28"/>
                    </a:lnTo>
                    <a:lnTo>
                      <a:pt x="56" y="4660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09" name="Rectangle 685"/>
              <p:cNvSpPr>
                <a:spLocks noChangeArrowheads="1"/>
              </p:cNvSpPr>
              <p:nvPr/>
            </p:nvSpPr>
            <p:spPr bwMode="auto">
              <a:xfrm>
                <a:off x="2618761" y="3543762"/>
                <a:ext cx="42817" cy="472080"/>
              </a:xfrm>
              <a:prstGeom prst="rect">
                <a:avLst/>
              </a:prstGeom>
              <a:solidFill>
                <a:srgbClr val="FFFF99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10" name="Freeform 686"/>
              <p:cNvSpPr>
                <a:spLocks noEditPoints="1"/>
              </p:cNvSpPr>
              <p:nvPr/>
            </p:nvSpPr>
            <p:spPr bwMode="auto">
              <a:xfrm>
                <a:off x="2615774" y="3541896"/>
                <a:ext cx="47795" cy="475812"/>
              </a:xfrm>
              <a:custGeom>
                <a:avLst/>
                <a:gdLst/>
                <a:ahLst/>
                <a:cxnLst>
                  <a:cxn ang="0">
                    <a:pos x="0" y="28"/>
                  </a:cxn>
                  <a:cxn ang="0">
                    <a:pos x="28" y="0"/>
                  </a:cxn>
                  <a:cxn ang="0">
                    <a:pos x="468" y="0"/>
                  </a:cxn>
                  <a:cxn ang="0">
                    <a:pos x="496" y="28"/>
                  </a:cxn>
                  <a:cxn ang="0">
                    <a:pos x="496" y="5784"/>
                  </a:cxn>
                  <a:cxn ang="0">
                    <a:pos x="468" y="5812"/>
                  </a:cxn>
                  <a:cxn ang="0">
                    <a:pos x="28" y="5812"/>
                  </a:cxn>
                  <a:cxn ang="0">
                    <a:pos x="0" y="5784"/>
                  </a:cxn>
                  <a:cxn ang="0">
                    <a:pos x="0" y="28"/>
                  </a:cxn>
                  <a:cxn ang="0">
                    <a:pos x="56" y="5784"/>
                  </a:cxn>
                  <a:cxn ang="0">
                    <a:pos x="28" y="5756"/>
                  </a:cxn>
                  <a:cxn ang="0">
                    <a:pos x="468" y="5756"/>
                  </a:cxn>
                  <a:cxn ang="0">
                    <a:pos x="440" y="5784"/>
                  </a:cxn>
                  <a:cxn ang="0">
                    <a:pos x="440" y="28"/>
                  </a:cxn>
                  <a:cxn ang="0">
                    <a:pos x="468" y="56"/>
                  </a:cxn>
                  <a:cxn ang="0">
                    <a:pos x="28" y="56"/>
                  </a:cxn>
                  <a:cxn ang="0">
                    <a:pos x="56" y="28"/>
                  </a:cxn>
                  <a:cxn ang="0">
                    <a:pos x="56" y="5784"/>
                  </a:cxn>
                </a:cxnLst>
                <a:rect l="0" t="0" r="r" b="b"/>
                <a:pathLst>
                  <a:path w="496" h="5812">
                    <a:moveTo>
                      <a:pt x="0" y="28"/>
                    </a:moveTo>
                    <a:cubicBezTo>
                      <a:pt x="0" y="13"/>
                      <a:pt x="13" y="0"/>
                      <a:pt x="28" y="0"/>
                    </a:cubicBezTo>
                    <a:lnTo>
                      <a:pt x="468" y="0"/>
                    </a:lnTo>
                    <a:cubicBezTo>
                      <a:pt x="484" y="0"/>
                      <a:pt x="496" y="13"/>
                      <a:pt x="496" y="28"/>
                    </a:cubicBezTo>
                    <a:lnTo>
                      <a:pt x="496" y="5784"/>
                    </a:lnTo>
                    <a:cubicBezTo>
                      <a:pt x="496" y="5800"/>
                      <a:pt x="484" y="5812"/>
                      <a:pt x="468" y="5812"/>
                    </a:cubicBezTo>
                    <a:lnTo>
                      <a:pt x="28" y="5812"/>
                    </a:lnTo>
                    <a:cubicBezTo>
                      <a:pt x="13" y="5812"/>
                      <a:pt x="0" y="5800"/>
                      <a:pt x="0" y="5784"/>
                    </a:cubicBezTo>
                    <a:lnTo>
                      <a:pt x="0" y="28"/>
                    </a:lnTo>
                    <a:close/>
                    <a:moveTo>
                      <a:pt x="56" y="5784"/>
                    </a:moveTo>
                    <a:lnTo>
                      <a:pt x="28" y="5756"/>
                    </a:lnTo>
                    <a:lnTo>
                      <a:pt x="468" y="5756"/>
                    </a:lnTo>
                    <a:lnTo>
                      <a:pt x="440" y="5784"/>
                    </a:lnTo>
                    <a:lnTo>
                      <a:pt x="440" y="28"/>
                    </a:lnTo>
                    <a:lnTo>
                      <a:pt x="468" y="56"/>
                    </a:lnTo>
                    <a:lnTo>
                      <a:pt x="28" y="56"/>
                    </a:lnTo>
                    <a:lnTo>
                      <a:pt x="56" y="28"/>
                    </a:lnTo>
                    <a:lnTo>
                      <a:pt x="56" y="5784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11" name="Rectangle 687"/>
              <p:cNvSpPr>
                <a:spLocks noChangeArrowheads="1"/>
              </p:cNvSpPr>
              <p:nvPr/>
            </p:nvSpPr>
            <p:spPr bwMode="auto">
              <a:xfrm>
                <a:off x="2870681" y="3512041"/>
                <a:ext cx="41821" cy="503801"/>
              </a:xfrm>
              <a:prstGeom prst="rect">
                <a:avLst/>
              </a:prstGeom>
              <a:solidFill>
                <a:srgbClr val="FFFF99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12" name="Freeform 688"/>
              <p:cNvSpPr>
                <a:spLocks noEditPoints="1"/>
              </p:cNvSpPr>
              <p:nvPr/>
            </p:nvSpPr>
            <p:spPr bwMode="auto">
              <a:xfrm>
                <a:off x="2867694" y="3510175"/>
                <a:ext cx="47795" cy="507532"/>
              </a:xfrm>
              <a:custGeom>
                <a:avLst/>
                <a:gdLst/>
                <a:ahLst/>
                <a:cxnLst>
                  <a:cxn ang="0">
                    <a:pos x="0" y="28"/>
                  </a:cxn>
                  <a:cxn ang="0">
                    <a:pos x="28" y="0"/>
                  </a:cxn>
                  <a:cxn ang="0">
                    <a:pos x="468" y="0"/>
                  </a:cxn>
                  <a:cxn ang="0">
                    <a:pos x="496" y="28"/>
                  </a:cxn>
                  <a:cxn ang="0">
                    <a:pos x="496" y="6172"/>
                  </a:cxn>
                  <a:cxn ang="0">
                    <a:pos x="468" y="6200"/>
                  </a:cxn>
                  <a:cxn ang="0">
                    <a:pos x="28" y="6200"/>
                  </a:cxn>
                  <a:cxn ang="0">
                    <a:pos x="0" y="6172"/>
                  </a:cxn>
                  <a:cxn ang="0">
                    <a:pos x="0" y="28"/>
                  </a:cxn>
                  <a:cxn ang="0">
                    <a:pos x="56" y="6172"/>
                  </a:cxn>
                  <a:cxn ang="0">
                    <a:pos x="28" y="6144"/>
                  </a:cxn>
                  <a:cxn ang="0">
                    <a:pos x="468" y="6144"/>
                  </a:cxn>
                  <a:cxn ang="0">
                    <a:pos x="440" y="6172"/>
                  </a:cxn>
                  <a:cxn ang="0">
                    <a:pos x="440" y="28"/>
                  </a:cxn>
                  <a:cxn ang="0">
                    <a:pos x="468" y="56"/>
                  </a:cxn>
                  <a:cxn ang="0">
                    <a:pos x="28" y="56"/>
                  </a:cxn>
                  <a:cxn ang="0">
                    <a:pos x="56" y="28"/>
                  </a:cxn>
                  <a:cxn ang="0">
                    <a:pos x="56" y="6172"/>
                  </a:cxn>
                </a:cxnLst>
                <a:rect l="0" t="0" r="r" b="b"/>
                <a:pathLst>
                  <a:path w="496" h="6200">
                    <a:moveTo>
                      <a:pt x="0" y="28"/>
                    </a:moveTo>
                    <a:cubicBezTo>
                      <a:pt x="0" y="13"/>
                      <a:pt x="13" y="0"/>
                      <a:pt x="28" y="0"/>
                    </a:cubicBezTo>
                    <a:lnTo>
                      <a:pt x="468" y="0"/>
                    </a:lnTo>
                    <a:cubicBezTo>
                      <a:pt x="484" y="0"/>
                      <a:pt x="496" y="13"/>
                      <a:pt x="496" y="28"/>
                    </a:cubicBezTo>
                    <a:lnTo>
                      <a:pt x="496" y="6172"/>
                    </a:lnTo>
                    <a:cubicBezTo>
                      <a:pt x="496" y="6188"/>
                      <a:pt x="484" y="6200"/>
                      <a:pt x="468" y="6200"/>
                    </a:cubicBezTo>
                    <a:lnTo>
                      <a:pt x="28" y="6200"/>
                    </a:lnTo>
                    <a:cubicBezTo>
                      <a:pt x="13" y="6200"/>
                      <a:pt x="0" y="6188"/>
                      <a:pt x="0" y="6172"/>
                    </a:cubicBezTo>
                    <a:lnTo>
                      <a:pt x="0" y="28"/>
                    </a:lnTo>
                    <a:close/>
                    <a:moveTo>
                      <a:pt x="56" y="6172"/>
                    </a:moveTo>
                    <a:lnTo>
                      <a:pt x="28" y="6144"/>
                    </a:lnTo>
                    <a:lnTo>
                      <a:pt x="468" y="6144"/>
                    </a:lnTo>
                    <a:lnTo>
                      <a:pt x="440" y="6172"/>
                    </a:lnTo>
                    <a:lnTo>
                      <a:pt x="440" y="28"/>
                    </a:lnTo>
                    <a:lnTo>
                      <a:pt x="468" y="56"/>
                    </a:lnTo>
                    <a:lnTo>
                      <a:pt x="28" y="56"/>
                    </a:lnTo>
                    <a:lnTo>
                      <a:pt x="56" y="28"/>
                    </a:lnTo>
                    <a:lnTo>
                      <a:pt x="56" y="6172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13" name="Rectangle 689"/>
              <p:cNvSpPr>
                <a:spLocks noChangeArrowheads="1"/>
              </p:cNvSpPr>
              <p:nvPr/>
            </p:nvSpPr>
            <p:spPr bwMode="auto">
              <a:xfrm>
                <a:off x="2996144" y="3443935"/>
                <a:ext cx="41821" cy="571907"/>
              </a:xfrm>
              <a:prstGeom prst="rect">
                <a:avLst/>
              </a:prstGeom>
              <a:solidFill>
                <a:srgbClr val="FFFF99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14" name="Freeform 690"/>
              <p:cNvSpPr>
                <a:spLocks noEditPoints="1"/>
              </p:cNvSpPr>
              <p:nvPr/>
            </p:nvSpPr>
            <p:spPr bwMode="auto">
              <a:xfrm>
                <a:off x="2993156" y="3441136"/>
                <a:ext cx="47795" cy="576572"/>
              </a:xfrm>
              <a:custGeom>
                <a:avLst/>
                <a:gdLst/>
                <a:ahLst/>
                <a:cxnLst>
                  <a:cxn ang="0">
                    <a:pos x="0" y="28"/>
                  </a:cxn>
                  <a:cxn ang="0">
                    <a:pos x="28" y="0"/>
                  </a:cxn>
                  <a:cxn ang="0">
                    <a:pos x="464" y="0"/>
                  </a:cxn>
                  <a:cxn ang="0">
                    <a:pos x="492" y="28"/>
                  </a:cxn>
                  <a:cxn ang="0">
                    <a:pos x="492" y="7012"/>
                  </a:cxn>
                  <a:cxn ang="0">
                    <a:pos x="464" y="7040"/>
                  </a:cxn>
                  <a:cxn ang="0">
                    <a:pos x="28" y="7040"/>
                  </a:cxn>
                  <a:cxn ang="0">
                    <a:pos x="0" y="7012"/>
                  </a:cxn>
                  <a:cxn ang="0">
                    <a:pos x="0" y="28"/>
                  </a:cxn>
                  <a:cxn ang="0">
                    <a:pos x="56" y="7012"/>
                  </a:cxn>
                  <a:cxn ang="0">
                    <a:pos x="28" y="6984"/>
                  </a:cxn>
                  <a:cxn ang="0">
                    <a:pos x="464" y="6984"/>
                  </a:cxn>
                  <a:cxn ang="0">
                    <a:pos x="436" y="7012"/>
                  </a:cxn>
                  <a:cxn ang="0">
                    <a:pos x="436" y="28"/>
                  </a:cxn>
                  <a:cxn ang="0">
                    <a:pos x="464" y="56"/>
                  </a:cxn>
                  <a:cxn ang="0">
                    <a:pos x="28" y="56"/>
                  </a:cxn>
                  <a:cxn ang="0">
                    <a:pos x="56" y="28"/>
                  </a:cxn>
                  <a:cxn ang="0">
                    <a:pos x="56" y="7012"/>
                  </a:cxn>
                </a:cxnLst>
                <a:rect l="0" t="0" r="r" b="b"/>
                <a:pathLst>
                  <a:path w="492" h="7040">
                    <a:moveTo>
                      <a:pt x="0" y="28"/>
                    </a:moveTo>
                    <a:cubicBezTo>
                      <a:pt x="0" y="13"/>
                      <a:pt x="13" y="0"/>
                      <a:pt x="28" y="0"/>
                    </a:cubicBezTo>
                    <a:lnTo>
                      <a:pt x="464" y="0"/>
                    </a:lnTo>
                    <a:cubicBezTo>
                      <a:pt x="480" y="0"/>
                      <a:pt x="492" y="13"/>
                      <a:pt x="492" y="28"/>
                    </a:cubicBezTo>
                    <a:lnTo>
                      <a:pt x="492" y="7012"/>
                    </a:lnTo>
                    <a:cubicBezTo>
                      <a:pt x="492" y="7028"/>
                      <a:pt x="480" y="7040"/>
                      <a:pt x="464" y="7040"/>
                    </a:cubicBezTo>
                    <a:lnTo>
                      <a:pt x="28" y="7040"/>
                    </a:lnTo>
                    <a:cubicBezTo>
                      <a:pt x="13" y="7040"/>
                      <a:pt x="0" y="7028"/>
                      <a:pt x="0" y="7012"/>
                    </a:cubicBezTo>
                    <a:lnTo>
                      <a:pt x="0" y="28"/>
                    </a:lnTo>
                    <a:close/>
                    <a:moveTo>
                      <a:pt x="56" y="7012"/>
                    </a:moveTo>
                    <a:lnTo>
                      <a:pt x="28" y="6984"/>
                    </a:lnTo>
                    <a:lnTo>
                      <a:pt x="464" y="6984"/>
                    </a:lnTo>
                    <a:lnTo>
                      <a:pt x="436" y="7012"/>
                    </a:lnTo>
                    <a:lnTo>
                      <a:pt x="436" y="28"/>
                    </a:lnTo>
                    <a:lnTo>
                      <a:pt x="464" y="56"/>
                    </a:lnTo>
                    <a:lnTo>
                      <a:pt x="28" y="56"/>
                    </a:lnTo>
                    <a:lnTo>
                      <a:pt x="56" y="28"/>
                    </a:lnTo>
                    <a:lnTo>
                      <a:pt x="56" y="7012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15" name="Rectangle 691"/>
              <p:cNvSpPr>
                <a:spLocks noChangeArrowheads="1"/>
              </p:cNvSpPr>
              <p:nvPr/>
            </p:nvSpPr>
            <p:spPr bwMode="auto">
              <a:xfrm>
                <a:off x="543654" y="2957861"/>
                <a:ext cx="1991" cy="1057981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16" name="Freeform 692"/>
              <p:cNvSpPr>
                <a:spLocks noEditPoints="1"/>
              </p:cNvSpPr>
              <p:nvPr/>
            </p:nvSpPr>
            <p:spPr bwMode="auto">
              <a:xfrm>
                <a:off x="527722" y="2956928"/>
                <a:ext cx="16928" cy="1058914"/>
              </a:xfrm>
              <a:custGeom>
                <a:avLst/>
                <a:gdLst/>
                <a:ahLst/>
                <a:cxnLst>
                  <a:cxn ang="0">
                    <a:pos x="0" y="1134"/>
                  </a:cxn>
                  <a:cxn ang="0">
                    <a:pos x="17" y="1134"/>
                  </a:cxn>
                  <a:cxn ang="0">
                    <a:pos x="17" y="1135"/>
                  </a:cxn>
                  <a:cxn ang="0">
                    <a:pos x="0" y="1135"/>
                  </a:cxn>
                  <a:cxn ang="0">
                    <a:pos x="0" y="1134"/>
                  </a:cxn>
                  <a:cxn ang="0">
                    <a:pos x="0" y="972"/>
                  </a:cxn>
                  <a:cxn ang="0">
                    <a:pos x="17" y="972"/>
                  </a:cxn>
                  <a:cxn ang="0">
                    <a:pos x="17" y="973"/>
                  </a:cxn>
                  <a:cxn ang="0">
                    <a:pos x="0" y="973"/>
                  </a:cxn>
                  <a:cxn ang="0">
                    <a:pos x="0" y="972"/>
                  </a:cxn>
                  <a:cxn ang="0">
                    <a:pos x="0" y="810"/>
                  </a:cxn>
                  <a:cxn ang="0">
                    <a:pos x="17" y="810"/>
                  </a:cxn>
                  <a:cxn ang="0">
                    <a:pos x="17" y="811"/>
                  </a:cxn>
                  <a:cxn ang="0">
                    <a:pos x="0" y="811"/>
                  </a:cxn>
                  <a:cxn ang="0">
                    <a:pos x="0" y="810"/>
                  </a:cxn>
                  <a:cxn ang="0">
                    <a:pos x="0" y="648"/>
                  </a:cxn>
                  <a:cxn ang="0">
                    <a:pos x="17" y="648"/>
                  </a:cxn>
                  <a:cxn ang="0">
                    <a:pos x="17" y="649"/>
                  </a:cxn>
                  <a:cxn ang="0">
                    <a:pos x="0" y="649"/>
                  </a:cxn>
                  <a:cxn ang="0">
                    <a:pos x="0" y="648"/>
                  </a:cxn>
                  <a:cxn ang="0">
                    <a:pos x="0" y="486"/>
                  </a:cxn>
                  <a:cxn ang="0">
                    <a:pos x="17" y="486"/>
                  </a:cxn>
                  <a:cxn ang="0">
                    <a:pos x="17" y="487"/>
                  </a:cxn>
                  <a:cxn ang="0">
                    <a:pos x="0" y="487"/>
                  </a:cxn>
                  <a:cxn ang="0">
                    <a:pos x="0" y="486"/>
                  </a:cxn>
                  <a:cxn ang="0">
                    <a:pos x="0" y="324"/>
                  </a:cxn>
                  <a:cxn ang="0">
                    <a:pos x="17" y="324"/>
                  </a:cxn>
                  <a:cxn ang="0">
                    <a:pos x="17" y="325"/>
                  </a:cxn>
                  <a:cxn ang="0">
                    <a:pos x="0" y="325"/>
                  </a:cxn>
                  <a:cxn ang="0">
                    <a:pos x="0" y="324"/>
                  </a:cxn>
                  <a:cxn ang="0">
                    <a:pos x="0" y="162"/>
                  </a:cxn>
                  <a:cxn ang="0">
                    <a:pos x="17" y="162"/>
                  </a:cxn>
                  <a:cxn ang="0">
                    <a:pos x="17" y="163"/>
                  </a:cxn>
                  <a:cxn ang="0">
                    <a:pos x="0" y="163"/>
                  </a:cxn>
                  <a:cxn ang="0">
                    <a:pos x="0" y="162"/>
                  </a:cxn>
                  <a:cxn ang="0">
                    <a:pos x="0" y="0"/>
                  </a:cxn>
                  <a:cxn ang="0">
                    <a:pos x="17" y="0"/>
                  </a:cxn>
                  <a:cxn ang="0">
                    <a:pos x="17" y="1"/>
                  </a:cxn>
                  <a:cxn ang="0">
                    <a:pos x="0" y="1"/>
                  </a:cxn>
                  <a:cxn ang="0">
                    <a:pos x="0" y="0"/>
                  </a:cxn>
                </a:cxnLst>
                <a:rect l="0" t="0" r="r" b="b"/>
                <a:pathLst>
                  <a:path w="17" h="1135">
                    <a:moveTo>
                      <a:pt x="0" y="1134"/>
                    </a:moveTo>
                    <a:lnTo>
                      <a:pt x="17" y="1134"/>
                    </a:lnTo>
                    <a:lnTo>
                      <a:pt x="17" y="1135"/>
                    </a:lnTo>
                    <a:lnTo>
                      <a:pt x="0" y="1135"/>
                    </a:lnTo>
                    <a:lnTo>
                      <a:pt x="0" y="1134"/>
                    </a:lnTo>
                    <a:close/>
                    <a:moveTo>
                      <a:pt x="0" y="972"/>
                    </a:moveTo>
                    <a:lnTo>
                      <a:pt x="17" y="972"/>
                    </a:lnTo>
                    <a:lnTo>
                      <a:pt x="17" y="973"/>
                    </a:lnTo>
                    <a:lnTo>
                      <a:pt x="0" y="973"/>
                    </a:lnTo>
                    <a:lnTo>
                      <a:pt x="0" y="972"/>
                    </a:lnTo>
                    <a:close/>
                    <a:moveTo>
                      <a:pt x="0" y="810"/>
                    </a:moveTo>
                    <a:lnTo>
                      <a:pt x="17" y="810"/>
                    </a:lnTo>
                    <a:lnTo>
                      <a:pt x="17" y="811"/>
                    </a:lnTo>
                    <a:lnTo>
                      <a:pt x="0" y="811"/>
                    </a:lnTo>
                    <a:lnTo>
                      <a:pt x="0" y="810"/>
                    </a:lnTo>
                    <a:close/>
                    <a:moveTo>
                      <a:pt x="0" y="648"/>
                    </a:moveTo>
                    <a:lnTo>
                      <a:pt x="17" y="648"/>
                    </a:lnTo>
                    <a:lnTo>
                      <a:pt x="17" y="649"/>
                    </a:lnTo>
                    <a:lnTo>
                      <a:pt x="0" y="649"/>
                    </a:lnTo>
                    <a:lnTo>
                      <a:pt x="0" y="648"/>
                    </a:lnTo>
                    <a:close/>
                    <a:moveTo>
                      <a:pt x="0" y="486"/>
                    </a:moveTo>
                    <a:lnTo>
                      <a:pt x="17" y="486"/>
                    </a:lnTo>
                    <a:lnTo>
                      <a:pt x="17" y="487"/>
                    </a:lnTo>
                    <a:lnTo>
                      <a:pt x="0" y="487"/>
                    </a:lnTo>
                    <a:lnTo>
                      <a:pt x="0" y="486"/>
                    </a:lnTo>
                    <a:close/>
                    <a:moveTo>
                      <a:pt x="0" y="324"/>
                    </a:moveTo>
                    <a:lnTo>
                      <a:pt x="17" y="324"/>
                    </a:lnTo>
                    <a:lnTo>
                      <a:pt x="17" y="325"/>
                    </a:lnTo>
                    <a:lnTo>
                      <a:pt x="0" y="325"/>
                    </a:lnTo>
                    <a:lnTo>
                      <a:pt x="0" y="324"/>
                    </a:lnTo>
                    <a:close/>
                    <a:moveTo>
                      <a:pt x="0" y="162"/>
                    </a:moveTo>
                    <a:lnTo>
                      <a:pt x="17" y="162"/>
                    </a:lnTo>
                    <a:lnTo>
                      <a:pt x="17" y="163"/>
                    </a:lnTo>
                    <a:lnTo>
                      <a:pt x="0" y="163"/>
                    </a:lnTo>
                    <a:lnTo>
                      <a:pt x="0" y="162"/>
                    </a:lnTo>
                    <a:close/>
                    <a:moveTo>
                      <a:pt x="0" y="0"/>
                    </a:moveTo>
                    <a:lnTo>
                      <a:pt x="17" y="0"/>
                    </a:lnTo>
                    <a:lnTo>
                      <a:pt x="17" y="1"/>
                    </a:lnTo>
                    <a:lnTo>
                      <a:pt x="0" y="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17" name="Rectangle 693"/>
              <p:cNvSpPr>
                <a:spLocks noChangeArrowheads="1"/>
              </p:cNvSpPr>
              <p:nvPr/>
            </p:nvSpPr>
            <p:spPr bwMode="auto">
              <a:xfrm>
                <a:off x="544650" y="4014909"/>
                <a:ext cx="2514225" cy="933"/>
              </a:xfrm>
              <a:prstGeom prst="rect">
                <a:avLst/>
              </a:pr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18" name="Freeform 694"/>
              <p:cNvSpPr>
                <a:spLocks noEditPoints="1"/>
              </p:cNvSpPr>
              <p:nvPr/>
            </p:nvSpPr>
            <p:spPr bwMode="auto">
              <a:xfrm>
                <a:off x="543654" y="4015842"/>
                <a:ext cx="2516217" cy="13995"/>
              </a:xfrm>
              <a:custGeom>
                <a:avLst/>
                <a:gdLst/>
                <a:ahLst/>
                <a:cxnLst>
                  <a:cxn ang="0">
                    <a:pos x="2" y="15"/>
                  </a:cxn>
                  <a:cxn ang="0">
                    <a:pos x="0" y="0"/>
                  </a:cxn>
                  <a:cxn ang="0">
                    <a:pos x="128" y="0"/>
                  </a:cxn>
                  <a:cxn ang="0">
                    <a:pos x="127" y="15"/>
                  </a:cxn>
                  <a:cxn ang="0">
                    <a:pos x="128" y="0"/>
                  </a:cxn>
                  <a:cxn ang="0">
                    <a:pos x="254" y="15"/>
                  </a:cxn>
                  <a:cxn ang="0">
                    <a:pos x="253" y="0"/>
                  </a:cxn>
                  <a:cxn ang="0">
                    <a:pos x="380" y="0"/>
                  </a:cxn>
                  <a:cxn ang="0">
                    <a:pos x="379" y="15"/>
                  </a:cxn>
                  <a:cxn ang="0">
                    <a:pos x="380" y="0"/>
                  </a:cxn>
                  <a:cxn ang="0">
                    <a:pos x="507" y="15"/>
                  </a:cxn>
                  <a:cxn ang="0">
                    <a:pos x="506" y="0"/>
                  </a:cxn>
                  <a:cxn ang="0">
                    <a:pos x="633" y="0"/>
                  </a:cxn>
                  <a:cxn ang="0">
                    <a:pos x="632" y="15"/>
                  </a:cxn>
                  <a:cxn ang="0">
                    <a:pos x="633" y="0"/>
                  </a:cxn>
                  <a:cxn ang="0">
                    <a:pos x="759" y="15"/>
                  </a:cxn>
                  <a:cxn ang="0">
                    <a:pos x="758" y="0"/>
                  </a:cxn>
                  <a:cxn ang="0">
                    <a:pos x="885" y="0"/>
                  </a:cxn>
                  <a:cxn ang="0">
                    <a:pos x="884" y="15"/>
                  </a:cxn>
                  <a:cxn ang="0">
                    <a:pos x="885" y="0"/>
                  </a:cxn>
                  <a:cxn ang="0">
                    <a:pos x="1012" y="15"/>
                  </a:cxn>
                  <a:cxn ang="0">
                    <a:pos x="1011" y="0"/>
                  </a:cxn>
                  <a:cxn ang="0">
                    <a:pos x="1138" y="0"/>
                  </a:cxn>
                  <a:cxn ang="0">
                    <a:pos x="1137" y="15"/>
                  </a:cxn>
                  <a:cxn ang="0">
                    <a:pos x="1138" y="0"/>
                  </a:cxn>
                  <a:cxn ang="0">
                    <a:pos x="1264" y="15"/>
                  </a:cxn>
                  <a:cxn ang="0">
                    <a:pos x="1263" y="0"/>
                  </a:cxn>
                  <a:cxn ang="0">
                    <a:pos x="1390" y="0"/>
                  </a:cxn>
                  <a:cxn ang="0">
                    <a:pos x="1389" y="15"/>
                  </a:cxn>
                  <a:cxn ang="0">
                    <a:pos x="1390" y="0"/>
                  </a:cxn>
                  <a:cxn ang="0">
                    <a:pos x="1517" y="15"/>
                  </a:cxn>
                  <a:cxn ang="0">
                    <a:pos x="1516" y="0"/>
                  </a:cxn>
                  <a:cxn ang="0">
                    <a:pos x="1643" y="0"/>
                  </a:cxn>
                  <a:cxn ang="0">
                    <a:pos x="1642" y="15"/>
                  </a:cxn>
                  <a:cxn ang="0">
                    <a:pos x="1643" y="0"/>
                  </a:cxn>
                  <a:cxn ang="0">
                    <a:pos x="1769" y="15"/>
                  </a:cxn>
                  <a:cxn ang="0">
                    <a:pos x="1768" y="0"/>
                  </a:cxn>
                  <a:cxn ang="0">
                    <a:pos x="1896" y="0"/>
                  </a:cxn>
                  <a:cxn ang="0">
                    <a:pos x="1894" y="15"/>
                  </a:cxn>
                  <a:cxn ang="0">
                    <a:pos x="1896" y="0"/>
                  </a:cxn>
                  <a:cxn ang="0">
                    <a:pos x="2022" y="15"/>
                  </a:cxn>
                  <a:cxn ang="0">
                    <a:pos x="2021" y="0"/>
                  </a:cxn>
                  <a:cxn ang="0">
                    <a:pos x="2148" y="0"/>
                  </a:cxn>
                  <a:cxn ang="0">
                    <a:pos x="2147" y="15"/>
                  </a:cxn>
                  <a:cxn ang="0">
                    <a:pos x="2148" y="0"/>
                  </a:cxn>
                  <a:cxn ang="0">
                    <a:pos x="2274" y="15"/>
                  </a:cxn>
                  <a:cxn ang="0">
                    <a:pos x="2273" y="0"/>
                  </a:cxn>
                  <a:cxn ang="0">
                    <a:pos x="2401" y="0"/>
                  </a:cxn>
                  <a:cxn ang="0">
                    <a:pos x="2399" y="15"/>
                  </a:cxn>
                  <a:cxn ang="0">
                    <a:pos x="2401" y="0"/>
                  </a:cxn>
                  <a:cxn ang="0">
                    <a:pos x="2527" y="15"/>
                  </a:cxn>
                  <a:cxn ang="0">
                    <a:pos x="2525" y="0"/>
                  </a:cxn>
                </a:cxnLst>
                <a:rect l="0" t="0" r="r" b="b"/>
                <a:pathLst>
                  <a:path w="2527" h="15">
                    <a:moveTo>
                      <a:pt x="2" y="0"/>
                    </a:moveTo>
                    <a:lnTo>
                      <a:pt x="2" y="15"/>
                    </a:lnTo>
                    <a:lnTo>
                      <a:pt x="0" y="15"/>
                    </a:lnTo>
                    <a:lnTo>
                      <a:pt x="0" y="0"/>
                    </a:lnTo>
                    <a:lnTo>
                      <a:pt x="2" y="0"/>
                    </a:lnTo>
                    <a:close/>
                    <a:moveTo>
                      <a:pt x="128" y="0"/>
                    </a:moveTo>
                    <a:lnTo>
                      <a:pt x="128" y="15"/>
                    </a:lnTo>
                    <a:lnTo>
                      <a:pt x="127" y="15"/>
                    </a:lnTo>
                    <a:lnTo>
                      <a:pt x="127" y="0"/>
                    </a:lnTo>
                    <a:lnTo>
                      <a:pt x="128" y="0"/>
                    </a:lnTo>
                    <a:close/>
                    <a:moveTo>
                      <a:pt x="254" y="0"/>
                    </a:moveTo>
                    <a:lnTo>
                      <a:pt x="254" y="15"/>
                    </a:lnTo>
                    <a:lnTo>
                      <a:pt x="253" y="15"/>
                    </a:lnTo>
                    <a:lnTo>
                      <a:pt x="253" y="0"/>
                    </a:lnTo>
                    <a:lnTo>
                      <a:pt x="254" y="0"/>
                    </a:lnTo>
                    <a:close/>
                    <a:moveTo>
                      <a:pt x="380" y="0"/>
                    </a:moveTo>
                    <a:lnTo>
                      <a:pt x="380" y="15"/>
                    </a:lnTo>
                    <a:lnTo>
                      <a:pt x="379" y="15"/>
                    </a:lnTo>
                    <a:lnTo>
                      <a:pt x="379" y="0"/>
                    </a:lnTo>
                    <a:lnTo>
                      <a:pt x="380" y="0"/>
                    </a:lnTo>
                    <a:close/>
                    <a:moveTo>
                      <a:pt x="507" y="0"/>
                    </a:moveTo>
                    <a:lnTo>
                      <a:pt x="507" y="15"/>
                    </a:lnTo>
                    <a:lnTo>
                      <a:pt x="506" y="15"/>
                    </a:lnTo>
                    <a:lnTo>
                      <a:pt x="506" y="0"/>
                    </a:lnTo>
                    <a:lnTo>
                      <a:pt x="507" y="0"/>
                    </a:lnTo>
                    <a:close/>
                    <a:moveTo>
                      <a:pt x="633" y="0"/>
                    </a:moveTo>
                    <a:lnTo>
                      <a:pt x="633" y="15"/>
                    </a:lnTo>
                    <a:lnTo>
                      <a:pt x="632" y="15"/>
                    </a:lnTo>
                    <a:lnTo>
                      <a:pt x="632" y="0"/>
                    </a:lnTo>
                    <a:lnTo>
                      <a:pt x="633" y="0"/>
                    </a:lnTo>
                    <a:close/>
                    <a:moveTo>
                      <a:pt x="759" y="0"/>
                    </a:moveTo>
                    <a:lnTo>
                      <a:pt x="759" y="15"/>
                    </a:lnTo>
                    <a:lnTo>
                      <a:pt x="758" y="15"/>
                    </a:lnTo>
                    <a:lnTo>
                      <a:pt x="758" y="0"/>
                    </a:lnTo>
                    <a:lnTo>
                      <a:pt x="759" y="0"/>
                    </a:lnTo>
                    <a:close/>
                    <a:moveTo>
                      <a:pt x="885" y="0"/>
                    </a:moveTo>
                    <a:lnTo>
                      <a:pt x="885" y="15"/>
                    </a:lnTo>
                    <a:lnTo>
                      <a:pt x="884" y="15"/>
                    </a:lnTo>
                    <a:lnTo>
                      <a:pt x="884" y="0"/>
                    </a:lnTo>
                    <a:lnTo>
                      <a:pt x="885" y="0"/>
                    </a:lnTo>
                    <a:close/>
                    <a:moveTo>
                      <a:pt x="1012" y="0"/>
                    </a:moveTo>
                    <a:lnTo>
                      <a:pt x="1012" y="15"/>
                    </a:lnTo>
                    <a:lnTo>
                      <a:pt x="1011" y="15"/>
                    </a:lnTo>
                    <a:lnTo>
                      <a:pt x="1011" y="0"/>
                    </a:lnTo>
                    <a:lnTo>
                      <a:pt x="1012" y="0"/>
                    </a:lnTo>
                    <a:close/>
                    <a:moveTo>
                      <a:pt x="1138" y="0"/>
                    </a:moveTo>
                    <a:lnTo>
                      <a:pt x="1138" y="15"/>
                    </a:lnTo>
                    <a:lnTo>
                      <a:pt x="1137" y="15"/>
                    </a:lnTo>
                    <a:lnTo>
                      <a:pt x="1137" y="0"/>
                    </a:lnTo>
                    <a:lnTo>
                      <a:pt x="1138" y="0"/>
                    </a:lnTo>
                    <a:close/>
                    <a:moveTo>
                      <a:pt x="1264" y="0"/>
                    </a:moveTo>
                    <a:lnTo>
                      <a:pt x="1264" y="15"/>
                    </a:lnTo>
                    <a:lnTo>
                      <a:pt x="1263" y="15"/>
                    </a:lnTo>
                    <a:lnTo>
                      <a:pt x="1263" y="0"/>
                    </a:lnTo>
                    <a:lnTo>
                      <a:pt x="1264" y="0"/>
                    </a:lnTo>
                    <a:close/>
                    <a:moveTo>
                      <a:pt x="1390" y="0"/>
                    </a:moveTo>
                    <a:lnTo>
                      <a:pt x="1390" y="15"/>
                    </a:lnTo>
                    <a:lnTo>
                      <a:pt x="1389" y="15"/>
                    </a:lnTo>
                    <a:lnTo>
                      <a:pt x="1389" y="0"/>
                    </a:lnTo>
                    <a:lnTo>
                      <a:pt x="1390" y="0"/>
                    </a:lnTo>
                    <a:close/>
                    <a:moveTo>
                      <a:pt x="1517" y="0"/>
                    </a:moveTo>
                    <a:lnTo>
                      <a:pt x="1517" y="15"/>
                    </a:lnTo>
                    <a:lnTo>
                      <a:pt x="1516" y="15"/>
                    </a:lnTo>
                    <a:lnTo>
                      <a:pt x="1516" y="0"/>
                    </a:lnTo>
                    <a:lnTo>
                      <a:pt x="1517" y="0"/>
                    </a:lnTo>
                    <a:close/>
                    <a:moveTo>
                      <a:pt x="1643" y="0"/>
                    </a:moveTo>
                    <a:lnTo>
                      <a:pt x="1643" y="15"/>
                    </a:lnTo>
                    <a:lnTo>
                      <a:pt x="1642" y="15"/>
                    </a:lnTo>
                    <a:lnTo>
                      <a:pt x="1642" y="0"/>
                    </a:lnTo>
                    <a:lnTo>
                      <a:pt x="1643" y="0"/>
                    </a:lnTo>
                    <a:close/>
                    <a:moveTo>
                      <a:pt x="1769" y="0"/>
                    </a:moveTo>
                    <a:lnTo>
                      <a:pt x="1769" y="15"/>
                    </a:lnTo>
                    <a:lnTo>
                      <a:pt x="1768" y="15"/>
                    </a:lnTo>
                    <a:lnTo>
                      <a:pt x="1768" y="0"/>
                    </a:lnTo>
                    <a:lnTo>
                      <a:pt x="1769" y="0"/>
                    </a:lnTo>
                    <a:close/>
                    <a:moveTo>
                      <a:pt x="1896" y="0"/>
                    </a:moveTo>
                    <a:lnTo>
                      <a:pt x="1896" y="15"/>
                    </a:lnTo>
                    <a:lnTo>
                      <a:pt x="1894" y="15"/>
                    </a:lnTo>
                    <a:lnTo>
                      <a:pt x="1894" y="0"/>
                    </a:lnTo>
                    <a:lnTo>
                      <a:pt x="1896" y="0"/>
                    </a:lnTo>
                    <a:close/>
                    <a:moveTo>
                      <a:pt x="2022" y="0"/>
                    </a:moveTo>
                    <a:lnTo>
                      <a:pt x="2022" y="15"/>
                    </a:lnTo>
                    <a:lnTo>
                      <a:pt x="2021" y="15"/>
                    </a:lnTo>
                    <a:lnTo>
                      <a:pt x="2021" y="0"/>
                    </a:lnTo>
                    <a:lnTo>
                      <a:pt x="2022" y="0"/>
                    </a:lnTo>
                    <a:close/>
                    <a:moveTo>
                      <a:pt x="2148" y="0"/>
                    </a:moveTo>
                    <a:lnTo>
                      <a:pt x="2148" y="15"/>
                    </a:lnTo>
                    <a:lnTo>
                      <a:pt x="2147" y="15"/>
                    </a:lnTo>
                    <a:lnTo>
                      <a:pt x="2147" y="0"/>
                    </a:lnTo>
                    <a:lnTo>
                      <a:pt x="2148" y="0"/>
                    </a:lnTo>
                    <a:close/>
                    <a:moveTo>
                      <a:pt x="2274" y="0"/>
                    </a:moveTo>
                    <a:lnTo>
                      <a:pt x="2274" y="15"/>
                    </a:lnTo>
                    <a:lnTo>
                      <a:pt x="2273" y="15"/>
                    </a:lnTo>
                    <a:lnTo>
                      <a:pt x="2273" y="0"/>
                    </a:lnTo>
                    <a:lnTo>
                      <a:pt x="2274" y="0"/>
                    </a:lnTo>
                    <a:close/>
                    <a:moveTo>
                      <a:pt x="2401" y="0"/>
                    </a:moveTo>
                    <a:lnTo>
                      <a:pt x="2401" y="15"/>
                    </a:lnTo>
                    <a:lnTo>
                      <a:pt x="2399" y="15"/>
                    </a:lnTo>
                    <a:lnTo>
                      <a:pt x="2399" y="0"/>
                    </a:lnTo>
                    <a:lnTo>
                      <a:pt x="2401" y="0"/>
                    </a:lnTo>
                    <a:close/>
                    <a:moveTo>
                      <a:pt x="2527" y="0"/>
                    </a:moveTo>
                    <a:lnTo>
                      <a:pt x="2527" y="15"/>
                    </a:lnTo>
                    <a:lnTo>
                      <a:pt x="2525" y="15"/>
                    </a:lnTo>
                    <a:lnTo>
                      <a:pt x="2525" y="0"/>
                    </a:lnTo>
                    <a:lnTo>
                      <a:pt x="2527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19" name="Rectangle 695"/>
              <p:cNvSpPr>
                <a:spLocks noChangeArrowheads="1"/>
              </p:cNvSpPr>
              <p:nvPr/>
            </p:nvSpPr>
            <p:spPr bwMode="auto">
              <a:xfrm>
                <a:off x="415375" y="3986920"/>
                <a:ext cx="60740" cy="718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720" name="Rectangle 696"/>
              <p:cNvSpPr>
                <a:spLocks noChangeArrowheads="1"/>
              </p:cNvSpPr>
              <p:nvPr/>
            </p:nvSpPr>
            <p:spPr bwMode="auto">
              <a:xfrm>
                <a:off x="381520" y="3835780"/>
                <a:ext cx="94595" cy="718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2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721" name="Rectangle 697"/>
              <p:cNvSpPr>
                <a:spLocks noChangeArrowheads="1"/>
              </p:cNvSpPr>
              <p:nvPr/>
            </p:nvSpPr>
            <p:spPr bwMode="auto">
              <a:xfrm>
                <a:off x="381520" y="3684640"/>
                <a:ext cx="94595" cy="7277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40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722" name="Rectangle 698"/>
              <p:cNvSpPr>
                <a:spLocks noChangeArrowheads="1"/>
              </p:cNvSpPr>
              <p:nvPr/>
            </p:nvSpPr>
            <p:spPr bwMode="auto">
              <a:xfrm>
                <a:off x="381520" y="3533500"/>
                <a:ext cx="94595" cy="7277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6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723" name="Rectangle 699"/>
              <p:cNvSpPr>
                <a:spLocks noChangeArrowheads="1"/>
              </p:cNvSpPr>
              <p:nvPr/>
            </p:nvSpPr>
            <p:spPr bwMode="auto">
              <a:xfrm>
                <a:off x="381520" y="3382359"/>
                <a:ext cx="94595" cy="7277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80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724" name="Rectangle 700"/>
              <p:cNvSpPr>
                <a:spLocks noChangeArrowheads="1"/>
              </p:cNvSpPr>
              <p:nvPr/>
            </p:nvSpPr>
            <p:spPr bwMode="auto">
              <a:xfrm>
                <a:off x="347665" y="3231219"/>
                <a:ext cx="128450" cy="7277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1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725" name="Rectangle 701"/>
              <p:cNvSpPr>
                <a:spLocks noChangeArrowheads="1"/>
              </p:cNvSpPr>
              <p:nvPr/>
            </p:nvSpPr>
            <p:spPr bwMode="auto">
              <a:xfrm>
                <a:off x="347665" y="3080079"/>
                <a:ext cx="128450" cy="7277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12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726" name="Rectangle 702"/>
              <p:cNvSpPr>
                <a:spLocks noChangeArrowheads="1"/>
              </p:cNvSpPr>
              <p:nvPr/>
            </p:nvSpPr>
            <p:spPr bwMode="auto">
              <a:xfrm>
                <a:off x="347665" y="2928939"/>
                <a:ext cx="128450" cy="7277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14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727" name="Rectangle 703"/>
              <p:cNvSpPr>
                <a:spLocks noChangeArrowheads="1"/>
              </p:cNvSpPr>
              <p:nvPr/>
            </p:nvSpPr>
            <p:spPr bwMode="auto">
              <a:xfrm>
                <a:off x="592445" y="4063423"/>
                <a:ext cx="60740" cy="7277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1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728" name="Rectangle 704"/>
              <p:cNvSpPr>
                <a:spLocks noChangeArrowheads="1"/>
              </p:cNvSpPr>
              <p:nvPr/>
            </p:nvSpPr>
            <p:spPr bwMode="auto">
              <a:xfrm>
                <a:off x="717907" y="4063423"/>
                <a:ext cx="59744" cy="7277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2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729" name="Rectangle 705"/>
              <p:cNvSpPr>
                <a:spLocks noChangeArrowheads="1"/>
              </p:cNvSpPr>
              <p:nvPr/>
            </p:nvSpPr>
            <p:spPr bwMode="auto">
              <a:xfrm>
                <a:off x="843370" y="4063423"/>
                <a:ext cx="60740" cy="7277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3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730" name="Rectangle 706"/>
              <p:cNvSpPr>
                <a:spLocks noChangeArrowheads="1"/>
              </p:cNvSpPr>
              <p:nvPr/>
            </p:nvSpPr>
            <p:spPr bwMode="auto">
              <a:xfrm>
                <a:off x="968832" y="4063423"/>
                <a:ext cx="60740" cy="7277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4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731" name="Rectangle 707"/>
              <p:cNvSpPr>
                <a:spLocks noChangeArrowheads="1"/>
              </p:cNvSpPr>
              <p:nvPr/>
            </p:nvSpPr>
            <p:spPr bwMode="auto">
              <a:xfrm>
                <a:off x="1095290" y="4063423"/>
                <a:ext cx="60740" cy="7277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5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732" name="Rectangle 708"/>
              <p:cNvSpPr>
                <a:spLocks noChangeArrowheads="1"/>
              </p:cNvSpPr>
              <p:nvPr/>
            </p:nvSpPr>
            <p:spPr bwMode="auto">
              <a:xfrm>
                <a:off x="1220752" y="4063423"/>
                <a:ext cx="59744" cy="7277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6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733" name="Rectangle 709"/>
              <p:cNvSpPr>
                <a:spLocks noChangeArrowheads="1"/>
              </p:cNvSpPr>
              <p:nvPr/>
            </p:nvSpPr>
            <p:spPr bwMode="auto">
              <a:xfrm>
                <a:off x="1346214" y="4063423"/>
                <a:ext cx="60740" cy="7277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7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734" name="Rectangle 710"/>
              <p:cNvSpPr>
                <a:spLocks noChangeArrowheads="1"/>
              </p:cNvSpPr>
              <p:nvPr/>
            </p:nvSpPr>
            <p:spPr bwMode="auto">
              <a:xfrm>
                <a:off x="1471677" y="4063423"/>
                <a:ext cx="60740" cy="7277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8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735" name="Rectangle 711"/>
              <p:cNvSpPr>
                <a:spLocks noChangeArrowheads="1"/>
              </p:cNvSpPr>
              <p:nvPr/>
            </p:nvSpPr>
            <p:spPr bwMode="auto">
              <a:xfrm>
                <a:off x="1598135" y="4063423"/>
                <a:ext cx="60740" cy="7277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9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736" name="Rectangle 712"/>
              <p:cNvSpPr>
                <a:spLocks noChangeArrowheads="1"/>
              </p:cNvSpPr>
              <p:nvPr/>
            </p:nvSpPr>
            <p:spPr bwMode="auto">
              <a:xfrm>
                <a:off x="1707666" y="4063423"/>
                <a:ext cx="93599" cy="7277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1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737" name="Rectangle 713"/>
              <p:cNvSpPr>
                <a:spLocks noChangeArrowheads="1"/>
              </p:cNvSpPr>
              <p:nvPr/>
            </p:nvSpPr>
            <p:spPr bwMode="auto">
              <a:xfrm>
                <a:off x="1833128" y="4063423"/>
                <a:ext cx="94595" cy="7277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11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738" name="Rectangle 714"/>
              <p:cNvSpPr>
                <a:spLocks noChangeArrowheads="1"/>
              </p:cNvSpPr>
              <p:nvPr/>
            </p:nvSpPr>
            <p:spPr bwMode="auto">
              <a:xfrm>
                <a:off x="1959586" y="4063423"/>
                <a:ext cx="94595" cy="7277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12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739" name="Rectangle 715"/>
              <p:cNvSpPr>
                <a:spLocks noChangeArrowheads="1"/>
              </p:cNvSpPr>
              <p:nvPr/>
            </p:nvSpPr>
            <p:spPr bwMode="auto">
              <a:xfrm>
                <a:off x="2085048" y="4063423"/>
                <a:ext cx="94595" cy="7277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13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740" name="Rectangle 716"/>
              <p:cNvSpPr>
                <a:spLocks noChangeArrowheads="1"/>
              </p:cNvSpPr>
              <p:nvPr/>
            </p:nvSpPr>
            <p:spPr bwMode="auto">
              <a:xfrm>
                <a:off x="2210510" y="4063423"/>
                <a:ext cx="93599" cy="7277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14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741" name="Rectangle 717"/>
              <p:cNvSpPr>
                <a:spLocks noChangeArrowheads="1"/>
              </p:cNvSpPr>
              <p:nvPr/>
            </p:nvSpPr>
            <p:spPr bwMode="auto">
              <a:xfrm>
                <a:off x="2335973" y="4063423"/>
                <a:ext cx="94595" cy="7277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15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742" name="Rectangle 718"/>
              <p:cNvSpPr>
                <a:spLocks noChangeArrowheads="1"/>
              </p:cNvSpPr>
              <p:nvPr/>
            </p:nvSpPr>
            <p:spPr bwMode="auto">
              <a:xfrm>
                <a:off x="2462431" y="4063423"/>
                <a:ext cx="94595" cy="7277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16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743" name="Rectangle 719"/>
              <p:cNvSpPr>
                <a:spLocks noChangeArrowheads="1"/>
              </p:cNvSpPr>
              <p:nvPr/>
            </p:nvSpPr>
            <p:spPr bwMode="auto">
              <a:xfrm>
                <a:off x="2587893" y="4063423"/>
                <a:ext cx="94595" cy="7277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17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744" name="Rectangle 720"/>
              <p:cNvSpPr>
                <a:spLocks noChangeArrowheads="1"/>
              </p:cNvSpPr>
              <p:nvPr/>
            </p:nvSpPr>
            <p:spPr bwMode="auto">
              <a:xfrm>
                <a:off x="2713356" y="4063423"/>
                <a:ext cx="93599" cy="7277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18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745" name="Rectangle 721"/>
              <p:cNvSpPr>
                <a:spLocks noChangeArrowheads="1"/>
              </p:cNvSpPr>
              <p:nvPr/>
            </p:nvSpPr>
            <p:spPr bwMode="auto">
              <a:xfrm>
                <a:off x="2838818" y="4063423"/>
                <a:ext cx="94595" cy="7277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19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746" name="Rectangle 722"/>
              <p:cNvSpPr>
                <a:spLocks noChangeArrowheads="1"/>
              </p:cNvSpPr>
              <p:nvPr/>
            </p:nvSpPr>
            <p:spPr bwMode="auto">
              <a:xfrm>
                <a:off x="2965276" y="4063423"/>
                <a:ext cx="94595" cy="7277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2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757" name="Rectangle 733"/>
              <p:cNvSpPr>
                <a:spLocks noChangeArrowheads="1"/>
              </p:cNvSpPr>
              <p:nvPr/>
            </p:nvSpPr>
            <p:spPr bwMode="auto">
              <a:xfrm>
                <a:off x="2258306" y="3950534"/>
                <a:ext cx="65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760" name="Rectangle 736"/>
              <p:cNvSpPr>
                <a:spLocks noChangeArrowheads="1"/>
              </p:cNvSpPr>
              <p:nvPr/>
            </p:nvSpPr>
            <p:spPr bwMode="auto">
              <a:xfrm>
                <a:off x="2807950" y="3950534"/>
                <a:ext cx="77667" cy="13341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</a:rPr>
                  <a:t> 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</p:grpSp>
        <p:sp>
          <p:nvSpPr>
            <p:cNvPr id="1773" name="Rectangle 749"/>
            <p:cNvSpPr>
              <a:spLocks noChangeArrowheads="1"/>
            </p:cNvSpPr>
            <p:nvPr/>
          </p:nvSpPr>
          <p:spPr bwMode="auto">
            <a:xfrm>
              <a:off x="4986297" y="2833686"/>
              <a:ext cx="56079" cy="405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4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774" name="Rectangle 750"/>
            <p:cNvSpPr>
              <a:spLocks noChangeArrowheads="1"/>
            </p:cNvSpPr>
            <p:nvPr/>
          </p:nvSpPr>
          <p:spPr bwMode="auto">
            <a:xfrm>
              <a:off x="4986297" y="3133117"/>
              <a:ext cx="56079" cy="405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2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775" name="Rectangle 751"/>
            <p:cNvSpPr>
              <a:spLocks noChangeArrowheads="1"/>
            </p:cNvSpPr>
            <p:nvPr/>
          </p:nvSpPr>
          <p:spPr bwMode="auto">
            <a:xfrm>
              <a:off x="5005291" y="3432548"/>
              <a:ext cx="36180" cy="405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776" name="Rectangle 752"/>
            <p:cNvSpPr>
              <a:spLocks noChangeArrowheads="1"/>
            </p:cNvSpPr>
            <p:nvPr/>
          </p:nvSpPr>
          <p:spPr bwMode="auto">
            <a:xfrm>
              <a:off x="4973634" y="3731980"/>
              <a:ext cx="67838" cy="405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-2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777" name="Rectangle 753"/>
            <p:cNvSpPr>
              <a:spLocks noChangeArrowheads="1"/>
            </p:cNvSpPr>
            <p:nvPr/>
          </p:nvSpPr>
          <p:spPr bwMode="auto">
            <a:xfrm>
              <a:off x="4973634" y="4031410"/>
              <a:ext cx="67838" cy="405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-4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grpSp>
          <p:nvGrpSpPr>
            <p:cNvPr id="767" name="Group 766"/>
            <p:cNvGrpSpPr/>
            <p:nvPr/>
          </p:nvGrpSpPr>
          <p:grpSpPr>
            <a:xfrm>
              <a:off x="5067576" y="2871009"/>
              <a:ext cx="250548" cy="1198476"/>
              <a:chOff x="3515001" y="2871009"/>
              <a:chExt cx="250548" cy="1198476"/>
            </a:xfrm>
          </p:grpSpPr>
          <p:sp>
            <p:nvSpPr>
              <p:cNvPr id="1768" name="Line 744"/>
              <p:cNvSpPr>
                <a:spLocks noChangeShapeType="1"/>
              </p:cNvSpPr>
              <p:nvPr/>
            </p:nvSpPr>
            <p:spPr bwMode="auto">
              <a:xfrm flipV="1">
                <a:off x="3536709" y="2871009"/>
                <a:ext cx="905" cy="1197724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69" name="Line 745"/>
              <p:cNvSpPr>
                <a:spLocks noChangeShapeType="1"/>
              </p:cNvSpPr>
              <p:nvPr/>
            </p:nvSpPr>
            <p:spPr bwMode="auto">
              <a:xfrm flipH="1">
                <a:off x="3515001" y="4068734"/>
                <a:ext cx="21708" cy="751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70" name="Line 746"/>
              <p:cNvSpPr>
                <a:spLocks noChangeShapeType="1"/>
              </p:cNvSpPr>
              <p:nvPr/>
            </p:nvSpPr>
            <p:spPr bwMode="auto">
              <a:xfrm flipH="1">
                <a:off x="3515001" y="3769303"/>
                <a:ext cx="21708" cy="751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71" name="Line 747"/>
              <p:cNvSpPr>
                <a:spLocks noChangeShapeType="1"/>
              </p:cNvSpPr>
              <p:nvPr/>
            </p:nvSpPr>
            <p:spPr bwMode="auto">
              <a:xfrm flipH="1">
                <a:off x="3515001" y="3469871"/>
                <a:ext cx="21708" cy="751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72" name="Line 748"/>
              <p:cNvSpPr>
                <a:spLocks noChangeShapeType="1"/>
              </p:cNvSpPr>
              <p:nvPr/>
            </p:nvSpPr>
            <p:spPr bwMode="auto">
              <a:xfrm flipH="1">
                <a:off x="3515001" y="3170441"/>
                <a:ext cx="21708" cy="751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78" name="Line 754"/>
              <p:cNvSpPr>
                <a:spLocks noChangeShapeType="1"/>
              </p:cNvSpPr>
              <p:nvPr/>
            </p:nvSpPr>
            <p:spPr bwMode="auto">
              <a:xfrm flipH="1">
                <a:off x="3515001" y="2871009"/>
                <a:ext cx="21708" cy="751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79" name="Freeform 755"/>
              <p:cNvSpPr>
                <a:spLocks/>
              </p:cNvSpPr>
              <p:nvPr/>
            </p:nvSpPr>
            <p:spPr bwMode="auto">
              <a:xfrm>
                <a:off x="3691380" y="2926543"/>
                <a:ext cx="29849" cy="980844"/>
              </a:xfrm>
              <a:custGeom>
                <a:avLst/>
                <a:gdLst/>
                <a:ahLst/>
                <a:cxnLst>
                  <a:cxn ang="0">
                    <a:pos x="0" y="7637"/>
                  </a:cxn>
                  <a:cxn ang="0">
                    <a:pos x="95" y="7637"/>
                  </a:cxn>
                  <a:cxn ang="0">
                    <a:pos x="95" y="0"/>
                  </a:cxn>
                  <a:cxn ang="0">
                    <a:pos x="0" y="0"/>
                  </a:cxn>
                  <a:cxn ang="0">
                    <a:pos x="189" y="0"/>
                  </a:cxn>
                  <a:cxn ang="0">
                    <a:pos x="95" y="0"/>
                  </a:cxn>
                  <a:cxn ang="0">
                    <a:pos x="95" y="7637"/>
                  </a:cxn>
                  <a:cxn ang="0">
                    <a:pos x="189" y="7637"/>
                  </a:cxn>
                  <a:cxn ang="0">
                    <a:pos x="0" y="7637"/>
                  </a:cxn>
                </a:cxnLst>
                <a:rect l="0" t="0" r="r" b="b"/>
                <a:pathLst>
                  <a:path w="189" h="7637">
                    <a:moveTo>
                      <a:pt x="0" y="7637"/>
                    </a:moveTo>
                    <a:lnTo>
                      <a:pt x="95" y="7637"/>
                    </a:lnTo>
                    <a:lnTo>
                      <a:pt x="95" y="0"/>
                    </a:lnTo>
                    <a:lnTo>
                      <a:pt x="0" y="0"/>
                    </a:lnTo>
                    <a:lnTo>
                      <a:pt x="189" y="0"/>
                    </a:lnTo>
                    <a:lnTo>
                      <a:pt x="95" y="0"/>
                    </a:lnTo>
                    <a:lnTo>
                      <a:pt x="95" y="7637"/>
                    </a:lnTo>
                    <a:lnTo>
                      <a:pt x="189" y="7637"/>
                    </a:lnTo>
                    <a:lnTo>
                      <a:pt x="0" y="7637"/>
                    </a:lnTo>
                    <a:close/>
                  </a:path>
                </a:pathLst>
              </a:custGeom>
              <a:solidFill>
                <a:srgbClr val="DBD8AC"/>
              </a:solidFill>
              <a:ln w="79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80" name="Rectangle 756"/>
              <p:cNvSpPr>
                <a:spLocks noChangeArrowheads="1"/>
              </p:cNvSpPr>
              <p:nvPr/>
            </p:nvSpPr>
            <p:spPr bwMode="auto">
              <a:xfrm>
                <a:off x="3646155" y="3054120"/>
                <a:ext cx="119394" cy="467533"/>
              </a:xfrm>
              <a:prstGeom prst="rect">
                <a:avLst/>
              </a:prstGeom>
              <a:solidFill>
                <a:srgbClr val="2EB848"/>
              </a:solidFill>
              <a:ln w="793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81" name="Freeform 757"/>
              <p:cNvSpPr>
                <a:spLocks/>
              </p:cNvSpPr>
              <p:nvPr/>
            </p:nvSpPr>
            <p:spPr bwMode="auto">
              <a:xfrm>
                <a:off x="3646155" y="3311526"/>
                <a:ext cx="119394" cy="751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756" y="0"/>
                  </a:cxn>
                  <a:cxn ang="0">
                    <a:pos x="0" y="0"/>
                  </a:cxn>
                </a:cxnLst>
                <a:rect l="0" t="0" r="r" b="b"/>
                <a:pathLst>
                  <a:path w="756">
                    <a:moveTo>
                      <a:pt x="0" y="0"/>
                    </a:moveTo>
                    <a:lnTo>
                      <a:pt x="756" y="0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w="2857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</p:grpSp>
        <p:sp>
          <p:nvSpPr>
            <p:cNvPr id="772" name="TextBox 771"/>
            <p:cNvSpPr txBox="1"/>
            <p:nvPr/>
          </p:nvSpPr>
          <p:spPr>
            <a:xfrm>
              <a:off x="-19049" y="3314700"/>
              <a:ext cx="15525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dirty="0" smtClean="0"/>
                <a:t>15-PGDH IHC</a:t>
              </a:r>
              <a:endParaRPr lang="en-GB" baseline="-25000" dirty="0"/>
            </a:p>
          </p:txBody>
        </p:sp>
        <p:sp>
          <p:nvSpPr>
            <p:cNvPr id="774" name="TextBox 773"/>
            <p:cNvSpPr txBox="1"/>
            <p:nvPr/>
          </p:nvSpPr>
          <p:spPr>
            <a:xfrm rot="16200000">
              <a:off x="1257300" y="3333750"/>
              <a:ext cx="11049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 smtClean="0">
                  <a:latin typeface="Arial" pitchFamily="34" charset="0"/>
                  <a:cs typeface="Arial" pitchFamily="34" charset="0"/>
                </a:rPr>
                <a:t>arbitrary units</a:t>
              </a:r>
              <a:endParaRPr lang="en-GB" sz="1000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611" name="Group 1610"/>
          <p:cNvGrpSpPr/>
          <p:nvPr/>
        </p:nvGrpSpPr>
        <p:grpSpPr>
          <a:xfrm>
            <a:off x="381001" y="1290636"/>
            <a:ext cx="4928020" cy="1604964"/>
            <a:chOff x="381001" y="1462086"/>
            <a:chExt cx="4928020" cy="1604964"/>
          </a:xfrm>
        </p:grpSpPr>
        <p:graphicFrame>
          <p:nvGraphicFramePr>
            <p:cNvPr id="584" name="Object 14"/>
            <p:cNvGraphicFramePr/>
            <p:nvPr/>
          </p:nvGraphicFramePr>
          <p:xfrm>
            <a:off x="1924048" y="1462086"/>
            <a:ext cx="2847977" cy="160496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pSp>
          <p:nvGrpSpPr>
            <p:cNvPr id="766" name="Group 765"/>
            <p:cNvGrpSpPr/>
            <p:nvPr/>
          </p:nvGrpSpPr>
          <p:grpSpPr>
            <a:xfrm>
              <a:off x="4977974" y="1496584"/>
              <a:ext cx="331047" cy="1236935"/>
              <a:chOff x="3850548" y="2029984"/>
              <a:chExt cx="331047" cy="1236935"/>
            </a:xfrm>
          </p:grpSpPr>
          <p:sp>
            <p:nvSpPr>
              <p:cNvPr id="1624" name="Rectangle 600"/>
              <p:cNvSpPr>
                <a:spLocks noChangeArrowheads="1"/>
              </p:cNvSpPr>
              <p:nvPr/>
            </p:nvSpPr>
            <p:spPr bwMode="auto">
              <a:xfrm>
                <a:off x="3862185" y="2029984"/>
                <a:ext cx="55498" cy="4048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5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40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625" name="Rectangle 601"/>
              <p:cNvSpPr>
                <a:spLocks noChangeArrowheads="1"/>
              </p:cNvSpPr>
              <p:nvPr/>
            </p:nvSpPr>
            <p:spPr bwMode="auto">
              <a:xfrm>
                <a:off x="3862185" y="2329098"/>
                <a:ext cx="55498" cy="4048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2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626" name="Rectangle 602"/>
              <p:cNvSpPr>
                <a:spLocks noChangeArrowheads="1"/>
              </p:cNvSpPr>
              <p:nvPr/>
            </p:nvSpPr>
            <p:spPr bwMode="auto">
              <a:xfrm>
                <a:off x="3881878" y="2628211"/>
                <a:ext cx="35805" cy="4048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627" name="Rectangle 603"/>
              <p:cNvSpPr>
                <a:spLocks noChangeArrowheads="1"/>
              </p:cNvSpPr>
              <p:nvPr/>
            </p:nvSpPr>
            <p:spPr bwMode="auto">
              <a:xfrm>
                <a:off x="3850548" y="2927324"/>
                <a:ext cx="67136" cy="4048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-2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628" name="Rectangle 604"/>
              <p:cNvSpPr>
                <a:spLocks noChangeArrowheads="1"/>
              </p:cNvSpPr>
              <p:nvPr/>
            </p:nvSpPr>
            <p:spPr bwMode="auto">
              <a:xfrm>
                <a:off x="3850548" y="3226437"/>
                <a:ext cx="67136" cy="4048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</a:rPr>
                  <a:t>-4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grpSp>
            <p:nvGrpSpPr>
              <p:cNvPr id="765" name="Group 764"/>
              <p:cNvGrpSpPr/>
              <p:nvPr/>
            </p:nvGrpSpPr>
            <p:grpSpPr>
              <a:xfrm>
                <a:off x="3944383" y="2064150"/>
                <a:ext cx="237212" cy="1197203"/>
                <a:chOff x="3944383" y="2064150"/>
                <a:chExt cx="237212" cy="1197203"/>
              </a:xfrm>
            </p:grpSpPr>
            <p:grpSp>
              <p:nvGrpSpPr>
                <p:cNvPr id="607" name="Group 606"/>
                <p:cNvGrpSpPr/>
                <p:nvPr/>
              </p:nvGrpSpPr>
              <p:grpSpPr>
                <a:xfrm>
                  <a:off x="3944383" y="2064150"/>
                  <a:ext cx="21484" cy="1197203"/>
                  <a:chOff x="3984336" y="2312061"/>
                  <a:chExt cx="34638" cy="1786597"/>
                </a:xfrm>
              </p:grpSpPr>
              <p:sp>
                <p:nvSpPr>
                  <p:cNvPr id="1619" name="Line 595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4017530" y="2312061"/>
                    <a:ext cx="1444" cy="1785478"/>
                  </a:xfrm>
                  <a:prstGeom prst="line">
                    <a:avLst/>
                  </a:prstGeom>
                  <a:noFill/>
                  <a:ln w="6350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GB"/>
                  </a:p>
                </p:txBody>
              </p:sp>
              <p:sp>
                <p:nvSpPr>
                  <p:cNvPr id="1620" name="Line 596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984336" y="4097539"/>
                    <a:ext cx="33194" cy="1119"/>
                  </a:xfrm>
                  <a:prstGeom prst="line">
                    <a:avLst/>
                  </a:prstGeom>
                  <a:noFill/>
                  <a:ln w="6350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GB"/>
                  </a:p>
                </p:txBody>
              </p:sp>
              <p:sp>
                <p:nvSpPr>
                  <p:cNvPr id="1621" name="Line 597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984336" y="3651170"/>
                    <a:ext cx="33194" cy="1119"/>
                  </a:xfrm>
                  <a:prstGeom prst="line">
                    <a:avLst/>
                  </a:prstGeom>
                  <a:noFill/>
                  <a:ln w="6350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GB"/>
                  </a:p>
                </p:txBody>
              </p:sp>
              <p:sp>
                <p:nvSpPr>
                  <p:cNvPr id="1622" name="Line 598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984336" y="3204800"/>
                    <a:ext cx="33194" cy="1119"/>
                  </a:xfrm>
                  <a:prstGeom prst="line">
                    <a:avLst/>
                  </a:prstGeom>
                  <a:noFill/>
                  <a:ln w="6350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GB"/>
                  </a:p>
                </p:txBody>
              </p:sp>
              <p:sp>
                <p:nvSpPr>
                  <p:cNvPr id="1623" name="Line 599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984336" y="2758431"/>
                    <a:ext cx="33194" cy="1119"/>
                  </a:xfrm>
                  <a:prstGeom prst="line">
                    <a:avLst/>
                  </a:prstGeom>
                  <a:noFill/>
                  <a:ln w="6350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GB"/>
                  </a:p>
                </p:txBody>
              </p:sp>
              <p:sp>
                <p:nvSpPr>
                  <p:cNvPr id="1629" name="Line 605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984336" y="2312061"/>
                    <a:ext cx="33194" cy="1119"/>
                  </a:xfrm>
                  <a:prstGeom prst="line">
                    <a:avLst/>
                  </a:prstGeom>
                  <a:noFill/>
                  <a:ln w="6350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GB"/>
                  </a:p>
                </p:txBody>
              </p:sp>
            </p:grpSp>
            <p:sp>
              <p:nvSpPr>
                <p:cNvPr id="1630" name="Freeform 606"/>
                <p:cNvSpPr>
                  <a:spLocks/>
                </p:cNvSpPr>
                <p:nvPr/>
              </p:nvSpPr>
              <p:spPr bwMode="auto">
                <a:xfrm>
                  <a:off x="4110879" y="2478711"/>
                  <a:ext cx="28645" cy="471535"/>
                </a:xfrm>
                <a:custGeom>
                  <a:avLst/>
                  <a:gdLst/>
                  <a:ahLst/>
                  <a:cxnLst>
                    <a:cxn ang="0">
                      <a:pos x="0" y="3676"/>
                    </a:cxn>
                    <a:cxn ang="0">
                      <a:pos x="95" y="3676"/>
                    </a:cxn>
                    <a:cxn ang="0">
                      <a:pos x="95" y="0"/>
                    </a:cxn>
                    <a:cxn ang="0">
                      <a:pos x="0" y="0"/>
                    </a:cxn>
                    <a:cxn ang="0">
                      <a:pos x="189" y="0"/>
                    </a:cxn>
                    <a:cxn ang="0">
                      <a:pos x="95" y="0"/>
                    </a:cxn>
                    <a:cxn ang="0">
                      <a:pos x="95" y="3676"/>
                    </a:cxn>
                    <a:cxn ang="0">
                      <a:pos x="189" y="3676"/>
                    </a:cxn>
                    <a:cxn ang="0">
                      <a:pos x="0" y="3676"/>
                    </a:cxn>
                  </a:cxnLst>
                  <a:rect l="0" t="0" r="r" b="b"/>
                  <a:pathLst>
                    <a:path w="189" h="3676">
                      <a:moveTo>
                        <a:pt x="0" y="3676"/>
                      </a:moveTo>
                      <a:lnTo>
                        <a:pt x="95" y="3676"/>
                      </a:lnTo>
                      <a:lnTo>
                        <a:pt x="95" y="0"/>
                      </a:lnTo>
                      <a:lnTo>
                        <a:pt x="0" y="0"/>
                      </a:lnTo>
                      <a:lnTo>
                        <a:pt x="189" y="0"/>
                      </a:lnTo>
                      <a:lnTo>
                        <a:pt x="95" y="0"/>
                      </a:lnTo>
                      <a:lnTo>
                        <a:pt x="95" y="3676"/>
                      </a:lnTo>
                      <a:lnTo>
                        <a:pt x="189" y="3676"/>
                      </a:lnTo>
                      <a:lnTo>
                        <a:pt x="0" y="3676"/>
                      </a:lnTo>
                      <a:close/>
                    </a:path>
                  </a:pathLst>
                </a:custGeom>
                <a:solidFill>
                  <a:srgbClr val="DBD8AC"/>
                </a:solidFill>
                <a:ln w="63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631" name="Rectangle 607"/>
                <p:cNvSpPr>
                  <a:spLocks noChangeArrowheads="1"/>
                </p:cNvSpPr>
                <p:nvPr/>
              </p:nvSpPr>
              <p:spPr bwMode="auto">
                <a:xfrm>
                  <a:off x="4068808" y="2513195"/>
                  <a:ext cx="112787" cy="221149"/>
                </a:xfrm>
                <a:prstGeom prst="rect">
                  <a:avLst/>
                </a:prstGeom>
                <a:solidFill>
                  <a:srgbClr val="2EB848"/>
                </a:solidFill>
                <a:ln w="63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632" name="Freeform 608"/>
                <p:cNvSpPr>
                  <a:spLocks/>
                </p:cNvSpPr>
                <p:nvPr/>
              </p:nvSpPr>
              <p:spPr bwMode="auto">
                <a:xfrm>
                  <a:off x="4068808" y="2669873"/>
                  <a:ext cx="112787" cy="750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756" y="0"/>
                    </a:cxn>
                    <a:cxn ang="0">
                      <a:pos x="0" y="0"/>
                    </a:cxn>
                  </a:cxnLst>
                  <a:rect l="0" t="0" r="r" b="b"/>
                  <a:pathLst>
                    <a:path w="756">
                      <a:moveTo>
                        <a:pt x="0" y="0"/>
                      </a:moveTo>
                      <a:lnTo>
                        <a:pt x="756" y="0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noFill/>
                <a:ln w="2857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</p:grpSp>
        </p:grpSp>
        <p:sp>
          <p:nvSpPr>
            <p:cNvPr id="771" name="TextBox 770"/>
            <p:cNvSpPr txBox="1"/>
            <p:nvPr/>
          </p:nvSpPr>
          <p:spPr>
            <a:xfrm>
              <a:off x="381001" y="1924050"/>
              <a:ext cx="115252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dirty="0" smtClean="0"/>
                <a:t>COX-2 IHC</a:t>
              </a:r>
              <a:endParaRPr lang="en-GB" baseline="-25000" dirty="0"/>
            </a:p>
          </p:txBody>
        </p:sp>
        <p:sp>
          <p:nvSpPr>
            <p:cNvPr id="775" name="TextBox 774"/>
            <p:cNvSpPr txBox="1"/>
            <p:nvPr/>
          </p:nvSpPr>
          <p:spPr>
            <a:xfrm rot="16200000">
              <a:off x="1247775" y="1933575"/>
              <a:ext cx="11049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 smtClean="0">
                  <a:latin typeface="Arial" pitchFamily="34" charset="0"/>
                  <a:cs typeface="Arial" pitchFamily="34" charset="0"/>
                </a:rPr>
                <a:t>arbitrary units</a:t>
              </a:r>
              <a:endParaRPr lang="en-GB" sz="1000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612" name="Group 1611"/>
          <p:cNvGrpSpPr/>
          <p:nvPr/>
        </p:nvGrpSpPr>
        <p:grpSpPr>
          <a:xfrm>
            <a:off x="-19049" y="3933826"/>
            <a:ext cx="5334000" cy="1447800"/>
            <a:chOff x="-19049" y="4371976"/>
            <a:chExt cx="5334000" cy="1447800"/>
          </a:xfrm>
        </p:grpSpPr>
        <p:graphicFrame>
          <p:nvGraphicFramePr>
            <p:cNvPr id="776" name="Object 41"/>
            <p:cNvGraphicFramePr/>
            <p:nvPr/>
          </p:nvGraphicFramePr>
          <p:xfrm>
            <a:off x="1647825" y="4412274"/>
            <a:ext cx="3045068" cy="140750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779" name="TextBox 778"/>
            <p:cNvSpPr txBox="1"/>
            <p:nvPr/>
          </p:nvSpPr>
          <p:spPr>
            <a:xfrm>
              <a:off x="-19049" y="4686300"/>
              <a:ext cx="1552574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dirty="0" smtClean="0"/>
                <a:t>15-PGDH activity</a:t>
              </a:r>
              <a:endParaRPr lang="en-GB" baseline="-25000" dirty="0"/>
            </a:p>
          </p:txBody>
        </p:sp>
        <p:sp>
          <p:nvSpPr>
            <p:cNvPr id="900" name="TextBox 899"/>
            <p:cNvSpPr txBox="1"/>
            <p:nvPr/>
          </p:nvSpPr>
          <p:spPr>
            <a:xfrm rot="16200000">
              <a:off x="1143715" y="4801315"/>
              <a:ext cx="11049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 err="1" smtClean="0">
                  <a:latin typeface="Arial" pitchFamily="34" charset="0"/>
                  <a:cs typeface="Arial" pitchFamily="34" charset="0"/>
                </a:rPr>
                <a:t>cpm</a:t>
              </a:r>
              <a:r>
                <a:rPr lang="en-GB" sz="1000" b="1" dirty="0" smtClean="0">
                  <a:latin typeface="Arial" pitchFamily="34" charset="0"/>
                  <a:cs typeface="Arial" pitchFamily="34" charset="0"/>
                </a:rPr>
                <a:t>/100 </a:t>
              </a:r>
              <a:r>
                <a:rPr lang="en-GB" sz="1000" b="1" dirty="0" smtClean="0">
                  <a:latin typeface="Symbol" pitchFamily="18" charset="2"/>
                  <a:cs typeface="Arial" pitchFamily="34" charset="0"/>
                </a:rPr>
                <a:t>m</a:t>
              </a:r>
              <a:r>
                <a:rPr lang="en-GB" sz="1000" b="1" dirty="0" smtClean="0">
                  <a:latin typeface="Arial" pitchFamily="34" charset="0"/>
                  <a:cs typeface="Arial" pitchFamily="34" charset="0"/>
                </a:rPr>
                <a:t>g</a:t>
              </a:r>
              <a:endParaRPr lang="en-GB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35" name="Rectangle 1011"/>
            <p:cNvSpPr>
              <a:spLocks noChangeArrowheads="1"/>
            </p:cNvSpPr>
            <p:nvPr/>
          </p:nvSpPr>
          <p:spPr bwMode="auto">
            <a:xfrm>
              <a:off x="4949818" y="4384676"/>
              <a:ext cx="81026" cy="4510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150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036" name="Rectangle 1012"/>
            <p:cNvSpPr>
              <a:spLocks noChangeArrowheads="1"/>
            </p:cNvSpPr>
            <p:nvPr/>
          </p:nvSpPr>
          <p:spPr bwMode="auto">
            <a:xfrm>
              <a:off x="4949818" y="4584313"/>
              <a:ext cx="81026" cy="4510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1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037" name="Rectangle 1013"/>
            <p:cNvSpPr>
              <a:spLocks noChangeArrowheads="1"/>
            </p:cNvSpPr>
            <p:nvPr/>
          </p:nvSpPr>
          <p:spPr bwMode="auto">
            <a:xfrm>
              <a:off x="4969342" y="4784786"/>
              <a:ext cx="59550" cy="4510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5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038" name="Rectangle 1014"/>
            <p:cNvSpPr>
              <a:spLocks noChangeArrowheads="1"/>
            </p:cNvSpPr>
            <p:nvPr/>
          </p:nvSpPr>
          <p:spPr bwMode="auto">
            <a:xfrm>
              <a:off x="4988867" y="4984423"/>
              <a:ext cx="38073" cy="4510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039" name="Rectangle 1015"/>
            <p:cNvSpPr>
              <a:spLocks noChangeArrowheads="1"/>
            </p:cNvSpPr>
            <p:nvPr/>
          </p:nvSpPr>
          <p:spPr bwMode="auto">
            <a:xfrm>
              <a:off x="4956651" y="5184060"/>
              <a:ext cx="72240" cy="4510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-5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040" name="Rectangle 1016"/>
            <p:cNvSpPr>
              <a:spLocks noChangeArrowheads="1"/>
            </p:cNvSpPr>
            <p:nvPr/>
          </p:nvSpPr>
          <p:spPr bwMode="auto">
            <a:xfrm>
              <a:off x="4937127" y="5384533"/>
              <a:ext cx="93717" cy="4510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-1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041" name="Rectangle 1017"/>
            <p:cNvSpPr>
              <a:spLocks noChangeArrowheads="1"/>
            </p:cNvSpPr>
            <p:nvPr/>
          </p:nvSpPr>
          <p:spPr bwMode="auto">
            <a:xfrm>
              <a:off x="4937127" y="5584170"/>
              <a:ext cx="93717" cy="4510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-15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grpSp>
          <p:nvGrpSpPr>
            <p:cNvPr id="1599" name="Group 1598"/>
            <p:cNvGrpSpPr/>
            <p:nvPr/>
          </p:nvGrpSpPr>
          <p:grpSpPr>
            <a:xfrm>
              <a:off x="5067968" y="4407565"/>
              <a:ext cx="246983" cy="1202834"/>
              <a:chOff x="5067968" y="4407565"/>
              <a:chExt cx="246983" cy="1202834"/>
            </a:xfrm>
          </p:grpSpPr>
          <p:grpSp>
            <p:nvGrpSpPr>
              <p:cNvPr id="1447" name="Group 1446"/>
              <p:cNvGrpSpPr/>
              <p:nvPr/>
            </p:nvGrpSpPr>
            <p:grpSpPr>
              <a:xfrm>
                <a:off x="5067968" y="4407565"/>
                <a:ext cx="22453" cy="1202834"/>
                <a:chOff x="5078413" y="4448174"/>
                <a:chExt cx="36513" cy="2285999"/>
              </a:xfrm>
            </p:grpSpPr>
            <p:sp>
              <p:nvSpPr>
                <p:cNvPr id="2028" name="Line 1004"/>
                <p:cNvSpPr>
                  <a:spLocks noChangeShapeType="1"/>
                </p:cNvSpPr>
                <p:nvPr/>
              </p:nvSpPr>
              <p:spPr bwMode="auto">
                <a:xfrm flipH="1" flipV="1">
                  <a:off x="5105400" y="4448174"/>
                  <a:ext cx="9525" cy="2285999"/>
                </a:xfrm>
                <a:prstGeom prst="line">
                  <a:avLst/>
                </a:prstGeom>
                <a:noFill/>
                <a:ln w="63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029" name="Line 1005"/>
                <p:cNvSpPr>
                  <a:spLocks noChangeShapeType="1"/>
                </p:cNvSpPr>
                <p:nvPr/>
              </p:nvSpPr>
              <p:spPr bwMode="auto">
                <a:xfrm flipH="1">
                  <a:off x="5078413" y="6731000"/>
                  <a:ext cx="36513" cy="1588"/>
                </a:xfrm>
                <a:prstGeom prst="line">
                  <a:avLst/>
                </a:prstGeom>
                <a:noFill/>
                <a:ln w="63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030" name="Line 1006"/>
                <p:cNvSpPr>
                  <a:spLocks noChangeShapeType="1"/>
                </p:cNvSpPr>
                <p:nvPr/>
              </p:nvSpPr>
              <p:spPr bwMode="auto">
                <a:xfrm flipH="1">
                  <a:off x="5078413" y="6350000"/>
                  <a:ext cx="36513" cy="1588"/>
                </a:xfrm>
                <a:prstGeom prst="line">
                  <a:avLst/>
                </a:prstGeom>
                <a:noFill/>
                <a:ln w="63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031" name="Line 1007"/>
                <p:cNvSpPr>
                  <a:spLocks noChangeShapeType="1"/>
                </p:cNvSpPr>
                <p:nvPr/>
              </p:nvSpPr>
              <p:spPr bwMode="auto">
                <a:xfrm flipH="1">
                  <a:off x="5078413" y="5970588"/>
                  <a:ext cx="36513" cy="1588"/>
                </a:xfrm>
                <a:prstGeom prst="line">
                  <a:avLst/>
                </a:prstGeom>
                <a:noFill/>
                <a:ln w="63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032" name="Line 1008"/>
                <p:cNvSpPr>
                  <a:spLocks noChangeShapeType="1"/>
                </p:cNvSpPr>
                <p:nvPr/>
              </p:nvSpPr>
              <p:spPr bwMode="auto">
                <a:xfrm flipH="1">
                  <a:off x="5078413" y="5591175"/>
                  <a:ext cx="36513" cy="1588"/>
                </a:xfrm>
                <a:prstGeom prst="line">
                  <a:avLst/>
                </a:prstGeom>
                <a:noFill/>
                <a:ln w="63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033" name="Line 1009"/>
                <p:cNvSpPr>
                  <a:spLocks noChangeShapeType="1"/>
                </p:cNvSpPr>
                <p:nvPr/>
              </p:nvSpPr>
              <p:spPr bwMode="auto">
                <a:xfrm flipH="1">
                  <a:off x="5078413" y="5210175"/>
                  <a:ext cx="36513" cy="1588"/>
                </a:xfrm>
                <a:prstGeom prst="line">
                  <a:avLst/>
                </a:prstGeom>
                <a:noFill/>
                <a:ln w="63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034" name="Line 1010"/>
                <p:cNvSpPr>
                  <a:spLocks noChangeShapeType="1"/>
                </p:cNvSpPr>
                <p:nvPr/>
              </p:nvSpPr>
              <p:spPr bwMode="auto">
                <a:xfrm flipH="1">
                  <a:off x="5078413" y="4830763"/>
                  <a:ext cx="36513" cy="1588"/>
                </a:xfrm>
                <a:prstGeom prst="line">
                  <a:avLst/>
                </a:prstGeom>
                <a:noFill/>
                <a:ln w="63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042" name="Line 1018"/>
                <p:cNvSpPr>
                  <a:spLocks noChangeShapeType="1"/>
                </p:cNvSpPr>
                <p:nvPr/>
              </p:nvSpPr>
              <p:spPr bwMode="auto">
                <a:xfrm flipH="1">
                  <a:off x="5078413" y="4451350"/>
                  <a:ext cx="36513" cy="1588"/>
                </a:xfrm>
                <a:prstGeom prst="line">
                  <a:avLst/>
                </a:prstGeom>
                <a:noFill/>
                <a:ln w="63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</p:grpSp>
          <p:sp>
            <p:nvSpPr>
              <p:cNvPr id="2043" name="Freeform 1019"/>
              <p:cNvSpPr>
                <a:spLocks/>
              </p:cNvSpPr>
              <p:nvPr/>
            </p:nvSpPr>
            <p:spPr bwMode="auto">
              <a:xfrm>
                <a:off x="5238805" y="4488590"/>
                <a:ext cx="30263" cy="658218"/>
              </a:xfrm>
              <a:custGeom>
                <a:avLst/>
                <a:gdLst/>
                <a:ahLst/>
                <a:cxnLst>
                  <a:cxn ang="0">
                    <a:pos x="0" y="4604"/>
                  </a:cxn>
                  <a:cxn ang="0">
                    <a:pos x="95" y="4604"/>
                  </a:cxn>
                  <a:cxn ang="0">
                    <a:pos x="95" y="0"/>
                  </a:cxn>
                  <a:cxn ang="0">
                    <a:pos x="0" y="0"/>
                  </a:cxn>
                  <a:cxn ang="0">
                    <a:pos x="189" y="0"/>
                  </a:cxn>
                  <a:cxn ang="0">
                    <a:pos x="95" y="0"/>
                  </a:cxn>
                  <a:cxn ang="0">
                    <a:pos x="95" y="4604"/>
                  </a:cxn>
                  <a:cxn ang="0">
                    <a:pos x="189" y="4604"/>
                  </a:cxn>
                  <a:cxn ang="0">
                    <a:pos x="0" y="4604"/>
                  </a:cxn>
                </a:cxnLst>
                <a:rect l="0" t="0" r="r" b="b"/>
                <a:pathLst>
                  <a:path w="189" h="4604">
                    <a:moveTo>
                      <a:pt x="0" y="4604"/>
                    </a:moveTo>
                    <a:lnTo>
                      <a:pt x="95" y="4604"/>
                    </a:lnTo>
                    <a:lnTo>
                      <a:pt x="95" y="0"/>
                    </a:lnTo>
                    <a:lnTo>
                      <a:pt x="0" y="0"/>
                    </a:lnTo>
                    <a:lnTo>
                      <a:pt x="189" y="0"/>
                    </a:lnTo>
                    <a:lnTo>
                      <a:pt x="95" y="0"/>
                    </a:lnTo>
                    <a:lnTo>
                      <a:pt x="95" y="4604"/>
                    </a:lnTo>
                    <a:lnTo>
                      <a:pt x="189" y="4604"/>
                    </a:lnTo>
                    <a:lnTo>
                      <a:pt x="0" y="4604"/>
                    </a:lnTo>
                    <a:close/>
                  </a:path>
                </a:pathLst>
              </a:custGeom>
              <a:solidFill>
                <a:srgbClr val="DBD8AC"/>
              </a:solidFill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44" name="Rectangle 1020"/>
              <p:cNvSpPr>
                <a:spLocks noChangeArrowheads="1"/>
              </p:cNvSpPr>
              <p:nvPr/>
            </p:nvSpPr>
            <p:spPr bwMode="auto">
              <a:xfrm>
                <a:off x="5192924" y="4770922"/>
                <a:ext cx="122027" cy="233050"/>
              </a:xfrm>
              <a:prstGeom prst="rect">
                <a:avLst/>
              </a:prstGeom>
              <a:solidFill>
                <a:srgbClr val="2EB848"/>
              </a:solidFill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45" name="Freeform 1021"/>
              <p:cNvSpPr>
                <a:spLocks/>
              </p:cNvSpPr>
              <p:nvPr/>
            </p:nvSpPr>
            <p:spPr bwMode="auto">
              <a:xfrm>
                <a:off x="5192924" y="4946336"/>
                <a:ext cx="122027" cy="836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756" y="0"/>
                  </a:cxn>
                  <a:cxn ang="0">
                    <a:pos x="0" y="0"/>
                  </a:cxn>
                </a:cxnLst>
                <a:rect l="0" t="0" r="r" b="b"/>
                <a:pathLst>
                  <a:path w="756">
                    <a:moveTo>
                      <a:pt x="0" y="0"/>
                    </a:moveTo>
                    <a:lnTo>
                      <a:pt x="756" y="0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w="2857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</p:grpSp>
      </p:grpSp>
      <p:sp>
        <p:nvSpPr>
          <p:cNvPr id="902" name="TextBox 901"/>
          <p:cNvSpPr txBox="1"/>
          <p:nvPr/>
        </p:nvSpPr>
        <p:spPr>
          <a:xfrm rot="16200000">
            <a:off x="1134190" y="5477591"/>
            <a:ext cx="11049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err="1" smtClean="0">
                <a:latin typeface="Arial" pitchFamily="34" charset="0"/>
                <a:cs typeface="Arial" pitchFamily="34" charset="0"/>
              </a:rPr>
              <a:t>pmol</a:t>
            </a:r>
            <a:r>
              <a:rPr lang="en-GB" sz="1000" b="1" dirty="0" smtClean="0">
                <a:latin typeface="Arial" pitchFamily="34" charset="0"/>
                <a:cs typeface="Arial" pitchFamily="34" charset="0"/>
              </a:rPr>
              <a:t>/mg</a:t>
            </a:r>
            <a:endParaRPr lang="en-GB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78" name="TextBox 777"/>
          <p:cNvSpPr txBox="1"/>
          <p:nvPr/>
        </p:nvSpPr>
        <p:spPr>
          <a:xfrm>
            <a:off x="266701" y="5695950"/>
            <a:ext cx="1257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dirty="0" smtClean="0"/>
              <a:t>NAD+</a:t>
            </a:r>
            <a:endParaRPr lang="en-GB" baseline="-25000" dirty="0"/>
          </a:p>
        </p:txBody>
      </p:sp>
      <p:sp>
        <p:nvSpPr>
          <p:cNvPr id="1785" name="Freeform 761"/>
          <p:cNvSpPr>
            <a:spLocks noEditPoints="1"/>
          </p:cNvSpPr>
          <p:nvPr/>
        </p:nvSpPr>
        <p:spPr bwMode="auto">
          <a:xfrm>
            <a:off x="2017700" y="5371546"/>
            <a:ext cx="2666496" cy="893040"/>
          </a:xfrm>
          <a:custGeom>
            <a:avLst/>
            <a:gdLst/>
            <a:ahLst/>
            <a:cxnLst>
              <a:cxn ang="0">
                <a:pos x="0" y="987"/>
              </a:cxn>
              <a:cxn ang="0">
                <a:pos x="2535" y="987"/>
              </a:cxn>
              <a:cxn ang="0">
                <a:pos x="2535" y="988"/>
              </a:cxn>
              <a:cxn ang="0">
                <a:pos x="0" y="988"/>
              </a:cxn>
              <a:cxn ang="0">
                <a:pos x="0" y="987"/>
              </a:cxn>
              <a:cxn ang="0">
                <a:pos x="0" y="877"/>
              </a:cxn>
              <a:cxn ang="0">
                <a:pos x="2535" y="877"/>
              </a:cxn>
              <a:cxn ang="0">
                <a:pos x="2535" y="878"/>
              </a:cxn>
              <a:cxn ang="0">
                <a:pos x="0" y="878"/>
              </a:cxn>
              <a:cxn ang="0">
                <a:pos x="0" y="877"/>
              </a:cxn>
              <a:cxn ang="0">
                <a:pos x="0" y="768"/>
              </a:cxn>
              <a:cxn ang="0">
                <a:pos x="2535" y="768"/>
              </a:cxn>
              <a:cxn ang="0">
                <a:pos x="2535" y="768"/>
              </a:cxn>
              <a:cxn ang="0">
                <a:pos x="0" y="768"/>
              </a:cxn>
              <a:cxn ang="0">
                <a:pos x="0" y="768"/>
              </a:cxn>
              <a:cxn ang="0">
                <a:pos x="0" y="658"/>
              </a:cxn>
              <a:cxn ang="0">
                <a:pos x="2535" y="658"/>
              </a:cxn>
              <a:cxn ang="0">
                <a:pos x="2535" y="659"/>
              </a:cxn>
              <a:cxn ang="0">
                <a:pos x="0" y="659"/>
              </a:cxn>
              <a:cxn ang="0">
                <a:pos x="0" y="658"/>
              </a:cxn>
              <a:cxn ang="0">
                <a:pos x="0" y="548"/>
              </a:cxn>
              <a:cxn ang="0">
                <a:pos x="2535" y="548"/>
              </a:cxn>
              <a:cxn ang="0">
                <a:pos x="2535" y="549"/>
              </a:cxn>
              <a:cxn ang="0">
                <a:pos x="0" y="549"/>
              </a:cxn>
              <a:cxn ang="0">
                <a:pos x="0" y="548"/>
              </a:cxn>
              <a:cxn ang="0">
                <a:pos x="0" y="439"/>
              </a:cxn>
              <a:cxn ang="0">
                <a:pos x="2535" y="439"/>
              </a:cxn>
              <a:cxn ang="0">
                <a:pos x="2535" y="440"/>
              </a:cxn>
              <a:cxn ang="0">
                <a:pos x="0" y="440"/>
              </a:cxn>
              <a:cxn ang="0">
                <a:pos x="0" y="439"/>
              </a:cxn>
              <a:cxn ang="0">
                <a:pos x="0" y="329"/>
              </a:cxn>
              <a:cxn ang="0">
                <a:pos x="2535" y="329"/>
              </a:cxn>
              <a:cxn ang="0">
                <a:pos x="2535" y="330"/>
              </a:cxn>
              <a:cxn ang="0">
                <a:pos x="0" y="330"/>
              </a:cxn>
              <a:cxn ang="0">
                <a:pos x="0" y="329"/>
              </a:cxn>
              <a:cxn ang="0">
                <a:pos x="0" y="219"/>
              </a:cxn>
              <a:cxn ang="0">
                <a:pos x="2535" y="219"/>
              </a:cxn>
              <a:cxn ang="0">
                <a:pos x="2535" y="220"/>
              </a:cxn>
              <a:cxn ang="0">
                <a:pos x="0" y="220"/>
              </a:cxn>
              <a:cxn ang="0">
                <a:pos x="0" y="219"/>
              </a:cxn>
              <a:cxn ang="0">
                <a:pos x="0" y="109"/>
              </a:cxn>
              <a:cxn ang="0">
                <a:pos x="2535" y="109"/>
              </a:cxn>
              <a:cxn ang="0">
                <a:pos x="2535" y="110"/>
              </a:cxn>
              <a:cxn ang="0">
                <a:pos x="0" y="110"/>
              </a:cxn>
              <a:cxn ang="0">
                <a:pos x="0" y="109"/>
              </a:cxn>
              <a:cxn ang="0">
                <a:pos x="0" y="0"/>
              </a:cxn>
              <a:cxn ang="0">
                <a:pos x="2535" y="0"/>
              </a:cxn>
              <a:cxn ang="0">
                <a:pos x="2535" y="0"/>
              </a:cxn>
              <a:cxn ang="0">
                <a:pos x="0" y="0"/>
              </a:cxn>
              <a:cxn ang="0">
                <a:pos x="0" y="0"/>
              </a:cxn>
            </a:cxnLst>
            <a:rect l="0" t="0" r="r" b="b"/>
            <a:pathLst>
              <a:path w="2535" h="988">
                <a:moveTo>
                  <a:pt x="0" y="987"/>
                </a:moveTo>
                <a:lnTo>
                  <a:pt x="2535" y="987"/>
                </a:lnTo>
                <a:lnTo>
                  <a:pt x="2535" y="988"/>
                </a:lnTo>
                <a:lnTo>
                  <a:pt x="0" y="988"/>
                </a:lnTo>
                <a:lnTo>
                  <a:pt x="0" y="987"/>
                </a:lnTo>
                <a:close/>
                <a:moveTo>
                  <a:pt x="0" y="877"/>
                </a:moveTo>
                <a:lnTo>
                  <a:pt x="2535" y="877"/>
                </a:lnTo>
                <a:lnTo>
                  <a:pt x="2535" y="878"/>
                </a:lnTo>
                <a:lnTo>
                  <a:pt x="0" y="878"/>
                </a:lnTo>
                <a:lnTo>
                  <a:pt x="0" y="877"/>
                </a:lnTo>
                <a:close/>
                <a:moveTo>
                  <a:pt x="0" y="768"/>
                </a:moveTo>
                <a:lnTo>
                  <a:pt x="2535" y="768"/>
                </a:lnTo>
                <a:lnTo>
                  <a:pt x="2535" y="768"/>
                </a:lnTo>
                <a:lnTo>
                  <a:pt x="0" y="768"/>
                </a:lnTo>
                <a:lnTo>
                  <a:pt x="0" y="768"/>
                </a:lnTo>
                <a:close/>
                <a:moveTo>
                  <a:pt x="0" y="658"/>
                </a:moveTo>
                <a:lnTo>
                  <a:pt x="2535" y="658"/>
                </a:lnTo>
                <a:lnTo>
                  <a:pt x="2535" y="659"/>
                </a:lnTo>
                <a:lnTo>
                  <a:pt x="0" y="659"/>
                </a:lnTo>
                <a:lnTo>
                  <a:pt x="0" y="658"/>
                </a:lnTo>
                <a:close/>
                <a:moveTo>
                  <a:pt x="0" y="548"/>
                </a:moveTo>
                <a:lnTo>
                  <a:pt x="2535" y="548"/>
                </a:lnTo>
                <a:lnTo>
                  <a:pt x="2535" y="549"/>
                </a:lnTo>
                <a:lnTo>
                  <a:pt x="0" y="549"/>
                </a:lnTo>
                <a:lnTo>
                  <a:pt x="0" y="548"/>
                </a:lnTo>
                <a:close/>
                <a:moveTo>
                  <a:pt x="0" y="439"/>
                </a:moveTo>
                <a:lnTo>
                  <a:pt x="2535" y="439"/>
                </a:lnTo>
                <a:lnTo>
                  <a:pt x="2535" y="440"/>
                </a:lnTo>
                <a:lnTo>
                  <a:pt x="0" y="440"/>
                </a:lnTo>
                <a:lnTo>
                  <a:pt x="0" y="439"/>
                </a:lnTo>
                <a:close/>
                <a:moveTo>
                  <a:pt x="0" y="329"/>
                </a:moveTo>
                <a:lnTo>
                  <a:pt x="2535" y="329"/>
                </a:lnTo>
                <a:lnTo>
                  <a:pt x="2535" y="330"/>
                </a:lnTo>
                <a:lnTo>
                  <a:pt x="0" y="330"/>
                </a:lnTo>
                <a:lnTo>
                  <a:pt x="0" y="329"/>
                </a:lnTo>
                <a:close/>
                <a:moveTo>
                  <a:pt x="0" y="219"/>
                </a:moveTo>
                <a:lnTo>
                  <a:pt x="2535" y="219"/>
                </a:lnTo>
                <a:lnTo>
                  <a:pt x="2535" y="220"/>
                </a:lnTo>
                <a:lnTo>
                  <a:pt x="0" y="220"/>
                </a:lnTo>
                <a:lnTo>
                  <a:pt x="0" y="219"/>
                </a:lnTo>
                <a:close/>
                <a:moveTo>
                  <a:pt x="0" y="109"/>
                </a:moveTo>
                <a:lnTo>
                  <a:pt x="2535" y="109"/>
                </a:lnTo>
                <a:lnTo>
                  <a:pt x="2535" y="110"/>
                </a:lnTo>
                <a:lnTo>
                  <a:pt x="0" y="110"/>
                </a:lnTo>
                <a:lnTo>
                  <a:pt x="0" y="109"/>
                </a:lnTo>
                <a:close/>
                <a:moveTo>
                  <a:pt x="0" y="0"/>
                </a:moveTo>
                <a:lnTo>
                  <a:pt x="2535" y="0"/>
                </a:lnTo>
                <a:lnTo>
                  <a:pt x="2535" y="0"/>
                </a:ln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786" name="Freeform 762"/>
          <p:cNvSpPr>
            <a:spLocks noEditPoints="1"/>
          </p:cNvSpPr>
          <p:nvPr/>
        </p:nvSpPr>
        <p:spPr bwMode="auto">
          <a:xfrm>
            <a:off x="2015596" y="5369738"/>
            <a:ext cx="2670704" cy="996083"/>
          </a:xfrm>
          <a:custGeom>
            <a:avLst/>
            <a:gdLst/>
            <a:ahLst/>
            <a:cxnLst>
              <a:cxn ang="0">
                <a:pos x="0" y="22"/>
              </a:cxn>
              <a:cxn ang="0">
                <a:pos x="22" y="0"/>
              </a:cxn>
              <a:cxn ang="0">
                <a:pos x="22186" y="0"/>
              </a:cxn>
              <a:cxn ang="0">
                <a:pos x="22208" y="22"/>
              </a:cxn>
              <a:cxn ang="0">
                <a:pos x="22208" y="9894"/>
              </a:cxn>
              <a:cxn ang="0">
                <a:pos x="22186" y="9916"/>
              </a:cxn>
              <a:cxn ang="0">
                <a:pos x="22" y="9916"/>
              </a:cxn>
              <a:cxn ang="0">
                <a:pos x="0" y="9894"/>
              </a:cxn>
              <a:cxn ang="0">
                <a:pos x="0" y="22"/>
              </a:cxn>
              <a:cxn ang="0">
                <a:pos x="44" y="9894"/>
              </a:cxn>
              <a:cxn ang="0">
                <a:pos x="22" y="9872"/>
              </a:cxn>
              <a:cxn ang="0">
                <a:pos x="22186" y="9872"/>
              </a:cxn>
              <a:cxn ang="0">
                <a:pos x="22164" y="9894"/>
              </a:cxn>
              <a:cxn ang="0">
                <a:pos x="22164" y="22"/>
              </a:cxn>
              <a:cxn ang="0">
                <a:pos x="22186" y="44"/>
              </a:cxn>
              <a:cxn ang="0">
                <a:pos x="22" y="44"/>
              </a:cxn>
              <a:cxn ang="0">
                <a:pos x="44" y="22"/>
              </a:cxn>
              <a:cxn ang="0">
                <a:pos x="44" y="9894"/>
              </a:cxn>
            </a:cxnLst>
            <a:rect l="0" t="0" r="r" b="b"/>
            <a:pathLst>
              <a:path w="22208" h="9916">
                <a:moveTo>
                  <a:pt x="0" y="22"/>
                </a:moveTo>
                <a:cubicBezTo>
                  <a:pt x="0" y="10"/>
                  <a:pt x="10" y="0"/>
                  <a:pt x="22" y="0"/>
                </a:cubicBezTo>
                <a:lnTo>
                  <a:pt x="22186" y="0"/>
                </a:lnTo>
                <a:cubicBezTo>
                  <a:pt x="22199" y="0"/>
                  <a:pt x="22208" y="10"/>
                  <a:pt x="22208" y="22"/>
                </a:cubicBezTo>
                <a:lnTo>
                  <a:pt x="22208" y="9894"/>
                </a:lnTo>
                <a:cubicBezTo>
                  <a:pt x="22208" y="9907"/>
                  <a:pt x="22199" y="9916"/>
                  <a:pt x="22186" y="9916"/>
                </a:cubicBezTo>
                <a:lnTo>
                  <a:pt x="22" y="9916"/>
                </a:lnTo>
                <a:cubicBezTo>
                  <a:pt x="10" y="9916"/>
                  <a:pt x="0" y="9907"/>
                  <a:pt x="0" y="9894"/>
                </a:cubicBezTo>
                <a:lnTo>
                  <a:pt x="0" y="22"/>
                </a:lnTo>
                <a:close/>
                <a:moveTo>
                  <a:pt x="44" y="9894"/>
                </a:moveTo>
                <a:lnTo>
                  <a:pt x="22" y="9872"/>
                </a:lnTo>
                <a:lnTo>
                  <a:pt x="22186" y="9872"/>
                </a:lnTo>
                <a:lnTo>
                  <a:pt x="22164" y="9894"/>
                </a:lnTo>
                <a:lnTo>
                  <a:pt x="22164" y="22"/>
                </a:lnTo>
                <a:lnTo>
                  <a:pt x="22186" y="44"/>
                </a:lnTo>
                <a:lnTo>
                  <a:pt x="22" y="44"/>
                </a:lnTo>
                <a:lnTo>
                  <a:pt x="44" y="22"/>
                </a:lnTo>
                <a:lnTo>
                  <a:pt x="44" y="9894"/>
                </a:lnTo>
                <a:close/>
              </a:path>
            </a:pathLst>
          </a:custGeom>
          <a:solidFill>
            <a:srgbClr val="808080"/>
          </a:solidFill>
          <a:ln w="0" cap="flat">
            <a:solidFill>
              <a:srgbClr val="80808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787" name="Rectangle 763"/>
          <p:cNvSpPr>
            <a:spLocks noChangeArrowheads="1"/>
          </p:cNvSpPr>
          <p:nvPr/>
        </p:nvSpPr>
        <p:spPr bwMode="auto">
          <a:xfrm>
            <a:off x="2046100" y="6289895"/>
            <a:ext cx="37867" cy="73215"/>
          </a:xfrm>
          <a:prstGeom prst="rect">
            <a:avLst/>
          </a:prstGeom>
          <a:solidFill>
            <a:srgbClr val="9999FF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788" name="Freeform 764"/>
          <p:cNvSpPr>
            <a:spLocks noEditPoints="1"/>
          </p:cNvSpPr>
          <p:nvPr/>
        </p:nvSpPr>
        <p:spPr bwMode="auto">
          <a:xfrm>
            <a:off x="2043996" y="6287184"/>
            <a:ext cx="43127" cy="78638"/>
          </a:xfrm>
          <a:custGeom>
            <a:avLst/>
            <a:gdLst/>
            <a:ahLst/>
            <a:cxnLst>
              <a:cxn ang="0">
                <a:pos x="0" y="44"/>
              </a:cxn>
              <a:cxn ang="0">
                <a:pos x="44" y="0"/>
              </a:cxn>
              <a:cxn ang="0">
                <a:pos x="676" y="0"/>
              </a:cxn>
              <a:cxn ang="0">
                <a:pos x="720" y="44"/>
              </a:cxn>
              <a:cxn ang="0">
                <a:pos x="720" y="1508"/>
              </a:cxn>
              <a:cxn ang="0">
                <a:pos x="676" y="1552"/>
              </a:cxn>
              <a:cxn ang="0">
                <a:pos x="44" y="1552"/>
              </a:cxn>
              <a:cxn ang="0">
                <a:pos x="0" y="1508"/>
              </a:cxn>
              <a:cxn ang="0">
                <a:pos x="0" y="44"/>
              </a:cxn>
              <a:cxn ang="0">
                <a:pos x="88" y="1508"/>
              </a:cxn>
              <a:cxn ang="0">
                <a:pos x="44" y="1464"/>
              </a:cxn>
              <a:cxn ang="0">
                <a:pos x="676" y="1464"/>
              </a:cxn>
              <a:cxn ang="0">
                <a:pos x="632" y="1508"/>
              </a:cxn>
              <a:cxn ang="0">
                <a:pos x="632" y="44"/>
              </a:cxn>
              <a:cxn ang="0">
                <a:pos x="676" y="88"/>
              </a:cxn>
              <a:cxn ang="0">
                <a:pos x="44" y="88"/>
              </a:cxn>
              <a:cxn ang="0">
                <a:pos x="88" y="44"/>
              </a:cxn>
              <a:cxn ang="0">
                <a:pos x="88" y="1508"/>
              </a:cxn>
            </a:cxnLst>
            <a:rect l="0" t="0" r="r" b="b"/>
            <a:pathLst>
              <a:path w="720" h="1552">
                <a:moveTo>
                  <a:pt x="0" y="44"/>
                </a:moveTo>
                <a:cubicBezTo>
                  <a:pt x="0" y="20"/>
                  <a:pt x="20" y="0"/>
                  <a:pt x="44" y="0"/>
                </a:cubicBezTo>
                <a:lnTo>
                  <a:pt x="676" y="0"/>
                </a:lnTo>
                <a:cubicBezTo>
                  <a:pt x="701" y="0"/>
                  <a:pt x="720" y="20"/>
                  <a:pt x="720" y="44"/>
                </a:cubicBezTo>
                <a:lnTo>
                  <a:pt x="720" y="1508"/>
                </a:lnTo>
                <a:cubicBezTo>
                  <a:pt x="720" y="1533"/>
                  <a:pt x="701" y="1552"/>
                  <a:pt x="676" y="1552"/>
                </a:cubicBezTo>
                <a:lnTo>
                  <a:pt x="44" y="1552"/>
                </a:lnTo>
                <a:cubicBezTo>
                  <a:pt x="20" y="1552"/>
                  <a:pt x="0" y="1533"/>
                  <a:pt x="0" y="1508"/>
                </a:cubicBezTo>
                <a:lnTo>
                  <a:pt x="0" y="44"/>
                </a:lnTo>
                <a:close/>
                <a:moveTo>
                  <a:pt x="88" y="1508"/>
                </a:moveTo>
                <a:lnTo>
                  <a:pt x="44" y="1464"/>
                </a:lnTo>
                <a:lnTo>
                  <a:pt x="676" y="1464"/>
                </a:lnTo>
                <a:lnTo>
                  <a:pt x="632" y="1508"/>
                </a:lnTo>
                <a:lnTo>
                  <a:pt x="632" y="44"/>
                </a:lnTo>
                <a:lnTo>
                  <a:pt x="676" y="88"/>
                </a:lnTo>
                <a:lnTo>
                  <a:pt x="44" y="88"/>
                </a:lnTo>
                <a:lnTo>
                  <a:pt x="88" y="44"/>
                </a:lnTo>
                <a:lnTo>
                  <a:pt x="88" y="1508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789" name="Rectangle 765"/>
          <p:cNvSpPr>
            <a:spLocks noChangeArrowheads="1"/>
          </p:cNvSpPr>
          <p:nvPr/>
        </p:nvSpPr>
        <p:spPr bwMode="auto">
          <a:xfrm>
            <a:off x="2179688" y="5622827"/>
            <a:ext cx="38920" cy="740284"/>
          </a:xfrm>
          <a:prstGeom prst="rect">
            <a:avLst/>
          </a:prstGeom>
          <a:solidFill>
            <a:srgbClr val="9999FF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790" name="Freeform 766"/>
          <p:cNvSpPr>
            <a:spLocks noEditPoints="1"/>
          </p:cNvSpPr>
          <p:nvPr/>
        </p:nvSpPr>
        <p:spPr bwMode="auto">
          <a:xfrm>
            <a:off x="2177584" y="5621019"/>
            <a:ext cx="43127" cy="744803"/>
          </a:xfrm>
          <a:custGeom>
            <a:avLst/>
            <a:gdLst/>
            <a:ahLst/>
            <a:cxnLst>
              <a:cxn ang="0">
                <a:pos x="0" y="44"/>
              </a:cxn>
              <a:cxn ang="0">
                <a:pos x="44" y="0"/>
              </a:cxn>
              <a:cxn ang="0">
                <a:pos x="684" y="0"/>
              </a:cxn>
              <a:cxn ang="0">
                <a:pos x="728" y="44"/>
              </a:cxn>
              <a:cxn ang="0">
                <a:pos x="728" y="14780"/>
              </a:cxn>
              <a:cxn ang="0">
                <a:pos x="684" y="14824"/>
              </a:cxn>
              <a:cxn ang="0">
                <a:pos x="44" y="14824"/>
              </a:cxn>
              <a:cxn ang="0">
                <a:pos x="0" y="14780"/>
              </a:cxn>
              <a:cxn ang="0">
                <a:pos x="0" y="44"/>
              </a:cxn>
              <a:cxn ang="0">
                <a:pos x="88" y="14780"/>
              </a:cxn>
              <a:cxn ang="0">
                <a:pos x="44" y="14736"/>
              </a:cxn>
              <a:cxn ang="0">
                <a:pos x="684" y="14736"/>
              </a:cxn>
              <a:cxn ang="0">
                <a:pos x="640" y="14780"/>
              </a:cxn>
              <a:cxn ang="0">
                <a:pos x="640" y="44"/>
              </a:cxn>
              <a:cxn ang="0">
                <a:pos x="684" y="88"/>
              </a:cxn>
              <a:cxn ang="0">
                <a:pos x="44" y="88"/>
              </a:cxn>
              <a:cxn ang="0">
                <a:pos x="88" y="44"/>
              </a:cxn>
              <a:cxn ang="0">
                <a:pos x="88" y="14780"/>
              </a:cxn>
            </a:cxnLst>
            <a:rect l="0" t="0" r="r" b="b"/>
            <a:pathLst>
              <a:path w="728" h="14824">
                <a:moveTo>
                  <a:pt x="0" y="44"/>
                </a:moveTo>
                <a:cubicBezTo>
                  <a:pt x="0" y="20"/>
                  <a:pt x="20" y="0"/>
                  <a:pt x="44" y="0"/>
                </a:cubicBezTo>
                <a:lnTo>
                  <a:pt x="684" y="0"/>
                </a:lnTo>
                <a:cubicBezTo>
                  <a:pt x="709" y="0"/>
                  <a:pt x="728" y="20"/>
                  <a:pt x="728" y="44"/>
                </a:cubicBezTo>
                <a:lnTo>
                  <a:pt x="728" y="14780"/>
                </a:lnTo>
                <a:cubicBezTo>
                  <a:pt x="728" y="14805"/>
                  <a:pt x="709" y="14824"/>
                  <a:pt x="684" y="14824"/>
                </a:cubicBezTo>
                <a:lnTo>
                  <a:pt x="44" y="14824"/>
                </a:lnTo>
                <a:cubicBezTo>
                  <a:pt x="20" y="14824"/>
                  <a:pt x="0" y="14805"/>
                  <a:pt x="0" y="14780"/>
                </a:cubicBezTo>
                <a:lnTo>
                  <a:pt x="0" y="44"/>
                </a:lnTo>
                <a:close/>
                <a:moveTo>
                  <a:pt x="88" y="14780"/>
                </a:moveTo>
                <a:lnTo>
                  <a:pt x="44" y="14736"/>
                </a:lnTo>
                <a:lnTo>
                  <a:pt x="684" y="14736"/>
                </a:lnTo>
                <a:lnTo>
                  <a:pt x="640" y="14780"/>
                </a:lnTo>
                <a:lnTo>
                  <a:pt x="640" y="44"/>
                </a:lnTo>
                <a:lnTo>
                  <a:pt x="684" y="88"/>
                </a:lnTo>
                <a:lnTo>
                  <a:pt x="44" y="88"/>
                </a:lnTo>
                <a:lnTo>
                  <a:pt x="88" y="44"/>
                </a:lnTo>
                <a:lnTo>
                  <a:pt x="88" y="1478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791" name="Rectangle 767"/>
          <p:cNvSpPr>
            <a:spLocks noChangeArrowheads="1"/>
          </p:cNvSpPr>
          <p:nvPr/>
        </p:nvSpPr>
        <p:spPr bwMode="auto">
          <a:xfrm>
            <a:off x="2313276" y="5984381"/>
            <a:ext cx="37867" cy="378729"/>
          </a:xfrm>
          <a:prstGeom prst="rect">
            <a:avLst/>
          </a:prstGeom>
          <a:solidFill>
            <a:srgbClr val="9999FF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792" name="Freeform 768"/>
          <p:cNvSpPr>
            <a:spLocks noEditPoints="1"/>
          </p:cNvSpPr>
          <p:nvPr/>
        </p:nvSpPr>
        <p:spPr bwMode="auto">
          <a:xfrm>
            <a:off x="2310120" y="5981670"/>
            <a:ext cx="44179" cy="384152"/>
          </a:xfrm>
          <a:custGeom>
            <a:avLst/>
            <a:gdLst/>
            <a:ahLst/>
            <a:cxnLst>
              <a:cxn ang="0">
                <a:pos x="0" y="44"/>
              </a:cxn>
              <a:cxn ang="0">
                <a:pos x="44" y="0"/>
              </a:cxn>
              <a:cxn ang="0">
                <a:pos x="684" y="0"/>
              </a:cxn>
              <a:cxn ang="0">
                <a:pos x="728" y="44"/>
              </a:cxn>
              <a:cxn ang="0">
                <a:pos x="728" y="7596"/>
              </a:cxn>
              <a:cxn ang="0">
                <a:pos x="684" y="7640"/>
              </a:cxn>
              <a:cxn ang="0">
                <a:pos x="44" y="7640"/>
              </a:cxn>
              <a:cxn ang="0">
                <a:pos x="0" y="7596"/>
              </a:cxn>
              <a:cxn ang="0">
                <a:pos x="0" y="44"/>
              </a:cxn>
              <a:cxn ang="0">
                <a:pos x="88" y="7596"/>
              </a:cxn>
              <a:cxn ang="0">
                <a:pos x="44" y="7552"/>
              </a:cxn>
              <a:cxn ang="0">
                <a:pos x="684" y="7552"/>
              </a:cxn>
              <a:cxn ang="0">
                <a:pos x="640" y="7596"/>
              </a:cxn>
              <a:cxn ang="0">
                <a:pos x="640" y="44"/>
              </a:cxn>
              <a:cxn ang="0">
                <a:pos x="684" y="88"/>
              </a:cxn>
              <a:cxn ang="0">
                <a:pos x="44" y="88"/>
              </a:cxn>
              <a:cxn ang="0">
                <a:pos x="88" y="44"/>
              </a:cxn>
              <a:cxn ang="0">
                <a:pos x="88" y="7596"/>
              </a:cxn>
            </a:cxnLst>
            <a:rect l="0" t="0" r="r" b="b"/>
            <a:pathLst>
              <a:path w="728" h="7640">
                <a:moveTo>
                  <a:pt x="0" y="44"/>
                </a:moveTo>
                <a:cubicBezTo>
                  <a:pt x="0" y="20"/>
                  <a:pt x="20" y="0"/>
                  <a:pt x="44" y="0"/>
                </a:cubicBezTo>
                <a:lnTo>
                  <a:pt x="684" y="0"/>
                </a:lnTo>
                <a:cubicBezTo>
                  <a:pt x="709" y="0"/>
                  <a:pt x="728" y="20"/>
                  <a:pt x="728" y="44"/>
                </a:cubicBezTo>
                <a:lnTo>
                  <a:pt x="728" y="7596"/>
                </a:lnTo>
                <a:cubicBezTo>
                  <a:pt x="728" y="7621"/>
                  <a:pt x="709" y="7640"/>
                  <a:pt x="684" y="7640"/>
                </a:cubicBezTo>
                <a:lnTo>
                  <a:pt x="44" y="7640"/>
                </a:lnTo>
                <a:cubicBezTo>
                  <a:pt x="20" y="7640"/>
                  <a:pt x="0" y="7621"/>
                  <a:pt x="0" y="7596"/>
                </a:cubicBezTo>
                <a:lnTo>
                  <a:pt x="0" y="44"/>
                </a:lnTo>
                <a:close/>
                <a:moveTo>
                  <a:pt x="88" y="7596"/>
                </a:moveTo>
                <a:lnTo>
                  <a:pt x="44" y="7552"/>
                </a:lnTo>
                <a:lnTo>
                  <a:pt x="684" y="7552"/>
                </a:lnTo>
                <a:lnTo>
                  <a:pt x="640" y="7596"/>
                </a:lnTo>
                <a:lnTo>
                  <a:pt x="640" y="44"/>
                </a:lnTo>
                <a:lnTo>
                  <a:pt x="684" y="88"/>
                </a:lnTo>
                <a:lnTo>
                  <a:pt x="44" y="88"/>
                </a:lnTo>
                <a:lnTo>
                  <a:pt x="88" y="44"/>
                </a:lnTo>
                <a:lnTo>
                  <a:pt x="88" y="7596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793" name="Rectangle 769"/>
          <p:cNvSpPr>
            <a:spLocks noChangeArrowheads="1"/>
          </p:cNvSpPr>
          <p:nvPr/>
        </p:nvSpPr>
        <p:spPr bwMode="auto">
          <a:xfrm>
            <a:off x="2445811" y="6292607"/>
            <a:ext cx="38920" cy="70503"/>
          </a:xfrm>
          <a:prstGeom prst="rect">
            <a:avLst/>
          </a:prstGeom>
          <a:solidFill>
            <a:srgbClr val="9999FF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794" name="Freeform 770"/>
          <p:cNvSpPr>
            <a:spLocks noEditPoints="1"/>
          </p:cNvSpPr>
          <p:nvPr/>
        </p:nvSpPr>
        <p:spPr bwMode="auto">
          <a:xfrm>
            <a:off x="2443708" y="6289895"/>
            <a:ext cx="44179" cy="75926"/>
          </a:xfrm>
          <a:custGeom>
            <a:avLst/>
            <a:gdLst/>
            <a:ahLst/>
            <a:cxnLst>
              <a:cxn ang="0">
                <a:pos x="0" y="44"/>
              </a:cxn>
              <a:cxn ang="0">
                <a:pos x="44" y="0"/>
              </a:cxn>
              <a:cxn ang="0">
                <a:pos x="684" y="0"/>
              </a:cxn>
              <a:cxn ang="0">
                <a:pos x="728" y="44"/>
              </a:cxn>
              <a:cxn ang="0">
                <a:pos x="728" y="1452"/>
              </a:cxn>
              <a:cxn ang="0">
                <a:pos x="684" y="1496"/>
              </a:cxn>
              <a:cxn ang="0">
                <a:pos x="44" y="1496"/>
              </a:cxn>
              <a:cxn ang="0">
                <a:pos x="0" y="1452"/>
              </a:cxn>
              <a:cxn ang="0">
                <a:pos x="0" y="44"/>
              </a:cxn>
              <a:cxn ang="0">
                <a:pos x="88" y="1452"/>
              </a:cxn>
              <a:cxn ang="0">
                <a:pos x="44" y="1408"/>
              </a:cxn>
              <a:cxn ang="0">
                <a:pos x="684" y="1408"/>
              </a:cxn>
              <a:cxn ang="0">
                <a:pos x="640" y="1452"/>
              </a:cxn>
              <a:cxn ang="0">
                <a:pos x="640" y="44"/>
              </a:cxn>
              <a:cxn ang="0">
                <a:pos x="684" y="88"/>
              </a:cxn>
              <a:cxn ang="0">
                <a:pos x="44" y="88"/>
              </a:cxn>
              <a:cxn ang="0">
                <a:pos x="88" y="44"/>
              </a:cxn>
              <a:cxn ang="0">
                <a:pos x="88" y="1452"/>
              </a:cxn>
            </a:cxnLst>
            <a:rect l="0" t="0" r="r" b="b"/>
            <a:pathLst>
              <a:path w="728" h="1496">
                <a:moveTo>
                  <a:pt x="0" y="44"/>
                </a:moveTo>
                <a:cubicBezTo>
                  <a:pt x="0" y="20"/>
                  <a:pt x="20" y="0"/>
                  <a:pt x="44" y="0"/>
                </a:cubicBezTo>
                <a:lnTo>
                  <a:pt x="684" y="0"/>
                </a:lnTo>
                <a:cubicBezTo>
                  <a:pt x="709" y="0"/>
                  <a:pt x="728" y="20"/>
                  <a:pt x="728" y="44"/>
                </a:cubicBezTo>
                <a:lnTo>
                  <a:pt x="728" y="1452"/>
                </a:lnTo>
                <a:cubicBezTo>
                  <a:pt x="728" y="1477"/>
                  <a:pt x="709" y="1496"/>
                  <a:pt x="684" y="1496"/>
                </a:cubicBezTo>
                <a:lnTo>
                  <a:pt x="44" y="1496"/>
                </a:lnTo>
                <a:cubicBezTo>
                  <a:pt x="20" y="1496"/>
                  <a:pt x="0" y="1477"/>
                  <a:pt x="0" y="1452"/>
                </a:cubicBezTo>
                <a:lnTo>
                  <a:pt x="0" y="44"/>
                </a:lnTo>
                <a:close/>
                <a:moveTo>
                  <a:pt x="88" y="1452"/>
                </a:moveTo>
                <a:lnTo>
                  <a:pt x="44" y="1408"/>
                </a:lnTo>
                <a:lnTo>
                  <a:pt x="684" y="1408"/>
                </a:lnTo>
                <a:lnTo>
                  <a:pt x="640" y="1452"/>
                </a:lnTo>
                <a:lnTo>
                  <a:pt x="640" y="44"/>
                </a:lnTo>
                <a:lnTo>
                  <a:pt x="684" y="88"/>
                </a:lnTo>
                <a:lnTo>
                  <a:pt x="44" y="88"/>
                </a:lnTo>
                <a:lnTo>
                  <a:pt x="88" y="44"/>
                </a:lnTo>
                <a:lnTo>
                  <a:pt x="88" y="1452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795" name="Rectangle 771"/>
          <p:cNvSpPr>
            <a:spLocks noChangeArrowheads="1"/>
          </p:cNvSpPr>
          <p:nvPr/>
        </p:nvSpPr>
        <p:spPr bwMode="auto">
          <a:xfrm>
            <a:off x="2580451" y="6032288"/>
            <a:ext cx="37867" cy="330823"/>
          </a:xfrm>
          <a:prstGeom prst="rect">
            <a:avLst/>
          </a:prstGeom>
          <a:solidFill>
            <a:srgbClr val="9999FF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796" name="Freeform 772"/>
          <p:cNvSpPr>
            <a:spLocks noEditPoints="1"/>
          </p:cNvSpPr>
          <p:nvPr/>
        </p:nvSpPr>
        <p:spPr bwMode="auto">
          <a:xfrm>
            <a:off x="2577296" y="6029576"/>
            <a:ext cx="43127" cy="336246"/>
          </a:xfrm>
          <a:custGeom>
            <a:avLst/>
            <a:gdLst/>
            <a:ahLst/>
            <a:cxnLst>
              <a:cxn ang="0">
                <a:pos x="0" y="44"/>
              </a:cxn>
              <a:cxn ang="0">
                <a:pos x="44" y="0"/>
              </a:cxn>
              <a:cxn ang="0">
                <a:pos x="676" y="0"/>
              </a:cxn>
              <a:cxn ang="0">
                <a:pos x="720" y="44"/>
              </a:cxn>
              <a:cxn ang="0">
                <a:pos x="720" y="6636"/>
              </a:cxn>
              <a:cxn ang="0">
                <a:pos x="676" y="6680"/>
              </a:cxn>
              <a:cxn ang="0">
                <a:pos x="44" y="6680"/>
              </a:cxn>
              <a:cxn ang="0">
                <a:pos x="0" y="6636"/>
              </a:cxn>
              <a:cxn ang="0">
                <a:pos x="0" y="44"/>
              </a:cxn>
              <a:cxn ang="0">
                <a:pos x="88" y="6636"/>
              </a:cxn>
              <a:cxn ang="0">
                <a:pos x="44" y="6592"/>
              </a:cxn>
              <a:cxn ang="0">
                <a:pos x="676" y="6592"/>
              </a:cxn>
              <a:cxn ang="0">
                <a:pos x="632" y="6636"/>
              </a:cxn>
              <a:cxn ang="0">
                <a:pos x="632" y="44"/>
              </a:cxn>
              <a:cxn ang="0">
                <a:pos x="676" y="88"/>
              </a:cxn>
              <a:cxn ang="0">
                <a:pos x="44" y="88"/>
              </a:cxn>
              <a:cxn ang="0">
                <a:pos x="88" y="44"/>
              </a:cxn>
              <a:cxn ang="0">
                <a:pos x="88" y="6636"/>
              </a:cxn>
            </a:cxnLst>
            <a:rect l="0" t="0" r="r" b="b"/>
            <a:pathLst>
              <a:path w="720" h="6680">
                <a:moveTo>
                  <a:pt x="0" y="44"/>
                </a:moveTo>
                <a:cubicBezTo>
                  <a:pt x="0" y="20"/>
                  <a:pt x="20" y="0"/>
                  <a:pt x="44" y="0"/>
                </a:cubicBezTo>
                <a:lnTo>
                  <a:pt x="676" y="0"/>
                </a:lnTo>
                <a:cubicBezTo>
                  <a:pt x="701" y="0"/>
                  <a:pt x="720" y="20"/>
                  <a:pt x="720" y="44"/>
                </a:cubicBezTo>
                <a:lnTo>
                  <a:pt x="720" y="6636"/>
                </a:lnTo>
                <a:cubicBezTo>
                  <a:pt x="720" y="6661"/>
                  <a:pt x="701" y="6680"/>
                  <a:pt x="676" y="6680"/>
                </a:cubicBezTo>
                <a:lnTo>
                  <a:pt x="44" y="6680"/>
                </a:lnTo>
                <a:cubicBezTo>
                  <a:pt x="20" y="6680"/>
                  <a:pt x="0" y="6661"/>
                  <a:pt x="0" y="6636"/>
                </a:cubicBezTo>
                <a:lnTo>
                  <a:pt x="0" y="44"/>
                </a:lnTo>
                <a:close/>
                <a:moveTo>
                  <a:pt x="88" y="6636"/>
                </a:moveTo>
                <a:lnTo>
                  <a:pt x="44" y="6592"/>
                </a:lnTo>
                <a:lnTo>
                  <a:pt x="676" y="6592"/>
                </a:lnTo>
                <a:lnTo>
                  <a:pt x="632" y="6636"/>
                </a:lnTo>
                <a:lnTo>
                  <a:pt x="632" y="44"/>
                </a:lnTo>
                <a:lnTo>
                  <a:pt x="676" y="88"/>
                </a:lnTo>
                <a:lnTo>
                  <a:pt x="44" y="88"/>
                </a:lnTo>
                <a:lnTo>
                  <a:pt x="88" y="44"/>
                </a:lnTo>
                <a:lnTo>
                  <a:pt x="88" y="6636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797" name="Rectangle 773"/>
          <p:cNvSpPr>
            <a:spLocks noChangeArrowheads="1"/>
          </p:cNvSpPr>
          <p:nvPr/>
        </p:nvSpPr>
        <p:spPr bwMode="auto">
          <a:xfrm>
            <a:off x="2712987" y="6273625"/>
            <a:ext cx="37867" cy="89485"/>
          </a:xfrm>
          <a:prstGeom prst="rect">
            <a:avLst/>
          </a:prstGeom>
          <a:solidFill>
            <a:srgbClr val="9999FF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798" name="Freeform 774"/>
          <p:cNvSpPr>
            <a:spLocks noEditPoints="1"/>
          </p:cNvSpPr>
          <p:nvPr/>
        </p:nvSpPr>
        <p:spPr bwMode="auto">
          <a:xfrm>
            <a:off x="2710883" y="6270914"/>
            <a:ext cx="43127" cy="94908"/>
          </a:xfrm>
          <a:custGeom>
            <a:avLst/>
            <a:gdLst/>
            <a:ahLst/>
            <a:cxnLst>
              <a:cxn ang="0">
                <a:pos x="0" y="44"/>
              </a:cxn>
              <a:cxn ang="0">
                <a:pos x="44" y="0"/>
              </a:cxn>
              <a:cxn ang="0">
                <a:pos x="676" y="0"/>
              </a:cxn>
              <a:cxn ang="0">
                <a:pos x="720" y="44"/>
              </a:cxn>
              <a:cxn ang="0">
                <a:pos x="720" y="1836"/>
              </a:cxn>
              <a:cxn ang="0">
                <a:pos x="676" y="1880"/>
              </a:cxn>
              <a:cxn ang="0">
                <a:pos x="44" y="1880"/>
              </a:cxn>
              <a:cxn ang="0">
                <a:pos x="0" y="1836"/>
              </a:cxn>
              <a:cxn ang="0">
                <a:pos x="0" y="44"/>
              </a:cxn>
              <a:cxn ang="0">
                <a:pos x="88" y="1836"/>
              </a:cxn>
              <a:cxn ang="0">
                <a:pos x="44" y="1792"/>
              </a:cxn>
              <a:cxn ang="0">
                <a:pos x="676" y="1792"/>
              </a:cxn>
              <a:cxn ang="0">
                <a:pos x="632" y="1836"/>
              </a:cxn>
              <a:cxn ang="0">
                <a:pos x="632" y="44"/>
              </a:cxn>
              <a:cxn ang="0">
                <a:pos x="676" y="88"/>
              </a:cxn>
              <a:cxn ang="0">
                <a:pos x="44" y="88"/>
              </a:cxn>
              <a:cxn ang="0">
                <a:pos x="88" y="44"/>
              </a:cxn>
              <a:cxn ang="0">
                <a:pos x="88" y="1836"/>
              </a:cxn>
            </a:cxnLst>
            <a:rect l="0" t="0" r="r" b="b"/>
            <a:pathLst>
              <a:path w="720" h="1880">
                <a:moveTo>
                  <a:pt x="0" y="44"/>
                </a:moveTo>
                <a:cubicBezTo>
                  <a:pt x="0" y="20"/>
                  <a:pt x="20" y="0"/>
                  <a:pt x="44" y="0"/>
                </a:cubicBezTo>
                <a:lnTo>
                  <a:pt x="676" y="0"/>
                </a:lnTo>
                <a:cubicBezTo>
                  <a:pt x="701" y="0"/>
                  <a:pt x="720" y="20"/>
                  <a:pt x="720" y="44"/>
                </a:cubicBezTo>
                <a:lnTo>
                  <a:pt x="720" y="1836"/>
                </a:lnTo>
                <a:cubicBezTo>
                  <a:pt x="720" y="1861"/>
                  <a:pt x="701" y="1880"/>
                  <a:pt x="676" y="1880"/>
                </a:cubicBezTo>
                <a:lnTo>
                  <a:pt x="44" y="1880"/>
                </a:lnTo>
                <a:cubicBezTo>
                  <a:pt x="20" y="1880"/>
                  <a:pt x="0" y="1861"/>
                  <a:pt x="0" y="1836"/>
                </a:cubicBezTo>
                <a:lnTo>
                  <a:pt x="0" y="44"/>
                </a:lnTo>
                <a:close/>
                <a:moveTo>
                  <a:pt x="88" y="1836"/>
                </a:moveTo>
                <a:lnTo>
                  <a:pt x="44" y="1792"/>
                </a:lnTo>
                <a:lnTo>
                  <a:pt x="676" y="1792"/>
                </a:lnTo>
                <a:lnTo>
                  <a:pt x="632" y="1836"/>
                </a:lnTo>
                <a:lnTo>
                  <a:pt x="632" y="44"/>
                </a:lnTo>
                <a:lnTo>
                  <a:pt x="676" y="88"/>
                </a:lnTo>
                <a:lnTo>
                  <a:pt x="44" y="88"/>
                </a:lnTo>
                <a:lnTo>
                  <a:pt x="88" y="44"/>
                </a:lnTo>
                <a:lnTo>
                  <a:pt x="88" y="1836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799" name="Rectangle 775"/>
          <p:cNvSpPr>
            <a:spLocks noChangeArrowheads="1"/>
          </p:cNvSpPr>
          <p:nvPr/>
        </p:nvSpPr>
        <p:spPr bwMode="auto">
          <a:xfrm>
            <a:off x="2846575" y="6351359"/>
            <a:ext cx="37867" cy="11751"/>
          </a:xfrm>
          <a:prstGeom prst="rect">
            <a:avLst/>
          </a:prstGeom>
          <a:solidFill>
            <a:srgbClr val="9999FF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800" name="Freeform 776"/>
          <p:cNvSpPr>
            <a:spLocks noEditPoints="1"/>
          </p:cNvSpPr>
          <p:nvPr/>
        </p:nvSpPr>
        <p:spPr bwMode="auto">
          <a:xfrm>
            <a:off x="2843419" y="6349552"/>
            <a:ext cx="44179" cy="16270"/>
          </a:xfrm>
          <a:custGeom>
            <a:avLst/>
            <a:gdLst/>
            <a:ahLst/>
            <a:cxnLst>
              <a:cxn ang="0">
                <a:pos x="0" y="44"/>
              </a:cxn>
              <a:cxn ang="0">
                <a:pos x="44" y="0"/>
              </a:cxn>
              <a:cxn ang="0">
                <a:pos x="676" y="0"/>
              </a:cxn>
              <a:cxn ang="0">
                <a:pos x="720" y="44"/>
              </a:cxn>
              <a:cxn ang="0">
                <a:pos x="720" y="276"/>
              </a:cxn>
              <a:cxn ang="0">
                <a:pos x="676" y="320"/>
              </a:cxn>
              <a:cxn ang="0">
                <a:pos x="44" y="320"/>
              </a:cxn>
              <a:cxn ang="0">
                <a:pos x="0" y="276"/>
              </a:cxn>
              <a:cxn ang="0">
                <a:pos x="0" y="44"/>
              </a:cxn>
              <a:cxn ang="0">
                <a:pos x="88" y="276"/>
              </a:cxn>
              <a:cxn ang="0">
                <a:pos x="44" y="232"/>
              </a:cxn>
              <a:cxn ang="0">
                <a:pos x="676" y="232"/>
              </a:cxn>
              <a:cxn ang="0">
                <a:pos x="632" y="276"/>
              </a:cxn>
              <a:cxn ang="0">
                <a:pos x="632" y="44"/>
              </a:cxn>
              <a:cxn ang="0">
                <a:pos x="676" y="88"/>
              </a:cxn>
              <a:cxn ang="0">
                <a:pos x="44" y="88"/>
              </a:cxn>
              <a:cxn ang="0">
                <a:pos x="88" y="44"/>
              </a:cxn>
              <a:cxn ang="0">
                <a:pos x="88" y="276"/>
              </a:cxn>
            </a:cxnLst>
            <a:rect l="0" t="0" r="r" b="b"/>
            <a:pathLst>
              <a:path w="720" h="320">
                <a:moveTo>
                  <a:pt x="0" y="44"/>
                </a:moveTo>
                <a:cubicBezTo>
                  <a:pt x="0" y="20"/>
                  <a:pt x="20" y="0"/>
                  <a:pt x="44" y="0"/>
                </a:cubicBezTo>
                <a:lnTo>
                  <a:pt x="676" y="0"/>
                </a:lnTo>
                <a:cubicBezTo>
                  <a:pt x="701" y="0"/>
                  <a:pt x="720" y="20"/>
                  <a:pt x="720" y="44"/>
                </a:cubicBezTo>
                <a:lnTo>
                  <a:pt x="720" y="276"/>
                </a:lnTo>
                <a:cubicBezTo>
                  <a:pt x="720" y="301"/>
                  <a:pt x="701" y="320"/>
                  <a:pt x="676" y="320"/>
                </a:cubicBezTo>
                <a:lnTo>
                  <a:pt x="44" y="320"/>
                </a:lnTo>
                <a:cubicBezTo>
                  <a:pt x="20" y="320"/>
                  <a:pt x="0" y="301"/>
                  <a:pt x="0" y="276"/>
                </a:cubicBezTo>
                <a:lnTo>
                  <a:pt x="0" y="44"/>
                </a:lnTo>
                <a:close/>
                <a:moveTo>
                  <a:pt x="88" y="276"/>
                </a:moveTo>
                <a:lnTo>
                  <a:pt x="44" y="232"/>
                </a:lnTo>
                <a:lnTo>
                  <a:pt x="676" y="232"/>
                </a:lnTo>
                <a:lnTo>
                  <a:pt x="632" y="276"/>
                </a:lnTo>
                <a:lnTo>
                  <a:pt x="632" y="44"/>
                </a:lnTo>
                <a:lnTo>
                  <a:pt x="676" y="88"/>
                </a:lnTo>
                <a:lnTo>
                  <a:pt x="44" y="88"/>
                </a:lnTo>
                <a:lnTo>
                  <a:pt x="88" y="44"/>
                </a:lnTo>
                <a:lnTo>
                  <a:pt x="88" y="276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801" name="Rectangle 777"/>
          <p:cNvSpPr>
            <a:spLocks noChangeArrowheads="1"/>
          </p:cNvSpPr>
          <p:nvPr/>
        </p:nvSpPr>
        <p:spPr bwMode="auto">
          <a:xfrm>
            <a:off x="2980163" y="6055789"/>
            <a:ext cx="37867" cy="307321"/>
          </a:xfrm>
          <a:prstGeom prst="rect">
            <a:avLst/>
          </a:prstGeom>
          <a:solidFill>
            <a:srgbClr val="9999FF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802" name="Freeform 778"/>
          <p:cNvSpPr>
            <a:spLocks noEditPoints="1"/>
          </p:cNvSpPr>
          <p:nvPr/>
        </p:nvSpPr>
        <p:spPr bwMode="auto">
          <a:xfrm>
            <a:off x="2977007" y="6053981"/>
            <a:ext cx="43127" cy="311841"/>
          </a:xfrm>
          <a:custGeom>
            <a:avLst/>
            <a:gdLst/>
            <a:ahLst/>
            <a:cxnLst>
              <a:cxn ang="0">
                <a:pos x="0" y="44"/>
              </a:cxn>
              <a:cxn ang="0">
                <a:pos x="44" y="0"/>
              </a:cxn>
              <a:cxn ang="0">
                <a:pos x="676" y="0"/>
              </a:cxn>
              <a:cxn ang="0">
                <a:pos x="720" y="44"/>
              </a:cxn>
              <a:cxn ang="0">
                <a:pos x="720" y="6164"/>
              </a:cxn>
              <a:cxn ang="0">
                <a:pos x="676" y="6208"/>
              </a:cxn>
              <a:cxn ang="0">
                <a:pos x="44" y="6208"/>
              </a:cxn>
              <a:cxn ang="0">
                <a:pos x="0" y="6164"/>
              </a:cxn>
              <a:cxn ang="0">
                <a:pos x="0" y="44"/>
              </a:cxn>
              <a:cxn ang="0">
                <a:pos x="88" y="6164"/>
              </a:cxn>
              <a:cxn ang="0">
                <a:pos x="44" y="6120"/>
              </a:cxn>
              <a:cxn ang="0">
                <a:pos x="676" y="6120"/>
              </a:cxn>
              <a:cxn ang="0">
                <a:pos x="632" y="6164"/>
              </a:cxn>
              <a:cxn ang="0">
                <a:pos x="632" y="44"/>
              </a:cxn>
              <a:cxn ang="0">
                <a:pos x="676" y="88"/>
              </a:cxn>
              <a:cxn ang="0">
                <a:pos x="44" y="88"/>
              </a:cxn>
              <a:cxn ang="0">
                <a:pos x="88" y="44"/>
              </a:cxn>
              <a:cxn ang="0">
                <a:pos x="88" y="6164"/>
              </a:cxn>
            </a:cxnLst>
            <a:rect l="0" t="0" r="r" b="b"/>
            <a:pathLst>
              <a:path w="720" h="6208">
                <a:moveTo>
                  <a:pt x="0" y="44"/>
                </a:moveTo>
                <a:cubicBezTo>
                  <a:pt x="0" y="20"/>
                  <a:pt x="20" y="0"/>
                  <a:pt x="44" y="0"/>
                </a:cubicBezTo>
                <a:lnTo>
                  <a:pt x="676" y="0"/>
                </a:lnTo>
                <a:cubicBezTo>
                  <a:pt x="701" y="0"/>
                  <a:pt x="720" y="20"/>
                  <a:pt x="720" y="44"/>
                </a:cubicBezTo>
                <a:lnTo>
                  <a:pt x="720" y="6164"/>
                </a:lnTo>
                <a:cubicBezTo>
                  <a:pt x="720" y="6189"/>
                  <a:pt x="701" y="6208"/>
                  <a:pt x="676" y="6208"/>
                </a:cubicBezTo>
                <a:lnTo>
                  <a:pt x="44" y="6208"/>
                </a:lnTo>
                <a:cubicBezTo>
                  <a:pt x="20" y="6208"/>
                  <a:pt x="0" y="6189"/>
                  <a:pt x="0" y="6164"/>
                </a:cubicBezTo>
                <a:lnTo>
                  <a:pt x="0" y="44"/>
                </a:lnTo>
                <a:close/>
                <a:moveTo>
                  <a:pt x="88" y="6164"/>
                </a:moveTo>
                <a:lnTo>
                  <a:pt x="44" y="6120"/>
                </a:lnTo>
                <a:lnTo>
                  <a:pt x="676" y="6120"/>
                </a:lnTo>
                <a:lnTo>
                  <a:pt x="632" y="6164"/>
                </a:lnTo>
                <a:lnTo>
                  <a:pt x="632" y="44"/>
                </a:lnTo>
                <a:lnTo>
                  <a:pt x="676" y="88"/>
                </a:lnTo>
                <a:lnTo>
                  <a:pt x="44" y="88"/>
                </a:lnTo>
                <a:lnTo>
                  <a:pt x="88" y="44"/>
                </a:lnTo>
                <a:lnTo>
                  <a:pt x="88" y="6164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803" name="Rectangle 779"/>
          <p:cNvSpPr>
            <a:spLocks noChangeArrowheads="1"/>
          </p:cNvSpPr>
          <p:nvPr/>
        </p:nvSpPr>
        <p:spPr bwMode="auto">
          <a:xfrm>
            <a:off x="3112698" y="6089232"/>
            <a:ext cx="38920" cy="273878"/>
          </a:xfrm>
          <a:prstGeom prst="rect">
            <a:avLst/>
          </a:prstGeom>
          <a:solidFill>
            <a:srgbClr val="9999FF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804" name="Freeform 780"/>
          <p:cNvSpPr>
            <a:spLocks noEditPoints="1"/>
          </p:cNvSpPr>
          <p:nvPr/>
        </p:nvSpPr>
        <p:spPr bwMode="auto">
          <a:xfrm>
            <a:off x="3110595" y="6087425"/>
            <a:ext cx="43127" cy="278397"/>
          </a:xfrm>
          <a:custGeom>
            <a:avLst/>
            <a:gdLst/>
            <a:ahLst/>
            <a:cxnLst>
              <a:cxn ang="0">
                <a:pos x="0" y="44"/>
              </a:cxn>
              <a:cxn ang="0">
                <a:pos x="44" y="0"/>
              </a:cxn>
              <a:cxn ang="0">
                <a:pos x="676" y="0"/>
              </a:cxn>
              <a:cxn ang="0">
                <a:pos x="720" y="44"/>
              </a:cxn>
              <a:cxn ang="0">
                <a:pos x="720" y="5492"/>
              </a:cxn>
              <a:cxn ang="0">
                <a:pos x="676" y="5536"/>
              </a:cxn>
              <a:cxn ang="0">
                <a:pos x="44" y="5536"/>
              </a:cxn>
              <a:cxn ang="0">
                <a:pos x="0" y="5492"/>
              </a:cxn>
              <a:cxn ang="0">
                <a:pos x="0" y="44"/>
              </a:cxn>
              <a:cxn ang="0">
                <a:pos x="88" y="5492"/>
              </a:cxn>
              <a:cxn ang="0">
                <a:pos x="44" y="5448"/>
              </a:cxn>
              <a:cxn ang="0">
                <a:pos x="676" y="5448"/>
              </a:cxn>
              <a:cxn ang="0">
                <a:pos x="632" y="5492"/>
              </a:cxn>
              <a:cxn ang="0">
                <a:pos x="632" y="44"/>
              </a:cxn>
              <a:cxn ang="0">
                <a:pos x="676" y="88"/>
              </a:cxn>
              <a:cxn ang="0">
                <a:pos x="44" y="88"/>
              </a:cxn>
              <a:cxn ang="0">
                <a:pos x="88" y="44"/>
              </a:cxn>
              <a:cxn ang="0">
                <a:pos x="88" y="5492"/>
              </a:cxn>
            </a:cxnLst>
            <a:rect l="0" t="0" r="r" b="b"/>
            <a:pathLst>
              <a:path w="720" h="5536">
                <a:moveTo>
                  <a:pt x="0" y="44"/>
                </a:moveTo>
                <a:cubicBezTo>
                  <a:pt x="0" y="20"/>
                  <a:pt x="20" y="0"/>
                  <a:pt x="44" y="0"/>
                </a:cubicBezTo>
                <a:lnTo>
                  <a:pt x="676" y="0"/>
                </a:lnTo>
                <a:cubicBezTo>
                  <a:pt x="701" y="0"/>
                  <a:pt x="720" y="20"/>
                  <a:pt x="720" y="44"/>
                </a:cubicBezTo>
                <a:lnTo>
                  <a:pt x="720" y="5492"/>
                </a:lnTo>
                <a:cubicBezTo>
                  <a:pt x="720" y="5517"/>
                  <a:pt x="701" y="5536"/>
                  <a:pt x="676" y="5536"/>
                </a:cubicBezTo>
                <a:lnTo>
                  <a:pt x="44" y="5536"/>
                </a:lnTo>
                <a:cubicBezTo>
                  <a:pt x="20" y="5536"/>
                  <a:pt x="0" y="5517"/>
                  <a:pt x="0" y="5492"/>
                </a:cubicBezTo>
                <a:lnTo>
                  <a:pt x="0" y="44"/>
                </a:lnTo>
                <a:close/>
                <a:moveTo>
                  <a:pt x="88" y="5492"/>
                </a:moveTo>
                <a:lnTo>
                  <a:pt x="44" y="5448"/>
                </a:lnTo>
                <a:lnTo>
                  <a:pt x="676" y="5448"/>
                </a:lnTo>
                <a:lnTo>
                  <a:pt x="632" y="5492"/>
                </a:lnTo>
                <a:lnTo>
                  <a:pt x="632" y="44"/>
                </a:lnTo>
                <a:lnTo>
                  <a:pt x="676" y="88"/>
                </a:lnTo>
                <a:lnTo>
                  <a:pt x="44" y="88"/>
                </a:lnTo>
                <a:lnTo>
                  <a:pt x="88" y="44"/>
                </a:lnTo>
                <a:lnTo>
                  <a:pt x="88" y="5492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805" name="Rectangle 781"/>
          <p:cNvSpPr>
            <a:spLocks noChangeArrowheads="1"/>
          </p:cNvSpPr>
          <p:nvPr/>
        </p:nvSpPr>
        <p:spPr bwMode="auto">
          <a:xfrm>
            <a:off x="3246287" y="5965400"/>
            <a:ext cx="37867" cy="397710"/>
          </a:xfrm>
          <a:prstGeom prst="rect">
            <a:avLst/>
          </a:prstGeom>
          <a:solidFill>
            <a:srgbClr val="9999FF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806" name="Freeform 782"/>
          <p:cNvSpPr>
            <a:spLocks noEditPoints="1"/>
          </p:cNvSpPr>
          <p:nvPr/>
        </p:nvSpPr>
        <p:spPr bwMode="auto">
          <a:xfrm>
            <a:off x="3244183" y="5963592"/>
            <a:ext cx="43127" cy="402230"/>
          </a:xfrm>
          <a:custGeom>
            <a:avLst/>
            <a:gdLst/>
            <a:ahLst/>
            <a:cxnLst>
              <a:cxn ang="0">
                <a:pos x="0" y="44"/>
              </a:cxn>
              <a:cxn ang="0">
                <a:pos x="44" y="0"/>
              </a:cxn>
              <a:cxn ang="0">
                <a:pos x="676" y="0"/>
              </a:cxn>
              <a:cxn ang="0">
                <a:pos x="720" y="44"/>
              </a:cxn>
              <a:cxn ang="0">
                <a:pos x="720" y="7964"/>
              </a:cxn>
              <a:cxn ang="0">
                <a:pos x="676" y="8008"/>
              </a:cxn>
              <a:cxn ang="0">
                <a:pos x="44" y="8008"/>
              </a:cxn>
              <a:cxn ang="0">
                <a:pos x="0" y="7964"/>
              </a:cxn>
              <a:cxn ang="0">
                <a:pos x="0" y="44"/>
              </a:cxn>
              <a:cxn ang="0">
                <a:pos x="88" y="7964"/>
              </a:cxn>
              <a:cxn ang="0">
                <a:pos x="44" y="7920"/>
              </a:cxn>
              <a:cxn ang="0">
                <a:pos x="676" y="7920"/>
              </a:cxn>
              <a:cxn ang="0">
                <a:pos x="632" y="7964"/>
              </a:cxn>
              <a:cxn ang="0">
                <a:pos x="632" y="44"/>
              </a:cxn>
              <a:cxn ang="0">
                <a:pos x="676" y="88"/>
              </a:cxn>
              <a:cxn ang="0">
                <a:pos x="44" y="88"/>
              </a:cxn>
              <a:cxn ang="0">
                <a:pos x="88" y="44"/>
              </a:cxn>
              <a:cxn ang="0">
                <a:pos x="88" y="7964"/>
              </a:cxn>
            </a:cxnLst>
            <a:rect l="0" t="0" r="r" b="b"/>
            <a:pathLst>
              <a:path w="720" h="8008">
                <a:moveTo>
                  <a:pt x="0" y="44"/>
                </a:moveTo>
                <a:cubicBezTo>
                  <a:pt x="0" y="20"/>
                  <a:pt x="20" y="0"/>
                  <a:pt x="44" y="0"/>
                </a:cubicBezTo>
                <a:lnTo>
                  <a:pt x="676" y="0"/>
                </a:lnTo>
                <a:cubicBezTo>
                  <a:pt x="701" y="0"/>
                  <a:pt x="720" y="20"/>
                  <a:pt x="720" y="44"/>
                </a:cubicBezTo>
                <a:lnTo>
                  <a:pt x="720" y="7964"/>
                </a:lnTo>
                <a:cubicBezTo>
                  <a:pt x="720" y="7989"/>
                  <a:pt x="701" y="8008"/>
                  <a:pt x="676" y="8008"/>
                </a:cubicBezTo>
                <a:lnTo>
                  <a:pt x="44" y="8008"/>
                </a:lnTo>
                <a:cubicBezTo>
                  <a:pt x="20" y="8008"/>
                  <a:pt x="0" y="7989"/>
                  <a:pt x="0" y="7964"/>
                </a:cubicBezTo>
                <a:lnTo>
                  <a:pt x="0" y="44"/>
                </a:lnTo>
                <a:close/>
                <a:moveTo>
                  <a:pt x="88" y="7964"/>
                </a:moveTo>
                <a:lnTo>
                  <a:pt x="44" y="7920"/>
                </a:lnTo>
                <a:lnTo>
                  <a:pt x="676" y="7920"/>
                </a:lnTo>
                <a:lnTo>
                  <a:pt x="632" y="7964"/>
                </a:lnTo>
                <a:lnTo>
                  <a:pt x="632" y="44"/>
                </a:lnTo>
                <a:lnTo>
                  <a:pt x="676" y="88"/>
                </a:lnTo>
                <a:lnTo>
                  <a:pt x="44" y="88"/>
                </a:lnTo>
                <a:lnTo>
                  <a:pt x="88" y="44"/>
                </a:lnTo>
                <a:lnTo>
                  <a:pt x="88" y="7964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807" name="Rectangle 783"/>
          <p:cNvSpPr>
            <a:spLocks noChangeArrowheads="1"/>
          </p:cNvSpPr>
          <p:nvPr/>
        </p:nvSpPr>
        <p:spPr bwMode="auto">
          <a:xfrm>
            <a:off x="3379874" y="5947322"/>
            <a:ext cx="37867" cy="415788"/>
          </a:xfrm>
          <a:prstGeom prst="rect">
            <a:avLst/>
          </a:prstGeom>
          <a:solidFill>
            <a:srgbClr val="9999FF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808" name="Freeform 784"/>
          <p:cNvSpPr>
            <a:spLocks noEditPoints="1"/>
          </p:cNvSpPr>
          <p:nvPr/>
        </p:nvSpPr>
        <p:spPr bwMode="auto">
          <a:xfrm>
            <a:off x="3376719" y="5944610"/>
            <a:ext cx="43127" cy="421211"/>
          </a:xfrm>
          <a:custGeom>
            <a:avLst/>
            <a:gdLst/>
            <a:ahLst/>
            <a:cxnLst>
              <a:cxn ang="0">
                <a:pos x="0" y="44"/>
              </a:cxn>
              <a:cxn ang="0">
                <a:pos x="44" y="0"/>
              </a:cxn>
              <a:cxn ang="0">
                <a:pos x="676" y="0"/>
              </a:cxn>
              <a:cxn ang="0">
                <a:pos x="720" y="44"/>
              </a:cxn>
              <a:cxn ang="0">
                <a:pos x="720" y="8332"/>
              </a:cxn>
              <a:cxn ang="0">
                <a:pos x="676" y="8376"/>
              </a:cxn>
              <a:cxn ang="0">
                <a:pos x="44" y="8376"/>
              </a:cxn>
              <a:cxn ang="0">
                <a:pos x="0" y="8332"/>
              </a:cxn>
              <a:cxn ang="0">
                <a:pos x="0" y="44"/>
              </a:cxn>
              <a:cxn ang="0">
                <a:pos x="88" y="8332"/>
              </a:cxn>
              <a:cxn ang="0">
                <a:pos x="44" y="8288"/>
              </a:cxn>
              <a:cxn ang="0">
                <a:pos x="676" y="8288"/>
              </a:cxn>
              <a:cxn ang="0">
                <a:pos x="632" y="8332"/>
              </a:cxn>
              <a:cxn ang="0">
                <a:pos x="632" y="44"/>
              </a:cxn>
              <a:cxn ang="0">
                <a:pos x="676" y="88"/>
              </a:cxn>
              <a:cxn ang="0">
                <a:pos x="44" y="88"/>
              </a:cxn>
              <a:cxn ang="0">
                <a:pos x="88" y="44"/>
              </a:cxn>
              <a:cxn ang="0">
                <a:pos x="88" y="8332"/>
              </a:cxn>
            </a:cxnLst>
            <a:rect l="0" t="0" r="r" b="b"/>
            <a:pathLst>
              <a:path w="720" h="8376">
                <a:moveTo>
                  <a:pt x="0" y="44"/>
                </a:moveTo>
                <a:cubicBezTo>
                  <a:pt x="0" y="20"/>
                  <a:pt x="20" y="0"/>
                  <a:pt x="44" y="0"/>
                </a:cubicBezTo>
                <a:lnTo>
                  <a:pt x="676" y="0"/>
                </a:lnTo>
                <a:cubicBezTo>
                  <a:pt x="701" y="0"/>
                  <a:pt x="720" y="20"/>
                  <a:pt x="720" y="44"/>
                </a:cubicBezTo>
                <a:lnTo>
                  <a:pt x="720" y="8332"/>
                </a:lnTo>
                <a:cubicBezTo>
                  <a:pt x="720" y="8357"/>
                  <a:pt x="701" y="8376"/>
                  <a:pt x="676" y="8376"/>
                </a:cubicBezTo>
                <a:lnTo>
                  <a:pt x="44" y="8376"/>
                </a:lnTo>
                <a:cubicBezTo>
                  <a:pt x="20" y="8376"/>
                  <a:pt x="0" y="8357"/>
                  <a:pt x="0" y="8332"/>
                </a:cubicBezTo>
                <a:lnTo>
                  <a:pt x="0" y="44"/>
                </a:lnTo>
                <a:close/>
                <a:moveTo>
                  <a:pt x="88" y="8332"/>
                </a:moveTo>
                <a:lnTo>
                  <a:pt x="44" y="8288"/>
                </a:lnTo>
                <a:lnTo>
                  <a:pt x="676" y="8288"/>
                </a:lnTo>
                <a:lnTo>
                  <a:pt x="632" y="8332"/>
                </a:lnTo>
                <a:lnTo>
                  <a:pt x="632" y="44"/>
                </a:lnTo>
                <a:lnTo>
                  <a:pt x="676" y="88"/>
                </a:lnTo>
                <a:lnTo>
                  <a:pt x="44" y="88"/>
                </a:lnTo>
                <a:lnTo>
                  <a:pt x="88" y="44"/>
                </a:lnTo>
                <a:lnTo>
                  <a:pt x="88" y="8332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809" name="Rectangle 785"/>
          <p:cNvSpPr>
            <a:spLocks noChangeArrowheads="1"/>
          </p:cNvSpPr>
          <p:nvPr/>
        </p:nvSpPr>
        <p:spPr bwMode="auto">
          <a:xfrm>
            <a:off x="3512410" y="6136234"/>
            <a:ext cx="38920" cy="226876"/>
          </a:xfrm>
          <a:prstGeom prst="rect">
            <a:avLst/>
          </a:prstGeom>
          <a:solidFill>
            <a:srgbClr val="9999FF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810" name="Freeform 786"/>
          <p:cNvSpPr>
            <a:spLocks noEditPoints="1"/>
          </p:cNvSpPr>
          <p:nvPr/>
        </p:nvSpPr>
        <p:spPr bwMode="auto">
          <a:xfrm>
            <a:off x="3510306" y="6133523"/>
            <a:ext cx="43127" cy="232299"/>
          </a:xfrm>
          <a:custGeom>
            <a:avLst/>
            <a:gdLst/>
            <a:ahLst/>
            <a:cxnLst>
              <a:cxn ang="0">
                <a:pos x="0" y="44"/>
              </a:cxn>
              <a:cxn ang="0">
                <a:pos x="44" y="0"/>
              </a:cxn>
              <a:cxn ang="0">
                <a:pos x="676" y="0"/>
              </a:cxn>
              <a:cxn ang="0">
                <a:pos x="720" y="44"/>
              </a:cxn>
              <a:cxn ang="0">
                <a:pos x="720" y="4572"/>
              </a:cxn>
              <a:cxn ang="0">
                <a:pos x="676" y="4616"/>
              </a:cxn>
              <a:cxn ang="0">
                <a:pos x="44" y="4616"/>
              </a:cxn>
              <a:cxn ang="0">
                <a:pos x="0" y="4572"/>
              </a:cxn>
              <a:cxn ang="0">
                <a:pos x="0" y="44"/>
              </a:cxn>
              <a:cxn ang="0">
                <a:pos x="88" y="4572"/>
              </a:cxn>
              <a:cxn ang="0">
                <a:pos x="44" y="4528"/>
              </a:cxn>
              <a:cxn ang="0">
                <a:pos x="676" y="4528"/>
              </a:cxn>
              <a:cxn ang="0">
                <a:pos x="632" y="4572"/>
              </a:cxn>
              <a:cxn ang="0">
                <a:pos x="632" y="44"/>
              </a:cxn>
              <a:cxn ang="0">
                <a:pos x="676" y="88"/>
              </a:cxn>
              <a:cxn ang="0">
                <a:pos x="44" y="88"/>
              </a:cxn>
              <a:cxn ang="0">
                <a:pos x="88" y="44"/>
              </a:cxn>
              <a:cxn ang="0">
                <a:pos x="88" y="4572"/>
              </a:cxn>
            </a:cxnLst>
            <a:rect l="0" t="0" r="r" b="b"/>
            <a:pathLst>
              <a:path w="720" h="4616">
                <a:moveTo>
                  <a:pt x="0" y="44"/>
                </a:moveTo>
                <a:cubicBezTo>
                  <a:pt x="0" y="20"/>
                  <a:pt x="20" y="0"/>
                  <a:pt x="44" y="0"/>
                </a:cubicBezTo>
                <a:lnTo>
                  <a:pt x="676" y="0"/>
                </a:lnTo>
                <a:cubicBezTo>
                  <a:pt x="701" y="0"/>
                  <a:pt x="720" y="20"/>
                  <a:pt x="720" y="44"/>
                </a:cubicBezTo>
                <a:lnTo>
                  <a:pt x="720" y="4572"/>
                </a:lnTo>
                <a:cubicBezTo>
                  <a:pt x="720" y="4597"/>
                  <a:pt x="701" y="4616"/>
                  <a:pt x="676" y="4616"/>
                </a:cubicBezTo>
                <a:lnTo>
                  <a:pt x="44" y="4616"/>
                </a:lnTo>
                <a:cubicBezTo>
                  <a:pt x="20" y="4616"/>
                  <a:pt x="0" y="4597"/>
                  <a:pt x="0" y="4572"/>
                </a:cubicBezTo>
                <a:lnTo>
                  <a:pt x="0" y="44"/>
                </a:lnTo>
                <a:close/>
                <a:moveTo>
                  <a:pt x="88" y="4572"/>
                </a:moveTo>
                <a:lnTo>
                  <a:pt x="44" y="4528"/>
                </a:lnTo>
                <a:lnTo>
                  <a:pt x="676" y="4528"/>
                </a:lnTo>
                <a:lnTo>
                  <a:pt x="632" y="4572"/>
                </a:lnTo>
                <a:lnTo>
                  <a:pt x="632" y="44"/>
                </a:lnTo>
                <a:lnTo>
                  <a:pt x="676" y="88"/>
                </a:lnTo>
                <a:lnTo>
                  <a:pt x="44" y="88"/>
                </a:lnTo>
                <a:lnTo>
                  <a:pt x="88" y="44"/>
                </a:lnTo>
                <a:lnTo>
                  <a:pt x="88" y="4572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811" name="Rectangle 787"/>
          <p:cNvSpPr>
            <a:spLocks noChangeArrowheads="1"/>
          </p:cNvSpPr>
          <p:nvPr/>
        </p:nvSpPr>
        <p:spPr bwMode="auto">
          <a:xfrm>
            <a:off x="3645998" y="6342321"/>
            <a:ext cx="37867" cy="20790"/>
          </a:xfrm>
          <a:prstGeom prst="rect">
            <a:avLst/>
          </a:prstGeom>
          <a:solidFill>
            <a:srgbClr val="9999FF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812" name="Freeform 788"/>
          <p:cNvSpPr>
            <a:spLocks noEditPoints="1"/>
          </p:cNvSpPr>
          <p:nvPr/>
        </p:nvSpPr>
        <p:spPr bwMode="auto">
          <a:xfrm>
            <a:off x="3643894" y="6339609"/>
            <a:ext cx="43127" cy="26213"/>
          </a:xfrm>
          <a:custGeom>
            <a:avLst/>
            <a:gdLst/>
            <a:ahLst/>
            <a:cxnLst>
              <a:cxn ang="0">
                <a:pos x="0" y="22"/>
              </a:cxn>
              <a:cxn ang="0">
                <a:pos x="22" y="0"/>
              </a:cxn>
              <a:cxn ang="0">
                <a:pos x="338" y="0"/>
              </a:cxn>
              <a:cxn ang="0">
                <a:pos x="360" y="22"/>
              </a:cxn>
              <a:cxn ang="0">
                <a:pos x="360" y="234"/>
              </a:cxn>
              <a:cxn ang="0">
                <a:pos x="338" y="256"/>
              </a:cxn>
              <a:cxn ang="0">
                <a:pos x="22" y="256"/>
              </a:cxn>
              <a:cxn ang="0">
                <a:pos x="0" y="234"/>
              </a:cxn>
              <a:cxn ang="0">
                <a:pos x="0" y="22"/>
              </a:cxn>
              <a:cxn ang="0">
                <a:pos x="44" y="234"/>
              </a:cxn>
              <a:cxn ang="0">
                <a:pos x="22" y="212"/>
              </a:cxn>
              <a:cxn ang="0">
                <a:pos x="338" y="212"/>
              </a:cxn>
              <a:cxn ang="0">
                <a:pos x="316" y="234"/>
              </a:cxn>
              <a:cxn ang="0">
                <a:pos x="316" y="22"/>
              </a:cxn>
              <a:cxn ang="0">
                <a:pos x="338" y="44"/>
              </a:cxn>
              <a:cxn ang="0">
                <a:pos x="22" y="44"/>
              </a:cxn>
              <a:cxn ang="0">
                <a:pos x="44" y="22"/>
              </a:cxn>
              <a:cxn ang="0">
                <a:pos x="44" y="234"/>
              </a:cxn>
            </a:cxnLst>
            <a:rect l="0" t="0" r="r" b="b"/>
            <a:pathLst>
              <a:path w="360" h="256">
                <a:moveTo>
                  <a:pt x="0" y="22"/>
                </a:moveTo>
                <a:cubicBezTo>
                  <a:pt x="0" y="10"/>
                  <a:pt x="10" y="0"/>
                  <a:pt x="22" y="0"/>
                </a:cubicBezTo>
                <a:lnTo>
                  <a:pt x="338" y="0"/>
                </a:lnTo>
                <a:cubicBezTo>
                  <a:pt x="351" y="0"/>
                  <a:pt x="360" y="10"/>
                  <a:pt x="360" y="22"/>
                </a:cubicBezTo>
                <a:lnTo>
                  <a:pt x="360" y="234"/>
                </a:lnTo>
                <a:cubicBezTo>
                  <a:pt x="360" y="247"/>
                  <a:pt x="351" y="256"/>
                  <a:pt x="338" y="256"/>
                </a:cubicBezTo>
                <a:lnTo>
                  <a:pt x="22" y="256"/>
                </a:lnTo>
                <a:cubicBezTo>
                  <a:pt x="10" y="256"/>
                  <a:pt x="0" y="247"/>
                  <a:pt x="0" y="234"/>
                </a:cubicBezTo>
                <a:lnTo>
                  <a:pt x="0" y="22"/>
                </a:lnTo>
                <a:close/>
                <a:moveTo>
                  <a:pt x="44" y="234"/>
                </a:moveTo>
                <a:lnTo>
                  <a:pt x="22" y="212"/>
                </a:lnTo>
                <a:lnTo>
                  <a:pt x="338" y="212"/>
                </a:lnTo>
                <a:lnTo>
                  <a:pt x="316" y="234"/>
                </a:lnTo>
                <a:lnTo>
                  <a:pt x="316" y="22"/>
                </a:lnTo>
                <a:lnTo>
                  <a:pt x="338" y="44"/>
                </a:lnTo>
                <a:lnTo>
                  <a:pt x="22" y="44"/>
                </a:lnTo>
                <a:lnTo>
                  <a:pt x="44" y="22"/>
                </a:lnTo>
                <a:lnTo>
                  <a:pt x="44" y="234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813" name="Rectangle 789"/>
          <p:cNvSpPr>
            <a:spLocks noChangeArrowheads="1"/>
          </p:cNvSpPr>
          <p:nvPr/>
        </p:nvSpPr>
        <p:spPr bwMode="auto">
          <a:xfrm>
            <a:off x="3779585" y="6176005"/>
            <a:ext cx="37867" cy="187105"/>
          </a:xfrm>
          <a:prstGeom prst="rect">
            <a:avLst/>
          </a:prstGeom>
          <a:solidFill>
            <a:srgbClr val="9999FF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814" name="Freeform 790"/>
          <p:cNvSpPr>
            <a:spLocks noEditPoints="1"/>
          </p:cNvSpPr>
          <p:nvPr/>
        </p:nvSpPr>
        <p:spPr bwMode="auto">
          <a:xfrm>
            <a:off x="3776430" y="6173294"/>
            <a:ext cx="44179" cy="192528"/>
          </a:xfrm>
          <a:custGeom>
            <a:avLst/>
            <a:gdLst/>
            <a:ahLst/>
            <a:cxnLst>
              <a:cxn ang="0">
                <a:pos x="0" y="22"/>
              </a:cxn>
              <a:cxn ang="0">
                <a:pos x="22" y="0"/>
              </a:cxn>
              <a:cxn ang="0">
                <a:pos x="338" y="0"/>
              </a:cxn>
              <a:cxn ang="0">
                <a:pos x="360" y="22"/>
              </a:cxn>
              <a:cxn ang="0">
                <a:pos x="360" y="1890"/>
              </a:cxn>
              <a:cxn ang="0">
                <a:pos x="338" y="1912"/>
              </a:cxn>
              <a:cxn ang="0">
                <a:pos x="22" y="1912"/>
              </a:cxn>
              <a:cxn ang="0">
                <a:pos x="0" y="1890"/>
              </a:cxn>
              <a:cxn ang="0">
                <a:pos x="0" y="22"/>
              </a:cxn>
              <a:cxn ang="0">
                <a:pos x="44" y="1890"/>
              </a:cxn>
              <a:cxn ang="0">
                <a:pos x="22" y="1868"/>
              </a:cxn>
              <a:cxn ang="0">
                <a:pos x="338" y="1868"/>
              </a:cxn>
              <a:cxn ang="0">
                <a:pos x="316" y="1890"/>
              </a:cxn>
              <a:cxn ang="0">
                <a:pos x="316" y="22"/>
              </a:cxn>
              <a:cxn ang="0">
                <a:pos x="338" y="44"/>
              </a:cxn>
              <a:cxn ang="0">
                <a:pos x="22" y="44"/>
              </a:cxn>
              <a:cxn ang="0">
                <a:pos x="44" y="22"/>
              </a:cxn>
              <a:cxn ang="0">
                <a:pos x="44" y="1890"/>
              </a:cxn>
            </a:cxnLst>
            <a:rect l="0" t="0" r="r" b="b"/>
            <a:pathLst>
              <a:path w="360" h="1912">
                <a:moveTo>
                  <a:pt x="0" y="22"/>
                </a:moveTo>
                <a:cubicBezTo>
                  <a:pt x="0" y="10"/>
                  <a:pt x="10" y="0"/>
                  <a:pt x="22" y="0"/>
                </a:cubicBezTo>
                <a:lnTo>
                  <a:pt x="338" y="0"/>
                </a:lnTo>
                <a:cubicBezTo>
                  <a:pt x="351" y="0"/>
                  <a:pt x="360" y="10"/>
                  <a:pt x="360" y="22"/>
                </a:cubicBezTo>
                <a:lnTo>
                  <a:pt x="360" y="1890"/>
                </a:lnTo>
                <a:cubicBezTo>
                  <a:pt x="360" y="1903"/>
                  <a:pt x="351" y="1912"/>
                  <a:pt x="338" y="1912"/>
                </a:cubicBezTo>
                <a:lnTo>
                  <a:pt x="22" y="1912"/>
                </a:lnTo>
                <a:cubicBezTo>
                  <a:pt x="10" y="1912"/>
                  <a:pt x="0" y="1903"/>
                  <a:pt x="0" y="1890"/>
                </a:cubicBezTo>
                <a:lnTo>
                  <a:pt x="0" y="22"/>
                </a:lnTo>
                <a:close/>
                <a:moveTo>
                  <a:pt x="44" y="1890"/>
                </a:moveTo>
                <a:lnTo>
                  <a:pt x="22" y="1868"/>
                </a:lnTo>
                <a:lnTo>
                  <a:pt x="338" y="1868"/>
                </a:lnTo>
                <a:lnTo>
                  <a:pt x="316" y="1890"/>
                </a:lnTo>
                <a:lnTo>
                  <a:pt x="316" y="22"/>
                </a:lnTo>
                <a:lnTo>
                  <a:pt x="338" y="44"/>
                </a:lnTo>
                <a:lnTo>
                  <a:pt x="22" y="44"/>
                </a:lnTo>
                <a:lnTo>
                  <a:pt x="44" y="22"/>
                </a:lnTo>
                <a:lnTo>
                  <a:pt x="44" y="189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815" name="Rectangle 791"/>
          <p:cNvSpPr>
            <a:spLocks noChangeArrowheads="1"/>
          </p:cNvSpPr>
          <p:nvPr/>
        </p:nvSpPr>
        <p:spPr bwMode="auto">
          <a:xfrm>
            <a:off x="3913174" y="6213969"/>
            <a:ext cx="37867" cy="149142"/>
          </a:xfrm>
          <a:prstGeom prst="rect">
            <a:avLst/>
          </a:prstGeom>
          <a:solidFill>
            <a:srgbClr val="9999FF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816" name="Freeform 792"/>
          <p:cNvSpPr>
            <a:spLocks noEditPoints="1"/>
          </p:cNvSpPr>
          <p:nvPr/>
        </p:nvSpPr>
        <p:spPr bwMode="auto">
          <a:xfrm>
            <a:off x="3910018" y="6211257"/>
            <a:ext cx="43127" cy="154565"/>
          </a:xfrm>
          <a:custGeom>
            <a:avLst/>
            <a:gdLst/>
            <a:ahLst/>
            <a:cxnLst>
              <a:cxn ang="0">
                <a:pos x="0" y="22"/>
              </a:cxn>
              <a:cxn ang="0">
                <a:pos x="22" y="0"/>
              </a:cxn>
              <a:cxn ang="0">
                <a:pos x="338" y="0"/>
              </a:cxn>
              <a:cxn ang="0">
                <a:pos x="360" y="22"/>
              </a:cxn>
              <a:cxn ang="0">
                <a:pos x="360" y="1510"/>
              </a:cxn>
              <a:cxn ang="0">
                <a:pos x="338" y="1532"/>
              </a:cxn>
              <a:cxn ang="0">
                <a:pos x="22" y="1532"/>
              </a:cxn>
              <a:cxn ang="0">
                <a:pos x="0" y="1510"/>
              </a:cxn>
              <a:cxn ang="0">
                <a:pos x="0" y="22"/>
              </a:cxn>
              <a:cxn ang="0">
                <a:pos x="44" y="1510"/>
              </a:cxn>
              <a:cxn ang="0">
                <a:pos x="22" y="1488"/>
              </a:cxn>
              <a:cxn ang="0">
                <a:pos x="338" y="1488"/>
              </a:cxn>
              <a:cxn ang="0">
                <a:pos x="316" y="1510"/>
              </a:cxn>
              <a:cxn ang="0">
                <a:pos x="316" y="22"/>
              </a:cxn>
              <a:cxn ang="0">
                <a:pos x="338" y="44"/>
              </a:cxn>
              <a:cxn ang="0">
                <a:pos x="22" y="44"/>
              </a:cxn>
              <a:cxn ang="0">
                <a:pos x="44" y="22"/>
              </a:cxn>
              <a:cxn ang="0">
                <a:pos x="44" y="1510"/>
              </a:cxn>
            </a:cxnLst>
            <a:rect l="0" t="0" r="r" b="b"/>
            <a:pathLst>
              <a:path w="360" h="1532">
                <a:moveTo>
                  <a:pt x="0" y="22"/>
                </a:moveTo>
                <a:cubicBezTo>
                  <a:pt x="0" y="10"/>
                  <a:pt x="10" y="0"/>
                  <a:pt x="22" y="0"/>
                </a:cubicBezTo>
                <a:lnTo>
                  <a:pt x="338" y="0"/>
                </a:lnTo>
                <a:cubicBezTo>
                  <a:pt x="351" y="0"/>
                  <a:pt x="360" y="10"/>
                  <a:pt x="360" y="22"/>
                </a:cubicBezTo>
                <a:lnTo>
                  <a:pt x="360" y="1510"/>
                </a:lnTo>
                <a:cubicBezTo>
                  <a:pt x="360" y="1523"/>
                  <a:pt x="351" y="1532"/>
                  <a:pt x="338" y="1532"/>
                </a:cubicBezTo>
                <a:lnTo>
                  <a:pt x="22" y="1532"/>
                </a:lnTo>
                <a:cubicBezTo>
                  <a:pt x="10" y="1532"/>
                  <a:pt x="0" y="1523"/>
                  <a:pt x="0" y="1510"/>
                </a:cubicBezTo>
                <a:lnTo>
                  <a:pt x="0" y="22"/>
                </a:lnTo>
                <a:close/>
                <a:moveTo>
                  <a:pt x="44" y="1510"/>
                </a:moveTo>
                <a:lnTo>
                  <a:pt x="22" y="1488"/>
                </a:lnTo>
                <a:lnTo>
                  <a:pt x="338" y="1488"/>
                </a:lnTo>
                <a:lnTo>
                  <a:pt x="316" y="1510"/>
                </a:lnTo>
                <a:lnTo>
                  <a:pt x="316" y="22"/>
                </a:lnTo>
                <a:lnTo>
                  <a:pt x="338" y="44"/>
                </a:lnTo>
                <a:lnTo>
                  <a:pt x="22" y="44"/>
                </a:lnTo>
                <a:lnTo>
                  <a:pt x="44" y="22"/>
                </a:lnTo>
                <a:lnTo>
                  <a:pt x="44" y="151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817" name="Rectangle 793"/>
          <p:cNvSpPr>
            <a:spLocks noChangeArrowheads="1"/>
          </p:cNvSpPr>
          <p:nvPr/>
        </p:nvSpPr>
        <p:spPr bwMode="auto">
          <a:xfrm>
            <a:off x="4045709" y="6317916"/>
            <a:ext cx="37867" cy="45194"/>
          </a:xfrm>
          <a:prstGeom prst="rect">
            <a:avLst/>
          </a:prstGeom>
          <a:solidFill>
            <a:srgbClr val="9999FF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818" name="Freeform 794"/>
          <p:cNvSpPr>
            <a:spLocks noEditPoints="1"/>
          </p:cNvSpPr>
          <p:nvPr/>
        </p:nvSpPr>
        <p:spPr bwMode="auto">
          <a:xfrm>
            <a:off x="4043606" y="6315204"/>
            <a:ext cx="43127" cy="50618"/>
          </a:xfrm>
          <a:custGeom>
            <a:avLst/>
            <a:gdLst/>
            <a:ahLst/>
            <a:cxnLst>
              <a:cxn ang="0">
                <a:pos x="0" y="22"/>
              </a:cxn>
              <a:cxn ang="0">
                <a:pos x="22" y="0"/>
              </a:cxn>
              <a:cxn ang="0">
                <a:pos x="338" y="0"/>
              </a:cxn>
              <a:cxn ang="0">
                <a:pos x="360" y="22"/>
              </a:cxn>
              <a:cxn ang="0">
                <a:pos x="360" y="474"/>
              </a:cxn>
              <a:cxn ang="0">
                <a:pos x="338" y="496"/>
              </a:cxn>
              <a:cxn ang="0">
                <a:pos x="22" y="496"/>
              </a:cxn>
              <a:cxn ang="0">
                <a:pos x="0" y="474"/>
              </a:cxn>
              <a:cxn ang="0">
                <a:pos x="0" y="22"/>
              </a:cxn>
              <a:cxn ang="0">
                <a:pos x="44" y="474"/>
              </a:cxn>
              <a:cxn ang="0">
                <a:pos x="22" y="452"/>
              </a:cxn>
              <a:cxn ang="0">
                <a:pos x="338" y="452"/>
              </a:cxn>
              <a:cxn ang="0">
                <a:pos x="316" y="474"/>
              </a:cxn>
              <a:cxn ang="0">
                <a:pos x="316" y="22"/>
              </a:cxn>
              <a:cxn ang="0">
                <a:pos x="338" y="44"/>
              </a:cxn>
              <a:cxn ang="0">
                <a:pos x="22" y="44"/>
              </a:cxn>
              <a:cxn ang="0">
                <a:pos x="44" y="22"/>
              </a:cxn>
              <a:cxn ang="0">
                <a:pos x="44" y="474"/>
              </a:cxn>
            </a:cxnLst>
            <a:rect l="0" t="0" r="r" b="b"/>
            <a:pathLst>
              <a:path w="360" h="496">
                <a:moveTo>
                  <a:pt x="0" y="22"/>
                </a:moveTo>
                <a:cubicBezTo>
                  <a:pt x="0" y="10"/>
                  <a:pt x="10" y="0"/>
                  <a:pt x="22" y="0"/>
                </a:cubicBezTo>
                <a:lnTo>
                  <a:pt x="338" y="0"/>
                </a:lnTo>
                <a:cubicBezTo>
                  <a:pt x="351" y="0"/>
                  <a:pt x="360" y="10"/>
                  <a:pt x="360" y="22"/>
                </a:cubicBezTo>
                <a:lnTo>
                  <a:pt x="360" y="474"/>
                </a:lnTo>
                <a:cubicBezTo>
                  <a:pt x="360" y="487"/>
                  <a:pt x="351" y="496"/>
                  <a:pt x="338" y="496"/>
                </a:cubicBezTo>
                <a:lnTo>
                  <a:pt x="22" y="496"/>
                </a:lnTo>
                <a:cubicBezTo>
                  <a:pt x="10" y="496"/>
                  <a:pt x="0" y="487"/>
                  <a:pt x="0" y="474"/>
                </a:cubicBezTo>
                <a:lnTo>
                  <a:pt x="0" y="22"/>
                </a:lnTo>
                <a:close/>
                <a:moveTo>
                  <a:pt x="44" y="474"/>
                </a:moveTo>
                <a:lnTo>
                  <a:pt x="22" y="452"/>
                </a:lnTo>
                <a:lnTo>
                  <a:pt x="338" y="452"/>
                </a:lnTo>
                <a:lnTo>
                  <a:pt x="316" y="474"/>
                </a:lnTo>
                <a:lnTo>
                  <a:pt x="316" y="22"/>
                </a:lnTo>
                <a:lnTo>
                  <a:pt x="338" y="44"/>
                </a:lnTo>
                <a:lnTo>
                  <a:pt x="22" y="44"/>
                </a:lnTo>
                <a:lnTo>
                  <a:pt x="44" y="22"/>
                </a:lnTo>
                <a:lnTo>
                  <a:pt x="44" y="474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819" name="Rectangle 795"/>
          <p:cNvSpPr>
            <a:spLocks noChangeArrowheads="1"/>
          </p:cNvSpPr>
          <p:nvPr/>
        </p:nvSpPr>
        <p:spPr bwMode="auto">
          <a:xfrm>
            <a:off x="4179297" y="6045846"/>
            <a:ext cx="37867" cy="317265"/>
          </a:xfrm>
          <a:prstGeom prst="rect">
            <a:avLst/>
          </a:prstGeom>
          <a:solidFill>
            <a:srgbClr val="9999FF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820" name="Freeform 796"/>
          <p:cNvSpPr>
            <a:spLocks noEditPoints="1"/>
          </p:cNvSpPr>
          <p:nvPr/>
        </p:nvSpPr>
        <p:spPr bwMode="auto">
          <a:xfrm>
            <a:off x="4176142" y="6043134"/>
            <a:ext cx="44179" cy="322688"/>
          </a:xfrm>
          <a:custGeom>
            <a:avLst/>
            <a:gdLst/>
            <a:ahLst/>
            <a:cxnLst>
              <a:cxn ang="0">
                <a:pos x="0" y="22"/>
              </a:cxn>
              <a:cxn ang="0">
                <a:pos x="22" y="0"/>
              </a:cxn>
              <a:cxn ang="0">
                <a:pos x="338" y="0"/>
              </a:cxn>
              <a:cxn ang="0">
                <a:pos x="360" y="22"/>
              </a:cxn>
              <a:cxn ang="0">
                <a:pos x="360" y="3186"/>
              </a:cxn>
              <a:cxn ang="0">
                <a:pos x="338" y="3208"/>
              </a:cxn>
              <a:cxn ang="0">
                <a:pos x="22" y="3208"/>
              </a:cxn>
              <a:cxn ang="0">
                <a:pos x="0" y="3186"/>
              </a:cxn>
              <a:cxn ang="0">
                <a:pos x="0" y="22"/>
              </a:cxn>
              <a:cxn ang="0">
                <a:pos x="44" y="3186"/>
              </a:cxn>
              <a:cxn ang="0">
                <a:pos x="22" y="3164"/>
              </a:cxn>
              <a:cxn ang="0">
                <a:pos x="338" y="3164"/>
              </a:cxn>
              <a:cxn ang="0">
                <a:pos x="316" y="3186"/>
              </a:cxn>
              <a:cxn ang="0">
                <a:pos x="316" y="22"/>
              </a:cxn>
              <a:cxn ang="0">
                <a:pos x="338" y="44"/>
              </a:cxn>
              <a:cxn ang="0">
                <a:pos x="22" y="44"/>
              </a:cxn>
              <a:cxn ang="0">
                <a:pos x="44" y="22"/>
              </a:cxn>
              <a:cxn ang="0">
                <a:pos x="44" y="3186"/>
              </a:cxn>
            </a:cxnLst>
            <a:rect l="0" t="0" r="r" b="b"/>
            <a:pathLst>
              <a:path w="360" h="3208">
                <a:moveTo>
                  <a:pt x="0" y="22"/>
                </a:moveTo>
                <a:cubicBezTo>
                  <a:pt x="0" y="10"/>
                  <a:pt x="10" y="0"/>
                  <a:pt x="22" y="0"/>
                </a:cubicBezTo>
                <a:lnTo>
                  <a:pt x="338" y="0"/>
                </a:lnTo>
                <a:cubicBezTo>
                  <a:pt x="351" y="0"/>
                  <a:pt x="360" y="10"/>
                  <a:pt x="360" y="22"/>
                </a:cubicBezTo>
                <a:lnTo>
                  <a:pt x="360" y="3186"/>
                </a:lnTo>
                <a:cubicBezTo>
                  <a:pt x="360" y="3199"/>
                  <a:pt x="351" y="3208"/>
                  <a:pt x="338" y="3208"/>
                </a:cubicBezTo>
                <a:lnTo>
                  <a:pt x="22" y="3208"/>
                </a:lnTo>
                <a:cubicBezTo>
                  <a:pt x="10" y="3208"/>
                  <a:pt x="0" y="3199"/>
                  <a:pt x="0" y="3186"/>
                </a:cubicBezTo>
                <a:lnTo>
                  <a:pt x="0" y="22"/>
                </a:lnTo>
                <a:close/>
                <a:moveTo>
                  <a:pt x="44" y="3186"/>
                </a:moveTo>
                <a:lnTo>
                  <a:pt x="22" y="3164"/>
                </a:lnTo>
                <a:lnTo>
                  <a:pt x="338" y="3164"/>
                </a:lnTo>
                <a:lnTo>
                  <a:pt x="316" y="3186"/>
                </a:lnTo>
                <a:lnTo>
                  <a:pt x="316" y="22"/>
                </a:lnTo>
                <a:lnTo>
                  <a:pt x="338" y="44"/>
                </a:lnTo>
                <a:lnTo>
                  <a:pt x="22" y="44"/>
                </a:lnTo>
                <a:lnTo>
                  <a:pt x="44" y="22"/>
                </a:lnTo>
                <a:lnTo>
                  <a:pt x="44" y="3186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821" name="Rectangle 797"/>
          <p:cNvSpPr>
            <a:spLocks noChangeArrowheads="1"/>
          </p:cNvSpPr>
          <p:nvPr/>
        </p:nvSpPr>
        <p:spPr bwMode="auto">
          <a:xfrm>
            <a:off x="4312885" y="6067539"/>
            <a:ext cx="37867" cy="295571"/>
          </a:xfrm>
          <a:prstGeom prst="rect">
            <a:avLst/>
          </a:prstGeom>
          <a:solidFill>
            <a:srgbClr val="9999FF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822" name="Freeform 798"/>
          <p:cNvSpPr>
            <a:spLocks noEditPoints="1"/>
          </p:cNvSpPr>
          <p:nvPr/>
        </p:nvSpPr>
        <p:spPr bwMode="auto">
          <a:xfrm>
            <a:off x="4309729" y="6064828"/>
            <a:ext cx="43127" cy="300995"/>
          </a:xfrm>
          <a:custGeom>
            <a:avLst/>
            <a:gdLst/>
            <a:ahLst/>
            <a:cxnLst>
              <a:cxn ang="0">
                <a:pos x="0" y="22"/>
              </a:cxn>
              <a:cxn ang="0">
                <a:pos x="22" y="0"/>
              </a:cxn>
              <a:cxn ang="0">
                <a:pos x="338" y="0"/>
              </a:cxn>
              <a:cxn ang="0">
                <a:pos x="360" y="22"/>
              </a:cxn>
              <a:cxn ang="0">
                <a:pos x="360" y="2970"/>
              </a:cxn>
              <a:cxn ang="0">
                <a:pos x="338" y="2992"/>
              </a:cxn>
              <a:cxn ang="0">
                <a:pos x="22" y="2992"/>
              </a:cxn>
              <a:cxn ang="0">
                <a:pos x="0" y="2970"/>
              </a:cxn>
              <a:cxn ang="0">
                <a:pos x="0" y="22"/>
              </a:cxn>
              <a:cxn ang="0">
                <a:pos x="44" y="2970"/>
              </a:cxn>
              <a:cxn ang="0">
                <a:pos x="22" y="2948"/>
              </a:cxn>
              <a:cxn ang="0">
                <a:pos x="338" y="2948"/>
              </a:cxn>
              <a:cxn ang="0">
                <a:pos x="316" y="2970"/>
              </a:cxn>
              <a:cxn ang="0">
                <a:pos x="316" y="22"/>
              </a:cxn>
              <a:cxn ang="0">
                <a:pos x="338" y="44"/>
              </a:cxn>
              <a:cxn ang="0">
                <a:pos x="22" y="44"/>
              </a:cxn>
              <a:cxn ang="0">
                <a:pos x="44" y="22"/>
              </a:cxn>
              <a:cxn ang="0">
                <a:pos x="44" y="2970"/>
              </a:cxn>
            </a:cxnLst>
            <a:rect l="0" t="0" r="r" b="b"/>
            <a:pathLst>
              <a:path w="360" h="2992">
                <a:moveTo>
                  <a:pt x="0" y="22"/>
                </a:moveTo>
                <a:cubicBezTo>
                  <a:pt x="0" y="10"/>
                  <a:pt x="10" y="0"/>
                  <a:pt x="22" y="0"/>
                </a:cubicBezTo>
                <a:lnTo>
                  <a:pt x="338" y="0"/>
                </a:lnTo>
                <a:cubicBezTo>
                  <a:pt x="351" y="0"/>
                  <a:pt x="360" y="10"/>
                  <a:pt x="360" y="22"/>
                </a:cubicBezTo>
                <a:lnTo>
                  <a:pt x="360" y="2970"/>
                </a:lnTo>
                <a:cubicBezTo>
                  <a:pt x="360" y="2983"/>
                  <a:pt x="351" y="2992"/>
                  <a:pt x="338" y="2992"/>
                </a:cubicBezTo>
                <a:lnTo>
                  <a:pt x="22" y="2992"/>
                </a:lnTo>
                <a:cubicBezTo>
                  <a:pt x="10" y="2992"/>
                  <a:pt x="0" y="2983"/>
                  <a:pt x="0" y="2970"/>
                </a:cubicBezTo>
                <a:lnTo>
                  <a:pt x="0" y="22"/>
                </a:lnTo>
                <a:close/>
                <a:moveTo>
                  <a:pt x="44" y="2970"/>
                </a:moveTo>
                <a:lnTo>
                  <a:pt x="22" y="2948"/>
                </a:lnTo>
                <a:lnTo>
                  <a:pt x="338" y="2948"/>
                </a:lnTo>
                <a:lnTo>
                  <a:pt x="316" y="2970"/>
                </a:lnTo>
                <a:lnTo>
                  <a:pt x="316" y="22"/>
                </a:lnTo>
                <a:lnTo>
                  <a:pt x="338" y="44"/>
                </a:lnTo>
                <a:lnTo>
                  <a:pt x="22" y="44"/>
                </a:lnTo>
                <a:lnTo>
                  <a:pt x="44" y="22"/>
                </a:lnTo>
                <a:lnTo>
                  <a:pt x="44" y="297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823" name="Rectangle 799"/>
          <p:cNvSpPr>
            <a:spLocks noChangeArrowheads="1"/>
          </p:cNvSpPr>
          <p:nvPr/>
        </p:nvSpPr>
        <p:spPr bwMode="auto">
          <a:xfrm>
            <a:off x="4445421" y="6010594"/>
            <a:ext cx="38920" cy="352516"/>
          </a:xfrm>
          <a:prstGeom prst="rect">
            <a:avLst/>
          </a:prstGeom>
          <a:solidFill>
            <a:srgbClr val="9999FF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824" name="Freeform 800"/>
          <p:cNvSpPr>
            <a:spLocks noEditPoints="1"/>
          </p:cNvSpPr>
          <p:nvPr/>
        </p:nvSpPr>
        <p:spPr bwMode="auto">
          <a:xfrm>
            <a:off x="4443317" y="6008787"/>
            <a:ext cx="43127" cy="357036"/>
          </a:xfrm>
          <a:custGeom>
            <a:avLst/>
            <a:gdLst/>
            <a:ahLst/>
            <a:cxnLst>
              <a:cxn ang="0">
                <a:pos x="0" y="22"/>
              </a:cxn>
              <a:cxn ang="0">
                <a:pos x="22" y="0"/>
              </a:cxn>
              <a:cxn ang="0">
                <a:pos x="338" y="0"/>
              </a:cxn>
              <a:cxn ang="0">
                <a:pos x="360" y="22"/>
              </a:cxn>
              <a:cxn ang="0">
                <a:pos x="360" y="3530"/>
              </a:cxn>
              <a:cxn ang="0">
                <a:pos x="338" y="3552"/>
              </a:cxn>
              <a:cxn ang="0">
                <a:pos x="22" y="3552"/>
              </a:cxn>
              <a:cxn ang="0">
                <a:pos x="0" y="3530"/>
              </a:cxn>
              <a:cxn ang="0">
                <a:pos x="0" y="22"/>
              </a:cxn>
              <a:cxn ang="0">
                <a:pos x="44" y="3530"/>
              </a:cxn>
              <a:cxn ang="0">
                <a:pos x="22" y="3508"/>
              </a:cxn>
              <a:cxn ang="0">
                <a:pos x="338" y="3508"/>
              </a:cxn>
              <a:cxn ang="0">
                <a:pos x="316" y="3530"/>
              </a:cxn>
              <a:cxn ang="0">
                <a:pos x="316" y="22"/>
              </a:cxn>
              <a:cxn ang="0">
                <a:pos x="338" y="44"/>
              </a:cxn>
              <a:cxn ang="0">
                <a:pos x="22" y="44"/>
              </a:cxn>
              <a:cxn ang="0">
                <a:pos x="44" y="22"/>
              </a:cxn>
              <a:cxn ang="0">
                <a:pos x="44" y="3530"/>
              </a:cxn>
            </a:cxnLst>
            <a:rect l="0" t="0" r="r" b="b"/>
            <a:pathLst>
              <a:path w="360" h="3552">
                <a:moveTo>
                  <a:pt x="0" y="22"/>
                </a:moveTo>
                <a:cubicBezTo>
                  <a:pt x="0" y="10"/>
                  <a:pt x="10" y="0"/>
                  <a:pt x="22" y="0"/>
                </a:cubicBezTo>
                <a:lnTo>
                  <a:pt x="338" y="0"/>
                </a:lnTo>
                <a:cubicBezTo>
                  <a:pt x="351" y="0"/>
                  <a:pt x="360" y="10"/>
                  <a:pt x="360" y="22"/>
                </a:cubicBezTo>
                <a:lnTo>
                  <a:pt x="360" y="3530"/>
                </a:lnTo>
                <a:cubicBezTo>
                  <a:pt x="360" y="3543"/>
                  <a:pt x="351" y="3552"/>
                  <a:pt x="338" y="3552"/>
                </a:cubicBezTo>
                <a:lnTo>
                  <a:pt x="22" y="3552"/>
                </a:lnTo>
                <a:cubicBezTo>
                  <a:pt x="10" y="3552"/>
                  <a:pt x="0" y="3543"/>
                  <a:pt x="0" y="3530"/>
                </a:cubicBezTo>
                <a:lnTo>
                  <a:pt x="0" y="22"/>
                </a:lnTo>
                <a:close/>
                <a:moveTo>
                  <a:pt x="44" y="3530"/>
                </a:moveTo>
                <a:lnTo>
                  <a:pt x="22" y="3508"/>
                </a:lnTo>
                <a:lnTo>
                  <a:pt x="338" y="3508"/>
                </a:lnTo>
                <a:lnTo>
                  <a:pt x="316" y="3530"/>
                </a:lnTo>
                <a:lnTo>
                  <a:pt x="316" y="22"/>
                </a:lnTo>
                <a:lnTo>
                  <a:pt x="338" y="44"/>
                </a:lnTo>
                <a:lnTo>
                  <a:pt x="22" y="44"/>
                </a:lnTo>
                <a:lnTo>
                  <a:pt x="44" y="22"/>
                </a:lnTo>
                <a:lnTo>
                  <a:pt x="44" y="353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825" name="Rectangle 801"/>
          <p:cNvSpPr>
            <a:spLocks noChangeArrowheads="1"/>
          </p:cNvSpPr>
          <p:nvPr/>
        </p:nvSpPr>
        <p:spPr bwMode="auto">
          <a:xfrm>
            <a:off x="4579008" y="5454704"/>
            <a:ext cx="37867" cy="908406"/>
          </a:xfrm>
          <a:prstGeom prst="rect">
            <a:avLst/>
          </a:prstGeom>
          <a:solidFill>
            <a:srgbClr val="9999FF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826" name="Freeform 802"/>
          <p:cNvSpPr>
            <a:spLocks noEditPoints="1"/>
          </p:cNvSpPr>
          <p:nvPr/>
        </p:nvSpPr>
        <p:spPr bwMode="auto">
          <a:xfrm>
            <a:off x="4576905" y="5452896"/>
            <a:ext cx="43127" cy="912926"/>
          </a:xfrm>
          <a:custGeom>
            <a:avLst/>
            <a:gdLst/>
            <a:ahLst/>
            <a:cxnLst>
              <a:cxn ang="0">
                <a:pos x="0" y="22"/>
              </a:cxn>
              <a:cxn ang="0">
                <a:pos x="22" y="0"/>
              </a:cxn>
              <a:cxn ang="0">
                <a:pos x="338" y="0"/>
              </a:cxn>
              <a:cxn ang="0">
                <a:pos x="360" y="22"/>
              </a:cxn>
              <a:cxn ang="0">
                <a:pos x="360" y="9066"/>
              </a:cxn>
              <a:cxn ang="0">
                <a:pos x="338" y="9088"/>
              </a:cxn>
              <a:cxn ang="0">
                <a:pos x="22" y="9088"/>
              </a:cxn>
              <a:cxn ang="0">
                <a:pos x="0" y="9066"/>
              </a:cxn>
              <a:cxn ang="0">
                <a:pos x="0" y="22"/>
              </a:cxn>
              <a:cxn ang="0">
                <a:pos x="44" y="9066"/>
              </a:cxn>
              <a:cxn ang="0">
                <a:pos x="22" y="9044"/>
              </a:cxn>
              <a:cxn ang="0">
                <a:pos x="338" y="9044"/>
              </a:cxn>
              <a:cxn ang="0">
                <a:pos x="316" y="9066"/>
              </a:cxn>
              <a:cxn ang="0">
                <a:pos x="316" y="22"/>
              </a:cxn>
              <a:cxn ang="0">
                <a:pos x="338" y="44"/>
              </a:cxn>
              <a:cxn ang="0">
                <a:pos x="22" y="44"/>
              </a:cxn>
              <a:cxn ang="0">
                <a:pos x="44" y="22"/>
              </a:cxn>
              <a:cxn ang="0">
                <a:pos x="44" y="9066"/>
              </a:cxn>
            </a:cxnLst>
            <a:rect l="0" t="0" r="r" b="b"/>
            <a:pathLst>
              <a:path w="360" h="9088">
                <a:moveTo>
                  <a:pt x="0" y="22"/>
                </a:moveTo>
                <a:cubicBezTo>
                  <a:pt x="0" y="10"/>
                  <a:pt x="10" y="0"/>
                  <a:pt x="22" y="0"/>
                </a:cubicBezTo>
                <a:lnTo>
                  <a:pt x="338" y="0"/>
                </a:lnTo>
                <a:cubicBezTo>
                  <a:pt x="351" y="0"/>
                  <a:pt x="360" y="10"/>
                  <a:pt x="360" y="22"/>
                </a:cubicBezTo>
                <a:lnTo>
                  <a:pt x="360" y="9066"/>
                </a:lnTo>
                <a:cubicBezTo>
                  <a:pt x="360" y="9079"/>
                  <a:pt x="351" y="9088"/>
                  <a:pt x="338" y="9088"/>
                </a:cubicBezTo>
                <a:lnTo>
                  <a:pt x="22" y="9088"/>
                </a:lnTo>
                <a:cubicBezTo>
                  <a:pt x="10" y="9088"/>
                  <a:pt x="0" y="9079"/>
                  <a:pt x="0" y="9066"/>
                </a:cubicBezTo>
                <a:lnTo>
                  <a:pt x="0" y="22"/>
                </a:lnTo>
                <a:close/>
                <a:moveTo>
                  <a:pt x="44" y="9066"/>
                </a:moveTo>
                <a:lnTo>
                  <a:pt x="22" y="9044"/>
                </a:lnTo>
                <a:lnTo>
                  <a:pt x="338" y="9044"/>
                </a:lnTo>
                <a:lnTo>
                  <a:pt x="316" y="9066"/>
                </a:lnTo>
                <a:lnTo>
                  <a:pt x="316" y="22"/>
                </a:lnTo>
                <a:lnTo>
                  <a:pt x="338" y="44"/>
                </a:lnTo>
                <a:lnTo>
                  <a:pt x="22" y="44"/>
                </a:lnTo>
                <a:lnTo>
                  <a:pt x="44" y="22"/>
                </a:lnTo>
                <a:lnTo>
                  <a:pt x="44" y="9066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827" name="Rectangle 803"/>
          <p:cNvSpPr>
            <a:spLocks noChangeArrowheads="1"/>
          </p:cNvSpPr>
          <p:nvPr/>
        </p:nvSpPr>
        <p:spPr bwMode="auto">
          <a:xfrm>
            <a:off x="2083967" y="6304357"/>
            <a:ext cx="38920" cy="58753"/>
          </a:xfrm>
          <a:prstGeom prst="rect">
            <a:avLst/>
          </a:prstGeom>
          <a:solidFill>
            <a:srgbClr val="FFFF99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828" name="Freeform 804"/>
          <p:cNvSpPr>
            <a:spLocks noEditPoints="1"/>
          </p:cNvSpPr>
          <p:nvPr/>
        </p:nvSpPr>
        <p:spPr bwMode="auto">
          <a:xfrm>
            <a:off x="2081864" y="6302550"/>
            <a:ext cx="44179" cy="63272"/>
          </a:xfrm>
          <a:custGeom>
            <a:avLst/>
            <a:gdLst/>
            <a:ahLst/>
            <a:cxnLst>
              <a:cxn ang="0">
                <a:pos x="0" y="44"/>
              </a:cxn>
              <a:cxn ang="0">
                <a:pos x="44" y="0"/>
              </a:cxn>
              <a:cxn ang="0">
                <a:pos x="684" y="0"/>
              </a:cxn>
              <a:cxn ang="0">
                <a:pos x="728" y="44"/>
              </a:cxn>
              <a:cxn ang="0">
                <a:pos x="728" y="1212"/>
              </a:cxn>
              <a:cxn ang="0">
                <a:pos x="684" y="1256"/>
              </a:cxn>
              <a:cxn ang="0">
                <a:pos x="44" y="1256"/>
              </a:cxn>
              <a:cxn ang="0">
                <a:pos x="0" y="1212"/>
              </a:cxn>
              <a:cxn ang="0">
                <a:pos x="0" y="44"/>
              </a:cxn>
              <a:cxn ang="0">
                <a:pos x="88" y="1212"/>
              </a:cxn>
              <a:cxn ang="0">
                <a:pos x="44" y="1168"/>
              </a:cxn>
              <a:cxn ang="0">
                <a:pos x="684" y="1168"/>
              </a:cxn>
              <a:cxn ang="0">
                <a:pos x="640" y="1212"/>
              </a:cxn>
              <a:cxn ang="0">
                <a:pos x="640" y="44"/>
              </a:cxn>
              <a:cxn ang="0">
                <a:pos x="684" y="88"/>
              </a:cxn>
              <a:cxn ang="0">
                <a:pos x="44" y="88"/>
              </a:cxn>
              <a:cxn ang="0">
                <a:pos x="88" y="44"/>
              </a:cxn>
              <a:cxn ang="0">
                <a:pos x="88" y="1212"/>
              </a:cxn>
            </a:cxnLst>
            <a:rect l="0" t="0" r="r" b="b"/>
            <a:pathLst>
              <a:path w="728" h="1256">
                <a:moveTo>
                  <a:pt x="0" y="44"/>
                </a:moveTo>
                <a:cubicBezTo>
                  <a:pt x="0" y="20"/>
                  <a:pt x="20" y="0"/>
                  <a:pt x="44" y="0"/>
                </a:cubicBezTo>
                <a:lnTo>
                  <a:pt x="684" y="0"/>
                </a:lnTo>
                <a:cubicBezTo>
                  <a:pt x="709" y="0"/>
                  <a:pt x="728" y="20"/>
                  <a:pt x="728" y="44"/>
                </a:cubicBezTo>
                <a:lnTo>
                  <a:pt x="728" y="1212"/>
                </a:lnTo>
                <a:cubicBezTo>
                  <a:pt x="728" y="1237"/>
                  <a:pt x="709" y="1256"/>
                  <a:pt x="684" y="1256"/>
                </a:cubicBezTo>
                <a:lnTo>
                  <a:pt x="44" y="1256"/>
                </a:lnTo>
                <a:cubicBezTo>
                  <a:pt x="20" y="1256"/>
                  <a:pt x="0" y="1237"/>
                  <a:pt x="0" y="1212"/>
                </a:cubicBezTo>
                <a:lnTo>
                  <a:pt x="0" y="44"/>
                </a:lnTo>
                <a:close/>
                <a:moveTo>
                  <a:pt x="88" y="1212"/>
                </a:moveTo>
                <a:lnTo>
                  <a:pt x="44" y="1168"/>
                </a:lnTo>
                <a:lnTo>
                  <a:pt x="684" y="1168"/>
                </a:lnTo>
                <a:lnTo>
                  <a:pt x="640" y="1212"/>
                </a:lnTo>
                <a:lnTo>
                  <a:pt x="640" y="44"/>
                </a:lnTo>
                <a:lnTo>
                  <a:pt x="684" y="88"/>
                </a:lnTo>
                <a:lnTo>
                  <a:pt x="44" y="88"/>
                </a:lnTo>
                <a:lnTo>
                  <a:pt x="88" y="44"/>
                </a:lnTo>
                <a:lnTo>
                  <a:pt x="88" y="1212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829" name="Rectangle 805"/>
          <p:cNvSpPr>
            <a:spLocks noChangeArrowheads="1"/>
          </p:cNvSpPr>
          <p:nvPr/>
        </p:nvSpPr>
        <p:spPr bwMode="auto">
          <a:xfrm>
            <a:off x="2218607" y="6289895"/>
            <a:ext cx="37867" cy="73215"/>
          </a:xfrm>
          <a:prstGeom prst="rect">
            <a:avLst/>
          </a:prstGeom>
          <a:solidFill>
            <a:srgbClr val="FFFF99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830" name="Freeform 806"/>
          <p:cNvSpPr>
            <a:spLocks noEditPoints="1"/>
          </p:cNvSpPr>
          <p:nvPr/>
        </p:nvSpPr>
        <p:spPr bwMode="auto">
          <a:xfrm>
            <a:off x="2215452" y="6287184"/>
            <a:ext cx="43127" cy="78638"/>
          </a:xfrm>
          <a:custGeom>
            <a:avLst/>
            <a:gdLst/>
            <a:ahLst/>
            <a:cxnLst>
              <a:cxn ang="0">
                <a:pos x="0" y="44"/>
              </a:cxn>
              <a:cxn ang="0">
                <a:pos x="44" y="0"/>
              </a:cxn>
              <a:cxn ang="0">
                <a:pos x="676" y="0"/>
              </a:cxn>
              <a:cxn ang="0">
                <a:pos x="720" y="44"/>
              </a:cxn>
              <a:cxn ang="0">
                <a:pos x="720" y="1508"/>
              </a:cxn>
              <a:cxn ang="0">
                <a:pos x="676" y="1552"/>
              </a:cxn>
              <a:cxn ang="0">
                <a:pos x="44" y="1552"/>
              </a:cxn>
              <a:cxn ang="0">
                <a:pos x="0" y="1508"/>
              </a:cxn>
              <a:cxn ang="0">
                <a:pos x="0" y="44"/>
              </a:cxn>
              <a:cxn ang="0">
                <a:pos x="88" y="1508"/>
              </a:cxn>
              <a:cxn ang="0">
                <a:pos x="44" y="1464"/>
              </a:cxn>
              <a:cxn ang="0">
                <a:pos x="676" y="1464"/>
              </a:cxn>
              <a:cxn ang="0">
                <a:pos x="632" y="1508"/>
              </a:cxn>
              <a:cxn ang="0">
                <a:pos x="632" y="44"/>
              </a:cxn>
              <a:cxn ang="0">
                <a:pos x="676" y="88"/>
              </a:cxn>
              <a:cxn ang="0">
                <a:pos x="44" y="88"/>
              </a:cxn>
              <a:cxn ang="0">
                <a:pos x="88" y="44"/>
              </a:cxn>
              <a:cxn ang="0">
                <a:pos x="88" y="1508"/>
              </a:cxn>
            </a:cxnLst>
            <a:rect l="0" t="0" r="r" b="b"/>
            <a:pathLst>
              <a:path w="720" h="1552">
                <a:moveTo>
                  <a:pt x="0" y="44"/>
                </a:moveTo>
                <a:cubicBezTo>
                  <a:pt x="0" y="20"/>
                  <a:pt x="20" y="0"/>
                  <a:pt x="44" y="0"/>
                </a:cubicBezTo>
                <a:lnTo>
                  <a:pt x="676" y="0"/>
                </a:lnTo>
                <a:cubicBezTo>
                  <a:pt x="701" y="0"/>
                  <a:pt x="720" y="20"/>
                  <a:pt x="720" y="44"/>
                </a:cubicBezTo>
                <a:lnTo>
                  <a:pt x="720" y="1508"/>
                </a:lnTo>
                <a:cubicBezTo>
                  <a:pt x="720" y="1533"/>
                  <a:pt x="701" y="1552"/>
                  <a:pt x="676" y="1552"/>
                </a:cubicBezTo>
                <a:lnTo>
                  <a:pt x="44" y="1552"/>
                </a:lnTo>
                <a:cubicBezTo>
                  <a:pt x="20" y="1552"/>
                  <a:pt x="0" y="1533"/>
                  <a:pt x="0" y="1508"/>
                </a:cubicBezTo>
                <a:lnTo>
                  <a:pt x="0" y="44"/>
                </a:lnTo>
                <a:close/>
                <a:moveTo>
                  <a:pt x="88" y="1508"/>
                </a:moveTo>
                <a:lnTo>
                  <a:pt x="44" y="1464"/>
                </a:lnTo>
                <a:lnTo>
                  <a:pt x="676" y="1464"/>
                </a:lnTo>
                <a:lnTo>
                  <a:pt x="632" y="1508"/>
                </a:lnTo>
                <a:lnTo>
                  <a:pt x="632" y="44"/>
                </a:lnTo>
                <a:lnTo>
                  <a:pt x="676" y="88"/>
                </a:lnTo>
                <a:lnTo>
                  <a:pt x="44" y="88"/>
                </a:lnTo>
                <a:lnTo>
                  <a:pt x="88" y="44"/>
                </a:lnTo>
                <a:lnTo>
                  <a:pt x="88" y="1508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831" name="Rectangle 807"/>
          <p:cNvSpPr>
            <a:spLocks noChangeArrowheads="1"/>
          </p:cNvSpPr>
          <p:nvPr/>
        </p:nvSpPr>
        <p:spPr bwMode="auto">
          <a:xfrm>
            <a:off x="2351143" y="6110022"/>
            <a:ext cx="37867" cy="253088"/>
          </a:xfrm>
          <a:prstGeom prst="rect">
            <a:avLst/>
          </a:prstGeom>
          <a:solidFill>
            <a:srgbClr val="FFFF99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832" name="Freeform 808"/>
          <p:cNvSpPr>
            <a:spLocks noEditPoints="1"/>
          </p:cNvSpPr>
          <p:nvPr/>
        </p:nvSpPr>
        <p:spPr bwMode="auto">
          <a:xfrm>
            <a:off x="2349039" y="6108214"/>
            <a:ext cx="43127" cy="257608"/>
          </a:xfrm>
          <a:custGeom>
            <a:avLst/>
            <a:gdLst/>
            <a:ahLst/>
            <a:cxnLst>
              <a:cxn ang="0">
                <a:pos x="0" y="44"/>
              </a:cxn>
              <a:cxn ang="0">
                <a:pos x="44" y="0"/>
              </a:cxn>
              <a:cxn ang="0">
                <a:pos x="676" y="0"/>
              </a:cxn>
              <a:cxn ang="0">
                <a:pos x="720" y="44"/>
              </a:cxn>
              <a:cxn ang="0">
                <a:pos x="720" y="5084"/>
              </a:cxn>
              <a:cxn ang="0">
                <a:pos x="676" y="5128"/>
              </a:cxn>
              <a:cxn ang="0">
                <a:pos x="44" y="5128"/>
              </a:cxn>
              <a:cxn ang="0">
                <a:pos x="0" y="5084"/>
              </a:cxn>
              <a:cxn ang="0">
                <a:pos x="0" y="44"/>
              </a:cxn>
              <a:cxn ang="0">
                <a:pos x="88" y="5084"/>
              </a:cxn>
              <a:cxn ang="0">
                <a:pos x="44" y="5040"/>
              </a:cxn>
              <a:cxn ang="0">
                <a:pos x="676" y="5040"/>
              </a:cxn>
              <a:cxn ang="0">
                <a:pos x="632" y="5084"/>
              </a:cxn>
              <a:cxn ang="0">
                <a:pos x="632" y="44"/>
              </a:cxn>
              <a:cxn ang="0">
                <a:pos x="676" y="88"/>
              </a:cxn>
              <a:cxn ang="0">
                <a:pos x="44" y="88"/>
              </a:cxn>
              <a:cxn ang="0">
                <a:pos x="88" y="44"/>
              </a:cxn>
              <a:cxn ang="0">
                <a:pos x="88" y="5084"/>
              </a:cxn>
            </a:cxnLst>
            <a:rect l="0" t="0" r="r" b="b"/>
            <a:pathLst>
              <a:path w="720" h="5128">
                <a:moveTo>
                  <a:pt x="0" y="44"/>
                </a:moveTo>
                <a:cubicBezTo>
                  <a:pt x="0" y="20"/>
                  <a:pt x="20" y="0"/>
                  <a:pt x="44" y="0"/>
                </a:cubicBezTo>
                <a:lnTo>
                  <a:pt x="676" y="0"/>
                </a:lnTo>
                <a:cubicBezTo>
                  <a:pt x="701" y="0"/>
                  <a:pt x="720" y="20"/>
                  <a:pt x="720" y="44"/>
                </a:cubicBezTo>
                <a:lnTo>
                  <a:pt x="720" y="5084"/>
                </a:lnTo>
                <a:cubicBezTo>
                  <a:pt x="720" y="5109"/>
                  <a:pt x="701" y="5128"/>
                  <a:pt x="676" y="5128"/>
                </a:cubicBezTo>
                <a:lnTo>
                  <a:pt x="44" y="5128"/>
                </a:lnTo>
                <a:cubicBezTo>
                  <a:pt x="20" y="5128"/>
                  <a:pt x="0" y="5109"/>
                  <a:pt x="0" y="5084"/>
                </a:cubicBezTo>
                <a:lnTo>
                  <a:pt x="0" y="44"/>
                </a:lnTo>
                <a:close/>
                <a:moveTo>
                  <a:pt x="88" y="5084"/>
                </a:moveTo>
                <a:lnTo>
                  <a:pt x="44" y="5040"/>
                </a:lnTo>
                <a:lnTo>
                  <a:pt x="676" y="5040"/>
                </a:lnTo>
                <a:lnTo>
                  <a:pt x="632" y="5084"/>
                </a:lnTo>
                <a:lnTo>
                  <a:pt x="632" y="44"/>
                </a:lnTo>
                <a:lnTo>
                  <a:pt x="676" y="88"/>
                </a:lnTo>
                <a:lnTo>
                  <a:pt x="44" y="88"/>
                </a:lnTo>
                <a:lnTo>
                  <a:pt x="88" y="44"/>
                </a:lnTo>
                <a:lnTo>
                  <a:pt x="88" y="5084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833" name="Rectangle 809"/>
          <p:cNvSpPr>
            <a:spLocks noChangeArrowheads="1"/>
          </p:cNvSpPr>
          <p:nvPr/>
        </p:nvSpPr>
        <p:spPr bwMode="auto">
          <a:xfrm>
            <a:off x="2618319" y="6317012"/>
            <a:ext cx="37867" cy="46099"/>
          </a:xfrm>
          <a:prstGeom prst="rect">
            <a:avLst/>
          </a:prstGeom>
          <a:solidFill>
            <a:srgbClr val="FFFF99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834" name="Freeform 810"/>
          <p:cNvSpPr>
            <a:spLocks noEditPoints="1"/>
          </p:cNvSpPr>
          <p:nvPr/>
        </p:nvSpPr>
        <p:spPr bwMode="auto">
          <a:xfrm>
            <a:off x="2615163" y="6315204"/>
            <a:ext cx="43127" cy="50618"/>
          </a:xfrm>
          <a:custGeom>
            <a:avLst/>
            <a:gdLst/>
            <a:ahLst/>
            <a:cxnLst>
              <a:cxn ang="0">
                <a:pos x="0" y="44"/>
              </a:cxn>
              <a:cxn ang="0">
                <a:pos x="44" y="0"/>
              </a:cxn>
              <a:cxn ang="0">
                <a:pos x="676" y="0"/>
              </a:cxn>
              <a:cxn ang="0">
                <a:pos x="720" y="44"/>
              </a:cxn>
              <a:cxn ang="0">
                <a:pos x="720" y="956"/>
              </a:cxn>
              <a:cxn ang="0">
                <a:pos x="676" y="1000"/>
              </a:cxn>
              <a:cxn ang="0">
                <a:pos x="44" y="1000"/>
              </a:cxn>
              <a:cxn ang="0">
                <a:pos x="0" y="956"/>
              </a:cxn>
              <a:cxn ang="0">
                <a:pos x="0" y="44"/>
              </a:cxn>
              <a:cxn ang="0">
                <a:pos x="88" y="956"/>
              </a:cxn>
              <a:cxn ang="0">
                <a:pos x="44" y="912"/>
              </a:cxn>
              <a:cxn ang="0">
                <a:pos x="676" y="912"/>
              </a:cxn>
              <a:cxn ang="0">
                <a:pos x="632" y="956"/>
              </a:cxn>
              <a:cxn ang="0">
                <a:pos x="632" y="44"/>
              </a:cxn>
              <a:cxn ang="0">
                <a:pos x="676" y="88"/>
              </a:cxn>
              <a:cxn ang="0">
                <a:pos x="44" y="88"/>
              </a:cxn>
              <a:cxn ang="0">
                <a:pos x="88" y="44"/>
              </a:cxn>
              <a:cxn ang="0">
                <a:pos x="88" y="956"/>
              </a:cxn>
            </a:cxnLst>
            <a:rect l="0" t="0" r="r" b="b"/>
            <a:pathLst>
              <a:path w="720" h="1000">
                <a:moveTo>
                  <a:pt x="0" y="44"/>
                </a:moveTo>
                <a:cubicBezTo>
                  <a:pt x="0" y="20"/>
                  <a:pt x="20" y="0"/>
                  <a:pt x="44" y="0"/>
                </a:cubicBezTo>
                <a:lnTo>
                  <a:pt x="676" y="0"/>
                </a:lnTo>
                <a:cubicBezTo>
                  <a:pt x="701" y="0"/>
                  <a:pt x="720" y="20"/>
                  <a:pt x="720" y="44"/>
                </a:cubicBezTo>
                <a:lnTo>
                  <a:pt x="720" y="956"/>
                </a:lnTo>
                <a:cubicBezTo>
                  <a:pt x="720" y="981"/>
                  <a:pt x="701" y="1000"/>
                  <a:pt x="676" y="1000"/>
                </a:cubicBezTo>
                <a:lnTo>
                  <a:pt x="44" y="1000"/>
                </a:lnTo>
                <a:cubicBezTo>
                  <a:pt x="20" y="1000"/>
                  <a:pt x="0" y="981"/>
                  <a:pt x="0" y="956"/>
                </a:cubicBezTo>
                <a:lnTo>
                  <a:pt x="0" y="44"/>
                </a:lnTo>
                <a:close/>
                <a:moveTo>
                  <a:pt x="88" y="956"/>
                </a:moveTo>
                <a:lnTo>
                  <a:pt x="44" y="912"/>
                </a:lnTo>
                <a:lnTo>
                  <a:pt x="676" y="912"/>
                </a:lnTo>
                <a:lnTo>
                  <a:pt x="632" y="956"/>
                </a:lnTo>
                <a:lnTo>
                  <a:pt x="632" y="44"/>
                </a:lnTo>
                <a:lnTo>
                  <a:pt x="676" y="88"/>
                </a:lnTo>
                <a:lnTo>
                  <a:pt x="44" y="88"/>
                </a:lnTo>
                <a:lnTo>
                  <a:pt x="88" y="44"/>
                </a:lnTo>
                <a:lnTo>
                  <a:pt x="88" y="956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835" name="Rectangle 811"/>
          <p:cNvSpPr>
            <a:spLocks noChangeArrowheads="1"/>
          </p:cNvSpPr>
          <p:nvPr/>
        </p:nvSpPr>
        <p:spPr bwMode="auto">
          <a:xfrm>
            <a:off x="2884443" y="6310685"/>
            <a:ext cx="37867" cy="52425"/>
          </a:xfrm>
          <a:prstGeom prst="rect">
            <a:avLst/>
          </a:prstGeom>
          <a:solidFill>
            <a:srgbClr val="FFFF99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836" name="Freeform 812"/>
          <p:cNvSpPr>
            <a:spLocks noEditPoints="1"/>
          </p:cNvSpPr>
          <p:nvPr/>
        </p:nvSpPr>
        <p:spPr bwMode="auto">
          <a:xfrm>
            <a:off x="2882339" y="6308877"/>
            <a:ext cx="43127" cy="56945"/>
          </a:xfrm>
          <a:custGeom>
            <a:avLst/>
            <a:gdLst/>
            <a:ahLst/>
            <a:cxnLst>
              <a:cxn ang="0">
                <a:pos x="0" y="44"/>
              </a:cxn>
              <a:cxn ang="0">
                <a:pos x="44" y="0"/>
              </a:cxn>
              <a:cxn ang="0">
                <a:pos x="676" y="0"/>
              </a:cxn>
              <a:cxn ang="0">
                <a:pos x="720" y="44"/>
              </a:cxn>
              <a:cxn ang="0">
                <a:pos x="720" y="1084"/>
              </a:cxn>
              <a:cxn ang="0">
                <a:pos x="676" y="1128"/>
              </a:cxn>
              <a:cxn ang="0">
                <a:pos x="44" y="1128"/>
              </a:cxn>
              <a:cxn ang="0">
                <a:pos x="0" y="1084"/>
              </a:cxn>
              <a:cxn ang="0">
                <a:pos x="0" y="44"/>
              </a:cxn>
              <a:cxn ang="0">
                <a:pos x="88" y="1084"/>
              </a:cxn>
              <a:cxn ang="0">
                <a:pos x="44" y="1040"/>
              </a:cxn>
              <a:cxn ang="0">
                <a:pos x="676" y="1040"/>
              </a:cxn>
              <a:cxn ang="0">
                <a:pos x="632" y="1084"/>
              </a:cxn>
              <a:cxn ang="0">
                <a:pos x="632" y="44"/>
              </a:cxn>
              <a:cxn ang="0">
                <a:pos x="676" y="88"/>
              </a:cxn>
              <a:cxn ang="0">
                <a:pos x="44" y="88"/>
              </a:cxn>
              <a:cxn ang="0">
                <a:pos x="88" y="44"/>
              </a:cxn>
              <a:cxn ang="0">
                <a:pos x="88" y="1084"/>
              </a:cxn>
            </a:cxnLst>
            <a:rect l="0" t="0" r="r" b="b"/>
            <a:pathLst>
              <a:path w="720" h="1128">
                <a:moveTo>
                  <a:pt x="0" y="44"/>
                </a:moveTo>
                <a:cubicBezTo>
                  <a:pt x="0" y="20"/>
                  <a:pt x="20" y="0"/>
                  <a:pt x="44" y="0"/>
                </a:cubicBezTo>
                <a:lnTo>
                  <a:pt x="676" y="0"/>
                </a:lnTo>
                <a:cubicBezTo>
                  <a:pt x="701" y="0"/>
                  <a:pt x="720" y="20"/>
                  <a:pt x="720" y="44"/>
                </a:cubicBezTo>
                <a:lnTo>
                  <a:pt x="720" y="1084"/>
                </a:lnTo>
                <a:cubicBezTo>
                  <a:pt x="720" y="1109"/>
                  <a:pt x="701" y="1128"/>
                  <a:pt x="676" y="1128"/>
                </a:cubicBezTo>
                <a:lnTo>
                  <a:pt x="44" y="1128"/>
                </a:lnTo>
                <a:cubicBezTo>
                  <a:pt x="20" y="1128"/>
                  <a:pt x="0" y="1109"/>
                  <a:pt x="0" y="1084"/>
                </a:cubicBezTo>
                <a:lnTo>
                  <a:pt x="0" y="44"/>
                </a:lnTo>
                <a:close/>
                <a:moveTo>
                  <a:pt x="88" y="1084"/>
                </a:moveTo>
                <a:lnTo>
                  <a:pt x="44" y="1040"/>
                </a:lnTo>
                <a:lnTo>
                  <a:pt x="676" y="1040"/>
                </a:lnTo>
                <a:lnTo>
                  <a:pt x="632" y="1084"/>
                </a:lnTo>
                <a:lnTo>
                  <a:pt x="632" y="44"/>
                </a:lnTo>
                <a:lnTo>
                  <a:pt x="676" y="88"/>
                </a:lnTo>
                <a:lnTo>
                  <a:pt x="44" y="88"/>
                </a:lnTo>
                <a:lnTo>
                  <a:pt x="88" y="44"/>
                </a:lnTo>
                <a:lnTo>
                  <a:pt x="88" y="1084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837" name="Rectangle 813"/>
          <p:cNvSpPr>
            <a:spLocks noChangeArrowheads="1"/>
          </p:cNvSpPr>
          <p:nvPr/>
        </p:nvSpPr>
        <p:spPr bwMode="auto">
          <a:xfrm>
            <a:off x="3151618" y="6277241"/>
            <a:ext cx="37867" cy="85870"/>
          </a:xfrm>
          <a:prstGeom prst="rect">
            <a:avLst/>
          </a:prstGeom>
          <a:solidFill>
            <a:srgbClr val="FFFF99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838" name="Freeform 814"/>
          <p:cNvSpPr>
            <a:spLocks noEditPoints="1"/>
          </p:cNvSpPr>
          <p:nvPr/>
        </p:nvSpPr>
        <p:spPr bwMode="auto">
          <a:xfrm>
            <a:off x="3148462" y="6274529"/>
            <a:ext cx="43127" cy="91293"/>
          </a:xfrm>
          <a:custGeom>
            <a:avLst/>
            <a:gdLst/>
            <a:ahLst/>
            <a:cxnLst>
              <a:cxn ang="0">
                <a:pos x="0" y="44"/>
              </a:cxn>
              <a:cxn ang="0">
                <a:pos x="44" y="0"/>
              </a:cxn>
              <a:cxn ang="0">
                <a:pos x="676" y="0"/>
              </a:cxn>
              <a:cxn ang="0">
                <a:pos x="720" y="44"/>
              </a:cxn>
              <a:cxn ang="0">
                <a:pos x="720" y="1764"/>
              </a:cxn>
              <a:cxn ang="0">
                <a:pos x="676" y="1808"/>
              </a:cxn>
              <a:cxn ang="0">
                <a:pos x="44" y="1808"/>
              </a:cxn>
              <a:cxn ang="0">
                <a:pos x="0" y="1764"/>
              </a:cxn>
              <a:cxn ang="0">
                <a:pos x="0" y="44"/>
              </a:cxn>
              <a:cxn ang="0">
                <a:pos x="88" y="1764"/>
              </a:cxn>
              <a:cxn ang="0">
                <a:pos x="44" y="1720"/>
              </a:cxn>
              <a:cxn ang="0">
                <a:pos x="676" y="1720"/>
              </a:cxn>
              <a:cxn ang="0">
                <a:pos x="632" y="1764"/>
              </a:cxn>
              <a:cxn ang="0">
                <a:pos x="632" y="44"/>
              </a:cxn>
              <a:cxn ang="0">
                <a:pos x="676" y="88"/>
              </a:cxn>
              <a:cxn ang="0">
                <a:pos x="44" y="88"/>
              </a:cxn>
              <a:cxn ang="0">
                <a:pos x="88" y="44"/>
              </a:cxn>
              <a:cxn ang="0">
                <a:pos x="88" y="1764"/>
              </a:cxn>
            </a:cxnLst>
            <a:rect l="0" t="0" r="r" b="b"/>
            <a:pathLst>
              <a:path w="720" h="1808">
                <a:moveTo>
                  <a:pt x="0" y="44"/>
                </a:moveTo>
                <a:cubicBezTo>
                  <a:pt x="0" y="20"/>
                  <a:pt x="20" y="0"/>
                  <a:pt x="44" y="0"/>
                </a:cubicBezTo>
                <a:lnTo>
                  <a:pt x="676" y="0"/>
                </a:lnTo>
                <a:cubicBezTo>
                  <a:pt x="701" y="0"/>
                  <a:pt x="720" y="20"/>
                  <a:pt x="720" y="44"/>
                </a:cubicBezTo>
                <a:lnTo>
                  <a:pt x="720" y="1764"/>
                </a:lnTo>
                <a:cubicBezTo>
                  <a:pt x="720" y="1789"/>
                  <a:pt x="701" y="1808"/>
                  <a:pt x="676" y="1808"/>
                </a:cubicBezTo>
                <a:lnTo>
                  <a:pt x="44" y="1808"/>
                </a:lnTo>
                <a:cubicBezTo>
                  <a:pt x="20" y="1808"/>
                  <a:pt x="0" y="1789"/>
                  <a:pt x="0" y="1764"/>
                </a:cubicBezTo>
                <a:lnTo>
                  <a:pt x="0" y="44"/>
                </a:lnTo>
                <a:close/>
                <a:moveTo>
                  <a:pt x="88" y="1764"/>
                </a:moveTo>
                <a:lnTo>
                  <a:pt x="44" y="1720"/>
                </a:lnTo>
                <a:lnTo>
                  <a:pt x="676" y="1720"/>
                </a:lnTo>
                <a:lnTo>
                  <a:pt x="632" y="1764"/>
                </a:lnTo>
                <a:lnTo>
                  <a:pt x="632" y="44"/>
                </a:lnTo>
                <a:lnTo>
                  <a:pt x="676" y="88"/>
                </a:lnTo>
                <a:lnTo>
                  <a:pt x="44" y="88"/>
                </a:lnTo>
                <a:lnTo>
                  <a:pt x="88" y="44"/>
                </a:lnTo>
                <a:lnTo>
                  <a:pt x="88" y="1764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839" name="Rectangle 815"/>
          <p:cNvSpPr>
            <a:spLocks noChangeArrowheads="1"/>
          </p:cNvSpPr>
          <p:nvPr/>
        </p:nvSpPr>
        <p:spPr bwMode="auto">
          <a:xfrm>
            <a:off x="3284154" y="6313396"/>
            <a:ext cx="37867" cy="49714"/>
          </a:xfrm>
          <a:prstGeom prst="rect">
            <a:avLst/>
          </a:prstGeom>
          <a:solidFill>
            <a:srgbClr val="FFFF99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840" name="Freeform 816"/>
          <p:cNvSpPr>
            <a:spLocks noEditPoints="1"/>
          </p:cNvSpPr>
          <p:nvPr/>
        </p:nvSpPr>
        <p:spPr bwMode="auto">
          <a:xfrm>
            <a:off x="3282050" y="6311588"/>
            <a:ext cx="43127" cy="54233"/>
          </a:xfrm>
          <a:custGeom>
            <a:avLst/>
            <a:gdLst/>
            <a:ahLst/>
            <a:cxnLst>
              <a:cxn ang="0">
                <a:pos x="0" y="44"/>
              </a:cxn>
              <a:cxn ang="0">
                <a:pos x="44" y="0"/>
              </a:cxn>
              <a:cxn ang="0">
                <a:pos x="676" y="0"/>
              </a:cxn>
              <a:cxn ang="0">
                <a:pos x="720" y="44"/>
              </a:cxn>
              <a:cxn ang="0">
                <a:pos x="720" y="1028"/>
              </a:cxn>
              <a:cxn ang="0">
                <a:pos x="676" y="1072"/>
              </a:cxn>
              <a:cxn ang="0">
                <a:pos x="44" y="1072"/>
              </a:cxn>
              <a:cxn ang="0">
                <a:pos x="0" y="1028"/>
              </a:cxn>
              <a:cxn ang="0">
                <a:pos x="0" y="44"/>
              </a:cxn>
              <a:cxn ang="0">
                <a:pos x="88" y="1028"/>
              </a:cxn>
              <a:cxn ang="0">
                <a:pos x="44" y="984"/>
              </a:cxn>
              <a:cxn ang="0">
                <a:pos x="676" y="984"/>
              </a:cxn>
              <a:cxn ang="0">
                <a:pos x="632" y="1028"/>
              </a:cxn>
              <a:cxn ang="0">
                <a:pos x="632" y="44"/>
              </a:cxn>
              <a:cxn ang="0">
                <a:pos x="676" y="88"/>
              </a:cxn>
              <a:cxn ang="0">
                <a:pos x="44" y="88"/>
              </a:cxn>
              <a:cxn ang="0">
                <a:pos x="88" y="44"/>
              </a:cxn>
              <a:cxn ang="0">
                <a:pos x="88" y="1028"/>
              </a:cxn>
            </a:cxnLst>
            <a:rect l="0" t="0" r="r" b="b"/>
            <a:pathLst>
              <a:path w="720" h="1072">
                <a:moveTo>
                  <a:pt x="0" y="44"/>
                </a:moveTo>
                <a:cubicBezTo>
                  <a:pt x="0" y="20"/>
                  <a:pt x="20" y="0"/>
                  <a:pt x="44" y="0"/>
                </a:cubicBezTo>
                <a:lnTo>
                  <a:pt x="676" y="0"/>
                </a:lnTo>
                <a:cubicBezTo>
                  <a:pt x="701" y="0"/>
                  <a:pt x="720" y="20"/>
                  <a:pt x="720" y="44"/>
                </a:cubicBezTo>
                <a:lnTo>
                  <a:pt x="720" y="1028"/>
                </a:lnTo>
                <a:cubicBezTo>
                  <a:pt x="720" y="1053"/>
                  <a:pt x="701" y="1072"/>
                  <a:pt x="676" y="1072"/>
                </a:cubicBezTo>
                <a:lnTo>
                  <a:pt x="44" y="1072"/>
                </a:lnTo>
                <a:cubicBezTo>
                  <a:pt x="20" y="1072"/>
                  <a:pt x="0" y="1053"/>
                  <a:pt x="0" y="1028"/>
                </a:cubicBezTo>
                <a:lnTo>
                  <a:pt x="0" y="44"/>
                </a:lnTo>
                <a:close/>
                <a:moveTo>
                  <a:pt x="88" y="1028"/>
                </a:moveTo>
                <a:lnTo>
                  <a:pt x="44" y="984"/>
                </a:lnTo>
                <a:lnTo>
                  <a:pt x="676" y="984"/>
                </a:lnTo>
                <a:lnTo>
                  <a:pt x="632" y="1028"/>
                </a:lnTo>
                <a:lnTo>
                  <a:pt x="632" y="44"/>
                </a:lnTo>
                <a:lnTo>
                  <a:pt x="676" y="88"/>
                </a:lnTo>
                <a:lnTo>
                  <a:pt x="44" y="88"/>
                </a:lnTo>
                <a:lnTo>
                  <a:pt x="88" y="44"/>
                </a:lnTo>
                <a:lnTo>
                  <a:pt x="88" y="1028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841" name="Rectangle 817"/>
          <p:cNvSpPr>
            <a:spLocks noChangeArrowheads="1"/>
          </p:cNvSpPr>
          <p:nvPr/>
        </p:nvSpPr>
        <p:spPr bwMode="auto">
          <a:xfrm>
            <a:off x="3417741" y="6190468"/>
            <a:ext cx="37867" cy="172643"/>
          </a:xfrm>
          <a:prstGeom prst="rect">
            <a:avLst/>
          </a:prstGeom>
          <a:solidFill>
            <a:srgbClr val="FFFF99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842" name="Freeform 818"/>
          <p:cNvSpPr>
            <a:spLocks noEditPoints="1"/>
          </p:cNvSpPr>
          <p:nvPr/>
        </p:nvSpPr>
        <p:spPr bwMode="auto">
          <a:xfrm>
            <a:off x="3414586" y="6188660"/>
            <a:ext cx="44179" cy="177162"/>
          </a:xfrm>
          <a:custGeom>
            <a:avLst/>
            <a:gdLst/>
            <a:ahLst/>
            <a:cxnLst>
              <a:cxn ang="0">
                <a:pos x="0" y="44"/>
              </a:cxn>
              <a:cxn ang="0">
                <a:pos x="44" y="0"/>
              </a:cxn>
              <a:cxn ang="0">
                <a:pos x="676" y="0"/>
              </a:cxn>
              <a:cxn ang="0">
                <a:pos x="720" y="44"/>
              </a:cxn>
              <a:cxn ang="0">
                <a:pos x="720" y="3484"/>
              </a:cxn>
              <a:cxn ang="0">
                <a:pos x="676" y="3528"/>
              </a:cxn>
              <a:cxn ang="0">
                <a:pos x="44" y="3528"/>
              </a:cxn>
              <a:cxn ang="0">
                <a:pos x="0" y="3484"/>
              </a:cxn>
              <a:cxn ang="0">
                <a:pos x="0" y="44"/>
              </a:cxn>
              <a:cxn ang="0">
                <a:pos x="88" y="3484"/>
              </a:cxn>
              <a:cxn ang="0">
                <a:pos x="44" y="3440"/>
              </a:cxn>
              <a:cxn ang="0">
                <a:pos x="676" y="3440"/>
              </a:cxn>
              <a:cxn ang="0">
                <a:pos x="632" y="3484"/>
              </a:cxn>
              <a:cxn ang="0">
                <a:pos x="632" y="44"/>
              </a:cxn>
              <a:cxn ang="0">
                <a:pos x="676" y="88"/>
              </a:cxn>
              <a:cxn ang="0">
                <a:pos x="44" y="88"/>
              </a:cxn>
              <a:cxn ang="0">
                <a:pos x="88" y="44"/>
              </a:cxn>
              <a:cxn ang="0">
                <a:pos x="88" y="3484"/>
              </a:cxn>
            </a:cxnLst>
            <a:rect l="0" t="0" r="r" b="b"/>
            <a:pathLst>
              <a:path w="720" h="3528">
                <a:moveTo>
                  <a:pt x="0" y="44"/>
                </a:moveTo>
                <a:cubicBezTo>
                  <a:pt x="0" y="20"/>
                  <a:pt x="20" y="0"/>
                  <a:pt x="44" y="0"/>
                </a:cubicBezTo>
                <a:lnTo>
                  <a:pt x="676" y="0"/>
                </a:lnTo>
                <a:cubicBezTo>
                  <a:pt x="701" y="0"/>
                  <a:pt x="720" y="20"/>
                  <a:pt x="720" y="44"/>
                </a:cubicBezTo>
                <a:lnTo>
                  <a:pt x="720" y="3484"/>
                </a:lnTo>
                <a:cubicBezTo>
                  <a:pt x="720" y="3509"/>
                  <a:pt x="701" y="3528"/>
                  <a:pt x="676" y="3528"/>
                </a:cubicBezTo>
                <a:lnTo>
                  <a:pt x="44" y="3528"/>
                </a:lnTo>
                <a:cubicBezTo>
                  <a:pt x="20" y="3528"/>
                  <a:pt x="0" y="3509"/>
                  <a:pt x="0" y="3484"/>
                </a:cubicBezTo>
                <a:lnTo>
                  <a:pt x="0" y="44"/>
                </a:lnTo>
                <a:close/>
                <a:moveTo>
                  <a:pt x="88" y="3484"/>
                </a:moveTo>
                <a:lnTo>
                  <a:pt x="44" y="3440"/>
                </a:lnTo>
                <a:lnTo>
                  <a:pt x="676" y="3440"/>
                </a:lnTo>
                <a:lnTo>
                  <a:pt x="632" y="3484"/>
                </a:lnTo>
                <a:lnTo>
                  <a:pt x="632" y="44"/>
                </a:lnTo>
                <a:lnTo>
                  <a:pt x="676" y="88"/>
                </a:lnTo>
                <a:lnTo>
                  <a:pt x="44" y="88"/>
                </a:lnTo>
                <a:lnTo>
                  <a:pt x="88" y="44"/>
                </a:lnTo>
                <a:lnTo>
                  <a:pt x="88" y="3484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843" name="Rectangle 819"/>
          <p:cNvSpPr>
            <a:spLocks noChangeArrowheads="1"/>
          </p:cNvSpPr>
          <p:nvPr/>
        </p:nvSpPr>
        <p:spPr bwMode="auto">
          <a:xfrm>
            <a:off x="3551330" y="6219392"/>
            <a:ext cx="37867" cy="143718"/>
          </a:xfrm>
          <a:prstGeom prst="rect">
            <a:avLst/>
          </a:prstGeom>
          <a:solidFill>
            <a:srgbClr val="FFFF99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844" name="Freeform 820"/>
          <p:cNvSpPr>
            <a:spLocks noEditPoints="1"/>
          </p:cNvSpPr>
          <p:nvPr/>
        </p:nvSpPr>
        <p:spPr bwMode="auto">
          <a:xfrm>
            <a:off x="3548174" y="6217584"/>
            <a:ext cx="43127" cy="148237"/>
          </a:xfrm>
          <a:custGeom>
            <a:avLst/>
            <a:gdLst/>
            <a:ahLst/>
            <a:cxnLst>
              <a:cxn ang="0">
                <a:pos x="0" y="44"/>
              </a:cxn>
              <a:cxn ang="0">
                <a:pos x="44" y="0"/>
              </a:cxn>
              <a:cxn ang="0">
                <a:pos x="676" y="0"/>
              </a:cxn>
              <a:cxn ang="0">
                <a:pos x="720" y="44"/>
              </a:cxn>
              <a:cxn ang="0">
                <a:pos x="720" y="2908"/>
              </a:cxn>
              <a:cxn ang="0">
                <a:pos x="676" y="2952"/>
              </a:cxn>
              <a:cxn ang="0">
                <a:pos x="44" y="2952"/>
              </a:cxn>
              <a:cxn ang="0">
                <a:pos x="0" y="2908"/>
              </a:cxn>
              <a:cxn ang="0">
                <a:pos x="0" y="44"/>
              </a:cxn>
              <a:cxn ang="0">
                <a:pos x="88" y="2908"/>
              </a:cxn>
              <a:cxn ang="0">
                <a:pos x="44" y="2864"/>
              </a:cxn>
              <a:cxn ang="0">
                <a:pos x="676" y="2864"/>
              </a:cxn>
              <a:cxn ang="0">
                <a:pos x="632" y="2908"/>
              </a:cxn>
              <a:cxn ang="0">
                <a:pos x="632" y="44"/>
              </a:cxn>
              <a:cxn ang="0">
                <a:pos x="676" y="88"/>
              </a:cxn>
              <a:cxn ang="0">
                <a:pos x="44" y="88"/>
              </a:cxn>
              <a:cxn ang="0">
                <a:pos x="88" y="44"/>
              </a:cxn>
              <a:cxn ang="0">
                <a:pos x="88" y="2908"/>
              </a:cxn>
            </a:cxnLst>
            <a:rect l="0" t="0" r="r" b="b"/>
            <a:pathLst>
              <a:path w="720" h="2952">
                <a:moveTo>
                  <a:pt x="0" y="44"/>
                </a:moveTo>
                <a:cubicBezTo>
                  <a:pt x="0" y="20"/>
                  <a:pt x="20" y="0"/>
                  <a:pt x="44" y="0"/>
                </a:cubicBezTo>
                <a:lnTo>
                  <a:pt x="676" y="0"/>
                </a:lnTo>
                <a:cubicBezTo>
                  <a:pt x="701" y="0"/>
                  <a:pt x="720" y="20"/>
                  <a:pt x="720" y="44"/>
                </a:cubicBezTo>
                <a:lnTo>
                  <a:pt x="720" y="2908"/>
                </a:lnTo>
                <a:cubicBezTo>
                  <a:pt x="720" y="2933"/>
                  <a:pt x="701" y="2952"/>
                  <a:pt x="676" y="2952"/>
                </a:cubicBezTo>
                <a:lnTo>
                  <a:pt x="44" y="2952"/>
                </a:lnTo>
                <a:cubicBezTo>
                  <a:pt x="20" y="2952"/>
                  <a:pt x="0" y="2933"/>
                  <a:pt x="0" y="2908"/>
                </a:cubicBezTo>
                <a:lnTo>
                  <a:pt x="0" y="44"/>
                </a:lnTo>
                <a:close/>
                <a:moveTo>
                  <a:pt x="88" y="2908"/>
                </a:moveTo>
                <a:lnTo>
                  <a:pt x="44" y="2864"/>
                </a:lnTo>
                <a:lnTo>
                  <a:pt x="676" y="2864"/>
                </a:lnTo>
                <a:lnTo>
                  <a:pt x="632" y="2908"/>
                </a:lnTo>
                <a:lnTo>
                  <a:pt x="632" y="44"/>
                </a:lnTo>
                <a:lnTo>
                  <a:pt x="676" y="88"/>
                </a:lnTo>
                <a:lnTo>
                  <a:pt x="44" y="88"/>
                </a:lnTo>
                <a:lnTo>
                  <a:pt x="88" y="44"/>
                </a:lnTo>
                <a:lnTo>
                  <a:pt x="88" y="2908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845" name="Rectangle 821"/>
          <p:cNvSpPr>
            <a:spLocks noChangeArrowheads="1"/>
          </p:cNvSpPr>
          <p:nvPr/>
        </p:nvSpPr>
        <p:spPr bwMode="auto">
          <a:xfrm>
            <a:off x="3683865" y="6166063"/>
            <a:ext cx="37867" cy="197047"/>
          </a:xfrm>
          <a:prstGeom prst="rect">
            <a:avLst/>
          </a:prstGeom>
          <a:solidFill>
            <a:srgbClr val="FFFF99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846" name="Freeform 822"/>
          <p:cNvSpPr>
            <a:spLocks noEditPoints="1"/>
          </p:cNvSpPr>
          <p:nvPr/>
        </p:nvSpPr>
        <p:spPr bwMode="auto">
          <a:xfrm>
            <a:off x="3681762" y="6164255"/>
            <a:ext cx="43127" cy="201567"/>
          </a:xfrm>
          <a:custGeom>
            <a:avLst/>
            <a:gdLst/>
            <a:ahLst/>
            <a:cxnLst>
              <a:cxn ang="0">
                <a:pos x="0" y="22"/>
              </a:cxn>
              <a:cxn ang="0">
                <a:pos x="22" y="0"/>
              </a:cxn>
              <a:cxn ang="0">
                <a:pos x="338" y="0"/>
              </a:cxn>
              <a:cxn ang="0">
                <a:pos x="360" y="22"/>
              </a:cxn>
              <a:cxn ang="0">
                <a:pos x="360" y="1982"/>
              </a:cxn>
              <a:cxn ang="0">
                <a:pos x="338" y="2004"/>
              </a:cxn>
              <a:cxn ang="0">
                <a:pos x="22" y="2004"/>
              </a:cxn>
              <a:cxn ang="0">
                <a:pos x="0" y="1982"/>
              </a:cxn>
              <a:cxn ang="0">
                <a:pos x="0" y="22"/>
              </a:cxn>
              <a:cxn ang="0">
                <a:pos x="44" y="1982"/>
              </a:cxn>
              <a:cxn ang="0">
                <a:pos x="22" y="1960"/>
              </a:cxn>
              <a:cxn ang="0">
                <a:pos x="338" y="1960"/>
              </a:cxn>
              <a:cxn ang="0">
                <a:pos x="316" y="1982"/>
              </a:cxn>
              <a:cxn ang="0">
                <a:pos x="316" y="22"/>
              </a:cxn>
              <a:cxn ang="0">
                <a:pos x="338" y="44"/>
              </a:cxn>
              <a:cxn ang="0">
                <a:pos x="22" y="44"/>
              </a:cxn>
              <a:cxn ang="0">
                <a:pos x="44" y="22"/>
              </a:cxn>
              <a:cxn ang="0">
                <a:pos x="44" y="1982"/>
              </a:cxn>
            </a:cxnLst>
            <a:rect l="0" t="0" r="r" b="b"/>
            <a:pathLst>
              <a:path w="360" h="2004">
                <a:moveTo>
                  <a:pt x="0" y="22"/>
                </a:moveTo>
                <a:cubicBezTo>
                  <a:pt x="0" y="10"/>
                  <a:pt x="10" y="0"/>
                  <a:pt x="22" y="0"/>
                </a:cubicBezTo>
                <a:lnTo>
                  <a:pt x="338" y="0"/>
                </a:lnTo>
                <a:cubicBezTo>
                  <a:pt x="351" y="0"/>
                  <a:pt x="360" y="10"/>
                  <a:pt x="360" y="22"/>
                </a:cubicBezTo>
                <a:lnTo>
                  <a:pt x="360" y="1982"/>
                </a:lnTo>
                <a:cubicBezTo>
                  <a:pt x="360" y="1995"/>
                  <a:pt x="351" y="2004"/>
                  <a:pt x="338" y="2004"/>
                </a:cubicBezTo>
                <a:lnTo>
                  <a:pt x="22" y="2004"/>
                </a:lnTo>
                <a:cubicBezTo>
                  <a:pt x="10" y="2004"/>
                  <a:pt x="0" y="1995"/>
                  <a:pt x="0" y="1982"/>
                </a:cubicBezTo>
                <a:lnTo>
                  <a:pt x="0" y="22"/>
                </a:lnTo>
                <a:close/>
                <a:moveTo>
                  <a:pt x="44" y="1982"/>
                </a:moveTo>
                <a:lnTo>
                  <a:pt x="22" y="1960"/>
                </a:lnTo>
                <a:lnTo>
                  <a:pt x="338" y="1960"/>
                </a:lnTo>
                <a:lnTo>
                  <a:pt x="316" y="1982"/>
                </a:lnTo>
                <a:lnTo>
                  <a:pt x="316" y="22"/>
                </a:lnTo>
                <a:lnTo>
                  <a:pt x="338" y="44"/>
                </a:lnTo>
                <a:lnTo>
                  <a:pt x="22" y="44"/>
                </a:lnTo>
                <a:lnTo>
                  <a:pt x="44" y="22"/>
                </a:lnTo>
                <a:lnTo>
                  <a:pt x="44" y="1982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847" name="Rectangle 823"/>
          <p:cNvSpPr>
            <a:spLocks noChangeArrowheads="1"/>
          </p:cNvSpPr>
          <p:nvPr/>
        </p:nvSpPr>
        <p:spPr bwMode="auto">
          <a:xfrm>
            <a:off x="3951041" y="6243797"/>
            <a:ext cx="37867" cy="119313"/>
          </a:xfrm>
          <a:prstGeom prst="rect">
            <a:avLst/>
          </a:prstGeom>
          <a:solidFill>
            <a:srgbClr val="FFFF99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848" name="Freeform 824"/>
          <p:cNvSpPr>
            <a:spLocks noEditPoints="1"/>
          </p:cNvSpPr>
          <p:nvPr/>
        </p:nvSpPr>
        <p:spPr bwMode="auto">
          <a:xfrm>
            <a:off x="3947885" y="6241989"/>
            <a:ext cx="43127" cy="123833"/>
          </a:xfrm>
          <a:custGeom>
            <a:avLst/>
            <a:gdLst/>
            <a:ahLst/>
            <a:cxnLst>
              <a:cxn ang="0">
                <a:pos x="0" y="22"/>
              </a:cxn>
              <a:cxn ang="0">
                <a:pos x="22" y="0"/>
              </a:cxn>
              <a:cxn ang="0">
                <a:pos x="338" y="0"/>
              </a:cxn>
              <a:cxn ang="0">
                <a:pos x="360" y="22"/>
              </a:cxn>
              <a:cxn ang="0">
                <a:pos x="360" y="1210"/>
              </a:cxn>
              <a:cxn ang="0">
                <a:pos x="338" y="1232"/>
              </a:cxn>
              <a:cxn ang="0">
                <a:pos x="22" y="1232"/>
              </a:cxn>
              <a:cxn ang="0">
                <a:pos x="0" y="1210"/>
              </a:cxn>
              <a:cxn ang="0">
                <a:pos x="0" y="22"/>
              </a:cxn>
              <a:cxn ang="0">
                <a:pos x="44" y="1210"/>
              </a:cxn>
              <a:cxn ang="0">
                <a:pos x="22" y="1188"/>
              </a:cxn>
              <a:cxn ang="0">
                <a:pos x="338" y="1188"/>
              </a:cxn>
              <a:cxn ang="0">
                <a:pos x="316" y="1210"/>
              </a:cxn>
              <a:cxn ang="0">
                <a:pos x="316" y="22"/>
              </a:cxn>
              <a:cxn ang="0">
                <a:pos x="338" y="44"/>
              </a:cxn>
              <a:cxn ang="0">
                <a:pos x="22" y="44"/>
              </a:cxn>
              <a:cxn ang="0">
                <a:pos x="44" y="22"/>
              </a:cxn>
              <a:cxn ang="0">
                <a:pos x="44" y="1210"/>
              </a:cxn>
            </a:cxnLst>
            <a:rect l="0" t="0" r="r" b="b"/>
            <a:pathLst>
              <a:path w="360" h="1232">
                <a:moveTo>
                  <a:pt x="0" y="22"/>
                </a:moveTo>
                <a:cubicBezTo>
                  <a:pt x="0" y="10"/>
                  <a:pt x="10" y="0"/>
                  <a:pt x="22" y="0"/>
                </a:cubicBezTo>
                <a:lnTo>
                  <a:pt x="338" y="0"/>
                </a:lnTo>
                <a:cubicBezTo>
                  <a:pt x="351" y="0"/>
                  <a:pt x="360" y="10"/>
                  <a:pt x="360" y="22"/>
                </a:cubicBezTo>
                <a:lnTo>
                  <a:pt x="360" y="1210"/>
                </a:lnTo>
                <a:cubicBezTo>
                  <a:pt x="360" y="1223"/>
                  <a:pt x="351" y="1232"/>
                  <a:pt x="338" y="1232"/>
                </a:cubicBezTo>
                <a:lnTo>
                  <a:pt x="22" y="1232"/>
                </a:lnTo>
                <a:cubicBezTo>
                  <a:pt x="10" y="1232"/>
                  <a:pt x="0" y="1223"/>
                  <a:pt x="0" y="1210"/>
                </a:cubicBezTo>
                <a:lnTo>
                  <a:pt x="0" y="22"/>
                </a:lnTo>
                <a:close/>
                <a:moveTo>
                  <a:pt x="44" y="1210"/>
                </a:moveTo>
                <a:lnTo>
                  <a:pt x="22" y="1188"/>
                </a:lnTo>
                <a:lnTo>
                  <a:pt x="338" y="1188"/>
                </a:lnTo>
                <a:lnTo>
                  <a:pt x="316" y="1210"/>
                </a:lnTo>
                <a:lnTo>
                  <a:pt x="316" y="22"/>
                </a:lnTo>
                <a:lnTo>
                  <a:pt x="338" y="44"/>
                </a:lnTo>
                <a:lnTo>
                  <a:pt x="22" y="44"/>
                </a:lnTo>
                <a:lnTo>
                  <a:pt x="44" y="22"/>
                </a:lnTo>
                <a:lnTo>
                  <a:pt x="44" y="121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849" name="Rectangle 825"/>
          <p:cNvSpPr>
            <a:spLocks noChangeArrowheads="1"/>
          </p:cNvSpPr>
          <p:nvPr/>
        </p:nvSpPr>
        <p:spPr bwMode="auto">
          <a:xfrm>
            <a:off x="4083577" y="6058500"/>
            <a:ext cx="38920" cy="304610"/>
          </a:xfrm>
          <a:prstGeom prst="rect">
            <a:avLst/>
          </a:prstGeom>
          <a:solidFill>
            <a:srgbClr val="FFFF99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850" name="Freeform 826"/>
          <p:cNvSpPr>
            <a:spLocks noEditPoints="1"/>
          </p:cNvSpPr>
          <p:nvPr/>
        </p:nvSpPr>
        <p:spPr bwMode="auto">
          <a:xfrm>
            <a:off x="4081473" y="6056692"/>
            <a:ext cx="43127" cy="309129"/>
          </a:xfrm>
          <a:custGeom>
            <a:avLst/>
            <a:gdLst/>
            <a:ahLst/>
            <a:cxnLst>
              <a:cxn ang="0">
                <a:pos x="0" y="22"/>
              </a:cxn>
              <a:cxn ang="0">
                <a:pos x="22" y="0"/>
              </a:cxn>
              <a:cxn ang="0">
                <a:pos x="338" y="0"/>
              </a:cxn>
              <a:cxn ang="0">
                <a:pos x="360" y="22"/>
              </a:cxn>
              <a:cxn ang="0">
                <a:pos x="360" y="3054"/>
              </a:cxn>
              <a:cxn ang="0">
                <a:pos x="338" y="3076"/>
              </a:cxn>
              <a:cxn ang="0">
                <a:pos x="22" y="3076"/>
              </a:cxn>
              <a:cxn ang="0">
                <a:pos x="0" y="3054"/>
              </a:cxn>
              <a:cxn ang="0">
                <a:pos x="0" y="22"/>
              </a:cxn>
              <a:cxn ang="0">
                <a:pos x="44" y="3054"/>
              </a:cxn>
              <a:cxn ang="0">
                <a:pos x="22" y="3032"/>
              </a:cxn>
              <a:cxn ang="0">
                <a:pos x="338" y="3032"/>
              </a:cxn>
              <a:cxn ang="0">
                <a:pos x="316" y="3054"/>
              </a:cxn>
              <a:cxn ang="0">
                <a:pos x="316" y="22"/>
              </a:cxn>
              <a:cxn ang="0">
                <a:pos x="338" y="44"/>
              </a:cxn>
              <a:cxn ang="0">
                <a:pos x="22" y="44"/>
              </a:cxn>
              <a:cxn ang="0">
                <a:pos x="44" y="22"/>
              </a:cxn>
              <a:cxn ang="0">
                <a:pos x="44" y="3054"/>
              </a:cxn>
            </a:cxnLst>
            <a:rect l="0" t="0" r="r" b="b"/>
            <a:pathLst>
              <a:path w="360" h="3076">
                <a:moveTo>
                  <a:pt x="0" y="22"/>
                </a:moveTo>
                <a:cubicBezTo>
                  <a:pt x="0" y="10"/>
                  <a:pt x="10" y="0"/>
                  <a:pt x="22" y="0"/>
                </a:cubicBezTo>
                <a:lnTo>
                  <a:pt x="338" y="0"/>
                </a:lnTo>
                <a:cubicBezTo>
                  <a:pt x="351" y="0"/>
                  <a:pt x="360" y="10"/>
                  <a:pt x="360" y="22"/>
                </a:cubicBezTo>
                <a:lnTo>
                  <a:pt x="360" y="3054"/>
                </a:lnTo>
                <a:cubicBezTo>
                  <a:pt x="360" y="3067"/>
                  <a:pt x="351" y="3076"/>
                  <a:pt x="338" y="3076"/>
                </a:cubicBezTo>
                <a:lnTo>
                  <a:pt x="22" y="3076"/>
                </a:lnTo>
                <a:cubicBezTo>
                  <a:pt x="10" y="3076"/>
                  <a:pt x="0" y="3067"/>
                  <a:pt x="0" y="3054"/>
                </a:cubicBezTo>
                <a:lnTo>
                  <a:pt x="0" y="22"/>
                </a:lnTo>
                <a:close/>
                <a:moveTo>
                  <a:pt x="44" y="3054"/>
                </a:moveTo>
                <a:lnTo>
                  <a:pt x="22" y="3032"/>
                </a:lnTo>
                <a:lnTo>
                  <a:pt x="338" y="3032"/>
                </a:lnTo>
                <a:lnTo>
                  <a:pt x="316" y="3054"/>
                </a:lnTo>
                <a:lnTo>
                  <a:pt x="316" y="22"/>
                </a:lnTo>
                <a:lnTo>
                  <a:pt x="338" y="44"/>
                </a:lnTo>
                <a:lnTo>
                  <a:pt x="22" y="44"/>
                </a:lnTo>
                <a:lnTo>
                  <a:pt x="44" y="22"/>
                </a:lnTo>
                <a:lnTo>
                  <a:pt x="44" y="3054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851" name="Rectangle 827"/>
          <p:cNvSpPr>
            <a:spLocks noChangeArrowheads="1"/>
          </p:cNvSpPr>
          <p:nvPr/>
        </p:nvSpPr>
        <p:spPr bwMode="auto">
          <a:xfrm>
            <a:off x="4217164" y="6360398"/>
            <a:ext cx="37867" cy="2712"/>
          </a:xfrm>
          <a:prstGeom prst="rect">
            <a:avLst/>
          </a:prstGeom>
          <a:solidFill>
            <a:srgbClr val="FFFF99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852" name="Freeform 828"/>
          <p:cNvSpPr>
            <a:spLocks noEditPoints="1"/>
          </p:cNvSpPr>
          <p:nvPr/>
        </p:nvSpPr>
        <p:spPr bwMode="auto">
          <a:xfrm>
            <a:off x="4215061" y="6358591"/>
            <a:ext cx="43127" cy="7231"/>
          </a:xfrm>
          <a:custGeom>
            <a:avLst/>
            <a:gdLst/>
            <a:ahLst/>
            <a:cxnLst>
              <a:cxn ang="0">
                <a:pos x="0" y="22"/>
              </a:cxn>
              <a:cxn ang="0">
                <a:pos x="22" y="0"/>
              </a:cxn>
              <a:cxn ang="0">
                <a:pos x="338" y="0"/>
              </a:cxn>
              <a:cxn ang="0">
                <a:pos x="360" y="22"/>
              </a:cxn>
              <a:cxn ang="0">
                <a:pos x="360" y="50"/>
              </a:cxn>
              <a:cxn ang="0">
                <a:pos x="338" y="72"/>
              </a:cxn>
              <a:cxn ang="0">
                <a:pos x="22" y="72"/>
              </a:cxn>
              <a:cxn ang="0">
                <a:pos x="0" y="50"/>
              </a:cxn>
              <a:cxn ang="0">
                <a:pos x="0" y="22"/>
              </a:cxn>
              <a:cxn ang="0">
                <a:pos x="44" y="50"/>
              </a:cxn>
              <a:cxn ang="0">
                <a:pos x="22" y="28"/>
              </a:cxn>
              <a:cxn ang="0">
                <a:pos x="338" y="28"/>
              </a:cxn>
              <a:cxn ang="0">
                <a:pos x="316" y="50"/>
              </a:cxn>
              <a:cxn ang="0">
                <a:pos x="316" y="22"/>
              </a:cxn>
              <a:cxn ang="0">
                <a:pos x="338" y="44"/>
              </a:cxn>
              <a:cxn ang="0">
                <a:pos x="22" y="44"/>
              </a:cxn>
              <a:cxn ang="0">
                <a:pos x="44" y="22"/>
              </a:cxn>
              <a:cxn ang="0">
                <a:pos x="44" y="50"/>
              </a:cxn>
            </a:cxnLst>
            <a:rect l="0" t="0" r="r" b="b"/>
            <a:pathLst>
              <a:path w="360" h="72">
                <a:moveTo>
                  <a:pt x="0" y="22"/>
                </a:moveTo>
                <a:cubicBezTo>
                  <a:pt x="0" y="10"/>
                  <a:pt x="10" y="0"/>
                  <a:pt x="22" y="0"/>
                </a:cubicBezTo>
                <a:lnTo>
                  <a:pt x="338" y="0"/>
                </a:lnTo>
                <a:cubicBezTo>
                  <a:pt x="351" y="0"/>
                  <a:pt x="360" y="10"/>
                  <a:pt x="360" y="22"/>
                </a:cubicBezTo>
                <a:lnTo>
                  <a:pt x="360" y="50"/>
                </a:lnTo>
                <a:cubicBezTo>
                  <a:pt x="360" y="63"/>
                  <a:pt x="351" y="72"/>
                  <a:pt x="338" y="72"/>
                </a:cubicBezTo>
                <a:lnTo>
                  <a:pt x="22" y="72"/>
                </a:lnTo>
                <a:cubicBezTo>
                  <a:pt x="10" y="72"/>
                  <a:pt x="0" y="63"/>
                  <a:pt x="0" y="50"/>
                </a:cubicBezTo>
                <a:lnTo>
                  <a:pt x="0" y="22"/>
                </a:lnTo>
                <a:close/>
                <a:moveTo>
                  <a:pt x="44" y="50"/>
                </a:moveTo>
                <a:lnTo>
                  <a:pt x="22" y="28"/>
                </a:lnTo>
                <a:lnTo>
                  <a:pt x="338" y="28"/>
                </a:lnTo>
                <a:lnTo>
                  <a:pt x="316" y="50"/>
                </a:lnTo>
                <a:lnTo>
                  <a:pt x="316" y="22"/>
                </a:lnTo>
                <a:lnTo>
                  <a:pt x="338" y="44"/>
                </a:lnTo>
                <a:lnTo>
                  <a:pt x="22" y="44"/>
                </a:lnTo>
                <a:lnTo>
                  <a:pt x="44" y="22"/>
                </a:lnTo>
                <a:lnTo>
                  <a:pt x="44" y="5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853" name="Rectangle 829"/>
          <p:cNvSpPr>
            <a:spLocks noChangeArrowheads="1"/>
          </p:cNvSpPr>
          <p:nvPr/>
        </p:nvSpPr>
        <p:spPr bwMode="auto">
          <a:xfrm>
            <a:off x="4484340" y="6360398"/>
            <a:ext cx="37867" cy="2712"/>
          </a:xfrm>
          <a:prstGeom prst="rect">
            <a:avLst/>
          </a:prstGeom>
          <a:solidFill>
            <a:srgbClr val="FFFF99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854" name="Freeform 830"/>
          <p:cNvSpPr>
            <a:spLocks noEditPoints="1"/>
          </p:cNvSpPr>
          <p:nvPr/>
        </p:nvSpPr>
        <p:spPr bwMode="auto">
          <a:xfrm>
            <a:off x="4481185" y="6358591"/>
            <a:ext cx="44179" cy="7231"/>
          </a:xfrm>
          <a:custGeom>
            <a:avLst/>
            <a:gdLst/>
            <a:ahLst/>
            <a:cxnLst>
              <a:cxn ang="0">
                <a:pos x="0" y="22"/>
              </a:cxn>
              <a:cxn ang="0">
                <a:pos x="22" y="0"/>
              </a:cxn>
              <a:cxn ang="0">
                <a:pos x="342" y="0"/>
              </a:cxn>
              <a:cxn ang="0">
                <a:pos x="364" y="22"/>
              </a:cxn>
              <a:cxn ang="0">
                <a:pos x="364" y="46"/>
              </a:cxn>
              <a:cxn ang="0">
                <a:pos x="342" y="68"/>
              </a:cxn>
              <a:cxn ang="0">
                <a:pos x="22" y="68"/>
              </a:cxn>
              <a:cxn ang="0">
                <a:pos x="0" y="46"/>
              </a:cxn>
              <a:cxn ang="0">
                <a:pos x="0" y="22"/>
              </a:cxn>
              <a:cxn ang="0">
                <a:pos x="44" y="46"/>
              </a:cxn>
              <a:cxn ang="0">
                <a:pos x="22" y="24"/>
              </a:cxn>
              <a:cxn ang="0">
                <a:pos x="342" y="24"/>
              </a:cxn>
              <a:cxn ang="0">
                <a:pos x="320" y="46"/>
              </a:cxn>
              <a:cxn ang="0">
                <a:pos x="320" y="22"/>
              </a:cxn>
              <a:cxn ang="0">
                <a:pos x="342" y="44"/>
              </a:cxn>
              <a:cxn ang="0">
                <a:pos x="22" y="44"/>
              </a:cxn>
              <a:cxn ang="0">
                <a:pos x="44" y="22"/>
              </a:cxn>
              <a:cxn ang="0">
                <a:pos x="44" y="46"/>
              </a:cxn>
            </a:cxnLst>
            <a:rect l="0" t="0" r="r" b="b"/>
            <a:pathLst>
              <a:path w="364" h="68">
                <a:moveTo>
                  <a:pt x="0" y="22"/>
                </a:moveTo>
                <a:cubicBezTo>
                  <a:pt x="0" y="10"/>
                  <a:pt x="10" y="0"/>
                  <a:pt x="22" y="0"/>
                </a:cubicBezTo>
                <a:lnTo>
                  <a:pt x="342" y="0"/>
                </a:lnTo>
                <a:cubicBezTo>
                  <a:pt x="355" y="0"/>
                  <a:pt x="364" y="10"/>
                  <a:pt x="364" y="22"/>
                </a:cubicBezTo>
                <a:lnTo>
                  <a:pt x="364" y="46"/>
                </a:lnTo>
                <a:cubicBezTo>
                  <a:pt x="364" y="59"/>
                  <a:pt x="355" y="68"/>
                  <a:pt x="342" y="68"/>
                </a:cubicBezTo>
                <a:lnTo>
                  <a:pt x="22" y="68"/>
                </a:lnTo>
                <a:cubicBezTo>
                  <a:pt x="10" y="68"/>
                  <a:pt x="0" y="59"/>
                  <a:pt x="0" y="46"/>
                </a:cubicBezTo>
                <a:lnTo>
                  <a:pt x="0" y="22"/>
                </a:lnTo>
                <a:close/>
                <a:moveTo>
                  <a:pt x="44" y="46"/>
                </a:moveTo>
                <a:lnTo>
                  <a:pt x="22" y="24"/>
                </a:lnTo>
                <a:lnTo>
                  <a:pt x="342" y="24"/>
                </a:lnTo>
                <a:lnTo>
                  <a:pt x="320" y="46"/>
                </a:lnTo>
                <a:lnTo>
                  <a:pt x="320" y="22"/>
                </a:lnTo>
                <a:lnTo>
                  <a:pt x="342" y="44"/>
                </a:lnTo>
                <a:lnTo>
                  <a:pt x="22" y="44"/>
                </a:lnTo>
                <a:lnTo>
                  <a:pt x="44" y="22"/>
                </a:lnTo>
                <a:lnTo>
                  <a:pt x="44" y="46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855" name="Rectangle 831"/>
          <p:cNvSpPr>
            <a:spLocks noChangeArrowheads="1"/>
          </p:cNvSpPr>
          <p:nvPr/>
        </p:nvSpPr>
        <p:spPr bwMode="auto">
          <a:xfrm>
            <a:off x="4616876" y="6018729"/>
            <a:ext cx="38920" cy="344381"/>
          </a:xfrm>
          <a:prstGeom prst="rect">
            <a:avLst/>
          </a:prstGeom>
          <a:solidFill>
            <a:srgbClr val="FFFF99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856" name="Freeform 832"/>
          <p:cNvSpPr>
            <a:spLocks noEditPoints="1"/>
          </p:cNvSpPr>
          <p:nvPr/>
        </p:nvSpPr>
        <p:spPr bwMode="auto">
          <a:xfrm>
            <a:off x="4614772" y="6016921"/>
            <a:ext cx="43127" cy="348900"/>
          </a:xfrm>
          <a:custGeom>
            <a:avLst/>
            <a:gdLst/>
            <a:ahLst/>
            <a:cxnLst>
              <a:cxn ang="0">
                <a:pos x="0" y="22"/>
              </a:cxn>
              <a:cxn ang="0">
                <a:pos x="22" y="0"/>
              </a:cxn>
              <a:cxn ang="0">
                <a:pos x="342" y="0"/>
              </a:cxn>
              <a:cxn ang="0">
                <a:pos x="364" y="22"/>
              </a:cxn>
              <a:cxn ang="0">
                <a:pos x="364" y="3450"/>
              </a:cxn>
              <a:cxn ang="0">
                <a:pos x="342" y="3472"/>
              </a:cxn>
              <a:cxn ang="0">
                <a:pos x="22" y="3472"/>
              </a:cxn>
              <a:cxn ang="0">
                <a:pos x="0" y="3450"/>
              </a:cxn>
              <a:cxn ang="0">
                <a:pos x="0" y="22"/>
              </a:cxn>
              <a:cxn ang="0">
                <a:pos x="44" y="3450"/>
              </a:cxn>
              <a:cxn ang="0">
                <a:pos x="22" y="3428"/>
              </a:cxn>
              <a:cxn ang="0">
                <a:pos x="342" y="3428"/>
              </a:cxn>
              <a:cxn ang="0">
                <a:pos x="320" y="3450"/>
              </a:cxn>
              <a:cxn ang="0">
                <a:pos x="320" y="22"/>
              </a:cxn>
              <a:cxn ang="0">
                <a:pos x="342" y="44"/>
              </a:cxn>
              <a:cxn ang="0">
                <a:pos x="22" y="44"/>
              </a:cxn>
              <a:cxn ang="0">
                <a:pos x="44" y="22"/>
              </a:cxn>
              <a:cxn ang="0">
                <a:pos x="44" y="3450"/>
              </a:cxn>
            </a:cxnLst>
            <a:rect l="0" t="0" r="r" b="b"/>
            <a:pathLst>
              <a:path w="364" h="3472">
                <a:moveTo>
                  <a:pt x="0" y="22"/>
                </a:moveTo>
                <a:cubicBezTo>
                  <a:pt x="0" y="10"/>
                  <a:pt x="10" y="0"/>
                  <a:pt x="22" y="0"/>
                </a:cubicBezTo>
                <a:lnTo>
                  <a:pt x="342" y="0"/>
                </a:lnTo>
                <a:cubicBezTo>
                  <a:pt x="355" y="0"/>
                  <a:pt x="364" y="10"/>
                  <a:pt x="364" y="22"/>
                </a:cubicBezTo>
                <a:lnTo>
                  <a:pt x="364" y="3450"/>
                </a:lnTo>
                <a:cubicBezTo>
                  <a:pt x="364" y="3463"/>
                  <a:pt x="355" y="3472"/>
                  <a:pt x="342" y="3472"/>
                </a:cubicBezTo>
                <a:lnTo>
                  <a:pt x="22" y="3472"/>
                </a:lnTo>
                <a:cubicBezTo>
                  <a:pt x="10" y="3472"/>
                  <a:pt x="0" y="3463"/>
                  <a:pt x="0" y="3450"/>
                </a:cubicBezTo>
                <a:lnTo>
                  <a:pt x="0" y="22"/>
                </a:lnTo>
                <a:close/>
                <a:moveTo>
                  <a:pt x="44" y="3450"/>
                </a:moveTo>
                <a:lnTo>
                  <a:pt x="22" y="3428"/>
                </a:lnTo>
                <a:lnTo>
                  <a:pt x="342" y="3428"/>
                </a:lnTo>
                <a:lnTo>
                  <a:pt x="320" y="3450"/>
                </a:lnTo>
                <a:lnTo>
                  <a:pt x="320" y="22"/>
                </a:lnTo>
                <a:lnTo>
                  <a:pt x="342" y="44"/>
                </a:lnTo>
                <a:lnTo>
                  <a:pt x="22" y="44"/>
                </a:lnTo>
                <a:lnTo>
                  <a:pt x="44" y="22"/>
                </a:lnTo>
                <a:lnTo>
                  <a:pt x="44" y="345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857" name="Rectangle 833"/>
          <p:cNvSpPr>
            <a:spLocks noChangeArrowheads="1"/>
          </p:cNvSpPr>
          <p:nvPr/>
        </p:nvSpPr>
        <p:spPr bwMode="auto">
          <a:xfrm>
            <a:off x="2017700" y="5371546"/>
            <a:ext cx="1052" cy="991564"/>
          </a:xfrm>
          <a:prstGeom prst="rect">
            <a:avLst/>
          </a:pr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858" name="Freeform 834"/>
          <p:cNvSpPr>
            <a:spLocks noEditPoints="1"/>
          </p:cNvSpPr>
          <p:nvPr/>
        </p:nvSpPr>
        <p:spPr bwMode="auto">
          <a:xfrm>
            <a:off x="2010395" y="5371546"/>
            <a:ext cx="16830" cy="992468"/>
          </a:xfrm>
          <a:custGeom>
            <a:avLst/>
            <a:gdLst/>
            <a:ahLst/>
            <a:cxnLst>
              <a:cxn ang="0">
                <a:pos x="0" y="1097"/>
              </a:cxn>
              <a:cxn ang="0">
                <a:pos x="16" y="1097"/>
              </a:cxn>
              <a:cxn ang="0">
                <a:pos x="16" y="1098"/>
              </a:cxn>
              <a:cxn ang="0">
                <a:pos x="0" y="1098"/>
              </a:cxn>
              <a:cxn ang="0">
                <a:pos x="0" y="1097"/>
              </a:cxn>
              <a:cxn ang="0">
                <a:pos x="0" y="987"/>
              </a:cxn>
              <a:cxn ang="0">
                <a:pos x="16" y="987"/>
              </a:cxn>
              <a:cxn ang="0">
                <a:pos x="16" y="988"/>
              </a:cxn>
              <a:cxn ang="0">
                <a:pos x="0" y="988"/>
              </a:cxn>
              <a:cxn ang="0">
                <a:pos x="0" y="987"/>
              </a:cxn>
              <a:cxn ang="0">
                <a:pos x="0" y="877"/>
              </a:cxn>
              <a:cxn ang="0">
                <a:pos x="16" y="877"/>
              </a:cxn>
              <a:cxn ang="0">
                <a:pos x="16" y="878"/>
              </a:cxn>
              <a:cxn ang="0">
                <a:pos x="0" y="878"/>
              </a:cxn>
              <a:cxn ang="0">
                <a:pos x="0" y="877"/>
              </a:cxn>
              <a:cxn ang="0">
                <a:pos x="0" y="768"/>
              </a:cxn>
              <a:cxn ang="0">
                <a:pos x="16" y="768"/>
              </a:cxn>
              <a:cxn ang="0">
                <a:pos x="16" y="768"/>
              </a:cxn>
              <a:cxn ang="0">
                <a:pos x="0" y="768"/>
              </a:cxn>
              <a:cxn ang="0">
                <a:pos x="0" y="768"/>
              </a:cxn>
              <a:cxn ang="0">
                <a:pos x="0" y="658"/>
              </a:cxn>
              <a:cxn ang="0">
                <a:pos x="16" y="658"/>
              </a:cxn>
              <a:cxn ang="0">
                <a:pos x="16" y="659"/>
              </a:cxn>
              <a:cxn ang="0">
                <a:pos x="0" y="659"/>
              </a:cxn>
              <a:cxn ang="0">
                <a:pos x="0" y="658"/>
              </a:cxn>
              <a:cxn ang="0">
                <a:pos x="0" y="548"/>
              </a:cxn>
              <a:cxn ang="0">
                <a:pos x="16" y="548"/>
              </a:cxn>
              <a:cxn ang="0">
                <a:pos x="16" y="549"/>
              </a:cxn>
              <a:cxn ang="0">
                <a:pos x="0" y="549"/>
              </a:cxn>
              <a:cxn ang="0">
                <a:pos x="0" y="548"/>
              </a:cxn>
              <a:cxn ang="0">
                <a:pos x="0" y="439"/>
              </a:cxn>
              <a:cxn ang="0">
                <a:pos x="16" y="439"/>
              </a:cxn>
              <a:cxn ang="0">
                <a:pos x="16" y="440"/>
              </a:cxn>
              <a:cxn ang="0">
                <a:pos x="0" y="440"/>
              </a:cxn>
              <a:cxn ang="0">
                <a:pos x="0" y="439"/>
              </a:cxn>
              <a:cxn ang="0">
                <a:pos x="0" y="329"/>
              </a:cxn>
              <a:cxn ang="0">
                <a:pos x="16" y="329"/>
              </a:cxn>
              <a:cxn ang="0">
                <a:pos x="16" y="330"/>
              </a:cxn>
              <a:cxn ang="0">
                <a:pos x="0" y="330"/>
              </a:cxn>
              <a:cxn ang="0">
                <a:pos x="0" y="329"/>
              </a:cxn>
              <a:cxn ang="0">
                <a:pos x="0" y="219"/>
              </a:cxn>
              <a:cxn ang="0">
                <a:pos x="16" y="219"/>
              </a:cxn>
              <a:cxn ang="0">
                <a:pos x="16" y="220"/>
              </a:cxn>
              <a:cxn ang="0">
                <a:pos x="0" y="220"/>
              </a:cxn>
              <a:cxn ang="0">
                <a:pos x="0" y="219"/>
              </a:cxn>
              <a:cxn ang="0">
                <a:pos x="0" y="109"/>
              </a:cxn>
              <a:cxn ang="0">
                <a:pos x="16" y="109"/>
              </a:cxn>
              <a:cxn ang="0">
                <a:pos x="16" y="110"/>
              </a:cxn>
              <a:cxn ang="0">
                <a:pos x="0" y="110"/>
              </a:cxn>
              <a:cxn ang="0">
                <a:pos x="0" y="109"/>
              </a:cxn>
              <a:cxn ang="0">
                <a:pos x="0" y="0"/>
              </a:cxn>
              <a:cxn ang="0">
                <a:pos x="16" y="0"/>
              </a:cxn>
              <a:cxn ang="0">
                <a:pos x="16" y="0"/>
              </a:cxn>
              <a:cxn ang="0">
                <a:pos x="0" y="0"/>
              </a:cxn>
              <a:cxn ang="0">
                <a:pos x="0" y="0"/>
              </a:cxn>
            </a:cxnLst>
            <a:rect l="0" t="0" r="r" b="b"/>
            <a:pathLst>
              <a:path w="16" h="1098">
                <a:moveTo>
                  <a:pt x="0" y="1097"/>
                </a:moveTo>
                <a:lnTo>
                  <a:pt x="16" y="1097"/>
                </a:lnTo>
                <a:lnTo>
                  <a:pt x="16" y="1098"/>
                </a:lnTo>
                <a:lnTo>
                  <a:pt x="0" y="1098"/>
                </a:lnTo>
                <a:lnTo>
                  <a:pt x="0" y="1097"/>
                </a:lnTo>
                <a:close/>
                <a:moveTo>
                  <a:pt x="0" y="987"/>
                </a:moveTo>
                <a:lnTo>
                  <a:pt x="16" y="987"/>
                </a:lnTo>
                <a:lnTo>
                  <a:pt x="16" y="988"/>
                </a:lnTo>
                <a:lnTo>
                  <a:pt x="0" y="988"/>
                </a:lnTo>
                <a:lnTo>
                  <a:pt x="0" y="987"/>
                </a:lnTo>
                <a:close/>
                <a:moveTo>
                  <a:pt x="0" y="877"/>
                </a:moveTo>
                <a:lnTo>
                  <a:pt x="16" y="877"/>
                </a:lnTo>
                <a:lnTo>
                  <a:pt x="16" y="878"/>
                </a:lnTo>
                <a:lnTo>
                  <a:pt x="0" y="878"/>
                </a:lnTo>
                <a:lnTo>
                  <a:pt x="0" y="877"/>
                </a:lnTo>
                <a:close/>
                <a:moveTo>
                  <a:pt x="0" y="768"/>
                </a:moveTo>
                <a:lnTo>
                  <a:pt x="16" y="768"/>
                </a:lnTo>
                <a:lnTo>
                  <a:pt x="16" y="768"/>
                </a:lnTo>
                <a:lnTo>
                  <a:pt x="0" y="768"/>
                </a:lnTo>
                <a:lnTo>
                  <a:pt x="0" y="768"/>
                </a:lnTo>
                <a:close/>
                <a:moveTo>
                  <a:pt x="0" y="658"/>
                </a:moveTo>
                <a:lnTo>
                  <a:pt x="16" y="658"/>
                </a:lnTo>
                <a:lnTo>
                  <a:pt x="16" y="659"/>
                </a:lnTo>
                <a:lnTo>
                  <a:pt x="0" y="659"/>
                </a:lnTo>
                <a:lnTo>
                  <a:pt x="0" y="658"/>
                </a:lnTo>
                <a:close/>
                <a:moveTo>
                  <a:pt x="0" y="548"/>
                </a:moveTo>
                <a:lnTo>
                  <a:pt x="16" y="548"/>
                </a:lnTo>
                <a:lnTo>
                  <a:pt x="16" y="549"/>
                </a:lnTo>
                <a:lnTo>
                  <a:pt x="0" y="549"/>
                </a:lnTo>
                <a:lnTo>
                  <a:pt x="0" y="548"/>
                </a:lnTo>
                <a:close/>
                <a:moveTo>
                  <a:pt x="0" y="439"/>
                </a:moveTo>
                <a:lnTo>
                  <a:pt x="16" y="439"/>
                </a:lnTo>
                <a:lnTo>
                  <a:pt x="16" y="440"/>
                </a:lnTo>
                <a:lnTo>
                  <a:pt x="0" y="440"/>
                </a:lnTo>
                <a:lnTo>
                  <a:pt x="0" y="439"/>
                </a:lnTo>
                <a:close/>
                <a:moveTo>
                  <a:pt x="0" y="329"/>
                </a:moveTo>
                <a:lnTo>
                  <a:pt x="16" y="329"/>
                </a:lnTo>
                <a:lnTo>
                  <a:pt x="16" y="330"/>
                </a:lnTo>
                <a:lnTo>
                  <a:pt x="0" y="330"/>
                </a:lnTo>
                <a:lnTo>
                  <a:pt x="0" y="329"/>
                </a:lnTo>
                <a:close/>
                <a:moveTo>
                  <a:pt x="0" y="219"/>
                </a:moveTo>
                <a:lnTo>
                  <a:pt x="16" y="219"/>
                </a:lnTo>
                <a:lnTo>
                  <a:pt x="16" y="220"/>
                </a:lnTo>
                <a:lnTo>
                  <a:pt x="0" y="220"/>
                </a:lnTo>
                <a:lnTo>
                  <a:pt x="0" y="219"/>
                </a:lnTo>
                <a:close/>
                <a:moveTo>
                  <a:pt x="0" y="109"/>
                </a:moveTo>
                <a:lnTo>
                  <a:pt x="16" y="109"/>
                </a:lnTo>
                <a:lnTo>
                  <a:pt x="16" y="110"/>
                </a:lnTo>
                <a:lnTo>
                  <a:pt x="0" y="110"/>
                </a:lnTo>
                <a:lnTo>
                  <a:pt x="0" y="109"/>
                </a:lnTo>
                <a:close/>
                <a:moveTo>
                  <a:pt x="0" y="0"/>
                </a:moveTo>
                <a:lnTo>
                  <a:pt x="16" y="0"/>
                </a:lnTo>
                <a:lnTo>
                  <a:pt x="16" y="0"/>
                </a:ln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859" name="Rectangle 835"/>
          <p:cNvSpPr>
            <a:spLocks noChangeArrowheads="1"/>
          </p:cNvSpPr>
          <p:nvPr/>
        </p:nvSpPr>
        <p:spPr bwMode="auto">
          <a:xfrm>
            <a:off x="2017700" y="6363110"/>
            <a:ext cx="2666496" cy="904"/>
          </a:xfrm>
          <a:prstGeom prst="rect">
            <a:avLst/>
          </a:pr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860" name="Freeform 836"/>
          <p:cNvSpPr>
            <a:spLocks noEditPoints="1"/>
          </p:cNvSpPr>
          <p:nvPr/>
        </p:nvSpPr>
        <p:spPr bwMode="auto">
          <a:xfrm>
            <a:off x="2017700" y="6363110"/>
            <a:ext cx="2666496" cy="14462"/>
          </a:xfrm>
          <a:custGeom>
            <a:avLst/>
            <a:gdLst/>
            <a:ahLst/>
            <a:cxnLst>
              <a:cxn ang="0">
                <a:pos x="1" y="16"/>
              </a:cxn>
              <a:cxn ang="0">
                <a:pos x="0" y="0"/>
              </a:cxn>
              <a:cxn ang="0">
                <a:pos x="128" y="0"/>
              </a:cxn>
              <a:cxn ang="0">
                <a:pos x="127" y="16"/>
              </a:cxn>
              <a:cxn ang="0">
                <a:pos x="128" y="0"/>
              </a:cxn>
              <a:cxn ang="0">
                <a:pos x="254" y="16"/>
              </a:cxn>
              <a:cxn ang="0">
                <a:pos x="254" y="0"/>
              </a:cxn>
              <a:cxn ang="0">
                <a:pos x="381" y="0"/>
              </a:cxn>
              <a:cxn ang="0">
                <a:pos x="380" y="16"/>
              </a:cxn>
              <a:cxn ang="0">
                <a:pos x="381" y="0"/>
              </a:cxn>
              <a:cxn ang="0">
                <a:pos x="508" y="16"/>
              </a:cxn>
              <a:cxn ang="0">
                <a:pos x="507" y="0"/>
              </a:cxn>
              <a:cxn ang="0">
                <a:pos x="635" y="0"/>
              </a:cxn>
              <a:cxn ang="0">
                <a:pos x="634" y="16"/>
              </a:cxn>
              <a:cxn ang="0">
                <a:pos x="635" y="0"/>
              </a:cxn>
              <a:cxn ang="0">
                <a:pos x="761" y="16"/>
              </a:cxn>
              <a:cxn ang="0">
                <a:pos x="760" y="0"/>
              </a:cxn>
              <a:cxn ang="0">
                <a:pos x="888" y="0"/>
              </a:cxn>
              <a:cxn ang="0">
                <a:pos x="887" y="16"/>
              </a:cxn>
              <a:cxn ang="0">
                <a:pos x="888" y="0"/>
              </a:cxn>
              <a:cxn ang="0">
                <a:pos x="1015" y="16"/>
              </a:cxn>
              <a:cxn ang="0">
                <a:pos x="1014" y="0"/>
              </a:cxn>
              <a:cxn ang="0">
                <a:pos x="1141" y="0"/>
              </a:cxn>
              <a:cxn ang="0">
                <a:pos x="1140" y="16"/>
              </a:cxn>
              <a:cxn ang="0">
                <a:pos x="1141" y="0"/>
              </a:cxn>
              <a:cxn ang="0">
                <a:pos x="1268" y="16"/>
              </a:cxn>
              <a:cxn ang="0">
                <a:pos x="1267" y="0"/>
              </a:cxn>
              <a:cxn ang="0">
                <a:pos x="1395" y="0"/>
              </a:cxn>
              <a:cxn ang="0">
                <a:pos x="1394" y="16"/>
              </a:cxn>
              <a:cxn ang="0">
                <a:pos x="1395" y="0"/>
              </a:cxn>
              <a:cxn ang="0">
                <a:pos x="1521" y="16"/>
              </a:cxn>
              <a:cxn ang="0">
                <a:pos x="1521" y="0"/>
              </a:cxn>
              <a:cxn ang="0">
                <a:pos x="1648" y="0"/>
              </a:cxn>
              <a:cxn ang="0">
                <a:pos x="1647" y="16"/>
              </a:cxn>
              <a:cxn ang="0">
                <a:pos x="1648" y="0"/>
              </a:cxn>
              <a:cxn ang="0">
                <a:pos x="1775" y="16"/>
              </a:cxn>
              <a:cxn ang="0">
                <a:pos x="1774" y="0"/>
              </a:cxn>
              <a:cxn ang="0">
                <a:pos x="1902" y="0"/>
              </a:cxn>
              <a:cxn ang="0">
                <a:pos x="1901" y="16"/>
              </a:cxn>
              <a:cxn ang="0">
                <a:pos x="1902" y="0"/>
              </a:cxn>
              <a:cxn ang="0">
                <a:pos x="2028" y="16"/>
              </a:cxn>
              <a:cxn ang="0">
                <a:pos x="2027" y="0"/>
              </a:cxn>
              <a:cxn ang="0">
                <a:pos x="2155" y="0"/>
              </a:cxn>
              <a:cxn ang="0">
                <a:pos x="2154" y="16"/>
              </a:cxn>
              <a:cxn ang="0">
                <a:pos x="2155" y="0"/>
              </a:cxn>
              <a:cxn ang="0">
                <a:pos x="2282" y="16"/>
              </a:cxn>
              <a:cxn ang="0">
                <a:pos x="2281" y="0"/>
              </a:cxn>
              <a:cxn ang="0">
                <a:pos x="2408" y="0"/>
              </a:cxn>
              <a:cxn ang="0">
                <a:pos x="2407" y="16"/>
              </a:cxn>
              <a:cxn ang="0">
                <a:pos x="2408" y="0"/>
              </a:cxn>
              <a:cxn ang="0">
                <a:pos x="2535" y="16"/>
              </a:cxn>
              <a:cxn ang="0">
                <a:pos x="2534" y="0"/>
              </a:cxn>
            </a:cxnLst>
            <a:rect l="0" t="0" r="r" b="b"/>
            <a:pathLst>
              <a:path w="2535" h="16">
                <a:moveTo>
                  <a:pt x="1" y="0"/>
                </a:moveTo>
                <a:lnTo>
                  <a:pt x="1" y="16"/>
                </a:lnTo>
                <a:lnTo>
                  <a:pt x="0" y="16"/>
                </a:lnTo>
                <a:lnTo>
                  <a:pt x="0" y="0"/>
                </a:lnTo>
                <a:lnTo>
                  <a:pt x="1" y="0"/>
                </a:lnTo>
                <a:close/>
                <a:moveTo>
                  <a:pt x="128" y="0"/>
                </a:moveTo>
                <a:lnTo>
                  <a:pt x="128" y="16"/>
                </a:lnTo>
                <a:lnTo>
                  <a:pt x="127" y="16"/>
                </a:lnTo>
                <a:lnTo>
                  <a:pt x="127" y="0"/>
                </a:lnTo>
                <a:lnTo>
                  <a:pt x="128" y="0"/>
                </a:lnTo>
                <a:close/>
                <a:moveTo>
                  <a:pt x="254" y="0"/>
                </a:moveTo>
                <a:lnTo>
                  <a:pt x="254" y="16"/>
                </a:lnTo>
                <a:lnTo>
                  <a:pt x="254" y="16"/>
                </a:lnTo>
                <a:lnTo>
                  <a:pt x="254" y="0"/>
                </a:lnTo>
                <a:lnTo>
                  <a:pt x="254" y="0"/>
                </a:lnTo>
                <a:close/>
                <a:moveTo>
                  <a:pt x="381" y="0"/>
                </a:moveTo>
                <a:lnTo>
                  <a:pt x="381" y="16"/>
                </a:lnTo>
                <a:lnTo>
                  <a:pt x="380" y="16"/>
                </a:lnTo>
                <a:lnTo>
                  <a:pt x="380" y="0"/>
                </a:lnTo>
                <a:lnTo>
                  <a:pt x="381" y="0"/>
                </a:lnTo>
                <a:close/>
                <a:moveTo>
                  <a:pt x="508" y="0"/>
                </a:moveTo>
                <a:lnTo>
                  <a:pt x="508" y="16"/>
                </a:lnTo>
                <a:lnTo>
                  <a:pt x="507" y="16"/>
                </a:lnTo>
                <a:lnTo>
                  <a:pt x="507" y="0"/>
                </a:lnTo>
                <a:lnTo>
                  <a:pt x="508" y="0"/>
                </a:lnTo>
                <a:close/>
                <a:moveTo>
                  <a:pt x="635" y="0"/>
                </a:moveTo>
                <a:lnTo>
                  <a:pt x="635" y="16"/>
                </a:lnTo>
                <a:lnTo>
                  <a:pt x="634" y="16"/>
                </a:lnTo>
                <a:lnTo>
                  <a:pt x="634" y="0"/>
                </a:lnTo>
                <a:lnTo>
                  <a:pt x="635" y="0"/>
                </a:lnTo>
                <a:close/>
                <a:moveTo>
                  <a:pt x="761" y="0"/>
                </a:moveTo>
                <a:lnTo>
                  <a:pt x="761" y="16"/>
                </a:lnTo>
                <a:lnTo>
                  <a:pt x="760" y="16"/>
                </a:lnTo>
                <a:lnTo>
                  <a:pt x="760" y="0"/>
                </a:lnTo>
                <a:lnTo>
                  <a:pt x="761" y="0"/>
                </a:lnTo>
                <a:close/>
                <a:moveTo>
                  <a:pt x="888" y="0"/>
                </a:moveTo>
                <a:lnTo>
                  <a:pt x="888" y="16"/>
                </a:lnTo>
                <a:lnTo>
                  <a:pt x="887" y="16"/>
                </a:lnTo>
                <a:lnTo>
                  <a:pt x="887" y="0"/>
                </a:lnTo>
                <a:lnTo>
                  <a:pt x="888" y="0"/>
                </a:lnTo>
                <a:close/>
                <a:moveTo>
                  <a:pt x="1015" y="0"/>
                </a:moveTo>
                <a:lnTo>
                  <a:pt x="1015" y="16"/>
                </a:lnTo>
                <a:lnTo>
                  <a:pt x="1014" y="16"/>
                </a:lnTo>
                <a:lnTo>
                  <a:pt x="1014" y="0"/>
                </a:lnTo>
                <a:lnTo>
                  <a:pt x="1015" y="0"/>
                </a:lnTo>
                <a:close/>
                <a:moveTo>
                  <a:pt x="1141" y="0"/>
                </a:moveTo>
                <a:lnTo>
                  <a:pt x="1141" y="16"/>
                </a:lnTo>
                <a:lnTo>
                  <a:pt x="1140" y="16"/>
                </a:lnTo>
                <a:lnTo>
                  <a:pt x="1140" y="0"/>
                </a:lnTo>
                <a:lnTo>
                  <a:pt x="1141" y="0"/>
                </a:lnTo>
                <a:close/>
                <a:moveTo>
                  <a:pt x="1268" y="0"/>
                </a:moveTo>
                <a:lnTo>
                  <a:pt x="1268" y="16"/>
                </a:lnTo>
                <a:lnTo>
                  <a:pt x="1267" y="16"/>
                </a:lnTo>
                <a:lnTo>
                  <a:pt x="1267" y="0"/>
                </a:lnTo>
                <a:lnTo>
                  <a:pt x="1268" y="0"/>
                </a:lnTo>
                <a:close/>
                <a:moveTo>
                  <a:pt x="1395" y="0"/>
                </a:moveTo>
                <a:lnTo>
                  <a:pt x="1395" y="16"/>
                </a:lnTo>
                <a:lnTo>
                  <a:pt x="1394" y="16"/>
                </a:lnTo>
                <a:lnTo>
                  <a:pt x="1394" y="0"/>
                </a:lnTo>
                <a:lnTo>
                  <a:pt x="1395" y="0"/>
                </a:lnTo>
                <a:close/>
                <a:moveTo>
                  <a:pt x="1521" y="0"/>
                </a:moveTo>
                <a:lnTo>
                  <a:pt x="1521" y="16"/>
                </a:lnTo>
                <a:lnTo>
                  <a:pt x="1521" y="16"/>
                </a:lnTo>
                <a:lnTo>
                  <a:pt x="1521" y="0"/>
                </a:lnTo>
                <a:lnTo>
                  <a:pt x="1521" y="0"/>
                </a:lnTo>
                <a:close/>
                <a:moveTo>
                  <a:pt x="1648" y="0"/>
                </a:moveTo>
                <a:lnTo>
                  <a:pt x="1648" y="16"/>
                </a:lnTo>
                <a:lnTo>
                  <a:pt x="1647" y="16"/>
                </a:lnTo>
                <a:lnTo>
                  <a:pt x="1647" y="0"/>
                </a:lnTo>
                <a:lnTo>
                  <a:pt x="1648" y="0"/>
                </a:lnTo>
                <a:close/>
                <a:moveTo>
                  <a:pt x="1775" y="0"/>
                </a:moveTo>
                <a:lnTo>
                  <a:pt x="1775" y="16"/>
                </a:lnTo>
                <a:lnTo>
                  <a:pt x="1774" y="16"/>
                </a:lnTo>
                <a:lnTo>
                  <a:pt x="1774" y="0"/>
                </a:lnTo>
                <a:lnTo>
                  <a:pt x="1775" y="0"/>
                </a:lnTo>
                <a:close/>
                <a:moveTo>
                  <a:pt x="1902" y="0"/>
                </a:moveTo>
                <a:lnTo>
                  <a:pt x="1902" y="16"/>
                </a:lnTo>
                <a:lnTo>
                  <a:pt x="1901" y="16"/>
                </a:lnTo>
                <a:lnTo>
                  <a:pt x="1901" y="0"/>
                </a:lnTo>
                <a:lnTo>
                  <a:pt x="1902" y="0"/>
                </a:lnTo>
                <a:close/>
                <a:moveTo>
                  <a:pt x="2028" y="0"/>
                </a:moveTo>
                <a:lnTo>
                  <a:pt x="2028" y="16"/>
                </a:lnTo>
                <a:lnTo>
                  <a:pt x="2027" y="16"/>
                </a:lnTo>
                <a:lnTo>
                  <a:pt x="2027" y="0"/>
                </a:lnTo>
                <a:lnTo>
                  <a:pt x="2028" y="0"/>
                </a:lnTo>
                <a:close/>
                <a:moveTo>
                  <a:pt x="2155" y="0"/>
                </a:moveTo>
                <a:lnTo>
                  <a:pt x="2155" y="16"/>
                </a:lnTo>
                <a:lnTo>
                  <a:pt x="2154" y="16"/>
                </a:lnTo>
                <a:lnTo>
                  <a:pt x="2154" y="0"/>
                </a:lnTo>
                <a:lnTo>
                  <a:pt x="2155" y="0"/>
                </a:lnTo>
                <a:close/>
                <a:moveTo>
                  <a:pt x="2282" y="0"/>
                </a:moveTo>
                <a:lnTo>
                  <a:pt x="2282" y="16"/>
                </a:lnTo>
                <a:lnTo>
                  <a:pt x="2281" y="16"/>
                </a:lnTo>
                <a:lnTo>
                  <a:pt x="2281" y="0"/>
                </a:lnTo>
                <a:lnTo>
                  <a:pt x="2282" y="0"/>
                </a:lnTo>
                <a:close/>
                <a:moveTo>
                  <a:pt x="2408" y="0"/>
                </a:moveTo>
                <a:lnTo>
                  <a:pt x="2408" y="16"/>
                </a:lnTo>
                <a:lnTo>
                  <a:pt x="2407" y="16"/>
                </a:lnTo>
                <a:lnTo>
                  <a:pt x="2407" y="0"/>
                </a:lnTo>
                <a:lnTo>
                  <a:pt x="2408" y="0"/>
                </a:lnTo>
                <a:close/>
                <a:moveTo>
                  <a:pt x="2535" y="0"/>
                </a:moveTo>
                <a:lnTo>
                  <a:pt x="2535" y="16"/>
                </a:lnTo>
                <a:lnTo>
                  <a:pt x="2534" y="16"/>
                </a:lnTo>
                <a:lnTo>
                  <a:pt x="2534" y="0"/>
                </a:lnTo>
                <a:lnTo>
                  <a:pt x="2535" y="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861" name="Rectangle 837"/>
          <p:cNvSpPr>
            <a:spLocks noChangeArrowheads="1"/>
          </p:cNvSpPr>
          <p:nvPr/>
        </p:nvSpPr>
        <p:spPr bwMode="auto">
          <a:xfrm>
            <a:off x="1897495" y="6335994"/>
            <a:ext cx="59957" cy="705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7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862" name="Rectangle 838"/>
          <p:cNvSpPr>
            <a:spLocks noChangeArrowheads="1"/>
          </p:cNvSpPr>
          <p:nvPr/>
        </p:nvSpPr>
        <p:spPr bwMode="auto">
          <a:xfrm>
            <a:off x="1829124" y="6236566"/>
            <a:ext cx="128328" cy="705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7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20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863" name="Rectangle 839"/>
          <p:cNvSpPr>
            <a:spLocks noChangeArrowheads="1"/>
          </p:cNvSpPr>
          <p:nvPr/>
        </p:nvSpPr>
        <p:spPr bwMode="auto">
          <a:xfrm>
            <a:off x="1829124" y="6137139"/>
            <a:ext cx="128328" cy="69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7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40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864" name="Rectangle 840"/>
          <p:cNvSpPr>
            <a:spLocks noChangeArrowheads="1"/>
          </p:cNvSpPr>
          <p:nvPr/>
        </p:nvSpPr>
        <p:spPr bwMode="auto">
          <a:xfrm>
            <a:off x="1829124" y="6037711"/>
            <a:ext cx="128328" cy="705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7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600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865" name="Rectangle 841"/>
          <p:cNvSpPr>
            <a:spLocks noChangeArrowheads="1"/>
          </p:cNvSpPr>
          <p:nvPr/>
        </p:nvSpPr>
        <p:spPr bwMode="auto">
          <a:xfrm>
            <a:off x="1829124" y="5939187"/>
            <a:ext cx="128328" cy="705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7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80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866" name="Rectangle 842"/>
          <p:cNvSpPr>
            <a:spLocks noChangeArrowheads="1"/>
          </p:cNvSpPr>
          <p:nvPr/>
        </p:nvSpPr>
        <p:spPr bwMode="auto">
          <a:xfrm>
            <a:off x="1795464" y="5839760"/>
            <a:ext cx="161988" cy="69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7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100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867" name="Rectangle 843"/>
          <p:cNvSpPr>
            <a:spLocks noChangeArrowheads="1"/>
          </p:cNvSpPr>
          <p:nvPr/>
        </p:nvSpPr>
        <p:spPr bwMode="auto">
          <a:xfrm>
            <a:off x="1795464" y="5740332"/>
            <a:ext cx="161988" cy="705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7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120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868" name="Rectangle 844"/>
          <p:cNvSpPr>
            <a:spLocks noChangeArrowheads="1"/>
          </p:cNvSpPr>
          <p:nvPr/>
        </p:nvSpPr>
        <p:spPr bwMode="auto">
          <a:xfrm>
            <a:off x="1795464" y="5641809"/>
            <a:ext cx="161988" cy="705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7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1400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869" name="Rectangle 845"/>
          <p:cNvSpPr>
            <a:spLocks noChangeArrowheads="1"/>
          </p:cNvSpPr>
          <p:nvPr/>
        </p:nvSpPr>
        <p:spPr bwMode="auto">
          <a:xfrm>
            <a:off x="1795464" y="5542381"/>
            <a:ext cx="161988" cy="705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7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160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870" name="Rectangle 846"/>
          <p:cNvSpPr>
            <a:spLocks noChangeArrowheads="1"/>
          </p:cNvSpPr>
          <p:nvPr/>
        </p:nvSpPr>
        <p:spPr bwMode="auto">
          <a:xfrm>
            <a:off x="1795464" y="5442954"/>
            <a:ext cx="161988" cy="69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7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180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871" name="Rectangle 847"/>
          <p:cNvSpPr>
            <a:spLocks noChangeArrowheads="1"/>
          </p:cNvSpPr>
          <p:nvPr/>
        </p:nvSpPr>
        <p:spPr bwMode="auto">
          <a:xfrm>
            <a:off x="1795464" y="5343526"/>
            <a:ext cx="161988" cy="705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7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200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872" name="Rectangle 848"/>
          <p:cNvSpPr>
            <a:spLocks noChangeArrowheads="1"/>
          </p:cNvSpPr>
          <p:nvPr/>
        </p:nvSpPr>
        <p:spPr bwMode="auto">
          <a:xfrm>
            <a:off x="2069241" y="6406497"/>
            <a:ext cx="59957" cy="705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7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1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873" name="Rectangle 849"/>
          <p:cNvSpPr>
            <a:spLocks noChangeArrowheads="1"/>
          </p:cNvSpPr>
          <p:nvPr/>
        </p:nvSpPr>
        <p:spPr bwMode="auto">
          <a:xfrm>
            <a:off x="2202829" y="6406497"/>
            <a:ext cx="61009" cy="705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7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2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874" name="Rectangle 850"/>
          <p:cNvSpPr>
            <a:spLocks noChangeArrowheads="1"/>
          </p:cNvSpPr>
          <p:nvPr/>
        </p:nvSpPr>
        <p:spPr bwMode="auto">
          <a:xfrm>
            <a:off x="2336417" y="6406497"/>
            <a:ext cx="61009" cy="705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7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3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875" name="Rectangle 851"/>
          <p:cNvSpPr>
            <a:spLocks noChangeArrowheads="1"/>
          </p:cNvSpPr>
          <p:nvPr/>
        </p:nvSpPr>
        <p:spPr bwMode="auto">
          <a:xfrm>
            <a:off x="2468953" y="6406497"/>
            <a:ext cx="61009" cy="705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7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4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876" name="Rectangle 852"/>
          <p:cNvSpPr>
            <a:spLocks noChangeArrowheads="1"/>
          </p:cNvSpPr>
          <p:nvPr/>
        </p:nvSpPr>
        <p:spPr bwMode="auto">
          <a:xfrm>
            <a:off x="2602541" y="6406497"/>
            <a:ext cx="59957" cy="705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7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5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877" name="Rectangle 853"/>
          <p:cNvSpPr>
            <a:spLocks noChangeArrowheads="1"/>
          </p:cNvSpPr>
          <p:nvPr/>
        </p:nvSpPr>
        <p:spPr bwMode="auto">
          <a:xfrm>
            <a:off x="2736128" y="6406497"/>
            <a:ext cx="61009" cy="705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7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6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878" name="Rectangle 854"/>
          <p:cNvSpPr>
            <a:spLocks noChangeArrowheads="1"/>
          </p:cNvSpPr>
          <p:nvPr/>
        </p:nvSpPr>
        <p:spPr bwMode="auto">
          <a:xfrm>
            <a:off x="2868664" y="6406497"/>
            <a:ext cx="61009" cy="705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7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7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879" name="Rectangle 855"/>
          <p:cNvSpPr>
            <a:spLocks noChangeArrowheads="1"/>
          </p:cNvSpPr>
          <p:nvPr/>
        </p:nvSpPr>
        <p:spPr bwMode="auto">
          <a:xfrm>
            <a:off x="3002252" y="6406497"/>
            <a:ext cx="59957" cy="705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7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8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880" name="Rectangle 856"/>
          <p:cNvSpPr>
            <a:spLocks noChangeArrowheads="1"/>
          </p:cNvSpPr>
          <p:nvPr/>
        </p:nvSpPr>
        <p:spPr bwMode="auto">
          <a:xfrm>
            <a:off x="3135840" y="6406497"/>
            <a:ext cx="59957" cy="705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7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9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881" name="Rectangle 857"/>
          <p:cNvSpPr>
            <a:spLocks noChangeArrowheads="1"/>
          </p:cNvSpPr>
          <p:nvPr/>
        </p:nvSpPr>
        <p:spPr bwMode="auto">
          <a:xfrm>
            <a:off x="3253649" y="6406497"/>
            <a:ext cx="94669" cy="705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7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1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882" name="Rectangle 858"/>
          <p:cNvSpPr>
            <a:spLocks noChangeArrowheads="1"/>
          </p:cNvSpPr>
          <p:nvPr/>
        </p:nvSpPr>
        <p:spPr bwMode="auto">
          <a:xfrm>
            <a:off x="3386185" y="6406497"/>
            <a:ext cx="94669" cy="705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7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11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883" name="Rectangle 859"/>
          <p:cNvSpPr>
            <a:spLocks noChangeArrowheads="1"/>
          </p:cNvSpPr>
          <p:nvPr/>
        </p:nvSpPr>
        <p:spPr bwMode="auto">
          <a:xfrm>
            <a:off x="3519773" y="6406497"/>
            <a:ext cx="93617" cy="705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7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12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884" name="Rectangle 860"/>
          <p:cNvSpPr>
            <a:spLocks noChangeArrowheads="1"/>
          </p:cNvSpPr>
          <p:nvPr/>
        </p:nvSpPr>
        <p:spPr bwMode="auto">
          <a:xfrm>
            <a:off x="3653361" y="6406497"/>
            <a:ext cx="94669" cy="705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7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13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885" name="Rectangle 861"/>
          <p:cNvSpPr>
            <a:spLocks noChangeArrowheads="1"/>
          </p:cNvSpPr>
          <p:nvPr/>
        </p:nvSpPr>
        <p:spPr bwMode="auto">
          <a:xfrm>
            <a:off x="3785897" y="6406497"/>
            <a:ext cx="94669" cy="705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7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14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886" name="Rectangle 862"/>
          <p:cNvSpPr>
            <a:spLocks noChangeArrowheads="1"/>
          </p:cNvSpPr>
          <p:nvPr/>
        </p:nvSpPr>
        <p:spPr bwMode="auto">
          <a:xfrm>
            <a:off x="3919485" y="6406497"/>
            <a:ext cx="93617" cy="705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7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15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887" name="Rectangle 863"/>
          <p:cNvSpPr>
            <a:spLocks noChangeArrowheads="1"/>
          </p:cNvSpPr>
          <p:nvPr/>
        </p:nvSpPr>
        <p:spPr bwMode="auto">
          <a:xfrm>
            <a:off x="4053072" y="6406497"/>
            <a:ext cx="93617" cy="705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7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16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888" name="Rectangle 864"/>
          <p:cNvSpPr>
            <a:spLocks noChangeArrowheads="1"/>
          </p:cNvSpPr>
          <p:nvPr/>
        </p:nvSpPr>
        <p:spPr bwMode="auto">
          <a:xfrm>
            <a:off x="4186660" y="6406497"/>
            <a:ext cx="94669" cy="705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7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17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889" name="Rectangle 865"/>
          <p:cNvSpPr>
            <a:spLocks noChangeArrowheads="1"/>
          </p:cNvSpPr>
          <p:nvPr/>
        </p:nvSpPr>
        <p:spPr bwMode="auto">
          <a:xfrm>
            <a:off x="4319196" y="6406497"/>
            <a:ext cx="94669" cy="705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7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18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890" name="Rectangle 866"/>
          <p:cNvSpPr>
            <a:spLocks noChangeArrowheads="1"/>
          </p:cNvSpPr>
          <p:nvPr/>
        </p:nvSpPr>
        <p:spPr bwMode="auto">
          <a:xfrm>
            <a:off x="4452784" y="6406497"/>
            <a:ext cx="93617" cy="705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7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19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891" name="Rectangle 867"/>
          <p:cNvSpPr>
            <a:spLocks noChangeArrowheads="1"/>
          </p:cNvSpPr>
          <p:nvPr/>
        </p:nvSpPr>
        <p:spPr bwMode="auto">
          <a:xfrm>
            <a:off x="4586372" y="6406497"/>
            <a:ext cx="94669" cy="705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7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2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4348" name="Rectangle 1036"/>
          <p:cNvSpPr>
            <a:spLocks noChangeArrowheads="1"/>
          </p:cNvSpPr>
          <p:nvPr/>
        </p:nvSpPr>
        <p:spPr bwMode="auto">
          <a:xfrm>
            <a:off x="4900674" y="5243512"/>
            <a:ext cx="99144" cy="408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150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4349" name="Rectangle 1037"/>
          <p:cNvSpPr>
            <a:spLocks noChangeArrowheads="1"/>
          </p:cNvSpPr>
          <p:nvPr/>
        </p:nvSpPr>
        <p:spPr bwMode="auto">
          <a:xfrm>
            <a:off x="4900674" y="5444668"/>
            <a:ext cx="99144" cy="408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100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4350" name="Rectangle 1038"/>
          <p:cNvSpPr>
            <a:spLocks noChangeArrowheads="1"/>
          </p:cNvSpPr>
          <p:nvPr/>
        </p:nvSpPr>
        <p:spPr bwMode="auto">
          <a:xfrm>
            <a:off x="4920306" y="5645825"/>
            <a:ext cx="78529" cy="408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50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4351" name="Rectangle 1039"/>
          <p:cNvSpPr>
            <a:spLocks noChangeArrowheads="1"/>
          </p:cNvSpPr>
          <p:nvPr/>
        </p:nvSpPr>
        <p:spPr bwMode="auto">
          <a:xfrm>
            <a:off x="4957608" y="5846981"/>
            <a:ext cx="37301" cy="408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4352" name="Rectangle 1040"/>
          <p:cNvSpPr>
            <a:spLocks noChangeArrowheads="1"/>
          </p:cNvSpPr>
          <p:nvPr/>
        </p:nvSpPr>
        <p:spPr bwMode="auto">
          <a:xfrm>
            <a:off x="4907545" y="6048138"/>
            <a:ext cx="91291" cy="408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-50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4353" name="Rectangle 1041"/>
          <p:cNvSpPr>
            <a:spLocks noChangeArrowheads="1"/>
          </p:cNvSpPr>
          <p:nvPr/>
        </p:nvSpPr>
        <p:spPr bwMode="auto">
          <a:xfrm>
            <a:off x="4887913" y="6249294"/>
            <a:ext cx="111904" cy="408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-100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4354" name="Rectangle 1042"/>
          <p:cNvSpPr>
            <a:spLocks noChangeArrowheads="1"/>
          </p:cNvSpPr>
          <p:nvPr/>
        </p:nvSpPr>
        <p:spPr bwMode="auto">
          <a:xfrm>
            <a:off x="4887913" y="6450451"/>
            <a:ext cx="111904" cy="408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-150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4341" name="Line 1029"/>
          <p:cNvSpPr>
            <a:spLocks noChangeShapeType="1"/>
          </p:cNvSpPr>
          <p:nvPr/>
        </p:nvSpPr>
        <p:spPr bwMode="auto">
          <a:xfrm flipV="1">
            <a:off x="5094377" y="5276174"/>
            <a:ext cx="982" cy="1206939"/>
          </a:xfrm>
          <a:prstGeom prst="line">
            <a:avLst/>
          </a:prstGeom>
          <a:noFill/>
          <a:ln w="6350" cap="flat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4342" name="Line 1030"/>
          <p:cNvSpPr>
            <a:spLocks noChangeShapeType="1"/>
          </p:cNvSpPr>
          <p:nvPr/>
        </p:nvSpPr>
        <p:spPr bwMode="auto">
          <a:xfrm flipH="1">
            <a:off x="5071800" y="6483113"/>
            <a:ext cx="22578" cy="756"/>
          </a:xfrm>
          <a:prstGeom prst="line">
            <a:avLst/>
          </a:prstGeom>
          <a:noFill/>
          <a:ln w="6350" cap="flat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4343" name="Line 1031"/>
          <p:cNvSpPr>
            <a:spLocks noChangeShapeType="1"/>
          </p:cNvSpPr>
          <p:nvPr/>
        </p:nvSpPr>
        <p:spPr bwMode="auto">
          <a:xfrm flipH="1">
            <a:off x="5071800" y="6281956"/>
            <a:ext cx="22578" cy="756"/>
          </a:xfrm>
          <a:prstGeom prst="line">
            <a:avLst/>
          </a:prstGeom>
          <a:noFill/>
          <a:ln w="6350" cap="flat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4344" name="Line 1032"/>
          <p:cNvSpPr>
            <a:spLocks noChangeShapeType="1"/>
          </p:cNvSpPr>
          <p:nvPr/>
        </p:nvSpPr>
        <p:spPr bwMode="auto">
          <a:xfrm flipH="1">
            <a:off x="5071800" y="6080800"/>
            <a:ext cx="22578" cy="756"/>
          </a:xfrm>
          <a:prstGeom prst="line">
            <a:avLst/>
          </a:prstGeom>
          <a:noFill/>
          <a:ln w="6350" cap="flat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4345" name="Line 1033"/>
          <p:cNvSpPr>
            <a:spLocks noChangeShapeType="1"/>
          </p:cNvSpPr>
          <p:nvPr/>
        </p:nvSpPr>
        <p:spPr bwMode="auto">
          <a:xfrm flipH="1">
            <a:off x="5071800" y="5879643"/>
            <a:ext cx="22578" cy="756"/>
          </a:xfrm>
          <a:prstGeom prst="line">
            <a:avLst/>
          </a:prstGeom>
          <a:noFill/>
          <a:ln w="6350" cap="flat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4346" name="Line 1034"/>
          <p:cNvSpPr>
            <a:spLocks noChangeShapeType="1"/>
          </p:cNvSpPr>
          <p:nvPr/>
        </p:nvSpPr>
        <p:spPr bwMode="auto">
          <a:xfrm flipH="1">
            <a:off x="5071800" y="5678487"/>
            <a:ext cx="22578" cy="756"/>
          </a:xfrm>
          <a:prstGeom prst="line">
            <a:avLst/>
          </a:prstGeom>
          <a:noFill/>
          <a:ln w="6350" cap="flat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4347" name="Line 1035"/>
          <p:cNvSpPr>
            <a:spLocks noChangeShapeType="1"/>
          </p:cNvSpPr>
          <p:nvPr/>
        </p:nvSpPr>
        <p:spPr bwMode="auto">
          <a:xfrm flipH="1">
            <a:off x="5071800" y="5477331"/>
            <a:ext cx="22578" cy="756"/>
          </a:xfrm>
          <a:prstGeom prst="line">
            <a:avLst/>
          </a:prstGeom>
          <a:noFill/>
          <a:ln w="6350" cap="flat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4355" name="Line 1043"/>
          <p:cNvSpPr>
            <a:spLocks noChangeShapeType="1"/>
          </p:cNvSpPr>
          <p:nvPr/>
        </p:nvSpPr>
        <p:spPr bwMode="auto">
          <a:xfrm flipH="1">
            <a:off x="5071800" y="5276174"/>
            <a:ext cx="22578" cy="756"/>
          </a:xfrm>
          <a:prstGeom prst="line">
            <a:avLst/>
          </a:prstGeom>
          <a:noFill/>
          <a:ln w="6350" cap="flat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grpSp>
        <p:nvGrpSpPr>
          <p:cNvPr id="579" name="Group 578"/>
          <p:cNvGrpSpPr/>
          <p:nvPr/>
        </p:nvGrpSpPr>
        <p:grpSpPr>
          <a:xfrm flipV="1">
            <a:off x="5185668" y="5662791"/>
            <a:ext cx="119757" cy="750934"/>
            <a:chOff x="5185668" y="5338941"/>
            <a:chExt cx="119757" cy="750934"/>
          </a:xfrm>
        </p:grpSpPr>
        <p:sp>
          <p:nvSpPr>
            <p:cNvPr id="14356" name="Freeform 1044"/>
            <p:cNvSpPr>
              <a:spLocks/>
            </p:cNvSpPr>
            <p:nvPr/>
          </p:nvSpPr>
          <p:spPr bwMode="auto">
            <a:xfrm>
              <a:off x="5230822" y="5338941"/>
              <a:ext cx="29449" cy="750934"/>
            </a:xfrm>
            <a:custGeom>
              <a:avLst/>
              <a:gdLst/>
              <a:ahLst/>
              <a:cxnLst>
                <a:cxn ang="0">
                  <a:pos x="0" y="5804"/>
                </a:cxn>
                <a:cxn ang="0">
                  <a:pos x="95" y="5804"/>
                </a:cxn>
                <a:cxn ang="0">
                  <a:pos x="95" y="0"/>
                </a:cxn>
                <a:cxn ang="0">
                  <a:pos x="0" y="0"/>
                </a:cxn>
                <a:cxn ang="0">
                  <a:pos x="189" y="0"/>
                </a:cxn>
                <a:cxn ang="0">
                  <a:pos x="95" y="0"/>
                </a:cxn>
                <a:cxn ang="0">
                  <a:pos x="95" y="5804"/>
                </a:cxn>
                <a:cxn ang="0">
                  <a:pos x="189" y="5804"/>
                </a:cxn>
                <a:cxn ang="0">
                  <a:pos x="0" y="5804"/>
                </a:cxn>
              </a:cxnLst>
              <a:rect l="0" t="0" r="r" b="b"/>
              <a:pathLst>
                <a:path w="189" h="5804">
                  <a:moveTo>
                    <a:pt x="0" y="5804"/>
                  </a:moveTo>
                  <a:lnTo>
                    <a:pt x="95" y="5804"/>
                  </a:lnTo>
                  <a:lnTo>
                    <a:pt x="95" y="0"/>
                  </a:lnTo>
                  <a:lnTo>
                    <a:pt x="0" y="0"/>
                  </a:lnTo>
                  <a:lnTo>
                    <a:pt x="189" y="0"/>
                  </a:lnTo>
                  <a:lnTo>
                    <a:pt x="95" y="0"/>
                  </a:lnTo>
                  <a:lnTo>
                    <a:pt x="95" y="5804"/>
                  </a:lnTo>
                  <a:lnTo>
                    <a:pt x="189" y="5804"/>
                  </a:lnTo>
                  <a:lnTo>
                    <a:pt x="0" y="5804"/>
                  </a:lnTo>
                  <a:close/>
                </a:path>
              </a:pathLst>
            </a:custGeom>
            <a:solidFill>
              <a:srgbClr val="DBD8AC"/>
            </a:solidFill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4357" name="Rectangle 1045"/>
            <p:cNvSpPr>
              <a:spLocks noChangeArrowheads="1"/>
            </p:cNvSpPr>
            <p:nvPr/>
          </p:nvSpPr>
          <p:spPr bwMode="auto">
            <a:xfrm>
              <a:off x="5185668" y="5610427"/>
              <a:ext cx="119757" cy="251067"/>
            </a:xfrm>
            <a:prstGeom prst="rect">
              <a:avLst/>
            </a:prstGeom>
            <a:solidFill>
              <a:srgbClr val="2EB848"/>
            </a:solidFill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4358" name="Freeform 1046"/>
            <p:cNvSpPr>
              <a:spLocks/>
            </p:cNvSpPr>
            <p:nvPr/>
          </p:nvSpPr>
          <p:spPr bwMode="auto">
            <a:xfrm>
              <a:off x="5185668" y="5727642"/>
              <a:ext cx="119757" cy="75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756" y="0"/>
                </a:cxn>
                <a:cxn ang="0">
                  <a:pos x="0" y="0"/>
                </a:cxn>
              </a:cxnLst>
              <a:rect l="0" t="0" r="r" b="b"/>
              <a:pathLst>
                <a:path w="756">
                  <a:moveTo>
                    <a:pt x="0" y="0"/>
                  </a:moveTo>
                  <a:lnTo>
                    <a:pt x="756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28575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</p:grpSp>
      <p:sp>
        <p:nvSpPr>
          <p:cNvPr id="777" name="TextBox 776"/>
          <p:cNvSpPr txBox="1"/>
          <p:nvPr/>
        </p:nvSpPr>
        <p:spPr>
          <a:xfrm>
            <a:off x="-9524" y="6991350"/>
            <a:ext cx="15525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dirty="0" smtClean="0"/>
              <a:t>NADH</a:t>
            </a:r>
            <a:endParaRPr lang="en-GB" baseline="-25000" dirty="0"/>
          </a:p>
        </p:txBody>
      </p:sp>
      <p:sp>
        <p:nvSpPr>
          <p:cNvPr id="1905" name="Freeform 881"/>
          <p:cNvSpPr>
            <a:spLocks noEditPoints="1"/>
          </p:cNvSpPr>
          <p:nvPr/>
        </p:nvSpPr>
        <p:spPr bwMode="auto">
          <a:xfrm>
            <a:off x="2031138" y="6612724"/>
            <a:ext cx="2614941" cy="982038"/>
          </a:xfrm>
          <a:custGeom>
            <a:avLst/>
            <a:gdLst/>
            <a:ahLst/>
            <a:cxnLst>
              <a:cxn ang="0">
                <a:pos x="0" y="879"/>
              </a:cxn>
              <a:cxn ang="0">
                <a:pos x="2468" y="879"/>
              </a:cxn>
              <a:cxn ang="0">
                <a:pos x="2468" y="880"/>
              </a:cxn>
              <a:cxn ang="0">
                <a:pos x="0" y="880"/>
              </a:cxn>
              <a:cxn ang="0">
                <a:pos x="0" y="879"/>
              </a:cxn>
              <a:cxn ang="0">
                <a:pos x="0" y="769"/>
              </a:cxn>
              <a:cxn ang="0">
                <a:pos x="2468" y="769"/>
              </a:cxn>
              <a:cxn ang="0">
                <a:pos x="2468" y="770"/>
              </a:cxn>
              <a:cxn ang="0">
                <a:pos x="0" y="770"/>
              </a:cxn>
              <a:cxn ang="0">
                <a:pos x="0" y="769"/>
              </a:cxn>
              <a:cxn ang="0">
                <a:pos x="0" y="659"/>
              </a:cxn>
              <a:cxn ang="0">
                <a:pos x="2468" y="659"/>
              </a:cxn>
              <a:cxn ang="0">
                <a:pos x="2468" y="660"/>
              </a:cxn>
              <a:cxn ang="0">
                <a:pos x="0" y="660"/>
              </a:cxn>
              <a:cxn ang="0">
                <a:pos x="0" y="659"/>
              </a:cxn>
              <a:cxn ang="0">
                <a:pos x="0" y="550"/>
              </a:cxn>
              <a:cxn ang="0">
                <a:pos x="2468" y="550"/>
              </a:cxn>
              <a:cxn ang="0">
                <a:pos x="2468" y="550"/>
              </a:cxn>
              <a:cxn ang="0">
                <a:pos x="0" y="550"/>
              </a:cxn>
              <a:cxn ang="0">
                <a:pos x="0" y="550"/>
              </a:cxn>
              <a:cxn ang="0">
                <a:pos x="0" y="440"/>
              </a:cxn>
              <a:cxn ang="0">
                <a:pos x="2468" y="440"/>
              </a:cxn>
              <a:cxn ang="0">
                <a:pos x="2468" y="440"/>
              </a:cxn>
              <a:cxn ang="0">
                <a:pos x="0" y="440"/>
              </a:cxn>
              <a:cxn ang="0">
                <a:pos x="0" y="440"/>
              </a:cxn>
              <a:cxn ang="0">
                <a:pos x="0" y="330"/>
              </a:cxn>
              <a:cxn ang="0">
                <a:pos x="2468" y="330"/>
              </a:cxn>
              <a:cxn ang="0">
                <a:pos x="2468" y="331"/>
              </a:cxn>
              <a:cxn ang="0">
                <a:pos x="0" y="331"/>
              </a:cxn>
              <a:cxn ang="0">
                <a:pos x="0" y="330"/>
              </a:cxn>
              <a:cxn ang="0">
                <a:pos x="0" y="220"/>
              </a:cxn>
              <a:cxn ang="0">
                <a:pos x="2468" y="220"/>
              </a:cxn>
              <a:cxn ang="0">
                <a:pos x="2468" y="221"/>
              </a:cxn>
              <a:cxn ang="0">
                <a:pos x="0" y="221"/>
              </a:cxn>
              <a:cxn ang="0">
                <a:pos x="0" y="220"/>
              </a:cxn>
              <a:cxn ang="0">
                <a:pos x="0" y="110"/>
              </a:cxn>
              <a:cxn ang="0">
                <a:pos x="2468" y="110"/>
              </a:cxn>
              <a:cxn ang="0">
                <a:pos x="2468" y="111"/>
              </a:cxn>
              <a:cxn ang="0">
                <a:pos x="0" y="111"/>
              </a:cxn>
              <a:cxn ang="0">
                <a:pos x="0" y="110"/>
              </a:cxn>
              <a:cxn ang="0">
                <a:pos x="0" y="0"/>
              </a:cxn>
              <a:cxn ang="0">
                <a:pos x="2468" y="0"/>
              </a:cxn>
              <a:cxn ang="0">
                <a:pos x="2468" y="1"/>
              </a:cxn>
              <a:cxn ang="0">
                <a:pos x="0" y="1"/>
              </a:cxn>
              <a:cxn ang="0">
                <a:pos x="0" y="0"/>
              </a:cxn>
            </a:cxnLst>
            <a:rect l="0" t="0" r="r" b="b"/>
            <a:pathLst>
              <a:path w="2468" h="880">
                <a:moveTo>
                  <a:pt x="0" y="879"/>
                </a:moveTo>
                <a:lnTo>
                  <a:pt x="2468" y="879"/>
                </a:lnTo>
                <a:lnTo>
                  <a:pt x="2468" y="880"/>
                </a:lnTo>
                <a:lnTo>
                  <a:pt x="0" y="880"/>
                </a:lnTo>
                <a:lnTo>
                  <a:pt x="0" y="879"/>
                </a:lnTo>
                <a:close/>
                <a:moveTo>
                  <a:pt x="0" y="769"/>
                </a:moveTo>
                <a:lnTo>
                  <a:pt x="2468" y="769"/>
                </a:lnTo>
                <a:lnTo>
                  <a:pt x="2468" y="770"/>
                </a:lnTo>
                <a:lnTo>
                  <a:pt x="0" y="770"/>
                </a:lnTo>
                <a:lnTo>
                  <a:pt x="0" y="769"/>
                </a:lnTo>
                <a:close/>
                <a:moveTo>
                  <a:pt x="0" y="659"/>
                </a:moveTo>
                <a:lnTo>
                  <a:pt x="2468" y="659"/>
                </a:lnTo>
                <a:lnTo>
                  <a:pt x="2468" y="660"/>
                </a:lnTo>
                <a:lnTo>
                  <a:pt x="0" y="660"/>
                </a:lnTo>
                <a:lnTo>
                  <a:pt x="0" y="659"/>
                </a:lnTo>
                <a:close/>
                <a:moveTo>
                  <a:pt x="0" y="550"/>
                </a:moveTo>
                <a:lnTo>
                  <a:pt x="2468" y="550"/>
                </a:lnTo>
                <a:lnTo>
                  <a:pt x="2468" y="550"/>
                </a:lnTo>
                <a:lnTo>
                  <a:pt x="0" y="550"/>
                </a:lnTo>
                <a:lnTo>
                  <a:pt x="0" y="550"/>
                </a:lnTo>
                <a:close/>
                <a:moveTo>
                  <a:pt x="0" y="440"/>
                </a:moveTo>
                <a:lnTo>
                  <a:pt x="2468" y="440"/>
                </a:lnTo>
                <a:lnTo>
                  <a:pt x="2468" y="440"/>
                </a:lnTo>
                <a:lnTo>
                  <a:pt x="0" y="440"/>
                </a:lnTo>
                <a:lnTo>
                  <a:pt x="0" y="440"/>
                </a:lnTo>
                <a:close/>
                <a:moveTo>
                  <a:pt x="0" y="330"/>
                </a:moveTo>
                <a:lnTo>
                  <a:pt x="2468" y="330"/>
                </a:lnTo>
                <a:lnTo>
                  <a:pt x="2468" y="331"/>
                </a:lnTo>
                <a:lnTo>
                  <a:pt x="0" y="331"/>
                </a:lnTo>
                <a:lnTo>
                  <a:pt x="0" y="330"/>
                </a:lnTo>
                <a:close/>
                <a:moveTo>
                  <a:pt x="0" y="220"/>
                </a:moveTo>
                <a:lnTo>
                  <a:pt x="2468" y="220"/>
                </a:lnTo>
                <a:lnTo>
                  <a:pt x="2468" y="221"/>
                </a:lnTo>
                <a:lnTo>
                  <a:pt x="0" y="221"/>
                </a:lnTo>
                <a:lnTo>
                  <a:pt x="0" y="220"/>
                </a:lnTo>
                <a:close/>
                <a:moveTo>
                  <a:pt x="0" y="110"/>
                </a:moveTo>
                <a:lnTo>
                  <a:pt x="2468" y="110"/>
                </a:lnTo>
                <a:lnTo>
                  <a:pt x="2468" y="111"/>
                </a:lnTo>
                <a:lnTo>
                  <a:pt x="0" y="111"/>
                </a:lnTo>
                <a:lnTo>
                  <a:pt x="0" y="110"/>
                </a:lnTo>
                <a:close/>
                <a:moveTo>
                  <a:pt x="0" y="0"/>
                </a:moveTo>
                <a:lnTo>
                  <a:pt x="2468" y="0"/>
                </a:lnTo>
                <a:lnTo>
                  <a:pt x="2468" y="1"/>
                </a:lnTo>
                <a:lnTo>
                  <a:pt x="0" y="1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06" name="Freeform 882"/>
          <p:cNvSpPr>
            <a:spLocks noEditPoints="1"/>
          </p:cNvSpPr>
          <p:nvPr/>
        </p:nvSpPr>
        <p:spPr bwMode="auto">
          <a:xfrm>
            <a:off x="2027960" y="6610493"/>
            <a:ext cx="2620239" cy="1109256"/>
          </a:xfrm>
          <a:custGeom>
            <a:avLst/>
            <a:gdLst/>
            <a:ahLst/>
            <a:cxnLst>
              <a:cxn ang="0">
                <a:pos x="0" y="20"/>
              </a:cxn>
              <a:cxn ang="0">
                <a:pos x="20" y="0"/>
              </a:cxn>
              <a:cxn ang="0">
                <a:pos x="22044" y="0"/>
              </a:cxn>
              <a:cxn ang="0">
                <a:pos x="22064" y="20"/>
              </a:cxn>
              <a:cxn ang="0">
                <a:pos x="22064" y="8512"/>
              </a:cxn>
              <a:cxn ang="0">
                <a:pos x="22044" y="8532"/>
              </a:cxn>
              <a:cxn ang="0">
                <a:pos x="20" y="8532"/>
              </a:cxn>
              <a:cxn ang="0">
                <a:pos x="0" y="8512"/>
              </a:cxn>
              <a:cxn ang="0">
                <a:pos x="0" y="20"/>
              </a:cxn>
              <a:cxn ang="0">
                <a:pos x="40" y="8512"/>
              </a:cxn>
              <a:cxn ang="0">
                <a:pos x="20" y="8492"/>
              </a:cxn>
              <a:cxn ang="0">
                <a:pos x="22044" y="8492"/>
              </a:cxn>
              <a:cxn ang="0">
                <a:pos x="22024" y="8512"/>
              </a:cxn>
              <a:cxn ang="0">
                <a:pos x="22024" y="20"/>
              </a:cxn>
              <a:cxn ang="0">
                <a:pos x="22044" y="40"/>
              </a:cxn>
              <a:cxn ang="0">
                <a:pos x="20" y="40"/>
              </a:cxn>
              <a:cxn ang="0">
                <a:pos x="40" y="20"/>
              </a:cxn>
              <a:cxn ang="0">
                <a:pos x="40" y="8512"/>
              </a:cxn>
            </a:cxnLst>
            <a:rect l="0" t="0" r="r" b="b"/>
            <a:pathLst>
              <a:path w="22064" h="8532">
                <a:moveTo>
                  <a:pt x="0" y="20"/>
                </a:moveTo>
                <a:cubicBezTo>
                  <a:pt x="0" y="9"/>
                  <a:pt x="9" y="0"/>
                  <a:pt x="20" y="0"/>
                </a:cubicBezTo>
                <a:lnTo>
                  <a:pt x="22044" y="0"/>
                </a:lnTo>
                <a:cubicBezTo>
                  <a:pt x="22056" y="0"/>
                  <a:pt x="22064" y="9"/>
                  <a:pt x="22064" y="20"/>
                </a:cubicBezTo>
                <a:lnTo>
                  <a:pt x="22064" y="8512"/>
                </a:lnTo>
                <a:cubicBezTo>
                  <a:pt x="22064" y="8524"/>
                  <a:pt x="22056" y="8532"/>
                  <a:pt x="22044" y="8532"/>
                </a:cubicBezTo>
                <a:lnTo>
                  <a:pt x="20" y="8532"/>
                </a:lnTo>
                <a:cubicBezTo>
                  <a:pt x="9" y="8532"/>
                  <a:pt x="0" y="8524"/>
                  <a:pt x="0" y="8512"/>
                </a:cubicBezTo>
                <a:lnTo>
                  <a:pt x="0" y="20"/>
                </a:lnTo>
                <a:close/>
                <a:moveTo>
                  <a:pt x="40" y="8512"/>
                </a:moveTo>
                <a:lnTo>
                  <a:pt x="20" y="8492"/>
                </a:lnTo>
                <a:lnTo>
                  <a:pt x="22044" y="8492"/>
                </a:lnTo>
                <a:lnTo>
                  <a:pt x="22024" y="8512"/>
                </a:lnTo>
                <a:lnTo>
                  <a:pt x="22024" y="20"/>
                </a:lnTo>
                <a:lnTo>
                  <a:pt x="22044" y="40"/>
                </a:lnTo>
                <a:lnTo>
                  <a:pt x="20" y="40"/>
                </a:lnTo>
                <a:lnTo>
                  <a:pt x="40" y="20"/>
                </a:lnTo>
                <a:lnTo>
                  <a:pt x="40" y="8512"/>
                </a:lnTo>
                <a:close/>
              </a:path>
            </a:pathLst>
          </a:custGeom>
          <a:solidFill>
            <a:srgbClr val="808080"/>
          </a:solidFill>
          <a:ln w="0" cap="flat">
            <a:solidFill>
              <a:srgbClr val="80808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07" name="Rectangle 883"/>
          <p:cNvSpPr>
            <a:spLocks noChangeArrowheads="1"/>
          </p:cNvSpPr>
          <p:nvPr/>
        </p:nvSpPr>
        <p:spPr bwMode="auto">
          <a:xfrm>
            <a:off x="2052329" y="7513297"/>
            <a:ext cx="43441" cy="203103"/>
          </a:xfrm>
          <a:prstGeom prst="rect">
            <a:avLst/>
          </a:prstGeom>
          <a:solidFill>
            <a:srgbClr val="9999FF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08" name="Freeform 884"/>
          <p:cNvSpPr>
            <a:spLocks noEditPoints="1"/>
          </p:cNvSpPr>
          <p:nvPr/>
        </p:nvSpPr>
        <p:spPr bwMode="auto">
          <a:xfrm>
            <a:off x="2050210" y="7511065"/>
            <a:ext cx="48739" cy="208683"/>
          </a:xfrm>
          <a:custGeom>
            <a:avLst/>
            <a:gdLst/>
            <a:ahLst/>
            <a:cxnLst>
              <a:cxn ang="0">
                <a:pos x="0" y="40"/>
              </a:cxn>
              <a:cxn ang="0">
                <a:pos x="40" y="0"/>
              </a:cxn>
              <a:cxn ang="0">
                <a:pos x="776" y="0"/>
              </a:cxn>
              <a:cxn ang="0">
                <a:pos x="816" y="40"/>
              </a:cxn>
              <a:cxn ang="0">
                <a:pos x="816" y="3168"/>
              </a:cxn>
              <a:cxn ang="0">
                <a:pos x="776" y="3208"/>
              </a:cxn>
              <a:cxn ang="0">
                <a:pos x="40" y="3208"/>
              </a:cxn>
              <a:cxn ang="0">
                <a:pos x="0" y="3168"/>
              </a:cxn>
              <a:cxn ang="0">
                <a:pos x="0" y="40"/>
              </a:cxn>
              <a:cxn ang="0">
                <a:pos x="80" y="3168"/>
              </a:cxn>
              <a:cxn ang="0">
                <a:pos x="40" y="3128"/>
              </a:cxn>
              <a:cxn ang="0">
                <a:pos x="776" y="3128"/>
              </a:cxn>
              <a:cxn ang="0">
                <a:pos x="736" y="3168"/>
              </a:cxn>
              <a:cxn ang="0">
                <a:pos x="736" y="40"/>
              </a:cxn>
              <a:cxn ang="0">
                <a:pos x="776" y="80"/>
              </a:cxn>
              <a:cxn ang="0">
                <a:pos x="40" y="80"/>
              </a:cxn>
              <a:cxn ang="0">
                <a:pos x="80" y="40"/>
              </a:cxn>
              <a:cxn ang="0">
                <a:pos x="80" y="3168"/>
              </a:cxn>
            </a:cxnLst>
            <a:rect l="0" t="0" r="r" b="b"/>
            <a:pathLst>
              <a:path w="816" h="3208">
                <a:moveTo>
                  <a:pt x="0" y="40"/>
                </a:moveTo>
                <a:cubicBezTo>
                  <a:pt x="0" y="18"/>
                  <a:pt x="18" y="0"/>
                  <a:pt x="40" y="0"/>
                </a:cubicBezTo>
                <a:lnTo>
                  <a:pt x="776" y="0"/>
                </a:lnTo>
                <a:cubicBezTo>
                  <a:pt x="799" y="0"/>
                  <a:pt x="816" y="18"/>
                  <a:pt x="816" y="40"/>
                </a:cubicBezTo>
                <a:lnTo>
                  <a:pt x="816" y="3168"/>
                </a:lnTo>
                <a:cubicBezTo>
                  <a:pt x="816" y="3191"/>
                  <a:pt x="799" y="3208"/>
                  <a:pt x="776" y="3208"/>
                </a:cubicBezTo>
                <a:lnTo>
                  <a:pt x="40" y="3208"/>
                </a:lnTo>
                <a:cubicBezTo>
                  <a:pt x="18" y="3208"/>
                  <a:pt x="0" y="3191"/>
                  <a:pt x="0" y="3168"/>
                </a:cubicBezTo>
                <a:lnTo>
                  <a:pt x="0" y="40"/>
                </a:lnTo>
                <a:close/>
                <a:moveTo>
                  <a:pt x="80" y="3168"/>
                </a:moveTo>
                <a:lnTo>
                  <a:pt x="40" y="3128"/>
                </a:lnTo>
                <a:lnTo>
                  <a:pt x="776" y="3128"/>
                </a:lnTo>
                <a:lnTo>
                  <a:pt x="736" y="3168"/>
                </a:lnTo>
                <a:lnTo>
                  <a:pt x="736" y="40"/>
                </a:lnTo>
                <a:lnTo>
                  <a:pt x="776" y="80"/>
                </a:lnTo>
                <a:lnTo>
                  <a:pt x="40" y="80"/>
                </a:lnTo>
                <a:lnTo>
                  <a:pt x="80" y="40"/>
                </a:lnTo>
                <a:lnTo>
                  <a:pt x="80" y="3168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09" name="Rectangle 885"/>
          <p:cNvSpPr>
            <a:spLocks noChangeArrowheads="1"/>
          </p:cNvSpPr>
          <p:nvPr/>
        </p:nvSpPr>
        <p:spPr bwMode="auto">
          <a:xfrm>
            <a:off x="2183712" y="6813596"/>
            <a:ext cx="43441" cy="902805"/>
          </a:xfrm>
          <a:prstGeom prst="rect">
            <a:avLst/>
          </a:prstGeom>
          <a:solidFill>
            <a:srgbClr val="9999FF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10" name="Freeform 886"/>
          <p:cNvSpPr>
            <a:spLocks noEditPoints="1"/>
          </p:cNvSpPr>
          <p:nvPr/>
        </p:nvSpPr>
        <p:spPr bwMode="auto">
          <a:xfrm>
            <a:off x="2181593" y="6811364"/>
            <a:ext cx="47680" cy="908385"/>
          </a:xfrm>
          <a:custGeom>
            <a:avLst/>
            <a:gdLst/>
            <a:ahLst/>
            <a:cxnLst>
              <a:cxn ang="0">
                <a:pos x="0" y="40"/>
              </a:cxn>
              <a:cxn ang="0">
                <a:pos x="40" y="0"/>
              </a:cxn>
              <a:cxn ang="0">
                <a:pos x="768" y="0"/>
              </a:cxn>
              <a:cxn ang="0">
                <a:pos x="808" y="40"/>
              </a:cxn>
              <a:cxn ang="0">
                <a:pos x="808" y="13936"/>
              </a:cxn>
              <a:cxn ang="0">
                <a:pos x="768" y="13976"/>
              </a:cxn>
              <a:cxn ang="0">
                <a:pos x="40" y="13976"/>
              </a:cxn>
              <a:cxn ang="0">
                <a:pos x="0" y="13936"/>
              </a:cxn>
              <a:cxn ang="0">
                <a:pos x="0" y="40"/>
              </a:cxn>
              <a:cxn ang="0">
                <a:pos x="80" y="13936"/>
              </a:cxn>
              <a:cxn ang="0">
                <a:pos x="40" y="13896"/>
              </a:cxn>
              <a:cxn ang="0">
                <a:pos x="768" y="13896"/>
              </a:cxn>
              <a:cxn ang="0">
                <a:pos x="728" y="13936"/>
              </a:cxn>
              <a:cxn ang="0">
                <a:pos x="728" y="40"/>
              </a:cxn>
              <a:cxn ang="0">
                <a:pos x="768" y="80"/>
              </a:cxn>
              <a:cxn ang="0">
                <a:pos x="40" y="80"/>
              </a:cxn>
              <a:cxn ang="0">
                <a:pos x="80" y="40"/>
              </a:cxn>
              <a:cxn ang="0">
                <a:pos x="80" y="13936"/>
              </a:cxn>
            </a:cxnLst>
            <a:rect l="0" t="0" r="r" b="b"/>
            <a:pathLst>
              <a:path w="808" h="13976">
                <a:moveTo>
                  <a:pt x="0" y="40"/>
                </a:moveTo>
                <a:cubicBezTo>
                  <a:pt x="0" y="18"/>
                  <a:pt x="18" y="0"/>
                  <a:pt x="40" y="0"/>
                </a:cubicBezTo>
                <a:lnTo>
                  <a:pt x="768" y="0"/>
                </a:lnTo>
                <a:cubicBezTo>
                  <a:pt x="791" y="0"/>
                  <a:pt x="808" y="18"/>
                  <a:pt x="808" y="40"/>
                </a:cubicBezTo>
                <a:lnTo>
                  <a:pt x="808" y="13936"/>
                </a:lnTo>
                <a:cubicBezTo>
                  <a:pt x="808" y="13959"/>
                  <a:pt x="791" y="13976"/>
                  <a:pt x="768" y="13976"/>
                </a:cubicBezTo>
                <a:lnTo>
                  <a:pt x="40" y="13976"/>
                </a:lnTo>
                <a:cubicBezTo>
                  <a:pt x="18" y="13976"/>
                  <a:pt x="0" y="13959"/>
                  <a:pt x="0" y="13936"/>
                </a:cubicBezTo>
                <a:lnTo>
                  <a:pt x="0" y="40"/>
                </a:lnTo>
                <a:close/>
                <a:moveTo>
                  <a:pt x="80" y="13936"/>
                </a:moveTo>
                <a:lnTo>
                  <a:pt x="40" y="13896"/>
                </a:lnTo>
                <a:lnTo>
                  <a:pt x="768" y="13896"/>
                </a:lnTo>
                <a:lnTo>
                  <a:pt x="728" y="13936"/>
                </a:lnTo>
                <a:lnTo>
                  <a:pt x="728" y="40"/>
                </a:lnTo>
                <a:lnTo>
                  <a:pt x="768" y="80"/>
                </a:lnTo>
                <a:lnTo>
                  <a:pt x="40" y="80"/>
                </a:lnTo>
                <a:lnTo>
                  <a:pt x="80" y="40"/>
                </a:lnTo>
                <a:lnTo>
                  <a:pt x="80" y="13936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11" name="Rectangle 887"/>
          <p:cNvSpPr>
            <a:spLocks noChangeArrowheads="1"/>
          </p:cNvSpPr>
          <p:nvPr/>
        </p:nvSpPr>
        <p:spPr bwMode="auto">
          <a:xfrm>
            <a:off x="2314035" y="7478703"/>
            <a:ext cx="43441" cy="237697"/>
          </a:xfrm>
          <a:prstGeom prst="rect">
            <a:avLst/>
          </a:prstGeom>
          <a:solidFill>
            <a:srgbClr val="9999FF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12" name="Freeform 888"/>
          <p:cNvSpPr>
            <a:spLocks noEditPoints="1"/>
          </p:cNvSpPr>
          <p:nvPr/>
        </p:nvSpPr>
        <p:spPr bwMode="auto">
          <a:xfrm>
            <a:off x="2311916" y="7475355"/>
            <a:ext cx="48739" cy="244393"/>
          </a:xfrm>
          <a:custGeom>
            <a:avLst/>
            <a:gdLst/>
            <a:ahLst/>
            <a:cxnLst>
              <a:cxn ang="0">
                <a:pos x="0" y="40"/>
              </a:cxn>
              <a:cxn ang="0">
                <a:pos x="40" y="0"/>
              </a:cxn>
              <a:cxn ang="0">
                <a:pos x="776" y="0"/>
              </a:cxn>
              <a:cxn ang="0">
                <a:pos x="816" y="40"/>
              </a:cxn>
              <a:cxn ang="0">
                <a:pos x="816" y="3712"/>
              </a:cxn>
              <a:cxn ang="0">
                <a:pos x="776" y="3752"/>
              </a:cxn>
              <a:cxn ang="0">
                <a:pos x="40" y="3752"/>
              </a:cxn>
              <a:cxn ang="0">
                <a:pos x="0" y="3712"/>
              </a:cxn>
              <a:cxn ang="0">
                <a:pos x="0" y="40"/>
              </a:cxn>
              <a:cxn ang="0">
                <a:pos x="80" y="3712"/>
              </a:cxn>
              <a:cxn ang="0">
                <a:pos x="40" y="3672"/>
              </a:cxn>
              <a:cxn ang="0">
                <a:pos x="776" y="3672"/>
              </a:cxn>
              <a:cxn ang="0">
                <a:pos x="736" y="3712"/>
              </a:cxn>
              <a:cxn ang="0">
                <a:pos x="736" y="40"/>
              </a:cxn>
              <a:cxn ang="0">
                <a:pos x="776" y="80"/>
              </a:cxn>
              <a:cxn ang="0">
                <a:pos x="40" y="80"/>
              </a:cxn>
              <a:cxn ang="0">
                <a:pos x="80" y="40"/>
              </a:cxn>
              <a:cxn ang="0">
                <a:pos x="80" y="3712"/>
              </a:cxn>
            </a:cxnLst>
            <a:rect l="0" t="0" r="r" b="b"/>
            <a:pathLst>
              <a:path w="816" h="3752">
                <a:moveTo>
                  <a:pt x="0" y="40"/>
                </a:moveTo>
                <a:cubicBezTo>
                  <a:pt x="0" y="18"/>
                  <a:pt x="18" y="0"/>
                  <a:pt x="40" y="0"/>
                </a:cubicBezTo>
                <a:lnTo>
                  <a:pt x="776" y="0"/>
                </a:lnTo>
                <a:cubicBezTo>
                  <a:pt x="799" y="0"/>
                  <a:pt x="816" y="18"/>
                  <a:pt x="816" y="40"/>
                </a:cubicBezTo>
                <a:lnTo>
                  <a:pt x="816" y="3712"/>
                </a:lnTo>
                <a:cubicBezTo>
                  <a:pt x="816" y="3735"/>
                  <a:pt x="799" y="3752"/>
                  <a:pt x="776" y="3752"/>
                </a:cubicBezTo>
                <a:lnTo>
                  <a:pt x="40" y="3752"/>
                </a:lnTo>
                <a:cubicBezTo>
                  <a:pt x="18" y="3752"/>
                  <a:pt x="0" y="3735"/>
                  <a:pt x="0" y="3712"/>
                </a:cubicBezTo>
                <a:lnTo>
                  <a:pt x="0" y="40"/>
                </a:lnTo>
                <a:close/>
                <a:moveTo>
                  <a:pt x="80" y="3712"/>
                </a:moveTo>
                <a:lnTo>
                  <a:pt x="40" y="3672"/>
                </a:lnTo>
                <a:lnTo>
                  <a:pt x="776" y="3672"/>
                </a:lnTo>
                <a:lnTo>
                  <a:pt x="736" y="3712"/>
                </a:lnTo>
                <a:lnTo>
                  <a:pt x="736" y="40"/>
                </a:lnTo>
                <a:lnTo>
                  <a:pt x="776" y="80"/>
                </a:lnTo>
                <a:lnTo>
                  <a:pt x="40" y="80"/>
                </a:lnTo>
                <a:lnTo>
                  <a:pt x="80" y="40"/>
                </a:lnTo>
                <a:lnTo>
                  <a:pt x="80" y="3712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13" name="Rectangle 889"/>
          <p:cNvSpPr>
            <a:spLocks noChangeArrowheads="1"/>
          </p:cNvSpPr>
          <p:nvPr/>
        </p:nvSpPr>
        <p:spPr bwMode="auto">
          <a:xfrm>
            <a:off x="2444358" y="7398355"/>
            <a:ext cx="44501" cy="318046"/>
          </a:xfrm>
          <a:prstGeom prst="rect">
            <a:avLst/>
          </a:prstGeom>
          <a:solidFill>
            <a:srgbClr val="9999FF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14" name="Freeform 890"/>
          <p:cNvSpPr>
            <a:spLocks noEditPoints="1"/>
          </p:cNvSpPr>
          <p:nvPr/>
        </p:nvSpPr>
        <p:spPr bwMode="auto">
          <a:xfrm>
            <a:off x="2442239" y="7396123"/>
            <a:ext cx="48739" cy="323626"/>
          </a:xfrm>
          <a:custGeom>
            <a:avLst/>
            <a:gdLst/>
            <a:ahLst/>
            <a:cxnLst>
              <a:cxn ang="0">
                <a:pos x="0" y="40"/>
              </a:cxn>
              <a:cxn ang="0">
                <a:pos x="40" y="0"/>
              </a:cxn>
              <a:cxn ang="0">
                <a:pos x="776" y="0"/>
              </a:cxn>
              <a:cxn ang="0">
                <a:pos x="816" y="40"/>
              </a:cxn>
              <a:cxn ang="0">
                <a:pos x="816" y="4936"/>
              </a:cxn>
              <a:cxn ang="0">
                <a:pos x="776" y="4976"/>
              </a:cxn>
              <a:cxn ang="0">
                <a:pos x="40" y="4976"/>
              </a:cxn>
              <a:cxn ang="0">
                <a:pos x="0" y="4936"/>
              </a:cxn>
              <a:cxn ang="0">
                <a:pos x="0" y="40"/>
              </a:cxn>
              <a:cxn ang="0">
                <a:pos x="80" y="4936"/>
              </a:cxn>
              <a:cxn ang="0">
                <a:pos x="40" y="4896"/>
              </a:cxn>
              <a:cxn ang="0">
                <a:pos x="776" y="4896"/>
              </a:cxn>
              <a:cxn ang="0">
                <a:pos x="736" y="4936"/>
              </a:cxn>
              <a:cxn ang="0">
                <a:pos x="736" y="40"/>
              </a:cxn>
              <a:cxn ang="0">
                <a:pos x="776" y="80"/>
              </a:cxn>
              <a:cxn ang="0">
                <a:pos x="40" y="80"/>
              </a:cxn>
              <a:cxn ang="0">
                <a:pos x="80" y="40"/>
              </a:cxn>
              <a:cxn ang="0">
                <a:pos x="80" y="4936"/>
              </a:cxn>
            </a:cxnLst>
            <a:rect l="0" t="0" r="r" b="b"/>
            <a:pathLst>
              <a:path w="816" h="4976">
                <a:moveTo>
                  <a:pt x="0" y="40"/>
                </a:moveTo>
                <a:cubicBezTo>
                  <a:pt x="0" y="18"/>
                  <a:pt x="18" y="0"/>
                  <a:pt x="40" y="0"/>
                </a:cubicBezTo>
                <a:lnTo>
                  <a:pt x="776" y="0"/>
                </a:lnTo>
                <a:cubicBezTo>
                  <a:pt x="799" y="0"/>
                  <a:pt x="816" y="18"/>
                  <a:pt x="816" y="40"/>
                </a:cubicBezTo>
                <a:lnTo>
                  <a:pt x="816" y="4936"/>
                </a:lnTo>
                <a:cubicBezTo>
                  <a:pt x="816" y="4959"/>
                  <a:pt x="799" y="4976"/>
                  <a:pt x="776" y="4976"/>
                </a:cubicBezTo>
                <a:lnTo>
                  <a:pt x="40" y="4976"/>
                </a:lnTo>
                <a:cubicBezTo>
                  <a:pt x="18" y="4976"/>
                  <a:pt x="0" y="4959"/>
                  <a:pt x="0" y="4936"/>
                </a:cubicBezTo>
                <a:lnTo>
                  <a:pt x="0" y="40"/>
                </a:lnTo>
                <a:close/>
                <a:moveTo>
                  <a:pt x="80" y="4936"/>
                </a:moveTo>
                <a:lnTo>
                  <a:pt x="40" y="4896"/>
                </a:lnTo>
                <a:lnTo>
                  <a:pt x="776" y="4896"/>
                </a:lnTo>
                <a:lnTo>
                  <a:pt x="736" y="4936"/>
                </a:lnTo>
                <a:lnTo>
                  <a:pt x="736" y="40"/>
                </a:lnTo>
                <a:lnTo>
                  <a:pt x="776" y="80"/>
                </a:lnTo>
                <a:lnTo>
                  <a:pt x="40" y="80"/>
                </a:lnTo>
                <a:lnTo>
                  <a:pt x="80" y="40"/>
                </a:lnTo>
                <a:lnTo>
                  <a:pt x="80" y="4936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15" name="Rectangle 891"/>
          <p:cNvSpPr>
            <a:spLocks noChangeArrowheads="1"/>
          </p:cNvSpPr>
          <p:nvPr/>
        </p:nvSpPr>
        <p:spPr bwMode="auto">
          <a:xfrm>
            <a:off x="2575741" y="6724320"/>
            <a:ext cx="43441" cy="992081"/>
          </a:xfrm>
          <a:prstGeom prst="rect">
            <a:avLst/>
          </a:prstGeom>
          <a:solidFill>
            <a:srgbClr val="9999FF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16" name="Freeform 892"/>
          <p:cNvSpPr>
            <a:spLocks noEditPoints="1"/>
          </p:cNvSpPr>
          <p:nvPr/>
        </p:nvSpPr>
        <p:spPr bwMode="auto">
          <a:xfrm>
            <a:off x="2573622" y="6722088"/>
            <a:ext cx="47680" cy="997661"/>
          </a:xfrm>
          <a:custGeom>
            <a:avLst/>
            <a:gdLst/>
            <a:ahLst/>
            <a:cxnLst>
              <a:cxn ang="0">
                <a:pos x="0" y="40"/>
              </a:cxn>
              <a:cxn ang="0">
                <a:pos x="40" y="0"/>
              </a:cxn>
              <a:cxn ang="0">
                <a:pos x="776" y="0"/>
              </a:cxn>
              <a:cxn ang="0">
                <a:pos x="816" y="40"/>
              </a:cxn>
              <a:cxn ang="0">
                <a:pos x="816" y="15304"/>
              </a:cxn>
              <a:cxn ang="0">
                <a:pos x="776" y="15344"/>
              </a:cxn>
              <a:cxn ang="0">
                <a:pos x="40" y="15344"/>
              </a:cxn>
              <a:cxn ang="0">
                <a:pos x="0" y="15304"/>
              </a:cxn>
              <a:cxn ang="0">
                <a:pos x="0" y="40"/>
              </a:cxn>
              <a:cxn ang="0">
                <a:pos x="80" y="15304"/>
              </a:cxn>
              <a:cxn ang="0">
                <a:pos x="40" y="15264"/>
              </a:cxn>
              <a:cxn ang="0">
                <a:pos x="776" y="15264"/>
              </a:cxn>
              <a:cxn ang="0">
                <a:pos x="736" y="15304"/>
              </a:cxn>
              <a:cxn ang="0">
                <a:pos x="736" y="40"/>
              </a:cxn>
              <a:cxn ang="0">
                <a:pos x="776" y="80"/>
              </a:cxn>
              <a:cxn ang="0">
                <a:pos x="40" y="80"/>
              </a:cxn>
              <a:cxn ang="0">
                <a:pos x="80" y="40"/>
              </a:cxn>
              <a:cxn ang="0">
                <a:pos x="80" y="15304"/>
              </a:cxn>
            </a:cxnLst>
            <a:rect l="0" t="0" r="r" b="b"/>
            <a:pathLst>
              <a:path w="816" h="15344">
                <a:moveTo>
                  <a:pt x="0" y="40"/>
                </a:moveTo>
                <a:cubicBezTo>
                  <a:pt x="0" y="18"/>
                  <a:pt x="18" y="0"/>
                  <a:pt x="40" y="0"/>
                </a:cubicBezTo>
                <a:lnTo>
                  <a:pt x="776" y="0"/>
                </a:lnTo>
                <a:cubicBezTo>
                  <a:pt x="799" y="0"/>
                  <a:pt x="816" y="18"/>
                  <a:pt x="816" y="40"/>
                </a:cubicBezTo>
                <a:lnTo>
                  <a:pt x="816" y="15304"/>
                </a:lnTo>
                <a:cubicBezTo>
                  <a:pt x="816" y="15327"/>
                  <a:pt x="799" y="15344"/>
                  <a:pt x="776" y="15344"/>
                </a:cubicBezTo>
                <a:lnTo>
                  <a:pt x="40" y="15344"/>
                </a:lnTo>
                <a:cubicBezTo>
                  <a:pt x="18" y="15344"/>
                  <a:pt x="0" y="15327"/>
                  <a:pt x="0" y="15304"/>
                </a:cubicBezTo>
                <a:lnTo>
                  <a:pt x="0" y="40"/>
                </a:lnTo>
                <a:close/>
                <a:moveTo>
                  <a:pt x="80" y="15304"/>
                </a:moveTo>
                <a:lnTo>
                  <a:pt x="40" y="15264"/>
                </a:lnTo>
                <a:lnTo>
                  <a:pt x="776" y="15264"/>
                </a:lnTo>
                <a:lnTo>
                  <a:pt x="736" y="15304"/>
                </a:lnTo>
                <a:lnTo>
                  <a:pt x="736" y="40"/>
                </a:lnTo>
                <a:lnTo>
                  <a:pt x="776" y="80"/>
                </a:lnTo>
                <a:lnTo>
                  <a:pt x="40" y="80"/>
                </a:lnTo>
                <a:lnTo>
                  <a:pt x="80" y="40"/>
                </a:lnTo>
                <a:lnTo>
                  <a:pt x="80" y="15304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17" name="Rectangle 893"/>
          <p:cNvSpPr>
            <a:spLocks noChangeArrowheads="1"/>
          </p:cNvSpPr>
          <p:nvPr/>
        </p:nvSpPr>
        <p:spPr bwMode="auto">
          <a:xfrm>
            <a:off x="2706065" y="7662835"/>
            <a:ext cx="43441" cy="53566"/>
          </a:xfrm>
          <a:prstGeom prst="rect">
            <a:avLst/>
          </a:prstGeom>
          <a:solidFill>
            <a:srgbClr val="9999FF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18" name="Freeform 894"/>
          <p:cNvSpPr>
            <a:spLocks noEditPoints="1"/>
          </p:cNvSpPr>
          <p:nvPr/>
        </p:nvSpPr>
        <p:spPr bwMode="auto">
          <a:xfrm>
            <a:off x="2703946" y="7660603"/>
            <a:ext cx="48739" cy="59145"/>
          </a:xfrm>
          <a:custGeom>
            <a:avLst/>
            <a:gdLst/>
            <a:ahLst/>
            <a:cxnLst>
              <a:cxn ang="0">
                <a:pos x="0" y="40"/>
              </a:cxn>
              <a:cxn ang="0">
                <a:pos x="40" y="0"/>
              </a:cxn>
              <a:cxn ang="0">
                <a:pos x="768" y="0"/>
              </a:cxn>
              <a:cxn ang="0">
                <a:pos x="808" y="40"/>
              </a:cxn>
              <a:cxn ang="0">
                <a:pos x="808" y="864"/>
              </a:cxn>
              <a:cxn ang="0">
                <a:pos x="768" y="904"/>
              </a:cxn>
              <a:cxn ang="0">
                <a:pos x="40" y="904"/>
              </a:cxn>
              <a:cxn ang="0">
                <a:pos x="0" y="864"/>
              </a:cxn>
              <a:cxn ang="0">
                <a:pos x="0" y="40"/>
              </a:cxn>
              <a:cxn ang="0">
                <a:pos x="80" y="864"/>
              </a:cxn>
              <a:cxn ang="0">
                <a:pos x="40" y="824"/>
              </a:cxn>
              <a:cxn ang="0">
                <a:pos x="768" y="824"/>
              </a:cxn>
              <a:cxn ang="0">
                <a:pos x="728" y="864"/>
              </a:cxn>
              <a:cxn ang="0">
                <a:pos x="728" y="40"/>
              </a:cxn>
              <a:cxn ang="0">
                <a:pos x="768" y="80"/>
              </a:cxn>
              <a:cxn ang="0">
                <a:pos x="40" y="80"/>
              </a:cxn>
              <a:cxn ang="0">
                <a:pos x="80" y="40"/>
              </a:cxn>
              <a:cxn ang="0">
                <a:pos x="80" y="864"/>
              </a:cxn>
            </a:cxnLst>
            <a:rect l="0" t="0" r="r" b="b"/>
            <a:pathLst>
              <a:path w="808" h="904">
                <a:moveTo>
                  <a:pt x="0" y="40"/>
                </a:moveTo>
                <a:cubicBezTo>
                  <a:pt x="0" y="18"/>
                  <a:pt x="18" y="0"/>
                  <a:pt x="40" y="0"/>
                </a:cubicBezTo>
                <a:lnTo>
                  <a:pt x="768" y="0"/>
                </a:lnTo>
                <a:cubicBezTo>
                  <a:pt x="791" y="0"/>
                  <a:pt x="808" y="18"/>
                  <a:pt x="808" y="40"/>
                </a:cubicBezTo>
                <a:lnTo>
                  <a:pt x="808" y="864"/>
                </a:lnTo>
                <a:cubicBezTo>
                  <a:pt x="808" y="887"/>
                  <a:pt x="791" y="904"/>
                  <a:pt x="768" y="904"/>
                </a:cubicBezTo>
                <a:lnTo>
                  <a:pt x="40" y="904"/>
                </a:lnTo>
                <a:cubicBezTo>
                  <a:pt x="18" y="904"/>
                  <a:pt x="0" y="887"/>
                  <a:pt x="0" y="864"/>
                </a:cubicBezTo>
                <a:lnTo>
                  <a:pt x="0" y="40"/>
                </a:lnTo>
                <a:close/>
                <a:moveTo>
                  <a:pt x="80" y="864"/>
                </a:moveTo>
                <a:lnTo>
                  <a:pt x="40" y="824"/>
                </a:lnTo>
                <a:lnTo>
                  <a:pt x="768" y="824"/>
                </a:lnTo>
                <a:lnTo>
                  <a:pt x="728" y="864"/>
                </a:lnTo>
                <a:lnTo>
                  <a:pt x="728" y="40"/>
                </a:lnTo>
                <a:lnTo>
                  <a:pt x="768" y="80"/>
                </a:lnTo>
                <a:lnTo>
                  <a:pt x="40" y="80"/>
                </a:lnTo>
                <a:lnTo>
                  <a:pt x="80" y="40"/>
                </a:lnTo>
                <a:lnTo>
                  <a:pt x="80" y="864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19" name="Rectangle 895"/>
          <p:cNvSpPr>
            <a:spLocks noChangeArrowheads="1"/>
          </p:cNvSpPr>
          <p:nvPr/>
        </p:nvSpPr>
        <p:spPr bwMode="auto">
          <a:xfrm>
            <a:off x="2837447" y="7402818"/>
            <a:ext cx="43441" cy="313582"/>
          </a:xfrm>
          <a:prstGeom prst="rect">
            <a:avLst/>
          </a:prstGeom>
          <a:solidFill>
            <a:srgbClr val="9999FF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20" name="Freeform 896"/>
          <p:cNvSpPr>
            <a:spLocks noEditPoints="1"/>
          </p:cNvSpPr>
          <p:nvPr/>
        </p:nvSpPr>
        <p:spPr bwMode="auto">
          <a:xfrm>
            <a:off x="2835328" y="7400586"/>
            <a:ext cx="47680" cy="319162"/>
          </a:xfrm>
          <a:custGeom>
            <a:avLst/>
            <a:gdLst/>
            <a:ahLst/>
            <a:cxnLst>
              <a:cxn ang="0">
                <a:pos x="0" y="40"/>
              </a:cxn>
              <a:cxn ang="0">
                <a:pos x="40" y="0"/>
              </a:cxn>
              <a:cxn ang="0">
                <a:pos x="776" y="0"/>
              </a:cxn>
              <a:cxn ang="0">
                <a:pos x="816" y="40"/>
              </a:cxn>
              <a:cxn ang="0">
                <a:pos x="816" y="4864"/>
              </a:cxn>
              <a:cxn ang="0">
                <a:pos x="776" y="4904"/>
              </a:cxn>
              <a:cxn ang="0">
                <a:pos x="40" y="4904"/>
              </a:cxn>
              <a:cxn ang="0">
                <a:pos x="0" y="4864"/>
              </a:cxn>
              <a:cxn ang="0">
                <a:pos x="0" y="40"/>
              </a:cxn>
              <a:cxn ang="0">
                <a:pos x="80" y="4864"/>
              </a:cxn>
              <a:cxn ang="0">
                <a:pos x="40" y="4824"/>
              </a:cxn>
              <a:cxn ang="0">
                <a:pos x="776" y="4824"/>
              </a:cxn>
              <a:cxn ang="0">
                <a:pos x="736" y="4864"/>
              </a:cxn>
              <a:cxn ang="0">
                <a:pos x="736" y="40"/>
              </a:cxn>
              <a:cxn ang="0">
                <a:pos x="776" y="80"/>
              </a:cxn>
              <a:cxn ang="0">
                <a:pos x="40" y="80"/>
              </a:cxn>
              <a:cxn ang="0">
                <a:pos x="80" y="40"/>
              </a:cxn>
              <a:cxn ang="0">
                <a:pos x="80" y="4864"/>
              </a:cxn>
            </a:cxnLst>
            <a:rect l="0" t="0" r="r" b="b"/>
            <a:pathLst>
              <a:path w="816" h="4904">
                <a:moveTo>
                  <a:pt x="0" y="40"/>
                </a:moveTo>
                <a:cubicBezTo>
                  <a:pt x="0" y="18"/>
                  <a:pt x="18" y="0"/>
                  <a:pt x="40" y="0"/>
                </a:cubicBezTo>
                <a:lnTo>
                  <a:pt x="776" y="0"/>
                </a:lnTo>
                <a:cubicBezTo>
                  <a:pt x="799" y="0"/>
                  <a:pt x="816" y="18"/>
                  <a:pt x="816" y="40"/>
                </a:cubicBezTo>
                <a:lnTo>
                  <a:pt x="816" y="4864"/>
                </a:lnTo>
                <a:cubicBezTo>
                  <a:pt x="816" y="4887"/>
                  <a:pt x="799" y="4904"/>
                  <a:pt x="776" y="4904"/>
                </a:cubicBezTo>
                <a:lnTo>
                  <a:pt x="40" y="4904"/>
                </a:lnTo>
                <a:cubicBezTo>
                  <a:pt x="18" y="4904"/>
                  <a:pt x="0" y="4887"/>
                  <a:pt x="0" y="4864"/>
                </a:cubicBezTo>
                <a:lnTo>
                  <a:pt x="0" y="40"/>
                </a:lnTo>
                <a:close/>
                <a:moveTo>
                  <a:pt x="80" y="4864"/>
                </a:moveTo>
                <a:lnTo>
                  <a:pt x="40" y="4824"/>
                </a:lnTo>
                <a:lnTo>
                  <a:pt x="776" y="4824"/>
                </a:lnTo>
                <a:lnTo>
                  <a:pt x="736" y="4864"/>
                </a:lnTo>
                <a:lnTo>
                  <a:pt x="736" y="40"/>
                </a:lnTo>
                <a:lnTo>
                  <a:pt x="776" y="80"/>
                </a:lnTo>
                <a:lnTo>
                  <a:pt x="40" y="80"/>
                </a:lnTo>
                <a:lnTo>
                  <a:pt x="80" y="40"/>
                </a:lnTo>
                <a:lnTo>
                  <a:pt x="80" y="4864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21" name="Rectangle 897"/>
          <p:cNvSpPr>
            <a:spLocks noChangeArrowheads="1"/>
          </p:cNvSpPr>
          <p:nvPr/>
        </p:nvSpPr>
        <p:spPr bwMode="auto">
          <a:xfrm>
            <a:off x="2967770" y="7578022"/>
            <a:ext cx="43441" cy="138378"/>
          </a:xfrm>
          <a:prstGeom prst="rect">
            <a:avLst/>
          </a:prstGeom>
          <a:solidFill>
            <a:srgbClr val="9999FF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22" name="Freeform 898"/>
          <p:cNvSpPr>
            <a:spLocks noEditPoints="1"/>
          </p:cNvSpPr>
          <p:nvPr/>
        </p:nvSpPr>
        <p:spPr bwMode="auto">
          <a:xfrm>
            <a:off x="2965651" y="7575791"/>
            <a:ext cx="48739" cy="143957"/>
          </a:xfrm>
          <a:custGeom>
            <a:avLst/>
            <a:gdLst/>
            <a:ahLst/>
            <a:cxnLst>
              <a:cxn ang="0">
                <a:pos x="0" y="40"/>
              </a:cxn>
              <a:cxn ang="0">
                <a:pos x="40" y="0"/>
              </a:cxn>
              <a:cxn ang="0">
                <a:pos x="776" y="0"/>
              </a:cxn>
              <a:cxn ang="0">
                <a:pos x="816" y="40"/>
              </a:cxn>
              <a:cxn ang="0">
                <a:pos x="816" y="2176"/>
              </a:cxn>
              <a:cxn ang="0">
                <a:pos x="776" y="2216"/>
              </a:cxn>
              <a:cxn ang="0">
                <a:pos x="40" y="2216"/>
              </a:cxn>
              <a:cxn ang="0">
                <a:pos x="0" y="2176"/>
              </a:cxn>
              <a:cxn ang="0">
                <a:pos x="0" y="40"/>
              </a:cxn>
              <a:cxn ang="0">
                <a:pos x="80" y="2176"/>
              </a:cxn>
              <a:cxn ang="0">
                <a:pos x="40" y="2136"/>
              </a:cxn>
              <a:cxn ang="0">
                <a:pos x="776" y="2136"/>
              </a:cxn>
              <a:cxn ang="0">
                <a:pos x="736" y="2176"/>
              </a:cxn>
              <a:cxn ang="0">
                <a:pos x="736" y="40"/>
              </a:cxn>
              <a:cxn ang="0">
                <a:pos x="776" y="80"/>
              </a:cxn>
              <a:cxn ang="0">
                <a:pos x="40" y="80"/>
              </a:cxn>
              <a:cxn ang="0">
                <a:pos x="80" y="40"/>
              </a:cxn>
              <a:cxn ang="0">
                <a:pos x="80" y="2176"/>
              </a:cxn>
            </a:cxnLst>
            <a:rect l="0" t="0" r="r" b="b"/>
            <a:pathLst>
              <a:path w="816" h="2216">
                <a:moveTo>
                  <a:pt x="0" y="40"/>
                </a:moveTo>
                <a:cubicBezTo>
                  <a:pt x="0" y="18"/>
                  <a:pt x="18" y="0"/>
                  <a:pt x="40" y="0"/>
                </a:cubicBezTo>
                <a:lnTo>
                  <a:pt x="776" y="0"/>
                </a:lnTo>
                <a:cubicBezTo>
                  <a:pt x="799" y="0"/>
                  <a:pt x="816" y="18"/>
                  <a:pt x="816" y="40"/>
                </a:cubicBezTo>
                <a:lnTo>
                  <a:pt x="816" y="2176"/>
                </a:lnTo>
                <a:cubicBezTo>
                  <a:pt x="816" y="2199"/>
                  <a:pt x="799" y="2216"/>
                  <a:pt x="776" y="2216"/>
                </a:cubicBezTo>
                <a:lnTo>
                  <a:pt x="40" y="2216"/>
                </a:lnTo>
                <a:cubicBezTo>
                  <a:pt x="18" y="2216"/>
                  <a:pt x="0" y="2199"/>
                  <a:pt x="0" y="2176"/>
                </a:cubicBezTo>
                <a:lnTo>
                  <a:pt x="0" y="40"/>
                </a:lnTo>
                <a:close/>
                <a:moveTo>
                  <a:pt x="80" y="2176"/>
                </a:moveTo>
                <a:lnTo>
                  <a:pt x="40" y="2136"/>
                </a:lnTo>
                <a:lnTo>
                  <a:pt x="776" y="2136"/>
                </a:lnTo>
                <a:lnTo>
                  <a:pt x="736" y="2176"/>
                </a:lnTo>
                <a:lnTo>
                  <a:pt x="736" y="40"/>
                </a:lnTo>
                <a:lnTo>
                  <a:pt x="776" y="80"/>
                </a:lnTo>
                <a:lnTo>
                  <a:pt x="40" y="80"/>
                </a:lnTo>
                <a:lnTo>
                  <a:pt x="80" y="40"/>
                </a:lnTo>
                <a:lnTo>
                  <a:pt x="80" y="2176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23" name="Rectangle 899"/>
          <p:cNvSpPr>
            <a:spLocks noChangeArrowheads="1"/>
          </p:cNvSpPr>
          <p:nvPr/>
        </p:nvSpPr>
        <p:spPr bwMode="auto">
          <a:xfrm>
            <a:off x="3098094" y="7400586"/>
            <a:ext cx="44501" cy="315814"/>
          </a:xfrm>
          <a:prstGeom prst="rect">
            <a:avLst/>
          </a:prstGeom>
          <a:solidFill>
            <a:srgbClr val="9999FF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24" name="Freeform 900"/>
          <p:cNvSpPr>
            <a:spLocks noEditPoints="1"/>
          </p:cNvSpPr>
          <p:nvPr/>
        </p:nvSpPr>
        <p:spPr bwMode="auto">
          <a:xfrm>
            <a:off x="3095975" y="7397238"/>
            <a:ext cx="48739" cy="322510"/>
          </a:xfrm>
          <a:custGeom>
            <a:avLst/>
            <a:gdLst/>
            <a:ahLst/>
            <a:cxnLst>
              <a:cxn ang="0">
                <a:pos x="0" y="40"/>
              </a:cxn>
              <a:cxn ang="0">
                <a:pos x="40" y="0"/>
              </a:cxn>
              <a:cxn ang="0">
                <a:pos x="776" y="0"/>
              </a:cxn>
              <a:cxn ang="0">
                <a:pos x="816" y="40"/>
              </a:cxn>
              <a:cxn ang="0">
                <a:pos x="816" y="4912"/>
              </a:cxn>
              <a:cxn ang="0">
                <a:pos x="776" y="4952"/>
              </a:cxn>
              <a:cxn ang="0">
                <a:pos x="40" y="4952"/>
              </a:cxn>
              <a:cxn ang="0">
                <a:pos x="0" y="4912"/>
              </a:cxn>
              <a:cxn ang="0">
                <a:pos x="0" y="40"/>
              </a:cxn>
              <a:cxn ang="0">
                <a:pos x="80" y="4912"/>
              </a:cxn>
              <a:cxn ang="0">
                <a:pos x="40" y="4872"/>
              </a:cxn>
              <a:cxn ang="0">
                <a:pos x="776" y="4872"/>
              </a:cxn>
              <a:cxn ang="0">
                <a:pos x="736" y="4912"/>
              </a:cxn>
              <a:cxn ang="0">
                <a:pos x="736" y="40"/>
              </a:cxn>
              <a:cxn ang="0">
                <a:pos x="776" y="80"/>
              </a:cxn>
              <a:cxn ang="0">
                <a:pos x="40" y="80"/>
              </a:cxn>
              <a:cxn ang="0">
                <a:pos x="80" y="40"/>
              </a:cxn>
              <a:cxn ang="0">
                <a:pos x="80" y="4912"/>
              </a:cxn>
            </a:cxnLst>
            <a:rect l="0" t="0" r="r" b="b"/>
            <a:pathLst>
              <a:path w="816" h="4952">
                <a:moveTo>
                  <a:pt x="0" y="40"/>
                </a:moveTo>
                <a:cubicBezTo>
                  <a:pt x="0" y="18"/>
                  <a:pt x="18" y="0"/>
                  <a:pt x="40" y="0"/>
                </a:cubicBezTo>
                <a:lnTo>
                  <a:pt x="776" y="0"/>
                </a:lnTo>
                <a:cubicBezTo>
                  <a:pt x="799" y="0"/>
                  <a:pt x="816" y="18"/>
                  <a:pt x="816" y="40"/>
                </a:cubicBezTo>
                <a:lnTo>
                  <a:pt x="816" y="4912"/>
                </a:lnTo>
                <a:cubicBezTo>
                  <a:pt x="816" y="4935"/>
                  <a:pt x="799" y="4952"/>
                  <a:pt x="776" y="4952"/>
                </a:cubicBezTo>
                <a:lnTo>
                  <a:pt x="40" y="4952"/>
                </a:lnTo>
                <a:cubicBezTo>
                  <a:pt x="18" y="4952"/>
                  <a:pt x="0" y="4935"/>
                  <a:pt x="0" y="4912"/>
                </a:cubicBezTo>
                <a:lnTo>
                  <a:pt x="0" y="40"/>
                </a:lnTo>
                <a:close/>
                <a:moveTo>
                  <a:pt x="80" y="4912"/>
                </a:moveTo>
                <a:lnTo>
                  <a:pt x="40" y="4872"/>
                </a:lnTo>
                <a:lnTo>
                  <a:pt x="776" y="4872"/>
                </a:lnTo>
                <a:lnTo>
                  <a:pt x="736" y="4912"/>
                </a:lnTo>
                <a:lnTo>
                  <a:pt x="736" y="40"/>
                </a:lnTo>
                <a:lnTo>
                  <a:pt x="776" y="80"/>
                </a:lnTo>
                <a:lnTo>
                  <a:pt x="40" y="80"/>
                </a:lnTo>
                <a:lnTo>
                  <a:pt x="80" y="40"/>
                </a:lnTo>
                <a:lnTo>
                  <a:pt x="80" y="4912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25" name="Rectangle 901"/>
          <p:cNvSpPr>
            <a:spLocks noChangeArrowheads="1"/>
          </p:cNvSpPr>
          <p:nvPr/>
        </p:nvSpPr>
        <p:spPr bwMode="auto">
          <a:xfrm>
            <a:off x="3229477" y="7341441"/>
            <a:ext cx="43441" cy="374960"/>
          </a:xfrm>
          <a:prstGeom prst="rect">
            <a:avLst/>
          </a:prstGeom>
          <a:solidFill>
            <a:srgbClr val="9999FF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26" name="Freeform 902"/>
          <p:cNvSpPr>
            <a:spLocks noEditPoints="1"/>
          </p:cNvSpPr>
          <p:nvPr/>
        </p:nvSpPr>
        <p:spPr bwMode="auto">
          <a:xfrm>
            <a:off x="3227358" y="7339209"/>
            <a:ext cx="48739" cy="380539"/>
          </a:xfrm>
          <a:custGeom>
            <a:avLst/>
            <a:gdLst/>
            <a:ahLst/>
            <a:cxnLst>
              <a:cxn ang="0">
                <a:pos x="0" y="40"/>
              </a:cxn>
              <a:cxn ang="0">
                <a:pos x="40" y="0"/>
              </a:cxn>
              <a:cxn ang="0">
                <a:pos x="776" y="0"/>
              </a:cxn>
              <a:cxn ang="0">
                <a:pos x="816" y="40"/>
              </a:cxn>
              <a:cxn ang="0">
                <a:pos x="816" y="5808"/>
              </a:cxn>
              <a:cxn ang="0">
                <a:pos x="776" y="5848"/>
              </a:cxn>
              <a:cxn ang="0">
                <a:pos x="40" y="5848"/>
              </a:cxn>
              <a:cxn ang="0">
                <a:pos x="0" y="5808"/>
              </a:cxn>
              <a:cxn ang="0">
                <a:pos x="0" y="40"/>
              </a:cxn>
              <a:cxn ang="0">
                <a:pos x="80" y="5808"/>
              </a:cxn>
              <a:cxn ang="0">
                <a:pos x="40" y="5768"/>
              </a:cxn>
              <a:cxn ang="0">
                <a:pos x="776" y="5768"/>
              </a:cxn>
              <a:cxn ang="0">
                <a:pos x="736" y="5808"/>
              </a:cxn>
              <a:cxn ang="0">
                <a:pos x="736" y="40"/>
              </a:cxn>
              <a:cxn ang="0">
                <a:pos x="776" y="80"/>
              </a:cxn>
              <a:cxn ang="0">
                <a:pos x="40" y="80"/>
              </a:cxn>
              <a:cxn ang="0">
                <a:pos x="80" y="40"/>
              </a:cxn>
              <a:cxn ang="0">
                <a:pos x="80" y="5808"/>
              </a:cxn>
            </a:cxnLst>
            <a:rect l="0" t="0" r="r" b="b"/>
            <a:pathLst>
              <a:path w="816" h="5848">
                <a:moveTo>
                  <a:pt x="0" y="40"/>
                </a:moveTo>
                <a:cubicBezTo>
                  <a:pt x="0" y="18"/>
                  <a:pt x="18" y="0"/>
                  <a:pt x="40" y="0"/>
                </a:cubicBezTo>
                <a:lnTo>
                  <a:pt x="776" y="0"/>
                </a:lnTo>
                <a:cubicBezTo>
                  <a:pt x="799" y="0"/>
                  <a:pt x="816" y="18"/>
                  <a:pt x="816" y="40"/>
                </a:cubicBezTo>
                <a:lnTo>
                  <a:pt x="816" y="5808"/>
                </a:lnTo>
                <a:cubicBezTo>
                  <a:pt x="816" y="5831"/>
                  <a:pt x="799" y="5848"/>
                  <a:pt x="776" y="5848"/>
                </a:cubicBezTo>
                <a:lnTo>
                  <a:pt x="40" y="5848"/>
                </a:lnTo>
                <a:cubicBezTo>
                  <a:pt x="18" y="5848"/>
                  <a:pt x="0" y="5831"/>
                  <a:pt x="0" y="5808"/>
                </a:cubicBezTo>
                <a:lnTo>
                  <a:pt x="0" y="40"/>
                </a:lnTo>
                <a:close/>
                <a:moveTo>
                  <a:pt x="80" y="5808"/>
                </a:moveTo>
                <a:lnTo>
                  <a:pt x="40" y="5768"/>
                </a:lnTo>
                <a:lnTo>
                  <a:pt x="776" y="5768"/>
                </a:lnTo>
                <a:lnTo>
                  <a:pt x="736" y="5808"/>
                </a:lnTo>
                <a:lnTo>
                  <a:pt x="736" y="40"/>
                </a:lnTo>
                <a:lnTo>
                  <a:pt x="776" y="80"/>
                </a:lnTo>
                <a:lnTo>
                  <a:pt x="40" y="80"/>
                </a:lnTo>
                <a:lnTo>
                  <a:pt x="80" y="40"/>
                </a:lnTo>
                <a:lnTo>
                  <a:pt x="80" y="5808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27" name="Rectangle 903"/>
          <p:cNvSpPr>
            <a:spLocks noChangeArrowheads="1"/>
          </p:cNvSpPr>
          <p:nvPr/>
        </p:nvSpPr>
        <p:spPr bwMode="auto">
          <a:xfrm>
            <a:off x="3359800" y="6630580"/>
            <a:ext cx="44501" cy="1085821"/>
          </a:xfrm>
          <a:prstGeom prst="rect">
            <a:avLst/>
          </a:prstGeom>
          <a:solidFill>
            <a:srgbClr val="9999FF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28" name="Freeform 904"/>
          <p:cNvSpPr>
            <a:spLocks noEditPoints="1"/>
          </p:cNvSpPr>
          <p:nvPr/>
        </p:nvSpPr>
        <p:spPr bwMode="auto">
          <a:xfrm>
            <a:off x="3357680" y="6627231"/>
            <a:ext cx="48739" cy="1092516"/>
          </a:xfrm>
          <a:custGeom>
            <a:avLst/>
            <a:gdLst/>
            <a:ahLst/>
            <a:cxnLst>
              <a:cxn ang="0">
                <a:pos x="0" y="40"/>
              </a:cxn>
              <a:cxn ang="0">
                <a:pos x="40" y="0"/>
              </a:cxn>
              <a:cxn ang="0">
                <a:pos x="776" y="0"/>
              </a:cxn>
              <a:cxn ang="0">
                <a:pos x="816" y="40"/>
              </a:cxn>
              <a:cxn ang="0">
                <a:pos x="816" y="16760"/>
              </a:cxn>
              <a:cxn ang="0">
                <a:pos x="776" y="16800"/>
              </a:cxn>
              <a:cxn ang="0">
                <a:pos x="40" y="16800"/>
              </a:cxn>
              <a:cxn ang="0">
                <a:pos x="0" y="16760"/>
              </a:cxn>
              <a:cxn ang="0">
                <a:pos x="0" y="40"/>
              </a:cxn>
              <a:cxn ang="0">
                <a:pos x="80" y="16760"/>
              </a:cxn>
              <a:cxn ang="0">
                <a:pos x="40" y="16720"/>
              </a:cxn>
              <a:cxn ang="0">
                <a:pos x="776" y="16720"/>
              </a:cxn>
              <a:cxn ang="0">
                <a:pos x="736" y="16760"/>
              </a:cxn>
              <a:cxn ang="0">
                <a:pos x="736" y="40"/>
              </a:cxn>
              <a:cxn ang="0">
                <a:pos x="776" y="80"/>
              </a:cxn>
              <a:cxn ang="0">
                <a:pos x="40" y="80"/>
              </a:cxn>
              <a:cxn ang="0">
                <a:pos x="80" y="40"/>
              </a:cxn>
              <a:cxn ang="0">
                <a:pos x="80" y="16760"/>
              </a:cxn>
            </a:cxnLst>
            <a:rect l="0" t="0" r="r" b="b"/>
            <a:pathLst>
              <a:path w="816" h="16800">
                <a:moveTo>
                  <a:pt x="0" y="40"/>
                </a:moveTo>
                <a:cubicBezTo>
                  <a:pt x="0" y="18"/>
                  <a:pt x="18" y="0"/>
                  <a:pt x="40" y="0"/>
                </a:cubicBezTo>
                <a:lnTo>
                  <a:pt x="776" y="0"/>
                </a:lnTo>
                <a:cubicBezTo>
                  <a:pt x="799" y="0"/>
                  <a:pt x="816" y="18"/>
                  <a:pt x="816" y="40"/>
                </a:cubicBezTo>
                <a:lnTo>
                  <a:pt x="816" y="16760"/>
                </a:lnTo>
                <a:cubicBezTo>
                  <a:pt x="816" y="16783"/>
                  <a:pt x="799" y="16800"/>
                  <a:pt x="776" y="16800"/>
                </a:cubicBezTo>
                <a:lnTo>
                  <a:pt x="40" y="16800"/>
                </a:lnTo>
                <a:cubicBezTo>
                  <a:pt x="18" y="16800"/>
                  <a:pt x="0" y="16783"/>
                  <a:pt x="0" y="16760"/>
                </a:cubicBezTo>
                <a:lnTo>
                  <a:pt x="0" y="40"/>
                </a:lnTo>
                <a:close/>
                <a:moveTo>
                  <a:pt x="80" y="16760"/>
                </a:moveTo>
                <a:lnTo>
                  <a:pt x="40" y="16720"/>
                </a:lnTo>
                <a:lnTo>
                  <a:pt x="776" y="16720"/>
                </a:lnTo>
                <a:lnTo>
                  <a:pt x="736" y="16760"/>
                </a:lnTo>
                <a:lnTo>
                  <a:pt x="736" y="40"/>
                </a:lnTo>
                <a:lnTo>
                  <a:pt x="776" y="80"/>
                </a:lnTo>
                <a:lnTo>
                  <a:pt x="40" y="80"/>
                </a:lnTo>
                <a:lnTo>
                  <a:pt x="80" y="40"/>
                </a:lnTo>
                <a:lnTo>
                  <a:pt x="80" y="1676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29" name="Rectangle 905"/>
          <p:cNvSpPr>
            <a:spLocks noChangeArrowheads="1"/>
          </p:cNvSpPr>
          <p:nvPr/>
        </p:nvSpPr>
        <p:spPr bwMode="auto">
          <a:xfrm>
            <a:off x="3491182" y="7083656"/>
            <a:ext cx="43441" cy="632744"/>
          </a:xfrm>
          <a:prstGeom prst="rect">
            <a:avLst/>
          </a:prstGeom>
          <a:solidFill>
            <a:srgbClr val="9999FF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30" name="Freeform 906"/>
          <p:cNvSpPr>
            <a:spLocks noEditPoints="1"/>
          </p:cNvSpPr>
          <p:nvPr/>
        </p:nvSpPr>
        <p:spPr bwMode="auto">
          <a:xfrm>
            <a:off x="3488004" y="7081424"/>
            <a:ext cx="48739" cy="638324"/>
          </a:xfrm>
          <a:custGeom>
            <a:avLst/>
            <a:gdLst/>
            <a:ahLst/>
            <a:cxnLst>
              <a:cxn ang="0">
                <a:pos x="0" y="40"/>
              </a:cxn>
              <a:cxn ang="0">
                <a:pos x="40" y="0"/>
              </a:cxn>
              <a:cxn ang="0">
                <a:pos x="776" y="0"/>
              </a:cxn>
              <a:cxn ang="0">
                <a:pos x="816" y="40"/>
              </a:cxn>
              <a:cxn ang="0">
                <a:pos x="816" y="9784"/>
              </a:cxn>
              <a:cxn ang="0">
                <a:pos x="776" y="9824"/>
              </a:cxn>
              <a:cxn ang="0">
                <a:pos x="40" y="9824"/>
              </a:cxn>
              <a:cxn ang="0">
                <a:pos x="0" y="9784"/>
              </a:cxn>
              <a:cxn ang="0">
                <a:pos x="0" y="40"/>
              </a:cxn>
              <a:cxn ang="0">
                <a:pos x="80" y="9784"/>
              </a:cxn>
              <a:cxn ang="0">
                <a:pos x="40" y="9744"/>
              </a:cxn>
              <a:cxn ang="0">
                <a:pos x="776" y="9744"/>
              </a:cxn>
              <a:cxn ang="0">
                <a:pos x="736" y="9784"/>
              </a:cxn>
              <a:cxn ang="0">
                <a:pos x="736" y="40"/>
              </a:cxn>
              <a:cxn ang="0">
                <a:pos x="776" y="80"/>
              </a:cxn>
              <a:cxn ang="0">
                <a:pos x="40" y="80"/>
              </a:cxn>
              <a:cxn ang="0">
                <a:pos x="80" y="40"/>
              </a:cxn>
              <a:cxn ang="0">
                <a:pos x="80" y="9784"/>
              </a:cxn>
            </a:cxnLst>
            <a:rect l="0" t="0" r="r" b="b"/>
            <a:pathLst>
              <a:path w="816" h="9824">
                <a:moveTo>
                  <a:pt x="0" y="40"/>
                </a:moveTo>
                <a:cubicBezTo>
                  <a:pt x="0" y="18"/>
                  <a:pt x="18" y="0"/>
                  <a:pt x="40" y="0"/>
                </a:cubicBezTo>
                <a:lnTo>
                  <a:pt x="776" y="0"/>
                </a:lnTo>
                <a:cubicBezTo>
                  <a:pt x="799" y="0"/>
                  <a:pt x="816" y="18"/>
                  <a:pt x="816" y="40"/>
                </a:cubicBezTo>
                <a:lnTo>
                  <a:pt x="816" y="9784"/>
                </a:lnTo>
                <a:cubicBezTo>
                  <a:pt x="816" y="9807"/>
                  <a:pt x="799" y="9824"/>
                  <a:pt x="776" y="9824"/>
                </a:cubicBezTo>
                <a:lnTo>
                  <a:pt x="40" y="9824"/>
                </a:lnTo>
                <a:cubicBezTo>
                  <a:pt x="18" y="9824"/>
                  <a:pt x="0" y="9807"/>
                  <a:pt x="0" y="9784"/>
                </a:cubicBezTo>
                <a:lnTo>
                  <a:pt x="0" y="40"/>
                </a:lnTo>
                <a:close/>
                <a:moveTo>
                  <a:pt x="80" y="9784"/>
                </a:moveTo>
                <a:lnTo>
                  <a:pt x="40" y="9744"/>
                </a:lnTo>
                <a:lnTo>
                  <a:pt x="776" y="9744"/>
                </a:lnTo>
                <a:lnTo>
                  <a:pt x="736" y="9784"/>
                </a:lnTo>
                <a:lnTo>
                  <a:pt x="736" y="40"/>
                </a:lnTo>
                <a:lnTo>
                  <a:pt x="776" y="80"/>
                </a:lnTo>
                <a:lnTo>
                  <a:pt x="40" y="80"/>
                </a:lnTo>
                <a:lnTo>
                  <a:pt x="80" y="40"/>
                </a:lnTo>
                <a:lnTo>
                  <a:pt x="80" y="9784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31" name="Rectangle 907"/>
          <p:cNvSpPr>
            <a:spLocks noChangeArrowheads="1"/>
          </p:cNvSpPr>
          <p:nvPr/>
        </p:nvSpPr>
        <p:spPr bwMode="auto">
          <a:xfrm>
            <a:off x="3621506" y="7428485"/>
            <a:ext cx="43441" cy="287916"/>
          </a:xfrm>
          <a:prstGeom prst="rect">
            <a:avLst/>
          </a:prstGeom>
          <a:solidFill>
            <a:srgbClr val="9999FF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32" name="Freeform 908"/>
          <p:cNvSpPr>
            <a:spLocks noEditPoints="1"/>
          </p:cNvSpPr>
          <p:nvPr/>
        </p:nvSpPr>
        <p:spPr bwMode="auto">
          <a:xfrm>
            <a:off x="3619387" y="7426253"/>
            <a:ext cx="47680" cy="293495"/>
          </a:xfrm>
          <a:custGeom>
            <a:avLst/>
            <a:gdLst/>
            <a:ahLst/>
            <a:cxnLst>
              <a:cxn ang="0">
                <a:pos x="0" y="20"/>
              </a:cxn>
              <a:cxn ang="0">
                <a:pos x="20" y="0"/>
              </a:cxn>
              <a:cxn ang="0">
                <a:pos x="384" y="0"/>
              </a:cxn>
              <a:cxn ang="0">
                <a:pos x="404" y="20"/>
              </a:cxn>
              <a:cxn ang="0">
                <a:pos x="404" y="2236"/>
              </a:cxn>
              <a:cxn ang="0">
                <a:pos x="384" y="2256"/>
              </a:cxn>
              <a:cxn ang="0">
                <a:pos x="20" y="2256"/>
              </a:cxn>
              <a:cxn ang="0">
                <a:pos x="0" y="2236"/>
              </a:cxn>
              <a:cxn ang="0">
                <a:pos x="0" y="20"/>
              </a:cxn>
              <a:cxn ang="0">
                <a:pos x="40" y="2236"/>
              </a:cxn>
              <a:cxn ang="0">
                <a:pos x="20" y="2216"/>
              </a:cxn>
              <a:cxn ang="0">
                <a:pos x="384" y="2216"/>
              </a:cxn>
              <a:cxn ang="0">
                <a:pos x="364" y="2236"/>
              </a:cxn>
              <a:cxn ang="0">
                <a:pos x="364" y="20"/>
              </a:cxn>
              <a:cxn ang="0">
                <a:pos x="384" y="40"/>
              </a:cxn>
              <a:cxn ang="0">
                <a:pos x="20" y="40"/>
              </a:cxn>
              <a:cxn ang="0">
                <a:pos x="40" y="20"/>
              </a:cxn>
              <a:cxn ang="0">
                <a:pos x="40" y="2236"/>
              </a:cxn>
            </a:cxnLst>
            <a:rect l="0" t="0" r="r" b="b"/>
            <a:pathLst>
              <a:path w="404" h="2256">
                <a:moveTo>
                  <a:pt x="0" y="20"/>
                </a:moveTo>
                <a:cubicBezTo>
                  <a:pt x="0" y="9"/>
                  <a:pt x="9" y="0"/>
                  <a:pt x="20" y="0"/>
                </a:cubicBezTo>
                <a:lnTo>
                  <a:pt x="384" y="0"/>
                </a:lnTo>
                <a:cubicBezTo>
                  <a:pt x="396" y="0"/>
                  <a:pt x="404" y="9"/>
                  <a:pt x="404" y="20"/>
                </a:cubicBezTo>
                <a:lnTo>
                  <a:pt x="404" y="2236"/>
                </a:lnTo>
                <a:cubicBezTo>
                  <a:pt x="404" y="2248"/>
                  <a:pt x="396" y="2256"/>
                  <a:pt x="384" y="2256"/>
                </a:cubicBezTo>
                <a:lnTo>
                  <a:pt x="20" y="2256"/>
                </a:lnTo>
                <a:cubicBezTo>
                  <a:pt x="9" y="2256"/>
                  <a:pt x="0" y="2248"/>
                  <a:pt x="0" y="2236"/>
                </a:cubicBezTo>
                <a:lnTo>
                  <a:pt x="0" y="20"/>
                </a:lnTo>
                <a:close/>
                <a:moveTo>
                  <a:pt x="40" y="2236"/>
                </a:moveTo>
                <a:lnTo>
                  <a:pt x="20" y="2216"/>
                </a:lnTo>
                <a:lnTo>
                  <a:pt x="384" y="2216"/>
                </a:lnTo>
                <a:lnTo>
                  <a:pt x="364" y="2236"/>
                </a:lnTo>
                <a:lnTo>
                  <a:pt x="364" y="20"/>
                </a:lnTo>
                <a:lnTo>
                  <a:pt x="384" y="40"/>
                </a:lnTo>
                <a:lnTo>
                  <a:pt x="20" y="40"/>
                </a:lnTo>
                <a:lnTo>
                  <a:pt x="40" y="20"/>
                </a:lnTo>
                <a:lnTo>
                  <a:pt x="40" y="2236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33" name="Rectangle 909"/>
          <p:cNvSpPr>
            <a:spLocks noChangeArrowheads="1"/>
          </p:cNvSpPr>
          <p:nvPr/>
        </p:nvSpPr>
        <p:spPr bwMode="auto">
          <a:xfrm>
            <a:off x="3752889" y="7469775"/>
            <a:ext cx="43441" cy="246625"/>
          </a:xfrm>
          <a:prstGeom prst="rect">
            <a:avLst/>
          </a:prstGeom>
          <a:solidFill>
            <a:srgbClr val="9999FF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34" name="Freeform 910"/>
          <p:cNvSpPr>
            <a:spLocks noEditPoints="1"/>
          </p:cNvSpPr>
          <p:nvPr/>
        </p:nvSpPr>
        <p:spPr bwMode="auto">
          <a:xfrm>
            <a:off x="3749710" y="7467544"/>
            <a:ext cx="48739" cy="252205"/>
          </a:xfrm>
          <a:custGeom>
            <a:avLst/>
            <a:gdLst/>
            <a:ahLst/>
            <a:cxnLst>
              <a:cxn ang="0">
                <a:pos x="0" y="20"/>
              </a:cxn>
              <a:cxn ang="0">
                <a:pos x="20" y="0"/>
              </a:cxn>
              <a:cxn ang="0">
                <a:pos x="388" y="0"/>
              </a:cxn>
              <a:cxn ang="0">
                <a:pos x="408" y="20"/>
              </a:cxn>
              <a:cxn ang="0">
                <a:pos x="408" y="1920"/>
              </a:cxn>
              <a:cxn ang="0">
                <a:pos x="388" y="1940"/>
              </a:cxn>
              <a:cxn ang="0">
                <a:pos x="20" y="1940"/>
              </a:cxn>
              <a:cxn ang="0">
                <a:pos x="0" y="1920"/>
              </a:cxn>
              <a:cxn ang="0">
                <a:pos x="0" y="20"/>
              </a:cxn>
              <a:cxn ang="0">
                <a:pos x="40" y="1920"/>
              </a:cxn>
              <a:cxn ang="0">
                <a:pos x="20" y="1900"/>
              </a:cxn>
              <a:cxn ang="0">
                <a:pos x="388" y="1900"/>
              </a:cxn>
              <a:cxn ang="0">
                <a:pos x="368" y="1920"/>
              </a:cxn>
              <a:cxn ang="0">
                <a:pos x="368" y="20"/>
              </a:cxn>
              <a:cxn ang="0">
                <a:pos x="388" y="40"/>
              </a:cxn>
              <a:cxn ang="0">
                <a:pos x="20" y="40"/>
              </a:cxn>
              <a:cxn ang="0">
                <a:pos x="40" y="20"/>
              </a:cxn>
              <a:cxn ang="0">
                <a:pos x="40" y="1920"/>
              </a:cxn>
            </a:cxnLst>
            <a:rect l="0" t="0" r="r" b="b"/>
            <a:pathLst>
              <a:path w="408" h="1940">
                <a:moveTo>
                  <a:pt x="0" y="20"/>
                </a:moveTo>
                <a:cubicBezTo>
                  <a:pt x="0" y="9"/>
                  <a:pt x="9" y="0"/>
                  <a:pt x="20" y="0"/>
                </a:cubicBezTo>
                <a:lnTo>
                  <a:pt x="388" y="0"/>
                </a:lnTo>
                <a:cubicBezTo>
                  <a:pt x="400" y="0"/>
                  <a:pt x="408" y="9"/>
                  <a:pt x="408" y="20"/>
                </a:cubicBezTo>
                <a:lnTo>
                  <a:pt x="408" y="1920"/>
                </a:lnTo>
                <a:cubicBezTo>
                  <a:pt x="408" y="1932"/>
                  <a:pt x="400" y="1940"/>
                  <a:pt x="388" y="1940"/>
                </a:cubicBezTo>
                <a:lnTo>
                  <a:pt x="20" y="1940"/>
                </a:lnTo>
                <a:cubicBezTo>
                  <a:pt x="9" y="1940"/>
                  <a:pt x="0" y="1932"/>
                  <a:pt x="0" y="1920"/>
                </a:cubicBezTo>
                <a:lnTo>
                  <a:pt x="0" y="20"/>
                </a:lnTo>
                <a:close/>
                <a:moveTo>
                  <a:pt x="40" y="1920"/>
                </a:moveTo>
                <a:lnTo>
                  <a:pt x="20" y="1900"/>
                </a:lnTo>
                <a:lnTo>
                  <a:pt x="388" y="1900"/>
                </a:lnTo>
                <a:lnTo>
                  <a:pt x="368" y="1920"/>
                </a:lnTo>
                <a:lnTo>
                  <a:pt x="368" y="20"/>
                </a:lnTo>
                <a:lnTo>
                  <a:pt x="388" y="40"/>
                </a:lnTo>
                <a:lnTo>
                  <a:pt x="20" y="40"/>
                </a:lnTo>
                <a:lnTo>
                  <a:pt x="40" y="20"/>
                </a:lnTo>
                <a:lnTo>
                  <a:pt x="40" y="192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35" name="Rectangle 911"/>
          <p:cNvSpPr>
            <a:spLocks noChangeArrowheads="1"/>
          </p:cNvSpPr>
          <p:nvPr/>
        </p:nvSpPr>
        <p:spPr bwMode="auto">
          <a:xfrm>
            <a:off x="3883212" y="7686270"/>
            <a:ext cx="43441" cy="30130"/>
          </a:xfrm>
          <a:prstGeom prst="rect">
            <a:avLst/>
          </a:prstGeom>
          <a:solidFill>
            <a:srgbClr val="9999FF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36" name="Freeform 912"/>
          <p:cNvSpPr>
            <a:spLocks noEditPoints="1"/>
          </p:cNvSpPr>
          <p:nvPr/>
        </p:nvSpPr>
        <p:spPr bwMode="auto">
          <a:xfrm>
            <a:off x="3881092" y="7684038"/>
            <a:ext cx="47680" cy="35710"/>
          </a:xfrm>
          <a:custGeom>
            <a:avLst/>
            <a:gdLst/>
            <a:ahLst/>
            <a:cxnLst>
              <a:cxn ang="0">
                <a:pos x="0" y="20"/>
              </a:cxn>
              <a:cxn ang="0">
                <a:pos x="20" y="0"/>
              </a:cxn>
              <a:cxn ang="0">
                <a:pos x="388" y="0"/>
              </a:cxn>
              <a:cxn ang="0">
                <a:pos x="408" y="20"/>
              </a:cxn>
              <a:cxn ang="0">
                <a:pos x="408" y="256"/>
              </a:cxn>
              <a:cxn ang="0">
                <a:pos x="388" y="276"/>
              </a:cxn>
              <a:cxn ang="0">
                <a:pos x="20" y="276"/>
              </a:cxn>
              <a:cxn ang="0">
                <a:pos x="0" y="256"/>
              </a:cxn>
              <a:cxn ang="0">
                <a:pos x="0" y="20"/>
              </a:cxn>
              <a:cxn ang="0">
                <a:pos x="40" y="256"/>
              </a:cxn>
              <a:cxn ang="0">
                <a:pos x="20" y="236"/>
              </a:cxn>
              <a:cxn ang="0">
                <a:pos x="388" y="236"/>
              </a:cxn>
              <a:cxn ang="0">
                <a:pos x="368" y="256"/>
              </a:cxn>
              <a:cxn ang="0">
                <a:pos x="368" y="20"/>
              </a:cxn>
              <a:cxn ang="0">
                <a:pos x="388" y="40"/>
              </a:cxn>
              <a:cxn ang="0">
                <a:pos x="20" y="40"/>
              </a:cxn>
              <a:cxn ang="0">
                <a:pos x="40" y="20"/>
              </a:cxn>
              <a:cxn ang="0">
                <a:pos x="40" y="256"/>
              </a:cxn>
            </a:cxnLst>
            <a:rect l="0" t="0" r="r" b="b"/>
            <a:pathLst>
              <a:path w="408" h="276">
                <a:moveTo>
                  <a:pt x="0" y="20"/>
                </a:moveTo>
                <a:cubicBezTo>
                  <a:pt x="0" y="9"/>
                  <a:pt x="9" y="0"/>
                  <a:pt x="20" y="0"/>
                </a:cubicBezTo>
                <a:lnTo>
                  <a:pt x="388" y="0"/>
                </a:lnTo>
                <a:cubicBezTo>
                  <a:pt x="400" y="0"/>
                  <a:pt x="408" y="9"/>
                  <a:pt x="408" y="20"/>
                </a:cubicBezTo>
                <a:lnTo>
                  <a:pt x="408" y="256"/>
                </a:lnTo>
                <a:cubicBezTo>
                  <a:pt x="408" y="268"/>
                  <a:pt x="400" y="276"/>
                  <a:pt x="388" y="276"/>
                </a:cubicBezTo>
                <a:lnTo>
                  <a:pt x="20" y="276"/>
                </a:lnTo>
                <a:cubicBezTo>
                  <a:pt x="9" y="276"/>
                  <a:pt x="0" y="268"/>
                  <a:pt x="0" y="256"/>
                </a:cubicBezTo>
                <a:lnTo>
                  <a:pt x="0" y="20"/>
                </a:lnTo>
                <a:close/>
                <a:moveTo>
                  <a:pt x="40" y="256"/>
                </a:moveTo>
                <a:lnTo>
                  <a:pt x="20" y="236"/>
                </a:lnTo>
                <a:lnTo>
                  <a:pt x="388" y="236"/>
                </a:lnTo>
                <a:lnTo>
                  <a:pt x="368" y="256"/>
                </a:lnTo>
                <a:lnTo>
                  <a:pt x="368" y="20"/>
                </a:lnTo>
                <a:lnTo>
                  <a:pt x="388" y="40"/>
                </a:lnTo>
                <a:lnTo>
                  <a:pt x="20" y="40"/>
                </a:lnTo>
                <a:lnTo>
                  <a:pt x="40" y="20"/>
                </a:lnTo>
                <a:lnTo>
                  <a:pt x="40" y="256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37" name="Rectangle 913"/>
          <p:cNvSpPr>
            <a:spLocks noChangeArrowheads="1"/>
          </p:cNvSpPr>
          <p:nvPr/>
        </p:nvSpPr>
        <p:spPr bwMode="auto">
          <a:xfrm>
            <a:off x="4013535" y="7506602"/>
            <a:ext cx="43441" cy="209799"/>
          </a:xfrm>
          <a:prstGeom prst="rect">
            <a:avLst/>
          </a:prstGeom>
          <a:solidFill>
            <a:srgbClr val="9999FF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38" name="Freeform 914"/>
          <p:cNvSpPr>
            <a:spLocks noEditPoints="1"/>
          </p:cNvSpPr>
          <p:nvPr/>
        </p:nvSpPr>
        <p:spPr bwMode="auto">
          <a:xfrm>
            <a:off x="4011416" y="7504370"/>
            <a:ext cx="48739" cy="215378"/>
          </a:xfrm>
          <a:custGeom>
            <a:avLst/>
            <a:gdLst/>
            <a:ahLst/>
            <a:cxnLst>
              <a:cxn ang="0">
                <a:pos x="0" y="20"/>
              </a:cxn>
              <a:cxn ang="0">
                <a:pos x="20" y="0"/>
              </a:cxn>
              <a:cxn ang="0">
                <a:pos x="388" y="0"/>
              </a:cxn>
              <a:cxn ang="0">
                <a:pos x="408" y="20"/>
              </a:cxn>
              <a:cxn ang="0">
                <a:pos x="408" y="1636"/>
              </a:cxn>
              <a:cxn ang="0">
                <a:pos x="388" y="1656"/>
              </a:cxn>
              <a:cxn ang="0">
                <a:pos x="20" y="1656"/>
              </a:cxn>
              <a:cxn ang="0">
                <a:pos x="0" y="1636"/>
              </a:cxn>
              <a:cxn ang="0">
                <a:pos x="0" y="20"/>
              </a:cxn>
              <a:cxn ang="0">
                <a:pos x="40" y="1636"/>
              </a:cxn>
              <a:cxn ang="0">
                <a:pos x="20" y="1616"/>
              </a:cxn>
              <a:cxn ang="0">
                <a:pos x="388" y="1616"/>
              </a:cxn>
              <a:cxn ang="0">
                <a:pos x="368" y="1636"/>
              </a:cxn>
              <a:cxn ang="0">
                <a:pos x="368" y="20"/>
              </a:cxn>
              <a:cxn ang="0">
                <a:pos x="388" y="40"/>
              </a:cxn>
              <a:cxn ang="0">
                <a:pos x="20" y="40"/>
              </a:cxn>
              <a:cxn ang="0">
                <a:pos x="40" y="20"/>
              </a:cxn>
              <a:cxn ang="0">
                <a:pos x="40" y="1636"/>
              </a:cxn>
            </a:cxnLst>
            <a:rect l="0" t="0" r="r" b="b"/>
            <a:pathLst>
              <a:path w="408" h="1656">
                <a:moveTo>
                  <a:pt x="0" y="20"/>
                </a:moveTo>
                <a:cubicBezTo>
                  <a:pt x="0" y="9"/>
                  <a:pt x="9" y="0"/>
                  <a:pt x="20" y="0"/>
                </a:cubicBezTo>
                <a:lnTo>
                  <a:pt x="388" y="0"/>
                </a:lnTo>
                <a:cubicBezTo>
                  <a:pt x="400" y="0"/>
                  <a:pt x="408" y="9"/>
                  <a:pt x="408" y="20"/>
                </a:cubicBezTo>
                <a:lnTo>
                  <a:pt x="408" y="1636"/>
                </a:lnTo>
                <a:cubicBezTo>
                  <a:pt x="408" y="1648"/>
                  <a:pt x="400" y="1656"/>
                  <a:pt x="388" y="1656"/>
                </a:cubicBezTo>
                <a:lnTo>
                  <a:pt x="20" y="1656"/>
                </a:lnTo>
                <a:cubicBezTo>
                  <a:pt x="9" y="1656"/>
                  <a:pt x="0" y="1648"/>
                  <a:pt x="0" y="1636"/>
                </a:cubicBezTo>
                <a:lnTo>
                  <a:pt x="0" y="20"/>
                </a:lnTo>
                <a:close/>
                <a:moveTo>
                  <a:pt x="40" y="1636"/>
                </a:moveTo>
                <a:lnTo>
                  <a:pt x="20" y="1616"/>
                </a:lnTo>
                <a:lnTo>
                  <a:pt x="388" y="1616"/>
                </a:lnTo>
                <a:lnTo>
                  <a:pt x="368" y="1636"/>
                </a:lnTo>
                <a:lnTo>
                  <a:pt x="368" y="20"/>
                </a:lnTo>
                <a:lnTo>
                  <a:pt x="388" y="40"/>
                </a:lnTo>
                <a:lnTo>
                  <a:pt x="20" y="40"/>
                </a:lnTo>
                <a:lnTo>
                  <a:pt x="40" y="20"/>
                </a:lnTo>
                <a:lnTo>
                  <a:pt x="40" y="1636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39" name="Rectangle 915"/>
          <p:cNvSpPr>
            <a:spLocks noChangeArrowheads="1"/>
          </p:cNvSpPr>
          <p:nvPr/>
        </p:nvSpPr>
        <p:spPr bwMode="auto">
          <a:xfrm>
            <a:off x="4144918" y="7560167"/>
            <a:ext cx="43441" cy="156233"/>
          </a:xfrm>
          <a:prstGeom prst="rect">
            <a:avLst/>
          </a:prstGeom>
          <a:solidFill>
            <a:srgbClr val="9999FF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40" name="Freeform 916"/>
          <p:cNvSpPr>
            <a:spLocks noEditPoints="1"/>
          </p:cNvSpPr>
          <p:nvPr/>
        </p:nvSpPr>
        <p:spPr bwMode="auto">
          <a:xfrm>
            <a:off x="4142799" y="7557935"/>
            <a:ext cx="47680" cy="161813"/>
          </a:xfrm>
          <a:custGeom>
            <a:avLst/>
            <a:gdLst/>
            <a:ahLst/>
            <a:cxnLst>
              <a:cxn ang="0">
                <a:pos x="0" y="20"/>
              </a:cxn>
              <a:cxn ang="0">
                <a:pos x="20" y="0"/>
              </a:cxn>
              <a:cxn ang="0">
                <a:pos x="384" y="0"/>
              </a:cxn>
              <a:cxn ang="0">
                <a:pos x="404" y="20"/>
              </a:cxn>
              <a:cxn ang="0">
                <a:pos x="404" y="1224"/>
              </a:cxn>
              <a:cxn ang="0">
                <a:pos x="384" y="1244"/>
              </a:cxn>
              <a:cxn ang="0">
                <a:pos x="20" y="1244"/>
              </a:cxn>
              <a:cxn ang="0">
                <a:pos x="0" y="1224"/>
              </a:cxn>
              <a:cxn ang="0">
                <a:pos x="0" y="20"/>
              </a:cxn>
              <a:cxn ang="0">
                <a:pos x="40" y="1224"/>
              </a:cxn>
              <a:cxn ang="0">
                <a:pos x="20" y="1204"/>
              </a:cxn>
              <a:cxn ang="0">
                <a:pos x="384" y="1204"/>
              </a:cxn>
              <a:cxn ang="0">
                <a:pos x="364" y="1224"/>
              </a:cxn>
              <a:cxn ang="0">
                <a:pos x="364" y="20"/>
              </a:cxn>
              <a:cxn ang="0">
                <a:pos x="384" y="40"/>
              </a:cxn>
              <a:cxn ang="0">
                <a:pos x="20" y="40"/>
              </a:cxn>
              <a:cxn ang="0">
                <a:pos x="40" y="20"/>
              </a:cxn>
              <a:cxn ang="0">
                <a:pos x="40" y="1224"/>
              </a:cxn>
            </a:cxnLst>
            <a:rect l="0" t="0" r="r" b="b"/>
            <a:pathLst>
              <a:path w="404" h="1244">
                <a:moveTo>
                  <a:pt x="0" y="20"/>
                </a:moveTo>
                <a:cubicBezTo>
                  <a:pt x="0" y="9"/>
                  <a:pt x="9" y="0"/>
                  <a:pt x="20" y="0"/>
                </a:cubicBezTo>
                <a:lnTo>
                  <a:pt x="384" y="0"/>
                </a:lnTo>
                <a:cubicBezTo>
                  <a:pt x="396" y="0"/>
                  <a:pt x="404" y="9"/>
                  <a:pt x="404" y="20"/>
                </a:cubicBezTo>
                <a:lnTo>
                  <a:pt x="404" y="1224"/>
                </a:lnTo>
                <a:cubicBezTo>
                  <a:pt x="404" y="1236"/>
                  <a:pt x="396" y="1244"/>
                  <a:pt x="384" y="1244"/>
                </a:cubicBezTo>
                <a:lnTo>
                  <a:pt x="20" y="1244"/>
                </a:lnTo>
                <a:cubicBezTo>
                  <a:pt x="9" y="1244"/>
                  <a:pt x="0" y="1236"/>
                  <a:pt x="0" y="1224"/>
                </a:cubicBezTo>
                <a:lnTo>
                  <a:pt x="0" y="20"/>
                </a:lnTo>
                <a:close/>
                <a:moveTo>
                  <a:pt x="40" y="1224"/>
                </a:moveTo>
                <a:lnTo>
                  <a:pt x="20" y="1204"/>
                </a:lnTo>
                <a:lnTo>
                  <a:pt x="384" y="1204"/>
                </a:lnTo>
                <a:lnTo>
                  <a:pt x="364" y="1224"/>
                </a:lnTo>
                <a:lnTo>
                  <a:pt x="364" y="20"/>
                </a:lnTo>
                <a:lnTo>
                  <a:pt x="384" y="40"/>
                </a:lnTo>
                <a:lnTo>
                  <a:pt x="20" y="40"/>
                </a:lnTo>
                <a:lnTo>
                  <a:pt x="40" y="20"/>
                </a:lnTo>
                <a:lnTo>
                  <a:pt x="40" y="1224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41" name="Rectangle 917"/>
          <p:cNvSpPr>
            <a:spLocks noChangeArrowheads="1"/>
          </p:cNvSpPr>
          <p:nvPr/>
        </p:nvSpPr>
        <p:spPr bwMode="auto">
          <a:xfrm>
            <a:off x="4275241" y="7502138"/>
            <a:ext cx="43441" cy="214263"/>
          </a:xfrm>
          <a:prstGeom prst="rect">
            <a:avLst/>
          </a:prstGeom>
          <a:solidFill>
            <a:srgbClr val="9999FF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42" name="Freeform 918"/>
          <p:cNvSpPr>
            <a:spLocks noEditPoints="1"/>
          </p:cNvSpPr>
          <p:nvPr/>
        </p:nvSpPr>
        <p:spPr bwMode="auto">
          <a:xfrm>
            <a:off x="4273122" y="7499906"/>
            <a:ext cx="48739" cy="219842"/>
          </a:xfrm>
          <a:custGeom>
            <a:avLst/>
            <a:gdLst/>
            <a:ahLst/>
            <a:cxnLst>
              <a:cxn ang="0">
                <a:pos x="0" y="20"/>
              </a:cxn>
              <a:cxn ang="0">
                <a:pos x="20" y="0"/>
              </a:cxn>
              <a:cxn ang="0">
                <a:pos x="388" y="0"/>
              </a:cxn>
              <a:cxn ang="0">
                <a:pos x="408" y="20"/>
              </a:cxn>
              <a:cxn ang="0">
                <a:pos x="408" y="1672"/>
              </a:cxn>
              <a:cxn ang="0">
                <a:pos x="388" y="1692"/>
              </a:cxn>
              <a:cxn ang="0">
                <a:pos x="20" y="1692"/>
              </a:cxn>
              <a:cxn ang="0">
                <a:pos x="0" y="1672"/>
              </a:cxn>
              <a:cxn ang="0">
                <a:pos x="0" y="20"/>
              </a:cxn>
              <a:cxn ang="0">
                <a:pos x="40" y="1672"/>
              </a:cxn>
              <a:cxn ang="0">
                <a:pos x="20" y="1652"/>
              </a:cxn>
              <a:cxn ang="0">
                <a:pos x="388" y="1652"/>
              </a:cxn>
              <a:cxn ang="0">
                <a:pos x="368" y="1672"/>
              </a:cxn>
              <a:cxn ang="0">
                <a:pos x="368" y="20"/>
              </a:cxn>
              <a:cxn ang="0">
                <a:pos x="388" y="40"/>
              </a:cxn>
              <a:cxn ang="0">
                <a:pos x="20" y="40"/>
              </a:cxn>
              <a:cxn ang="0">
                <a:pos x="40" y="20"/>
              </a:cxn>
              <a:cxn ang="0">
                <a:pos x="40" y="1672"/>
              </a:cxn>
            </a:cxnLst>
            <a:rect l="0" t="0" r="r" b="b"/>
            <a:pathLst>
              <a:path w="408" h="1692">
                <a:moveTo>
                  <a:pt x="0" y="20"/>
                </a:moveTo>
                <a:cubicBezTo>
                  <a:pt x="0" y="9"/>
                  <a:pt x="9" y="0"/>
                  <a:pt x="20" y="0"/>
                </a:cubicBezTo>
                <a:lnTo>
                  <a:pt x="388" y="0"/>
                </a:lnTo>
                <a:cubicBezTo>
                  <a:pt x="400" y="0"/>
                  <a:pt x="408" y="9"/>
                  <a:pt x="408" y="20"/>
                </a:cubicBezTo>
                <a:lnTo>
                  <a:pt x="408" y="1672"/>
                </a:lnTo>
                <a:cubicBezTo>
                  <a:pt x="408" y="1684"/>
                  <a:pt x="400" y="1692"/>
                  <a:pt x="388" y="1692"/>
                </a:cubicBezTo>
                <a:lnTo>
                  <a:pt x="20" y="1692"/>
                </a:lnTo>
                <a:cubicBezTo>
                  <a:pt x="9" y="1692"/>
                  <a:pt x="0" y="1684"/>
                  <a:pt x="0" y="1672"/>
                </a:cubicBezTo>
                <a:lnTo>
                  <a:pt x="0" y="20"/>
                </a:lnTo>
                <a:close/>
                <a:moveTo>
                  <a:pt x="40" y="1672"/>
                </a:moveTo>
                <a:lnTo>
                  <a:pt x="20" y="1652"/>
                </a:lnTo>
                <a:lnTo>
                  <a:pt x="388" y="1652"/>
                </a:lnTo>
                <a:lnTo>
                  <a:pt x="368" y="1672"/>
                </a:lnTo>
                <a:lnTo>
                  <a:pt x="368" y="20"/>
                </a:lnTo>
                <a:lnTo>
                  <a:pt x="388" y="40"/>
                </a:lnTo>
                <a:lnTo>
                  <a:pt x="20" y="40"/>
                </a:lnTo>
                <a:lnTo>
                  <a:pt x="40" y="20"/>
                </a:lnTo>
                <a:lnTo>
                  <a:pt x="40" y="1672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43" name="Rectangle 919"/>
          <p:cNvSpPr>
            <a:spLocks noChangeArrowheads="1"/>
          </p:cNvSpPr>
          <p:nvPr/>
        </p:nvSpPr>
        <p:spPr bwMode="auto">
          <a:xfrm>
            <a:off x="4405564" y="7229845"/>
            <a:ext cx="44501" cy="486555"/>
          </a:xfrm>
          <a:prstGeom prst="rect">
            <a:avLst/>
          </a:prstGeom>
          <a:solidFill>
            <a:srgbClr val="9999FF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44" name="Freeform 920"/>
          <p:cNvSpPr>
            <a:spLocks noEditPoints="1"/>
          </p:cNvSpPr>
          <p:nvPr/>
        </p:nvSpPr>
        <p:spPr bwMode="auto">
          <a:xfrm>
            <a:off x="4403445" y="7226498"/>
            <a:ext cx="48739" cy="493251"/>
          </a:xfrm>
          <a:custGeom>
            <a:avLst/>
            <a:gdLst/>
            <a:ahLst/>
            <a:cxnLst>
              <a:cxn ang="0">
                <a:pos x="0" y="20"/>
              </a:cxn>
              <a:cxn ang="0">
                <a:pos x="20" y="0"/>
              </a:cxn>
              <a:cxn ang="0">
                <a:pos x="388" y="0"/>
              </a:cxn>
              <a:cxn ang="0">
                <a:pos x="408" y="20"/>
              </a:cxn>
              <a:cxn ang="0">
                <a:pos x="408" y="3768"/>
              </a:cxn>
              <a:cxn ang="0">
                <a:pos x="388" y="3788"/>
              </a:cxn>
              <a:cxn ang="0">
                <a:pos x="20" y="3788"/>
              </a:cxn>
              <a:cxn ang="0">
                <a:pos x="0" y="3768"/>
              </a:cxn>
              <a:cxn ang="0">
                <a:pos x="0" y="20"/>
              </a:cxn>
              <a:cxn ang="0">
                <a:pos x="40" y="3768"/>
              </a:cxn>
              <a:cxn ang="0">
                <a:pos x="20" y="3748"/>
              </a:cxn>
              <a:cxn ang="0">
                <a:pos x="388" y="3748"/>
              </a:cxn>
              <a:cxn ang="0">
                <a:pos x="368" y="3768"/>
              </a:cxn>
              <a:cxn ang="0">
                <a:pos x="368" y="20"/>
              </a:cxn>
              <a:cxn ang="0">
                <a:pos x="388" y="40"/>
              </a:cxn>
              <a:cxn ang="0">
                <a:pos x="20" y="40"/>
              </a:cxn>
              <a:cxn ang="0">
                <a:pos x="40" y="20"/>
              </a:cxn>
              <a:cxn ang="0">
                <a:pos x="40" y="3768"/>
              </a:cxn>
            </a:cxnLst>
            <a:rect l="0" t="0" r="r" b="b"/>
            <a:pathLst>
              <a:path w="408" h="3788">
                <a:moveTo>
                  <a:pt x="0" y="20"/>
                </a:moveTo>
                <a:cubicBezTo>
                  <a:pt x="0" y="9"/>
                  <a:pt x="9" y="0"/>
                  <a:pt x="20" y="0"/>
                </a:cubicBezTo>
                <a:lnTo>
                  <a:pt x="388" y="0"/>
                </a:lnTo>
                <a:cubicBezTo>
                  <a:pt x="400" y="0"/>
                  <a:pt x="408" y="9"/>
                  <a:pt x="408" y="20"/>
                </a:cubicBezTo>
                <a:lnTo>
                  <a:pt x="408" y="3768"/>
                </a:lnTo>
                <a:cubicBezTo>
                  <a:pt x="408" y="3780"/>
                  <a:pt x="400" y="3788"/>
                  <a:pt x="388" y="3788"/>
                </a:cubicBezTo>
                <a:lnTo>
                  <a:pt x="20" y="3788"/>
                </a:lnTo>
                <a:cubicBezTo>
                  <a:pt x="9" y="3788"/>
                  <a:pt x="0" y="3780"/>
                  <a:pt x="0" y="3768"/>
                </a:cubicBezTo>
                <a:lnTo>
                  <a:pt x="0" y="20"/>
                </a:lnTo>
                <a:close/>
                <a:moveTo>
                  <a:pt x="40" y="3768"/>
                </a:moveTo>
                <a:lnTo>
                  <a:pt x="20" y="3748"/>
                </a:lnTo>
                <a:lnTo>
                  <a:pt x="388" y="3748"/>
                </a:lnTo>
                <a:lnTo>
                  <a:pt x="368" y="3768"/>
                </a:lnTo>
                <a:lnTo>
                  <a:pt x="368" y="20"/>
                </a:lnTo>
                <a:lnTo>
                  <a:pt x="388" y="40"/>
                </a:lnTo>
                <a:lnTo>
                  <a:pt x="20" y="40"/>
                </a:lnTo>
                <a:lnTo>
                  <a:pt x="40" y="20"/>
                </a:lnTo>
                <a:lnTo>
                  <a:pt x="40" y="3768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45" name="Rectangle 921"/>
          <p:cNvSpPr>
            <a:spLocks noChangeArrowheads="1"/>
          </p:cNvSpPr>
          <p:nvPr/>
        </p:nvSpPr>
        <p:spPr bwMode="auto">
          <a:xfrm>
            <a:off x="4536947" y="6685261"/>
            <a:ext cx="43441" cy="1031139"/>
          </a:xfrm>
          <a:prstGeom prst="rect">
            <a:avLst/>
          </a:prstGeom>
          <a:solidFill>
            <a:srgbClr val="9999FF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46" name="Freeform 922"/>
          <p:cNvSpPr>
            <a:spLocks noEditPoints="1"/>
          </p:cNvSpPr>
          <p:nvPr/>
        </p:nvSpPr>
        <p:spPr bwMode="auto">
          <a:xfrm>
            <a:off x="4534828" y="6683029"/>
            <a:ext cx="47680" cy="1036719"/>
          </a:xfrm>
          <a:custGeom>
            <a:avLst/>
            <a:gdLst/>
            <a:ahLst/>
            <a:cxnLst>
              <a:cxn ang="0">
                <a:pos x="0" y="20"/>
              </a:cxn>
              <a:cxn ang="0">
                <a:pos x="20" y="0"/>
              </a:cxn>
              <a:cxn ang="0">
                <a:pos x="388" y="0"/>
              </a:cxn>
              <a:cxn ang="0">
                <a:pos x="408" y="20"/>
              </a:cxn>
              <a:cxn ang="0">
                <a:pos x="408" y="7956"/>
              </a:cxn>
              <a:cxn ang="0">
                <a:pos x="388" y="7976"/>
              </a:cxn>
              <a:cxn ang="0">
                <a:pos x="20" y="7976"/>
              </a:cxn>
              <a:cxn ang="0">
                <a:pos x="0" y="7956"/>
              </a:cxn>
              <a:cxn ang="0">
                <a:pos x="0" y="20"/>
              </a:cxn>
              <a:cxn ang="0">
                <a:pos x="40" y="7956"/>
              </a:cxn>
              <a:cxn ang="0">
                <a:pos x="20" y="7936"/>
              </a:cxn>
              <a:cxn ang="0">
                <a:pos x="388" y="7936"/>
              </a:cxn>
              <a:cxn ang="0">
                <a:pos x="368" y="7956"/>
              </a:cxn>
              <a:cxn ang="0">
                <a:pos x="368" y="20"/>
              </a:cxn>
              <a:cxn ang="0">
                <a:pos x="388" y="40"/>
              </a:cxn>
              <a:cxn ang="0">
                <a:pos x="20" y="40"/>
              </a:cxn>
              <a:cxn ang="0">
                <a:pos x="40" y="20"/>
              </a:cxn>
              <a:cxn ang="0">
                <a:pos x="40" y="7956"/>
              </a:cxn>
            </a:cxnLst>
            <a:rect l="0" t="0" r="r" b="b"/>
            <a:pathLst>
              <a:path w="408" h="7976">
                <a:moveTo>
                  <a:pt x="0" y="20"/>
                </a:moveTo>
                <a:cubicBezTo>
                  <a:pt x="0" y="9"/>
                  <a:pt x="9" y="0"/>
                  <a:pt x="20" y="0"/>
                </a:cubicBezTo>
                <a:lnTo>
                  <a:pt x="388" y="0"/>
                </a:lnTo>
                <a:cubicBezTo>
                  <a:pt x="400" y="0"/>
                  <a:pt x="408" y="9"/>
                  <a:pt x="408" y="20"/>
                </a:cubicBezTo>
                <a:lnTo>
                  <a:pt x="408" y="7956"/>
                </a:lnTo>
                <a:cubicBezTo>
                  <a:pt x="408" y="7968"/>
                  <a:pt x="400" y="7976"/>
                  <a:pt x="388" y="7976"/>
                </a:cubicBezTo>
                <a:lnTo>
                  <a:pt x="20" y="7976"/>
                </a:lnTo>
                <a:cubicBezTo>
                  <a:pt x="9" y="7976"/>
                  <a:pt x="0" y="7968"/>
                  <a:pt x="0" y="7956"/>
                </a:cubicBezTo>
                <a:lnTo>
                  <a:pt x="0" y="20"/>
                </a:lnTo>
                <a:close/>
                <a:moveTo>
                  <a:pt x="40" y="7956"/>
                </a:moveTo>
                <a:lnTo>
                  <a:pt x="20" y="7936"/>
                </a:lnTo>
                <a:lnTo>
                  <a:pt x="388" y="7936"/>
                </a:lnTo>
                <a:lnTo>
                  <a:pt x="368" y="7956"/>
                </a:lnTo>
                <a:lnTo>
                  <a:pt x="368" y="20"/>
                </a:lnTo>
                <a:lnTo>
                  <a:pt x="388" y="40"/>
                </a:lnTo>
                <a:lnTo>
                  <a:pt x="20" y="40"/>
                </a:lnTo>
                <a:lnTo>
                  <a:pt x="40" y="20"/>
                </a:lnTo>
                <a:lnTo>
                  <a:pt x="40" y="7956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47" name="Rectangle 923"/>
          <p:cNvSpPr>
            <a:spLocks noChangeArrowheads="1"/>
          </p:cNvSpPr>
          <p:nvPr/>
        </p:nvSpPr>
        <p:spPr bwMode="auto">
          <a:xfrm>
            <a:off x="2095770" y="7679574"/>
            <a:ext cx="44501" cy="36826"/>
          </a:xfrm>
          <a:prstGeom prst="rect">
            <a:avLst/>
          </a:prstGeom>
          <a:solidFill>
            <a:srgbClr val="FFFF99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48" name="Freeform 924"/>
          <p:cNvSpPr>
            <a:spLocks noEditPoints="1"/>
          </p:cNvSpPr>
          <p:nvPr/>
        </p:nvSpPr>
        <p:spPr bwMode="auto">
          <a:xfrm>
            <a:off x="2093651" y="7677343"/>
            <a:ext cx="48739" cy="42406"/>
          </a:xfrm>
          <a:custGeom>
            <a:avLst/>
            <a:gdLst/>
            <a:ahLst/>
            <a:cxnLst>
              <a:cxn ang="0">
                <a:pos x="0" y="40"/>
              </a:cxn>
              <a:cxn ang="0">
                <a:pos x="40" y="0"/>
              </a:cxn>
              <a:cxn ang="0">
                <a:pos x="776" y="0"/>
              </a:cxn>
              <a:cxn ang="0">
                <a:pos x="816" y="40"/>
              </a:cxn>
              <a:cxn ang="0">
                <a:pos x="816" y="616"/>
              </a:cxn>
              <a:cxn ang="0">
                <a:pos x="776" y="656"/>
              </a:cxn>
              <a:cxn ang="0">
                <a:pos x="40" y="656"/>
              </a:cxn>
              <a:cxn ang="0">
                <a:pos x="0" y="616"/>
              </a:cxn>
              <a:cxn ang="0">
                <a:pos x="0" y="40"/>
              </a:cxn>
              <a:cxn ang="0">
                <a:pos x="80" y="616"/>
              </a:cxn>
              <a:cxn ang="0">
                <a:pos x="40" y="576"/>
              </a:cxn>
              <a:cxn ang="0">
                <a:pos x="776" y="576"/>
              </a:cxn>
              <a:cxn ang="0">
                <a:pos x="736" y="616"/>
              </a:cxn>
              <a:cxn ang="0">
                <a:pos x="736" y="40"/>
              </a:cxn>
              <a:cxn ang="0">
                <a:pos x="776" y="80"/>
              </a:cxn>
              <a:cxn ang="0">
                <a:pos x="40" y="80"/>
              </a:cxn>
              <a:cxn ang="0">
                <a:pos x="80" y="40"/>
              </a:cxn>
              <a:cxn ang="0">
                <a:pos x="80" y="616"/>
              </a:cxn>
            </a:cxnLst>
            <a:rect l="0" t="0" r="r" b="b"/>
            <a:pathLst>
              <a:path w="816" h="656">
                <a:moveTo>
                  <a:pt x="0" y="40"/>
                </a:moveTo>
                <a:cubicBezTo>
                  <a:pt x="0" y="18"/>
                  <a:pt x="18" y="0"/>
                  <a:pt x="40" y="0"/>
                </a:cubicBezTo>
                <a:lnTo>
                  <a:pt x="776" y="0"/>
                </a:lnTo>
                <a:cubicBezTo>
                  <a:pt x="799" y="0"/>
                  <a:pt x="816" y="18"/>
                  <a:pt x="816" y="40"/>
                </a:cubicBezTo>
                <a:lnTo>
                  <a:pt x="816" y="616"/>
                </a:lnTo>
                <a:cubicBezTo>
                  <a:pt x="816" y="639"/>
                  <a:pt x="799" y="656"/>
                  <a:pt x="776" y="656"/>
                </a:cubicBezTo>
                <a:lnTo>
                  <a:pt x="40" y="656"/>
                </a:lnTo>
                <a:cubicBezTo>
                  <a:pt x="18" y="656"/>
                  <a:pt x="0" y="639"/>
                  <a:pt x="0" y="616"/>
                </a:cubicBezTo>
                <a:lnTo>
                  <a:pt x="0" y="40"/>
                </a:lnTo>
                <a:close/>
                <a:moveTo>
                  <a:pt x="80" y="616"/>
                </a:moveTo>
                <a:lnTo>
                  <a:pt x="40" y="576"/>
                </a:lnTo>
                <a:lnTo>
                  <a:pt x="776" y="576"/>
                </a:lnTo>
                <a:lnTo>
                  <a:pt x="736" y="616"/>
                </a:lnTo>
                <a:lnTo>
                  <a:pt x="736" y="40"/>
                </a:lnTo>
                <a:lnTo>
                  <a:pt x="776" y="80"/>
                </a:lnTo>
                <a:lnTo>
                  <a:pt x="40" y="80"/>
                </a:lnTo>
                <a:lnTo>
                  <a:pt x="80" y="40"/>
                </a:lnTo>
                <a:lnTo>
                  <a:pt x="80" y="616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49" name="Rectangle 925"/>
          <p:cNvSpPr>
            <a:spLocks noChangeArrowheads="1"/>
          </p:cNvSpPr>
          <p:nvPr/>
        </p:nvSpPr>
        <p:spPr bwMode="auto">
          <a:xfrm>
            <a:off x="2227153" y="7661719"/>
            <a:ext cx="43441" cy="54681"/>
          </a:xfrm>
          <a:prstGeom prst="rect">
            <a:avLst/>
          </a:prstGeom>
          <a:solidFill>
            <a:srgbClr val="FFFF99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50" name="Freeform 926"/>
          <p:cNvSpPr>
            <a:spLocks noEditPoints="1"/>
          </p:cNvSpPr>
          <p:nvPr/>
        </p:nvSpPr>
        <p:spPr bwMode="auto">
          <a:xfrm>
            <a:off x="2223974" y="7659487"/>
            <a:ext cx="48739" cy="60261"/>
          </a:xfrm>
          <a:custGeom>
            <a:avLst/>
            <a:gdLst/>
            <a:ahLst/>
            <a:cxnLst>
              <a:cxn ang="0">
                <a:pos x="0" y="40"/>
              </a:cxn>
              <a:cxn ang="0">
                <a:pos x="40" y="0"/>
              </a:cxn>
              <a:cxn ang="0">
                <a:pos x="776" y="0"/>
              </a:cxn>
              <a:cxn ang="0">
                <a:pos x="816" y="40"/>
              </a:cxn>
              <a:cxn ang="0">
                <a:pos x="816" y="888"/>
              </a:cxn>
              <a:cxn ang="0">
                <a:pos x="776" y="928"/>
              </a:cxn>
              <a:cxn ang="0">
                <a:pos x="40" y="928"/>
              </a:cxn>
              <a:cxn ang="0">
                <a:pos x="0" y="888"/>
              </a:cxn>
              <a:cxn ang="0">
                <a:pos x="0" y="40"/>
              </a:cxn>
              <a:cxn ang="0">
                <a:pos x="80" y="888"/>
              </a:cxn>
              <a:cxn ang="0">
                <a:pos x="40" y="848"/>
              </a:cxn>
              <a:cxn ang="0">
                <a:pos x="776" y="848"/>
              </a:cxn>
              <a:cxn ang="0">
                <a:pos x="736" y="888"/>
              </a:cxn>
              <a:cxn ang="0">
                <a:pos x="736" y="40"/>
              </a:cxn>
              <a:cxn ang="0">
                <a:pos x="776" y="80"/>
              </a:cxn>
              <a:cxn ang="0">
                <a:pos x="40" y="80"/>
              </a:cxn>
              <a:cxn ang="0">
                <a:pos x="80" y="40"/>
              </a:cxn>
              <a:cxn ang="0">
                <a:pos x="80" y="888"/>
              </a:cxn>
            </a:cxnLst>
            <a:rect l="0" t="0" r="r" b="b"/>
            <a:pathLst>
              <a:path w="816" h="928">
                <a:moveTo>
                  <a:pt x="0" y="40"/>
                </a:moveTo>
                <a:cubicBezTo>
                  <a:pt x="0" y="18"/>
                  <a:pt x="18" y="0"/>
                  <a:pt x="40" y="0"/>
                </a:cubicBezTo>
                <a:lnTo>
                  <a:pt x="776" y="0"/>
                </a:lnTo>
                <a:cubicBezTo>
                  <a:pt x="799" y="0"/>
                  <a:pt x="816" y="18"/>
                  <a:pt x="816" y="40"/>
                </a:cubicBezTo>
                <a:lnTo>
                  <a:pt x="816" y="888"/>
                </a:lnTo>
                <a:cubicBezTo>
                  <a:pt x="816" y="911"/>
                  <a:pt x="799" y="928"/>
                  <a:pt x="776" y="928"/>
                </a:cubicBezTo>
                <a:lnTo>
                  <a:pt x="40" y="928"/>
                </a:lnTo>
                <a:cubicBezTo>
                  <a:pt x="18" y="928"/>
                  <a:pt x="0" y="911"/>
                  <a:pt x="0" y="888"/>
                </a:cubicBezTo>
                <a:lnTo>
                  <a:pt x="0" y="40"/>
                </a:lnTo>
                <a:close/>
                <a:moveTo>
                  <a:pt x="80" y="888"/>
                </a:moveTo>
                <a:lnTo>
                  <a:pt x="40" y="848"/>
                </a:lnTo>
                <a:lnTo>
                  <a:pt x="776" y="848"/>
                </a:lnTo>
                <a:lnTo>
                  <a:pt x="736" y="888"/>
                </a:lnTo>
                <a:lnTo>
                  <a:pt x="736" y="40"/>
                </a:lnTo>
                <a:lnTo>
                  <a:pt x="776" y="80"/>
                </a:lnTo>
                <a:lnTo>
                  <a:pt x="40" y="80"/>
                </a:lnTo>
                <a:lnTo>
                  <a:pt x="80" y="40"/>
                </a:lnTo>
                <a:lnTo>
                  <a:pt x="80" y="888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51" name="Rectangle 927"/>
          <p:cNvSpPr>
            <a:spLocks noChangeArrowheads="1"/>
          </p:cNvSpPr>
          <p:nvPr/>
        </p:nvSpPr>
        <p:spPr bwMode="auto">
          <a:xfrm>
            <a:off x="2357476" y="7673994"/>
            <a:ext cx="43441" cy="42406"/>
          </a:xfrm>
          <a:prstGeom prst="rect">
            <a:avLst/>
          </a:prstGeom>
          <a:solidFill>
            <a:srgbClr val="FFFF99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52" name="Freeform 928"/>
          <p:cNvSpPr>
            <a:spLocks noEditPoints="1"/>
          </p:cNvSpPr>
          <p:nvPr/>
        </p:nvSpPr>
        <p:spPr bwMode="auto">
          <a:xfrm>
            <a:off x="2355357" y="7670647"/>
            <a:ext cx="47680" cy="49102"/>
          </a:xfrm>
          <a:custGeom>
            <a:avLst/>
            <a:gdLst/>
            <a:ahLst/>
            <a:cxnLst>
              <a:cxn ang="0">
                <a:pos x="0" y="40"/>
              </a:cxn>
              <a:cxn ang="0">
                <a:pos x="40" y="0"/>
              </a:cxn>
              <a:cxn ang="0">
                <a:pos x="768" y="0"/>
              </a:cxn>
              <a:cxn ang="0">
                <a:pos x="808" y="40"/>
              </a:cxn>
              <a:cxn ang="0">
                <a:pos x="808" y="704"/>
              </a:cxn>
              <a:cxn ang="0">
                <a:pos x="768" y="744"/>
              </a:cxn>
              <a:cxn ang="0">
                <a:pos x="40" y="744"/>
              </a:cxn>
              <a:cxn ang="0">
                <a:pos x="0" y="704"/>
              </a:cxn>
              <a:cxn ang="0">
                <a:pos x="0" y="40"/>
              </a:cxn>
              <a:cxn ang="0">
                <a:pos x="80" y="704"/>
              </a:cxn>
              <a:cxn ang="0">
                <a:pos x="40" y="664"/>
              </a:cxn>
              <a:cxn ang="0">
                <a:pos x="768" y="664"/>
              </a:cxn>
              <a:cxn ang="0">
                <a:pos x="728" y="704"/>
              </a:cxn>
              <a:cxn ang="0">
                <a:pos x="728" y="40"/>
              </a:cxn>
              <a:cxn ang="0">
                <a:pos x="768" y="80"/>
              </a:cxn>
              <a:cxn ang="0">
                <a:pos x="40" y="80"/>
              </a:cxn>
              <a:cxn ang="0">
                <a:pos x="80" y="40"/>
              </a:cxn>
              <a:cxn ang="0">
                <a:pos x="80" y="704"/>
              </a:cxn>
            </a:cxnLst>
            <a:rect l="0" t="0" r="r" b="b"/>
            <a:pathLst>
              <a:path w="808" h="744">
                <a:moveTo>
                  <a:pt x="0" y="40"/>
                </a:moveTo>
                <a:cubicBezTo>
                  <a:pt x="0" y="18"/>
                  <a:pt x="18" y="0"/>
                  <a:pt x="40" y="0"/>
                </a:cubicBezTo>
                <a:lnTo>
                  <a:pt x="768" y="0"/>
                </a:lnTo>
                <a:cubicBezTo>
                  <a:pt x="791" y="0"/>
                  <a:pt x="808" y="18"/>
                  <a:pt x="808" y="40"/>
                </a:cubicBezTo>
                <a:lnTo>
                  <a:pt x="808" y="704"/>
                </a:lnTo>
                <a:cubicBezTo>
                  <a:pt x="808" y="727"/>
                  <a:pt x="791" y="744"/>
                  <a:pt x="768" y="744"/>
                </a:cubicBezTo>
                <a:lnTo>
                  <a:pt x="40" y="744"/>
                </a:lnTo>
                <a:cubicBezTo>
                  <a:pt x="18" y="744"/>
                  <a:pt x="0" y="727"/>
                  <a:pt x="0" y="704"/>
                </a:cubicBezTo>
                <a:lnTo>
                  <a:pt x="0" y="40"/>
                </a:lnTo>
                <a:close/>
                <a:moveTo>
                  <a:pt x="80" y="704"/>
                </a:moveTo>
                <a:lnTo>
                  <a:pt x="40" y="664"/>
                </a:lnTo>
                <a:lnTo>
                  <a:pt x="768" y="664"/>
                </a:lnTo>
                <a:lnTo>
                  <a:pt x="728" y="704"/>
                </a:lnTo>
                <a:lnTo>
                  <a:pt x="728" y="40"/>
                </a:lnTo>
                <a:lnTo>
                  <a:pt x="768" y="80"/>
                </a:lnTo>
                <a:lnTo>
                  <a:pt x="40" y="80"/>
                </a:lnTo>
                <a:lnTo>
                  <a:pt x="80" y="40"/>
                </a:lnTo>
                <a:lnTo>
                  <a:pt x="80" y="704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53" name="Rectangle 929"/>
          <p:cNvSpPr>
            <a:spLocks noChangeArrowheads="1"/>
          </p:cNvSpPr>
          <p:nvPr/>
        </p:nvSpPr>
        <p:spPr bwMode="auto">
          <a:xfrm>
            <a:off x="2619182" y="7695198"/>
            <a:ext cx="43441" cy="21203"/>
          </a:xfrm>
          <a:prstGeom prst="rect">
            <a:avLst/>
          </a:prstGeom>
          <a:solidFill>
            <a:srgbClr val="FFFF99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54" name="Freeform 930"/>
          <p:cNvSpPr>
            <a:spLocks noEditPoints="1"/>
          </p:cNvSpPr>
          <p:nvPr/>
        </p:nvSpPr>
        <p:spPr bwMode="auto">
          <a:xfrm>
            <a:off x="2617063" y="7692966"/>
            <a:ext cx="47680" cy="26783"/>
          </a:xfrm>
          <a:custGeom>
            <a:avLst/>
            <a:gdLst/>
            <a:ahLst/>
            <a:cxnLst>
              <a:cxn ang="0">
                <a:pos x="0" y="40"/>
              </a:cxn>
              <a:cxn ang="0">
                <a:pos x="40" y="0"/>
              </a:cxn>
              <a:cxn ang="0">
                <a:pos x="776" y="0"/>
              </a:cxn>
              <a:cxn ang="0">
                <a:pos x="816" y="40"/>
              </a:cxn>
              <a:cxn ang="0">
                <a:pos x="816" y="368"/>
              </a:cxn>
              <a:cxn ang="0">
                <a:pos x="776" y="408"/>
              </a:cxn>
              <a:cxn ang="0">
                <a:pos x="40" y="408"/>
              </a:cxn>
              <a:cxn ang="0">
                <a:pos x="0" y="368"/>
              </a:cxn>
              <a:cxn ang="0">
                <a:pos x="0" y="40"/>
              </a:cxn>
              <a:cxn ang="0">
                <a:pos x="80" y="368"/>
              </a:cxn>
              <a:cxn ang="0">
                <a:pos x="40" y="328"/>
              </a:cxn>
              <a:cxn ang="0">
                <a:pos x="776" y="328"/>
              </a:cxn>
              <a:cxn ang="0">
                <a:pos x="736" y="368"/>
              </a:cxn>
              <a:cxn ang="0">
                <a:pos x="736" y="40"/>
              </a:cxn>
              <a:cxn ang="0">
                <a:pos x="776" y="80"/>
              </a:cxn>
              <a:cxn ang="0">
                <a:pos x="40" y="80"/>
              </a:cxn>
              <a:cxn ang="0">
                <a:pos x="80" y="40"/>
              </a:cxn>
              <a:cxn ang="0">
                <a:pos x="80" y="368"/>
              </a:cxn>
            </a:cxnLst>
            <a:rect l="0" t="0" r="r" b="b"/>
            <a:pathLst>
              <a:path w="816" h="408">
                <a:moveTo>
                  <a:pt x="0" y="40"/>
                </a:moveTo>
                <a:cubicBezTo>
                  <a:pt x="0" y="18"/>
                  <a:pt x="18" y="0"/>
                  <a:pt x="40" y="0"/>
                </a:cubicBezTo>
                <a:lnTo>
                  <a:pt x="776" y="0"/>
                </a:lnTo>
                <a:cubicBezTo>
                  <a:pt x="799" y="0"/>
                  <a:pt x="816" y="18"/>
                  <a:pt x="816" y="40"/>
                </a:cubicBezTo>
                <a:lnTo>
                  <a:pt x="816" y="368"/>
                </a:lnTo>
                <a:cubicBezTo>
                  <a:pt x="816" y="391"/>
                  <a:pt x="799" y="408"/>
                  <a:pt x="776" y="408"/>
                </a:cubicBezTo>
                <a:lnTo>
                  <a:pt x="40" y="408"/>
                </a:lnTo>
                <a:cubicBezTo>
                  <a:pt x="18" y="408"/>
                  <a:pt x="0" y="391"/>
                  <a:pt x="0" y="368"/>
                </a:cubicBezTo>
                <a:lnTo>
                  <a:pt x="0" y="40"/>
                </a:lnTo>
                <a:close/>
                <a:moveTo>
                  <a:pt x="80" y="368"/>
                </a:moveTo>
                <a:lnTo>
                  <a:pt x="40" y="328"/>
                </a:lnTo>
                <a:lnTo>
                  <a:pt x="776" y="328"/>
                </a:lnTo>
                <a:lnTo>
                  <a:pt x="736" y="368"/>
                </a:lnTo>
                <a:lnTo>
                  <a:pt x="736" y="40"/>
                </a:lnTo>
                <a:lnTo>
                  <a:pt x="776" y="80"/>
                </a:lnTo>
                <a:lnTo>
                  <a:pt x="40" y="80"/>
                </a:lnTo>
                <a:lnTo>
                  <a:pt x="80" y="40"/>
                </a:lnTo>
                <a:lnTo>
                  <a:pt x="80" y="368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55" name="Rectangle 931"/>
          <p:cNvSpPr>
            <a:spLocks noChangeArrowheads="1"/>
          </p:cNvSpPr>
          <p:nvPr/>
        </p:nvSpPr>
        <p:spPr bwMode="auto">
          <a:xfrm>
            <a:off x="2880888" y="7592530"/>
            <a:ext cx="43441" cy="123870"/>
          </a:xfrm>
          <a:prstGeom prst="rect">
            <a:avLst/>
          </a:prstGeom>
          <a:solidFill>
            <a:srgbClr val="FFFF99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56" name="Freeform 932"/>
          <p:cNvSpPr>
            <a:spLocks noEditPoints="1"/>
          </p:cNvSpPr>
          <p:nvPr/>
        </p:nvSpPr>
        <p:spPr bwMode="auto">
          <a:xfrm>
            <a:off x="2878769" y="7589182"/>
            <a:ext cx="47680" cy="130566"/>
          </a:xfrm>
          <a:custGeom>
            <a:avLst/>
            <a:gdLst/>
            <a:ahLst/>
            <a:cxnLst>
              <a:cxn ang="0">
                <a:pos x="0" y="40"/>
              </a:cxn>
              <a:cxn ang="0">
                <a:pos x="40" y="0"/>
              </a:cxn>
              <a:cxn ang="0">
                <a:pos x="768" y="0"/>
              </a:cxn>
              <a:cxn ang="0">
                <a:pos x="808" y="40"/>
              </a:cxn>
              <a:cxn ang="0">
                <a:pos x="808" y="1960"/>
              </a:cxn>
              <a:cxn ang="0">
                <a:pos x="768" y="2000"/>
              </a:cxn>
              <a:cxn ang="0">
                <a:pos x="40" y="2000"/>
              </a:cxn>
              <a:cxn ang="0">
                <a:pos x="0" y="1960"/>
              </a:cxn>
              <a:cxn ang="0">
                <a:pos x="0" y="40"/>
              </a:cxn>
              <a:cxn ang="0">
                <a:pos x="80" y="1960"/>
              </a:cxn>
              <a:cxn ang="0">
                <a:pos x="40" y="1920"/>
              </a:cxn>
              <a:cxn ang="0">
                <a:pos x="768" y="1920"/>
              </a:cxn>
              <a:cxn ang="0">
                <a:pos x="728" y="1960"/>
              </a:cxn>
              <a:cxn ang="0">
                <a:pos x="728" y="40"/>
              </a:cxn>
              <a:cxn ang="0">
                <a:pos x="768" y="80"/>
              </a:cxn>
              <a:cxn ang="0">
                <a:pos x="40" y="80"/>
              </a:cxn>
              <a:cxn ang="0">
                <a:pos x="80" y="40"/>
              </a:cxn>
              <a:cxn ang="0">
                <a:pos x="80" y="1960"/>
              </a:cxn>
            </a:cxnLst>
            <a:rect l="0" t="0" r="r" b="b"/>
            <a:pathLst>
              <a:path w="808" h="2000">
                <a:moveTo>
                  <a:pt x="0" y="40"/>
                </a:moveTo>
                <a:cubicBezTo>
                  <a:pt x="0" y="18"/>
                  <a:pt x="18" y="0"/>
                  <a:pt x="40" y="0"/>
                </a:cubicBezTo>
                <a:lnTo>
                  <a:pt x="768" y="0"/>
                </a:lnTo>
                <a:cubicBezTo>
                  <a:pt x="791" y="0"/>
                  <a:pt x="808" y="18"/>
                  <a:pt x="808" y="40"/>
                </a:cubicBezTo>
                <a:lnTo>
                  <a:pt x="808" y="1960"/>
                </a:lnTo>
                <a:cubicBezTo>
                  <a:pt x="808" y="1983"/>
                  <a:pt x="791" y="2000"/>
                  <a:pt x="768" y="2000"/>
                </a:cubicBezTo>
                <a:lnTo>
                  <a:pt x="40" y="2000"/>
                </a:lnTo>
                <a:cubicBezTo>
                  <a:pt x="18" y="2000"/>
                  <a:pt x="0" y="1983"/>
                  <a:pt x="0" y="1960"/>
                </a:cubicBezTo>
                <a:lnTo>
                  <a:pt x="0" y="40"/>
                </a:lnTo>
                <a:close/>
                <a:moveTo>
                  <a:pt x="80" y="1960"/>
                </a:moveTo>
                <a:lnTo>
                  <a:pt x="40" y="1920"/>
                </a:lnTo>
                <a:lnTo>
                  <a:pt x="768" y="1920"/>
                </a:lnTo>
                <a:lnTo>
                  <a:pt x="728" y="1960"/>
                </a:lnTo>
                <a:lnTo>
                  <a:pt x="728" y="40"/>
                </a:lnTo>
                <a:lnTo>
                  <a:pt x="768" y="80"/>
                </a:lnTo>
                <a:lnTo>
                  <a:pt x="40" y="80"/>
                </a:lnTo>
                <a:lnTo>
                  <a:pt x="80" y="40"/>
                </a:lnTo>
                <a:lnTo>
                  <a:pt x="80" y="196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57" name="Rectangle 933"/>
          <p:cNvSpPr>
            <a:spLocks noChangeArrowheads="1"/>
          </p:cNvSpPr>
          <p:nvPr/>
        </p:nvSpPr>
        <p:spPr bwMode="auto">
          <a:xfrm>
            <a:off x="3142594" y="7384963"/>
            <a:ext cx="43441" cy="331437"/>
          </a:xfrm>
          <a:prstGeom prst="rect">
            <a:avLst/>
          </a:prstGeom>
          <a:solidFill>
            <a:srgbClr val="FFFF99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58" name="Freeform 934"/>
          <p:cNvSpPr>
            <a:spLocks noEditPoints="1"/>
          </p:cNvSpPr>
          <p:nvPr/>
        </p:nvSpPr>
        <p:spPr bwMode="auto">
          <a:xfrm>
            <a:off x="3139416" y="7381615"/>
            <a:ext cx="48739" cy="338133"/>
          </a:xfrm>
          <a:custGeom>
            <a:avLst/>
            <a:gdLst/>
            <a:ahLst/>
            <a:cxnLst>
              <a:cxn ang="0">
                <a:pos x="0" y="40"/>
              </a:cxn>
              <a:cxn ang="0">
                <a:pos x="40" y="0"/>
              </a:cxn>
              <a:cxn ang="0">
                <a:pos x="776" y="0"/>
              </a:cxn>
              <a:cxn ang="0">
                <a:pos x="816" y="40"/>
              </a:cxn>
              <a:cxn ang="0">
                <a:pos x="816" y="5152"/>
              </a:cxn>
              <a:cxn ang="0">
                <a:pos x="776" y="5192"/>
              </a:cxn>
              <a:cxn ang="0">
                <a:pos x="40" y="5192"/>
              </a:cxn>
              <a:cxn ang="0">
                <a:pos x="0" y="5152"/>
              </a:cxn>
              <a:cxn ang="0">
                <a:pos x="0" y="40"/>
              </a:cxn>
              <a:cxn ang="0">
                <a:pos x="80" y="5152"/>
              </a:cxn>
              <a:cxn ang="0">
                <a:pos x="40" y="5112"/>
              </a:cxn>
              <a:cxn ang="0">
                <a:pos x="776" y="5112"/>
              </a:cxn>
              <a:cxn ang="0">
                <a:pos x="736" y="5152"/>
              </a:cxn>
              <a:cxn ang="0">
                <a:pos x="736" y="40"/>
              </a:cxn>
              <a:cxn ang="0">
                <a:pos x="776" y="80"/>
              </a:cxn>
              <a:cxn ang="0">
                <a:pos x="40" y="80"/>
              </a:cxn>
              <a:cxn ang="0">
                <a:pos x="80" y="40"/>
              </a:cxn>
              <a:cxn ang="0">
                <a:pos x="80" y="5152"/>
              </a:cxn>
            </a:cxnLst>
            <a:rect l="0" t="0" r="r" b="b"/>
            <a:pathLst>
              <a:path w="816" h="5192">
                <a:moveTo>
                  <a:pt x="0" y="40"/>
                </a:moveTo>
                <a:cubicBezTo>
                  <a:pt x="0" y="18"/>
                  <a:pt x="18" y="0"/>
                  <a:pt x="40" y="0"/>
                </a:cubicBezTo>
                <a:lnTo>
                  <a:pt x="776" y="0"/>
                </a:lnTo>
                <a:cubicBezTo>
                  <a:pt x="799" y="0"/>
                  <a:pt x="816" y="18"/>
                  <a:pt x="816" y="40"/>
                </a:cubicBezTo>
                <a:lnTo>
                  <a:pt x="816" y="5152"/>
                </a:lnTo>
                <a:cubicBezTo>
                  <a:pt x="816" y="5175"/>
                  <a:pt x="799" y="5192"/>
                  <a:pt x="776" y="5192"/>
                </a:cubicBezTo>
                <a:lnTo>
                  <a:pt x="40" y="5192"/>
                </a:lnTo>
                <a:cubicBezTo>
                  <a:pt x="18" y="5192"/>
                  <a:pt x="0" y="5175"/>
                  <a:pt x="0" y="5152"/>
                </a:cubicBezTo>
                <a:lnTo>
                  <a:pt x="0" y="40"/>
                </a:lnTo>
                <a:close/>
                <a:moveTo>
                  <a:pt x="80" y="5152"/>
                </a:moveTo>
                <a:lnTo>
                  <a:pt x="40" y="5112"/>
                </a:lnTo>
                <a:lnTo>
                  <a:pt x="776" y="5112"/>
                </a:lnTo>
                <a:lnTo>
                  <a:pt x="736" y="5152"/>
                </a:lnTo>
                <a:lnTo>
                  <a:pt x="736" y="40"/>
                </a:lnTo>
                <a:lnTo>
                  <a:pt x="776" y="80"/>
                </a:lnTo>
                <a:lnTo>
                  <a:pt x="40" y="80"/>
                </a:lnTo>
                <a:lnTo>
                  <a:pt x="80" y="40"/>
                </a:lnTo>
                <a:lnTo>
                  <a:pt x="80" y="5152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59" name="Rectangle 935"/>
          <p:cNvSpPr>
            <a:spLocks noChangeArrowheads="1"/>
          </p:cNvSpPr>
          <p:nvPr/>
        </p:nvSpPr>
        <p:spPr bwMode="auto">
          <a:xfrm>
            <a:off x="3272917" y="7641632"/>
            <a:ext cx="43441" cy="74768"/>
          </a:xfrm>
          <a:prstGeom prst="rect">
            <a:avLst/>
          </a:prstGeom>
          <a:solidFill>
            <a:srgbClr val="FFFF99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60" name="Freeform 936"/>
          <p:cNvSpPr>
            <a:spLocks noEditPoints="1"/>
          </p:cNvSpPr>
          <p:nvPr/>
        </p:nvSpPr>
        <p:spPr bwMode="auto">
          <a:xfrm>
            <a:off x="3270798" y="7638284"/>
            <a:ext cx="47680" cy="81464"/>
          </a:xfrm>
          <a:custGeom>
            <a:avLst/>
            <a:gdLst/>
            <a:ahLst/>
            <a:cxnLst>
              <a:cxn ang="0">
                <a:pos x="0" y="40"/>
              </a:cxn>
              <a:cxn ang="0">
                <a:pos x="40" y="0"/>
              </a:cxn>
              <a:cxn ang="0">
                <a:pos x="768" y="0"/>
              </a:cxn>
              <a:cxn ang="0">
                <a:pos x="808" y="40"/>
              </a:cxn>
              <a:cxn ang="0">
                <a:pos x="808" y="1200"/>
              </a:cxn>
              <a:cxn ang="0">
                <a:pos x="768" y="1240"/>
              </a:cxn>
              <a:cxn ang="0">
                <a:pos x="40" y="1240"/>
              </a:cxn>
              <a:cxn ang="0">
                <a:pos x="0" y="1200"/>
              </a:cxn>
              <a:cxn ang="0">
                <a:pos x="0" y="40"/>
              </a:cxn>
              <a:cxn ang="0">
                <a:pos x="80" y="1200"/>
              </a:cxn>
              <a:cxn ang="0">
                <a:pos x="40" y="1160"/>
              </a:cxn>
              <a:cxn ang="0">
                <a:pos x="768" y="1160"/>
              </a:cxn>
              <a:cxn ang="0">
                <a:pos x="728" y="1200"/>
              </a:cxn>
              <a:cxn ang="0">
                <a:pos x="728" y="40"/>
              </a:cxn>
              <a:cxn ang="0">
                <a:pos x="768" y="80"/>
              </a:cxn>
              <a:cxn ang="0">
                <a:pos x="40" y="80"/>
              </a:cxn>
              <a:cxn ang="0">
                <a:pos x="80" y="40"/>
              </a:cxn>
              <a:cxn ang="0">
                <a:pos x="80" y="1200"/>
              </a:cxn>
            </a:cxnLst>
            <a:rect l="0" t="0" r="r" b="b"/>
            <a:pathLst>
              <a:path w="808" h="1240">
                <a:moveTo>
                  <a:pt x="0" y="40"/>
                </a:moveTo>
                <a:cubicBezTo>
                  <a:pt x="0" y="18"/>
                  <a:pt x="18" y="0"/>
                  <a:pt x="40" y="0"/>
                </a:cubicBezTo>
                <a:lnTo>
                  <a:pt x="768" y="0"/>
                </a:lnTo>
                <a:cubicBezTo>
                  <a:pt x="791" y="0"/>
                  <a:pt x="808" y="18"/>
                  <a:pt x="808" y="40"/>
                </a:cubicBezTo>
                <a:lnTo>
                  <a:pt x="808" y="1200"/>
                </a:lnTo>
                <a:cubicBezTo>
                  <a:pt x="808" y="1223"/>
                  <a:pt x="791" y="1240"/>
                  <a:pt x="768" y="1240"/>
                </a:cubicBezTo>
                <a:lnTo>
                  <a:pt x="40" y="1240"/>
                </a:lnTo>
                <a:cubicBezTo>
                  <a:pt x="18" y="1240"/>
                  <a:pt x="0" y="1223"/>
                  <a:pt x="0" y="1200"/>
                </a:cubicBezTo>
                <a:lnTo>
                  <a:pt x="0" y="40"/>
                </a:lnTo>
                <a:close/>
                <a:moveTo>
                  <a:pt x="80" y="1200"/>
                </a:moveTo>
                <a:lnTo>
                  <a:pt x="40" y="1160"/>
                </a:lnTo>
                <a:lnTo>
                  <a:pt x="768" y="1160"/>
                </a:lnTo>
                <a:lnTo>
                  <a:pt x="728" y="1200"/>
                </a:lnTo>
                <a:lnTo>
                  <a:pt x="728" y="40"/>
                </a:lnTo>
                <a:lnTo>
                  <a:pt x="768" y="80"/>
                </a:lnTo>
                <a:lnTo>
                  <a:pt x="40" y="80"/>
                </a:lnTo>
                <a:lnTo>
                  <a:pt x="80" y="40"/>
                </a:lnTo>
                <a:lnTo>
                  <a:pt x="80" y="120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61" name="Rectangle 937"/>
          <p:cNvSpPr>
            <a:spLocks noChangeArrowheads="1"/>
          </p:cNvSpPr>
          <p:nvPr/>
        </p:nvSpPr>
        <p:spPr bwMode="auto">
          <a:xfrm>
            <a:off x="3404300" y="7699662"/>
            <a:ext cx="43441" cy="16739"/>
          </a:xfrm>
          <a:prstGeom prst="rect">
            <a:avLst/>
          </a:prstGeom>
          <a:solidFill>
            <a:srgbClr val="FFFF99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62" name="Freeform 938"/>
          <p:cNvSpPr>
            <a:spLocks noEditPoints="1"/>
          </p:cNvSpPr>
          <p:nvPr/>
        </p:nvSpPr>
        <p:spPr bwMode="auto">
          <a:xfrm>
            <a:off x="3401122" y="7697430"/>
            <a:ext cx="48739" cy="22319"/>
          </a:xfrm>
          <a:custGeom>
            <a:avLst/>
            <a:gdLst/>
            <a:ahLst/>
            <a:cxnLst>
              <a:cxn ang="0">
                <a:pos x="0" y="40"/>
              </a:cxn>
              <a:cxn ang="0">
                <a:pos x="40" y="0"/>
              </a:cxn>
              <a:cxn ang="0">
                <a:pos x="776" y="0"/>
              </a:cxn>
              <a:cxn ang="0">
                <a:pos x="816" y="40"/>
              </a:cxn>
              <a:cxn ang="0">
                <a:pos x="816" y="296"/>
              </a:cxn>
              <a:cxn ang="0">
                <a:pos x="776" y="336"/>
              </a:cxn>
              <a:cxn ang="0">
                <a:pos x="40" y="336"/>
              </a:cxn>
              <a:cxn ang="0">
                <a:pos x="0" y="296"/>
              </a:cxn>
              <a:cxn ang="0">
                <a:pos x="0" y="40"/>
              </a:cxn>
              <a:cxn ang="0">
                <a:pos x="80" y="296"/>
              </a:cxn>
              <a:cxn ang="0">
                <a:pos x="40" y="256"/>
              </a:cxn>
              <a:cxn ang="0">
                <a:pos x="776" y="256"/>
              </a:cxn>
              <a:cxn ang="0">
                <a:pos x="736" y="296"/>
              </a:cxn>
              <a:cxn ang="0">
                <a:pos x="736" y="40"/>
              </a:cxn>
              <a:cxn ang="0">
                <a:pos x="776" y="80"/>
              </a:cxn>
              <a:cxn ang="0">
                <a:pos x="40" y="80"/>
              </a:cxn>
              <a:cxn ang="0">
                <a:pos x="80" y="40"/>
              </a:cxn>
              <a:cxn ang="0">
                <a:pos x="80" y="296"/>
              </a:cxn>
            </a:cxnLst>
            <a:rect l="0" t="0" r="r" b="b"/>
            <a:pathLst>
              <a:path w="816" h="336">
                <a:moveTo>
                  <a:pt x="0" y="40"/>
                </a:moveTo>
                <a:cubicBezTo>
                  <a:pt x="0" y="18"/>
                  <a:pt x="18" y="0"/>
                  <a:pt x="40" y="0"/>
                </a:cubicBezTo>
                <a:lnTo>
                  <a:pt x="776" y="0"/>
                </a:lnTo>
                <a:cubicBezTo>
                  <a:pt x="799" y="0"/>
                  <a:pt x="816" y="18"/>
                  <a:pt x="816" y="40"/>
                </a:cubicBezTo>
                <a:lnTo>
                  <a:pt x="816" y="296"/>
                </a:lnTo>
                <a:cubicBezTo>
                  <a:pt x="816" y="319"/>
                  <a:pt x="799" y="336"/>
                  <a:pt x="776" y="336"/>
                </a:cubicBezTo>
                <a:lnTo>
                  <a:pt x="40" y="336"/>
                </a:lnTo>
                <a:cubicBezTo>
                  <a:pt x="18" y="336"/>
                  <a:pt x="0" y="319"/>
                  <a:pt x="0" y="296"/>
                </a:cubicBezTo>
                <a:lnTo>
                  <a:pt x="0" y="40"/>
                </a:lnTo>
                <a:close/>
                <a:moveTo>
                  <a:pt x="80" y="296"/>
                </a:moveTo>
                <a:lnTo>
                  <a:pt x="40" y="256"/>
                </a:lnTo>
                <a:lnTo>
                  <a:pt x="776" y="256"/>
                </a:lnTo>
                <a:lnTo>
                  <a:pt x="736" y="296"/>
                </a:lnTo>
                <a:lnTo>
                  <a:pt x="736" y="40"/>
                </a:lnTo>
                <a:lnTo>
                  <a:pt x="776" y="80"/>
                </a:lnTo>
                <a:lnTo>
                  <a:pt x="40" y="80"/>
                </a:lnTo>
                <a:lnTo>
                  <a:pt x="80" y="40"/>
                </a:lnTo>
                <a:lnTo>
                  <a:pt x="80" y="296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63" name="Rectangle 939"/>
          <p:cNvSpPr>
            <a:spLocks noChangeArrowheads="1"/>
          </p:cNvSpPr>
          <p:nvPr/>
        </p:nvSpPr>
        <p:spPr bwMode="auto">
          <a:xfrm>
            <a:off x="3534624" y="7605922"/>
            <a:ext cx="43441" cy="110479"/>
          </a:xfrm>
          <a:prstGeom prst="rect">
            <a:avLst/>
          </a:prstGeom>
          <a:solidFill>
            <a:srgbClr val="FFFF99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64" name="Freeform 940"/>
          <p:cNvSpPr>
            <a:spLocks noEditPoints="1"/>
          </p:cNvSpPr>
          <p:nvPr/>
        </p:nvSpPr>
        <p:spPr bwMode="auto">
          <a:xfrm>
            <a:off x="3532505" y="7602573"/>
            <a:ext cx="47680" cy="117175"/>
          </a:xfrm>
          <a:custGeom>
            <a:avLst/>
            <a:gdLst/>
            <a:ahLst/>
            <a:cxnLst>
              <a:cxn ang="0">
                <a:pos x="0" y="40"/>
              </a:cxn>
              <a:cxn ang="0">
                <a:pos x="40" y="0"/>
              </a:cxn>
              <a:cxn ang="0">
                <a:pos x="776" y="0"/>
              </a:cxn>
              <a:cxn ang="0">
                <a:pos x="816" y="40"/>
              </a:cxn>
              <a:cxn ang="0">
                <a:pos x="816" y="1752"/>
              </a:cxn>
              <a:cxn ang="0">
                <a:pos x="776" y="1792"/>
              </a:cxn>
              <a:cxn ang="0">
                <a:pos x="40" y="1792"/>
              </a:cxn>
              <a:cxn ang="0">
                <a:pos x="0" y="1752"/>
              </a:cxn>
              <a:cxn ang="0">
                <a:pos x="0" y="40"/>
              </a:cxn>
              <a:cxn ang="0">
                <a:pos x="80" y="1752"/>
              </a:cxn>
              <a:cxn ang="0">
                <a:pos x="40" y="1712"/>
              </a:cxn>
              <a:cxn ang="0">
                <a:pos x="776" y="1712"/>
              </a:cxn>
              <a:cxn ang="0">
                <a:pos x="736" y="1752"/>
              </a:cxn>
              <a:cxn ang="0">
                <a:pos x="736" y="40"/>
              </a:cxn>
              <a:cxn ang="0">
                <a:pos x="776" y="80"/>
              </a:cxn>
              <a:cxn ang="0">
                <a:pos x="40" y="80"/>
              </a:cxn>
              <a:cxn ang="0">
                <a:pos x="80" y="40"/>
              </a:cxn>
              <a:cxn ang="0">
                <a:pos x="80" y="1752"/>
              </a:cxn>
            </a:cxnLst>
            <a:rect l="0" t="0" r="r" b="b"/>
            <a:pathLst>
              <a:path w="816" h="1792">
                <a:moveTo>
                  <a:pt x="0" y="40"/>
                </a:moveTo>
                <a:cubicBezTo>
                  <a:pt x="0" y="18"/>
                  <a:pt x="18" y="0"/>
                  <a:pt x="40" y="0"/>
                </a:cubicBezTo>
                <a:lnTo>
                  <a:pt x="776" y="0"/>
                </a:lnTo>
                <a:cubicBezTo>
                  <a:pt x="799" y="0"/>
                  <a:pt x="816" y="18"/>
                  <a:pt x="816" y="40"/>
                </a:cubicBezTo>
                <a:lnTo>
                  <a:pt x="816" y="1752"/>
                </a:lnTo>
                <a:cubicBezTo>
                  <a:pt x="816" y="1775"/>
                  <a:pt x="799" y="1792"/>
                  <a:pt x="776" y="1792"/>
                </a:cubicBezTo>
                <a:lnTo>
                  <a:pt x="40" y="1792"/>
                </a:lnTo>
                <a:cubicBezTo>
                  <a:pt x="18" y="1792"/>
                  <a:pt x="0" y="1775"/>
                  <a:pt x="0" y="1752"/>
                </a:cubicBezTo>
                <a:lnTo>
                  <a:pt x="0" y="40"/>
                </a:lnTo>
                <a:close/>
                <a:moveTo>
                  <a:pt x="80" y="1752"/>
                </a:moveTo>
                <a:lnTo>
                  <a:pt x="40" y="1712"/>
                </a:lnTo>
                <a:lnTo>
                  <a:pt x="776" y="1712"/>
                </a:lnTo>
                <a:lnTo>
                  <a:pt x="736" y="1752"/>
                </a:lnTo>
                <a:lnTo>
                  <a:pt x="736" y="40"/>
                </a:lnTo>
                <a:lnTo>
                  <a:pt x="776" y="80"/>
                </a:lnTo>
                <a:lnTo>
                  <a:pt x="40" y="80"/>
                </a:lnTo>
                <a:lnTo>
                  <a:pt x="80" y="40"/>
                </a:lnTo>
                <a:lnTo>
                  <a:pt x="80" y="1752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65" name="Rectangle 941"/>
          <p:cNvSpPr>
            <a:spLocks noChangeArrowheads="1"/>
          </p:cNvSpPr>
          <p:nvPr/>
        </p:nvSpPr>
        <p:spPr bwMode="auto">
          <a:xfrm>
            <a:off x="3664947" y="7690734"/>
            <a:ext cx="43441" cy="25667"/>
          </a:xfrm>
          <a:prstGeom prst="rect">
            <a:avLst/>
          </a:prstGeom>
          <a:solidFill>
            <a:srgbClr val="FFFF99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66" name="Freeform 942"/>
          <p:cNvSpPr>
            <a:spLocks noEditPoints="1"/>
          </p:cNvSpPr>
          <p:nvPr/>
        </p:nvSpPr>
        <p:spPr bwMode="auto">
          <a:xfrm>
            <a:off x="3662828" y="7687386"/>
            <a:ext cx="48739" cy="32362"/>
          </a:xfrm>
          <a:custGeom>
            <a:avLst/>
            <a:gdLst/>
            <a:ahLst/>
            <a:cxnLst>
              <a:cxn ang="0">
                <a:pos x="0" y="20"/>
              </a:cxn>
              <a:cxn ang="0">
                <a:pos x="20" y="0"/>
              </a:cxn>
              <a:cxn ang="0">
                <a:pos x="388" y="0"/>
              </a:cxn>
              <a:cxn ang="0">
                <a:pos x="408" y="20"/>
              </a:cxn>
              <a:cxn ang="0">
                <a:pos x="408" y="224"/>
              </a:cxn>
              <a:cxn ang="0">
                <a:pos x="388" y="244"/>
              </a:cxn>
              <a:cxn ang="0">
                <a:pos x="20" y="244"/>
              </a:cxn>
              <a:cxn ang="0">
                <a:pos x="0" y="224"/>
              </a:cxn>
              <a:cxn ang="0">
                <a:pos x="0" y="20"/>
              </a:cxn>
              <a:cxn ang="0">
                <a:pos x="40" y="224"/>
              </a:cxn>
              <a:cxn ang="0">
                <a:pos x="20" y="204"/>
              </a:cxn>
              <a:cxn ang="0">
                <a:pos x="388" y="204"/>
              </a:cxn>
              <a:cxn ang="0">
                <a:pos x="368" y="224"/>
              </a:cxn>
              <a:cxn ang="0">
                <a:pos x="368" y="20"/>
              </a:cxn>
              <a:cxn ang="0">
                <a:pos x="388" y="40"/>
              </a:cxn>
              <a:cxn ang="0">
                <a:pos x="20" y="40"/>
              </a:cxn>
              <a:cxn ang="0">
                <a:pos x="40" y="20"/>
              </a:cxn>
              <a:cxn ang="0">
                <a:pos x="40" y="224"/>
              </a:cxn>
            </a:cxnLst>
            <a:rect l="0" t="0" r="r" b="b"/>
            <a:pathLst>
              <a:path w="408" h="244">
                <a:moveTo>
                  <a:pt x="0" y="20"/>
                </a:moveTo>
                <a:cubicBezTo>
                  <a:pt x="0" y="9"/>
                  <a:pt x="9" y="0"/>
                  <a:pt x="20" y="0"/>
                </a:cubicBezTo>
                <a:lnTo>
                  <a:pt x="388" y="0"/>
                </a:lnTo>
                <a:cubicBezTo>
                  <a:pt x="400" y="0"/>
                  <a:pt x="408" y="9"/>
                  <a:pt x="408" y="20"/>
                </a:cubicBezTo>
                <a:lnTo>
                  <a:pt x="408" y="224"/>
                </a:lnTo>
                <a:cubicBezTo>
                  <a:pt x="408" y="236"/>
                  <a:pt x="400" y="244"/>
                  <a:pt x="388" y="244"/>
                </a:cubicBezTo>
                <a:lnTo>
                  <a:pt x="20" y="244"/>
                </a:lnTo>
                <a:cubicBezTo>
                  <a:pt x="9" y="244"/>
                  <a:pt x="0" y="236"/>
                  <a:pt x="0" y="224"/>
                </a:cubicBezTo>
                <a:lnTo>
                  <a:pt x="0" y="20"/>
                </a:lnTo>
                <a:close/>
                <a:moveTo>
                  <a:pt x="40" y="224"/>
                </a:moveTo>
                <a:lnTo>
                  <a:pt x="20" y="204"/>
                </a:lnTo>
                <a:lnTo>
                  <a:pt x="388" y="204"/>
                </a:lnTo>
                <a:lnTo>
                  <a:pt x="368" y="224"/>
                </a:lnTo>
                <a:lnTo>
                  <a:pt x="368" y="20"/>
                </a:lnTo>
                <a:lnTo>
                  <a:pt x="388" y="40"/>
                </a:lnTo>
                <a:lnTo>
                  <a:pt x="20" y="40"/>
                </a:lnTo>
                <a:lnTo>
                  <a:pt x="40" y="20"/>
                </a:lnTo>
                <a:lnTo>
                  <a:pt x="40" y="224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67" name="Rectangle 943"/>
          <p:cNvSpPr>
            <a:spLocks noChangeArrowheads="1"/>
          </p:cNvSpPr>
          <p:nvPr/>
        </p:nvSpPr>
        <p:spPr bwMode="auto">
          <a:xfrm>
            <a:off x="3926653" y="7618197"/>
            <a:ext cx="43441" cy="98204"/>
          </a:xfrm>
          <a:prstGeom prst="rect">
            <a:avLst/>
          </a:prstGeom>
          <a:solidFill>
            <a:srgbClr val="FFFF99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68" name="Freeform 944"/>
          <p:cNvSpPr>
            <a:spLocks noEditPoints="1"/>
          </p:cNvSpPr>
          <p:nvPr/>
        </p:nvSpPr>
        <p:spPr bwMode="auto">
          <a:xfrm>
            <a:off x="3924534" y="7615965"/>
            <a:ext cx="48739" cy="103783"/>
          </a:xfrm>
          <a:custGeom>
            <a:avLst/>
            <a:gdLst/>
            <a:ahLst/>
            <a:cxnLst>
              <a:cxn ang="0">
                <a:pos x="0" y="20"/>
              </a:cxn>
              <a:cxn ang="0">
                <a:pos x="20" y="0"/>
              </a:cxn>
              <a:cxn ang="0">
                <a:pos x="388" y="0"/>
              </a:cxn>
              <a:cxn ang="0">
                <a:pos x="408" y="20"/>
              </a:cxn>
              <a:cxn ang="0">
                <a:pos x="408" y="776"/>
              </a:cxn>
              <a:cxn ang="0">
                <a:pos x="388" y="796"/>
              </a:cxn>
              <a:cxn ang="0">
                <a:pos x="20" y="796"/>
              </a:cxn>
              <a:cxn ang="0">
                <a:pos x="0" y="776"/>
              </a:cxn>
              <a:cxn ang="0">
                <a:pos x="0" y="20"/>
              </a:cxn>
              <a:cxn ang="0">
                <a:pos x="40" y="776"/>
              </a:cxn>
              <a:cxn ang="0">
                <a:pos x="20" y="756"/>
              </a:cxn>
              <a:cxn ang="0">
                <a:pos x="388" y="756"/>
              </a:cxn>
              <a:cxn ang="0">
                <a:pos x="368" y="776"/>
              </a:cxn>
              <a:cxn ang="0">
                <a:pos x="368" y="20"/>
              </a:cxn>
              <a:cxn ang="0">
                <a:pos x="388" y="40"/>
              </a:cxn>
              <a:cxn ang="0">
                <a:pos x="20" y="40"/>
              </a:cxn>
              <a:cxn ang="0">
                <a:pos x="40" y="20"/>
              </a:cxn>
              <a:cxn ang="0">
                <a:pos x="40" y="776"/>
              </a:cxn>
            </a:cxnLst>
            <a:rect l="0" t="0" r="r" b="b"/>
            <a:pathLst>
              <a:path w="408" h="796">
                <a:moveTo>
                  <a:pt x="0" y="20"/>
                </a:moveTo>
                <a:cubicBezTo>
                  <a:pt x="0" y="9"/>
                  <a:pt x="9" y="0"/>
                  <a:pt x="20" y="0"/>
                </a:cubicBezTo>
                <a:lnTo>
                  <a:pt x="388" y="0"/>
                </a:lnTo>
                <a:cubicBezTo>
                  <a:pt x="400" y="0"/>
                  <a:pt x="408" y="9"/>
                  <a:pt x="408" y="20"/>
                </a:cubicBezTo>
                <a:lnTo>
                  <a:pt x="408" y="776"/>
                </a:lnTo>
                <a:cubicBezTo>
                  <a:pt x="408" y="788"/>
                  <a:pt x="400" y="796"/>
                  <a:pt x="388" y="796"/>
                </a:cubicBezTo>
                <a:lnTo>
                  <a:pt x="20" y="796"/>
                </a:lnTo>
                <a:cubicBezTo>
                  <a:pt x="9" y="796"/>
                  <a:pt x="0" y="788"/>
                  <a:pt x="0" y="776"/>
                </a:cubicBezTo>
                <a:lnTo>
                  <a:pt x="0" y="20"/>
                </a:lnTo>
                <a:close/>
                <a:moveTo>
                  <a:pt x="40" y="776"/>
                </a:moveTo>
                <a:lnTo>
                  <a:pt x="20" y="756"/>
                </a:lnTo>
                <a:lnTo>
                  <a:pt x="388" y="756"/>
                </a:lnTo>
                <a:lnTo>
                  <a:pt x="368" y="776"/>
                </a:lnTo>
                <a:lnTo>
                  <a:pt x="368" y="20"/>
                </a:lnTo>
                <a:lnTo>
                  <a:pt x="388" y="40"/>
                </a:lnTo>
                <a:lnTo>
                  <a:pt x="20" y="40"/>
                </a:lnTo>
                <a:lnTo>
                  <a:pt x="40" y="20"/>
                </a:lnTo>
                <a:lnTo>
                  <a:pt x="40" y="776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69" name="Rectangle 945"/>
          <p:cNvSpPr>
            <a:spLocks noChangeArrowheads="1"/>
          </p:cNvSpPr>
          <p:nvPr/>
        </p:nvSpPr>
        <p:spPr bwMode="auto">
          <a:xfrm>
            <a:off x="4056976" y="7621545"/>
            <a:ext cx="44501" cy="94856"/>
          </a:xfrm>
          <a:prstGeom prst="rect">
            <a:avLst/>
          </a:prstGeom>
          <a:solidFill>
            <a:srgbClr val="FFFF99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70" name="Freeform 946"/>
          <p:cNvSpPr>
            <a:spLocks noEditPoints="1"/>
          </p:cNvSpPr>
          <p:nvPr/>
        </p:nvSpPr>
        <p:spPr bwMode="auto">
          <a:xfrm>
            <a:off x="4054857" y="7618197"/>
            <a:ext cx="48739" cy="101551"/>
          </a:xfrm>
          <a:custGeom>
            <a:avLst/>
            <a:gdLst/>
            <a:ahLst/>
            <a:cxnLst>
              <a:cxn ang="0">
                <a:pos x="0" y="20"/>
              </a:cxn>
              <a:cxn ang="0">
                <a:pos x="20" y="0"/>
              </a:cxn>
              <a:cxn ang="0">
                <a:pos x="388" y="0"/>
              </a:cxn>
              <a:cxn ang="0">
                <a:pos x="408" y="20"/>
              </a:cxn>
              <a:cxn ang="0">
                <a:pos x="408" y="756"/>
              </a:cxn>
              <a:cxn ang="0">
                <a:pos x="388" y="776"/>
              </a:cxn>
              <a:cxn ang="0">
                <a:pos x="20" y="776"/>
              </a:cxn>
              <a:cxn ang="0">
                <a:pos x="0" y="756"/>
              </a:cxn>
              <a:cxn ang="0">
                <a:pos x="0" y="20"/>
              </a:cxn>
              <a:cxn ang="0">
                <a:pos x="40" y="756"/>
              </a:cxn>
              <a:cxn ang="0">
                <a:pos x="20" y="736"/>
              </a:cxn>
              <a:cxn ang="0">
                <a:pos x="388" y="736"/>
              </a:cxn>
              <a:cxn ang="0">
                <a:pos x="368" y="756"/>
              </a:cxn>
              <a:cxn ang="0">
                <a:pos x="368" y="20"/>
              </a:cxn>
              <a:cxn ang="0">
                <a:pos x="388" y="40"/>
              </a:cxn>
              <a:cxn ang="0">
                <a:pos x="20" y="40"/>
              </a:cxn>
              <a:cxn ang="0">
                <a:pos x="40" y="20"/>
              </a:cxn>
              <a:cxn ang="0">
                <a:pos x="40" y="756"/>
              </a:cxn>
            </a:cxnLst>
            <a:rect l="0" t="0" r="r" b="b"/>
            <a:pathLst>
              <a:path w="408" h="776">
                <a:moveTo>
                  <a:pt x="0" y="20"/>
                </a:moveTo>
                <a:cubicBezTo>
                  <a:pt x="0" y="9"/>
                  <a:pt x="9" y="0"/>
                  <a:pt x="20" y="0"/>
                </a:cubicBezTo>
                <a:lnTo>
                  <a:pt x="388" y="0"/>
                </a:lnTo>
                <a:cubicBezTo>
                  <a:pt x="400" y="0"/>
                  <a:pt x="408" y="9"/>
                  <a:pt x="408" y="20"/>
                </a:cubicBezTo>
                <a:lnTo>
                  <a:pt x="408" y="756"/>
                </a:lnTo>
                <a:cubicBezTo>
                  <a:pt x="408" y="768"/>
                  <a:pt x="400" y="776"/>
                  <a:pt x="388" y="776"/>
                </a:cubicBezTo>
                <a:lnTo>
                  <a:pt x="20" y="776"/>
                </a:lnTo>
                <a:cubicBezTo>
                  <a:pt x="9" y="776"/>
                  <a:pt x="0" y="768"/>
                  <a:pt x="0" y="756"/>
                </a:cubicBezTo>
                <a:lnTo>
                  <a:pt x="0" y="20"/>
                </a:lnTo>
                <a:close/>
                <a:moveTo>
                  <a:pt x="40" y="756"/>
                </a:moveTo>
                <a:lnTo>
                  <a:pt x="20" y="736"/>
                </a:lnTo>
                <a:lnTo>
                  <a:pt x="388" y="736"/>
                </a:lnTo>
                <a:lnTo>
                  <a:pt x="368" y="756"/>
                </a:lnTo>
                <a:lnTo>
                  <a:pt x="368" y="20"/>
                </a:lnTo>
                <a:lnTo>
                  <a:pt x="388" y="40"/>
                </a:lnTo>
                <a:lnTo>
                  <a:pt x="20" y="40"/>
                </a:lnTo>
                <a:lnTo>
                  <a:pt x="40" y="20"/>
                </a:lnTo>
                <a:lnTo>
                  <a:pt x="40" y="756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71" name="Rectangle 947"/>
          <p:cNvSpPr>
            <a:spLocks noChangeArrowheads="1"/>
          </p:cNvSpPr>
          <p:nvPr/>
        </p:nvSpPr>
        <p:spPr bwMode="auto">
          <a:xfrm>
            <a:off x="4188359" y="7699662"/>
            <a:ext cx="43441" cy="16739"/>
          </a:xfrm>
          <a:prstGeom prst="rect">
            <a:avLst/>
          </a:prstGeom>
          <a:solidFill>
            <a:srgbClr val="FFFF99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72" name="Freeform 948"/>
          <p:cNvSpPr>
            <a:spLocks noEditPoints="1"/>
          </p:cNvSpPr>
          <p:nvPr/>
        </p:nvSpPr>
        <p:spPr bwMode="auto">
          <a:xfrm>
            <a:off x="4185180" y="7696313"/>
            <a:ext cx="48739" cy="23435"/>
          </a:xfrm>
          <a:custGeom>
            <a:avLst/>
            <a:gdLst/>
            <a:ahLst/>
            <a:cxnLst>
              <a:cxn ang="0">
                <a:pos x="0" y="20"/>
              </a:cxn>
              <a:cxn ang="0">
                <a:pos x="20" y="0"/>
              </a:cxn>
              <a:cxn ang="0">
                <a:pos x="388" y="0"/>
              </a:cxn>
              <a:cxn ang="0">
                <a:pos x="408" y="20"/>
              </a:cxn>
              <a:cxn ang="0">
                <a:pos x="408" y="156"/>
              </a:cxn>
              <a:cxn ang="0">
                <a:pos x="388" y="176"/>
              </a:cxn>
              <a:cxn ang="0">
                <a:pos x="20" y="176"/>
              </a:cxn>
              <a:cxn ang="0">
                <a:pos x="0" y="156"/>
              </a:cxn>
              <a:cxn ang="0">
                <a:pos x="0" y="20"/>
              </a:cxn>
              <a:cxn ang="0">
                <a:pos x="40" y="156"/>
              </a:cxn>
              <a:cxn ang="0">
                <a:pos x="20" y="136"/>
              </a:cxn>
              <a:cxn ang="0">
                <a:pos x="388" y="136"/>
              </a:cxn>
              <a:cxn ang="0">
                <a:pos x="368" y="156"/>
              </a:cxn>
              <a:cxn ang="0">
                <a:pos x="368" y="20"/>
              </a:cxn>
              <a:cxn ang="0">
                <a:pos x="388" y="40"/>
              </a:cxn>
              <a:cxn ang="0">
                <a:pos x="20" y="40"/>
              </a:cxn>
              <a:cxn ang="0">
                <a:pos x="40" y="20"/>
              </a:cxn>
              <a:cxn ang="0">
                <a:pos x="40" y="156"/>
              </a:cxn>
            </a:cxnLst>
            <a:rect l="0" t="0" r="r" b="b"/>
            <a:pathLst>
              <a:path w="408" h="176">
                <a:moveTo>
                  <a:pt x="0" y="20"/>
                </a:moveTo>
                <a:cubicBezTo>
                  <a:pt x="0" y="9"/>
                  <a:pt x="9" y="0"/>
                  <a:pt x="20" y="0"/>
                </a:cubicBezTo>
                <a:lnTo>
                  <a:pt x="388" y="0"/>
                </a:lnTo>
                <a:cubicBezTo>
                  <a:pt x="400" y="0"/>
                  <a:pt x="408" y="9"/>
                  <a:pt x="408" y="20"/>
                </a:cubicBezTo>
                <a:lnTo>
                  <a:pt x="408" y="156"/>
                </a:lnTo>
                <a:cubicBezTo>
                  <a:pt x="408" y="168"/>
                  <a:pt x="400" y="176"/>
                  <a:pt x="388" y="176"/>
                </a:cubicBezTo>
                <a:lnTo>
                  <a:pt x="20" y="176"/>
                </a:lnTo>
                <a:cubicBezTo>
                  <a:pt x="9" y="176"/>
                  <a:pt x="0" y="168"/>
                  <a:pt x="0" y="156"/>
                </a:cubicBezTo>
                <a:lnTo>
                  <a:pt x="0" y="20"/>
                </a:lnTo>
                <a:close/>
                <a:moveTo>
                  <a:pt x="40" y="156"/>
                </a:moveTo>
                <a:lnTo>
                  <a:pt x="20" y="136"/>
                </a:lnTo>
                <a:lnTo>
                  <a:pt x="388" y="136"/>
                </a:lnTo>
                <a:lnTo>
                  <a:pt x="368" y="156"/>
                </a:lnTo>
                <a:lnTo>
                  <a:pt x="368" y="20"/>
                </a:lnTo>
                <a:lnTo>
                  <a:pt x="388" y="40"/>
                </a:lnTo>
                <a:lnTo>
                  <a:pt x="20" y="40"/>
                </a:lnTo>
                <a:lnTo>
                  <a:pt x="40" y="20"/>
                </a:lnTo>
                <a:lnTo>
                  <a:pt x="40" y="156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73" name="Rectangle 949"/>
          <p:cNvSpPr>
            <a:spLocks noChangeArrowheads="1"/>
          </p:cNvSpPr>
          <p:nvPr/>
        </p:nvSpPr>
        <p:spPr bwMode="auto">
          <a:xfrm>
            <a:off x="4450065" y="7701893"/>
            <a:ext cx="43441" cy="14507"/>
          </a:xfrm>
          <a:prstGeom prst="rect">
            <a:avLst/>
          </a:prstGeom>
          <a:solidFill>
            <a:srgbClr val="FFFF99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74" name="Freeform 950"/>
          <p:cNvSpPr>
            <a:spLocks noEditPoints="1"/>
          </p:cNvSpPr>
          <p:nvPr/>
        </p:nvSpPr>
        <p:spPr bwMode="auto">
          <a:xfrm>
            <a:off x="4446886" y="7699662"/>
            <a:ext cx="48739" cy="20087"/>
          </a:xfrm>
          <a:custGeom>
            <a:avLst/>
            <a:gdLst/>
            <a:ahLst/>
            <a:cxnLst>
              <a:cxn ang="0">
                <a:pos x="0" y="20"/>
              </a:cxn>
              <a:cxn ang="0">
                <a:pos x="20" y="0"/>
              </a:cxn>
              <a:cxn ang="0">
                <a:pos x="388" y="0"/>
              </a:cxn>
              <a:cxn ang="0">
                <a:pos x="408" y="20"/>
              </a:cxn>
              <a:cxn ang="0">
                <a:pos x="408" y="136"/>
              </a:cxn>
              <a:cxn ang="0">
                <a:pos x="388" y="156"/>
              </a:cxn>
              <a:cxn ang="0">
                <a:pos x="20" y="156"/>
              </a:cxn>
              <a:cxn ang="0">
                <a:pos x="0" y="136"/>
              </a:cxn>
              <a:cxn ang="0">
                <a:pos x="0" y="20"/>
              </a:cxn>
              <a:cxn ang="0">
                <a:pos x="40" y="136"/>
              </a:cxn>
              <a:cxn ang="0">
                <a:pos x="20" y="116"/>
              </a:cxn>
              <a:cxn ang="0">
                <a:pos x="388" y="116"/>
              </a:cxn>
              <a:cxn ang="0">
                <a:pos x="368" y="136"/>
              </a:cxn>
              <a:cxn ang="0">
                <a:pos x="368" y="20"/>
              </a:cxn>
              <a:cxn ang="0">
                <a:pos x="388" y="40"/>
              </a:cxn>
              <a:cxn ang="0">
                <a:pos x="20" y="40"/>
              </a:cxn>
              <a:cxn ang="0">
                <a:pos x="40" y="20"/>
              </a:cxn>
              <a:cxn ang="0">
                <a:pos x="40" y="136"/>
              </a:cxn>
            </a:cxnLst>
            <a:rect l="0" t="0" r="r" b="b"/>
            <a:pathLst>
              <a:path w="408" h="156">
                <a:moveTo>
                  <a:pt x="0" y="20"/>
                </a:moveTo>
                <a:cubicBezTo>
                  <a:pt x="0" y="9"/>
                  <a:pt x="9" y="0"/>
                  <a:pt x="20" y="0"/>
                </a:cubicBezTo>
                <a:lnTo>
                  <a:pt x="388" y="0"/>
                </a:lnTo>
                <a:cubicBezTo>
                  <a:pt x="400" y="0"/>
                  <a:pt x="408" y="9"/>
                  <a:pt x="408" y="20"/>
                </a:cubicBezTo>
                <a:lnTo>
                  <a:pt x="408" y="136"/>
                </a:lnTo>
                <a:cubicBezTo>
                  <a:pt x="408" y="148"/>
                  <a:pt x="400" y="156"/>
                  <a:pt x="388" y="156"/>
                </a:cubicBezTo>
                <a:lnTo>
                  <a:pt x="20" y="156"/>
                </a:lnTo>
                <a:cubicBezTo>
                  <a:pt x="9" y="156"/>
                  <a:pt x="0" y="148"/>
                  <a:pt x="0" y="136"/>
                </a:cubicBezTo>
                <a:lnTo>
                  <a:pt x="0" y="20"/>
                </a:lnTo>
                <a:close/>
                <a:moveTo>
                  <a:pt x="40" y="136"/>
                </a:moveTo>
                <a:lnTo>
                  <a:pt x="20" y="116"/>
                </a:lnTo>
                <a:lnTo>
                  <a:pt x="388" y="116"/>
                </a:lnTo>
                <a:lnTo>
                  <a:pt x="368" y="136"/>
                </a:lnTo>
                <a:lnTo>
                  <a:pt x="368" y="20"/>
                </a:lnTo>
                <a:lnTo>
                  <a:pt x="388" y="40"/>
                </a:lnTo>
                <a:lnTo>
                  <a:pt x="20" y="40"/>
                </a:lnTo>
                <a:lnTo>
                  <a:pt x="40" y="20"/>
                </a:lnTo>
                <a:lnTo>
                  <a:pt x="40" y="136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75" name="Rectangle 951"/>
          <p:cNvSpPr>
            <a:spLocks noChangeArrowheads="1"/>
          </p:cNvSpPr>
          <p:nvPr/>
        </p:nvSpPr>
        <p:spPr bwMode="auto">
          <a:xfrm>
            <a:off x="4580388" y="7071380"/>
            <a:ext cx="43441" cy="645020"/>
          </a:xfrm>
          <a:prstGeom prst="rect">
            <a:avLst/>
          </a:prstGeom>
          <a:solidFill>
            <a:srgbClr val="FFFF99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76" name="Freeform 952"/>
          <p:cNvSpPr>
            <a:spLocks noEditPoints="1"/>
          </p:cNvSpPr>
          <p:nvPr/>
        </p:nvSpPr>
        <p:spPr bwMode="auto">
          <a:xfrm>
            <a:off x="4578269" y="7068033"/>
            <a:ext cx="48739" cy="651716"/>
          </a:xfrm>
          <a:custGeom>
            <a:avLst/>
            <a:gdLst/>
            <a:ahLst/>
            <a:cxnLst>
              <a:cxn ang="0">
                <a:pos x="0" y="20"/>
              </a:cxn>
              <a:cxn ang="0">
                <a:pos x="20" y="0"/>
              </a:cxn>
              <a:cxn ang="0">
                <a:pos x="388" y="0"/>
              </a:cxn>
              <a:cxn ang="0">
                <a:pos x="408" y="20"/>
              </a:cxn>
              <a:cxn ang="0">
                <a:pos x="408" y="4988"/>
              </a:cxn>
              <a:cxn ang="0">
                <a:pos x="388" y="5008"/>
              </a:cxn>
              <a:cxn ang="0">
                <a:pos x="20" y="5008"/>
              </a:cxn>
              <a:cxn ang="0">
                <a:pos x="0" y="4988"/>
              </a:cxn>
              <a:cxn ang="0">
                <a:pos x="0" y="20"/>
              </a:cxn>
              <a:cxn ang="0">
                <a:pos x="40" y="4988"/>
              </a:cxn>
              <a:cxn ang="0">
                <a:pos x="20" y="4968"/>
              </a:cxn>
              <a:cxn ang="0">
                <a:pos x="388" y="4968"/>
              </a:cxn>
              <a:cxn ang="0">
                <a:pos x="368" y="4988"/>
              </a:cxn>
              <a:cxn ang="0">
                <a:pos x="368" y="20"/>
              </a:cxn>
              <a:cxn ang="0">
                <a:pos x="388" y="40"/>
              </a:cxn>
              <a:cxn ang="0">
                <a:pos x="20" y="40"/>
              </a:cxn>
              <a:cxn ang="0">
                <a:pos x="40" y="20"/>
              </a:cxn>
              <a:cxn ang="0">
                <a:pos x="40" y="4988"/>
              </a:cxn>
            </a:cxnLst>
            <a:rect l="0" t="0" r="r" b="b"/>
            <a:pathLst>
              <a:path w="408" h="5008">
                <a:moveTo>
                  <a:pt x="0" y="20"/>
                </a:moveTo>
                <a:cubicBezTo>
                  <a:pt x="0" y="9"/>
                  <a:pt x="9" y="0"/>
                  <a:pt x="20" y="0"/>
                </a:cubicBezTo>
                <a:lnTo>
                  <a:pt x="388" y="0"/>
                </a:lnTo>
                <a:cubicBezTo>
                  <a:pt x="400" y="0"/>
                  <a:pt x="408" y="9"/>
                  <a:pt x="408" y="20"/>
                </a:cubicBezTo>
                <a:lnTo>
                  <a:pt x="408" y="4988"/>
                </a:lnTo>
                <a:cubicBezTo>
                  <a:pt x="408" y="5000"/>
                  <a:pt x="400" y="5008"/>
                  <a:pt x="388" y="5008"/>
                </a:cubicBezTo>
                <a:lnTo>
                  <a:pt x="20" y="5008"/>
                </a:lnTo>
                <a:cubicBezTo>
                  <a:pt x="9" y="5008"/>
                  <a:pt x="0" y="5000"/>
                  <a:pt x="0" y="4988"/>
                </a:cubicBezTo>
                <a:lnTo>
                  <a:pt x="0" y="20"/>
                </a:lnTo>
                <a:close/>
                <a:moveTo>
                  <a:pt x="40" y="4988"/>
                </a:moveTo>
                <a:lnTo>
                  <a:pt x="20" y="4968"/>
                </a:lnTo>
                <a:lnTo>
                  <a:pt x="388" y="4968"/>
                </a:lnTo>
                <a:lnTo>
                  <a:pt x="368" y="4988"/>
                </a:lnTo>
                <a:lnTo>
                  <a:pt x="368" y="20"/>
                </a:lnTo>
                <a:lnTo>
                  <a:pt x="388" y="40"/>
                </a:lnTo>
                <a:lnTo>
                  <a:pt x="20" y="40"/>
                </a:lnTo>
                <a:lnTo>
                  <a:pt x="40" y="20"/>
                </a:lnTo>
                <a:lnTo>
                  <a:pt x="40" y="4988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77" name="Rectangle 953"/>
          <p:cNvSpPr>
            <a:spLocks noChangeArrowheads="1"/>
          </p:cNvSpPr>
          <p:nvPr/>
        </p:nvSpPr>
        <p:spPr bwMode="auto">
          <a:xfrm>
            <a:off x="2030079" y="6612724"/>
            <a:ext cx="1060" cy="1103676"/>
          </a:xfrm>
          <a:prstGeom prst="rect">
            <a:avLst/>
          </a:pr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78" name="Freeform 954"/>
          <p:cNvSpPr>
            <a:spLocks noEditPoints="1"/>
          </p:cNvSpPr>
          <p:nvPr/>
        </p:nvSpPr>
        <p:spPr bwMode="auto">
          <a:xfrm>
            <a:off x="2014186" y="6612724"/>
            <a:ext cx="16953" cy="1104792"/>
          </a:xfrm>
          <a:custGeom>
            <a:avLst/>
            <a:gdLst/>
            <a:ahLst/>
            <a:cxnLst>
              <a:cxn ang="0">
                <a:pos x="0" y="989"/>
              </a:cxn>
              <a:cxn ang="0">
                <a:pos x="16" y="989"/>
              </a:cxn>
              <a:cxn ang="0">
                <a:pos x="16" y="990"/>
              </a:cxn>
              <a:cxn ang="0">
                <a:pos x="0" y="990"/>
              </a:cxn>
              <a:cxn ang="0">
                <a:pos x="0" y="989"/>
              </a:cxn>
              <a:cxn ang="0">
                <a:pos x="0" y="879"/>
              </a:cxn>
              <a:cxn ang="0">
                <a:pos x="16" y="879"/>
              </a:cxn>
              <a:cxn ang="0">
                <a:pos x="16" y="880"/>
              </a:cxn>
              <a:cxn ang="0">
                <a:pos x="0" y="880"/>
              </a:cxn>
              <a:cxn ang="0">
                <a:pos x="0" y="879"/>
              </a:cxn>
              <a:cxn ang="0">
                <a:pos x="0" y="769"/>
              </a:cxn>
              <a:cxn ang="0">
                <a:pos x="16" y="769"/>
              </a:cxn>
              <a:cxn ang="0">
                <a:pos x="16" y="770"/>
              </a:cxn>
              <a:cxn ang="0">
                <a:pos x="0" y="770"/>
              </a:cxn>
              <a:cxn ang="0">
                <a:pos x="0" y="769"/>
              </a:cxn>
              <a:cxn ang="0">
                <a:pos x="0" y="659"/>
              </a:cxn>
              <a:cxn ang="0">
                <a:pos x="16" y="659"/>
              </a:cxn>
              <a:cxn ang="0">
                <a:pos x="16" y="660"/>
              </a:cxn>
              <a:cxn ang="0">
                <a:pos x="0" y="660"/>
              </a:cxn>
              <a:cxn ang="0">
                <a:pos x="0" y="659"/>
              </a:cxn>
              <a:cxn ang="0">
                <a:pos x="0" y="550"/>
              </a:cxn>
              <a:cxn ang="0">
                <a:pos x="16" y="550"/>
              </a:cxn>
              <a:cxn ang="0">
                <a:pos x="16" y="550"/>
              </a:cxn>
              <a:cxn ang="0">
                <a:pos x="0" y="550"/>
              </a:cxn>
              <a:cxn ang="0">
                <a:pos x="0" y="550"/>
              </a:cxn>
              <a:cxn ang="0">
                <a:pos x="0" y="440"/>
              </a:cxn>
              <a:cxn ang="0">
                <a:pos x="16" y="440"/>
              </a:cxn>
              <a:cxn ang="0">
                <a:pos x="16" y="440"/>
              </a:cxn>
              <a:cxn ang="0">
                <a:pos x="0" y="440"/>
              </a:cxn>
              <a:cxn ang="0">
                <a:pos x="0" y="440"/>
              </a:cxn>
              <a:cxn ang="0">
                <a:pos x="0" y="330"/>
              </a:cxn>
              <a:cxn ang="0">
                <a:pos x="16" y="330"/>
              </a:cxn>
              <a:cxn ang="0">
                <a:pos x="16" y="331"/>
              </a:cxn>
              <a:cxn ang="0">
                <a:pos x="0" y="331"/>
              </a:cxn>
              <a:cxn ang="0">
                <a:pos x="0" y="330"/>
              </a:cxn>
              <a:cxn ang="0">
                <a:pos x="0" y="220"/>
              </a:cxn>
              <a:cxn ang="0">
                <a:pos x="16" y="220"/>
              </a:cxn>
              <a:cxn ang="0">
                <a:pos x="16" y="221"/>
              </a:cxn>
              <a:cxn ang="0">
                <a:pos x="0" y="221"/>
              </a:cxn>
              <a:cxn ang="0">
                <a:pos x="0" y="220"/>
              </a:cxn>
              <a:cxn ang="0">
                <a:pos x="0" y="110"/>
              </a:cxn>
              <a:cxn ang="0">
                <a:pos x="16" y="110"/>
              </a:cxn>
              <a:cxn ang="0">
                <a:pos x="16" y="111"/>
              </a:cxn>
              <a:cxn ang="0">
                <a:pos x="0" y="111"/>
              </a:cxn>
              <a:cxn ang="0">
                <a:pos x="0" y="110"/>
              </a:cxn>
              <a:cxn ang="0">
                <a:pos x="0" y="0"/>
              </a:cxn>
              <a:cxn ang="0">
                <a:pos x="16" y="0"/>
              </a:cxn>
              <a:cxn ang="0">
                <a:pos x="16" y="1"/>
              </a:cxn>
              <a:cxn ang="0">
                <a:pos x="0" y="1"/>
              </a:cxn>
              <a:cxn ang="0">
                <a:pos x="0" y="0"/>
              </a:cxn>
            </a:cxnLst>
            <a:rect l="0" t="0" r="r" b="b"/>
            <a:pathLst>
              <a:path w="16" h="990">
                <a:moveTo>
                  <a:pt x="0" y="989"/>
                </a:moveTo>
                <a:lnTo>
                  <a:pt x="16" y="989"/>
                </a:lnTo>
                <a:lnTo>
                  <a:pt x="16" y="990"/>
                </a:lnTo>
                <a:lnTo>
                  <a:pt x="0" y="990"/>
                </a:lnTo>
                <a:lnTo>
                  <a:pt x="0" y="989"/>
                </a:lnTo>
                <a:close/>
                <a:moveTo>
                  <a:pt x="0" y="879"/>
                </a:moveTo>
                <a:lnTo>
                  <a:pt x="16" y="879"/>
                </a:lnTo>
                <a:lnTo>
                  <a:pt x="16" y="880"/>
                </a:lnTo>
                <a:lnTo>
                  <a:pt x="0" y="880"/>
                </a:lnTo>
                <a:lnTo>
                  <a:pt x="0" y="879"/>
                </a:lnTo>
                <a:close/>
                <a:moveTo>
                  <a:pt x="0" y="769"/>
                </a:moveTo>
                <a:lnTo>
                  <a:pt x="16" y="769"/>
                </a:lnTo>
                <a:lnTo>
                  <a:pt x="16" y="770"/>
                </a:lnTo>
                <a:lnTo>
                  <a:pt x="0" y="770"/>
                </a:lnTo>
                <a:lnTo>
                  <a:pt x="0" y="769"/>
                </a:lnTo>
                <a:close/>
                <a:moveTo>
                  <a:pt x="0" y="659"/>
                </a:moveTo>
                <a:lnTo>
                  <a:pt x="16" y="659"/>
                </a:lnTo>
                <a:lnTo>
                  <a:pt x="16" y="660"/>
                </a:lnTo>
                <a:lnTo>
                  <a:pt x="0" y="660"/>
                </a:lnTo>
                <a:lnTo>
                  <a:pt x="0" y="659"/>
                </a:lnTo>
                <a:close/>
                <a:moveTo>
                  <a:pt x="0" y="550"/>
                </a:moveTo>
                <a:lnTo>
                  <a:pt x="16" y="550"/>
                </a:lnTo>
                <a:lnTo>
                  <a:pt x="16" y="550"/>
                </a:lnTo>
                <a:lnTo>
                  <a:pt x="0" y="550"/>
                </a:lnTo>
                <a:lnTo>
                  <a:pt x="0" y="550"/>
                </a:lnTo>
                <a:close/>
                <a:moveTo>
                  <a:pt x="0" y="440"/>
                </a:moveTo>
                <a:lnTo>
                  <a:pt x="16" y="440"/>
                </a:lnTo>
                <a:lnTo>
                  <a:pt x="16" y="440"/>
                </a:lnTo>
                <a:lnTo>
                  <a:pt x="0" y="440"/>
                </a:lnTo>
                <a:lnTo>
                  <a:pt x="0" y="440"/>
                </a:lnTo>
                <a:close/>
                <a:moveTo>
                  <a:pt x="0" y="330"/>
                </a:moveTo>
                <a:lnTo>
                  <a:pt x="16" y="330"/>
                </a:lnTo>
                <a:lnTo>
                  <a:pt x="16" y="331"/>
                </a:lnTo>
                <a:lnTo>
                  <a:pt x="0" y="331"/>
                </a:lnTo>
                <a:lnTo>
                  <a:pt x="0" y="330"/>
                </a:lnTo>
                <a:close/>
                <a:moveTo>
                  <a:pt x="0" y="220"/>
                </a:moveTo>
                <a:lnTo>
                  <a:pt x="16" y="220"/>
                </a:lnTo>
                <a:lnTo>
                  <a:pt x="16" y="221"/>
                </a:lnTo>
                <a:lnTo>
                  <a:pt x="0" y="221"/>
                </a:lnTo>
                <a:lnTo>
                  <a:pt x="0" y="220"/>
                </a:lnTo>
                <a:close/>
                <a:moveTo>
                  <a:pt x="0" y="110"/>
                </a:moveTo>
                <a:lnTo>
                  <a:pt x="16" y="110"/>
                </a:lnTo>
                <a:lnTo>
                  <a:pt x="16" y="111"/>
                </a:lnTo>
                <a:lnTo>
                  <a:pt x="0" y="111"/>
                </a:lnTo>
                <a:lnTo>
                  <a:pt x="0" y="110"/>
                </a:lnTo>
                <a:close/>
                <a:moveTo>
                  <a:pt x="0" y="0"/>
                </a:moveTo>
                <a:lnTo>
                  <a:pt x="16" y="0"/>
                </a:lnTo>
                <a:lnTo>
                  <a:pt x="16" y="1"/>
                </a:lnTo>
                <a:lnTo>
                  <a:pt x="0" y="1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79" name="Rectangle 955"/>
          <p:cNvSpPr>
            <a:spLocks noChangeArrowheads="1"/>
          </p:cNvSpPr>
          <p:nvPr/>
        </p:nvSpPr>
        <p:spPr bwMode="auto">
          <a:xfrm>
            <a:off x="2031138" y="7716400"/>
            <a:ext cx="2614941" cy="1116"/>
          </a:xfrm>
          <a:prstGeom prst="rect">
            <a:avLst/>
          </a:pr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80" name="Freeform 956"/>
          <p:cNvSpPr>
            <a:spLocks noEditPoints="1"/>
          </p:cNvSpPr>
          <p:nvPr/>
        </p:nvSpPr>
        <p:spPr bwMode="auto">
          <a:xfrm>
            <a:off x="2030079" y="7716400"/>
            <a:ext cx="2616001" cy="18971"/>
          </a:xfrm>
          <a:custGeom>
            <a:avLst/>
            <a:gdLst/>
            <a:ahLst/>
            <a:cxnLst>
              <a:cxn ang="0">
                <a:pos x="1" y="17"/>
              </a:cxn>
              <a:cxn ang="0">
                <a:pos x="0" y="0"/>
              </a:cxn>
              <a:cxn ang="0">
                <a:pos x="125" y="0"/>
              </a:cxn>
              <a:cxn ang="0">
                <a:pos x="124" y="17"/>
              </a:cxn>
              <a:cxn ang="0">
                <a:pos x="125" y="0"/>
              </a:cxn>
              <a:cxn ang="0">
                <a:pos x="248" y="17"/>
              </a:cxn>
              <a:cxn ang="0">
                <a:pos x="247" y="0"/>
              </a:cxn>
              <a:cxn ang="0">
                <a:pos x="371" y="0"/>
              </a:cxn>
              <a:cxn ang="0">
                <a:pos x="370" y="17"/>
              </a:cxn>
              <a:cxn ang="0">
                <a:pos x="371" y="0"/>
              </a:cxn>
              <a:cxn ang="0">
                <a:pos x="495" y="17"/>
              </a:cxn>
              <a:cxn ang="0">
                <a:pos x="494" y="0"/>
              </a:cxn>
              <a:cxn ang="0">
                <a:pos x="618" y="0"/>
              </a:cxn>
              <a:cxn ang="0">
                <a:pos x="617" y="17"/>
              </a:cxn>
              <a:cxn ang="0">
                <a:pos x="618" y="0"/>
              </a:cxn>
              <a:cxn ang="0">
                <a:pos x="742" y="17"/>
              </a:cxn>
              <a:cxn ang="0">
                <a:pos x="741" y="0"/>
              </a:cxn>
              <a:cxn ang="0">
                <a:pos x="865" y="0"/>
              </a:cxn>
              <a:cxn ang="0">
                <a:pos x="864" y="17"/>
              </a:cxn>
              <a:cxn ang="0">
                <a:pos x="865" y="0"/>
              </a:cxn>
              <a:cxn ang="0">
                <a:pos x="989" y="17"/>
              </a:cxn>
              <a:cxn ang="0">
                <a:pos x="988" y="0"/>
              </a:cxn>
              <a:cxn ang="0">
                <a:pos x="1112" y="0"/>
              </a:cxn>
              <a:cxn ang="0">
                <a:pos x="1111" y="17"/>
              </a:cxn>
              <a:cxn ang="0">
                <a:pos x="1112" y="0"/>
              </a:cxn>
              <a:cxn ang="0">
                <a:pos x="1235" y="17"/>
              </a:cxn>
              <a:cxn ang="0">
                <a:pos x="1234" y="0"/>
              </a:cxn>
              <a:cxn ang="0">
                <a:pos x="1358" y="0"/>
              </a:cxn>
              <a:cxn ang="0">
                <a:pos x="1358" y="17"/>
              </a:cxn>
              <a:cxn ang="0">
                <a:pos x="1358" y="0"/>
              </a:cxn>
              <a:cxn ang="0">
                <a:pos x="1482" y="17"/>
              </a:cxn>
              <a:cxn ang="0">
                <a:pos x="1481" y="0"/>
              </a:cxn>
              <a:cxn ang="0">
                <a:pos x="1605" y="0"/>
              </a:cxn>
              <a:cxn ang="0">
                <a:pos x="1605" y="17"/>
              </a:cxn>
              <a:cxn ang="0">
                <a:pos x="1605" y="0"/>
              </a:cxn>
              <a:cxn ang="0">
                <a:pos x="1729" y="17"/>
              </a:cxn>
              <a:cxn ang="0">
                <a:pos x="1728" y="0"/>
              </a:cxn>
              <a:cxn ang="0">
                <a:pos x="1852" y="0"/>
              </a:cxn>
              <a:cxn ang="0">
                <a:pos x="1852" y="17"/>
              </a:cxn>
              <a:cxn ang="0">
                <a:pos x="1852" y="0"/>
              </a:cxn>
              <a:cxn ang="0">
                <a:pos x="1976" y="17"/>
              </a:cxn>
              <a:cxn ang="0">
                <a:pos x="1975" y="0"/>
              </a:cxn>
              <a:cxn ang="0">
                <a:pos x="2099" y="0"/>
              </a:cxn>
              <a:cxn ang="0">
                <a:pos x="2098" y="17"/>
              </a:cxn>
              <a:cxn ang="0">
                <a:pos x="2099" y="0"/>
              </a:cxn>
              <a:cxn ang="0">
                <a:pos x="2222" y="17"/>
              </a:cxn>
              <a:cxn ang="0">
                <a:pos x="2221" y="0"/>
              </a:cxn>
              <a:cxn ang="0">
                <a:pos x="2346" y="0"/>
              </a:cxn>
              <a:cxn ang="0">
                <a:pos x="2345" y="17"/>
              </a:cxn>
              <a:cxn ang="0">
                <a:pos x="2346" y="0"/>
              </a:cxn>
              <a:cxn ang="0">
                <a:pos x="2469" y="17"/>
              </a:cxn>
              <a:cxn ang="0">
                <a:pos x="2468" y="0"/>
              </a:cxn>
            </a:cxnLst>
            <a:rect l="0" t="0" r="r" b="b"/>
            <a:pathLst>
              <a:path w="2469" h="17">
                <a:moveTo>
                  <a:pt x="1" y="0"/>
                </a:moveTo>
                <a:lnTo>
                  <a:pt x="1" y="17"/>
                </a:lnTo>
                <a:lnTo>
                  <a:pt x="0" y="17"/>
                </a:lnTo>
                <a:lnTo>
                  <a:pt x="0" y="0"/>
                </a:lnTo>
                <a:lnTo>
                  <a:pt x="1" y="0"/>
                </a:lnTo>
                <a:close/>
                <a:moveTo>
                  <a:pt x="125" y="0"/>
                </a:moveTo>
                <a:lnTo>
                  <a:pt x="125" y="17"/>
                </a:lnTo>
                <a:lnTo>
                  <a:pt x="124" y="17"/>
                </a:lnTo>
                <a:lnTo>
                  <a:pt x="124" y="0"/>
                </a:lnTo>
                <a:lnTo>
                  <a:pt x="125" y="0"/>
                </a:lnTo>
                <a:close/>
                <a:moveTo>
                  <a:pt x="248" y="0"/>
                </a:moveTo>
                <a:lnTo>
                  <a:pt x="248" y="17"/>
                </a:lnTo>
                <a:lnTo>
                  <a:pt x="247" y="17"/>
                </a:lnTo>
                <a:lnTo>
                  <a:pt x="247" y="0"/>
                </a:lnTo>
                <a:lnTo>
                  <a:pt x="248" y="0"/>
                </a:lnTo>
                <a:close/>
                <a:moveTo>
                  <a:pt x="371" y="0"/>
                </a:moveTo>
                <a:lnTo>
                  <a:pt x="371" y="17"/>
                </a:lnTo>
                <a:lnTo>
                  <a:pt x="370" y="17"/>
                </a:lnTo>
                <a:lnTo>
                  <a:pt x="370" y="0"/>
                </a:lnTo>
                <a:lnTo>
                  <a:pt x="371" y="0"/>
                </a:lnTo>
                <a:close/>
                <a:moveTo>
                  <a:pt x="495" y="0"/>
                </a:moveTo>
                <a:lnTo>
                  <a:pt x="495" y="17"/>
                </a:lnTo>
                <a:lnTo>
                  <a:pt x="494" y="17"/>
                </a:lnTo>
                <a:lnTo>
                  <a:pt x="494" y="0"/>
                </a:lnTo>
                <a:lnTo>
                  <a:pt x="495" y="0"/>
                </a:lnTo>
                <a:close/>
                <a:moveTo>
                  <a:pt x="618" y="0"/>
                </a:moveTo>
                <a:lnTo>
                  <a:pt x="618" y="17"/>
                </a:lnTo>
                <a:lnTo>
                  <a:pt x="617" y="17"/>
                </a:lnTo>
                <a:lnTo>
                  <a:pt x="617" y="0"/>
                </a:lnTo>
                <a:lnTo>
                  <a:pt x="618" y="0"/>
                </a:lnTo>
                <a:close/>
                <a:moveTo>
                  <a:pt x="742" y="0"/>
                </a:moveTo>
                <a:lnTo>
                  <a:pt x="742" y="17"/>
                </a:lnTo>
                <a:lnTo>
                  <a:pt x="741" y="17"/>
                </a:lnTo>
                <a:lnTo>
                  <a:pt x="741" y="0"/>
                </a:lnTo>
                <a:lnTo>
                  <a:pt x="742" y="0"/>
                </a:lnTo>
                <a:close/>
                <a:moveTo>
                  <a:pt x="865" y="0"/>
                </a:moveTo>
                <a:lnTo>
                  <a:pt x="865" y="17"/>
                </a:lnTo>
                <a:lnTo>
                  <a:pt x="864" y="17"/>
                </a:lnTo>
                <a:lnTo>
                  <a:pt x="864" y="0"/>
                </a:lnTo>
                <a:lnTo>
                  <a:pt x="865" y="0"/>
                </a:lnTo>
                <a:close/>
                <a:moveTo>
                  <a:pt x="989" y="0"/>
                </a:moveTo>
                <a:lnTo>
                  <a:pt x="989" y="17"/>
                </a:lnTo>
                <a:lnTo>
                  <a:pt x="988" y="17"/>
                </a:lnTo>
                <a:lnTo>
                  <a:pt x="988" y="0"/>
                </a:lnTo>
                <a:lnTo>
                  <a:pt x="989" y="0"/>
                </a:lnTo>
                <a:close/>
                <a:moveTo>
                  <a:pt x="1112" y="0"/>
                </a:moveTo>
                <a:lnTo>
                  <a:pt x="1112" y="17"/>
                </a:lnTo>
                <a:lnTo>
                  <a:pt x="1111" y="17"/>
                </a:lnTo>
                <a:lnTo>
                  <a:pt x="1111" y="0"/>
                </a:lnTo>
                <a:lnTo>
                  <a:pt x="1112" y="0"/>
                </a:lnTo>
                <a:close/>
                <a:moveTo>
                  <a:pt x="1235" y="0"/>
                </a:moveTo>
                <a:lnTo>
                  <a:pt x="1235" y="17"/>
                </a:lnTo>
                <a:lnTo>
                  <a:pt x="1234" y="17"/>
                </a:lnTo>
                <a:lnTo>
                  <a:pt x="1234" y="0"/>
                </a:lnTo>
                <a:lnTo>
                  <a:pt x="1235" y="0"/>
                </a:lnTo>
                <a:close/>
                <a:moveTo>
                  <a:pt x="1358" y="0"/>
                </a:moveTo>
                <a:lnTo>
                  <a:pt x="1358" y="17"/>
                </a:lnTo>
                <a:lnTo>
                  <a:pt x="1358" y="17"/>
                </a:lnTo>
                <a:lnTo>
                  <a:pt x="1358" y="0"/>
                </a:lnTo>
                <a:lnTo>
                  <a:pt x="1358" y="0"/>
                </a:lnTo>
                <a:close/>
                <a:moveTo>
                  <a:pt x="1482" y="0"/>
                </a:moveTo>
                <a:lnTo>
                  <a:pt x="1482" y="17"/>
                </a:lnTo>
                <a:lnTo>
                  <a:pt x="1481" y="17"/>
                </a:lnTo>
                <a:lnTo>
                  <a:pt x="1481" y="0"/>
                </a:lnTo>
                <a:lnTo>
                  <a:pt x="1482" y="0"/>
                </a:lnTo>
                <a:close/>
                <a:moveTo>
                  <a:pt x="1605" y="0"/>
                </a:moveTo>
                <a:lnTo>
                  <a:pt x="1605" y="17"/>
                </a:lnTo>
                <a:lnTo>
                  <a:pt x="1605" y="17"/>
                </a:lnTo>
                <a:lnTo>
                  <a:pt x="1605" y="0"/>
                </a:lnTo>
                <a:lnTo>
                  <a:pt x="1605" y="0"/>
                </a:lnTo>
                <a:close/>
                <a:moveTo>
                  <a:pt x="1729" y="0"/>
                </a:moveTo>
                <a:lnTo>
                  <a:pt x="1729" y="17"/>
                </a:lnTo>
                <a:lnTo>
                  <a:pt x="1728" y="17"/>
                </a:lnTo>
                <a:lnTo>
                  <a:pt x="1728" y="0"/>
                </a:lnTo>
                <a:lnTo>
                  <a:pt x="1729" y="0"/>
                </a:lnTo>
                <a:close/>
                <a:moveTo>
                  <a:pt x="1852" y="0"/>
                </a:moveTo>
                <a:lnTo>
                  <a:pt x="1852" y="17"/>
                </a:lnTo>
                <a:lnTo>
                  <a:pt x="1852" y="17"/>
                </a:lnTo>
                <a:lnTo>
                  <a:pt x="1852" y="0"/>
                </a:lnTo>
                <a:lnTo>
                  <a:pt x="1852" y="0"/>
                </a:lnTo>
                <a:close/>
                <a:moveTo>
                  <a:pt x="1976" y="0"/>
                </a:moveTo>
                <a:lnTo>
                  <a:pt x="1976" y="17"/>
                </a:lnTo>
                <a:lnTo>
                  <a:pt x="1975" y="17"/>
                </a:lnTo>
                <a:lnTo>
                  <a:pt x="1975" y="0"/>
                </a:lnTo>
                <a:lnTo>
                  <a:pt x="1976" y="0"/>
                </a:lnTo>
                <a:close/>
                <a:moveTo>
                  <a:pt x="2099" y="0"/>
                </a:moveTo>
                <a:lnTo>
                  <a:pt x="2099" y="17"/>
                </a:lnTo>
                <a:lnTo>
                  <a:pt x="2098" y="17"/>
                </a:lnTo>
                <a:lnTo>
                  <a:pt x="2098" y="0"/>
                </a:lnTo>
                <a:lnTo>
                  <a:pt x="2099" y="0"/>
                </a:lnTo>
                <a:close/>
                <a:moveTo>
                  <a:pt x="2222" y="0"/>
                </a:moveTo>
                <a:lnTo>
                  <a:pt x="2222" y="17"/>
                </a:lnTo>
                <a:lnTo>
                  <a:pt x="2221" y="17"/>
                </a:lnTo>
                <a:lnTo>
                  <a:pt x="2221" y="0"/>
                </a:lnTo>
                <a:lnTo>
                  <a:pt x="2222" y="0"/>
                </a:lnTo>
                <a:close/>
                <a:moveTo>
                  <a:pt x="2346" y="0"/>
                </a:moveTo>
                <a:lnTo>
                  <a:pt x="2346" y="17"/>
                </a:lnTo>
                <a:lnTo>
                  <a:pt x="2345" y="17"/>
                </a:lnTo>
                <a:lnTo>
                  <a:pt x="2345" y="0"/>
                </a:lnTo>
                <a:lnTo>
                  <a:pt x="2346" y="0"/>
                </a:lnTo>
                <a:close/>
                <a:moveTo>
                  <a:pt x="2469" y="0"/>
                </a:moveTo>
                <a:lnTo>
                  <a:pt x="2469" y="17"/>
                </a:lnTo>
                <a:lnTo>
                  <a:pt x="2468" y="17"/>
                </a:lnTo>
                <a:lnTo>
                  <a:pt x="2468" y="0"/>
                </a:lnTo>
                <a:lnTo>
                  <a:pt x="2469" y="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81" name="Rectangle 957"/>
          <p:cNvSpPr>
            <a:spLocks noChangeArrowheads="1"/>
          </p:cNvSpPr>
          <p:nvPr/>
        </p:nvSpPr>
        <p:spPr bwMode="auto">
          <a:xfrm>
            <a:off x="1883938" y="7680690"/>
            <a:ext cx="57215" cy="8592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7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982" name="Rectangle 958"/>
          <p:cNvSpPr>
            <a:spLocks noChangeArrowheads="1"/>
          </p:cNvSpPr>
          <p:nvPr/>
        </p:nvSpPr>
        <p:spPr bwMode="auto">
          <a:xfrm>
            <a:off x="1821426" y="7557935"/>
            <a:ext cx="120787" cy="8592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7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20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983" name="Rectangle 959"/>
          <p:cNvSpPr>
            <a:spLocks noChangeArrowheads="1"/>
          </p:cNvSpPr>
          <p:nvPr/>
        </p:nvSpPr>
        <p:spPr bwMode="auto">
          <a:xfrm>
            <a:off x="1821426" y="7435181"/>
            <a:ext cx="120787" cy="8592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7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40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984" name="Rectangle 960"/>
          <p:cNvSpPr>
            <a:spLocks noChangeArrowheads="1"/>
          </p:cNvSpPr>
          <p:nvPr/>
        </p:nvSpPr>
        <p:spPr bwMode="auto">
          <a:xfrm>
            <a:off x="1821426" y="7312426"/>
            <a:ext cx="120787" cy="8592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7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60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985" name="Rectangle 961"/>
          <p:cNvSpPr>
            <a:spLocks noChangeArrowheads="1"/>
          </p:cNvSpPr>
          <p:nvPr/>
        </p:nvSpPr>
        <p:spPr bwMode="auto">
          <a:xfrm>
            <a:off x="1821426" y="7189671"/>
            <a:ext cx="120787" cy="870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7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80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986" name="Rectangle 962"/>
          <p:cNvSpPr>
            <a:spLocks noChangeArrowheads="1"/>
          </p:cNvSpPr>
          <p:nvPr/>
        </p:nvSpPr>
        <p:spPr bwMode="auto">
          <a:xfrm>
            <a:off x="1790699" y="7066917"/>
            <a:ext cx="152574" cy="870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7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100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987" name="Rectangle 963"/>
          <p:cNvSpPr>
            <a:spLocks noChangeArrowheads="1"/>
          </p:cNvSpPr>
          <p:nvPr/>
        </p:nvSpPr>
        <p:spPr bwMode="auto">
          <a:xfrm>
            <a:off x="1790699" y="6944162"/>
            <a:ext cx="152574" cy="870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7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120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988" name="Rectangle 964"/>
          <p:cNvSpPr>
            <a:spLocks noChangeArrowheads="1"/>
          </p:cNvSpPr>
          <p:nvPr/>
        </p:nvSpPr>
        <p:spPr bwMode="auto">
          <a:xfrm>
            <a:off x="1790699" y="6822523"/>
            <a:ext cx="152574" cy="8592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7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140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989" name="Rectangle 965"/>
          <p:cNvSpPr>
            <a:spLocks noChangeArrowheads="1"/>
          </p:cNvSpPr>
          <p:nvPr/>
        </p:nvSpPr>
        <p:spPr bwMode="auto">
          <a:xfrm>
            <a:off x="1790699" y="6699769"/>
            <a:ext cx="152574" cy="8592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7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160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990" name="Rectangle 966"/>
          <p:cNvSpPr>
            <a:spLocks noChangeArrowheads="1"/>
          </p:cNvSpPr>
          <p:nvPr/>
        </p:nvSpPr>
        <p:spPr bwMode="auto">
          <a:xfrm>
            <a:off x="1790699" y="6577014"/>
            <a:ext cx="152574" cy="8592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7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180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991" name="Rectangle 967"/>
          <p:cNvSpPr>
            <a:spLocks noChangeArrowheads="1"/>
          </p:cNvSpPr>
          <p:nvPr/>
        </p:nvSpPr>
        <p:spPr bwMode="auto">
          <a:xfrm>
            <a:off x="2080937" y="7772198"/>
            <a:ext cx="57215" cy="8592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7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1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992" name="Rectangle 968"/>
          <p:cNvSpPr>
            <a:spLocks noChangeArrowheads="1"/>
          </p:cNvSpPr>
          <p:nvPr/>
        </p:nvSpPr>
        <p:spPr bwMode="auto">
          <a:xfrm>
            <a:off x="2212320" y="7772198"/>
            <a:ext cx="56156" cy="8592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7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2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993" name="Rectangle 969"/>
          <p:cNvSpPr>
            <a:spLocks noChangeArrowheads="1"/>
          </p:cNvSpPr>
          <p:nvPr/>
        </p:nvSpPr>
        <p:spPr bwMode="auto">
          <a:xfrm>
            <a:off x="2342643" y="7772198"/>
            <a:ext cx="57215" cy="8592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7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3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994" name="Rectangle 970"/>
          <p:cNvSpPr>
            <a:spLocks noChangeArrowheads="1"/>
          </p:cNvSpPr>
          <p:nvPr/>
        </p:nvSpPr>
        <p:spPr bwMode="auto">
          <a:xfrm>
            <a:off x="2472966" y="7772198"/>
            <a:ext cx="57215" cy="8592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7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4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995" name="Rectangle 971"/>
          <p:cNvSpPr>
            <a:spLocks noChangeArrowheads="1"/>
          </p:cNvSpPr>
          <p:nvPr/>
        </p:nvSpPr>
        <p:spPr bwMode="auto">
          <a:xfrm>
            <a:off x="2604349" y="7772198"/>
            <a:ext cx="56156" cy="8592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7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5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996" name="Rectangle 972"/>
          <p:cNvSpPr>
            <a:spLocks noChangeArrowheads="1"/>
          </p:cNvSpPr>
          <p:nvPr/>
        </p:nvSpPr>
        <p:spPr bwMode="auto">
          <a:xfrm>
            <a:off x="2734672" y="7772198"/>
            <a:ext cx="57215" cy="8592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7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6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997" name="Rectangle 973"/>
          <p:cNvSpPr>
            <a:spLocks noChangeArrowheads="1"/>
          </p:cNvSpPr>
          <p:nvPr/>
        </p:nvSpPr>
        <p:spPr bwMode="auto">
          <a:xfrm>
            <a:off x="2866055" y="7772198"/>
            <a:ext cx="56156" cy="8592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7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7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998" name="Rectangle 974"/>
          <p:cNvSpPr>
            <a:spLocks noChangeArrowheads="1"/>
          </p:cNvSpPr>
          <p:nvPr/>
        </p:nvSpPr>
        <p:spPr bwMode="auto">
          <a:xfrm>
            <a:off x="2996378" y="7772198"/>
            <a:ext cx="57215" cy="8592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7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8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999" name="Rectangle 975"/>
          <p:cNvSpPr>
            <a:spLocks noChangeArrowheads="1"/>
          </p:cNvSpPr>
          <p:nvPr/>
        </p:nvSpPr>
        <p:spPr bwMode="auto">
          <a:xfrm>
            <a:off x="3126701" y="7772198"/>
            <a:ext cx="57215" cy="8592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7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9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000" name="Rectangle 976"/>
          <p:cNvSpPr>
            <a:spLocks noChangeArrowheads="1"/>
          </p:cNvSpPr>
          <p:nvPr/>
        </p:nvSpPr>
        <p:spPr bwMode="auto">
          <a:xfrm>
            <a:off x="3242191" y="7772198"/>
            <a:ext cx="89001" cy="8592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7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1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001" name="Rectangle 977"/>
          <p:cNvSpPr>
            <a:spLocks noChangeArrowheads="1"/>
          </p:cNvSpPr>
          <p:nvPr/>
        </p:nvSpPr>
        <p:spPr bwMode="auto">
          <a:xfrm>
            <a:off x="3372514" y="7772198"/>
            <a:ext cx="89001" cy="8592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7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11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002" name="Rectangle 978"/>
          <p:cNvSpPr>
            <a:spLocks noChangeArrowheads="1"/>
          </p:cNvSpPr>
          <p:nvPr/>
        </p:nvSpPr>
        <p:spPr bwMode="auto">
          <a:xfrm>
            <a:off x="3503897" y="7772198"/>
            <a:ext cx="87942" cy="8592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7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12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003" name="Rectangle 979"/>
          <p:cNvSpPr>
            <a:spLocks noChangeArrowheads="1"/>
          </p:cNvSpPr>
          <p:nvPr/>
        </p:nvSpPr>
        <p:spPr bwMode="auto">
          <a:xfrm>
            <a:off x="3634220" y="7772198"/>
            <a:ext cx="89001" cy="8592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7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13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004" name="Rectangle 980"/>
          <p:cNvSpPr>
            <a:spLocks noChangeArrowheads="1"/>
          </p:cNvSpPr>
          <p:nvPr/>
        </p:nvSpPr>
        <p:spPr bwMode="auto">
          <a:xfrm>
            <a:off x="3765603" y="7772198"/>
            <a:ext cx="89001" cy="8592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7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14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005" name="Rectangle 981"/>
          <p:cNvSpPr>
            <a:spLocks noChangeArrowheads="1"/>
          </p:cNvSpPr>
          <p:nvPr/>
        </p:nvSpPr>
        <p:spPr bwMode="auto">
          <a:xfrm>
            <a:off x="3895926" y="7772198"/>
            <a:ext cx="89001" cy="8592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7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15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006" name="Rectangle 982"/>
          <p:cNvSpPr>
            <a:spLocks noChangeArrowheads="1"/>
          </p:cNvSpPr>
          <p:nvPr/>
        </p:nvSpPr>
        <p:spPr bwMode="auto">
          <a:xfrm>
            <a:off x="4026250" y="7772198"/>
            <a:ext cx="89001" cy="8592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7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16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007" name="Rectangle 983"/>
          <p:cNvSpPr>
            <a:spLocks noChangeArrowheads="1"/>
          </p:cNvSpPr>
          <p:nvPr/>
        </p:nvSpPr>
        <p:spPr bwMode="auto">
          <a:xfrm>
            <a:off x="4157632" y="7772198"/>
            <a:ext cx="87942" cy="8592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7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17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008" name="Rectangle 984"/>
          <p:cNvSpPr>
            <a:spLocks noChangeArrowheads="1"/>
          </p:cNvSpPr>
          <p:nvPr/>
        </p:nvSpPr>
        <p:spPr bwMode="auto">
          <a:xfrm>
            <a:off x="4287955" y="7772198"/>
            <a:ext cx="89001" cy="8592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7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18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009" name="Rectangle 985"/>
          <p:cNvSpPr>
            <a:spLocks noChangeArrowheads="1"/>
          </p:cNvSpPr>
          <p:nvPr/>
        </p:nvSpPr>
        <p:spPr bwMode="auto">
          <a:xfrm>
            <a:off x="4419338" y="7772198"/>
            <a:ext cx="89001" cy="8592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7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19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010" name="Rectangle 986"/>
          <p:cNvSpPr>
            <a:spLocks noChangeArrowheads="1"/>
          </p:cNvSpPr>
          <p:nvPr/>
        </p:nvSpPr>
        <p:spPr bwMode="auto">
          <a:xfrm>
            <a:off x="4549662" y="7772198"/>
            <a:ext cx="89001" cy="8592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7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2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4375" name="Rectangle 1063"/>
          <p:cNvSpPr>
            <a:spLocks noChangeArrowheads="1"/>
          </p:cNvSpPr>
          <p:nvPr/>
        </p:nvSpPr>
        <p:spPr bwMode="auto">
          <a:xfrm>
            <a:off x="4915677" y="6557369"/>
            <a:ext cx="109876" cy="4291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150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4376" name="Rectangle 1064"/>
          <p:cNvSpPr>
            <a:spLocks noChangeArrowheads="1"/>
          </p:cNvSpPr>
          <p:nvPr/>
        </p:nvSpPr>
        <p:spPr bwMode="auto">
          <a:xfrm>
            <a:off x="4915677" y="6726657"/>
            <a:ext cx="109876" cy="4291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5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1000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4377" name="Rectangle 1065"/>
          <p:cNvSpPr>
            <a:spLocks noChangeArrowheads="1"/>
          </p:cNvSpPr>
          <p:nvPr/>
        </p:nvSpPr>
        <p:spPr bwMode="auto">
          <a:xfrm>
            <a:off x="4936408" y="6895945"/>
            <a:ext cx="87072" cy="4291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50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4378" name="Rectangle 1066"/>
          <p:cNvSpPr>
            <a:spLocks noChangeArrowheads="1"/>
          </p:cNvSpPr>
          <p:nvPr/>
        </p:nvSpPr>
        <p:spPr bwMode="auto">
          <a:xfrm>
            <a:off x="4978908" y="7065233"/>
            <a:ext cx="41463" cy="4291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4379" name="Rectangle 1067"/>
          <p:cNvSpPr>
            <a:spLocks noChangeArrowheads="1"/>
          </p:cNvSpPr>
          <p:nvPr/>
        </p:nvSpPr>
        <p:spPr bwMode="auto">
          <a:xfrm>
            <a:off x="4922933" y="7234520"/>
            <a:ext cx="100547" cy="4291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5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-500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4380" name="Rectangle 1068"/>
          <p:cNvSpPr>
            <a:spLocks noChangeArrowheads="1"/>
          </p:cNvSpPr>
          <p:nvPr/>
        </p:nvSpPr>
        <p:spPr bwMode="auto">
          <a:xfrm>
            <a:off x="4902202" y="7403808"/>
            <a:ext cx="123352" cy="4291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-100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4381" name="Rectangle 1069"/>
          <p:cNvSpPr>
            <a:spLocks noChangeArrowheads="1"/>
          </p:cNvSpPr>
          <p:nvPr/>
        </p:nvSpPr>
        <p:spPr bwMode="auto">
          <a:xfrm>
            <a:off x="4902202" y="7572301"/>
            <a:ext cx="123352" cy="4291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-1500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4366" name="Line 1054"/>
          <p:cNvSpPr>
            <a:spLocks noChangeShapeType="1"/>
          </p:cNvSpPr>
          <p:nvPr/>
        </p:nvSpPr>
        <p:spPr bwMode="auto">
          <a:xfrm flipV="1">
            <a:off x="5100773" y="6583387"/>
            <a:ext cx="1038" cy="1186603"/>
          </a:xfrm>
          <a:prstGeom prst="line">
            <a:avLst/>
          </a:prstGeom>
          <a:noFill/>
          <a:ln w="6350" cap="flat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4367" name="Line 1055"/>
          <p:cNvSpPr>
            <a:spLocks noChangeShapeType="1"/>
          </p:cNvSpPr>
          <p:nvPr/>
        </p:nvSpPr>
        <p:spPr bwMode="auto">
          <a:xfrm flipH="1">
            <a:off x="5075896" y="7767607"/>
            <a:ext cx="24878" cy="795"/>
          </a:xfrm>
          <a:prstGeom prst="line">
            <a:avLst/>
          </a:prstGeom>
          <a:noFill/>
          <a:ln w="6350" cap="flat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4368" name="Line 1056"/>
          <p:cNvSpPr>
            <a:spLocks noChangeShapeType="1"/>
          </p:cNvSpPr>
          <p:nvPr/>
        </p:nvSpPr>
        <p:spPr bwMode="auto">
          <a:xfrm flipH="1">
            <a:off x="5075896" y="7598319"/>
            <a:ext cx="24878" cy="795"/>
          </a:xfrm>
          <a:prstGeom prst="line">
            <a:avLst/>
          </a:prstGeom>
          <a:noFill/>
          <a:ln w="6350" cap="flat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4369" name="Line 1057"/>
          <p:cNvSpPr>
            <a:spLocks noChangeShapeType="1"/>
          </p:cNvSpPr>
          <p:nvPr/>
        </p:nvSpPr>
        <p:spPr bwMode="auto">
          <a:xfrm flipH="1">
            <a:off x="5075896" y="7429031"/>
            <a:ext cx="24878" cy="795"/>
          </a:xfrm>
          <a:prstGeom prst="line">
            <a:avLst/>
          </a:prstGeom>
          <a:noFill/>
          <a:ln w="6350" cap="flat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4370" name="Line 1058"/>
          <p:cNvSpPr>
            <a:spLocks noChangeShapeType="1"/>
          </p:cNvSpPr>
          <p:nvPr/>
        </p:nvSpPr>
        <p:spPr bwMode="auto">
          <a:xfrm flipH="1">
            <a:off x="5075896" y="7260538"/>
            <a:ext cx="24878" cy="795"/>
          </a:xfrm>
          <a:prstGeom prst="line">
            <a:avLst/>
          </a:prstGeom>
          <a:noFill/>
          <a:ln w="6350" cap="flat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4371" name="Line 1059"/>
          <p:cNvSpPr>
            <a:spLocks noChangeShapeType="1"/>
          </p:cNvSpPr>
          <p:nvPr/>
        </p:nvSpPr>
        <p:spPr bwMode="auto">
          <a:xfrm flipH="1">
            <a:off x="5075896" y="7091250"/>
            <a:ext cx="24878" cy="795"/>
          </a:xfrm>
          <a:prstGeom prst="line">
            <a:avLst/>
          </a:prstGeom>
          <a:noFill/>
          <a:ln w="6350" cap="flat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4372" name="Line 1060"/>
          <p:cNvSpPr>
            <a:spLocks noChangeShapeType="1"/>
          </p:cNvSpPr>
          <p:nvPr/>
        </p:nvSpPr>
        <p:spPr bwMode="auto">
          <a:xfrm flipH="1">
            <a:off x="5075896" y="6921963"/>
            <a:ext cx="24878" cy="795"/>
          </a:xfrm>
          <a:prstGeom prst="line">
            <a:avLst/>
          </a:prstGeom>
          <a:noFill/>
          <a:ln w="6350" cap="flat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4373" name="Line 1061"/>
          <p:cNvSpPr>
            <a:spLocks noChangeShapeType="1"/>
          </p:cNvSpPr>
          <p:nvPr/>
        </p:nvSpPr>
        <p:spPr bwMode="auto">
          <a:xfrm flipH="1">
            <a:off x="5075896" y="6752675"/>
            <a:ext cx="24878" cy="795"/>
          </a:xfrm>
          <a:prstGeom prst="line">
            <a:avLst/>
          </a:prstGeom>
          <a:noFill/>
          <a:ln w="6350" cap="flat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4382" name="Line 1070"/>
          <p:cNvSpPr>
            <a:spLocks noChangeShapeType="1"/>
          </p:cNvSpPr>
          <p:nvPr/>
        </p:nvSpPr>
        <p:spPr bwMode="auto">
          <a:xfrm flipH="1">
            <a:off x="5075896" y="6583388"/>
            <a:ext cx="24878" cy="795"/>
          </a:xfrm>
          <a:prstGeom prst="line">
            <a:avLst/>
          </a:prstGeom>
          <a:noFill/>
          <a:ln w="6350" cap="flat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grpSp>
        <p:nvGrpSpPr>
          <p:cNvPr id="578" name="Group 577"/>
          <p:cNvGrpSpPr/>
          <p:nvPr/>
        </p:nvGrpSpPr>
        <p:grpSpPr>
          <a:xfrm flipV="1">
            <a:off x="5201321" y="7058268"/>
            <a:ext cx="132680" cy="572240"/>
            <a:chOff x="5201321" y="6724858"/>
            <a:chExt cx="132680" cy="572240"/>
          </a:xfrm>
        </p:grpSpPr>
        <p:sp>
          <p:nvSpPr>
            <p:cNvPr id="14383" name="Freeform 1071"/>
            <p:cNvSpPr>
              <a:spLocks/>
            </p:cNvSpPr>
            <p:nvPr/>
          </p:nvSpPr>
          <p:spPr bwMode="auto">
            <a:xfrm>
              <a:off x="5251076" y="6724858"/>
              <a:ext cx="33170" cy="572240"/>
            </a:xfrm>
            <a:custGeom>
              <a:avLst/>
              <a:gdLst/>
              <a:ahLst/>
              <a:cxnLst>
                <a:cxn ang="0">
                  <a:pos x="0" y="4207"/>
                </a:cxn>
                <a:cxn ang="0">
                  <a:pos x="95" y="4207"/>
                </a:cxn>
                <a:cxn ang="0">
                  <a:pos x="95" y="0"/>
                </a:cxn>
                <a:cxn ang="0">
                  <a:pos x="0" y="0"/>
                </a:cxn>
                <a:cxn ang="0">
                  <a:pos x="189" y="0"/>
                </a:cxn>
                <a:cxn ang="0">
                  <a:pos x="95" y="0"/>
                </a:cxn>
                <a:cxn ang="0">
                  <a:pos x="95" y="4207"/>
                </a:cxn>
                <a:cxn ang="0">
                  <a:pos x="189" y="4207"/>
                </a:cxn>
                <a:cxn ang="0">
                  <a:pos x="0" y="4207"/>
                </a:cxn>
              </a:cxnLst>
              <a:rect l="0" t="0" r="r" b="b"/>
              <a:pathLst>
                <a:path w="189" h="4207">
                  <a:moveTo>
                    <a:pt x="0" y="4207"/>
                  </a:moveTo>
                  <a:lnTo>
                    <a:pt x="95" y="4207"/>
                  </a:lnTo>
                  <a:lnTo>
                    <a:pt x="95" y="0"/>
                  </a:lnTo>
                  <a:lnTo>
                    <a:pt x="0" y="0"/>
                  </a:lnTo>
                  <a:lnTo>
                    <a:pt x="189" y="0"/>
                  </a:lnTo>
                  <a:lnTo>
                    <a:pt x="95" y="0"/>
                  </a:lnTo>
                  <a:lnTo>
                    <a:pt x="95" y="4207"/>
                  </a:lnTo>
                  <a:lnTo>
                    <a:pt x="189" y="4207"/>
                  </a:lnTo>
                  <a:lnTo>
                    <a:pt x="0" y="4207"/>
                  </a:lnTo>
                  <a:close/>
                </a:path>
              </a:pathLst>
            </a:custGeom>
            <a:solidFill>
              <a:srgbClr val="DBD8AC"/>
            </a:solidFill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4384" name="Rectangle 1072"/>
            <p:cNvSpPr>
              <a:spLocks noChangeArrowheads="1"/>
            </p:cNvSpPr>
            <p:nvPr/>
          </p:nvSpPr>
          <p:spPr bwMode="auto">
            <a:xfrm>
              <a:off x="5201321" y="6986340"/>
              <a:ext cx="132680" cy="189952"/>
            </a:xfrm>
            <a:prstGeom prst="rect">
              <a:avLst/>
            </a:prstGeom>
            <a:solidFill>
              <a:srgbClr val="2EB848"/>
            </a:solidFill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4385" name="Freeform 1073"/>
            <p:cNvSpPr>
              <a:spLocks/>
            </p:cNvSpPr>
            <p:nvPr/>
          </p:nvSpPr>
          <p:spPr bwMode="auto">
            <a:xfrm>
              <a:off x="5201321" y="7115889"/>
              <a:ext cx="132680" cy="79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756" y="0"/>
                </a:cxn>
                <a:cxn ang="0">
                  <a:pos x="0" y="0"/>
                </a:cxn>
              </a:cxnLst>
              <a:rect l="0" t="0" r="r" b="b"/>
              <a:pathLst>
                <a:path w="756">
                  <a:moveTo>
                    <a:pt x="0" y="0"/>
                  </a:moveTo>
                  <a:lnTo>
                    <a:pt x="756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28575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</p:grpSp>
      <p:sp>
        <p:nvSpPr>
          <p:cNvPr id="1902" name="TextBox 1901"/>
          <p:cNvSpPr txBox="1"/>
          <p:nvPr/>
        </p:nvSpPr>
        <p:spPr>
          <a:xfrm>
            <a:off x="600075" y="7953375"/>
            <a:ext cx="5667375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smtClean="0">
                <a:latin typeface="Arial" pitchFamily="34" charset="0"/>
                <a:cs typeface="Arial" pitchFamily="34" charset="0"/>
              </a:rPr>
              <a:t>Supplementary Figure 4.</a:t>
            </a:r>
            <a:r>
              <a:rPr lang="en-GB" sz="1100" dirty="0" smtClean="0">
                <a:latin typeface="Arial" pitchFamily="34" charset="0"/>
                <a:cs typeface="Arial" pitchFamily="34" charset="0"/>
              </a:rPr>
              <a:t> Individual paired values from the periphery (blue) and centre (yellow) of 20 CRCLM. The box and whisker plots represent the median, inter-quartile range and range of the absolute difference between central and peripheral tissue values for each tumour. The columns and error bars for 15-PGDH activity are the mean and SD of triplicate values per sample. No IHC scores were derived from central tissue from tumours 14 and 18 </a:t>
            </a:r>
            <a:r>
              <a:rPr lang="en-GB" sz="1100" smtClean="0">
                <a:latin typeface="Arial" pitchFamily="34" charset="0"/>
                <a:cs typeface="Arial" pitchFamily="34" charset="0"/>
              </a:rPr>
              <a:t>in which no </a:t>
            </a:r>
            <a:r>
              <a:rPr lang="en-GB" sz="1100" dirty="0" smtClean="0">
                <a:latin typeface="Arial" pitchFamily="34" charset="0"/>
                <a:cs typeface="Arial" pitchFamily="34" charset="0"/>
              </a:rPr>
              <a:t>tumour cells were evident. </a:t>
            </a:r>
            <a:endParaRPr lang="en-GB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73" name="TextBox 572"/>
          <p:cNvSpPr txBox="1"/>
          <p:nvPr/>
        </p:nvSpPr>
        <p:spPr>
          <a:xfrm>
            <a:off x="5391151" y="266700"/>
            <a:ext cx="9334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/>
              <a:t>centre&gt;peripheral</a:t>
            </a:r>
            <a:endParaRPr lang="en-GB" sz="800" dirty="0"/>
          </a:p>
        </p:txBody>
      </p:sp>
      <p:sp>
        <p:nvSpPr>
          <p:cNvPr id="574" name="TextBox 573"/>
          <p:cNvSpPr txBox="1"/>
          <p:nvPr/>
        </p:nvSpPr>
        <p:spPr>
          <a:xfrm>
            <a:off x="5391151" y="857250"/>
            <a:ext cx="9715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/>
              <a:t>peripheral&gt;central</a:t>
            </a:r>
            <a:endParaRPr lang="en-GB" sz="800" dirty="0"/>
          </a:p>
        </p:txBody>
      </p:sp>
      <p:sp>
        <p:nvSpPr>
          <p:cNvPr id="575" name="TextBox 574"/>
          <p:cNvSpPr txBox="1"/>
          <p:nvPr/>
        </p:nvSpPr>
        <p:spPr>
          <a:xfrm>
            <a:off x="5391151" y="1543050"/>
            <a:ext cx="9334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/>
              <a:t>centre&gt;peripheral</a:t>
            </a:r>
            <a:endParaRPr lang="en-GB" sz="800" dirty="0"/>
          </a:p>
        </p:txBody>
      </p:sp>
      <p:sp>
        <p:nvSpPr>
          <p:cNvPr id="576" name="TextBox 575"/>
          <p:cNvSpPr txBox="1"/>
          <p:nvPr/>
        </p:nvSpPr>
        <p:spPr>
          <a:xfrm>
            <a:off x="5391151" y="2133600"/>
            <a:ext cx="9715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/>
              <a:t>peripheral&gt;central</a:t>
            </a:r>
            <a:endParaRPr lang="en-GB" sz="800" dirty="0"/>
          </a:p>
        </p:txBody>
      </p:sp>
      <p:sp>
        <p:nvSpPr>
          <p:cNvPr id="580" name="TextBox 579"/>
          <p:cNvSpPr txBox="1"/>
          <p:nvPr/>
        </p:nvSpPr>
        <p:spPr>
          <a:xfrm>
            <a:off x="5391151" y="2838450"/>
            <a:ext cx="9334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/>
              <a:t>centre&gt;peripheral</a:t>
            </a:r>
            <a:endParaRPr lang="en-GB" sz="800" dirty="0"/>
          </a:p>
        </p:txBody>
      </p:sp>
      <p:sp>
        <p:nvSpPr>
          <p:cNvPr id="581" name="TextBox 580"/>
          <p:cNvSpPr txBox="1"/>
          <p:nvPr/>
        </p:nvSpPr>
        <p:spPr>
          <a:xfrm>
            <a:off x="5391151" y="3438525"/>
            <a:ext cx="9715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/>
              <a:t>peripheral&gt;central</a:t>
            </a:r>
            <a:endParaRPr lang="en-GB" sz="800" dirty="0"/>
          </a:p>
        </p:txBody>
      </p:sp>
      <p:sp>
        <p:nvSpPr>
          <p:cNvPr id="582" name="TextBox 581"/>
          <p:cNvSpPr txBox="1"/>
          <p:nvPr/>
        </p:nvSpPr>
        <p:spPr>
          <a:xfrm>
            <a:off x="5391151" y="4057650"/>
            <a:ext cx="9334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/>
              <a:t>centre&gt;peripheral</a:t>
            </a:r>
            <a:endParaRPr lang="en-GB" sz="800" dirty="0"/>
          </a:p>
        </p:txBody>
      </p:sp>
      <p:sp>
        <p:nvSpPr>
          <p:cNvPr id="583" name="TextBox 582"/>
          <p:cNvSpPr txBox="1"/>
          <p:nvPr/>
        </p:nvSpPr>
        <p:spPr>
          <a:xfrm>
            <a:off x="5391151" y="4857750"/>
            <a:ext cx="9715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/>
              <a:t>peripheral&gt;central</a:t>
            </a:r>
            <a:endParaRPr lang="en-GB" sz="800" dirty="0"/>
          </a:p>
        </p:txBody>
      </p:sp>
      <p:sp>
        <p:nvSpPr>
          <p:cNvPr id="585" name="TextBox 584"/>
          <p:cNvSpPr txBox="1"/>
          <p:nvPr/>
        </p:nvSpPr>
        <p:spPr>
          <a:xfrm>
            <a:off x="5391151" y="5562600"/>
            <a:ext cx="9334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/>
              <a:t>centre&gt;peripheral</a:t>
            </a:r>
            <a:endParaRPr lang="en-GB" sz="800" dirty="0"/>
          </a:p>
        </p:txBody>
      </p:sp>
      <p:sp>
        <p:nvSpPr>
          <p:cNvPr id="586" name="TextBox 585"/>
          <p:cNvSpPr txBox="1"/>
          <p:nvPr/>
        </p:nvSpPr>
        <p:spPr>
          <a:xfrm>
            <a:off x="5391151" y="5962650"/>
            <a:ext cx="9715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/>
              <a:t>peripheral&gt;central</a:t>
            </a:r>
            <a:endParaRPr lang="en-GB" sz="800" dirty="0"/>
          </a:p>
        </p:txBody>
      </p:sp>
      <p:sp>
        <p:nvSpPr>
          <p:cNvPr id="587" name="TextBox 586"/>
          <p:cNvSpPr txBox="1"/>
          <p:nvPr/>
        </p:nvSpPr>
        <p:spPr>
          <a:xfrm>
            <a:off x="5391151" y="6810375"/>
            <a:ext cx="9334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/>
              <a:t>centre&gt;peripheral</a:t>
            </a:r>
            <a:endParaRPr lang="en-GB" sz="800" dirty="0"/>
          </a:p>
        </p:txBody>
      </p:sp>
      <p:sp>
        <p:nvSpPr>
          <p:cNvPr id="588" name="TextBox 587"/>
          <p:cNvSpPr txBox="1"/>
          <p:nvPr/>
        </p:nvSpPr>
        <p:spPr>
          <a:xfrm>
            <a:off x="5391151" y="7143750"/>
            <a:ext cx="9715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/>
              <a:t>peripheral&gt;central</a:t>
            </a:r>
            <a:endParaRPr lang="en-GB" sz="800" dirty="0"/>
          </a:p>
        </p:txBody>
      </p:sp>
      <p:sp>
        <p:nvSpPr>
          <p:cNvPr id="589" name="Rectangle 1062"/>
          <p:cNvSpPr>
            <a:spLocks noChangeArrowheads="1"/>
          </p:cNvSpPr>
          <p:nvPr/>
        </p:nvSpPr>
        <p:spPr bwMode="auto">
          <a:xfrm>
            <a:off x="4896622" y="7735887"/>
            <a:ext cx="161904" cy="769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5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-2000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cxnSp>
        <p:nvCxnSpPr>
          <p:cNvPr id="591" name="Straight Connector 590"/>
          <p:cNvCxnSpPr/>
          <p:nvPr/>
        </p:nvCxnSpPr>
        <p:spPr>
          <a:xfrm flipV="1">
            <a:off x="5105400" y="1962150"/>
            <a:ext cx="1152525" cy="1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4" name="Straight Connector 593"/>
          <p:cNvCxnSpPr/>
          <p:nvPr/>
        </p:nvCxnSpPr>
        <p:spPr>
          <a:xfrm flipV="1">
            <a:off x="5114925" y="676275"/>
            <a:ext cx="1152525" cy="1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5" name="Straight Connector 594"/>
          <p:cNvCxnSpPr/>
          <p:nvPr/>
        </p:nvCxnSpPr>
        <p:spPr>
          <a:xfrm flipV="1">
            <a:off x="5124450" y="3248025"/>
            <a:ext cx="1152525" cy="1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6" name="Straight Connector 595"/>
          <p:cNvCxnSpPr/>
          <p:nvPr/>
        </p:nvCxnSpPr>
        <p:spPr>
          <a:xfrm flipV="1">
            <a:off x="5105400" y="4572000"/>
            <a:ext cx="1152525" cy="1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7" name="Straight Connector 596"/>
          <p:cNvCxnSpPr/>
          <p:nvPr/>
        </p:nvCxnSpPr>
        <p:spPr>
          <a:xfrm flipV="1">
            <a:off x="5105400" y="5876925"/>
            <a:ext cx="1152525" cy="1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8" name="Straight Connector 597"/>
          <p:cNvCxnSpPr/>
          <p:nvPr/>
        </p:nvCxnSpPr>
        <p:spPr>
          <a:xfrm flipV="1">
            <a:off x="5124450" y="7096125"/>
            <a:ext cx="1152525" cy="1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0" name="TextBox 589"/>
          <p:cNvSpPr txBox="1"/>
          <p:nvPr/>
        </p:nvSpPr>
        <p:spPr>
          <a:xfrm rot="16200000">
            <a:off x="1134192" y="6777752"/>
            <a:ext cx="11049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err="1" smtClean="0">
                <a:latin typeface="Arial" pitchFamily="34" charset="0"/>
                <a:cs typeface="Arial" pitchFamily="34" charset="0"/>
              </a:rPr>
              <a:t>pmol</a:t>
            </a:r>
            <a:r>
              <a:rPr lang="en-GB" sz="1000" b="1" dirty="0" smtClean="0">
                <a:latin typeface="Arial" pitchFamily="34" charset="0"/>
                <a:cs typeface="Arial" pitchFamily="34" charset="0"/>
              </a:rPr>
              <a:t>/mg</a:t>
            </a:r>
            <a:endParaRPr lang="en-GB" sz="10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0</TotalTime>
  <Words>292</Words>
  <Application>Microsoft Office PowerPoint</Application>
  <PresentationFormat>On-screen Show (4:3)</PresentationFormat>
  <Paragraphs>18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University of Leeds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edmah</dc:creator>
  <cp:lastModifiedBy>Owner</cp:lastModifiedBy>
  <cp:revision>28</cp:revision>
  <dcterms:created xsi:type="dcterms:W3CDTF">2012-03-30T13:35:33Z</dcterms:created>
  <dcterms:modified xsi:type="dcterms:W3CDTF">2012-07-20T14:40:43Z</dcterms:modified>
</cp:coreProperties>
</file>